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68" r:id="rId1"/>
  </p:sldMasterIdLst>
  <p:notesMasterIdLst>
    <p:notesMasterId r:id="rId6"/>
  </p:notesMasterIdLst>
  <p:sldIdLst>
    <p:sldId id="671" r:id="rId2"/>
    <p:sldId id="675" r:id="rId3"/>
    <p:sldId id="676" r:id="rId4"/>
    <p:sldId id="67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0100FC"/>
    <a:srgbClr val="F3794B"/>
    <a:srgbClr val="F3916D"/>
    <a:srgbClr val="FAC9B7"/>
    <a:srgbClr val="0001FD"/>
    <a:srgbClr val="C978A7"/>
    <a:srgbClr val="30BFF3"/>
    <a:srgbClr val="FF5050"/>
    <a:srgbClr val="0000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63" autoAdjust="0"/>
    <p:restoredTop sz="91717" autoAdjust="0"/>
  </p:normalViewPr>
  <p:slideViewPr>
    <p:cSldViewPr snapToGrid="0">
      <p:cViewPr varScale="1">
        <p:scale>
          <a:sx n="118" d="100"/>
          <a:sy n="118" d="100"/>
        </p:scale>
        <p:origin x="537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Relationship Id="rId14" Type="http://schemas.openxmlformats.org/officeDocument/2006/relationships/customXml" Target="../customXml/item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yk Barseghyan" userId="1af3c995-31f7-415e-9aa1-2b36900e994d" providerId="ADAL" clId="{F2E7F468-1AD9-4DAD-9D39-1A9D274F9CE4}"/>
    <pc:docChg chg="undo custSel addSld delSld modSld delMainMaster">
      <pc:chgData name="Hayk Barseghyan" userId="1af3c995-31f7-415e-9aa1-2b36900e994d" providerId="ADAL" clId="{F2E7F468-1AD9-4DAD-9D39-1A9D274F9CE4}" dt="2021-02-23T02:24:47.858" v="938" actId="1076"/>
      <pc:docMkLst>
        <pc:docMk/>
      </pc:docMkLst>
      <pc:sldChg chg="del">
        <pc:chgData name="Hayk Barseghyan" userId="1af3c995-31f7-415e-9aa1-2b36900e994d" providerId="ADAL" clId="{F2E7F468-1AD9-4DAD-9D39-1A9D274F9CE4}" dt="2021-02-08T06:41:58.892" v="18" actId="47"/>
        <pc:sldMkLst>
          <pc:docMk/>
          <pc:sldMk cId="3640561564" sldId="257"/>
        </pc:sldMkLst>
      </pc:sldChg>
      <pc:sldChg chg="del">
        <pc:chgData name="Hayk Barseghyan" userId="1af3c995-31f7-415e-9aa1-2b36900e994d" providerId="ADAL" clId="{F2E7F468-1AD9-4DAD-9D39-1A9D274F9CE4}" dt="2021-02-08T06:41:58.970" v="19" actId="47"/>
        <pc:sldMkLst>
          <pc:docMk/>
          <pc:sldMk cId="4219882457" sldId="259"/>
        </pc:sldMkLst>
      </pc:sldChg>
      <pc:sldChg chg="del">
        <pc:chgData name="Hayk Barseghyan" userId="1af3c995-31f7-415e-9aa1-2b36900e994d" providerId="ADAL" clId="{F2E7F468-1AD9-4DAD-9D39-1A9D274F9CE4}" dt="2021-02-08T06:41:59.014" v="20" actId="47"/>
        <pc:sldMkLst>
          <pc:docMk/>
          <pc:sldMk cId="3933391997" sldId="260"/>
        </pc:sldMkLst>
      </pc:sldChg>
      <pc:sldChg chg="del">
        <pc:chgData name="Hayk Barseghyan" userId="1af3c995-31f7-415e-9aa1-2b36900e994d" providerId="ADAL" clId="{F2E7F468-1AD9-4DAD-9D39-1A9D274F9CE4}" dt="2021-02-08T06:41:58.611" v="10" actId="47"/>
        <pc:sldMkLst>
          <pc:docMk/>
          <pc:sldMk cId="4108621243" sldId="265"/>
        </pc:sldMkLst>
      </pc:sldChg>
      <pc:sldChg chg="del">
        <pc:chgData name="Hayk Barseghyan" userId="1af3c995-31f7-415e-9aa1-2b36900e994d" providerId="ADAL" clId="{F2E7F468-1AD9-4DAD-9D39-1A9D274F9CE4}" dt="2021-02-08T06:41:57.824" v="6" actId="47"/>
        <pc:sldMkLst>
          <pc:docMk/>
          <pc:sldMk cId="2457274627" sldId="266"/>
        </pc:sldMkLst>
      </pc:sldChg>
      <pc:sldChg chg="del">
        <pc:chgData name="Hayk Barseghyan" userId="1af3c995-31f7-415e-9aa1-2b36900e994d" providerId="ADAL" clId="{F2E7F468-1AD9-4DAD-9D39-1A9D274F9CE4}" dt="2021-02-08T06:41:58.672" v="11" actId="47"/>
        <pc:sldMkLst>
          <pc:docMk/>
          <pc:sldMk cId="1773068846" sldId="267"/>
        </pc:sldMkLst>
      </pc:sldChg>
      <pc:sldChg chg="del">
        <pc:chgData name="Hayk Barseghyan" userId="1af3c995-31f7-415e-9aa1-2b36900e994d" providerId="ADAL" clId="{F2E7F468-1AD9-4DAD-9D39-1A9D274F9CE4}" dt="2021-02-08T06:41:58.759" v="14" actId="47"/>
        <pc:sldMkLst>
          <pc:docMk/>
          <pc:sldMk cId="2829546756" sldId="268"/>
        </pc:sldMkLst>
      </pc:sldChg>
      <pc:sldChg chg="del">
        <pc:chgData name="Hayk Barseghyan" userId="1af3c995-31f7-415e-9aa1-2b36900e994d" providerId="ADAL" clId="{F2E7F468-1AD9-4DAD-9D39-1A9D274F9CE4}" dt="2021-02-08T06:41:58.789" v="15" actId="47"/>
        <pc:sldMkLst>
          <pc:docMk/>
          <pc:sldMk cId="3843375511" sldId="269"/>
        </pc:sldMkLst>
      </pc:sldChg>
      <pc:sldChg chg="del">
        <pc:chgData name="Hayk Barseghyan" userId="1af3c995-31f7-415e-9aa1-2b36900e994d" providerId="ADAL" clId="{F2E7F468-1AD9-4DAD-9D39-1A9D274F9CE4}" dt="2021-02-08T06:41:58.832" v="16" actId="47"/>
        <pc:sldMkLst>
          <pc:docMk/>
          <pc:sldMk cId="2687638488" sldId="270"/>
        </pc:sldMkLst>
      </pc:sldChg>
      <pc:sldChg chg="del">
        <pc:chgData name="Hayk Barseghyan" userId="1af3c995-31f7-415e-9aa1-2b36900e994d" providerId="ADAL" clId="{F2E7F468-1AD9-4DAD-9D39-1A9D274F9CE4}" dt="2021-02-08T06:41:58.852" v="17" actId="47"/>
        <pc:sldMkLst>
          <pc:docMk/>
          <pc:sldMk cId="107768422" sldId="271"/>
        </pc:sldMkLst>
      </pc:sldChg>
      <pc:sldChg chg="del">
        <pc:chgData name="Hayk Barseghyan" userId="1af3c995-31f7-415e-9aa1-2b36900e994d" providerId="ADAL" clId="{F2E7F468-1AD9-4DAD-9D39-1A9D274F9CE4}" dt="2021-02-08T06:42:00.870" v="27" actId="47"/>
        <pc:sldMkLst>
          <pc:docMk/>
          <pc:sldMk cId="3682063670" sldId="455"/>
        </pc:sldMkLst>
      </pc:sldChg>
      <pc:sldChg chg="del">
        <pc:chgData name="Hayk Barseghyan" userId="1af3c995-31f7-415e-9aa1-2b36900e994d" providerId="ADAL" clId="{F2E7F468-1AD9-4DAD-9D39-1A9D274F9CE4}" dt="2021-02-08T06:41:59.750" v="22" actId="47"/>
        <pc:sldMkLst>
          <pc:docMk/>
          <pc:sldMk cId="2576092573" sldId="521"/>
        </pc:sldMkLst>
      </pc:sldChg>
      <pc:sldChg chg="del">
        <pc:chgData name="Hayk Barseghyan" userId="1af3c995-31f7-415e-9aa1-2b36900e994d" providerId="ADAL" clId="{F2E7F468-1AD9-4DAD-9D39-1A9D274F9CE4}" dt="2021-02-08T06:41:59.033" v="21" actId="47"/>
        <pc:sldMkLst>
          <pc:docMk/>
          <pc:sldMk cId="3929734210" sldId="537"/>
        </pc:sldMkLst>
      </pc:sldChg>
      <pc:sldChg chg="del">
        <pc:chgData name="Hayk Barseghyan" userId="1af3c995-31f7-415e-9aa1-2b36900e994d" providerId="ADAL" clId="{F2E7F468-1AD9-4DAD-9D39-1A9D274F9CE4}" dt="2021-02-08T06:42:00.041" v="23" actId="47"/>
        <pc:sldMkLst>
          <pc:docMk/>
          <pc:sldMk cId="3832950115" sldId="539"/>
        </pc:sldMkLst>
      </pc:sldChg>
      <pc:sldChg chg="del">
        <pc:chgData name="Hayk Barseghyan" userId="1af3c995-31f7-415e-9aa1-2b36900e994d" providerId="ADAL" clId="{F2E7F468-1AD9-4DAD-9D39-1A9D274F9CE4}" dt="2021-02-08T06:41:51.550" v="0" actId="47"/>
        <pc:sldMkLst>
          <pc:docMk/>
          <pc:sldMk cId="643427405" sldId="612"/>
        </pc:sldMkLst>
      </pc:sldChg>
      <pc:sldChg chg="del">
        <pc:chgData name="Hayk Barseghyan" userId="1af3c995-31f7-415e-9aa1-2b36900e994d" providerId="ADAL" clId="{F2E7F468-1AD9-4DAD-9D39-1A9D274F9CE4}" dt="2021-02-08T06:42:00.427" v="25" actId="47"/>
        <pc:sldMkLst>
          <pc:docMk/>
          <pc:sldMk cId="2360386703" sldId="625"/>
        </pc:sldMkLst>
      </pc:sldChg>
      <pc:sldChg chg="del">
        <pc:chgData name="Hayk Barseghyan" userId="1af3c995-31f7-415e-9aa1-2b36900e994d" providerId="ADAL" clId="{F2E7F468-1AD9-4DAD-9D39-1A9D274F9CE4}" dt="2021-02-08T06:41:57.987" v="7" actId="47"/>
        <pc:sldMkLst>
          <pc:docMk/>
          <pc:sldMk cId="1288986825" sldId="630"/>
        </pc:sldMkLst>
      </pc:sldChg>
      <pc:sldChg chg="del">
        <pc:chgData name="Hayk Barseghyan" userId="1af3c995-31f7-415e-9aa1-2b36900e994d" providerId="ADAL" clId="{F2E7F468-1AD9-4DAD-9D39-1A9D274F9CE4}" dt="2021-02-08T06:41:58.491" v="8" actId="47"/>
        <pc:sldMkLst>
          <pc:docMk/>
          <pc:sldMk cId="2209209365" sldId="631"/>
        </pc:sldMkLst>
      </pc:sldChg>
      <pc:sldChg chg="del">
        <pc:chgData name="Hayk Barseghyan" userId="1af3c995-31f7-415e-9aa1-2b36900e994d" providerId="ADAL" clId="{F2E7F468-1AD9-4DAD-9D39-1A9D274F9CE4}" dt="2021-02-08T06:41:53.325" v="3" actId="47"/>
        <pc:sldMkLst>
          <pc:docMk/>
          <pc:sldMk cId="2183533813" sldId="632"/>
        </pc:sldMkLst>
      </pc:sldChg>
      <pc:sldChg chg="del">
        <pc:chgData name="Hayk Barseghyan" userId="1af3c995-31f7-415e-9aa1-2b36900e994d" providerId="ADAL" clId="{F2E7F468-1AD9-4DAD-9D39-1A9D274F9CE4}" dt="2021-02-08T06:42:00.242" v="24" actId="47"/>
        <pc:sldMkLst>
          <pc:docMk/>
          <pc:sldMk cId="2499353837" sldId="636"/>
        </pc:sldMkLst>
      </pc:sldChg>
      <pc:sldChg chg="del">
        <pc:chgData name="Hayk Barseghyan" userId="1af3c995-31f7-415e-9aa1-2b36900e994d" providerId="ADAL" clId="{F2E7F468-1AD9-4DAD-9D39-1A9D274F9CE4}" dt="2021-02-08T06:41:57.350" v="4" actId="47"/>
        <pc:sldMkLst>
          <pc:docMk/>
          <pc:sldMk cId="1328227361" sldId="637"/>
        </pc:sldMkLst>
      </pc:sldChg>
      <pc:sldChg chg="del">
        <pc:chgData name="Hayk Barseghyan" userId="1af3c995-31f7-415e-9aa1-2b36900e994d" providerId="ADAL" clId="{F2E7F468-1AD9-4DAD-9D39-1A9D274F9CE4}" dt="2021-02-08T06:41:52.101" v="1" actId="47"/>
        <pc:sldMkLst>
          <pc:docMk/>
          <pc:sldMk cId="3397895423" sldId="642"/>
        </pc:sldMkLst>
      </pc:sldChg>
      <pc:sldChg chg="del">
        <pc:chgData name="Hayk Barseghyan" userId="1af3c995-31f7-415e-9aa1-2b36900e994d" providerId="ADAL" clId="{F2E7F468-1AD9-4DAD-9D39-1A9D274F9CE4}" dt="2021-02-08T06:42:00.667" v="26" actId="47"/>
        <pc:sldMkLst>
          <pc:docMk/>
          <pc:sldMk cId="898802219" sldId="644"/>
        </pc:sldMkLst>
      </pc:sldChg>
      <pc:sldChg chg="del">
        <pc:chgData name="Hayk Barseghyan" userId="1af3c995-31f7-415e-9aa1-2b36900e994d" providerId="ADAL" clId="{F2E7F468-1AD9-4DAD-9D39-1A9D274F9CE4}" dt="2021-02-08T06:41:52.787" v="2" actId="47"/>
        <pc:sldMkLst>
          <pc:docMk/>
          <pc:sldMk cId="3226516300" sldId="645"/>
        </pc:sldMkLst>
      </pc:sldChg>
      <pc:sldChg chg="del">
        <pc:chgData name="Hayk Barseghyan" userId="1af3c995-31f7-415e-9aa1-2b36900e994d" providerId="ADAL" clId="{F2E7F468-1AD9-4DAD-9D39-1A9D274F9CE4}" dt="2021-02-08T06:41:57.611" v="5" actId="47"/>
        <pc:sldMkLst>
          <pc:docMk/>
          <pc:sldMk cId="1258691686" sldId="647"/>
        </pc:sldMkLst>
      </pc:sldChg>
      <pc:sldChg chg="del">
        <pc:chgData name="Hayk Barseghyan" userId="1af3c995-31f7-415e-9aa1-2b36900e994d" providerId="ADAL" clId="{F2E7F468-1AD9-4DAD-9D39-1A9D274F9CE4}" dt="2021-02-08T06:41:58.521" v="9" actId="47"/>
        <pc:sldMkLst>
          <pc:docMk/>
          <pc:sldMk cId="1278248765" sldId="648"/>
        </pc:sldMkLst>
      </pc:sldChg>
      <pc:sldChg chg="del">
        <pc:chgData name="Hayk Barseghyan" userId="1af3c995-31f7-415e-9aa1-2b36900e994d" providerId="ADAL" clId="{F2E7F468-1AD9-4DAD-9D39-1A9D274F9CE4}" dt="2021-02-12T05:47:14.819" v="688" actId="47"/>
        <pc:sldMkLst>
          <pc:docMk/>
          <pc:sldMk cId="3868126251" sldId="648"/>
        </pc:sldMkLst>
      </pc:sldChg>
      <pc:sldChg chg="del">
        <pc:chgData name="Hayk Barseghyan" userId="1af3c995-31f7-415e-9aa1-2b36900e994d" providerId="ADAL" clId="{F2E7F468-1AD9-4DAD-9D39-1A9D274F9CE4}" dt="2021-02-08T06:41:58.749" v="13" actId="47"/>
        <pc:sldMkLst>
          <pc:docMk/>
          <pc:sldMk cId="3933587027" sldId="649"/>
        </pc:sldMkLst>
      </pc:sldChg>
      <pc:sldChg chg="del">
        <pc:chgData name="Hayk Barseghyan" userId="1af3c995-31f7-415e-9aa1-2b36900e994d" providerId="ADAL" clId="{F2E7F468-1AD9-4DAD-9D39-1A9D274F9CE4}" dt="2021-02-08T06:41:58.701" v="12" actId="47"/>
        <pc:sldMkLst>
          <pc:docMk/>
          <pc:sldMk cId="316078502" sldId="650"/>
        </pc:sldMkLst>
      </pc:sldChg>
      <pc:sldChg chg="addSp delSp modSp mod">
        <pc:chgData name="Hayk Barseghyan" userId="1af3c995-31f7-415e-9aa1-2b36900e994d" providerId="ADAL" clId="{F2E7F468-1AD9-4DAD-9D39-1A9D274F9CE4}" dt="2021-02-23T02:22:36.552" v="935" actId="478"/>
        <pc:sldMkLst>
          <pc:docMk/>
          <pc:sldMk cId="524483127" sldId="651"/>
        </pc:sldMkLst>
        <pc:spChg chg="add del mod ord">
          <ac:chgData name="Hayk Barseghyan" userId="1af3c995-31f7-415e-9aa1-2b36900e994d" providerId="ADAL" clId="{F2E7F468-1AD9-4DAD-9D39-1A9D274F9CE4}" dt="2021-02-23T02:22:36.552" v="935" actId="478"/>
          <ac:spMkLst>
            <pc:docMk/>
            <pc:sldMk cId="524483127" sldId="651"/>
            <ac:spMk id="2" creationId="{0AD7DC0C-F0D5-49AF-A21A-FCA35C7AB25A}"/>
          </ac:spMkLst>
        </pc:spChg>
        <pc:spChg chg="mod">
          <ac:chgData name="Hayk Barseghyan" userId="1af3c995-31f7-415e-9aa1-2b36900e994d" providerId="ADAL" clId="{F2E7F468-1AD9-4DAD-9D39-1A9D274F9CE4}" dt="2021-02-12T02:05:17.096" v="116" actId="14100"/>
          <ac:spMkLst>
            <pc:docMk/>
            <pc:sldMk cId="524483127" sldId="651"/>
            <ac:spMk id="9" creationId="{FAEB7540-E1AA-4AA8-8E2D-B822141FCC75}"/>
          </ac:spMkLst>
        </pc:spChg>
        <pc:spChg chg="mod">
          <ac:chgData name="Hayk Barseghyan" userId="1af3c995-31f7-415e-9aa1-2b36900e994d" providerId="ADAL" clId="{F2E7F468-1AD9-4DAD-9D39-1A9D274F9CE4}" dt="2021-02-12T02:15:19.282" v="186" actId="1076"/>
          <ac:spMkLst>
            <pc:docMk/>
            <pc:sldMk cId="524483127" sldId="651"/>
            <ac:spMk id="15" creationId="{1DA809E1-700B-4B5F-80D1-146841C532CC}"/>
          </ac:spMkLst>
        </pc:spChg>
        <pc:spChg chg="mod">
          <ac:chgData name="Hayk Barseghyan" userId="1af3c995-31f7-415e-9aa1-2b36900e994d" providerId="ADAL" clId="{F2E7F468-1AD9-4DAD-9D39-1A9D274F9CE4}" dt="2021-02-12T02:15:19.282" v="186" actId="1076"/>
          <ac:spMkLst>
            <pc:docMk/>
            <pc:sldMk cId="524483127" sldId="651"/>
            <ac:spMk id="16" creationId="{219D3844-749C-4AC5-8AAC-A5A6E4F706D5}"/>
          </ac:spMkLst>
        </pc:spChg>
        <pc:spChg chg="mod">
          <ac:chgData name="Hayk Barseghyan" userId="1af3c995-31f7-415e-9aa1-2b36900e994d" providerId="ADAL" clId="{F2E7F468-1AD9-4DAD-9D39-1A9D274F9CE4}" dt="2021-02-12T02:15:19.282" v="186" actId="1076"/>
          <ac:spMkLst>
            <pc:docMk/>
            <pc:sldMk cId="524483127" sldId="651"/>
            <ac:spMk id="17" creationId="{238D452B-545B-49D2-9AA5-4774F789BA52}"/>
          </ac:spMkLst>
        </pc:spChg>
        <pc:spChg chg="mod">
          <ac:chgData name="Hayk Barseghyan" userId="1af3c995-31f7-415e-9aa1-2b36900e994d" providerId="ADAL" clId="{F2E7F468-1AD9-4DAD-9D39-1A9D274F9CE4}" dt="2021-02-12T02:15:19.282" v="186" actId="1076"/>
          <ac:spMkLst>
            <pc:docMk/>
            <pc:sldMk cId="524483127" sldId="651"/>
            <ac:spMk id="18" creationId="{3B330CDD-DF8E-4329-9F8F-0C05A3EBA278}"/>
          </ac:spMkLst>
        </pc:spChg>
        <pc:spChg chg="mod">
          <ac:chgData name="Hayk Barseghyan" userId="1af3c995-31f7-415e-9aa1-2b36900e994d" providerId="ADAL" clId="{F2E7F468-1AD9-4DAD-9D39-1A9D274F9CE4}" dt="2021-02-12T02:15:19.282" v="186" actId="1076"/>
          <ac:spMkLst>
            <pc:docMk/>
            <pc:sldMk cId="524483127" sldId="651"/>
            <ac:spMk id="19" creationId="{92E3FBB9-4482-4901-BB7B-515414A60BF3}"/>
          </ac:spMkLst>
        </pc:spChg>
        <pc:spChg chg="mod">
          <ac:chgData name="Hayk Barseghyan" userId="1af3c995-31f7-415e-9aa1-2b36900e994d" providerId="ADAL" clId="{F2E7F468-1AD9-4DAD-9D39-1A9D274F9CE4}" dt="2021-02-12T02:18:23.561" v="336" actId="1035"/>
          <ac:spMkLst>
            <pc:docMk/>
            <pc:sldMk cId="524483127" sldId="651"/>
            <ac:spMk id="20" creationId="{33617DAE-E7EA-4947-A705-85255111007E}"/>
          </ac:spMkLst>
        </pc:spChg>
        <pc:spChg chg="mod">
          <ac:chgData name="Hayk Barseghyan" userId="1af3c995-31f7-415e-9aa1-2b36900e994d" providerId="ADAL" clId="{F2E7F468-1AD9-4DAD-9D39-1A9D274F9CE4}" dt="2021-02-12T02:18:00.034" v="308" actId="1038"/>
          <ac:spMkLst>
            <pc:docMk/>
            <pc:sldMk cId="524483127" sldId="651"/>
            <ac:spMk id="21" creationId="{C9A0FE9C-502B-4BBD-8A60-74F846E3930A}"/>
          </ac:spMkLst>
        </pc:spChg>
        <pc:spChg chg="mod">
          <ac:chgData name="Hayk Barseghyan" userId="1af3c995-31f7-415e-9aa1-2b36900e994d" providerId="ADAL" clId="{F2E7F468-1AD9-4DAD-9D39-1A9D274F9CE4}" dt="2021-02-12T02:17:47.532" v="275" actId="1038"/>
          <ac:spMkLst>
            <pc:docMk/>
            <pc:sldMk cId="524483127" sldId="651"/>
            <ac:spMk id="22" creationId="{097F0FB6-DB3D-4B12-9E76-180A15D9B845}"/>
          </ac:spMkLst>
        </pc:spChg>
        <pc:spChg chg="mod">
          <ac:chgData name="Hayk Barseghyan" userId="1af3c995-31f7-415e-9aa1-2b36900e994d" providerId="ADAL" clId="{F2E7F468-1AD9-4DAD-9D39-1A9D274F9CE4}" dt="2021-02-12T02:06:02.633" v="122" actId="1076"/>
          <ac:spMkLst>
            <pc:docMk/>
            <pc:sldMk cId="524483127" sldId="651"/>
            <ac:spMk id="28" creationId="{627423C8-B194-4935-85FA-5ED8C3D13EA3}"/>
          </ac:spMkLst>
        </pc:spChg>
        <pc:spChg chg="mod">
          <ac:chgData name="Hayk Barseghyan" userId="1af3c995-31f7-415e-9aa1-2b36900e994d" providerId="ADAL" clId="{F2E7F468-1AD9-4DAD-9D39-1A9D274F9CE4}" dt="2021-02-12T02:23:58.968" v="371" actId="1076"/>
          <ac:spMkLst>
            <pc:docMk/>
            <pc:sldMk cId="524483127" sldId="651"/>
            <ac:spMk id="31" creationId="{831FD28B-6273-4CCE-B35E-843034652E14}"/>
          </ac:spMkLst>
        </pc:spChg>
        <pc:spChg chg="mod">
          <ac:chgData name="Hayk Barseghyan" userId="1af3c995-31f7-415e-9aa1-2b36900e994d" providerId="ADAL" clId="{F2E7F468-1AD9-4DAD-9D39-1A9D274F9CE4}" dt="2021-02-23T02:20:46.354" v="929" actId="1076"/>
          <ac:spMkLst>
            <pc:docMk/>
            <pc:sldMk cId="524483127" sldId="651"/>
            <ac:spMk id="32" creationId="{3C8C9310-67BF-4B6E-89F4-3CEC1EC49D05}"/>
          </ac:spMkLst>
        </pc:spChg>
        <pc:spChg chg="add mod ord">
          <ac:chgData name="Hayk Barseghyan" userId="1af3c995-31f7-415e-9aa1-2b36900e994d" providerId="ADAL" clId="{F2E7F468-1AD9-4DAD-9D39-1A9D274F9CE4}" dt="2021-02-12T02:04:57.746" v="113" actId="1076"/>
          <ac:spMkLst>
            <pc:docMk/>
            <pc:sldMk cId="524483127" sldId="651"/>
            <ac:spMk id="45" creationId="{E1202E27-E275-4FF1-9346-5942DC51A46F}"/>
          </ac:spMkLst>
        </pc:spChg>
        <pc:spChg chg="add mod ord">
          <ac:chgData name="Hayk Barseghyan" userId="1af3c995-31f7-415e-9aa1-2b36900e994d" providerId="ADAL" clId="{F2E7F468-1AD9-4DAD-9D39-1A9D274F9CE4}" dt="2021-02-12T02:04:57.746" v="113" actId="1076"/>
          <ac:spMkLst>
            <pc:docMk/>
            <pc:sldMk cId="524483127" sldId="651"/>
            <ac:spMk id="46" creationId="{53DB97C0-C16E-4AF3-9475-288F41C17F0C}"/>
          </ac:spMkLst>
        </pc:spChg>
        <pc:spChg chg="mod">
          <ac:chgData name="Hayk Barseghyan" userId="1af3c995-31f7-415e-9aa1-2b36900e994d" providerId="ADAL" clId="{F2E7F468-1AD9-4DAD-9D39-1A9D274F9CE4}" dt="2021-02-12T01:43:53.088" v="74" actId="208"/>
          <ac:spMkLst>
            <pc:docMk/>
            <pc:sldMk cId="524483127" sldId="651"/>
            <ac:spMk id="48" creationId="{7DECEAD3-1F4B-4349-B3E1-EC2281C752C7}"/>
          </ac:spMkLst>
        </pc:spChg>
        <pc:spChg chg="add mod">
          <ac:chgData name="Hayk Barseghyan" userId="1af3c995-31f7-415e-9aa1-2b36900e994d" providerId="ADAL" clId="{F2E7F468-1AD9-4DAD-9D39-1A9D274F9CE4}" dt="2021-02-12T02:07:32.266" v="130" actId="1076"/>
          <ac:spMkLst>
            <pc:docMk/>
            <pc:sldMk cId="524483127" sldId="651"/>
            <ac:spMk id="54" creationId="{F7458320-CCC7-41FB-87F4-002910417CD3}"/>
          </ac:spMkLst>
        </pc:spChg>
        <pc:spChg chg="add mod">
          <ac:chgData name="Hayk Barseghyan" userId="1af3c995-31f7-415e-9aa1-2b36900e994d" providerId="ADAL" clId="{F2E7F468-1AD9-4DAD-9D39-1A9D274F9CE4}" dt="2021-02-12T02:07:32.266" v="130" actId="1076"/>
          <ac:spMkLst>
            <pc:docMk/>
            <pc:sldMk cId="524483127" sldId="651"/>
            <ac:spMk id="56" creationId="{902E1D0E-02B6-46FE-95D6-E066345D07BC}"/>
          </ac:spMkLst>
        </pc:spChg>
        <pc:spChg chg="add mod">
          <ac:chgData name="Hayk Barseghyan" userId="1af3c995-31f7-415e-9aa1-2b36900e994d" providerId="ADAL" clId="{F2E7F468-1AD9-4DAD-9D39-1A9D274F9CE4}" dt="2021-02-12T02:11:13.359" v="162" actId="1076"/>
          <ac:spMkLst>
            <pc:docMk/>
            <pc:sldMk cId="524483127" sldId="651"/>
            <ac:spMk id="57" creationId="{5C46408B-2224-4888-8628-992ACAE3B9B5}"/>
          </ac:spMkLst>
        </pc:spChg>
        <pc:spChg chg="del">
          <ac:chgData name="Hayk Barseghyan" userId="1af3c995-31f7-415e-9aa1-2b36900e994d" providerId="ADAL" clId="{F2E7F468-1AD9-4DAD-9D39-1A9D274F9CE4}" dt="2021-02-12T02:20:11.418" v="348" actId="478"/>
          <ac:spMkLst>
            <pc:docMk/>
            <pc:sldMk cId="524483127" sldId="651"/>
            <ac:spMk id="58" creationId="{C7E49091-0ACC-4142-9B93-9F0BE2716A65}"/>
          </ac:spMkLst>
        </pc:spChg>
        <pc:spChg chg="del">
          <ac:chgData name="Hayk Barseghyan" userId="1af3c995-31f7-415e-9aa1-2b36900e994d" providerId="ADAL" clId="{F2E7F468-1AD9-4DAD-9D39-1A9D274F9CE4}" dt="2021-02-12T02:20:10.452" v="347" actId="478"/>
          <ac:spMkLst>
            <pc:docMk/>
            <pc:sldMk cId="524483127" sldId="651"/>
            <ac:spMk id="59" creationId="{D1E7461A-0DE2-46AC-9A6B-AD21D7804CB3}"/>
          </ac:spMkLst>
        </pc:spChg>
        <pc:spChg chg="add del mod">
          <ac:chgData name="Hayk Barseghyan" userId="1af3c995-31f7-415e-9aa1-2b36900e994d" providerId="ADAL" clId="{F2E7F468-1AD9-4DAD-9D39-1A9D274F9CE4}" dt="2021-02-12T02:11:26.393" v="165" actId="478"/>
          <ac:spMkLst>
            <pc:docMk/>
            <pc:sldMk cId="524483127" sldId="651"/>
            <ac:spMk id="60" creationId="{58F59927-5F91-4E24-B86D-38AF4016D064}"/>
          </ac:spMkLst>
        </pc:spChg>
        <pc:spChg chg="add mod">
          <ac:chgData name="Hayk Barseghyan" userId="1af3c995-31f7-415e-9aa1-2b36900e994d" providerId="ADAL" clId="{F2E7F468-1AD9-4DAD-9D39-1A9D274F9CE4}" dt="2021-02-12T02:12:09.282" v="170" actId="1076"/>
          <ac:spMkLst>
            <pc:docMk/>
            <pc:sldMk cId="524483127" sldId="651"/>
            <ac:spMk id="61" creationId="{78673695-BE63-4187-8E05-62448935B3F1}"/>
          </ac:spMkLst>
        </pc:spChg>
        <pc:spChg chg="add mod">
          <ac:chgData name="Hayk Barseghyan" userId="1af3c995-31f7-415e-9aa1-2b36900e994d" providerId="ADAL" clId="{F2E7F468-1AD9-4DAD-9D39-1A9D274F9CE4}" dt="2021-02-12T02:13:04.180" v="174" actId="14100"/>
          <ac:spMkLst>
            <pc:docMk/>
            <pc:sldMk cId="524483127" sldId="651"/>
            <ac:spMk id="62" creationId="{166F1B38-B853-4F51-B5BF-0D624B3F55C0}"/>
          </ac:spMkLst>
        </pc:spChg>
        <pc:spChg chg="add mod">
          <ac:chgData name="Hayk Barseghyan" userId="1af3c995-31f7-415e-9aa1-2b36900e994d" providerId="ADAL" clId="{F2E7F468-1AD9-4DAD-9D39-1A9D274F9CE4}" dt="2021-02-12T02:14:50.807" v="183" actId="571"/>
          <ac:spMkLst>
            <pc:docMk/>
            <pc:sldMk cId="524483127" sldId="651"/>
            <ac:spMk id="66" creationId="{DCDBE126-0240-4044-A4D8-B15C4F048770}"/>
          </ac:spMkLst>
        </pc:spChg>
        <pc:spChg chg="add mod">
          <ac:chgData name="Hayk Barseghyan" userId="1af3c995-31f7-415e-9aa1-2b36900e994d" providerId="ADAL" clId="{F2E7F468-1AD9-4DAD-9D39-1A9D274F9CE4}" dt="2021-02-12T02:14:50.807" v="183" actId="571"/>
          <ac:spMkLst>
            <pc:docMk/>
            <pc:sldMk cId="524483127" sldId="651"/>
            <ac:spMk id="67" creationId="{EC9C902A-65A0-44FC-BD04-4F5BF163CC7B}"/>
          </ac:spMkLst>
        </pc:spChg>
        <pc:spChg chg="add mod">
          <ac:chgData name="Hayk Barseghyan" userId="1af3c995-31f7-415e-9aa1-2b36900e994d" providerId="ADAL" clId="{F2E7F468-1AD9-4DAD-9D39-1A9D274F9CE4}" dt="2021-02-12T02:14:50.807" v="183" actId="571"/>
          <ac:spMkLst>
            <pc:docMk/>
            <pc:sldMk cId="524483127" sldId="651"/>
            <ac:spMk id="68" creationId="{07A8FCD9-9EA6-43FE-B45E-D4157926D026}"/>
          </ac:spMkLst>
        </pc:spChg>
        <pc:spChg chg="add mod">
          <ac:chgData name="Hayk Barseghyan" userId="1af3c995-31f7-415e-9aa1-2b36900e994d" providerId="ADAL" clId="{F2E7F468-1AD9-4DAD-9D39-1A9D274F9CE4}" dt="2021-02-12T02:14:50.807" v="183" actId="571"/>
          <ac:spMkLst>
            <pc:docMk/>
            <pc:sldMk cId="524483127" sldId="651"/>
            <ac:spMk id="69" creationId="{7006ACA8-3A6C-41A6-AF4E-D11238F23562}"/>
          </ac:spMkLst>
        </pc:spChg>
        <pc:spChg chg="add mod">
          <ac:chgData name="Hayk Barseghyan" userId="1af3c995-31f7-415e-9aa1-2b36900e994d" providerId="ADAL" clId="{F2E7F468-1AD9-4DAD-9D39-1A9D274F9CE4}" dt="2021-02-12T02:14:50.807" v="183" actId="571"/>
          <ac:spMkLst>
            <pc:docMk/>
            <pc:sldMk cId="524483127" sldId="651"/>
            <ac:spMk id="70" creationId="{FE2691E7-EB93-4BA9-B95A-0D13D2390B37}"/>
          </ac:spMkLst>
        </pc:spChg>
        <pc:spChg chg="add mod">
          <ac:chgData name="Hayk Barseghyan" userId="1af3c995-31f7-415e-9aa1-2b36900e994d" providerId="ADAL" clId="{F2E7F468-1AD9-4DAD-9D39-1A9D274F9CE4}" dt="2021-02-12T02:14:50.807" v="183" actId="571"/>
          <ac:spMkLst>
            <pc:docMk/>
            <pc:sldMk cId="524483127" sldId="651"/>
            <ac:spMk id="71" creationId="{05EFB0DA-5897-4798-AA5B-D056F40825D2}"/>
          </ac:spMkLst>
        </pc:spChg>
        <pc:spChg chg="add mod">
          <ac:chgData name="Hayk Barseghyan" userId="1af3c995-31f7-415e-9aa1-2b36900e994d" providerId="ADAL" clId="{F2E7F468-1AD9-4DAD-9D39-1A9D274F9CE4}" dt="2021-02-12T02:21:48.722" v="350" actId="1076"/>
          <ac:spMkLst>
            <pc:docMk/>
            <pc:sldMk cId="524483127" sldId="651"/>
            <ac:spMk id="88" creationId="{7309DE7D-82B3-4F46-B078-58EBF40D4703}"/>
          </ac:spMkLst>
        </pc:spChg>
        <pc:spChg chg="add mod">
          <ac:chgData name="Hayk Barseghyan" userId="1af3c995-31f7-415e-9aa1-2b36900e994d" providerId="ADAL" clId="{F2E7F468-1AD9-4DAD-9D39-1A9D274F9CE4}" dt="2021-02-12T02:22:13.862" v="355" actId="255"/>
          <ac:spMkLst>
            <pc:docMk/>
            <pc:sldMk cId="524483127" sldId="651"/>
            <ac:spMk id="91" creationId="{13B1F2AA-C6E8-4BA8-9C3E-AADD95A31E93}"/>
          </ac:spMkLst>
        </pc:spChg>
        <pc:spChg chg="add mod">
          <ac:chgData name="Hayk Barseghyan" userId="1af3c995-31f7-415e-9aa1-2b36900e994d" providerId="ADAL" clId="{F2E7F468-1AD9-4DAD-9D39-1A9D274F9CE4}" dt="2021-02-12T02:22:13.862" v="355" actId="255"/>
          <ac:spMkLst>
            <pc:docMk/>
            <pc:sldMk cId="524483127" sldId="651"/>
            <ac:spMk id="92" creationId="{C38076EE-D1EB-4356-9361-84DA46C2351B}"/>
          </ac:spMkLst>
        </pc:spChg>
        <pc:spChg chg="add mod">
          <ac:chgData name="Hayk Barseghyan" userId="1af3c995-31f7-415e-9aa1-2b36900e994d" providerId="ADAL" clId="{F2E7F468-1AD9-4DAD-9D39-1A9D274F9CE4}" dt="2021-02-12T02:23:02.324" v="360" actId="1076"/>
          <ac:spMkLst>
            <pc:docMk/>
            <pc:sldMk cId="524483127" sldId="651"/>
            <ac:spMk id="93" creationId="{3EAC0E29-A0FD-42DD-8F3E-7B6BDF36A320}"/>
          </ac:spMkLst>
        </pc:spChg>
        <pc:spChg chg="add mod">
          <ac:chgData name="Hayk Barseghyan" userId="1af3c995-31f7-415e-9aa1-2b36900e994d" providerId="ADAL" clId="{F2E7F468-1AD9-4DAD-9D39-1A9D274F9CE4}" dt="2021-02-12T02:22:48.064" v="357" actId="1076"/>
          <ac:spMkLst>
            <pc:docMk/>
            <pc:sldMk cId="524483127" sldId="651"/>
            <ac:spMk id="94" creationId="{C3B2E742-FF55-4D80-8A82-03F353C11C9E}"/>
          </ac:spMkLst>
        </pc:spChg>
        <pc:spChg chg="add mod">
          <ac:chgData name="Hayk Barseghyan" userId="1af3c995-31f7-415e-9aa1-2b36900e994d" providerId="ADAL" clId="{F2E7F468-1AD9-4DAD-9D39-1A9D274F9CE4}" dt="2021-02-12T04:38:03.095" v="589" actId="1076"/>
          <ac:spMkLst>
            <pc:docMk/>
            <pc:sldMk cId="524483127" sldId="651"/>
            <ac:spMk id="97" creationId="{2C10D2CA-3F19-4321-86BC-73EED86092D3}"/>
          </ac:spMkLst>
        </pc:spChg>
        <pc:spChg chg="add mod">
          <ac:chgData name="Hayk Barseghyan" userId="1af3c995-31f7-415e-9aa1-2b36900e994d" providerId="ADAL" clId="{F2E7F468-1AD9-4DAD-9D39-1A9D274F9CE4}" dt="2021-02-12T04:39:16.021" v="601" actId="20577"/>
          <ac:spMkLst>
            <pc:docMk/>
            <pc:sldMk cId="524483127" sldId="651"/>
            <ac:spMk id="98" creationId="{CC1A3F83-E94B-4F3C-9D62-2C0B7D404690}"/>
          </ac:spMkLst>
        </pc:spChg>
        <pc:picChg chg="add mod ord">
          <ac:chgData name="Hayk Barseghyan" userId="1af3c995-31f7-415e-9aa1-2b36900e994d" providerId="ADAL" clId="{F2E7F468-1AD9-4DAD-9D39-1A9D274F9CE4}" dt="2021-02-12T02:23:46.737" v="369" actId="1076"/>
          <ac:picMkLst>
            <pc:docMk/>
            <pc:sldMk cId="524483127" sldId="651"/>
            <ac:picMk id="3" creationId="{4349EB37-DBC2-4C1A-92F4-42F3EFE3046E}"/>
          </ac:picMkLst>
        </pc:picChg>
        <pc:picChg chg="add del mod">
          <ac:chgData name="Hayk Barseghyan" userId="1af3c995-31f7-415e-9aa1-2b36900e994d" providerId="ADAL" clId="{F2E7F468-1AD9-4DAD-9D39-1A9D274F9CE4}" dt="2021-02-12T02:19:27.339" v="340" actId="478"/>
          <ac:picMkLst>
            <pc:docMk/>
            <pc:sldMk cId="524483127" sldId="651"/>
            <ac:picMk id="8" creationId="{FA8751FD-A7F1-4C2F-BD3F-91C8983C1B2D}"/>
          </ac:picMkLst>
        </pc:picChg>
        <pc:picChg chg="add del mod">
          <ac:chgData name="Hayk Barseghyan" userId="1af3c995-31f7-415e-9aa1-2b36900e994d" providerId="ADAL" clId="{F2E7F468-1AD9-4DAD-9D39-1A9D274F9CE4}" dt="2021-02-12T02:00:52.157" v="91" actId="478"/>
          <ac:picMkLst>
            <pc:docMk/>
            <pc:sldMk cId="524483127" sldId="651"/>
            <ac:picMk id="11" creationId="{87901B8E-128D-4517-98FE-A58C1403B629}"/>
          </ac:picMkLst>
        </pc:picChg>
        <pc:picChg chg="mod">
          <ac:chgData name="Hayk Barseghyan" userId="1af3c995-31f7-415e-9aa1-2b36900e994d" providerId="ADAL" clId="{F2E7F468-1AD9-4DAD-9D39-1A9D274F9CE4}" dt="2021-02-12T02:15:19.282" v="186" actId="1076"/>
          <ac:picMkLst>
            <pc:docMk/>
            <pc:sldMk cId="524483127" sldId="651"/>
            <ac:picMk id="14" creationId="{BD596D5A-A8B5-4F23-971B-B0033B030440}"/>
          </ac:picMkLst>
        </pc:picChg>
        <pc:picChg chg="add del mod">
          <ac:chgData name="Hayk Barseghyan" userId="1af3c995-31f7-415e-9aa1-2b36900e994d" providerId="ADAL" clId="{F2E7F468-1AD9-4DAD-9D39-1A9D274F9CE4}" dt="2021-02-12T02:01:27.439" v="95" actId="478"/>
          <ac:picMkLst>
            <pc:docMk/>
            <pc:sldMk cId="524483127" sldId="651"/>
            <ac:picMk id="33" creationId="{BA32DB42-561D-4E0E-9B25-DD11DA28C7AA}"/>
          </ac:picMkLst>
        </pc:picChg>
        <pc:picChg chg="del">
          <ac:chgData name="Hayk Barseghyan" userId="1af3c995-31f7-415e-9aa1-2b36900e994d" providerId="ADAL" clId="{F2E7F468-1AD9-4DAD-9D39-1A9D274F9CE4}" dt="2021-02-12T02:00:25.128" v="84" actId="478"/>
          <ac:picMkLst>
            <pc:docMk/>
            <pc:sldMk cId="524483127" sldId="651"/>
            <ac:picMk id="35" creationId="{66FD96DE-C6EB-4683-ADCB-50E7FBA9AAF3}"/>
          </ac:picMkLst>
        </pc:picChg>
        <pc:picChg chg="del">
          <ac:chgData name="Hayk Barseghyan" userId="1af3c995-31f7-415e-9aa1-2b36900e994d" providerId="ADAL" clId="{F2E7F468-1AD9-4DAD-9D39-1A9D274F9CE4}" dt="2021-02-12T01:47:15.083" v="82" actId="478"/>
          <ac:picMkLst>
            <pc:docMk/>
            <pc:sldMk cId="524483127" sldId="651"/>
            <ac:picMk id="36" creationId="{E9E5B046-D97F-4288-AA74-79294CC4F6EE}"/>
          </ac:picMkLst>
        </pc:picChg>
        <pc:picChg chg="add mod ord">
          <ac:chgData name="Hayk Barseghyan" userId="1af3c995-31f7-415e-9aa1-2b36900e994d" providerId="ADAL" clId="{F2E7F468-1AD9-4DAD-9D39-1A9D274F9CE4}" dt="2021-02-12T02:04:37.898" v="112" actId="1076"/>
          <ac:picMkLst>
            <pc:docMk/>
            <pc:sldMk cId="524483127" sldId="651"/>
            <ac:picMk id="37" creationId="{1CAC37ED-BD26-468D-A4D4-DD1DB2974763}"/>
          </ac:picMkLst>
        </pc:picChg>
        <pc:picChg chg="del">
          <ac:chgData name="Hayk Barseghyan" userId="1af3c995-31f7-415e-9aa1-2b36900e994d" providerId="ADAL" clId="{F2E7F468-1AD9-4DAD-9D39-1A9D274F9CE4}" dt="2021-02-12T01:23:41.103" v="45" actId="478"/>
          <ac:picMkLst>
            <pc:docMk/>
            <pc:sldMk cId="524483127" sldId="651"/>
            <ac:picMk id="43" creationId="{4F5972F7-3200-4EE7-BF84-33C378BBBBBB}"/>
          </ac:picMkLst>
        </pc:picChg>
        <pc:picChg chg="add mod">
          <ac:chgData name="Hayk Barseghyan" userId="1af3c995-31f7-415e-9aa1-2b36900e994d" providerId="ADAL" clId="{F2E7F468-1AD9-4DAD-9D39-1A9D274F9CE4}" dt="2021-02-12T02:07:32.266" v="130" actId="1076"/>
          <ac:picMkLst>
            <pc:docMk/>
            <pc:sldMk cId="524483127" sldId="651"/>
            <ac:picMk id="47" creationId="{CEDD3B1B-C263-4B57-8CBB-CB1FEC2206B8}"/>
          </ac:picMkLst>
        </pc:picChg>
        <pc:picChg chg="del">
          <ac:chgData name="Hayk Barseghyan" userId="1af3c995-31f7-415e-9aa1-2b36900e994d" providerId="ADAL" clId="{F2E7F468-1AD9-4DAD-9D39-1A9D274F9CE4}" dt="2021-02-12T01:23:45.931" v="46" actId="478"/>
          <ac:picMkLst>
            <pc:docMk/>
            <pc:sldMk cId="524483127" sldId="651"/>
            <ac:picMk id="55" creationId="{3292E05B-B4A2-4F12-88CC-882830945CA9}"/>
          </ac:picMkLst>
        </pc:picChg>
        <pc:picChg chg="add mod">
          <ac:chgData name="Hayk Barseghyan" userId="1af3c995-31f7-415e-9aa1-2b36900e994d" providerId="ADAL" clId="{F2E7F468-1AD9-4DAD-9D39-1A9D274F9CE4}" dt="2021-02-12T02:14:50.807" v="183" actId="571"/>
          <ac:picMkLst>
            <pc:docMk/>
            <pc:sldMk cId="524483127" sldId="651"/>
            <ac:picMk id="65" creationId="{82C5BD34-04A0-4739-99F0-8AE70D12EDA5}"/>
          </ac:picMkLst>
        </pc:picChg>
        <pc:picChg chg="add mod">
          <ac:chgData name="Hayk Barseghyan" userId="1af3c995-31f7-415e-9aa1-2b36900e994d" providerId="ADAL" clId="{F2E7F468-1AD9-4DAD-9D39-1A9D274F9CE4}" dt="2021-02-12T02:22:58.167" v="359" actId="1076"/>
          <ac:picMkLst>
            <pc:docMk/>
            <pc:sldMk cId="524483127" sldId="651"/>
            <ac:picMk id="87" creationId="{CB13D170-E4E8-47EE-A56B-B439A249975F}"/>
          </ac:picMkLst>
        </pc:picChg>
        <pc:cxnChg chg="mod">
          <ac:chgData name="Hayk Barseghyan" userId="1af3c995-31f7-415e-9aa1-2b36900e994d" providerId="ADAL" clId="{F2E7F468-1AD9-4DAD-9D39-1A9D274F9CE4}" dt="2021-02-12T02:13:25.745" v="176" actId="14100"/>
          <ac:cxnSpMkLst>
            <pc:docMk/>
            <pc:sldMk cId="524483127" sldId="651"/>
            <ac:cxnSpMk id="12" creationId="{77BFB2D3-AD99-4A46-A69B-5F7DA3AE9F40}"/>
          </ac:cxnSpMkLst>
        </pc:cxnChg>
        <pc:cxnChg chg="mod">
          <ac:chgData name="Hayk Barseghyan" userId="1af3c995-31f7-415e-9aa1-2b36900e994d" providerId="ADAL" clId="{F2E7F468-1AD9-4DAD-9D39-1A9D274F9CE4}" dt="2021-02-12T02:13:22.890" v="175" actId="14100"/>
          <ac:cxnSpMkLst>
            <pc:docMk/>
            <pc:sldMk cId="524483127" sldId="651"/>
            <ac:cxnSpMk id="13" creationId="{9C5A0F15-52CF-47D7-9374-8C8C2F340DD2}"/>
          </ac:cxnSpMkLst>
        </pc:cxnChg>
        <pc:cxnChg chg="mod">
          <ac:chgData name="Hayk Barseghyan" userId="1af3c995-31f7-415e-9aa1-2b36900e994d" providerId="ADAL" clId="{F2E7F468-1AD9-4DAD-9D39-1A9D274F9CE4}" dt="2021-02-12T02:18:04.106" v="309" actId="14100"/>
          <ac:cxnSpMkLst>
            <pc:docMk/>
            <pc:sldMk cId="524483127" sldId="651"/>
            <ac:cxnSpMk id="23" creationId="{B97A16ED-5542-4DD1-94CA-D032D3F72196}"/>
          </ac:cxnSpMkLst>
        </pc:cxnChg>
        <pc:cxnChg chg="mod">
          <ac:chgData name="Hayk Barseghyan" userId="1af3c995-31f7-415e-9aa1-2b36900e994d" providerId="ADAL" clId="{F2E7F468-1AD9-4DAD-9D39-1A9D274F9CE4}" dt="2021-02-12T02:17:51.708" v="276" actId="14100"/>
          <ac:cxnSpMkLst>
            <pc:docMk/>
            <pc:sldMk cId="524483127" sldId="651"/>
            <ac:cxnSpMk id="24" creationId="{792D8F66-E748-410F-BB9B-B632B254BDFB}"/>
          </ac:cxnSpMkLst>
        </pc:cxnChg>
        <pc:cxnChg chg="mod">
          <ac:chgData name="Hayk Barseghyan" userId="1af3c995-31f7-415e-9aa1-2b36900e994d" providerId="ADAL" clId="{F2E7F468-1AD9-4DAD-9D39-1A9D274F9CE4}" dt="2021-02-12T02:18:23.561" v="336" actId="1035"/>
          <ac:cxnSpMkLst>
            <pc:docMk/>
            <pc:sldMk cId="524483127" sldId="651"/>
            <ac:cxnSpMk id="25" creationId="{A4F48631-3605-414B-96A3-B4E7701F3903}"/>
          </ac:cxnSpMkLst>
        </pc:cxnChg>
        <pc:cxnChg chg="del">
          <ac:chgData name="Hayk Barseghyan" userId="1af3c995-31f7-415e-9aa1-2b36900e994d" providerId="ADAL" clId="{F2E7F468-1AD9-4DAD-9D39-1A9D274F9CE4}" dt="2021-02-12T02:14:24.461" v="180" actId="478"/>
          <ac:cxnSpMkLst>
            <pc:docMk/>
            <pc:sldMk cId="524483127" sldId="651"/>
            <ac:cxnSpMk id="26" creationId="{251C4E22-4DE1-42F8-831F-C59D805817CB}"/>
          </ac:cxnSpMkLst>
        </pc:cxnChg>
        <pc:cxnChg chg="add del">
          <ac:chgData name="Hayk Barseghyan" userId="1af3c995-31f7-415e-9aa1-2b36900e994d" providerId="ADAL" clId="{F2E7F468-1AD9-4DAD-9D39-1A9D274F9CE4}" dt="2021-02-12T02:14:58.727" v="185" actId="478"/>
          <ac:cxnSpMkLst>
            <pc:docMk/>
            <pc:sldMk cId="524483127" sldId="651"/>
            <ac:cxnSpMk id="27" creationId="{3A04AB6E-BA74-4664-AB00-DE51EF69DC08}"/>
          </ac:cxnSpMkLst>
        </pc:cxnChg>
        <pc:cxnChg chg="mod">
          <ac:chgData name="Hayk Barseghyan" userId="1af3c995-31f7-415e-9aa1-2b36900e994d" providerId="ADAL" clId="{F2E7F468-1AD9-4DAD-9D39-1A9D274F9CE4}" dt="2021-02-12T02:23:37.446" v="367" actId="14100"/>
          <ac:cxnSpMkLst>
            <pc:docMk/>
            <pc:sldMk cId="524483127" sldId="651"/>
            <ac:cxnSpMk id="49" creationId="{4423681D-AADF-4D62-AC9E-3FDDF18E21B9}"/>
          </ac:cxnSpMkLst>
        </pc:cxnChg>
        <pc:cxnChg chg="mod">
          <ac:chgData name="Hayk Barseghyan" userId="1af3c995-31f7-415e-9aa1-2b36900e994d" providerId="ADAL" clId="{F2E7F468-1AD9-4DAD-9D39-1A9D274F9CE4}" dt="2021-02-12T02:21:56.372" v="352" actId="14100"/>
          <ac:cxnSpMkLst>
            <pc:docMk/>
            <pc:sldMk cId="524483127" sldId="651"/>
            <ac:cxnSpMk id="52" creationId="{67E81840-D31A-48DD-9275-CD08F7D6F031}"/>
          </ac:cxnSpMkLst>
        </pc:cxnChg>
        <pc:cxnChg chg="add mod">
          <ac:chgData name="Hayk Barseghyan" userId="1af3c995-31f7-415e-9aa1-2b36900e994d" providerId="ADAL" clId="{F2E7F468-1AD9-4DAD-9D39-1A9D274F9CE4}" dt="2021-02-12T02:23:27.658" v="366" actId="1582"/>
          <ac:cxnSpMkLst>
            <pc:docMk/>
            <pc:sldMk cId="524483127" sldId="651"/>
            <ac:cxnSpMk id="63" creationId="{C0AA72CC-1333-4FD8-8FD6-2BAF30BE944A}"/>
          </ac:cxnSpMkLst>
        </pc:cxnChg>
        <pc:cxnChg chg="add mod">
          <ac:chgData name="Hayk Barseghyan" userId="1af3c995-31f7-415e-9aa1-2b36900e994d" providerId="ADAL" clId="{F2E7F468-1AD9-4DAD-9D39-1A9D274F9CE4}" dt="2021-02-12T02:14:50.807" v="183" actId="571"/>
          <ac:cxnSpMkLst>
            <pc:docMk/>
            <pc:sldMk cId="524483127" sldId="651"/>
            <ac:cxnSpMk id="72" creationId="{9EE49E41-9E26-44C9-8F05-399AD8B94CAA}"/>
          </ac:cxnSpMkLst>
        </pc:cxnChg>
        <pc:cxnChg chg="add mod">
          <ac:chgData name="Hayk Barseghyan" userId="1af3c995-31f7-415e-9aa1-2b36900e994d" providerId="ADAL" clId="{F2E7F468-1AD9-4DAD-9D39-1A9D274F9CE4}" dt="2021-02-12T02:23:19.908" v="365" actId="1035"/>
          <ac:cxnSpMkLst>
            <pc:docMk/>
            <pc:sldMk cId="524483127" sldId="651"/>
            <ac:cxnSpMk id="95" creationId="{5EB10151-CF0F-4162-A03A-2FB4661DCBE8}"/>
          </ac:cxnSpMkLst>
        </pc:cxnChg>
      </pc:sldChg>
      <pc:sldChg chg="addSp delSp modSp mod">
        <pc:chgData name="Hayk Barseghyan" userId="1af3c995-31f7-415e-9aa1-2b36900e994d" providerId="ADAL" clId="{F2E7F468-1AD9-4DAD-9D39-1A9D274F9CE4}" dt="2021-02-12T04:46:34.102" v="640" actId="14100"/>
        <pc:sldMkLst>
          <pc:docMk/>
          <pc:sldMk cId="779035963" sldId="652"/>
        </pc:sldMkLst>
        <pc:spChg chg="add mod">
          <ac:chgData name="Hayk Barseghyan" userId="1af3c995-31f7-415e-9aa1-2b36900e994d" providerId="ADAL" clId="{F2E7F468-1AD9-4DAD-9D39-1A9D274F9CE4}" dt="2021-02-12T04:46:28.497" v="639" actId="164"/>
          <ac:spMkLst>
            <pc:docMk/>
            <pc:sldMk cId="779035963" sldId="652"/>
            <ac:spMk id="12" creationId="{1D62726D-D640-4D16-A00D-0156315EC567}"/>
          </ac:spMkLst>
        </pc:spChg>
        <pc:spChg chg="add mod">
          <ac:chgData name="Hayk Barseghyan" userId="1af3c995-31f7-415e-9aa1-2b36900e994d" providerId="ADAL" clId="{F2E7F468-1AD9-4DAD-9D39-1A9D274F9CE4}" dt="2021-02-12T04:46:28.497" v="639" actId="164"/>
          <ac:spMkLst>
            <pc:docMk/>
            <pc:sldMk cId="779035963" sldId="652"/>
            <ac:spMk id="15" creationId="{423D3002-2561-4B5D-B27B-8A6A1CBD1CE2}"/>
          </ac:spMkLst>
        </pc:spChg>
        <pc:grpChg chg="add mod">
          <ac:chgData name="Hayk Barseghyan" userId="1af3c995-31f7-415e-9aa1-2b36900e994d" providerId="ADAL" clId="{F2E7F468-1AD9-4DAD-9D39-1A9D274F9CE4}" dt="2021-02-12T04:46:34.102" v="640" actId="14100"/>
          <ac:grpSpMkLst>
            <pc:docMk/>
            <pc:sldMk cId="779035963" sldId="652"/>
            <ac:grpSpMk id="13" creationId="{9E4D9DAB-6CD3-4E3F-8EF2-046DE94E8069}"/>
          </ac:grpSpMkLst>
        </pc:grpChg>
        <pc:picChg chg="add del mod">
          <ac:chgData name="Hayk Barseghyan" userId="1af3c995-31f7-415e-9aa1-2b36900e994d" providerId="ADAL" clId="{F2E7F468-1AD9-4DAD-9D39-1A9D274F9CE4}" dt="2021-02-12T04:42:26.374" v="612" actId="478"/>
          <ac:picMkLst>
            <pc:docMk/>
            <pc:sldMk cId="779035963" sldId="652"/>
            <ac:picMk id="3" creationId="{05AFA900-6DE8-48D7-993B-89030ABAE6D3}"/>
          </ac:picMkLst>
        </pc:picChg>
        <pc:picChg chg="add mod">
          <ac:chgData name="Hayk Barseghyan" userId="1af3c995-31f7-415e-9aa1-2b36900e994d" providerId="ADAL" clId="{F2E7F468-1AD9-4DAD-9D39-1A9D274F9CE4}" dt="2021-02-12T04:46:28.497" v="639" actId="164"/>
          <ac:picMkLst>
            <pc:docMk/>
            <pc:sldMk cId="779035963" sldId="652"/>
            <ac:picMk id="5" creationId="{F62AFEDA-F03C-4F83-9592-97ADDA57189B}"/>
          </ac:picMkLst>
        </pc:picChg>
        <pc:picChg chg="mod">
          <ac:chgData name="Hayk Barseghyan" userId="1af3c995-31f7-415e-9aa1-2b36900e994d" providerId="ADAL" clId="{F2E7F468-1AD9-4DAD-9D39-1A9D274F9CE4}" dt="2021-02-12T04:42:32.284" v="613" actId="1076"/>
          <ac:picMkLst>
            <pc:docMk/>
            <pc:sldMk cId="779035963" sldId="652"/>
            <ac:picMk id="6" creationId="{29673125-500E-43F5-B58F-69DE183A953F}"/>
          </ac:picMkLst>
        </pc:picChg>
        <pc:picChg chg="add del mod">
          <ac:chgData name="Hayk Barseghyan" userId="1af3c995-31f7-415e-9aa1-2b36900e994d" providerId="ADAL" clId="{F2E7F468-1AD9-4DAD-9D39-1A9D274F9CE4}" dt="2021-02-12T04:44:03.411" v="622" actId="478"/>
          <ac:picMkLst>
            <pc:docMk/>
            <pc:sldMk cId="779035963" sldId="652"/>
            <ac:picMk id="8" creationId="{C9C6C681-18AB-4E37-80C3-9E5613441EA3}"/>
          </ac:picMkLst>
        </pc:picChg>
        <pc:picChg chg="add mod">
          <ac:chgData name="Hayk Barseghyan" userId="1af3c995-31f7-415e-9aa1-2b36900e994d" providerId="ADAL" clId="{F2E7F468-1AD9-4DAD-9D39-1A9D274F9CE4}" dt="2021-02-12T04:46:28.497" v="639" actId="164"/>
          <ac:picMkLst>
            <pc:docMk/>
            <pc:sldMk cId="779035963" sldId="652"/>
            <ac:picMk id="10" creationId="{2D7AE0BF-D10F-4421-9A93-3EA1251EFACF}"/>
          </ac:picMkLst>
        </pc:picChg>
        <pc:picChg chg="mod">
          <ac:chgData name="Hayk Barseghyan" userId="1af3c995-31f7-415e-9aa1-2b36900e994d" providerId="ADAL" clId="{F2E7F468-1AD9-4DAD-9D39-1A9D274F9CE4}" dt="2021-02-12T04:42:38.942" v="615" actId="1076"/>
          <ac:picMkLst>
            <pc:docMk/>
            <pc:sldMk cId="779035963" sldId="652"/>
            <ac:picMk id="11" creationId="{93BCB08C-5D80-4873-BCE0-EE955C255779}"/>
          </ac:picMkLst>
        </pc:picChg>
        <pc:picChg chg="mod">
          <ac:chgData name="Hayk Barseghyan" userId="1af3c995-31f7-415e-9aa1-2b36900e994d" providerId="ADAL" clId="{F2E7F468-1AD9-4DAD-9D39-1A9D274F9CE4}" dt="2021-02-12T04:42:32.284" v="613" actId="1076"/>
          <ac:picMkLst>
            <pc:docMk/>
            <pc:sldMk cId="779035963" sldId="652"/>
            <ac:picMk id="17" creationId="{B156458E-E13E-4479-9FE5-90D11C044CE8}"/>
          </ac:picMkLst>
        </pc:picChg>
        <pc:picChg chg="mod">
          <ac:chgData name="Hayk Barseghyan" userId="1af3c995-31f7-415e-9aa1-2b36900e994d" providerId="ADAL" clId="{F2E7F468-1AD9-4DAD-9D39-1A9D274F9CE4}" dt="2021-02-12T04:42:32.284" v="613" actId="1076"/>
          <ac:picMkLst>
            <pc:docMk/>
            <pc:sldMk cId="779035963" sldId="652"/>
            <ac:picMk id="21" creationId="{6E8C6618-D138-4944-8E6F-18F2105A5E40}"/>
          </ac:picMkLst>
        </pc:picChg>
      </pc:sldChg>
      <pc:sldChg chg="addSp delSp modSp mod">
        <pc:chgData name="Hayk Barseghyan" userId="1af3c995-31f7-415e-9aa1-2b36900e994d" providerId="ADAL" clId="{F2E7F468-1AD9-4DAD-9D39-1A9D274F9CE4}" dt="2021-02-23T02:23:19.295" v="937" actId="166"/>
        <pc:sldMkLst>
          <pc:docMk/>
          <pc:sldMk cId="827945534" sldId="654"/>
        </pc:sldMkLst>
        <pc:spChg chg="mod">
          <ac:chgData name="Hayk Barseghyan" userId="1af3c995-31f7-415e-9aa1-2b36900e994d" providerId="ADAL" clId="{F2E7F468-1AD9-4DAD-9D39-1A9D274F9CE4}" dt="2021-02-12T05:56:20.893" v="711" actId="1036"/>
          <ac:spMkLst>
            <pc:docMk/>
            <pc:sldMk cId="827945534" sldId="654"/>
            <ac:spMk id="44" creationId="{0C85C3E2-DE72-4F69-97FD-EE2A64F65902}"/>
          </ac:spMkLst>
        </pc:spChg>
        <pc:spChg chg="mod">
          <ac:chgData name="Hayk Barseghyan" userId="1af3c995-31f7-415e-9aa1-2b36900e994d" providerId="ADAL" clId="{F2E7F468-1AD9-4DAD-9D39-1A9D274F9CE4}" dt="2021-02-12T05:56:20.893" v="711" actId="1036"/>
          <ac:spMkLst>
            <pc:docMk/>
            <pc:sldMk cId="827945534" sldId="654"/>
            <ac:spMk id="50" creationId="{55CD9F97-512F-48BF-9B69-5CDE38C934FC}"/>
          </ac:spMkLst>
        </pc:spChg>
        <pc:spChg chg="mod">
          <ac:chgData name="Hayk Barseghyan" userId="1af3c995-31f7-415e-9aa1-2b36900e994d" providerId="ADAL" clId="{F2E7F468-1AD9-4DAD-9D39-1A9D274F9CE4}" dt="2021-02-12T05:56:20.893" v="711" actId="1036"/>
          <ac:spMkLst>
            <pc:docMk/>
            <pc:sldMk cId="827945534" sldId="654"/>
            <ac:spMk id="51" creationId="{AC3B91D7-FF9B-4988-9E6B-EAD51DD2DF4F}"/>
          </ac:spMkLst>
        </pc:spChg>
        <pc:spChg chg="mod ord">
          <ac:chgData name="Hayk Barseghyan" userId="1af3c995-31f7-415e-9aa1-2b36900e994d" providerId="ADAL" clId="{F2E7F468-1AD9-4DAD-9D39-1A9D274F9CE4}" dt="2021-02-23T02:23:19.295" v="937" actId="166"/>
          <ac:spMkLst>
            <pc:docMk/>
            <pc:sldMk cId="827945534" sldId="654"/>
            <ac:spMk id="52" creationId="{3C4CF752-D100-4648-B7BC-5DB3FB658991}"/>
          </ac:spMkLst>
        </pc:spChg>
        <pc:spChg chg="add mod">
          <ac:chgData name="Hayk Barseghyan" userId="1af3c995-31f7-415e-9aa1-2b36900e994d" providerId="ADAL" clId="{F2E7F468-1AD9-4DAD-9D39-1A9D274F9CE4}" dt="2021-02-12T04:31:02.522" v="378" actId="1076"/>
          <ac:spMkLst>
            <pc:docMk/>
            <pc:sldMk cId="827945534" sldId="654"/>
            <ac:spMk id="53" creationId="{68B00FA6-B8FE-4BDC-965F-134174286DD9}"/>
          </ac:spMkLst>
        </pc:spChg>
        <pc:spChg chg="add mod">
          <ac:chgData name="Hayk Barseghyan" userId="1af3c995-31f7-415e-9aa1-2b36900e994d" providerId="ADAL" clId="{F2E7F468-1AD9-4DAD-9D39-1A9D274F9CE4}" dt="2021-02-12T04:31:02.522" v="378" actId="1076"/>
          <ac:spMkLst>
            <pc:docMk/>
            <pc:sldMk cId="827945534" sldId="654"/>
            <ac:spMk id="54" creationId="{E863B169-6BF6-4624-A891-6B3C9852B628}"/>
          </ac:spMkLst>
        </pc:spChg>
        <pc:spChg chg="add mod">
          <ac:chgData name="Hayk Barseghyan" userId="1af3c995-31f7-415e-9aa1-2b36900e994d" providerId="ADAL" clId="{F2E7F468-1AD9-4DAD-9D39-1A9D274F9CE4}" dt="2021-02-12T04:48:12.829" v="685" actId="208"/>
          <ac:spMkLst>
            <pc:docMk/>
            <pc:sldMk cId="827945534" sldId="654"/>
            <ac:spMk id="55" creationId="{07D69AF5-89C5-4D08-90B5-12B866765EE3}"/>
          </ac:spMkLst>
        </pc:spChg>
        <pc:spChg chg="mod">
          <ac:chgData name="Hayk Barseghyan" userId="1af3c995-31f7-415e-9aa1-2b36900e994d" providerId="ADAL" clId="{F2E7F468-1AD9-4DAD-9D39-1A9D274F9CE4}" dt="2021-02-12T04:47:26.923" v="667" actId="1035"/>
          <ac:spMkLst>
            <pc:docMk/>
            <pc:sldMk cId="827945534" sldId="654"/>
            <ac:spMk id="69" creationId="{E1E5F7CF-BD53-4D18-9581-71C86B5CC80B}"/>
          </ac:spMkLst>
        </pc:spChg>
        <pc:spChg chg="mod">
          <ac:chgData name="Hayk Barseghyan" userId="1af3c995-31f7-415e-9aa1-2b36900e994d" providerId="ADAL" clId="{F2E7F468-1AD9-4DAD-9D39-1A9D274F9CE4}" dt="2021-02-12T04:47:31.901" v="682" actId="1036"/>
          <ac:spMkLst>
            <pc:docMk/>
            <pc:sldMk cId="827945534" sldId="654"/>
            <ac:spMk id="70" creationId="{C130D79F-13B5-4C92-B80F-4EB8B3100D47}"/>
          </ac:spMkLst>
        </pc:spChg>
        <pc:spChg chg="del mod">
          <ac:chgData name="Hayk Barseghyan" userId="1af3c995-31f7-415e-9aa1-2b36900e994d" providerId="ADAL" clId="{F2E7F468-1AD9-4DAD-9D39-1A9D274F9CE4}" dt="2021-02-12T04:39:47.035" v="604" actId="478"/>
          <ac:spMkLst>
            <pc:docMk/>
            <pc:sldMk cId="827945534" sldId="654"/>
            <ac:spMk id="71" creationId="{7C476E1B-D9EF-4520-BE3C-FE0C57ADB6CB}"/>
          </ac:spMkLst>
        </pc:spChg>
        <pc:spChg chg="mod">
          <ac:chgData name="Hayk Barseghyan" userId="1af3c995-31f7-415e-9aa1-2b36900e994d" providerId="ADAL" clId="{F2E7F468-1AD9-4DAD-9D39-1A9D274F9CE4}" dt="2021-02-12T04:32:44.695" v="395"/>
          <ac:spMkLst>
            <pc:docMk/>
            <pc:sldMk cId="827945534" sldId="654"/>
            <ac:spMk id="76" creationId="{1C554B34-C002-4DB1-8784-4B391E209899}"/>
          </ac:spMkLst>
        </pc:spChg>
        <pc:spChg chg="mod">
          <ac:chgData name="Hayk Barseghyan" userId="1af3c995-31f7-415e-9aa1-2b36900e994d" providerId="ADAL" clId="{F2E7F468-1AD9-4DAD-9D39-1A9D274F9CE4}" dt="2021-02-12T04:32:44.695" v="395"/>
          <ac:spMkLst>
            <pc:docMk/>
            <pc:sldMk cId="827945534" sldId="654"/>
            <ac:spMk id="86" creationId="{88884125-F75C-4D8B-80D0-8186E9D62A91}"/>
          </ac:spMkLst>
        </pc:spChg>
        <pc:spChg chg="mod">
          <ac:chgData name="Hayk Barseghyan" userId="1af3c995-31f7-415e-9aa1-2b36900e994d" providerId="ADAL" clId="{F2E7F468-1AD9-4DAD-9D39-1A9D274F9CE4}" dt="2021-02-12T04:32:44.695" v="395"/>
          <ac:spMkLst>
            <pc:docMk/>
            <pc:sldMk cId="827945534" sldId="654"/>
            <ac:spMk id="89" creationId="{73E0F48C-F069-413E-8BDC-0DEC675D822E}"/>
          </ac:spMkLst>
        </pc:spChg>
        <pc:spChg chg="mod">
          <ac:chgData name="Hayk Barseghyan" userId="1af3c995-31f7-415e-9aa1-2b36900e994d" providerId="ADAL" clId="{F2E7F468-1AD9-4DAD-9D39-1A9D274F9CE4}" dt="2021-02-12T04:32:44.695" v="395"/>
          <ac:spMkLst>
            <pc:docMk/>
            <pc:sldMk cId="827945534" sldId="654"/>
            <ac:spMk id="90" creationId="{413DD0F0-9162-4A06-A57F-A2B4EFE8B4A8}"/>
          </ac:spMkLst>
        </pc:spChg>
        <pc:spChg chg="mod">
          <ac:chgData name="Hayk Barseghyan" userId="1af3c995-31f7-415e-9aa1-2b36900e994d" providerId="ADAL" clId="{F2E7F468-1AD9-4DAD-9D39-1A9D274F9CE4}" dt="2021-02-12T04:37:02.143" v="578" actId="1038"/>
          <ac:spMkLst>
            <pc:docMk/>
            <pc:sldMk cId="827945534" sldId="654"/>
            <ac:spMk id="92" creationId="{A7923036-41CC-45E7-87FE-8526B7B8123C}"/>
          </ac:spMkLst>
        </pc:spChg>
        <pc:spChg chg="mod">
          <ac:chgData name="Hayk Barseghyan" userId="1af3c995-31f7-415e-9aa1-2b36900e994d" providerId="ADAL" clId="{F2E7F468-1AD9-4DAD-9D39-1A9D274F9CE4}" dt="2021-02-12T04:36:57.949" v="565" actId="1038"/>
          <ac:spMkLst>
            <pc:docMk/>
            <pc:sldMk cId="827945534" sldId="654"/>
            <ac:spMk id="93" creationId="{2002BCC4-A7D6-4550-844A-2D78A9481393}"/>
          </ac:spMkLst>
        </pc:spChg>
        <pc:spChg chg="mod">
          <ac:chgData name="Hayk Barseghyan" userId="1af3c995-31f7-415e-9aa1-2b36900e994d" providerId="ADAL" clId="{F2E7F468-1AD9-4DAD-9D39-1A9D274F9CE4}" dt="2021-02-12T04:32:44.695" v="395"/>
          <ac:spMkLst>
            <pc:docMk/>
            <pc:sldMk cId="827945534" sldId="654"/>
            <ac:spMk id="101" creationId="{C9248449-982F-4C60-8168-07A673D9C059}"/>
          </ac:spMkLst>
        </pc:spChg>
        <pc:spChg chg="del">
          <ac:chgData name="Hayk Barseghyan" userId="1af3c995-31f7-415e-9aa1-2b36900e994d" providerId="ADAL" clId="{F2E7F468-1AD9-4DAD-9D39-1A9D274F9CE4}" dt="2021-02-12T01:22:17.118" v="38" actId="478"/>
          <ac:spMkLst>
            <pc:docMk/>
            <pc:sldMk cId="827945534" sldId="654"/>
            <ac:spMk id="108" creationId="{259FC43F-09D6-43C3-AA81-1690713F7632}"/>
          </ac:spMkLst>
        </pc:spChg>
        <pc:spChg chg="del">
          <ac:chgData name="Hayk Barseghyan" userId="1af3c995-31f7-415e-9aa1-2b36900e994d" providerId="ADAL" clId="{F2E7F468-1AD9-4DAD-9D39-1A9D274F9CE4}" dt="2021-02-12T01:22:17.118" v="38" actId="478"/>
          <ac:spMkLst>
            <pc:docMk/>
            <pc:sldMk cId="827945534" sldId="654"/>
            <ac:spMk id="110" creationId="{C9BF5608-8FA5-4E0E-8EC7-4C89C8050A07}"/>
          </ac:spMkLst>
        </pc:spChg>
        <pc:spChg chg="del">
          <ac:chgData name="Hayk Barseghyan" userId="1af3c995-31f7-415e-9aa1-2b36900e994d" providerId="ADAL" clId="{F2E7F468-1AD9-4DAD-9D39-1A9D274F9CE4}" dt="2021-02-12T01:22:17.118" v="38" actId="478"/>
          <ac:spMkLst>
            <pc:docMk/>
            <pc:sldMk cId="827945534" sldId="654"/>
            <ac:spMk id="111" creationId="{7D458B18-8E57-4E9D-BB87-1AA20127D901}"/>
          </ac:spMkLst>
        </pc:spChg>
        <pc:spChg chg="mod">
          <ac:chgData name="Hayk Barseghyan" userId="1af3c995-31f7-415e-9aa1-2b36900e994d" providerId="ADAL" clId="{F2E7F468-1AD9-4DAD-9D39-1A9D274F9CE4}" dt="2021-02-12T04:46:42.691" v="641"/>
          <ac:spMkLst>
            <pc:docMk/>
            <pc:sldMk cId="827945534" sldId="654"/>
            <ac:spMk id="114" creationId="{B69FEA02-3931-436D-B542-691B9B88E7E3}"/>
          </ac:spMkLst>
        </pc:spChg>
        <pc:spChg chg="mod">
          <ac:chgData name="Hayk Barseghyan" userId="1af3c995-31f7-415e-9aa1-2b36900e994d" providerId="ADAL" clId="{F2E7F468-1AD9-4DAD-9D39-1A9D274F9CE4}" dt="2021-02-12T04:46:42.691" v="641"/>
          <ac:spMkLst>
            <pc:docMk/>
            <pc:sldMk cId="827945534" sldId="654"/>
            <ac:spMk id="116" creationId="{90305681-79DA-4EB7-AA46-A01F61BD0AB3}"/>
          </ac:spMkLst>
        </pc:spChg>
        <pc:spChg chg="add mod">
          <ac:chgData name="Hayk Barseghyan" userId="1af3c995-31f7-415e-9aa1-2b36900e994d" providerId="ADAL" clId="{F2E7F468-1AD9-4DAD-9D39-1A9D274F9CE4}" dt="2021-02-12T05:57:31.714" v="761" actId="1076"/>
          <ac:spMkLst>
            <pc:docMk/>
            <pc:sldMk cId="827945534" sldId="654"/>
            <ac:spMk id="117" creationId="{AE5BBEBF-EB2C-498D-9B80-53D0F5A0D595}"/>
          </ac:spMkLst>
        </pc:spChg>
        <pc:spChg chg="add mod">
          <ac:chgData name="Hayk Barseghyan" userId="1af3c995-31f7-415e-9aa1-2b36900e994d" providerId="ADAL" clId="{F2E7F468-1AD9-4DAD-9D39-1A9D274F9CE4}" dt="2021-02-12T06:09:42.473" v="797" actId="1076"/>
          <ac:spMkLst>
            <pc:docMk/>
            <pc:sldMk cId="827945534" sldId="654"/>
            <ac:spMk id="118" creationId="{066264C0-0B22-4722-A2BA-8C702062244E}"/>
          </ac:spMkLst>
        </pc:spChg>
        <pc:grpChg chg="add mod">
          <ac:chgData name="Hayk Barseghyan" userId="1af3c995-31f7-415e-9aa1-2b36900e994d" providerId="ADAL" clId="{F2E7F468-1AD9-4DAD-9D39-1A9D274F9CE4}" dt="2021-02-12T04:32:44.695" v="395"/>
          <ac:grpSpMkLst>
            <pc:docMk/>
            <pc:sldMk cId="827945534" sldId="654"/>
            <ac:grpSpMk id="63" creationId="{EF2C7A10-0284-41A0-BC17-809962B03E09}"/>
          </ac:grpSpMkLst>
        </pc:grpChg>
        <pc:grpChg chg="add mod">
          <ac:chgData name="Hayk Barseghyan" userId="1af3c995-31f7-415e-9aa1-2b36900e994d" providerId="ADAL" clId="{F2E7F468-1AD9-4DAD-9D39-1A9D274F9CE4}" dt="2021-02-12T04:36:19.814" v="525" actId="1076"/>
          <ac:grpSpMkLst>
            <pc:docMk/>
            <pc:sldMk cId="827945534" sldId="654"/>
            <ac:grpSpMk id="77" creationId="{44803872-5E86-449C-8096-E1A8CF55BF75}"/>
          </ac:grpSpMkLst>
        </pc:grpChg>
        <pc:grpChg chg="del">
          <ac:chgData name="Hayk Barseghyan" userId="1af3c995-31f7-415e-9aa1-2b36900e994d" providerId="ADAL" clId="{F2E7F468-1AD9-4DAD-9D39-1A9D274F9CE4}" dt="2021-02-12T01:22:18.683" v="40" actId="478"/>
          <ac:grpSpMkLst>
            <pc:docMk/>
            <pc:sldMk cId="827945534" sldId="654"/>
            <ac:grpSpMk id="85" creationId="{557AE439-D02F-4A9D-9266-BB65A8EAA5EC}"/>
          </ac:grpSpMkLst>
        </pc:grpChg>
        <pc:grpChg chg="add mod">
          <ac:chgData name="Hayk Barseghyan" userId="1af3c995-31f7-415e-9aa1-2b36900e994d" providerId="ADAL" clId="{F2E7F468-1AD9-4DAD-9D39-1A9D274F9CE4}" dt="2021-02-12T04:47:12.071" v="647" actId="1076"/>
          <ac:grpSpMkLst>
            <pc:docMk/>
            <pc:sldMk cId="827945534" sldId="654"/>
            <ac:grpSpMk id="103" creationId="{6092B2D2-FD47-4DE2-B1C8-277AEE662DB1}"/>
          </ac:grpSpMkLst>
        </pc:grpChg>
        <pc:grpChg chg="del">
          <ac:chgData name="Hayk Barseghyan" userId="1af3c995-31f7-415e-9aa1-2b36900e994d" providerId="ADAL" clId="{F2E7F468-1AD9-4DAD-9D39-1A9D274F9CE4}" dt="2021-02-12T01:22:18.063" v="39" actId="478"/>
          <ac:grpSpMkLst>
            <pc:docMk/>
            <pc:sldMk cId="827945534" sldId="654"/>
            <ac:grpSpMk id="105" creationId="{A554AF4F-F2EC-499E-AD80-B9AFE5FE56A6}"/>
          </ac:grpSpMkLst>
        </pc:grpChg>
        <pc:grpChg chg="del">
          <ac:chgData name="Hayk Barseghyan" userId="1af3c995-31f7-415e-9aa1-2b36900e994d" providerId="ADAL" clId="{F2E7F468-1AD9-4DAD-9D39-1A9D274F9CE4}" dt="2021-02-12T01:22:11.173" v="34" actId="478"/>
          <ac:grpSpMkLst>
            <pc:docMk/>
            <pc:sldMk cId="827945534" sldId="654"/>
            <ac:grpSpMk id="106" creationId="{FB70DBDB-EC7B-45C1-BCD2-EEC48EF9C8C3}"/>
          </ac:grpSpMkLst>
        </pc:grpChg>
        <pc:picChg chg="add mod">
          <ac:chgData name="Hayk Barseghyan" userId="1af3c995-31f7-415e-9aa1-2b36900e994d" providerId="ADAL" clId="{F2E7F468-1AD9-4DAD-9D39-1A9D274F9CE4}" dt="2021-02-12T04:30:50.606" v="376" actId="1076"/>
          <ac:picMkLst>
            <pc:docMk/>
            <pc:sldMk cId="827945534" sldId="654"/>
            <ac:picMk id="3" creationId="{8D3A5F37-3DE6-4371-B224-FA7A789D2484}"/>
          </ac:picMkLst>
        </pc:picChg>
        <pc:picChg chg="add mod ord">
          <ac:chgData name="Hayk Barseghyan" userId="1af3c995-31f7-415e-9aa1-2b36900e994d" providerId="ADAL" clId="{F2E7F468-1AD9-4DAD-9D39-1A9D274F9CE4}" dt="2021-02-12T04:35:28.804" v="422" actId="1038"/>
          <ac:picMkLst>
            <pc:docMk/>
            <pc:sldMk cId="827945534" sldId="654"/>
            <ac:picMk id="17" creationId="{1EDA1680-38DE-45AC-BAB3-51091D58A59D}"/>
          </ac:picMkLst>
        </pc:picChg>
        <pc:picChg chg="add mod">
          <ac:chgData name="Hayk Barseghyan" userId="1af3c995-31f7-415e-9aa1-2b36900e994d" providerId="ADAL" clId="{F2E7F468-1AD9-4DAD-9D39-1A9D274F9CE4}" dt="2021-02-12T06:05:10.955" v="764" actId="14100"/>
          <ac:picMkLst>
            <pc:docMk/>
            <pc:sldMk cId="827945534" sldId="654"/>
            <ac:picMk id="22" creationId="{7E5880E1-FE4E-4149-9D74-A8668402A859}"/>
          </ac:picMkLst>
        </pc:picChg>
        <pc:picChg chg="add del mod">
          <ac:chgData name="Hayk Barseghyan" userId="1af3c995-31f7-415e-9aa1-2b36900e994d" providerId="ADAL" clId="{F2E7F468-1AD9-4DAD-9D39-1A9D274F9CE4}" dt="2021-02-12T05:56:20.893" v="711" actId="1036"/>
          <ac:picMkLst>
            <pc:docMk/>
            <pc:sldMk cId="827945534" sldId="654"/>
            <ac:picMk id="47" creationId="{67DEB9C8-1071-4239-A286-985511548301}"/>
          </ac:picMkLst>
        </pc:picChg>
        <pc:picChg chg="del mod">
          <ac:chgData name="Hayk Barseghyan" userId="1af3c995-31f7-415e-9aa1-2b36900e994d" providerId="ADAL" clId="{F2E7F468-1AD9-4DAD-9D39-1A9D274F9CE4}" dt="2021-02-12T04:39:38.440" v="603" actId="478"/>
          <ac:picMkLst>
            <pc:docMk/>
            <pc:sldMk cId="827945534" sldId="654"/>
            <ac:picMk id="64" creationId="{E71E56C5-EA72-4956-BA22-A703E2B36897}"/>
          </ac:picMkLst>
        </pc:picChg>
        <pc:picChg chg="del mod">
          <ac:chgData name="Hayk Barseghyan" userId="1af3c995-31f7-415e-9aa1-2b36900e994d" providerId="ADAL" clId="{F2E7F468-1AD9-4DAD-9D39-1A9D274F9CE4}" dt="2021-02-12T04:39:36.477" v="602" actId="478"/>
          <ac:picMkLst>
            <pc:docMk/>
            <pc:sldMk cId="827945534" sldId="654"/>
            <ac:picMk id="65" creationId="{3A11F57E-FE65-4FC4-AD46-FDD648CB8BA1}"/>
          </ac:picMkLst>
        </pc:picChg>
        <pc:picChg chg="del mod">
          <ac:chgData name="Hayk Barseghyan" userId="1af3c995-31f7-415e-9aa1-2b36900e994d" providerId="ADAL" clId="{F2E7F468-1AD9-4DAD-9D39-1A9D274F9CE4}" dt="2021-02-12T04:33:00.008" v="396" actId="478"/>
          <ac:picMkLst>
            <pc:docMk/>
            <pc:sldMk cId="827945534" sldId="654"/>
            <ac:picMk id="80" creationId="{0047D878-8927-4782-8923-985C517EA007}"/>
          </ac:picMkLst>
        </pc:picChg>
        <pc:picChg chg="mod">
          <ac:chgData name="Hayk Barseghyan" userId="1af3c995-31f7-415e-9aa1-2b36900e994d" providerId="ADAL" clId="{F2E7F468-1AD9-4DAD-9D39-1A9D274F9CE4}" dt="2021-02-12T04:47:16.532" v="655" actId="1035"/>
          <ac:picMkLst>
            <pc:docMk/>
            <pc:sldMk cId="827945534" sldId="654"/>
            <ac:picMk id="109" creationId="{7BA3D14B-546C-4516-9B98-9B9CCF333258}"/>
          </ac:picMkLst>
        </pc:picChg>
        <pc:picChg chg="mod">
          <ac:chgData name="Hayk Barseghyan" userId="1af3c995-31f7-415e-9aa1-2b36900e994d" providerId="ADAL" clId="{F2E7F468-1AD9-4DAD-9D39-1A9D274F9CE4}" dt="2021-02-12T04:46:42.691" v="641"/>
          <ac:picMkLst>
            <pc:docMk/>
            <pc:sldMk cId="827945534" sldId="654"/>
            <ac:picMk id="113" creationId="{A04D0DEF-CBBD-47BF-9A58-80E3EDABED7F}"/>
          </ac:picMkLst>
        </pc:picChg>
        <pc:cxnChg chg="del mod">
          <ac:chgData name="Hayk Barseghyan" userId="1af3c995-31f7-415e-9aa1-2b36900e994d" providerId="ADAL" clId="{F2E7F468-1AD9-4DAD-9D39-1A9D274F9CE4}" dt="2021-02-12T01:22:15.733" v="37" actId="478"/>
          <ac:cxnSpMkLst>
            <pc:docMk/>
            <pc:sldMk cId="827945534" sldId="654"/>
            <ac:cxnSpMk id="49" creationId="{D482CA38-14E8-45AF-8202-90566DF01A86}"/>
          </ac:cxnSpMkLst>
        </pc:cxnChg>
        <pc:cxnChg chg="add mod">
          <ac:chgData name="Hayk Barseghyan" userId="1af3c995-31f7-415e-9aa1-2b36900e994d" providerId="ADAL" clId="{F2E7F468-1AD9-4DAD-9D39-1A9D274F9CE4}" dt="2021-02-12T04:48:12.829" v="685" actId="208"/>
          <ac:cxnSpMkLst>
            <pc:docMk/>
            <pc:sldMk cId="827945534" sldId="654"/>
            <ac:cxnSpMk id="56" creationId="{3CFAB489-8807-4BA3-9020-3CC0451293AE}"/>
          </ac:cxnSpMkLst>
        </pc:cxnChg>
        <pc:cxnChg chg="add mod">
          <ac:chgData name="Hayk Barseghyan" userId="1af3c995-31f7-415e-9aa1-2b36900e994d" providerId="ADAL" clId="{F2E7F468-1AD9-4DAD-9D39-1A9D274F9CE4}" dt="2021-02-12T04:48:12.829" v="685" actId="208"/>
          <ac:cxnSpMkLst>
            <pc:docMk/>
            <pc:sldMk cId="827945534" sldId="654"/>
            <ac:cxnSpMk id="57" creationId="{0D4ABBEE-13C4-463C-BDA1-4546744CB24F}"/>
          </ac:cxnSpMkLst>
        </pc:cxnChg>
        <pc:cxnChg chg="del mod">
          <ac:chgData name="Hayk Barseghyan" userId="1af3c995-31f7-415e-9aa1-2b36900e994d" providerId="ADAL" clId="{F2E7F468-1AD9-4DAD-9D39-1A9D274F9CE4}" dt="2021-02-12T04:36:30.563" v="527" actId="478"/>
          <ac:cxnSpMkLst>
            <pc:docMk/>
            <pc:sldMk cId="827945534" sldId="654"/>
            <ac:cxnSpMk id="95" creationId="{A87D24C4-0A4C-4204-B713-DFE711C066DA}"/>
          </ac:cxnSpMkLst>
        </pc:cxnChg>
        <pc:cxnChg chg="del mod">
          <ac:chgData name="Hayk Barseghyan" userId="1af3c995-31f7-415e-9aa1-2b36900e994d" providerId="ADAL" clId="{F2E7F468-1AD9-4DAD-9D39-1A9D274F9CE4}" dt="2021-02-12T04:33:38.955" v="399" actId="478"/>
          <ac:cxnSpMkLst>
            <pc:docMk/>
            <pc:sldMk cId="827945534" sldId="654"/>
            <ac:cxnSpMk id="96" creationId="{005A15E9-0420-460A-82F4-9F300FFDB9DA}"/>
          </ac:cxnSpMkLst>
        </pc:cxnChg>
        <pc:cxnChg chg="mod">
          <ac:chgData name="Hayk Barseghyan" userId="1af3c995-31f7-415e-9aa1-2b36900e994d" providerId="ADAL" clId="{F2E7F468-1AD9-4DAD-9D39-1A9D274F9CE4}" dt="2021-02-12T04:36:15.246" v="523" actId="1037"/>
          <ac:cxnSpMkLst>
            <pc:docMk/>
            <pc:sldMk cId="827945534" sldId="654"/>
            <ac:cxnSpMk id="97" creationId="{BBD9632F-6DAC-454A-87ED-47C5408900EE}"/>
          </ac:cxnSpMkLst>
        </pc:cxnChg>
        <pc:cxnChg chg="del mod">
          <ac:chgData name="Hayk Barseghyan" userId="1af3c995-31f7-415e-9aa1-2b36900e994d" providerId="ADAL" clId="{F2E7F468-1AD9-4DAD-9D39-1A9D274F9CE4}" dt="2021-02-12T04:33:41.865" v="400" actId="478"/>
          <ac:cxnSpMkLst>
            <pc:docMk/>
            <pc:sldMk cId="827945534" sldId="654"/>
            <ac:cxnSpMk id="99" creationId="{857FDE51-71F0-4F73-828E-8DC5FD6AF7C0}"/>
          </ac:cxnSpMkLst>
        </pc:cxnChg>
        <pc:cxnChg chg="add mod">
          <ac:chgData name="Hayk Barseghyan" userId="1af3c995-31f7-415e-9aa1-2b36900e994d" providerId="ADAL" clId="{F2E7F468-1AD9-4DAD-9D39-1A9D274F9CE4}" dt="2021-02-12T04:36:47.783" v="554" actId="1036"/>
          <ac:cxnSpMkLst>
            <pc:docMk/>
            <pc:sldMk cId="827945534" sldId="654"/>
            <ac:cxnSpMk id="102" creationId="{C68D6FCC-99EA-4905-840B-A0BEF455C074}"/>
          </ac:cxnSpMkLst>
        </pc:cxnChg>
        <pc:cxnChg chg="del mod">
          <ac:chgData name="Hayk Barseghyan" userId="1af3c995-31f7-415e-9aa1-2b36900e994d" providerId="ADAL" clId="{F2E7F468-1AD9-4DAD-9D39-1A9D274F9CE4}" dt="2021-02-12T01:22:13.309" v="35" actId="478"/>
          <ac:cxnSpMkLst>
            <pc:docMk/>
            <pc:sldMk cId="827945534" sldId="654"/>
            <ac:cxnSpMk id="112" creationId="{E249D177-7017-436F-A541-3BC956E34475}"/>
          </ac:cxnSpMkLst>
        </pc:cxnChg>
        <pc:cxnChg chg="del mod">
          <ac:chgData name="Hayk Barseghyan" userId="1af3c995-31f7-415e-9aa1-2b36900e994d" providerId="ADAL" clId="{F2E7F468-1AD9-4DAD-9D39-1A9D274F9CE4}" dt="2021-02-12T01:22:14.655" v="36" actId="478"/>
          <ac:cxnSpMkLst>
            <pc:docMk/>
            <pc:sldMk cId="827945534" sldId="654"/>
            <ac:cxnSpMk id="115" creationId="{9FD92BDB-58CD-4458-98F3-99188233AC86}"/>
          </ac:cxnSpMkLst>
        </pc:cxnChg>
      </pc:sldChg>
      <pc:sldChg chg="del">
        <pc:chgData name="Hayk Barseghyan" userId="1af3c995-31f7-415e-9aa1-2b36900e994d" providerId="ADAL" clId="{F2E7F468-1AD9-4DAD-9D39-1A9D274F9CE4}" dt="2021-02-12T05:47:18.225" v="689" actId="47"/>
        <pc:sldMkLst>
          <pc:docMk/>
          <pc:sldMk cId="1106897071" sldId="655"/>
        </pc:sldMkLst>
      </pc:sldChg>
      <pc:sldChg chg="addSp delSp modSp add mod modNotesTx">
        <pc:chgData name="Hayk Barseghyan" userId="1af3c995-31f7-415e-9aa1-2b36900e994d" providerId="ADAL" clId="{F2E7F468-1AD9-4DAD-9D39-1A9D274F9CE4}" dt="2021-02-23T02:24:47.858" v="938" actId="1076"/>
        <pc:sldMkLst>
          <pc:docMk/>
          <pc:sldMk cId="2358330284" sldId="656"/>
        </pc:sldMkLst>
        <pc:spChg chg="add mod">
          <ac:chgData name="Hayk Barseghyan" userId="1af3c995-31f7-415e-9aa1-2b36900e994d" providerId="ADAL" clId="{F2E7F468-1AD9-4DAD-9D39-1A9D274F9CE4}" dt="2021-02-14T17:23:57.196" v="876" actId="1038"/>
          <ac:spMkLst>
            <pc:docMk/>
            <pc:sldMk cId="2358330284" sldId="656"/>
            <ac:spMk id="6" creationId="{DCC070EE-C68A-4F43-9E6D-7528A9F0B5B5}"/>
          </ac:spMkLst>
        </pc:spChg>
        <pc:spChg chg="del">
          <ac:chgData name="Hayk Barseghyan" userId="1af3c995-31f7-415e-9aa1-2b36900e994d" providerId="ADAL" clId="{F2E7F468-1AD9-4DAD-9D39-1A9D274F9CE4}" dt="2021-02-12T01:22:05.503" v="32" actId="478"/>
          <ac:spMkLst>
            <pc:docMk/>
            <pc:sldMk cId="2358330284" sldId="656"/>
            <ac:spMk id="29" creationId="{BF880D0C-7AA2-4DE0-BCB3-74F7E125FD7C}"/>
          </ac:spMkLst>
        </pc:spChg>
        <pc:spChg chg="add mod">
          <ac:chgData name="Hayk Barseghyan" userId="1af3c995-31f7-415e-9aa1-2b36900e994d" providerId="ADAL" clId="{F2E7F468-1AD9-4DAD-9D39-1A9D274F9CE4}" dt="2021-02-14T17:32:12.318" v="927" actId="1076"/>
          <ac:spMkLst>
            <pc:docMk/>
            <pc:sldMk cId="2358330284" sldId="656"/>
            <ac:spMk id="36" creationId="{BDAE001D-E072-435A-B758-31B212FABC51}"/>
          </ac:spMkLst>
        </pc:spChg>
        <pc:spChg chg="add mod">
          <ac:chgData name="Hayk Barseghyan" userId="1af3c995-31f7-415e-9aa1-2b36900e994d" providerId="ADAL" clId="{F2E7F468-1AD9-4DAD-9D39-1A9D274F9CE4}" dt="2021-02-14T17:32:12.318" v="927" actId="1076"/>
          <ac:spMkLst>
            <pc:docMk/>
            <pc:sldMk cId="2358330284" sldId="656"/>
            <ac:spMk id="37" creationId="{DDDBEA59-6657-462C-9E29-C85DC1B003A4}"/>
          </ac:spMkLst>
        </pc:spChg>
        <pc:spChg chg="add mod">
          <ac:chgData name="Hayk Barseghyan" userId="1af3c995-31f7-415e-9aa1-2b36900e994d" providerId="ADAL" clId="{F2E7F468-1AD9-4DAD-9D39-1A9D274F9CE4}" dt="2021-02-14T17:23:57.196" v="876" actId="1038"/>
          <ac:spMkLst>
            <pc:docMk/>
            <pc:sldMk cId="2358330284" sldId="656"/>
            <ac:spMk id="46" creationId="{F12CE94F-9768-4348-9E90-CD072B837C6B}"/>
          </ac:spMkLst>
        </pc:spChg>
        <pc:spChg chg="add mod">
          <ac:chgData name="Hayk Barseghyan" userId="1af3c995-31f7-415e-9aa1-2b36900e994d" providerId="ADAL" clId="{F2E7F468-1AD9-4DAD-9D39-1A9D274F9CE4}" dt="2021-02-14T17:23:57.196" v="876" actId="1038"/>
          <ac:spMkLst>
            <pc:docMk/>
            <pc:sldMk cId="2358330284" sldId="656"/>
            <ac:spMk id="47" creationId="{7706E418-66C6-4F48-9E46-932FB52600F5}"/>
          </ac:spMkLst>
        </pc:spChg>
        <pc:spChg chg="mod">
          <ac:chgData name="Hayk Barseghyan" userId="1af3c995-31f7-415e-9aa1-2b36900e994d" providerId="ADAL" clId="{F2E7F468-1AD9-4DAD-9D39-1A9D274F9CE4}" dt="2021-02-12T01:22:27.163" v="42" actId="20577"/>
          <ac:spMkLst>
            <pc:docMk/>
            <pc:sldMk cId="2358330284" sldId="656"/>
            <ac:spMk id="48" creationId="{A5767109-BE3E-4EBA-BE34-EC7C3FC9B538}"/>
          </ac:spMkLst>
        </pc:spChg>
        <pc:spChg chg="add mod">
          <ac:chgData name="Hayk Barseghyan" userId="1af3c995-31f7-415e-9aa1-2b36900e994d" providerId="ADAL" clId="{F2E7F468-1AD9-4DAD-9D39-1A9D274F9CE4}" dt="2021-02-14T17:23:57.196" v="876" actId="1038"/>
          <ac:spMkLst>
            <pc:docMk/>
            <pc:sldMk cId="2358330284" sldId="656"/>
            <ac:spMk id="50" creationId="{3D4AFFA2-0EB1-479A-8CF2-256D7E2234D4}"/>
          </ac:spMkLst>
        </pc:spChg>
        <pc:spChg chg="add mod">
          <ac:chgData name="Hayk Barseghyan" userId="1af3c995-31f7-415e-9aa1-2b36900e994d" providerId="ADAL" clId="{F2E7F468-1AD9-4DAD-9D39-1A9D274F9CE4}" dt="2021-02-14T17:23:57.196" v="876" actId="1038"/>
          <ac:spMkLst>
            <pc:docMk/>
            <pc:sldMk cId="2358330284" sldId="656"/>
            <ac:spMk id="51" creationId="{462953EC-3CAB-4C48-8219-5F337546FD73}"/>
          </ac:spMkLst>
        </pc:spChg>
        <pc:spChg chg="mod">
          <ac:chgData name="Hayk Barseghyan" userId="1af3c995-31f7-415e-9aa1-2b36900e994d" providerId="ADAL" clId="{F2E7F468-1AD9-4DAD-9D39-1A9D274F9CE4}" dt="2021-02-23T02:24:47.858" v="938" actId="1076"/>
          <ac:spMkLst>
            <pc:docMk/>
            <pc:sldMk cId="2358330284" sldId="656"/>
            <ac:spMk id="52" creationId="{3C4CF752-D100-4648-B7BC-5DB3FB658991}"/>
          </ac:spMkLst>
        </pc:spChg>
        <pc:spChg chg="add mod">
          <ac:chgData name="Hayk Barseghyan" userId="1af3c995-31f7-415e-9aa1-2b36900e994d" providerId="ADAL" clId="{F2E7F468-1AD9-4DAD-9D39-1A9D274F9CE4}" dt="2021-02-14T17:23:57.196" v="876" actId="1038"/>
          <ac:spMkLst>
            <pc:docMk/>
            <pc:sldMk cId="2358330284" sldId="656"/>
            <ac:spMk id="53" creationId="{0EF46C9D-B904-40A9-AD2E-BB09B47D9365}"/>
          </ac:spMkLst>
        </pc:spChg>
        <pc:spChg chg="add mod">
          <ac:chgData name="Hayk Barseghyan" userId="1af3c995-31f7-415e-9aa1-2b36900e994d" providerId="ADAL" clId="{F2E7F468-1AD9-4DAD-9D39-1A9D274F9CE4}" dt="2021-02-14T17:24:02.684" v="877" actId="14100"/>
          <ac:spMkLst>
            <pc:docMk/>
            <pc:sldMk cId="2358330284" sldId="656"/>
            <ac:spMk id="55" creationId="{67E70582-D155-4977-8567-F97FA5196E55}"/>
          </ac:spMkLst>
        </pc:spChg>
        <pc:spChg chg="add mod">
          <ac:chgData name="Hayk Barseghyan" userId="1af3c995-31f7-415e-9aa1-2b36900e994d" providerId="ADAL" clId="{F2E7F468-1AD9-4DAD-9D39-1A9D274F9CE4}" dt="2021-02-14T17:32:05.518" v="926" actId="20577"/>
          <ac:spMkLst>
            <pc:docMk/>
            <pc:sldMk cId="2358330284" sldId="656"/>
            <ac:spMk id="56" creationId="{2AAA84E1-BA7A-4D0D-86A2-FA71C57D9380}"/>
          </ac:spMkLst>
        </pc:spChg>
        <pc:spChg chg="del">
          <ac:chgData name="Hayk Barseghyan" userId="1af3c995-31f7-415e-9aa1-2b36900e994d" providerId="ADAL" clId="{F2E7F468-1AD9-4DAD-9D39-1A9D274F9CE4}" dt="2021-02-12T01:22:07.518" v="33" actId="478"/>
          <ac:spMkLst>
            <pc:docMk/>
            <pc:sldMk cId="2358330284" sldId="656"/>
            <ac:spMk id="107" creationId="{BC0792DA-1127-48FD-A582-05E47E97B134}"/>
          </ac:spMkLst>
        </pc:spChg>
        <pc:grpChg chg="del">
          <ac:chgData name="Hayk Barseghyan" userId="1af3c995-31f7-415e-9aa1-2b36900e994d" providerId="ADAL" clId="{F2E7F468-1AD9-4DAD-9D39-1A9D274F9CE4}" dt="2021-02-12T01:22:02.913" v="31" actId="478"/>
          <ac:grpSpMkLst>
            <pc:docMk/>
            <pc:sldMk cId="2358330284" sldId="656"/>
            <ac:grpSpMk id="10" creationId="{F42BC947-A5E9-40A9-BBF3-A551526EBE7B}"/>
          </ac:grpSpMkLst>
        </pc:grpChg>
        <pc:grpChg chg="del">
          <ac:chgData name="Hayk Barseghyan" userId="1af3c995-31f7-415e-9aa1-2b36900e994d" providerId="ADAL" clId="{F2E7F468-1AD9-4DAD-9D39-1A9D274F9CE4}" dt="2021-02-12T01:22:00.224" v="29" actId="478"/>
          <ac:grpSpMkLst>
            <pc:docMk/>
            <pc:sldMk cId="2358330284" sldId="656"/>
            <ac:grpSpMk id="60" creationId="{4E313384-1C78-459B-BB63-90009F44FF76}"/>
          </ac:grpSpMkLst>
        </pc:grpChg>
        <pc:picChg chg="add mod ord">
          <ac:chgData name="Hayk Barseghyan" userId="1af3c995-31f7-415e-9aa1-2b36900e994d" providerId="ADAL" clId="{F2E7F468-1AD9-4DAD-9D39-1A9D274F9CE4}" dt="2021-02-14T17:32:02.238" v="925" actId="1076"/>
          <ac:picMkLst>
            <pc:docMk/>
            <pc:sldMk cId="2358330284" sldId="656"/>
            <ac:picMk id="35" creationId="{597C9DC4-AFB7-4810-9147-66C314D6BDBF}"/>
          </ac:picMkLst>
        </pc:picChg>
        <pc:picChg chg="add del mod">
          <ac:chgData name="Hayk Barseghyan" userId="1af3c995-31f7-415e-9aa1-2b36900e994d" providerId="ADAL" clId="{F2E7F468-1AD9-4DAD-9D39-1A9D274F9CE4}" dt="2021-02-14T17:20:04.570" v="822" actId="21"/>
          <ac:picMkLst>
            <pc:docMk/>
            <pc:sldMk cId="2358330284" sldId="656"/>
            <ac:picMk id="40" creationId="{0330A404-AE04-4502-B2BB-9B2E6B64BAE5}"/>
          </ac:picMkLst>
        </pc:picChg>
        <pc:picChg chg="add mod">
          <ac:chgData name="Hayk Barseghyan" userId="1af3c995-31f7-415e-9aa1-2b36900e994d" providerId="ADAL" clId="{F2E7F468-1AD9-4DAD-9D39-1A9D274F9CE4}" dt="2021-02-14T17:23:57.196" v="876" actId="1038"/>
          <ac:picMkLst>
            <pc:docMk/>
            <pc:sldMk cId="2358330284" sldId="656"/>
            <ac:picMk id="41" creationId="{C4828305-CE52-4BA4-9E44-3E3868CB3F25}"/>
          </ac:picMkLst>
        </pc:picChg>
        <pc:picChg chg="add mod">
          <ac:chgData name="Hayk Barseghyan" userId="1af3c995-31f7-415e-9aa1-2b36900e994d" providerId="ADAL" clId="{F2E7F468-1AD9-4DAD-9D39-1A9D274F9CE4}" dt="2021-02-14T17:23:57.196" v="876" actId="1038"/>
          <ac:picMkLst>
            <pc:docMk/>
            <pc:sldMk cId="2358330284" sldId="656"/>
            <ac:picMk id="54" creationId="{46E4ED50-9DC1-484D-9F24-CCAA96DB7FAB}"/>
          </ac:picMkLst>
        </pc:picChg>
        <pc:cxnChg chg="del mod">
          <ac:chgData name="Hayk Barseghyan" userId="1af3c995-31f7-415e-9aa1-2b36900e994d" providerId="ADAL" clId="{F2E7F468-1AD9-4DAD-9D39-1A9D274F9CE4}" dt="2021-02-12T01:22:01.720" v="30" actId="478"/>
          <ac:cxnSpMkLst>
            <pc:docMk/>
            <pc:sldMk cId="2358330284" sldId="656"/>
            <ac:cxnSpMk id="12" creationId="{77BFB2D3-AD99-4A46-A69B-5F7DA3AE9F40}"/>
          </ac:cxnSpMkLst>
        </pc:cxnChg>
        <pc:cxnChg chg="add mod ord">
          <ac:chgData name="Hayk Barseghyan" userId="1af3c995-31f7-415e-9aa1-2b36900e994d" providerId="ADAL" clId="{F2E7F468-1AD9-4DAD-9D39-1A9D274F9CE4}" dt="2021-02-14T17:32:21.820" v="928" actId="14100"/>
          <ac:cxnSpMkLst>
            <pc:docMk/>
            <pc:sldMk cId="2358330284" sldId="656"/>
            <ac:cxnSpMk id="38" creationId="{280E1CA7-8E28-40EC-9556-AAD471D255E8}"/>
          </ac:cxnSpMkLst>
        </pc:cxnChg>
      </pc:sldChg>
      <pc:sldChg chg="addSp delSp modSp new mod">
        <pc:chgData name="Hayk Barseghyan" userId="1af3c995-31f7-415e-9aa1-2b36900e994d" providerId="ADAL" clId="{F2E7F468-1AD9-4DAD-9D39-1A9D274F9CE4}" dt="2021-02-14T17:20:35.051" v="829" actId="1076"/>
        <pc:sldMkLst>
          <pc:docMk/>
          <pc:sldMk cId="2214109847" sldId="4371"/>
        </pc:sldMkLst>
        <pc:spChg chg="del">
          <ac:chgData name="Hayk Barseghyan" userId="1af3c995-31f7-415e-9aa1-2b36900e994d" providerId="ADAL" clId="{F2E7F468-1AD9-4DAD-9D39-1A9D274F9CE4}" dt="2021-02-14T17:20:21.265" v="825" actId="478"/>
          <ac:spMkLst>
            <pc:docMk/>
            <pc:sldMk cId="2214109847" sldId="4371"/>
            <ac:spMk id="2" creationId="{E38A198C-4B8B-495D-A9CC-FE711D935BD2}"/>
          </ac:spMkLst>
        </pc:spChg>
        <pc:spChg chg="del">
          <ac:chgData name="Hayk Barseghyan" userId="1af3c995-31f7-415e-9aa1-2b36900e994d" providerId="ADAL" clId="{F2E7F468-1AD9-4DAD-9D39-1A9D274F9CE4}" dt="2021-02-14T17:20:21.265" v="825" actId="478"/>
          <ac:spMkLst>
            <pc:docMk/>
            <pc:sldMk cId="2214109847" sldId="4371"/>
            <ac:spMk id="3" creationId="{F53740D0-CD49-4A1B-BFE9-CDB5E076B0EC}"/>
          </ac:spMkLst>
        </pc:spChg>
        <pc:picChg chg="add del mod">
          <ac:chgData name="Hayk Barseghyan" userId="1af3c995-31f7-415e-9aa1-2b36900e994d" providerId="ADAL" clId="{F2E7F468-1AD9-4DAD-9D39-1A9D274F9CE4}" dt="2021-02-14T17:20:21.265" v="825" actId="478"/>
          <ac:picMkLst>
            <pc:docMk/>
            <pc:sldMk cId="2214109847" sldId="4371"/>
            <ac:picMk id="4" creationId="{959BA1EC-504C-4014-A4F0-925A7D4E0408}"/>
          </ac:picMkLst>
        </pc:picChg>
        <pc:picChg chg="add mod">
          <ac:chgData name="Hayk Barseghyan" userId="1af3c995-31f7-415e-9aa1-2b36900e994d" providerId="ADAL" clId="{F2E7F468-1AD9-4DAD-9D39-1A9D274F9CE4}" dt="2021-02-14T17:20:24.268" v="827" actId="14100"/>
          <ac:picMkLst>
            <pc:docMk/>
            <pc:sldMk cId="2214109847" sldId="4371"/>
            <ac:picMk id="5" creationId="{D22536F5-2D86-463E-9A86-63ED6D2D2EC2}"/>
          </ac:picMkLst>
        </pc:picChg>
        <pc:picChg chg="add mod">
          <ac:chgData name="Hayk Barseghyan" userId="1af3c995-31f7-415e-9aa1-2b36900e994d" providerId="ADAL" clId="{F2E7F468-1AD9-4DAD-9D39-1A9D274F9CE4}" dt="2021-02-14T17:20:35.051" v="829" actId="1076"/>
          <ac:picMkLst>
            <pc:docMk/>
            <pc:sldMk cId="2214109847" sldId="4371"/>
            <ac:picMk id="6" creationId="{87731D74-16E4-4D31-AECF-DFC79BEEEFB5}"/>
          </ac:picMkLst>
        </pc:picChg>
      </pc:sldChg>
      <pc:sldMasterChg chg="del delSldLayout">
        <pc:chgData name="Hayk Barseghyan" userId="1af3c995-31f7-415e-9aa1-2b36900e994d" providerId="ADAL" clId="{F2E7F468-1AD9-4DAD-9D39-1A9D274F9CE4}" dt="2021-02-08T06:42:00.870" v="27" actId="47"/>
        <pc:sldMasterMkLst>
          <pc:docMk/>
          <pc:sldMasterMk cId="3219717621" sldId="2147483805"/>
        </pc:sldMasterMkLst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1249024075" sldId="2147483806"/>
          </pc:sldLayoutMkLst>
        </pc:sldLayoutChg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1440452897" sldId="2147483807"/>
          </pc:sldLayoutMkLst>
        </pc:sldLayoutChg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2244988793" sldId="2147483808"/>
          </pc:sldLayoutMkLst>
        </pc:sldLayoutChg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3684898146" sldId="2147483809"/>
          </pc:sldLayoutMkLst>
        </pc:sldLayoutChg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1301101525" sldId="2147483810"/>
          </pc:sldLayoutMkLst>
        </pc:sldLayoutChg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3383605012" sldId="2147483811"/>
          </pc:sldLayoutMkLst>
        </pc:sldLayoutChg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2176439025" sldId="2147483812"/>
          </pc:sldLayoutMkLst>
        </pc:sldLayoutChg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2643671950" sldId="2147483813"/>
          </pc:sldLayoutMkLst>
        </pc:sldLayoutChg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2483464945" sldId="2147483814"/>
          </pc:sldLayoutMkLst>
        </pc:sldLayoutChg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2181195177" sldId="2147483815"/>
          </pc:sldLayoutMkLst>
        </pc:sldLayoutChg>
        <pc:sldLayoutChg chg="del">
          <pc:chgData name="Hayk Barseghyan" userId="1af3c995-31f7-415e-9aa1-2b36900e994d" providerId="ADAL" clId="{F2E7F468-1AD9-4DAD-9D39-1A9D274F9CE4}" dt="2021-02-08T06:42:00.870" v="27" actId="47"/>
          <pc:sldLayoutMkLst>
            <pc:docMk/>
            <pc:sldMasterMk cId="3219717621" sldId="2147483805"/>
            <pc:sldLayoutMk cId="644446883" sldId="2147483816"/>
          </pc:sldLayoutMkLst>
        </pc:sldLayoutChg>
        <pc:sldLayoutChg chg="del">
          <pc:chgData name="Hayk Barseghyan" userId="1af3c995-31f7-415e-9aa1-2b36900e994d" providerId="ADAL" clId="{F2E7F468-1AD9-4DAD-9D39-1A9D274F9CE4}" dt="2021-02-08T06:41:52.101" v="1" actId="47"/>
          <pc:sldLayoutMkLst>
            <pc:docMk/>
            <pc:sldMasterMk cId="3219717621" sldId="2147483805"/>
            <pc:sldLayoutMk cId="3492746133" sldId="2147483881"/>
          </pc:sldLayoutMkLst>
        </pc:sldLayoutChg>
      </pc:sldMasterChg>
    </pc:docChg>
  </pc:docChgLst>
  <pc:docChgLst>
    <pc:chgData name="Ben Clifford" userId="S::bclifford@bionanogenomics.com::37190262-3d35-4585-9cd0-592803b01aba" providerId="AD" clId="Web-{EDC333A8-CE90-8F00-B310-F6FDC88645C1}"/>
    <pc:docChg chg="modSld">
      <pc:chgData name="Ben Clifford" userId="S::bclifford@bionanogenomics.com::37190262-3d35-4585-9cd0-592803b01aba" providerId="AD" clId="Web-{EDC333A8-CE90-8F00-B310-F6FDC88645C1}" dt="2021-11-08T21:54:12.670" v="3" actId="1076"/>
      <pc:docMkLst>
        <pc:docMk/>
      </pc:docMkLst>
      <pc:sldChg chg="modSp">
        <pc:chgData name="Ben Clifford" userId="S::bclifford@bionanogenomics.com::37190262-3d35-4585-9cd0-592803b01aba" providerId="AD" clId="Web-{EDC333A8-CE90-8F00-B310-F6FDC88645C1}" dt="2021-11-08T21:54:12.670" v="3" actId="1076"/>
        <pc:sldMkLst>
          <pc:docMk/>
          <pc:sldMk cId="367579465" sldId="675"/>
        </pc:sldMkLst>
        <pc:cxnChg chg="mod">
          <ac:chgData name="Ben Clifford" userId="S::bclifford@bionanogenomics.com::37190262-3d35-4585-9cd0-592803b01aba" providerId="AD" clId="Web-{EDC333A8-CE90-8F00-B310-F6FDC88645C1}" dt="2021-11-08T21:54:12.670" v="3" actId="1076"/>
          <ac:cxnSpMkLst>
            <pc:docMk/>
            <pc:sldMk cId="367579465" sldId="675"/>
            <ac:cxnSpMk id="95" creationId="{5EB10151-CF0F-4162-A03A-2FB4661DCBE8}"/>
          </ac:cxnSpMkLst>
        </pc:cxnChg>
      </pc:sldChg>
    </pc:docChg>
  </pc:docChgLst>
  <pc:docChgLst>
    <pc:chgData name="Hayk Barseghyan" userId="1af3c995-31f7-415e-9aa1-2b36900e994d" providerId="ADAL" clId="{817F6B4A-A95C-41F4-9215-42C8F6493746}"/>
    <pc:docChg chg="undo redo custSel addSld delSld modSld sldOrd">
      <pc:chgData name="Hayk Barseghyan" userId="1af3c995-31f7-415e-9aa1-2b36900e994d" providerId="ADAL" clId="{817F6B4A-A95C-41F4-9215-42C8F6493746}" dt="2021-03-19T22:40:38.425" v="1545" actId="20577"/>
      <pc:docMkLst>
        <pc:docMk/>
      </pc:docMkLst>
      <pc:sldChg chg="modSp del mod">
        <pc:chgData name="Hayk Barseghyan" userId="1af3c995-31f7-415e-9aa1-2b36900e994d" providerId="ADAL" clId="{817F6B4A-A95C-41F4-9215-42C8F6493746}" dt="2021-03-19T19:02:33.174" v="738" actId="47"/>
        <pc:sldMkLst>
          <pc:docMk/>
          <pc:sldMk cId="827945534" sldId="654"/>
        </pc:sldMkLst>
        <pc:spChg chg="mod">
          <ac:chgData name="Hayk Barseghyan" userId="1af3c995-31f7-415e-9aa1-2b36900e994d" providerId="ADAL" clId="{817F6B4A-A95C-41F4-9215-42C8F6493746}" dt="2021-03-19T17:38:55.890" v="231" actId="20577"/>
          <ac:spMkLst>
            <pc:docMk/>
            <pc:sldMk cId="827945534" sldId="654"/>
            <ac:spMk id="30" creationId="{68ED1E75-B125-4C10-BB29-81E202553B2C}"/>
          </ac:spMkLst>
        </pc:spChg>
        <pc:spChg chg="mod">
          <ac:chgData name="Hayk Barseghyan" userId="1af3c995-31f7-415e-9aa1-2b36900e994d" providerId="ADAL" clId="{817F6B4A-A95C-41F4-9215-42C8F6493746}" dt="2021-03-19T17:27:58.273" v="4" actId="2711"/>
          <ac:spMkLst>
            <pc:docMk/>
            <pc:sldMk cId="827945534" sldId="654"/>
            <ac:spMk id="53" creationId="{68B00FA6-B8FE-4BDC-965F-134174286DD9}"/>
          </ac:spMkLst>
        </pc:spChg>
        <pc:spChg chg="mod">
          <ac:chgData name="Hayk Barseghyan" userId="1af3c995-31f7-415e-9aa1-2b36900e994d" providerId="ADAL" clId="{817F6B4A-A95C-41F4-9215-42C8F6493746}" dt="2021-03-19T17:27:58.273" v="4" actId="2711"/>
          <ac:spMkLst>
            <pc:docMk/>
            <pc:sldMk cId="827945534" sldId="654"/>
            <ac:spMk id="54" creationId="{E863B169-6BF6-4624-A891-6B3C9852B628}"/>
          </ac:spMkLst>
        </pc:spChg>
      </pc:sldChg>
      <pc:sldChg chg="addSp delSp modSp mod modNotesTx">
        <pc:chgData name="Hayk Barseghyan" userId="1af3c995-31f7-415e-9aa1-2b36900e994d" providerId="ADAL" clId="{817F6B4A-A95C-41F4-9215-42C8F6493746}" dt="2021-03-19T22:40:38.425" v="1545" actId="20577"/>
        <pc:sldMkLst>
          <pc:docMk/>
          <pc:sldMk cId="1879609064" sldId="655"/>
        </pc:sldMkLst>
        <pc:spChg chg="mod">
          <ac:chgData name="Hayk Barseghyan" userId="1af3c995-31f7-415e-9aa1-2b36900e994d" providerId="ADAL" clId="{817F6B4A-A95C-41F4-9215-42C8F6493746}" dt="2021-03-19T17:34:08.993" v="89" actId="1037"/>
          <ac:spMkLst>
            <pc:docMk/>
            <pc:sldMk cId="1879609064" sldId="655"/>
            <ac:spMk id="15" creationId="{1DA809E1-700B-4B5F-80D1-146841C532CC}"/>
          </ac:spMkLst>
        </pc:spChg>
        <pc:spChg chg="mod">
          <ac:chgData name="Hayk Barseghyan" userId="1af3c995-31f7-415e-9aa1-2b36900e994d" providerId="ADAL" clId="{817F6B4A-A95C-41F4-9215-42C8F6493746}" dt="2021-03-19T17:34:08.993" v="89" actId="1037"/>
          <ac:spMkLst>
            <pc:docMk/>
            <pc:sldMk cId="1879609064" sldId="655"/>
            <ac:spMk id="16" creationId="{219D3844-749C-4AC5-8AAC-A5A6E4F706D5}"/>
          </ac:spMkLst>
        </pc:spChg>
        <pc:spChg chg="mod">
          <ac:chgData name="Hayk Barseghyan" userId="1af3c995-31f7-415e-9aa1-2b36900e994d" providerId="ADAL" clId="{817F6B4A-A95C-41F4-9215-42C8F6493746}" dt="2021-03-19T17:34:08.993" v="89" actId="1037"/>
          <ac:spMkLst>
            <pc:docMk/>
            <pc:sldMk cId="1879609064" sldId="655"/>
            <ac:spMk id="17" creationId="{238D452B-545B-49D2-9AA5-4774F789BA52}"/>
          </ac:spMkLst>
        </pc:spChg>
        <pc:spChg chg="mod">
          <ac:chgData name="Hayk Barseghyan" userId="1af3c995-31f7-415e-9aa1-2b36900e994d" providerId="ADAL" clId="{817F6B4A-A95C-41F4-9215-42C8F6493746}" dt="2021-03-19T17:34:08.993" v="89" actId="1037"/>
          <ac:spMkLst>
            <pc:docMk/>
            <pc:sldMk cId="1879609064" sldId="655"/>
            <ac:spMk id="18" creationId="{3B330CDD-DF8E-4329-9F8F-0C05A3EBA278}"/>
          </ac:spMkLst>
        </pc:spChg>
        <pc:spChg chg="mod">
          <ac:chgData name="Hayk Barseghyan" userId="1af3c995-31f7-415e-9aa1-2b36900e994d" providerId="ADAL" clId="{817F6B4A-A95C-41F4-9215-42C8F6493746}" dt="2021-03-19T17:34:08.993" v="89" actId="1037"/>
          <ac:spMkLst>
            <pc:docMk/>
            <pc:sldMk cId="1879609064" sldId="655"/>
            <ac:spMk id="19" creationId="{92E3FBB9-4482-4901-BB7B-515414A60BF3}"/>
          </ac:spMkLst>
        </pc:spChg>
        <pc:spChg chg="mod">
          <ac:chgData name="Hayk Barseghyan" userId="1af3c995-31f7-415e-9aa1-2b36900e994d" providerId="ADAL" clId="{817F6B4A-A95C-41F4-9215-42C8F6493746}" dt="2021-03-19T17:34:08.993" v="89" actId="1037"/>
          <ac:spMkLst>
            <pc:docMk/>
            <pc:sldMk cId="1879609064" sldId="655"/>
            <ac:spMk id="20" creationId="{33617DAE-E7EA-4947-A705-85255111007E}"/>
          </ac:spMkLst>
        </pc:spChg>
        <pc:spChg chg="mod">
          <ac:chgData name="Hayk Barseghyan" userId="1af3c995-31f7-415e-9aa1-2b36900e994d" providerId="ADAL" clId="{817F6B4A-A95C-41F4-9215-42C8F6493746}" dt="2021-03-19T17:34:08.993" v="89" actId="1037"/>
          <ac:spMkLst>
            <pc:docMk/>
            <pc:sldMk cId="1879609064" sldId="655"/>
            <ac:spMk id="21" creationId="{C9A0FE9C-502B-4BBD-8A60-74F846E3930A}"/>
          </ac:spMkLst>
        </pc:spChg>
        <pc:spChg chg="mod">
          <ac:chgData name="Hayk Barseghyan" userId="1af3c995-31f7-415e-9aa1-2b36900e994d" providerId="ADAL" clId="{817F6B4A-A95C-41F4-9215-42C8F6493746}" dt="2021-03-19T17:34:08.993" v="89" actId="1037"/>
          <ac:spMkLst>
            <pc:docMk/>
            <pc:sldMk cId="1879609064" sldId="655"/>
            <ac:spMk id="22" creationId="{097F0FB6-DB3D-4B12-9E76-180A15D9B845}"/>
          </ac:spMkLst>
        </pc:spChg>
        <pc:spChg chg="mod">
          <ac:chgData name="Hayk Barseghyan" userId="1af3c995-31f7-415e-9aa1-2b36900e994d" providerId="ADAL" clId="{817F6B4A-A95C-41F4-9215-42C8F6493746}" dt="2021-03-19T18:41:03.325" v="396" actId="20577"/>
          <ac:spMkLst>
            <pc:docMk/>
            <pc:sldMk cId="1879609064" sldId="655"/>
            <ac:spMk id="28" creationId="{627423C8-B194-4935-85FA-5ED8C3D13EA3}"/>
          </ac:spMkLst>
        </pc:spChg>
        <pc:spChg chg="mod">
          <ac:chgData name="Hayk Barseghyan" userId="1af3c995-31f7-415e-9aa1-2b36900e994d" providerId="ADAL" clId="{817F6B4A-A95C-41F4-9215-42C8F6493746}" dt="2021-03-19T17:39:07.582" v="236" actId="1076"/>
          <ac:spMkLst>
            <pc:docMk/>
            <pc:sldMk cId="1879609064" sldId="655"/>
            <ac:spMk id="30" creationId="{68ED1E75-B125-4C10-BB29-81E202553B2C}"/>
          </ac:spMkLst>
        </pc:spChg>
        <pc:spChg chg="mod">
          <ac:chgData name="Hayk Barseghyan" userId="1af3c995-31f7-415e-9aa1-2b36900e994d" providerId="ADAL" clId="{817F6B4A-A95C-41F4-9215-42C8F6493746}" dt="2021-03-19T17:28:24.858" v="6" actId="20577"/>
          <ac:spMkLst>
            <pc:docMk/>
            <pc:sldMk cId="1879609064" sldId="655"/>
            <ac:spMk id="33" creationId="{27D04DB1-6D7F-4335-AAA1-99D44F3F14E9}"/>
          </ac:spMkLst>
        </pc:spChg>
        <pc:spChg chg="add mod">
          <ac:chgData name="Hayk Barseghyan" userId="1af3c995-31f7-415e-9aa1-2b36900e994d" providerId="ADAL" clId="{817F6B4A-A95C-41F4-9215-42C8F6493746}" dt="2021-03-19T18:41:16.291" v="419" actId="20577"/>
          <ac:spMkLst>
            <pc:docMk/>
            <pc:sldMk cId="1879609064" sldId="655"/>
            <ac:spMk id="34" creationId="{9E232FB5-9A42-4416-8E4E-5620B622F041}"/>
          </ac:spMkLst>
        </pc:spChg>
        <pc:spChg chg="add mod">
          <ac:chgData name="Hayk Barseghyan" userId="1af3c995-31f7-415e-9aa1-2b36900e994d" providerId="ADAL" clId="{817F6B4A-A95C-41F4-9215-42C8F6493746}" dt="2021-03-19T17:34:54.177" v="112" actId="1038"/>
          <ac:spMkLst>
            <pc:docMk/>
            <pc:sldMk cId="1879609064" sldId="655"/>
            <ac:spMk id="36" creationId="{D1390CDB-8C38-45E4-B737-627C1887B062}"/>
          </ac:spMkLst>
        </pc:spChg>
        <pc:spChg chg="add mod">
          <ac:chgData name="Hayk Barseghyan" userId="1af3c995-31f7-415e-9aa1-2b36900e994d" providerId="ADAL" clId="{817F6B4A-A95C-41F4-9215-42C8F6493746}" dt="2021-03-19T17:36:11.257" v="159" actId="1076"/>
          <ac:spMkLst>
            <pc:docMk/>
            <pc:sldMk cId="1879609064" sldId="655"/>
            <ac:spMk id="40" creationId="{EFE6C304-6608-4E19-9AF5-28280CCAEF69}"/>
          </ac:spMkLst>
        </pc:spChg>
        <pc:spChg chg="add del mod">
          <ac:chgData name="Hayk Barseghyan" userId="1af3c995-31f7-415e-9aa1-2b36900e994d" providerId="ADAL" clId="{817F6B4A-A95C-41F4-9215-42C8F6493746}" dt="2021-03-19T19:00:36.705" v="716"/>
          <ac:spMkLst>
            <pc:docMk/>
            <pc:sldMk cId="1879609064" sldId="655"/>
            <ac:spMk id="41" creationId="{556E34CC-F5CD-4CB1-8FD7-78888E6EEA4C}"/>
          </ac:spMkLst>
        </pc:spChg>
        <pc:spChg chg="add mod">
          <ac:chgData name="Hayk Barseghyan" userId="1af3c995-31f7-415e-9aa1-2b36900e994d" providerId="ADAL" clId="{817F6B4A-A95C-41F4-9215-42C8F6493746}" dt="2021-03-19T22:40:38.425" v="1545" actId="20577"/>
          <ac:spMkLst>
            <pc:docMk/>
            <pc:sldMk cId="1879609064" sldId="655"/>
            <ac:spMk id="42" creationId="{BCAF44B2-159A-4E49-9C66-509D0254A0FB}"/>
          </ac:spMkLst>
        </pc:spChg>
        <pc:spChg chg="mod">
          <ac:chgData name="Hayk Barseghyan" userId="1af3c995-31f7-415e-9aa1-2b36900e994d" providerId="ADAL" clId="{817F6B4A-A95C-41F4-9215-42C8F6493746}" dt="2021-03-19T17:34:26.416" v="90" actId="1076"/>
          <ac:spMkLst>
            <pc:docMk/>
            <pc:sldMk cId="1879609064" sldId="655"/>
            <ac:spMk id="44" creationId="{732812E5-D6B9-4FEF-975D-E2E3D93D0E47}"/>
          </ac:spMkLst>
        </pc:spChg>
        <pc:spChg chg="mod">
          <ac:chgData name="Hayk Barseghyan" userId="1af3c995-31f7-415e-9aa1-2b36900e994d" providerId="ADAL" clId="{817F6B4A-A95C-41F4-9215-42C8F6493746}" dt="2021-03-19T17:34:26.416" v="90" actId="1076"/>
          <ac:spMkLst>
            <pc:docMk/>
            <pc:sldMk cId="1879609064" sldId="655"/>
            <ac:spMk id="45" creationId="{706B5154-0B8D-4A97-9481-9F43337FAC30}"/>
          </ac:spMkLst>
        </pc:spChg>
        <pc:spChg chg="mod">
          <ac:chgData name="Hayk Barseghyan" userId="1af3c995-31f7-415e-9aa1-2b36900e994d" providerId="ADAL" clId="{817F6B4A-A95C-41F4-9215-42C8F6493746}" dt="2021-03-19T17:35:18.629" v="115" actId="1076"/>
          <ac:spMkLst>
            <pc:docMk/>
            <pc:sldMk cId="1879609064" sldId="655"/>
            <ac:spMk id="48" creationId="{7DECEAD3-1F4B-4349-B3E1-EC2281C752C7}"/>
          </ac:spMkLst>
        </pc:spChg>
        <pc:spChg chg="mod">
          <ac:chgData name="Hayk Barseghyan" userId="1af3c995-31f7-415e-9aa1-2b36900e994d" providerId="ADAL" clId="{817F6B4A-A95C-41F4-9215-42C8F6493746}" dt="2021-03-19T17:34:26.416" v="90" actId="1076"/>
          <ac:spMkLst>
            <pc:docMk/>
            <pc:sldMk cId="1879609064" sldId="655"/>
            <ac:spMk id="88" creationId="{7309DE7D-82B3-4F46-B078-58EBF40D4703}"/>
          </ac:spMkLst>
        </pc:spChg>
        <pc:spChg chg="mod">
          <ac:chgData name="Hayk Barseghyan" userId="1af3c995-31f7-415e-9aa1-2b36900e994d" providerId="ADAL" clId="{817F6B4A-A95C-41F4-9215-42C8F6493746}" dt="2021-03-19T17:37:56.022" v="219" actId="1038"/>
          <ac:spMkLst>
            <pc:docMk/>
            <pc:sldMk cId="1879609064" sldId="655"/>
            <ac:spMk id="91" creationId="{13B1F2AA-C6E8-4BA8-9C3E-AADD95A31E93}"/>
          </ac:spMkLst>
        </pc:spChg>
        <pc:spChg chg="mod">
          <ac:chgData name="Hayk Barseghyan" userId="1af3c995-31f7-415e-9aa1-2b36900e994d" providerId="ADAL" clId="{817F6B4A-A95C-41F4-9215-42C8F6493746}" dt="2021-03-19T17:37:46.924" v="205" actId="1038"/>
          <ac:spMkLst>
            <pc:docMk/>
            <pc:sldMk cId="1879609064" sldId="655"/>
            <ac:spMk id="92" creationId="{C38076EE-D1EB-4356-9361-84DA46C2351B}"/>
          </ac:spMkLst>
        </pc:spChg>
        <pc:spChg chg="mod">
          <ac:chgData name="Hayk Barseghyan" userId="1af3c995-31f7-415e-9aa1-2b36900e994d" providerId="ADAL" clId="{817F6B4A-A95C-41F4-9215-42C8F6493746}" dt="2021-03-19T17:34:26.416" v="90" actId="1076"/>
          <ac:spMkLst>
            <pc:docMk/>
            <pc:sldMk cId="1879609064" sldId="655"/>
            <ac:spMk id="93" creationId="{3EAC0E29-A0FD-42DD-8F3E-7B6BDF36A320}"/>
          </ac:spMkLst>
        </pc:spChg>
        <pc:spChg chg="mod">
          <ac:chgData name="Hayk Barseghyan" userId="1af3c995-31f7-415e-9aa1-2b36900e994d" providerId="ADAL" clId="{817F6B4A-A95C-41F4-9215-42C8F6493746}" dt="2021-03-19T17:34:26.416" v="90" actId="1076"/>
          <ac:spMkLst>
            <pc:docMk/>
            <pc:sldMk cId="1879609064" sldId="655"/>
            <ac:spMk id="94" creationId="{C3B2E742-FF55-4D80-8A82-03F353C11C9E}"/>
          </ac:spMkLst>
        </pc:spChg>
        <pc:spChg chg="add del mod">
          <ac:chgData name="Hayk Barseghyan" userId="1af3c995-31f7-415e-9aa1-2b36900e994d" providerId="ADAL" clId="{817F6B4A-A95C-41F4-9215-42C8F6493746}" dt="2021-03-19T17:56:21.345" v="251" actId="478"/>
          <ac:spMkLst>
            <pc:docMk/>
            <pc:sldMk cId="1879609064" sldId="655"/>
            <ac:spMk id="98" creationId="{CC1A3F83-E94B-4F3C-9D62-2C0B7D404690}"/>
          </ac:spMkLst>
        </pc:spChg>
        <pc:picChg chg="mod">
          <ac:chgData name="Hayk Barseghyan" userId="1af3c995-31f7-415e-9aa1-2b36900e994d" providerId="ADAL" clId="{817F6B4A-A95C-41F4-9215-42C8F6493746}" dt="2021-03-19T17:34:08.993" v="89" actId="1037"/>
          <ac:picMkLst>
            <pc:docMk/>
            <pc:sldMk cId="1879609064" sldId="655"/>
            <ac:picMk id="4" creationId="{6EE723D7-82C2-40C7-9EDF-695ABCFD2852}"/>
          </ac:picMkLst>
        </pc:picChg>
        <pc:picChg chg="mod">
          <ac:chgData name="Hayk Barseghyan" userId="1af3c995-31f7-415e-9aa1-2b36900e994d" providerId="ADAL" clId="{817F6B4A-A95C-41F4-9215-42C8F6493746}" dt="2021-03-19T17:34:08.993" v="89" actId="1037"/>
          <ac:picMkLst>
            <pc:docMk/>
            <pc:sldMk cId="1879609064" sldId="655"/>
            <ac:picMk id="14" creationId="{BD596D5A-A8B5-4F23-971B-B0033B030440}"/>
          </ac:picMkLst>
        </pc:picChg>
        <pc:picChg chg="mod">
          <ac:chgData name="Hayk Barseghyan" userId="1af3c995-31f7-415e-9aa1-2b36900e994d" providerId="ADAL" clId="{817F6B4A-A95C-41F4-9215-42C8F6493746}" dt="2021-03-19T17:34:26.416" v="90" actId="1076"/>
          <ac:picMkLst>
            <pc:docMk/>
            <pc:sldMk cId="1879609064" sldId="655"/>
            <ac:picMk id="35" creationId="{347E1D22-E15C-425D-925B-99F60A60B955}"/>
          </ac:picMkLst>
        </pc:picChg>
        <pc:cxnChg chg="mod">
          <ac:chgData name="Hayk Barseghyan" userId="1af3c995-31f7-415e-9aa1-2b36900e994d" providerId="ADAL" clId="{817F6B4A-A95C-41F4-9215-42C8F6493746}" dt="2021-03-19T17:34:08.993" v="89" actId="1037"/>
          <ac:cxnSpMkLst>
            <pc:docMk/>
            <pc:sldMk cId="1879609064" sldId="655"/>
            <ac:cxnSpMk id="23" creationId="{B97A16ED-5542-4DD1-94CA-D032D3F72196}"/>
          </ac:cxnSpMkLst>
        </pc:cxnChg>
        <pc:cxnChg chg="mod">
          <ac:chgData name="Hayk Barseghyan" userId="1af3c995-31f7-415e-9aa1-2b36900e994d" providerId="ADAL" clId="{817F6B4A-A95C-41F4-9215-42C8F6493746}" dt="2021-03-19T17:34:08.993" v="89" actId="1037"/>
          <ac:cxnSpMkLst>
            <pc:docMk/>
            <pc:sldMk cId="1879609064" sldId="655"/>
            <ac:cxnSpMk id="24" creationId="{792D8F66-E748-410F-BB9B-B632B254BDFB}"/>
          </ac:cxnSpMkLst>
        </pc:cxnChg>
        <pc:cxnChg chg="mod">
          <ac:chgData name="Hayk Barseghyan" userId="1af3c995-31f7-415e-9aa1-2b36900e994d" providerId="ADAL" clId="{817F6B4A-A95C-41F4-9215-42C8F6493746}" dt="2021-03-19T17:34:08.993" v="89" actId="1037"/>
          <ac:cxnSpMkLst>
            <pc:docMk/>
            <pc:sldMk cId="1879609064" sldId="655"/>
            <ac:cxnSpMk id="25" creationId="{A4F48631-3605-414B-96A3-B4E7701F3903}"/>
          </ac:cxnSpMkLst>
        </pc:cxnChg>
        <pc:cxnChg chg="mod">
          <ac:chgData name="Hayk Barseghyan" userId="1af3c995-31f7-415e-9aa1-2b36900e994d" providerId="ADAL" clId="{817F6B4A-A95C-41F4-9215-42C8F6493746}" dt="2021-03-19T17:35:22.367" v="116" actId="14100"/>
          <ac:cxnSpMkLst>
            <pc:docMk/>
            <pc:sldMk cId="1879609064" sldId="655"/>
            <ac:cxnSpMk id="49" creationId="{4423681D-AADF-4D62-AC9E-3FDDF18E21B9}"/>
          </ac:cxnSpMkLst>
        </pc:cxnChg>
        <pc:cxnChg chg="mod">
          <ac:chgData name="Hayk Barseghyan" userId="1af3c995-31f7-415e-9aa1-2b36900e994d" providerId="ADAL" clId="{817F6B4A-A95C-41F4-9215-42C8F6493746}" dt="2021-03-19T17:35:27.097" v="117" actId="14100"/>
          <ac:cxnSpMkLst>
            <pc:docMk/>
            <pc:sldMk cId="1879609064" sldId="655"/>
            <ac:cxnSpMk id="52" creationId="{67E81840-D31A-48DD-9275-CD08F7D6F031}"/>
          </ac:cxnSpMkLst>
        </pc:cxnChg>
        <pc:cxnChg chg="mod">
          <ac:chgData name="Hayk Barseghyan" userId="1af3c995-31f7-415e-9aa1-2b36900e994d" providerId="ADAL" clId="{817F6B4A-A95C-41F4-9215-42C8F6493746}" dt="2021-03-19T17:34:26.416" v="90" actId="1076"/>
          <ac:cxnSpMkLst>
            <pc:docMk/>
            <pc:sldMk cId="1879609064" sldId="655"/>
            <ac:cxnSpMk id="95" creationId="{5EB10151-CF0F-4162-A03A-2FB4661DCBE8}"/>
          </ac:cxnSpMkLst>
        </pc:cxnChg>
      </pc:sldChg>
      <pc:sldChg chg="addSp delSp modSp mod ord modNotesTx">
        <pc:chgData name="Hayk Barseghyan" userId="1af3c995-31f7-415e-9aa1-2b36900e994d" providerId="ADAL" clId="{817F6B4A-A95C-41F4-9215-42C8F6493746}" dt="2021-03-19T22:37:33.517" v="1528" actId="20577"/>
        <pc:sldMkLst>
          <pc:docMk/>
          <pc:sldMk cId="742313956" sldId="656"/>
        </pc:sldMkLst>
        <pc:spChg chg="add mod">
          <ac:chgData name="Hayk Barseghyan" userId="1af3c995-31f7-415e-9aa1-2b36900e994d" providerId="ADAL" clId="{817F6B4A-A95C-41F4-9215-42C8F6493746}" dt="2021-03-19T20:32:08.534" v="1415" actId="1076"/>
          <ac:spMkLst>
            <pc:docMk/>
            <pc:sldMk cId="742313956" sldId="656"/>
            <ac:spMk id="18" creationId="{5DD4D5E1-1043-4AC3-B4A3-DB3836370A00}"/>
          </ac:spMkLst>
        </pc:spChg>
        <pc:spChg chg="add mod">
          <ac:chgData name="Hayk Barseghyan" userId="1af3c995-31f7-415e-9aa1-2b36900e994d" providerId="ADAL" clId="{817F6B4A-A95C-41F4-9215-42C8F6493746}" dt="2021-03-19T20:31:59.421" v="1413" actId="14100"/>
          <ac:spMkLst>
            <pc:docMk/>
            <pc:sldMk cId="742313956" sldId="656"/>
            <ac:spMk id="19" creationId="{3F12C9F5-C449-4B43-AC1C-C3E0C524D931}"/>
          </ac:spMkLst>
        </pc:spChg>
        <pc:spChg chg="add del mod">
          <ac:chgData name="Hayk Barseghyan" userId="1af3c995-31f7-415e-9aa1-2b36900e994d" providerId="ADAL" clId="{817F6B4A-A95C-41F4-9215-42C8F6493746}" dt="2021-03-19T20:22:02.308" v="1223"/>
          <ac:spMkLst>
            <pc:docMk/>
            <pc:sldMk cId="742313956" sldId="656"/>
            <ac:spMk id="21" creationId="{BAFF2F70-CAE2-47FF-9709-CC724144406E}"/>
          </ac:spMkLst>
        </pc:spChg>
        <pc:spChg chg="add del mod">
          <ac:chgData name="Hayk Barseghyan" userId="1af3c995-31f7-415e-9aa1-2b36900e994d" providerId="ADAL" clId="{817F6B4A-A95C-41F4-9215-42C8F6493746}" dt="2021-03-19T20:22:02.308" v="1223"/>
          <ac:spMkLst>
            <pc:docMk/>
            <pc:sldMk cId="742313956" sldId="656"/>
            <ac:spMk id="22" creationId="{1EE915B2-81AB-4F0C-9522-D9352190A946}"/>
          </ac:spMkLst>
        </pc:spChg>
        <pc:spChg chg="add del mod">
          <ac:chgData name="Hayk Barseghyan" userId="1af3c995-31f7-415e-9aa1-2b36900e994d" providerId="ADAL" clId="{817F6B4A-A95C-41F4-9215-42C8F6493746}" dt="2021-03-19T20:22:02.308" v="1223"/>
          <ac:spMkLst>
            <pc:docMk/>
            <pc:sldMk cId="742313956" sldId="656"/>
            <ac:spMk id="23" creationId="{42288A41-E542-44F7-9EE0-27F5B0F77E66}"/>
          </ac:spMkLst>
        </pc:spChg>
        <pc:spChg chg="add mod">
          <ac:chgData name="Hayk Barseghyan" userId="1af3c995-31f7-415e-9aa1-2b36900e994d" providerId="ADAL" clId="{817F6B4A-A95C-41F4-9215-42C8F6493746}" dt="2021-03-19T20:23:07.279" v="1246"/>
          <ac:spMkLst>
            <pc:docMk/>
            <pc:sldMk cId="742313956" sldId="656"/>
            <ac:spMk id="24" creationId="{08AD8F4B-F50F-48B3-A1C6-A8E9F84AFB80}"/>
          </ac:spMkLst>
        </pc:spChg>
        <pc:spChg chg="add mod">
          <ac:chgData name="Hayk Barseghyan" userId="1af3c995-31f7-415e-9aa1-2b36900e994d" providerId="ADAL" clId="{817F6B4A-A95C-41F4-9215-42C8F6493746}" dt="2021-03-19T20:23:07.279" v="1246"/>
          <ac:spMkLst>
            <pc:docMk/>
            <pc:sldMk cId="742313956" sldId="656"/>
            <ac:spMk id="25" creationId="{09902C2B-5D85-4723-8E35-13D99ED2764C}"/>
          </ac:spMkLst>
        </pc:spChg>
        <pc:spChg chg="add mod">
          <ac:chgData name="Hayk Barseghyan" userId="1af3c995-31f7-415e-9aa1-2b36900e994d" providerId="ADAL" clId="{817F6B4A-A95C-41F4-9215-42C8F6493746}" dt="2021-03-19T20:23:07.279" v="1246"/>
          <ac:spMkLst>
            <pc:docMk/>
            <pc:sldMk cId="742313956" sldId="656"/>
            <ac:spMk id="26" creationId="{28F00DCA-4ACB-421E-8A62-5F0025FD3DB2}"/>
          </ac:spMkLst>
        </pc:spChg>
        <pc:spChg chg="del">
          <ac:chgData name="Hayk Barseghyan" userId="1af3c995-31f7-415e-9aa1-2b36900e994d" providerId="ADAL" clId="{817F6B4A-A95C-41F4-9215-42C8F6493746}" dt="2021-03-19T20:22:10.464" v="1226" actId="478"/>
          <ac:spMkLst>
            <pc:docMk/>
            <pc:sldMk cId="742313956" sldId="656"/>
            <ac:spMk id="30" creationId="{68ED1E75-B125-4C10-BB29-81E202553B2C}"/>
          </ac:spMkLst>
        </pc:spChg>
        <pc:spChg chg="mod">
          <ac:chgData name="Hayk Barseghyan" userId="1af3c995-31f7-415e-9aa1-2b36900e994d" providerId="ADAL" clId="{817F6B4A-A95C-41F4-9215-42C8F6493746}" dt="2021-03-19T20:24:23.379" v="1308" actId="1076"/>
          <ac:spMkLst>
            <pc:docMk/>
            <pc:sldMk cId="742313956" sldId="656"/>
            <ac:spMk id="32" creationId="{C8EED87A-0AE7-41CB-B85F-5690D93EF3E6}"/>
          </ac:spMkLst>
        </pc:spChg>
        <pc:spChg chg="del mod">
          <ac:chgData name="Hayk Barseghyan" userId="1af3c995-31f7-415e-9aa1-2b36900e994d" providerId="ADAL" clId="{817F6B4A-A95C-41F4-9215-42C8F6493746}" dt="2021-03-19T20:20:56.184" v="1219" actId="478"/>
          <ac:spMkLst>
            <pc:docMk/>
            <pc:sldMk cId="742313956" sldId="656"/>
            <ac:spMk id="37" creationId="{46E22F1A-4B6B-4497-A10E-1133F9386895}"/>
          </ac:spMkLst>
        </pc:spChg>
        <pc:spChg chg="mod">
          <ac:chgData name="Hayk Barseghyan" userId="1af3c995-31f7-415e-9aa1-2b36900e994d" providerId="ADAL" clId="{817F6B4A-A95C-41F4-9215-42C8F6493746}" dt="2021-03-19T20:24:10.896" v="1305" actId="1038"/>
          <ac:spMkLst>
            <pc:docMk/>
            <pc:sldMk cId="742313956" sldId="656"/>
            <ac:spMk id="40" creationId="{03C35834-9994-4DBC-A8F8-7F81D9308BC6}"/>
          </ac:spMkLst>
        </pc:spChg>
        <pc:spChg chg="mod">
          <ac:chgData name="Hayk Barseghyan" userId="1af3c995-31f7-415e-9aa1-2b36900e994d" providerId="ADAL" clId="{817F6B4A-A95C-41F4-9215-42C8F6493746}" dt="2021-03-19T20:24:10.896" v="1305" actId="1038"/>
          <ac:spMkLst>
            <pc:docMk/>
            <pc:sldMk cId="742313956" sldId="656"/>
            <ac:spMk id="41" creationId="{77AA0295-E04C-47D7-9AD2-E60A3E1CF6E9}"/>
          </ac:spMkLst>
        </pc:spChg>
        <pc:spChg chg="mod">
          <ac:chgData name="Hayk Barseghyan" userId="1af3c995-31f7-415e-9aa1-2b36900e994d" providerId="ADAL" clId="{817F6B4A-A95C-41F4-9215-42C8F6493746}" dt="2021-03-19T22:37:33.517" v="1528" actId="20577"/>
          <ac:spMkLst>
            <pc:docMk/>
            <pc:sldMk cId="742313956" sldId="656"/>
            <ac:spMk id="49" creationId="{270740F3-8276-4A91-AA98-A4A4273156A7}"/>
          </ac:spMkLst>
        </pc:spChg>
        <pc:spChg chg="del mod">
          <ac:chgData name="Hayk Barseghyan" userId="1af3c995-31f7-415e-9aa1-2b36900e994d" providerId="ADAL" clId="{817F6B4A-A95C-41F4-9215-42C8F6493746}" dt="2021-03-19T20:22:04.841" v="1224" actId="478"/>
          <ac:spMkLst>
            <pc:docMk/>
            <pc:sldMk cId="742313956" sldId="656"/>
            <ac:spMk id="53" creationId="{68B00FA6-B8FE-4BDC-965F-134174286DD9}"/>
          </ac:spMkLst>
        </pc:spChg>
        <pc:spChg chg="del mod">
          <ac:chgData name="Hayk Barseghyan" userId="1af3c995-31f7-415e-9aa1-2b36900e994d" providerId="ADAL" clId="{817F6B4A-A95C-41F4-9215-42C8F6493746}" dt="2021-03-19T20:22:06.524" v="1225" actId="478"/>
          <ac:spMkLst>
            <pc:docMk/>
            <pc:sldMk cId="742313956" sldId="656"/>
            <ac:spMk id="54" creationId="{E863B169-6BF6-4624-A891-6B3C9852B628}"/>
          </ac:spMkLst>
        </pc:spChg>
        <pc:spChg chg="del">
          <ac:chgData name="Hayk Barseghyan" userId="1af3c995-31f7-415e-9aa1-2b36900e994d" providerId="ADAL" clId="{817F6B4A-A95C-41F4-9215-42C8F6493746}" dt="2021-03-19T20:20:16.219" v="1212" actId="478"/>
          <ac:spMkLst>
            <pc:docMk/>
            <pc:sldMk cId="742313956" sldId="656"/>
            <ac:spMk id="76" creationId="{1C554B34-C002-4DB1-8784-4B391E209899}"/>
          </ac:spMkLst>
        </pc:spChg>
        <pc:spChg chg="del mod">
          <ac:chgData name="Hayk Barseghyan" userId="1af3c995-31f7-415e-9aa1-2b36900e994d" providerId="ADAL" clId="{817F6B4A-A95C-41F4-9215-42C8F6493746}" dt="2021-03-19T20:20:59.920" v="1220" actId="478"/>
          <ac:spMkLst>
            <pc:docMk/>
            <pc:sldMk cId="742313956" sldId="656"/>
            <ac:spMk id="90" creationId="{413DD0F0-9162-4A06-A57F-A2B4EFE8B4A8}"/>
          </ac:spMkLst>
        </pc:spChg>
        <pc:picChg chg="mod">
          <ac:chgData name="Hayk Barseghyan" userId="1af3c995-31f7-415e-9aa1-2b36900e994d" providerId="ADAL" clId="{817F6B4A-A95C-41F4-9215-42C8F6493746}" dt="2021-03-19T20:32:03.442" v="1414" actId="1076"/>
          <ac:picMkLst>
            <pc:docMk/>
            <pc:sldMk cId="742313956" sldId="656"/>
            <ac:picMk id="8" creationId="{2025D8F4-DB00-4692-A85A-11644A3ECBF3}"/>
          </ac:picMkLst>
        </pc:picChg>
        <pc:picChg chg="add del mod">
          <ac:chgData name="Hayk Barseghyan" userId="1af3c995-31f7-415e-9aa1-2b36900e994d" providerId="ADAL" clId="{817F6B4A-A95C-41F4-9215-42C8F6493746}" dt="2021-03-19T20:22:02.308" v="1223"/>
          <ac:picMkLst>
            <pc:docMk/>
            <pc:sldMk cId="742313956" sldId="656"/>
            <ac:picMk id="20" creationId="{EA598FD2-E34C-4E0F-BFB8-2B61BC828039}"/>
          </ac:picMkLst>
        </pc:picChg>
        <pc:picChg chg="mod">
          <ac:chgData name="Hayk Barseghyan" userId="1af3c995-31f7-415e-9aa1-2b36900e994d" providerId="ADAL" clId="{817F6B4A-A95C-41F4-9215-42C8F6493746}" dt="2021-03-19T20:24:20.889" v="1307" actId="1076"/>
          <ac:picMkLst>
            <pc:docMk/>
            <pc:sldMk cId="742313956" sldId="656"/>
            <ac:picMk id="31" creationId="{A423A7A3-37E0-495F-A41D-46390BECA406}"/>
          </ac:picMkLst>
        </pc:picChg>
        <pc:cxnChg chg="add mod">
          <ac:chgData name="Hayk Barseghyan" userId="1af3c995-31f7-415e-9aa1-2b36900e994d" providerId="ADAL" clId="{817F6B4A-A95C-41F4-9215-42C8F6493746}" dt="2021-03-19T20:31:59.421" v="1413" actId="14100"/>
          <ac:cxnSpMkLst>
            <pc:docMk/>
            <pc:sldMk cId="742313956" sldId="656"/>
            <ac:cxnSpMk id="15" creationId="{83C67EB0-D1EA-4634-9EF7-15A5E4407077}"/>
          </ac:cxnSpMkLst>
        </pc:cxnChg>
        <pc:cxnChg chg="del">
          <ac:chgData name="Hayk Barseghyan" userId="1af3c995-31f7-415e-9aa1-2b36900e994d" providerId="ADAL" clId="{817F6B4A-A95C-41F4-9215-42C8F6493746}" dt="2021-03-19T20:20:30.916" v="1214" actId="478"/>
          <ac:cxnSpMkLst>
            <pc:docMk/>
            <pc:sldMk cId="742313956" sldId="656"/>
            <ac:cxnSpMk id="33" creationId="{1B628404-82F4-4D74-879A-D2CAC769448A}"/>
          </ac:cxnSpMkLst>
        </pc:cxnChg>
      </pc:sldChg>
      <pc:sldChg chg="addSp delSp modSp mod modNotesTx">
        <pc:chgData name="Hayk Barseghyan" userId="1af3c995-31f7-415e-9aa1-2b36900e994d" providerId="ADAL" clId="{817F6B4A-A95C-41F4-9215-42C8F6493746}" dt="2021-03-19T20:26:31.189" v="1410" actId="14100"/>
        <pc:sldMkLst>
          <pc:docMk/>
          <pc:sldMk cId="2755479697" sldId="657"/>
        </pc:sldMkLst>
        <pc:spChg chg="del">
          <ac:chgData name="Hayk Barseghyan" userId="1af3c995-31f7-415e-9aa1-2b36900e994d" providerId="ADAL" clId="{817F6B4A-A95C-41F4-9215-42C8F6493746}" dt="2021-03-19T19:18:14.484" v="770" actId="478"/>
          <ac:spMkLst>
            <pc:docMk/>
            <pc:sldMk cId="2755479697" sldId="657"/>
            <ac:spMk id="28" creationId="{627423C8-B194-4935-85FA-5ED8C3D13EA3}"/>
          </ac:spMkLst>
        </pc:spChg>
        <pc:spChg chg="del">
          <ac:chgData name="Hayk Barseghyan" userId="1af3c995-31f7-415e-9aa1-2b36900e994d" providerId="ADAL" clId="{817F6B4A-A95C-41F4-9215-42C8F6493746}" dt="2021-03-19T20:24:41.431" v="1311" actId="478"/>
          <ac:spMkLst>
            <pc:docMk/>
            <pc:sldMk cId="2755479697" sldId="657"/>
            <ac:spMk id="30" creationId="{68ED1E75-B125-4C10-BB29-81E202553B2C}"/>
          </ac:spMkLst>
        </pc:spChg>
        <pc:spChg chg="add mod">
          <ac:chgData name="Hayk Barseghyan" userId="1af3c995-31f7-415e-9aa1-2b36900e994d" providerId="ADAL" clId="{817F6B4A-A95C-41F4-9215-42C8F6493746}" dt="2021-03-19T19:18:10.893" v="769" actId="1076"/>
          <ac:spMkLst>
            <pc:docMk/>
            <pc:sldMk cId="2755479697" sldId="657"/>
            <ac:spMk id="31" creationId="{9E94FD29-26A3-4250-90B8-01A2CDD1802D}"/>
          </ac:spMkLst>
        </pc:spChg>
        <pc:spChg chg="add 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33" creationId="{A160E36A-BAB1-47CD-94C7-4E111391A11F}"/>
          </ac:spMkLst>
        </pc:spChg>
        <pc:spChg chg="add 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34" creationId="{05CB38A4-C9D7-49FD-99AF-2F0DEDA1D811}"/>
          </ac:spMkLst>
        </pc:spChg>
        <pc:spChg chg="add del mod">
          <ac:chgData name="Hayk Barseghyan" userId="1af3c995-31f7-415e-9aa1-2b36900e994d" providerId="ADAL" clId="{817F6B4A-A95C-41F4-9215-42C8F6493746}" dt="2021-03-19T20:18:43.490" v="1172" actId="478"/>
          <ac:spMkLst>
            <pc:docMk/>
            <pc:sldMk cId="2755479697" sldId="657"/>
            <ac:spMk id="35" creationId="{01652DBF-632B-48E2-A912-418F65E63C77}"/>
          </ac:spMkLst>
        </pc:spChg>
        <pc:spChg chg="add del mod">
          <ac:chgData name="Hayk Barseghyan" userId="1af3c995-31f7-415e-9aa1-2b36900e994d" providerId="ADAL" clId="{817F6B4A-A95C-41F4-9215-42C8F6493746}" dt="2021-03-19T20:24:58.642" v="1314"/>
          <ac:spMkLst>
            <pc:docMk/>
            <pc:sldMk cId="2755479697" sldId="657"/>
            <ac:spMk id="36" creationId="{AAA6FDD3-1997-4440-B229-25C5E9AA3C78}"/>
          </ac:spMkLst>
        </pc:spChg>
        <pc:spChg chg="add mod">
          <ac:chgData name="Hayk Barseghyan" userId="1af3c995-31f7-415e-9aa1-2b36900e994d" providerId="ADAL" clId="{817F6B4A-A95C-41F4-9215-42C8F6493746}" dt="2021-03-19T20:25:26.396" v="1317"/>
          <ac:spMkLst>
            <pc:docMk/>
            <pc:sldMk cId="2755479697" sldId="657"/>
            <ac:spMk id="37" creationId="{8FB068C2-9704-43F5-A556-B959D1EBFF14}"/>
          </ac:spMkLst>
        </pc:spChg>
        <pc:spChg chg="add mod">
          <ac:chgData name="Hayk Barseghyan" userId="1af3c995-31f7-415e-9aa1-2b36900e994d" providerId="ADAL" clId="{817F6B4A-A95C-41F4-9215-42C8F6493746}" dt="2021-03-19T20:25:26.396" v="1317"/>
          <ac:spMkLst>
            <pc:docMk/>
            <pc:sldMk cId="2755479697" sldId="657"/>
            <ac:spMk id="38" creationId="{E1D4BE3F-7DAB-455D-95E5-C2EE8C764DA9}"/>
          </ac:spMkLst>
        </pc:spChg>
        <pc:spChg chg="del mod">
          <ac:chgData name="Hayk Barseghyan" userId="1af3c995-31f7-415e-9aa1-2b36900e994d" providerId="ADAL" clId="{817F6B4A-A95C-41F4-9215-42C8F6493746}" dt="2021-03-19T20:25:15.485" v="1315" actId="478"/>
          <ac:spMkLst>
            <pc:docMk/>
            <pc:sldMk cId="2755479697" sldId="657"/>
            <ac:spMk id="53" creationId="{68B00FA6-B8FE-4BDC-965F-134174286DD9}"/>
          </ac:spMkLst>
        </pc:spChg>
        <pc:spChg chg="del mod">
          <ac:chgData name="Hayk Barseghyan" userId="1af3c995-31f7-415e-9aa1-2b36900e994d" providerId="ADAL" clId="{817F6B4A-A95C-41F4-9215-42C8F6493746}" dt="2021-03-19T20:25:19.249" v="1316" actId="478"/>
          <ac:spMkLst>
            <pc:docMk/>
            <pc:sldMk cId="2755479697" sldId="657"/>
            <ac:spMk id="54" creationId="{E863B169-6BF6-4624-A891-6B3C9852B628}"/>
          </ac:spMkLst>
        </pc:spChg>
        <pc:spChg chg="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68" creationId="{34BD1FF5-2295-462F-BA39-E70FC71178F8}"/>
          </ac:spMkLst>
        </pc:spChg>
        <pc:spChg chg="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71" creationId="{5AADF1D3-8691-430F-89D1-A94B46D2A263}"/>
          </ac:spMkLst>
        </pc:spChg>
        <pc:spChg chg="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72" creationId="{6E8E9403-AB50-4FEB-B4C4-601B6706A470}"/>
          </ac:spMkLst>
        </pc:spChg>
        <pc:spChg chg="mod">
          <ac:chgData name="Hayk Barseghyan" userId="1af3c995-31f7-415e-9aa1-2b36900e994d" providerId="ADAL" clId="{817F6B4A-A95C-41F4-9215-42C8F6493746}" dt="2021-03-19T20:26:23.694" v="1409" actId="14100"/>
          <ac:spMkLst>
            <pc:docMk/>
            <pc:sldMk cId="2755479697" sldId="657"/>
            <ac:spMk id="73" creationId="{1D26E09B-A378-4E7C-B3BE-7B103434FCB6}"/>
          </ac:spMkLst>
        </pc:spChg>
        <pc:spChg chg="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78" creationId="{A378CE8E-FD3C-4B20-A24B-AF9809EA6C83}"/>
          </ac:spMkLst>
        </pc:spChg>
        <pc:spChg chg="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79" creationId="{C51ADB4D-3640-45C3-80EF-5502C71420FD}"/>
          </ac:spMkLst>
        </pc:spChg>
        <pc:spChg chg="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81" creationId="{07786BAB-F6A6-4296-89B6-7CA9DAA57F71}"/>
          </ac:spMkLst>
        </pc:spChg>
        <pc:spChg chg="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82" creationId="{6061F006-A694-4901-A849-27628F0B9AA7}"/>
          </ac:spMkLst>
        </pc:spChg>
        <pc:spChg chg="del">
          <ac:chgData name="Hayk Barseghyan" userId="1af3c995-31f7-415e-9aa1-2b36900e994d" providerId="ADAL" clId="{817F6B4A-A95C-41F4-9215-42C8F6493746}" dt="2021-03-19T19:18:26.105" v="772" actId="478"/>
          <ac:spMkLst>
            <pc:docMk/>
            <pc:sldMk cId="2755479697" sldId="657"/>
            <ac:spMk id="88" creationId="{2562C061-A185-46DF-B9DE-A215AEBDE50B}"/>
          </ac:spMkLst>
        </pc:spChg>
        <pc:spChg chg="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91" creationId="{890F756B-174F-4736-BB50-7F07F8A6C603}"/>
          </ac:spMkLst>
        </pc:spChg>
        <pc:spChg chg="mod">
          <ac:chgData name="Hayk Barseghyan" userId="1af3c995-31f7-415e-9aa1-2b36900e994d" providerId="ADAL" clId="{817F6B4A-A95C-41F4-9215-42C8F6493746}" dt="2021-03-19T20:25:53.686" v="1383" actId="1037"/>
          <ac:spMkLst>
            <pc:docMk/>
            <pc:sldMk cId="2755479697" sldId="657"/>
            <ac:spMk id="94" creationId="{BF106B4E-9057-4F0F-B25D-27BD2332C592}"/>
          </ac:spMkLst>
        </pc:spChg>
        <pc:spChg chg="mod">
          <ac:chgData name="Hayk Barseghyan" userId="1af3c995-31f7-415e-9aa1-2b36900e994d" providerId="ADAL" clId="{817F6B4A-A95C-41F4-9215-42C8F6493746}" dt="2021-03-19T20:26:31.189" v="1410" actId="14100"/>
          <ac:spMkLst>
            <pc:docMk/>
            <pc:sldMk cId="2755479697" sldId="657"/>
            <ac:spMk id="99" creationId="{5463678B-2C98-4048-B0E3-1D5FC1D58F2B}"/>
          </ac:spMkLst>
        </pc:spChg>
        <pc:picChg chg="mod">
          <ac:chgData name="Hayk Barseghyan" userId="1af3c995-31f7-415e-9aa1-2b36900e994d" providerId="ADAL" clId="{817F6B4A-A95C-41F4-9215-42C8F6493746}" dt="2021-03-19T20:25:53.686" v="1383" actId="1037"/>
          <ac:picMkLst>
            <pc:docMk/>
            <pc:sldMk cId="2755479697" sldId="657"/>
            <ac:picMk id="6" creationId="{647E26B7-A751-4F7B-AE55-58021DFF200F}"/>
          </ac:picMkLst>
        </pc:picChg>
        <pc:picChg chg="mod">
          <ac:chgData name="Hayk Barseghyan" userId="1af3c995-31f7-415e-9aa1-2b36900e994d" providerId="ADAL" clId="{817F6B4A-A95C-41F4-9215-42C8F6493746}" dt="2021-03-19T20:25:53.686" v="1383" actId="1037"/>
          <ac:picMkLst>
            <pc:docMk/>
            <pc:sldMk cId="2755479697" sldId="657"/>
            <ac:picMk id="18" creationId="{F227534F-7555-45D8-89C1-5409D1E697AC}"/>
          </ac:picMkLst>
        </pc:picChg>
        <pc:picChg chg="mod">
          <ac:chgData name="Hayk Barseghyan" userId="1af3c995-31f7-415e-9aa1-2b36900e994d" providerId="ADAL" clId="{817F6B4A-A95C-41F4-9215-42C8F6493746}" dt="2021-03-19T20:26:19.136" v="1408" actId="1037"/>
          <ac:picMkLst>
            <pc:docMk/>
            <pc:sldMk cId="2755479697" sldId="657"/>
            <ac:picMk id="29" creationId="{CF9A21CF-EDBB-4665-A266-4092EEDE63E8}"/>
          </ac:picMkLst>
        </pc:picChg>
        <pc:picChg chg="add del mod">
          <ac:chgData name="Hayk Barseghyan" userId="1af3c995-31f7-415e-9aa1-2b36900e994d" providerId="ADAL" clId="{817F6B4A-A95C-41F4-9215-42C8F6493746}" dt="2021-03-19T20:26:19.136" v="1408" actId="1037"/>
          <ac:picMkLst>
            <pc:docMk/>
            <pc:sldMk cId="2755479697" sldId="657"/>
            <ac:picMk id="32" creationId="{9C4F5BC9-4380-4AC1-A310-9AB023C36173}"/>
          </ac:picMkLst>
        </pc:picChg>
        <pc:cxnChg chg="mod">
          <ac:chgData name="Hayk Barseghyan" userId="1af3c995-31f7-415e-9aa1-2b36900e994d" providerId="ADAL" clId="{817F6B4A-A95C-41F4-9215-42C8F6493746}" dt="2021-03-19T20:25:53.686" v="1383" actId="1037"/>
          <ac:cxnSpMkLst>
            <pc:docMk/>
            <pc:sldMk cId="2755479697" sldId="657"/>
            <ac:cxnSpMk id="83" creationId="{58D0C8E9-615F-4BB4-8DBD-A90AD120C04D}"/>
          </ac:cxnSpMkLst>
        </pc:cxnChg>
        <pc:cxnChg chg="mod">
          <ac:chgData name="Hayk Barseghyan" userId="1af3c995-31f7-415e-9aa1-2b36900e994d" providerId="ADAL" clId="{817F6B4A-A95C-41F4-9215-42C8F6493746}" dt="2021-03-19T20:25:53.686" v="1383" actId="1037"/>
          <ac:cxnSpMkLst>
            <pc:docMk/>
            <pc:sldMk cId="2755479697" sldId="657"/>
            <ac:cxnSpMk id="85" creationId="{0EF1E4F0-CD42-453C-B817-5170CC59B83F}"/>
          </ac:cxnSpMkLst>
        </pc:cxnChg>
        <pc:cxnChg chg="mod">
          <ac:chgData name="Hayk Barseghyan" userId="1af3c995-31f7-415e-9aa1-2b36900e994d" providerId="ADAL" clId="{817F6B4A-A95C-41F4-9215-42C8F6493746}" dt="2021-03-19T20:26:31.189" v="1410" actId="14100"/>
          <ac:cxnSpMkLst>
            <pc:docMk/>
            <pc:sldMk cId="2755479697" sldId="657"/>
            <ac:cxnSpMk id="95" creationId="{16507A16-B1EA-41FC-BA29-6F79662AB745}"/>
          </ac:cxnSpMkLst>
        </pc:cxnChg>
        <pc:cxnChg chg="mod">
          <ac:chgData name="Hayk Barseghyan" userId="1af3c995-31f7-415e-9aa1-2b36900e994d" providerId="ADAL" clId="{817F6B4A-A95C-41F4-9215-42C8F6493746}" dt="2021-03-19T20:26:31.189" v="1410" actId="14100"/>
          <ac:cxnSpMkLst>
            <pc:docMk/>
            <pc:sldMk cId="2755479697" sldId="657"/>
            <ac:cxnSpMk id="96" creationId="{0E9D330C-7EF6-4A8F-8BD0-1DFEE913D44D}"/>
          </ac:cxnSpMkLst>
        </pc:cxnChg>
        <pc:cxnChg chg="mod">
          <ac:chgData name="Hayk Barseghyan" userId="1af3c995-31f7-415e-9aa1-2b36900e994d" providerId="ADAL" clId="{817F6B4A-A95C-41F4-9215-42C8F6493746}" dt="2021-03-19T20:26:23.694" v="1409" actId="14100"/>
          <ac:cxnSpMkLst>
            <pc:docMk/>
            <pc:sldMk cId="2755479697" sldId="657"/>
            <ac:cxnSpMk id="98" creationId="{17657C10-69D0-4CE3-8C03-DFB56D86A81D}"/>
          </ac:cxnSpMkLst>
        </pc:cxnChg>
        <pc:cxnChg chg="mod">
          <ac:chgData name="Hayk Barseghyan" userId="1af3c995-31f7-415e-9aa1-2b36900e994d" providerId="ADAL" clId="{817F6B4A-A95C-41F4-9215-42C8F6493746}" dt="2021-03-19T20:25:53.686" v="1383" actId="1037"/>
          <ac:cxnSpMkLst>
            <pc:docMk/>
            <pc:sldMk cId="2755479697" sldId="657"/>
            <ac:cxnSpMk id="101" creationId="{19BBA3F5-EFCD-49F7-BDCC-66B89FA196B9}"/>
          </ac:cxnSpMkLst>
        </pc:cxnChg>
        <pc:cxnChg chg="mod">
          <ac:chgData name="Hayk Barseghyan" userId="1af3c995-31f7-415e-9aa1-2b36900e994d" providerId="ADAL" clId="{817F6B4A-A95C-41F4-9215-42C8F6493746}" dt="2021-03-19T20:25:53.686" v="1383" actId="1037"/>
          <ac:cxnSpMkLst>
            <pc:docMk/>
            <pc:sldMk cId="2755479697" sldId="657"/>
            <ac:cxnSpMk id="104" creationId="{05153E8D-36D1-430B-B3A6-660A80B985D2}"/>
          </ac:cxnSpMkLst>
        </pc:cxnChg>
      </pc:sldChg>
      <pc:sldChg chg="delSp del mod">
        <pc:chgData name="Hayk Barseghyan" userId="1af3c995-31f7-415e-9aa1-2b36900e994d" providerId="ADAL" clId="{817F6B4A-A95C-41F4-9215-42C8F6493746}" dt="2021-03-19T20:44:28.340" v="1439" actId="47"/>
        <pc:sldMkLst>
          <pc:docMk/>
          <pc:sldMk cId="1987727170" sldId="658"/>
        </pc:sldMkLst>
        <pc:spChg chg="del">
          <ac:chgData name="Hayk Barseghyan" userId="1af3c995-31f7-415e-9aa1-2b36900e994d" providerId="ADAL" clId="{817F6B4A-A95C-41F4-9215-42C8F6493746}" dt="2021-03-19T20:32:41.597" v="1416" actId="478"/>
          <ac:spMkLst>
            <pc:docMk/>
            <pc:sldMk cId="1987727170" sldId="658"/>
            <ac:spMk id="30" creationId="{68ED1E75-B125-4C10-BB29-81E202553B2C}"/>
          </ac:spMkLst>
        </pc:spChg>
        <pc:picChg chg="del">
          <ac:chgData name="Hayk Barseghyan" userId="1af3c995-31f7-415e-9aa1-2b36900e994d" providerId="ADAL" clId="{817F6B4A-A95C-41F4-9215-42C8F6493746}" dt="2021-03-19T20:32:55.157" v="1418" actId="21"/>
          <ac:picMkLst>
            <pc:docMk/>
            <pc:sldMk cId="1987727170" sldId="658"/>
            <ac:picMk id="4" creationId="{CB449226-8FE1-4D7C-86AE-CECE2F887C09}"/>
          </ac:picMkLst>
        </pc:picChg>
      </pc:sldChg>
      <pc:sldChg chg="del">
        <pc:chgData name="Hayk Barseghyan" userId="1af3c995-31f7-415e-9aa1-2b36900e994d" providerId="ADAL" clId="{817F6B4A-A95C-41F4-9215-42C8F6493746}" dt="2021-03-19T19:11:37.656" v="754" actId="47"/>
        <pc:sldMkLst>
          <pc:docMk/>
          <pc:sldMk cId="810307725" sldId="659"/>
        </pc:sldMkLst>
      </pc:sldChg>
      <pc:sldChg chg="addSp delSp mod modNotesTx">
        <pc:chgData name="Hayk Barseghyan" userId="1af3c995-31f7-415e-9aa1-2b36900e994d" providerId="ADAL" clId="{817F6B4A-A95C-41F4-9215-42C8F6493746}" dt="2021-03-19T20:49:58.668" v="1469"/>
        <pc:sldMkLst>
          <pc:docMk/>
          <pc:sldMk cId="2000704347" sldId="660"/>
        </pc:sldMkLst>
        <pc:picChg chg="add del">
          <ac:chgData name="Hayk Barseghyan" userId="1af3c995-31f7-415e-9aa1-2b36900e994d" providerId="ADAL" clId="{817F6B4A-A95C-41F4-9215-42C8F6493746}" dt="2021-03-19T20:04:47.395" v="884" actId="478"/>
          <ac:picMkLst>
            <pc:docMk/>
            <pc:sldMk cId="2000704347" sldId="660"/>
            <ac:picMk id="3" creationId="{64B432B6-4C2F-4EEC-9B98-8AFD62C7DA76}"/>
          </ac:picMkLst>
        </pc:picChg>
        <pc:picChg chg="add del">
          <ac:chgData name="Hayk Barseghyan" userId="1af3c995-31f7-415e-9aa1-2b36900e994d" providerId="ADAL" clId="{817F6B4A-A95C-41F4-9215-42C8F6493746}" dt="2021-03-19T20:04:50.689" v="886" actId="478"/>
          <ac:picMkLst>
            <pc:docMk/>
            <pc:sldMk cId="2000704347" sldId="660"/>
            <ac:picMk id="5" creationId="{48CFAF9A-B9B5-437C-BDB3-2565179B574E}"/>
          </ac:picMkLst>
        </pc:picChg>
      </pc:sldChg>
      <pc:sldChg chg="addSp delSp modSp mod modNotesTx">
        <pc:chgData name="Hayk Barseghyan" userId="1af3c995-31f7-415e-9aa1-2b36900e994d" providerId="ADAL" clId="{817F6B4A-A95C-41F4-9215-42C8F6493746}" dt="2021-03-19T20:48:44.844" v="1456"/>
        <pc:sldMkLst>
          <pc:docMk/>
          <pc:sldMk cId="3227928584" sldId="661"/>
        </pc:sldMkLst>
        <pc:spChg chg="add mod">
          <ac:chgData name="Hayk Barseghyan" userId="1af3c995-31f7-415e-9aa1-2b36900e994d" providerId="ADAL" clId="{817F6B4A-A95C-41F4-9215-42C8F6493746}" dt="2021-03-19T20:48:26.798" v="1454" actId="20577"/>
          <ac:spMkLst>
            <pc:docMk/>
            <pc:sldMk cId="3227928584" sldId="661"/>
            <ac:spMk id="7" creationId="{E71A5CF8-4675-4894-B98F-9790B8805E6A}"/>
          </ac:spMkLst>
        </pc:spChg>
        <pc:spChg chg="del">
          <ac:chgData name="Hayk Barseghyan" userId="1af3c995-31f7-415e-9aa1-2b36900e994d" providerId="ADAL" clId="{817F6B4A-A95C-41F4-9215-42C8F6493746}" dt="2021-03-19T20:44:34.019" v="1440" actId="478"/>
          <ac:spMkLst>
            <pc:docMk/>
            <pc:sldMk cId="3227928584" sldId="661"/>
            <ac:spMk id="28" creationId="{627423C8-B194-4935-85FA-5ED8C3D13EA3}"/>
          </ac:spMkLst>
        </pc:spChg>
        <pc:spChg chg="del">
          <ac:chgData name="Hayk Barseghyan" userId="1af3c995-31f7-415e-9aa1-2b36900e994d" providerId="ADAL" clId="{817F6B4A-A95C-41F4-9215-42C8F6493746}" dt="2021-03-19T20:44:34.019" v="1440" actId="478"/>
          <ac:spMkLst>
            <pc:docMk/>
            <pc:sldMk cId="3227928584" sldId="661"/>
            <ac:spMk id="30" creationId="{68ED1E75-B125-4C10-BB29-81E202553B2C}"/>
          </ac:spMkLst>
        </pc:spChg>
        <pc:spChg chg="del">
          <ac:chgData name="Hayk Barseghyan" userId="1af3c995-31f7-415e-9aa1-2b36900e994d" providerId="ADAL" clId="{817F6B4A-A95C-41F4-9215-42C8F6493746}" dt="2021-03-19T20:44:34.019" v="1440" actId="478"/>
          <ac:spMkLst>
            <pc:docMk/>
            <pc:sldMk cId="3227928584" sldId="661"/>
            <ac:spMk id="53" creationId="{68B00FA6-B8FE-4BDC-965F-134174286DD9}"/>
          </ac:spMkLst>
        </pc:spChg>
        <pc:spChg chg="del">
          <ac:chgData name="Hayk Barseghyan" userId="1af3c995-31f7-415e-9aa1-2b36900e994d" providerId="ADAL" clId="{817F6B4A-A95C-41F4-9215-42C8F6493746}" dt="2021-03-19T20:44:34.019" v="1440" actId="478"/>
          <ac:spMkLst>
            <pc:docMk/>
            <pc:sldMk cId="3227928584" sldId="661"/>
            <ac:spMk id="54" creationId="{E863B169-6BF6-4624-A891-6B3C9852B628}"/>
          </ac:spMkLst>
        </pc:spChg>
      </pc:sldChg>
      <pc:sldChg chg="delSp modSp add del mod modNotesTx">
        <pc:chgData name="Hayk Barseghyan" userId="1af3c995-31f7-415e-9aa1-2b36900e994d" providerId="ADAL" clId="{817F6B4A-A95C-41F4-9215-42C8F6493746}" dt="2021-03-19T17:38:17.622" v="222" actId="47"/>
        <pc:sldMkLst>
          <pc:docMk/>
          <pc:sldMk cId="2045322269" sldId="662"/>
        </pc:sldMkLst>
        <pc:spChg chg="del">
          <ac:chgData name="Hayk Barseghyan" userId="1af3c995-31f7-415e-9aa1-2b36900e994d" providerId="ADAL" clId="{817F6B4A-A95C-41F4-9215-42C8F6493746}" dt="2021-03-19T17:37:17.086" v="168" actId="478"/>
          <ac:spMkLst>
            <pc:docMk/>
            <pc:sldMk cId="2045322269" sldId="662"/>
            <ac:spMk id="15" creationId="{1DA809E1-700B-4B5F-80D1-146841C532CC}"/>
          </ac:spMkLst>
        </pc:spChg>
        <pc:spChg chg="del">
          <ac:chgData name="Hayk Barseghyan" userId="1af3c995-31f7-415e-9aa1-2b36900e994d" providerId="ADAL" clId="{817F6B4A-A95C-41F4-9215-42C8F6493746}" dt="2021-03-19T17:37:17.086" v="168" actId="478"/>
          <ac:spMkLst>
            <pc:docMk/>
            <pc:sldMk cId="2045322269" sldId="662"/>
            <ac:spMk id="16" creationId="{219D3844-749C-4AC5-8AAC-A5A6E4F706D5}"/>
          </ac:spMkLst>
        </pc:spChg>
        <pc:spChg chg="del">
          <ac:chgData name="Hayk Barseghyan" userId="1af3c995-31f7-415e-9aa1-2b36900e994d" providerId="ADAL" clId="{817F6B4A-A95C-41F4-9215-42C8F6493746}" dt="2021-03-19T17:37:17.086" v="168" actId="478"/>
          <ac:spMkLst>
            <pc:docMk/>
            <pc:sldMk cId="2045322269" sldId="662"/>
            <ac:spMk id="17" creationId="{238D452B-545B-49D2-9AA5-4774F789BA52}"/>
          </ac:spMkLst>
        </pc:spChg>
        <pc:spChg chg="del">
          <ac:chgData name="Hayk Barseghyan" userId="1af3c995-31f7-415e-9aa1-2b36900e994d" providerId="ADAL" clId="{817F6B4A-A95C-41F4-9215-42C8F6493746}" dt="2021-03-19T17:37:17.086" v="168" actId="478"/>
          <ac:spMkLst>
            <pc:docMk/>
            <pc:sldMk cId="2045322269" sldId="662"/>
            <ac:spMk id="18" creationId="{3B330CDD-DF8E-4329-9F8F-0C05A3EBA278}"/>
          </ac:spMkLst>
        </pc:spChg>
        <pc:spChg chg="del">
          <ac:chgData name="Hayk Barseghyan" userId="1af3c995-31f7-415e-9aa1-2b36900e994d" providerId="ADAL" clId="{817F6B4A-A95C-41F4-9215-42C8F6493746}" dt="2021-03-19T17:37:17.086" v="168" actId="478"/>
          <ac:spMkLst>
            <pc:docMk/>
            <pc:sldMk cId="2045322269" sldId="662"/>
            <ac:spMk id="19" creationId="{92E3FBB9-4482-4901-BB7B-515414A60BF3}"/>
          </ac:spMkLst>
        </pc:spChg>
        <pc:spChg chg="del">
          <ac:chgData name="Hayk Barseghyan" userId="1af3c995-31f7-415e-9aa1-2b36900e994d" providerId="ADAL" clId="{817F6B4A-A95C-41F4-9215-42C8F6493746}" dt="2021-03-19T17:37:17.086" v="168" actId="478"/>
          <ac:spMkLst>
            <pc:docMk/>
            <pc:sldMk cId="2045322269" sldId="662"/>
            <ac:spMk id="20" creationId="{33617DAE-E7EA-4947-A705-85255111007E}"/>
          </ac:spMkLst>
        </pc:spChg>
        <pc:spChg chg="del">
          <ac:chgData name="Hayk Barseghyan" userId="1af3c995-31f7-415e-9aa1-2b36900e994d" providerId="ADAL" clId="{817F6B4A-A95C-41F4-9215-42C8F6493746}" dt="2021-03-19T17:37:17.086" v="168" actId="478"/>
          <ac:spMkLst>
            <pc:docMk/>
            <pc:sldMk cId="2045322269" sldId="662"/>
            <ac:spMk id="21" creationId="{C9A0FE9C-502B-4BBD-8A60-74F846E3930A}"/>
          </ac:spMkLst>
        </pc:spChg>
        <pc:spChg chg="del">
          <ac:chgData name="Hayk Barseghyan" userId="1af3c995-31f7-415e-9aa1-2b36900e994d" providerId="ADAL" clId="{817F6B4A-A95C-41F4-9215-42C8F6493746}" dt="2021-03-19T17:37:18.685" v="169" actId="478"/>
          <ac:spMkLst>
            <pc:docMk/>
            <pc:sldMk cId="2045322269" sldId="662"/>
            <ac:spMk id="22" creationId="{097F0FB6-DB3D-4B12-9E76-180A15D9B845}"/>
          </ac:spMkLst>
        </pc:spChg>
        <pc:spChg chg="mod">
          <ac:chgData name="Hayk Barseghyan" userId="1af3c995-31f7-415e-9aa1-2b36900e994d" providerId="ADAL" clId="{817F6B4A-A95C-41F4-9215-42C8F6493746}" dt="2021-03-19T17:36:39.005" v="162" actId="20577"/>
          <ac:spMkLst>
            <pc:docMk/>
            <pc:sldMk cId="2045322269" sldId="662"/>
            <ac:spMk id="33" creationId="{27D04DB1-6D7F-4335-AAA1-99D44F3F14E9}"/>
          </ac:spMkLst>
        </pc:spChg>
        <pc:picChg chg="del">
          <ac:chgData name="Hayk Barseghyan" userId="1af3c995-31f7-415e-9aa1-2b36900e994d" providerId="ADAL" clId="{817F6B4A-A95C-41F4-9215-42C8F6493746}" dt="2021-03-19T17:37:17.086" v="168" actId="478"/>
          <ac:picMkLst>
            <pc:docMk/>
            <pc:sldMk cId="2045322269" sldId="662"/>
            <ac:picMk id="14" creationId="{BD596D5A-A8B5-4F23-971B-B0033B030440}"/>
          </ac:picMkLst>
        </pc:picChg>
        <pc:cxnChg chg="del mod">
          <ac:chgData name="Hayk Barseghyan" userId="1af3c995-31f7-415e-9aa1-2b36900e994d" providerId="ADAL" clId="{817F6B4A-A95C-41F4-9215-42C8F6493746}" dt="2021-03-19T17:37:17.086" v="168" actId="478"/>
          <ac:cxnSpMkLst>
            <pc:docMk/>
            <pc:sldMk cId="2045322269" sldId="662"/>
            <ac:cxnSpMk id="23" creationId="{B97A16ED-5542-4DD1-94CA-D032D3F72196}"/>
          </ac:cxnSpMkLst>
        </pc:cxnChg>
        <pc:cxnChg chg="del mod">
          <ac:chgData name="Hayk Barseghyan" userId="1af3c995-31f7-415e-9aa1-2b36900e994d" providerId="ADAL" clId="{817F6B4A-A95C-41F4-9215-42C8F6493746}" dt="2021-03-19T17:37:17.086" v="168" actId="478"/>
          <ac:cxnSpMkLst>
            <pc:docMk/>
            <pc:sldMk cId="2045322269" sldId="662"/>
            <ac:cxnSpMk id="24" creationId="{792D8F66-E748-410F-BB9B-B632B254BDFB}"/>
          </ac:cxnSpMkLst>
        </pc:cxnChg>
        <pc:cxnChg chg="del mod">
          <ac:chgData name="Hayk Barseghyan" userId="1af3c995-31f7-415e-9aa1-2b36900e994d" providerId="ADAL" clId="{817F6B4A-A95C-41F4-9215-42C8F6493746}" dt="2021-03-19T17:37:17.086" v="168" actId="478"/>
          <ac:cxnSpMkLst>
            <pc:docMk/>
            <pc:sldMk cId="2045322269" sldId="662"/>
            <ac:cxnSpMk id="25" creationId="{A4F48631-3605-414B-96A3-B4E7701F3903}"/>
          </ac:cxnSpMkLst>
        </pc:cxnChg>
      </pc:sldChg>
      <pc:sldChg chg="addSp delSp modSp add mod modNotesTx">
        <pc:chgData name="Hayk Barseghyan" userId="1af3c995-31f7-415e-9aa1-2b36900e994d" providerId="ADAL" clId="{817F6B4A-A95C-41F4-9215-42C8F6493746}" dt="2021-03-19T20:18:11.844" v="1170" actId="20577"/>
        <pc:sldMkLst>
          <pc:docMk/>
          <pc:sldMk cId="47234520" sldId="663"/>
        </pc:sldMkLst>
        <pc:spChg chg="del">
          <ac:chgData name="Hayk Barseghyan" userId="1af3c995-31f7-415e-9aa1-2b36900e994d" providerId="ADAL" clId="{817F6B4A-A95C-41F4-9215-42C8F6493746}" dt="2021-03-19T17:38:22.257" v="223" actId="478"/>
          <ac:spMkLst>
            <pc:docMk/>
            <pc:sldMk cId="47234520" sldId="663"/>
            <ac:spMk id="15" creationId="{1DA809E1-700B-4B5F-80D1-146841C532CC}"/>
          </ac:spMkLst>
        </pc:spChg>
        <pc:spChg chg="del">
          <ac:chgData name="Hayk Barseghyan" userId="1af3c995-31f7-415e-9aa1-2b36900e994d" providerId="ADAL" clId="{817F6B4A-A95C-41F4-9215-42C8F6493746}" dt="2021-03-19T17:38:22.257" v="223" actId="478"/>
          <ac:spMkLst>
            <pc:docMk/>
            <pc:sldMk cId="47234520" sldId="663"/>
            <ac:spMk id="16" creationId="{219D3844-749C-4AC5-8AAC-A5A6E4F706D5}"/>
          </ac:spMkLst>
        </pc:spChg>
        <pc:spChg chg="del">
          <ac:chgData name="Hayk Barseghyan" userId="1af3c995-31f7-415e-9aa1-2b36900e994d" providerId="ADAL" clId="{817F6B4A-A95C-41F4-9215-42C8F6493746}" dt="2021-03-19T17:38:22.257" v="223" actId="478"/>
          <ac:spMkLst>
            <pc:docMk/>
            <pc:sldMk cId="47234520" sldId="663"/>
            <ac:spMk id="17" creationId="{238D452B-545B-49D2-9AA5-4774F789BA52}"/>
          </ac:spMkLst>
        </pc:spChg>
        <pc:spChg chg="del">
          <ac:chgData name="Hayk Barseghyan" userId="1af3c995-31f7-415e-9aa1-2b36900e994d" providerId="ADAL" clId="{817F6B4A-A95C-41F4-9215-42C8F6493746}" dt="2021-03-19T17:38:22.257" v="223" actId="478"/>
          <ac:spMkLst>
            <pc:docMk/>
            <pc:sldMk cId="47234520" sldId="663"/>
            <ac:spMk id="18" creationId="{3B330CDD-DF8E-4329-9F8F-0C05A3EBA278}"/>
          </ac:spMkLst>
        </pc:spChg>
        <pc:spChg chg="del">
          <ac:chgData name="Hayk Barseghyan" userId="1af3c995-31f7-415e-9aa1-2b36900e994d" providerId="ADAL" clId="{817F6B4A-A95C-41F4-9215-42C8F6493746}" dt="2021-03-19T17:38:22.257" v="223" actId="478"/>
          <ac:spMkLst>
            <pc:docMk/>
            <pc:sldMk cId="47234520" sldId="663"/>
            <ac:spMk id="19" creationId="{92E3FBB9-4482-4901-BB7B-515414A60BF3}"/>
          </ac:spMkLst>
        </pc:spChg>
        <pc:spChg chg="del">
          <ac:chgData name="Hayk Barseghyan" userId="1af3c995-31f7-415e-9aa1-2b36900e994d" providerId="ADAL" clId="{817F6B4A-A95C-41F4-9215-42C8F6493746}" dt="2021-03-19T17:38:22.257" v="223" actId="478"/>
          <ac:spMkLst>
            <pc:docMk/>
            <pc:sldMk cId="47234520" sldId="663"/>
            <ac:spMk id="20" creationId="{33617DAE-E7EA-4947-A705-85255111007E}"/>
          </ac:spMkLst>
        </pc:spChg>
        <pc:spChg chg="del">
          <ac:chgData name="Hayk Barseghyan" userId="1af3c995-31f7-415e-9aa1-2b36900e994d" providerId="ADAL" clId="{817F6B4A-A95C-41F4-9215-42C8F6493746}" dt="2021-03-19T17:38:22.257" v="223" actId="478"/>
          <ac:spMkLst>
            <pc:docMk/>
            <pc:sldMk cId="47234520" sldId="663"/>
            <ac:spMk id="21" creationId="{C9A0FE9C-502B-4BBD-8A60-74F846E3930A}"/>
          </ac:spMkLst>
        </pc:spChg>
        <pc:spChg chg="del">
          <ac:chgData name="Hayk Barseghyan" userId="1af3c995-31f7-415e-9aa1-2b36900e994d" providerId="ADAL" clId="{817F6B4A-A95C-41F4-9215-42C8F6493746}" dt="2021-03-19T17:38:24.420" v="224" actId="478"/>
          <ac:spMkLst>
            <pc:docMk/>
            <pc:sldMk cId="47234520" sldId="663"/>
            <ac:spMk id="22" creationId="{097F0FB6-DB3D-4B12-9E76-180A15D9B845}"/>
          </ac:spMkLst>
        </pc:spChg>
        <pc:spChg chg="del mod">
          <ac:chgData name="Hayk Barseghyan" userId="1af3c995-31f7-415e-9aa1-2b36900e994d" providerId="ADAL" clId="{817F6B4A-A95C-41F4-9215-42C8F6493746}" dt="2021-03-19T18:40:32.563" v="377" actId="478"/>
          <ac:spMkLst>
            <pc:docMk/>
            <pc:sldMk cId="47234520" sldId="663"/>
            <ac:spMk id="28" creationId="{627423C8-B194-4935-85FA-5ED8C3D13EA3}"/>
          </ac:spMkLst>
        </pc:spChg>
        <pc:spChg chg="del">
          <ac:chgData name="Hayk Barseghyan" userId="1af3c995-31f7-415e-9aa1-2b36900e994d" providerId="ADAL" clId="{817F6B4A-A95C-41F4-9215-42C8F6493746}" dt="2021-03-19T17:39:14.623" v="239" actId="478"/>
          <ac:spMkLst>
            <pc:docMk/>
            <pc:sldMk cId="47234520" sldId="663"/>
            <ac:spMk id="30" creationId="{68ED1E75-B125-4C10-BB29-81E202553B2C}"/>
          </ac:spMkLst>
        </pc:spChg>
        <pc:spChg chg="mod">
          <ac:chgData name="Hayk Barseghyan" userId="1af3c995-31f7-415e-9aa1-2b36900e994d" providerId="ADAL" clId="{817F6B4A-A95C-41F4-9215-42C8F6493746}" dt="2021-03-19T17:38:28.509" v="225" actId="20577"/>
          <ac:spMkLst>
            <pc:docMk/>
            <pc:sldMk cId="47234520" sldId="663"/>
            <ac:spMk id="33" creationId="{27D04DB1-6D7F-4335-AAA1-99D44F3F14E9}"/>
          </ac:spMkLst>
        </pc:spChg>
        <pc:spChg chg="del">
          <ac:chgData name="Hayk Barseghyan" userId="1af3c995-31f7-415e-9aa1-2b36900e994d" providerId="ADAL" clId="{817F6B4A-A95C-41F4-9215-42C8F6493746}" dt="2021-03-19T17:57:07.832" v="255" actId="478"/>
          <ac:spMkLst>
            <pc:docMk/>
            <pc:sldMk cId="47234520" sldId="663"/>
            <ac:spMk id="34" creationId="{9E232FB5-9A42-4416-8E4E-5620B622F041}"/>
          </ac:spMkLst>
        </pc:spChg>
        <pc:spChg chg="mod">
          <ac:chgData name="Hayk Barseghyan" userId="1af3c995-31f7-415e-9aa1-2b36900e994d" providerId="ADAL" clId="{817F6B4A-A95C-41F4-9215-42C8F6493746}" dt="2021-03-19T18:42:59.046" v="455" actId="14100"/>
          <ac:spMkLst>
            <pc:docMk/>
            <pc:sldMk cId="47234520" sldId="663"/>
            <ac:spMk id="36" creationId="{D1390CDB-8C38-45E4-B737-627C1887B062}"/>
          </ac:spMkLst>
        </pc:spChg>
        <pc:spChg chg="add del mod">
          <ac:chgData name="Hayk Barseghyan" userId="1af3c995-31f7-415e-9aa1-2b36900e994d" providerId="ADAL" clId="{817F6B4A-A95C-41F4-9215-42C8F6493746}" dt="2021-03-19T17:39:12.307" v="238"/>
          <ac:spMkLst>
            <pc:docMk/>
            <pc:sldMk cId="47234520" sldId="663"/>
            <ac:spMk id="37" creationId="{4B2A2528-1C39-46B2-86F0-7A3A0D6D91D3}"/>
          </ac:spMkLst>
        </pc:spChg>
        <pc:spChg chg="add mod">
          <ac:chgData name="Hayk Barseghyan" userId="1af3c995-31f7-415e-9aa1-2b36900e994d" providerId="ADAL" clId="{817F6B4A-A95C-41F4-9215-42C8F6493746}" dt="2021-03-19T18:59:29.830" v="663" actId="1076"/>
          <ac:spMkLst>
            <pc:docMk/>
            <pc:sldMk cId="47234520" sldId="663"/>
            <ac:spMk id="38" creationId="{B638ABDB-D9E0-4BD6-B852-539AADEF668A}"/>
          </ac:spMkLst>
        </pc:spChg>
        <pc:spChg chg="add mod">
          <ac:chgData name="Hayk Barseghyan" userId="1af3c995-31f7-415e-9aa1-2b36900e994d" providerId="ADAL" clId="{817F6B4A-A95C-41F4-9215-42C8F6493746}" dt="2021-03-19T18:41:41.350" v="429" actId="1076"/>
          <ac:spMkLst>
            <pc:docMk/>
            <pc:sldMk cId="47234520" sldId="663"/>
            <ac:spMk id="39" creationId="{4AF27A96-917F-4EF1-9A35-A7FA933A8FDE}"/>
          </ac:spMkLst>
        </pc:spChg>
        <pc:spChg chg="del">
          <ac:chgData name="Hayk Barseghyan" userId="1af3c995-31f7-415e-9aa1-2b36900e994d" providerId="ADAL" clId="{817F6B4A-A95C-41F4-9215-42C8F6493746}" dt="2021-03-19T18:29:22.744" v="274" actId="478"/>
          <ac:spMkLst>
            <pc:docMk/>
            <pc:sldMk cId="47234520" sldId="663"/>
            <ac:spMk id="40" creationId="{EFE6C304-6608-4E19-9AF5-28280CCAEF69}"/>
          </ac:spMkLst>
        </pc:spChg>
        <pc:spChg chg="add del mod">
          <ac:chgData name="Hayk Barseghyan" userId="1af3c995-31f7-415e-9aa1-2b36900e994d" providerId="ADAL" clId="{817F6B4A-A95C-41F4-9215-42C8F6493746}" dt="2021-03-19T18:42:41.499" v="442" actId="478"/>
          <ac:spMkLst>
            <pc:docMk/>
            <pc:sldMk cId="47234520" sldId="663"/>
            <ac:spMk id="41" creationId="{4641CFE8-3360-4C71-8BF5-C426280991BD}"/>
          </ac:spMkLst>
        </pc:spChg>
        <pc:spChg chg="add mod">
          <ac:chgData name="Hayk Barseghyan" userId="1af3c995-31f7-415e-9aa1-2b36900e994d" providerId="ADAL" clId="{817F6B4A-A95C-41F4-9215-42C8F6493746}" dt="2021-03-19T19:38:23.200" v="879" actId="1038"/>
          <ac:spMkLst>
            <pc:docMk/>
            <pc:sldMk cId="47234520" sldId="663"/>
            <ac:spMk id="42" creationId="{A6A7EB23-F2F1-4B41-AF1C-F4019CBB76B4}"/>
          </ac:spMkLst>
        </pc:spChg>
        <pc:spChg chg="add mod">
          <ac:chgData name="Hayk Barseghyan" userId="1af3c995-31f7-415e-9aa1-2b36900e994d" providerId="ADAL" clId="{817F6B4A-A95C-41F4-9215-42C8F6493746}" dt="2021-03-19T18:53:28.816" v="621" actId="14100"/>
          <ac:spMkLst>
            <pc:docMk/>
            <pc:sldMk cId="47234520" sldId="663"/>
            <ac:spMk id="43" creationId="{22614E9B-0192-4105-BED4-42AFDEB76135}"/>
          </ac:spMkLst>
        </pc:spChg>
        <pc:spChg chg="del">
          <ac:chgData name="Hayk Barseghyan" userId="1af3c995-31f7-415e-9aa1-2b36900e994d" providerId="ADAL" clId="{817F6B4A-A95C-41F4-9215-42C8F6493746}" dt="2021-03-19T18:39:47.343" v="365" actId="478"/>
          <ac:spMkLst>
            <pc:docMk/>
            <pc:sldMk cId="47234520" sldId="663"/>
            <ac:spMk id="44" creationId="{732812E5-D6B9-4FEF-975D-E2E3D93D0E47}"/>
          </ac:spMkLst>
        </pc:spChg>
        <pc:spChg chg="del">
          <ac:chgData name="Hayk Barseghyan" userId="1af3c995-31f7-415e-9aa1-2b36900e994d" providerId="ADAL" clId="{817F6B4A-A95C-41F4-9215-42C8F6493746}" dt="2021-03-19T18:39:47.343" v="365" actId="478"/>
          <ac:spMkLst>
            <pc:docMk/>
            <pc:sldMk cId="47234520" sldId="663"/>
            <ac:spMk id="45" creationId="{706B5154-0B8D-4A97-9481-9F43337FAC30}"/>
          </ac:spMkLst>
        </pc:spChg>
        <pc:spChg chg="add mod">
          <ac:chgData name="Hayk Barseghyan" userId="1af3c995-31f7-415e-9aa1-2b36900e994d" providerId="ADAL" clId="{817F6B4A-A95C-41F4-9215-42C8F6493746}" dt="2021-03-19T18:53:39.230" v="622" actId="14100"/>
          <ac:spMkLst>
            <pc:docMk/>
            <pc:sldMk cId="47234520" sldId="663"/>
            <ac:spMk id="46" creationId="{CFC0E298-E244-4D43-AC83-9C57B99A2027}"/>
          </ac:spMkLst>
        </pc:spChg>
        <pc:spChg chg="del">
          <ac:chgData name="Hayk Barseghyan" userId="1af3c995-31f7-415e-9aa1-2b36900e994d" providerId="ADAL" clId="{817F6B4A-A95C-41F4-9215-42C8F6493746}" dt="2021-03-19T18:55:00.358" v="629" actId="478"/>
          <ac:spMkLst>
            <pc:docMk/>
            <pc:sldMk cId="47234520" sldId="663"/>
            <ac:spMk id="48" creationId="{7DECEAD3-1F4B-4349-B3E1-EC2281C752C7}"/>
          </ac:spMkLst>
        </pc:spChg>
        <pc:spChg chg="add mod">
          <ac:chgData name="Hayk Barseghyan" userId="1af3c995-31f7-415e-9aa1-2b36900e994d" providerId="ADAL" clId="{817F6B4A-A95C-41F4-9215-42C8F6493746}" dt="2021-03-19T18:41:28.359" v="421" actId="1076"/>
          <ac:spMkLst>
            <pc:docMk/>
            <pc:sldMk cId="47234520" sldId="663"/>
            <ac:spMk id="50" creationId="{EFAE23AD-764D-4717-BFC6-A667BE9E9DA0}"/>
          </ac:spMkLst>
        </pc:spChg>
        <pc:spChg chg="add mod">
          <ac:chgData name="Hayk Barseghyan" userId="1af3c995-31f7-415e-9aa1-2b36900e994d" providerId="ADAL" clId="{817F6B4A-A95C-41F4-9215-42C8F6493746}" dt="2021-03-19T18:43:27.478" v="466" actId="1076"/>
          <ac:spMkLst>
            <pc:docMk/>
            <pc:sldMk cId="47234520" sldId="663"/>
            <ac:spMk id="51" creationId="{9798F9A3-1382-497E-B44B-594D4B24624B}"/>
          </ac:spMkLst>
        </pc:spChg>
        <pc:spChg chg="add mod">
          <ac:chgData name="Hayk Barseghyan" userId="1af3c995-31f7-415e-9aa1-2b36900e994d" providerId="ADAL" clId="{817F6B4A-A95C-41F4-9215-42C8F6493746}" dt="2021-03-19T18:43:37.971" v="470" actId="20577"/>
          <ac:spMkLst>
            <pc:docMk/>
            <pc:sldMk cId="47234520" sldId="663"/>
            <ac:spMk id="53" creationId="{5327C358-684E-4D6A-80D1-00FE015EB529}"/>
          </ac:spMkLst>
        </pc:spChg>
        <pc:spChg chg="add mod">
          <ac:chgData name="Hayk Barseghyan" userId="1af3c995-31f7-415e-9aa1-2b36900e994d" providerId="ADAL" clId="{817F6B4A-A95C-41F4-9215-42C8F6493746}" dt="2021-03-19T18:44:48.332" v="508" actId="1036"/>
          <ac:spMkLst>
            <pc:docMk/>
            <pc:sldMk cId="47234520" sldId="663"/>
            <ac:spMk id="54" creationId="{AEFE19ED-D06A-4675-A62E-6210959B4F43}"/>
          </ac:spMkLst>
        </pc:spChg>
        <pc:spChg chg="add del mod">
          <ac:chgData name="Hayk Barseghyan" userId="1af3c995-31f7-415e-9aa1-2b36900e994d" providerId="ADAL" clId="{817F6B4A-A95C-41F4-9215-42C8F6493746}" dt="2021-03-19T18:58:15.570" v="647" actId="478"/>
          <ac:spMkLst>
            <pc:docMk/>
            <pc:sldMk cId="47234520" sldId="663"/>
            <ac:spMk id="55" creationId="{C838293D-F285-4C78-9F93-CE2184C8C8CE}"/>
          </ac:spMkLst>
        </pc:spChg>
        <pc:spChg chg="add mod">
          <ac:chgData name="Hayk Barseghyan" userId="1af3c995-31f7-415e-9aa1-2b36900e994d" providerId="ADAL" clId="{817F6B4A-A95C-41F4-9215-42C8F6493746}" dt="2021-03-19T18:47:23.671" v="566" actId="14100"/>
          <ac:spMkLst>
            <pc:docMk/>
            <pc:sldMk cId="47234520" sldId="663"/>
            <ac:spMk id="56" creationId="{B7D042E6-A9A2-4A90-94A4-3A23DC3ECE2B}"/>
          </ac:spMkLst>
        </pc:spChg>
        <pc:spChg chg="add mod">
          <ac:chgData name="Hayk Barseghyan" userId="1af3c995-31f7-415e-9aa1-2b36900e994d" providerId="ADAL" clId="{817F6B4A-A95C-41F4-9215-42C8F6493746}" dt="2021-03-19T18:47:53.614" v="584" actId="1076"/>
          <ac:spMkLst>
            <pc:docMk/>
            <pc:sldMk cId="47234520" sldId="663"/>
            <ac:spMk id="57" creationId="{508547CC-91BF-4ACA-AF7D-3F69DF44DE59}"/>
          </ac:spMkLst>
        </pc:spChg>
        <pc:spChg chg="add mod">
          <ac:chgData name="Hayk Barseghyan" userId="1af3c995-31f7-415e-9aa1-2b36900e994d" providerId="ADAL" clId="{817F6B4A-A95C-41F4-9215-42C8F6493746}" dt="2021-03-19T18:48:08.666" v="596" actId="1076"/>
          <ac:spMkLst>
            <pc:docMk/>
            <pc:sldMk cId="47234520" sldId="663"/>
            <ac:spMk id="58" creationId="{D61BAF5E-4DA2-43A9-B710-E5677683F7C5}"/>
          </ac:spMkLst>
        </pc:spChg>
        <pc:spChg chg="add mod">
          <ac:chgData name="Hayk Barseghyan" userId="1af3c995-31f7-415e-9aa1-2b36900e994d" providerId="ADAL" clId="{817F6B4A-A95C-41F4-9215-42C8F6493746}" dt="2021-03-19T19:01:03.545" v="724" actId="14100"/>
          <ac:spMkLst>
            <pc:docMk/>
            <pc:sldMk cId="47234520" sldId="663"/>
            <ac:spMk id="74" creationId="{300107C0-2A44-48D8-8889-DC81D8213279}"/>
          </ac:spMkLst>
        </pc:spChg>
        <pc:spChg chg="mod">
          <ac:chgData name="Hayk Barseghyan" userId="1af3c995-31f7-415e-9aa1-2b36900e994d" providerId="ADAL" clId="{817F6B4A-A95C-41F4-9215-42C8F6493746}" dt="2021-03-19T18:40:25.108" v="375" actId="14100"/>
          <ac:spMkLst>
            <pc:docMk/>
            <pc:sldMk cId="47234520" sldId="663"/>
            <ac:spMk id="88" creationId="{7309DE7D-82B3-4F46-B078-58EBF40D4703}"/>
          </ac:spMkLst>
        </pc:spChg>
        <pc:spChg chg="add mod">
          <ac:chgData name="Hayk Barseghyan" userId="1af3c995-31f7-415e-9aa1-2b36900e994d" providerId="ADAL" clId="{817F6B4A-A95C-41F4-9215-42C8F6493746}" dt="2021-03-19T20:18:11.844" v="1170" actId="20577"/>
          <ac:spMkLst>
            <pc:docMk/>
            <pc:sldMk cId="47234520" sldId="663"/>
            <ac:spMk id="89" creationId="{480DB1C9-4E87-4915-8B99-BCAC4399DCEB}"/>
          </ac:spMkLst>
        </pc:spChg>
        <pc:spChg chg="mod">
          <ac:chgData name="Hayk Barseghyan" userId="1af3c995-31f7-415e-9aa1-2b36900e994d" providerId="ADAL" clId="{817F6B4A-A95C-41F4-9215-42C8F6493746}" dt="2021-03-19T18:59:24.466" v="662" actId="1035"/>
          <ac:spMkLst>
            <pc:docMk/>
            <pc:sldMk cId="47234520" sldId="663"/>
            <ac:spMk id="91" creationId="{13B1F2AA-C6E8-4BA8-9C3E-AADD95A31E93}"/>
          </ac:spMkLst>
        </pc:spChg>
        <pc:spChg chg="mod">
          <ac:chgData name="Hayk Barseghyan" userId="1af3c995-31f7-415e-9aa1-2b36900e994d" providerId="ADAL" clId="{817F6B4A-A95C-41F4-9215-42C8F6493746}" dt="2021-03-19T18:59:12.360" v="656" actId="1076"/>
          <ac:spMkLst>
            <pc:docMk/>
            <pc:sldMk cId="47234520" sldId="663"/>
            <ac:spMk id="92" creationId="{C38076EE-D1EB-4356-9361-84DA46C2351B}"/>
          </ac:spMkLst>
        </pc:spChg>
        <pc:spChg chg="mod">
          <ac:chgData name="Hayk Barseghyan" userId="1af3c995-31f7-415e-9aa1-2b36900e994d" providerId="ADAL" clId="{817F6B4A-A95C-41F4-9215-42C8F6493746}" dt="2021-03-19T18:44:38.812" v="499" actId="1076"/>
          <ac:spMkLst>
            <pc:docMk/>
            <pc:sldMk cId="47234520" sldId="663"/>
            <ac:spMk id="93" creationId="{3EAC0E29-A0FD-42DD-8F3E-7B6BDF36A320}"/>
          </ac:spMkLst>
        </pc:spChg>
        <pc:spChg chg="del mod">
          <ac:chgData name="Hayk Barseghyan" userId="1af3c995-31f7-415e-9aa1-2b36900e994d" providerId="ADAL" clId="{817F6B4A-A95C-41F4-9215-42C8F6493746}" dt="2021-03-19T18:44:09.521" v="482" actId="478"/>
          <ac:spMkLst>
            <pc:docMk/>
            <pc:sldMk cId="47234520" sldId="663"/>
            <ac:spMk id="94" creationId="{C3B2E742-FF55-4D80-8A82-03F353C11C9E}"/>
          </ac:spMkLst>
        </pc:spChg>
        <pc:spChg chg="mod">
          <ac:chgData name="Hayk Barseghyan" userId="1af3c995-31f7-415e-9aa1-2b36900e994d" providerId="ADAL" clId="{817F6B4A-A95C-41F4-9215-42C8F6493746}" dt="2021-03-19T19:01:33.574" v="730" actId="1076"/>
          <ac:spMkLst>
            <pc:docMk/>
            <pc:sldMk cId="47234520" sldId="663"/>
            <ac:spMk id="98" creationId="{CC1A3F83-E94B-4F3C-9D62-2C0B7D404690}"/>
          </ac:spMkLst>
        </pc:spChg>
        <pc:picChg chg="add mod ord">
          <ac:chgData name="Hayk Barseghyan" userId="1af3c995-31f7-415e-9aa1-2b36900e994d" providerId="ADAL" clId="{817F6B4A-A95C-41F4-9215-42C8F6493746}" dt="2021-03-19T18:43:18.561" v="465" actId="1037"/>
          <ac:picMkLst>
            <pc:docMk/>
            <pc:sldMk cId="47234520" sldId="663"/>
            <ac:picMk id="3" creationId="{83ED3CC2-4027-49CD-B58C-F97A5ED1330E}"/>
          </ac:picMkLst>
        </pc:picChg>
        <pc:picChg chg="add del">
          <ac:chgData name="Hayk Barseghyan" userId="1af3c995-31f7-415e-9aa1-2b36900e994d" providerId="ADAL" clId="{817F6B4A-A95C-41F4-9215-42C8F6493746}" dt="2021-03-19T18:28:27.457" v="269" actId="478"/>
          <ac:picMkLst>
            <pc:docMk/>
            <pc:sldMk cId="47234520" sldId="663"/>
            <ac:picMk id="4" creationId="{6EE723D7-82C2-40C7-9EDF-695ABCFD2852}"/>
          </ac:picMkLst>
        </pc:picChg>
        <pc:picChg chg="add del mod">
          <ac:chgData name="Hayk Barseghyan" userId="1af3c995-31f7-415e-9aa1-2b36900e994d" providerId="ADAL" clId="{817F6B4A-A95C-41F4-9215-42C8F6493746}" dt="2021-03-19T18:35:12.091" v="351" actId="478"/>
          <ac:picMkLst>
            <pc:docMk/>
            <pc:sldMk cId="47234520" sldId="663"/>
            <ac:picMk id="6" creationId="{6AAC4778-1EE8-493A-9674-06A0C166946F}"/>
          </ac:picMkLst>
        </pc:picChg>
        <pc:picChg chg="add del mod">
          <ac:chgData name="Hayk Barseghyan" userId="1af3c995-31f7-415e-9aa1-2b36900e994d" providerId="ADAL" clId="{817F6B4A-A95C-41F4-9215-42C8F6493746}" dt="2021-03-19T18:39:39.776" v="362" actId="478"/>
          <ac:picMkLst>
            <pc:docMk/>
            <pc:sldMk cId="47234520" sldId="663"/>
            <ac:picMk id="8" creationId="{DB632C3E-AE6B-42A8-899C-C2CC2B1FA925}"/>
          </ac:picMkLst>
        </pc:picChg>
        <pc:picChg chg="add mod ord">
          <ac:chgData name="Hayk Barseghyan" userId="1af3c995-31f7-415e-9aa1-2b36900e994d" providerId="ADAL" clId="{817F6B4A-A95C-41F4-9215-42C8F6493746}" dt="2021-03-19T18:46:37.658" v="550" actId="1035"/>
          <ac:picMkLst>
            <pc:docMk/>
            <pc:sldMk cId="47234520" sldId="663"/>
            <ac:picMk id="10" creationId="{E238B8FE-BA66-4E00-BE15-D0DF19DE94CD}"/>
          </ac:picMkLst>
        </pc:picChg>
        <pc:picChg chg="add mod">
          <ac:chgData name="Hayk Barseghyan" userId="1af3c995-31f7-415e-9aa1-2b36900e994d" providerId="ADAL" clId="{817F6B4A-A95C-41F4-9215-42C8F6493746}" dt="2021-03-19T18:46:37.658" v="550" actId="1035"/>
          <ac:picMkLst>
            <pc:docMk/>
            <pc:sldMk cId="47234520" sldId="663"/>
            <ac:picMk id="13" creationId="{A8E41785-72B2-4763-8ED7-1E2D89338DBD}"/>
          </ac:picMkLst>
        </pc:picChg>
        <pc:picChg chg="del">
          <ac:chgData name="Hayk Barseghyan" userId="1af3c995-31f7-415e-9aa1-2b36900e994d" providerId="ADAL" clId="{817F6B4A-A95C-41F4-9215-42C8F6493746}" dt="2021-03-19T17:38:22.257" v="223" actId="478"/>
          <ac:picMkLst>
            <pc:docMk/>
            <pc:sldMk cId="47234520" sldId="663"/>
            <ac:picMk id="14" creationId="{BD596D5A-A8B5-4F23-971B-B0033B030440}"/>
          </ac:picMkLst>
        </pc:picChg>
        <pc:picChg chg="add mod ord">
          <ac:chgData name="Hayk Barseghyan" userId="1af3c995-31f7-415e-9aa1-2b36900e994d" providerId="ADAL" clId="{817F6B4A-A95C-41F4-9215-42C8F6493746}" dt="2021-03-19T18:58:35.887" v="650" actId="1076"/>
          <ac:picMkLst>
            <pc:docMk/>
            <pc:sldMk cId="47234520" sldId="663"/>
            <ac:picMk id="27" creationId="{4FE6C486-F782-468B-985B-6C0EFD2310B0}"/>
          </ac:picMkLst>
        </pc:picChg>
        <pc:picChg chg="add del">
          <ac:chgData name="Hayk Barseghyan" userId="1af3c995-31f7-415e-9aa1-2b36900e994d" providerId="ADAL" clId="{817F6B4A-A95C-41F4-9215-42C8F6493746}" dt="2021-03-19T17:56:31.121" v="253" actId="478"/>
          <ac:picMkLst>
            <pc:docMk/>
            <pc:sldMk cId="47234520" sldId="663"/>
            <ac:picMk id="35" creationId="{347E1D22-E15C-425D-925B-99F60A60B955}"/>
          </ac:picMkLst>
        </pc:picChg>
        <pc:cxnChg chg="del mod">
          <ac:chgData name="Hayk Barseghyan" userId="1af3c995-31f7-415e-9aa1-2b36900e994d" providerId="ADAL" clId="{817F6B4A-A95C-41F4-9215-42C8F6493746}" dt="2021-03-19T17:38:22.257" v="223" actId="478"/>
          <ac:cxnSpMkLst>
            <pc:docMk/>
            <pc:sldMk cId="47234520" sldId="663"/>
            <ac:cxnSpMk id="23" creationId="{B97A16ED-5542-4DD1-94CA-D032D3F72196}"/>
          </ac:cxnSpMkLst>
        </pc:cxnChg>
        <pc:cxnChg chg="del mod">
          <ac:chgData name="Hayk Barseghyan" userId="1af3c995-31f7-415e-9aa1-2b36900e994d" providerId="ADAL" clId="{817F6B4A-A95C-41F4-9215-42C8F6493746}" dt="2021-03-19T17:38:22.257" v="223" actId="478"/>
          <ac:cxnSpMkLst>
            <pc:docMk/>
            <pc:sldMk cId="47234520" sldId="663"/>
            <ac:cxnSpMk id="24" creationId="{792D8F66-E748-410F-BB9B-B632B254BDFB}"/>
          </ac:cxnSpMkLst>
        </pc:cxnChg>
        <pc:cxnChg chg="del mod">
          <ac:chgData name="Hayk Barseghyan" userId="1af3c995-31f7-415e-9aa1-2b36900e994d" providerId="ADAL" clId="{817F6B4A-A95C-41F4-9215-42C8F6493746}" dt="2021-03-19T17:38:22.257" v="223" actId="478"/>
          <ac:cxnSpMkLst>
            <pc:docMk/>
            <pc:sldMk cId="47234520" sldId="663"/>
            <ac:cxnSpMk id="25" creationId="{A4F48631-3605-414B-96A3-B4E7701F3903}"/>
          </ac:cxnSpMkLst>
        </pc:cxnChg>
        <pc:cxnChg chg="mod">
          <ac:chgData name="Hayk Barseghyan" userId="1af3c995-31f7-415e-9aa1-2b36900e994d" providerId="ADAL" clId="{817F6B4A-A95C-41F4-9215-42C8F6493746}" dt="2021-03-19T19:01:37.515" v="731" actId="14100"/>
          <ac:cxnSpMkLst>
            <pc:docMk/>
            <pc:sldMk cId="47234520" sldId="663"/>
            <ac:cxnSpMk id="49" creationId="{4423681D-AADF-4D62-AC9E-3FDDF18E21B9}"/>
          </ac:cxnSpMkLst>
        </pc:cxnChg>
        <pc:cxnChg chg="del mod">
          <ac:chgData name="Hayk Barseghyan" userId="1af3c995-31f7-415e-9aa1-2b36900e994d" providerId="ADAL" clId="{817F6B4A-A95C-41F4-9215-42C8F6493746}" dt="2021-03-19T18:55:03.683" v="630" actId="478"/>
          <ac:cxnSpMkLst>
            <pc:docMk/>
            <pc:sldMk cId="47234520" sldId="663"/>
            <ac:cxnSpMk id="52" creationId="{67E81840-D31A-48DD-9275-CD08F7D6F031}"/>
          </ac:cxnSpMkLst>
        </pc:cxnChg>
        <pc:cxnChg chg="add del mod">
          <ac:chgData name="Hayk Barseghyan" userId="1af3c995-31f7-415e-9aa1-2b36900e994d" providerId="ADAL" clId="{817F6B4A-A95C-41F4-9215-42C8F6493746}" dt="2021-03-19T18:58:53.178" v="653" actId="478"/>
          <ac:cxnSpMkLst>
            <pc:docMk/>
            <pc:sldMk cId="47234520" sldId="663"/>
            <ac:cxnSpMk id="60" creationId="{D7900501-8EAA-4BFA-986C-7B175DBB52C1}"/>
          </ac:cxnSpMkLst>
        </pc:cxnChg>
        <pc:cxnChg chg="add del mod">
          <ac:chgData name="Hayk Barseghyan" userId="1af3c995-31f7-415e-9aa1-2b36900e994d" providerId="ADAL" clId="{817F6B4A-A95C-41F4-9215-42C8F6493746}" dt="2021-03-19T18:59:38.117" v="664" actId="478"/>
          <ac:cxnSpMkLst>
            <pc:docMk/>
            <pc:sldMk cId="47234520" sldId="663"/>
            <ac:cxnSpMk id="63" creationId="{8D75B6B9-FF43-4462-A2B3-BDF87AE585B0}"/>
          </ac:cxnSpMkLst>
        </pc:cxnChg>
        <pc:cxnChg chg="add del mod">
          <ac:chgData name="Hayk Barseghyan" userId="1af3c995-31f7-415e-9aa1-2b36900e994d" providerId="ADAL" clId="{817F6B4A-A95C-41F4-9215-42C8F6493746}" dt="2021-03-19T19:00:25.582" v="714" actId="478"/>
          <ac:cxnSpMkLst>
            <pc:docMk/>
            <pc:sldMk cId="47234520" sldId="663"/>
            <ac:cxnSpMk id="71" creationId="{33FED888-1508-4D2B-8863-4D4A8EEBDC3F}"/>
          </ac:cxnSpMkLst>
        </pc:cxnChg>
        <pc:cxnChg chg="add mod">
          <ac:chgData name="Hayk Barseghyan" userId="1af3c995-31f7-415e-9aa1-2b36900e994d" providerId="ADAL" clId="{817F6B4A-A95C-41F4-9215-42C8F6493746}" dt="2021-03-19T19:01:48.174" v="734" actId="14100"/>
          <ac:cxnSpMkLst>
            <pc:docMk/>
            <pc:sldMk cId="47234520" sldId="663"/>
            <ac:cxnSpMk id="81" creationId="{4BCC25EA-B583-41A5-993F-C933337AE38C}"/>
          </ac:cxnSpMkLst>
        </pc:cxnChg>
        <pc:cxnChg chg="add mod">
          <ac:chgData name="Hayk Barseghyan" userId="1af3c995-31f7-415e-9aa1-2b36900e994d" providerId="ADAL" clId="{817F6B4A-A95C-41F4-9215-42C8F6493746}" dt="2021-03-19T19:01:56.254" v="737" actId="14100"/>
          <ac:cxnSpMkLst>
            <pc:docMk/>
            <pc:sldMk cId="47234520" sldId="663"/>
            <ac:cxnSpMk id="84" creationId="{B2FDD7DF-34CC-49AF-BA68-F741766F788A}"/>
          </ac:cxnSpMkLst>
        </pc:cxnChg>
        <pc:cxnChg chg="add del mod">
          <ac:chgData name="Hayk Barseghyan" userId="1af3c995-31f7-415e-9aa1-2b36900e994d" providerId="ADAL" clId="{817F6B4A-A95C-41F4-9215-42C8F6493746}" dt="2021-03-19T19:10:44.549" v="741" actId="478"/>
          <ac:cxnSpMkLst>
            <pc:docMk/>
            <pc:sldMk cId="47234520" sldId="663"/>
            <ac:cxnSpMk id="87" creationId="{CA9B886A-2D36-4D06-ADBD-0D635F8AB8A0}"/>
          </ac:cxnSpMkLst>
        </pc:cxnChg>
        <pc:cxnChg chg="mod">
          <ac:chgData name="Hayk Barseghyan" userId="1af3c995-31f7-415e-9aa1-2b36900e994d" providerId="ADAL" clId="{817F6B4A-A95C-41F4-9215-42C8F6493746}" dt="2021-03-19T18:46:53.391" v="551" actId="1076"/>
          <ac:cxnSpMkLst>
            <pc:docMk/>
            <pc:sldMk cId="47234520" sldId="663"/>
            <ac:cxnSpMk id="95" creationId="{5EB10151-CF0F-4162-A03A-2FB4661DCBE8}"/>
          </ac:cxnSpMkLst>
        </pc:cxnChg>
      </pc:sldChg>
      <pc:sldChg chg="addSp delSp new del mod">
        <pc:chgData name="Hayk Barseghyan" userId="1af3c995-31f7-415e-9aa1-2b36900e994d" providerId="ADAL" clId="{817F6B4A-A95C-41F4-9215-42C8F6493746}" dt="2021-03-19T20:20:08.864" v="1211" actId="47"/>
        <pc:sldMkLst>
          <pc:docMk/>
          <pc:sldMk cId="694439744" sldId="664"/>
        </pc:sldMkLst>
        <pc:picChg chg="add">
          <ac:chgData name="Hayk Barseghyan" userId="1af3c995-31f7-415e-9aa1-2b36900e994d" providerId="ADAL" clId="{817F6B4A-A95C-41F4-9215-42C8F6493746}" dt="2021-03-19T20:04:32.822" v="881" actId="22"/>
          <ac:picMkLst>
            <pc:docMk/>
            <pc:sldMk cId="694439744" sldId="664"/>
            <ac:picMk id="3" creationId="{C4333CAA-A9E7-4CD4-A80F-FD15129779EE}"/>
          </ac:picMkLst>
        </pc:picChg>
        <pc:picChg chg="add del">
          <ac:chgData name="Hayk Barseghyan" userId="1af3c995-31f7-415e-9aa1-2b36900e994d" providerId="ADAL" clId="{817F6B4A-A95C-41F4-9215-42C8F6493746}" dt="2021-03-19T20:04:59.538" v="888" actId="21"/>
          <ac:picMkLst>
            <pc:docMk/>
            <pc:sldMk cId="694439744" sldId="664"/>
            <ac:picMk id="5" creationId="{89C0E90B-2626-4C0B-90B3-80BEA1E1FF9C}"/>
          </ac:picMkLst>
        </pc:picChg>
      </pc:sldChg>
      <pc:sldChg chg="addSp delSp modSp add mod modNotesTx">
        <pc:chgData name="Hayk Barseghyan" userId="1af3c995-31f7-415e-9aa1-2b36900e994d" providerId="ADAL" clId="{817F6B4A-A95C-41F4-9215-42C8F6493746}" dt="2021-03-19T22:37:39.255" v="1530" actId="20577"/>
        <pc:sldMkLst>
          <pc:docMk/>
          <pc:sldMk cId="4129799046" sldId="665"/>
        </pc:sldMkLst>
        <pc:spChg chg="add del">
          <ac:chgData name="Hayk Barseghyan" userId="1af3c995-31f7-415e-9aa1-2b36900e994d" providerId="ADAL" clId="{817F6B4A-A95C-41F4-9215-42C8F6493746}" dt="2021-03-19T20:08:52.554" v="962" actId="478"/>
          <ac:spMkLst>
            <pc:docMk/>
            <pc:sldMk cId="4129799046" sldId="665"/>
            <ac:spMk id="6" creationId="{B4F59837-0798-43DD-8123-3E92EDD62CD9}"/>
          </ac:spMkLst>
        </pc:spChg>
        <pc:spChg chg="mod">
          <ac:chgData name="Hayk Barseghyan" userId="1af3c995-31f7-415e-9aa1-2b36900e994d" providerId="ADAL" clId="{817F6B4A-A95C-41F4-9215-42C8F6493746}" dt="2021-03-19T22:37:39.255" v="1530" actId="20577"/>
          <ac:spMkLst>
            <pc:docMk/>
            <pc:sldMk cId="4129799046" sldId="665"/>
            <ac:spMk id="33" creationId="{27D04DB1-6D7F-4335-AAA1-99D44F3F14E9}"/>
          </ac:spMkLst>
        </pc:spChg>
        <pc:spChg chg="mod">
          <ac:chgData name="Hayk Barseghyan" userId="1af3c995-31f7-415e-9aa1-2b36900e994d" providerId="ADAL" clId="{817F6B4A-A95C-41F4-9215-42C8F6493746}" dt="2021-03-19T20:10:32.524" v="1034" actId="1036"/>
          <ac:spMkLst>
            <pc:docMk/>
            <pc:sldMk cId="4129799046" sldId="665"/>
            <ac:spMk id="36" creationId="{D1390CDB-8C38-45E4-B737-627C1887B062}"/>
          </ac:spMkLst>
        </pc:spChg>
        <pc:spChg chg="mod">
          <ac:chgData name="Hayk Barseghyan" userId="1af3c995-31f7-415e-9aa1-2b36900e994d" providerId="ADAL" clId="{817F6B4A-A95C-41F4-9215-42C8F6493746}" dt="2021-03-19T20:10:32.524" v="1034" actId="1036"/>
          <ac:spMkLst>
            <pc:docMk/>
            <pc:sldMk cId="4129799046" sldId="665"/>
            <ac:spMk id="39" creationId="{4AF27A96-917F-4EF1-9A35-A7FA933A8FDE}"/>
          </ac:spMkLst>
        </pc:spChg>
        <pc:spChg chg="mod">
          <ac:chgData name="Hayk Barseghyan" userId="1af3c995-31f7-415e-9aa1-2b36900e994d" providerId="ADAL" clId="{817F6B4A-A95C-41F4-9215-42C8F6493746}" dt="2021-03-19T20:10:32.524" v="1034" actId="1036"/>
          <ac:spMkLst>
            <pc:docMk/>
            <pc:sldMk cId="4129799046" sldId="665"/>
            <ac:spMk id="42" creationId="{A6A7EB23-F2F1-4B41-AF1C-F4019CBB76B4}"/>
          </ac:spMkLst>
        </pc:spChg>
        <pc:spChg chg="del">
          <ac:chgData name="Hayk Barseghyan" userId="1af3c995-31f7-415e-9aa1-2b36900e994d" providerId="ADAL" clId="{817F6B4A-A95C-41F4-9215-42C8F6493746}" dt="2021-03-19T20:05:29" v="895" actId="478"/>
          <ac:spMkLst>
            <pc:docMk/>
            <pc:sldMk cId="4129799046" sldId="665"/>
            <ac:spMk id="43" creationId="{22614E9B-0192-4105-BED4-42AFDEB76135}"/>
          </ac:spMkLst>
        </pc:spChg>
        <pc:spChg chg="add mod">
          <ac:chgData name="Hayk Barseghyan" userId="1af3c995-31f7-415e-9aa1-2b36900e994d" providerId="ADAL" clId="{817F6B4A-A95C-41F4-9215-42C8F6493746}" dt="2021-03-19T20:16:37.919" v="1114" actId="1076"/>
          <ac:spMkLst>
            <pc:docMk/>
            <pc:sldMk cId="4129799046" sldId="665"/>
            <ac:spMk id="44" creationId="{1A60BD52-2298-45AC-95F9-B14280D17388}"/>
          </ac:spMkLst>
        </pc:spChg>
        <pc:spChg chg="add mod">
          <ac:chgData name="Hayk Barseghyan" userId="1af3c995-31f7-415e-9aa1-2b36900e994d" providerId="ADAL" clId="{817F6B4A-A95C-41F4-9215-42C8F6493746}" dt="2021-03-19T20:18:55.066" v="1173"/>
          <ac:spMkLst>
            <pc:docMk/>
            <pc:sldMk cId="4129799046" sldId="665"/>
            <ac:spMk id="45" creationId="{775C6D39-311A-4AAB-BCB9-BD6FB80825A6}"/>
          </ac:spMkLst>
        </pc:spChg>
        <pc:spChg chg="del">
          <ac:chgData name="Hayk Barseghyan" userId="1af3c995-31f7-415e-9aa1-2b36900e994d" providerId="ADAL" clId="{817F6B4A-A95C-41F4-9215-42C8F6493746}" dt="2021-03-19T20:05:32.359" v="896" actId="478"/>
          <ac:spMkLst>
            <pc:docMk/>
            <pc:sldMk cId="4129799046" sldId="665"/>
            <ac:spMk id="46" creationId="{CFC0E298-E244-4D43-AC83-9C57B99A2027}"/>
          </ac:spMkLst>
        </pc:spChg>
        <pc:spChg chg="mod">
          <ac:chgData name="Hayk Barseghyan" userId="1af3c995-31f7-415e-9aa1-2b36900e994d" providerId="ADAL" clId="{817F6B4A-A95C-41F4-9215-42C8F6493746}" dt="2021-03-19T20:10:43.921" v="1043" actId="1035"/>
          <ac:spMkLst>
            <pc:docMk/>
            <pc:sldMk cId="4129799046" sldId="665"/>
            <ac:spMk id="50" creationId="{EFAE23AD-764D-4717-BFC6-A667BE9E9DA0}"/>
          </ac:spMkLst>
        </pc:spChg>
        <pc:spChg chg="mod">
          <ac:chgData name="Hayk Barseghyan" userId="1af3c995-31f7-415e-9aa1-2b36900e994d" providerId="ADAL" clId="{817F6B4A-A95C-41F4-9215-42C8F6493746}" dt="2021-03-19T20:10:32.524" v="1034" actId="1036"/>
          <ac:spMkLst>
            <pc:docMk/>
            <pc:sldMk cId="4129799046" sldId="665"/>
            <ac:spMk id="51" creationId="{9798F9A3-1382-497E-B44B-594D4B24624B}"/>
          </ac:spMkLst>
        </pc:spChg>
        <pc:spChg chg="del">
          <ac:chgData name="Hayk Barseghyan" userId="1af3c995-31f7-415e-9aa1-2b36900e994d" providerId="ADAL" clId="{817F6B4A-A95C-41F4-9215-42C8F6493746}" dt="2021-03-19T20:05:54.090" v="901" actId="478"/>
          <ac:spMkLst>
            <pc:docMk/>
            <pc:sldMk cId="4129799046" sldId="665"/>
            <ac:spMk id="53" creationId="{5327C358-684E-4D6A-80D1-00FE015EB529}"/>
          </ac:spMkLst>
        </pc:spChg>
        <pc:spChg chg="mod">
          <ac:chgData name="Hayk Barseghyan" userId="1af3c995-31f7-415e-9aa1-2b36900e994d" providerId="ADAL" clId="{817F6B4A-A95C-41F4-9215-42C8F6493746}" dt="2021-03-19T20:11:00.861" v="1048" actId="20577"/>
          <ac:spMkLst>
            <pc:docMk/>
            <pc:sldMk cId="4129799046" sldId="665"/>
            <ac:spMk id="54" creationId="{AEFE19ED-D06A-4675-A62E-6210959B4F43}"/>
          </ac:spMkLst>
        </pc:spChg>
        <pc:spChg chg="del">
          <ac:chgData name="Hayk Barseghyan" userId="1af3c995-31f7-415e-9aa1-2b36900e994d" providerId="ADAL" clId="{817F6B4A-A95C-41F4-9215-42C8F6493746}" dt="2021-03-19T20:06:02.279" v="903" actId="478"/>
          <ac:spMkLst>
            <pc:docMk/>
            <pc:sldMk cId="4129799046" sldId="665"/>
            <ac:spMk id="56" creationId="{B7D042E6-A9A2-4A90-94A4-3A23DC3ECE2B}"/>
          </ac:spMkLst>
        </pc:spChg>
        <pc:spChg chg="del">
          <ac:chgData name="Hayk Barseghyan" userId="1af3c995-31f7-415e-9aa1-2b36900e994d" providerId="ADAL" clId="{817F6B4A-A95C-41F4-9215-42C8F6493746}" dt="2021-03-19T20:05:59.364" v="902" actId="478"/>
          <ac:spMkLst>
            <pc:docMk/>
            <pc:sldMk cId="4129799046" sldId="665"/>
            <ac:spMk id="57" creationId="{508547CC-91BF-4ACA-AF7D-3F69DF44DE59}"/>
          </ac:spMkLst>
        </pc:spChg>
        <pc:spChg chg="mod">
          <ac:chgData name="Hayk Barseghyan" userId="1af3c995-31f7-415e-9aa1-2b36900e994d" providerId="ADAL" clId="{817F6B4A-A95C-41F4-9215-42C8F6493746}" dt="2021-03-19T20:10:32.524" v="1034" actId="1036"/>
          <ac:spMkLst>
            <pc:docMk/>
            <pc:sldMk cId="4129799046" sldId="665"/>
            <ac:spMk id="58" creationId="{D61BAF5E-4DA2-43A9-B710-E5677683F7C5}"/>
          </ac:spMkLst>
        </pc:spChg>
        <pc:spChg chg="mod">
          <ac:chgData name="Hayk Barseghyan" userId="1af3c995-31f7-415e-9aa1-2b36900e994d" providerId="ADAL" clId="{817F6B4A-A95C-41F4-9215-42C8F6493746}" dt="2021-03-19T20:10:11.284" v="980" actId="208"/>
          <ac:spMkLst>
            <pc:docMk/>
            <pc:sldMk cId="4129799046" sldId="665"/>
            <ac:spMk id="74" creationId="{300107C0-2A44-48D8-8889-DC81D8213279}"/>
          </ac:spMkLst>
        </pc:spChg>
        <pc:spChg chg="mod">
          <ac:chgData name="Hayk Barseghyan" userId="1af3c995-31f7-415e-9aa1-2b36900e994d" providerId="ADAL" clId="{817F6B4A-A95C-41F4-9215-42C8F6493746}" dt="2021-03-19T20:10:43.921" v="1043" actId="1035"/>
          <ac:spMkLst>
            <pc:docMk/>
            <pc:sldMk cId="4129799046" sldId="665"/>
            <ac:spMk id="88" creationId="{7309DE7D-82B3-4F46-B078-58EBF40D4703}"/>
          </ac:spMkLst>
        </pc:spChg>
        <pc:spChg chg="mod">
          <ac:chgData name="Hayk Barseghyan" userId="1af3c995-31f7-415e-9aa1-2b36900e994d" providerId="ADAL" clId="{817F6B4A-A95C-41F4-9215-42C8F6493746}" dt="2021-03-19T20:10:43.921" v="1043" actId="1035"/>
          <ac:spMkLst>
            <pc:docMk/>
            <pc:sldMk cId="4129799046" sldId="665"/>
            <ac:spMk id="93" creationId="{3EAC0E29-A0FD-42DD-8F3E-7B6BDF36A320}"/>
          </ac:spMkLst>
        </pc:spChg>
        <pc:spChg chg="del">
          <ac:chgData name="Hayk Barseghyan" userId="1af3c995-31f7-415e-9aa1-2b36900e994d" providerId="ADAL" clId="{817F6B4A-A95C-41F4-9215-42C8F6493746}" dt="2021-03-19T20:07:15.734" v="952" actId="478"/>
          <ac:spMkLst>
            <pc:docMk/>
            <pc:sldMk cId="4129799046" sldId="665"/>
            <ac:spMk id="98" creationId="{CC1A3F83-E94B-4F3C-9D62-2C0B7D404690}"/>
          </ac:spMkLst>
        </pc:spChg>
        <pc:picChg chg="del">
          <ac:chgData name="Hayk Barseghyan" userId="1af3c995-31f7-415e-9aa1-2b36900e994d" providerId="ADAL" clId="{817F6B4A-A95C-41F4-9215-42C8F6493746}" dt="2021-03-19T20:05:26.405" v="894" actId="478"/>
          <ac:picMkLst>
            <pc:docMk/>
            <pc:sldMk cId="4129799046" sldId="665"/>
            <ac:picMk id="3" creationId="{83ED3CC2-4027-49CD-B58C-F97A5ED1330E}"/>
          </ac:picMkLst>
        </pc:picChg>
        <pc:picChg chg="add mod ord">
          <ac:chgData name="Hayk Barseghyan" userId="1af3c995-31f7-415e-9aa1-2b36900e994d" providerId="ADAL" clId="{817F6B4A-A95C-41F4-9215-42C8F6493746}" dt="2021-03-19T20:10:07.372" v="978" actId="14100"/>
          <ac:picMkLst>
            <pc:docMk/>
            <pc:sldMk cId="4129799046" sldId="665"/>
            <ac:picMk id="5" creationId="{9A6EBBE4-095F-46FD-B82F-F05D5EF223BB}"/>
          </ac:picMkLst>
        </pc:picChg>
        <pc:picChg chg="del mod">
          <ac:chgData name="Hayk Barseghyan" userId="1af3c995-31f7-415e-9aa1-2b36900e994d" providerId="ADAL" clId="{817F6B4A-A95C-41F4-9215-42C8F6493746}" dt="2021-03-19T20:10:53.579" v="1044" actId="478"/>
          <ac:picMkLst>
            <pc:docMk/>
            <pc:sldMk cId="4129799046" sldId="665"/>
            <ac:picMk id="10" creationId="{E238B8FE-BA66-4E00-BE15-D0DF19DE94CD}"/>
          </ac:picMkLst>
        </pc:picChg>
        <pc:picChg chg="add mod">
          <ac:chgData name="Hayk Barseghyan" userId="1af3c995-31f7-415e-9aa1-2b36900e994d" providerId="ADAL" clId="{817F6B4A-A95C-41F4-9215-42C8F6493746}" dt="2021-03-19T20:13:35.168" v="1055" actId="1076"/>
          <ac:picMkLst>
            <pc:docMk/>
            <pc:sldMk cId="4129799046" sldId="665"/>
            <ac:picMk id="11" creationId="{6AB853F9-4BCE-41E8-BEE4-EBA3E7352317}"/>
          </ac:picMkLst>
        </pc:picChg>
        <pc:picChg chg="del mod">
          <ac:chgData name="Hayk Barseghyan" userId="1af3c995-31f7-415e-9aa1-2b36900e994d" providerId="ADAL" clId="{817F6B4A-A95C-41F4-9215-42C8F6493746}" dt="2021-03-19T20:10:56.591" v="1045" actId="478"/>
          <ac:picMkLst>
            <pc:docMk/>
            <pc:sldMk cId="4129799046" sldId="665"/>
            <ac:picMk id="13" creationId="{A8E41785-72B2-4763-8ED7-1E2D89338DBD}"/>
          </ac:picMkLst>
        </pc:picChg>
        <pc:picChg chg="add mod">
          <ac:chgData name="Hayk Barseghyan" userId="1af3c995-31f7-415e-9aa1-2b36900e994d" providerId="ADAL" clId="{817F6B4A-A95C-41F4-9215-42C8F6493746}" dt="2021-03-19T20:15:22.954" v="1100" actId="1036"/>
          <ac:picMkLst>
            <pc:docMk/>
            <pc:sldMk cId="4129799046" sldId="665"/>
            <ac:picMk id="14" creationId="{541C2ADA-B614-4339-BEFE-835814EA3BF6}"/>
          </ac:picMkLst>
        </pc:picChg>
        <pc:picChg chg="del">
          <ac:chgData name="Hayk Barseghyan" userId="1af3c995-31f7-415e-9aa1-2b36900e994d" providerId="ADAL" clId="{817F6B4A-A95C-41F4-9215-42C8F6493746}" dt="2021-03-19T20:07:11.671" v="951" actId="478"/>
          <ac:picMkLst>
            <pc:docMk/>
            <pc:sldMk cId="4129799046" sldId="665"/>
            <ac:picMk id="27" creationId="{4FE6C486-F782-468B-985B-6C0EFD2310B0}"/>
          </ac:picMkLst>
        </pc:picChg>
        <pc:picChg chg="add mod">
          <ac:chgData name="Hayk Barseghyan" userId="1af3c995-31f7-415e-9aa1-2b36900e994d" providerId="ADAL" clId="{817F6B4A-A95C-41F4-9215-42C8F6493746}" dt="2021-03-19T20:10:32.524" v="1034" actId="1036"/>
          <ac:picMkLst>
            <pc:docMk/>
            <pc:sldMk cId="4129799046" sldId="665"/>
            <ac:picMk id="30" creationId="{1D784E8D-27C4-4F68-A620-A9BC920296D8}"/>
          </ac:picMkLst>
        </pc:picChg>
        <pc:cxnChg chg="del mod">
          <ac:chgData name="Hayk Barseghyan" userId="1af3c995-31f7-415e-9aa1-2b36900e994d" providerId="ADAL" clId="{817F6B4A-A95C-41F4-9215-42C8F6493746}" dt="2021-03-19T20:08:38.872" v="959" actId="478"/>
          <ac:cxnSpMkLst>
            <pc:docMk/>
            <pc:sldMk cId="4129799046" sldId="665"/>
            <ac:cxnSpMk id="49" creationId="{4423681D-AADF-4D62-AC9E-3FDDF18E21B9}"/>
          </ac:cxnSpMkLst>
        </pc:cxnChg>
        <pc:cxnChg chg="mod">
          <ac:chgData name="Hayk Barseghyan" userId="1af3c995-31f7-415e-9aa1-2b36900e994d" providerId="ADAL" clId="{817F6B4A-A95C-41F4-9215-42C8F6493746}" dt="2021-03-19T20:10:43.921" v="1043" actId="1035"/>
          <ac:cxnSpMkLst>
            <pc:docMk/>
            <pc:sldMk cId="4129799046" sldId="665"/>
            <ac:cxnSpMk id="81" creationId="{4BCC25EA-B583-41A5-993F-C933337AE38C}"/>
          </ac:cxnSpMkLst>
        </pc:cxnChg>
        <pc:cxnChg chg="mod">
          <ac:chgData name="Hayk Barseghyan" userId="1af3c995-31f7-415e-9aa1-2b36900e994d" providerId="ADAL" clId="{817F6B4A-A95C-41F4-9215-42C8F6493746}" dt="2021-03-19T20:10:32.524" v="1034" actId="1036"/>
          <ac:cxnSpMkLst>
            <pc:docMk/>
            <pc:sldMk cId="4129799046" sldId="665"/>
            <ac:cxnSpMk id="84" creationId="{B2FDD7DF-34CC-49AF-BA68-F741766F788A}"/>
          </ac:cxnSpMkLst>
        </pc:cxnChg>
        <pc:cxnChg chg="del mod">
          <ac:chgData name="Hayk Barseghyan" userId="1af3c995-31f7-415e-9aa1-2b36900e994d" providerId="ADAL" clId="{817F6B4A-A95C-41F4-9215-42C8F6493746}" dt="2021-03-19T20:15:29.005" v="1101" actId="478"/>
          <ac:cxnSpMkLst>
            <pc:docMk/>
            <pc:sldMk cId="4129799046" sldId="665"/>
            <ac:cxnSpMk id="95" creationId="{5EB10151-CF0F-4162-A03A-2FB4661DCBE8}"/>
          </ac:cxnSpMkLst>
        </pc:cxnChg>
      </pc:sldChg>
      <pc:sldChg chg="addSp delSp modSp add mod modNotesTx">
        <pc:chgData name="Hayk Barseghyan" userId="1af3c995-31f7-415e-9aa1-2b36900e994d" providerId="ADAL" clId="{817F6B4A-A95C-41F4-9215-42C8F6493746}" dt="2021-03-19T21:00:21.023" v="1524" actId="1076"/>
        <pc:sldMkLst>
          <pc:docMk/>
          <pc:sldMk cId="2230132588" sldId="666"/>
        </pc:sldMkLst>
        <pc:spChg chg="add mod">
          <ac:chgData name="Hayk Barseghyan" userId="1af3c995-31f7-415e-9aa1-2b36900e994d" providerId="ADAL" clId="{817F6B4A-A95C-41F4-9215-42C8F6493746}" dt="2021-03-19T20:33:44.518" v="1432" actId="1076"/>
          <ac:spMkLst>
            <pc:docMk/>
            <pc:sldMk cId="2230132588" sldId="666"/>
            <ac:spMk id="32" creationId="{275EC0D4-17D0-4E29-9224-8550B15B2CA3}"/>
          </ac:spMkLst>
        </pc:spChg>
        <pc:spChg chg="mod">
          <ac:chgData name="Hayk Barseghyan" userId="1af3c995-31f7-415e-9aa1-2b36900e994d" providerId="ADAL" clId="{817F6B4A-A95C-41F4-9215-42C8F6493746}" dt="2021-03-19T20:50:18.453" v="1471" actId="20577"/>
          <ac:spMkLst>
            <pc:docMk/>
            <pc:sldMk cId="2230132588" sldId="666"/>
            <ac:spMk id="33" creationId="{27D04DB1-6D7F-4335-AAA1-99D44F3F14E9}"/>
          </ac:spMkLst>
        </pc:spChg>
        <pc:spChg chg="add mod">
          <ac:chgData name="Hayk Barseghyan" userId="1af3c995-31f7-415e-9aa1-2b36900e994d" providerId="ADAL" clId="{817F6B4A-A95C-41F4-9215-42C8F6493746}" dt="2021-03-19T20:54:39.732" v="1500" actId="1037"/>
          <ac:spMkLst>
            <pc:docMk/>
            <pc:sldMk cId="2230132588" sldId="666"/>
            <ac:spMk id="35" creationId="{49036F1A-3C55-4443-9347-0525B6BCACAD}"/>
          </ac:spMkLst>
        </pc:spChg>
        <pc:spChg chg="mod">
          <ac:chgData name="Hayk Barseghyan" userId="1af3c995-31f7-415e-9aa1-2b36900e994d" providerId="ADAL" clId="{817F6B4A-A95C-41F4-9215-42C8F6493746}" dt="2021-03-19T20:55:03.502" v="1502" actId="14100"/>
          <ac:spMkLst>
            <pc:docMk/>
            <pc:sldMk cId="2230132588" sldId="666"/>
            <ac:spMk id="36" creationId="{D1390CDB-8C38-45E4-B737-627C1887B062}"/>
          </ac:spMkLst>
        </pc:spChg>
        <pc:spChg chg="mod">
          <ac:chgData name="Hayk Barseghyan" userId="1af3c995-31f7-415e-9aa1-2b36900e994d" providerId="ADAL" clId="{817F6B4A-A95C-41F4-9215-42C8F6493746}" dt="2021-03-19T20:54:02.969" v="1490" actId="1036"/>
          <ac:spMkLst>
            <pc:docMk/>
            <pc:sldMk cId="2230132588" sldId="666"/>
            <ac:spMk id="39" creationId="{4AF27A96-917F-4EF1-9A35-A7FA933A8FDE}"/>
          </ac:spMkLst>
        </pc:spChg>
        <pc:spChg chg="add mod">
          <ac:chgData name="Hayk Barseghyan" userId="1af3c995-31f7-415e-9aa1-2b36900e994d" providerId="ADAL" clId="{817F6B4A-A95C-41F4-9215-42C8F6493746}" dt="2021-03-19T21:00:16.356" v="1523" actId="1076"/>
          <ac:spMkLst>
            <pc:docMk/>
            <pc:sldMk cId="2230132588" sldId="666"/>
            <ac:spMk id="41" creationId="{3C1C60B3-B313-4BFB-8EF1-E3B2393673C1}"/>
          </ac:spMkLst>
        </pc:spChg>
        <pc:spChg chg="del">
          <ac:chgData name="Hayk Barseghyan" userId="1af3c995-31f7-415e-9aa1-2b36900e994d" providerId="ADAL" clId="{817F6B4A-A95C-41F4-9215-42C8F6493746}" dt="2021-03-19T20:33:50.959" v="1434" actId="478"/>
          <ac:spMkLst>
            <pc:docMk/>
            <pc:sldMk cId="2230132588" sldId="666"/>
            <ac:spMk id="43" creationId="{22614E9B-0192-4105-BED4-42AFDEB76135}"/>
          </ac:spMkLst>
        </pc:spChg>
        <pc:spChg chg="del">
          <ac:chgData name="Hayk Barseghyan" userId="1af3c995-31f7-415e-9aa1-2b36900e994d" providerId="ADAL" clId="{817F6B4A-A95C-41F4-9215-42C8F6493746}" dt="2021-03-19T20:33:52.598" v="1435" actId="478"/>
          <ac:spMkLst>
            <pc:docMk/>
            <pc:sldMk cId="2230132588" sldId="666"/>
            <ac:spMk id="46" creationId="{CFC0E298-E244-4D43-AC83-9C57B99A2027}"/>
          </ac:spMkLst>
        </pc:spChg>
        <pc:spChg chg="del">
          <ac:chgData name="Hayk Barseghyan" userId="1af3c995-31f7-415e-9aa1-2b36900e994d" providerId="ADAL" clId="{817F6B4A-A95C-41F4-9215-42C8F6493746}" dt="2021-03-19T20:33:12.474" v="1423" actId="478"/>
          <ac:spMkLst>
            <pc:docMk/>
            <pc:sldMk cId="2230132588" sldId="666"/>
            <ac:spMk id="50" creationId="{EFAE23AD-764D-4717-BFC6-A667BE9E9DA0}"/>
          </ac:spMkLst>
        </pc:spChg>
        <pc:spChg chg="del">
          <ac:chgData name="Hayk Barseghyan" userId="1af3c995-31f7-415e-9aa1-2b36900e994d" providerId="ADAL" clId="{817F6B4A-A95C-41F4-9215-42C8F6493746}" dt="2021-03-19T20:53:43.396" v="1482" actId="478"/>
          <ac:spMkLst>
            <pc:docMk/>
            <pc:sldMk cId="2230132588" sldId="666"/>
            <ac:spMk id="74" creationId="{300107C0-2A44-48D8-8889-DC81D8213279}"/>
          </ac:spMkLst>
        </pc:spChg>
        <pc:spChg chg="mod">
          <ac:chgData name="Hayk Barseghyan" userId="1af3c995-31f7-415e-9aa1-2b36900e994d" providerId="ADAL" clId="{817F6B4A-A95C-41F4-9215-42C8F6493746}" dt="2021-03-19T21:00:21.023" v="1524" actId="1076"/>
          <ac:spMkLst>
            <pc:docMk/>
            <pc:sldMk cId="2230132588" sldId="666"/>
            <ac:spMk id="89" creationId="{480DB1C9-4E87-4915-8B99-BCAC4399DCEB}"/>
          </ac:spMkLst>
        </pc:spChg>
        <pc:spChg chg="del">
          <ac:chgData name="Hayk Barseghyan" userId="1af3c995-31f7-415e-9aa1-2b36900e994d" providerId="ADAL" clId="{817F6B4A-A95C-41F4-9215-42C8F6493746}" dt="2021-03-19T20:41:27.701" v="1437" actId="478"/>
          <ac:spMkLst>
            <pc:docMk/>
            <pc:sldMk cId="2230132588" sldId="666"/>
            <ac:spMk id="98" creationId="{CC1A3F83-E94B-4F3C-9D62-2C0B7D404690}"/>
          </ac:spMkLst>
        </pc:spChg>
        <pc:picChg chg="del">
          <ac:chgData name="Hayk Barseghyan" userId="1af3c995-31f7-415e-9aa1-2b36900e994d" providerId="ADAL" clId="{817F6B4A-A95C-41F4-9215-42C8F6493746}" dt="2021-03-19T20:33:48.888" v="1433" actId="478"/>
          <ac:picMkLst>
            <pc:docMk/>
            <pc:sldMk cId="2230132588" sldId="666"/>
            <ac:picMk id="3" creationId="{83ED3CC2-4027-49CD-B58C-F97A5ED1330E}"/>
          </ac:picMkLst>
        </pc:picChg>
        <pc:picChg chg="add mod ord">
          <ac:chgData name="Hayk Barseghyan" userId="1af3c995-31f7-415e-9aa1-2b36900e994d" providerId="ADAL" clId="{817F6B4A-A95C-41F4-9215-42C8F6493746}" dt="2021-03-19T20:53:32.152" v="1478" actId="1076"/>
          <ac:picMkLst>
            <pc:docMk/>
            <pc:sldMk cId="2230132588" sldId="666"/>
            <ac:picMk id="4" creationId="{D8CD75F2-B8CC-4FBA-BEF2-291B126DDA83}"/>
          </ac:picMkLst>
        </pc:picChg>
        <pc:picChg chg="del">
          <ac:chgData name="Hayk Barseghyan" userId="1af3c995-31f7-415e-9aa1-2b36900e994d" providerId="ADAL" clId="{817F6B4A-A95C-41F4-9215-42C8F6493746}" dt="2021-03-19T20:41:30.030" v="1438" actId="478"/>
          <ac:picMkLst>
            <pc:docMk/>
            <pc:sldMk cId="2230132588" sldId="666"/>
            <ac:picMk id="27" creationId="{4FE6C486-F782-468B-985B-6C0EFD2310B0}"/>
          </ac:picMkLst>
        </pc:picChg>
        <pc:picChg chg="add mod">
          <ac:chgData name="Hayk Barseghyan" userId="1af3c995-31f7-415e-9aa1-2b36900e994d" providerId="ADAL" clId="{817F6B4A-A95C-41F4-9215-42C8F6493746}" dt="2021-03-19T20:33:57.920" v="1436" actId="1076"/>
          <ac:picMkLst>
            <pc:docMk/>
            <pc:sldMk cId="2230132588" sldId="666"/>
            <ac:picMk id="31" creationId="{A268F165-891D-4E0E-95D3-4928F0ED258F}"/>
          </ac:picMkLst>
        </pc:picChg>
        <pc:cxnChg chg="add mod">
          <ac:chgData name="Hayk Barseghyan" userId="1af3c995-31f7-415e-9aa1-2b36900e994d" providerId="ADAL" clId="{817F6B4A-A95C-41F4-9215-42C8F6493746}" dt="2021-03-19T20:55:03.502" v="1502" actId="14100"/>
          <ac:cxnSpMkLst>
            <pc:docMk/>
            <pc:sldMk cId="2230132588" sldId="666"/>
            <ac:cxnSpMk id="37" creationId="{937AADC3-57B6-4F7D-B029-7175FA4FA202}"/>
          </ac:cxnSpMkLst>
        </pc:cxnChg>
        <pc:cxnChg chg="del mod">
          <ac:chgData name="Hayk Barseghyan" userId="1af3c995-31f7-415e-9aa1-2b36900e994d" providerId="ADAL" clId="{817F6B4A-A95C-41F4-9215-42C8F6493746}" dt="2021-03-19T20:53:35.058" v="1479" actId="478"/>
          <ac:cxnSpMkLst>
            <pc:docMk/>
            <pc:sldMk cId="2230132588" sldId="666"/>
            <ac:cxnSpMk id="49" creationId="{4423681D-AADF-4D62-AC9E-3FDDF18E21B9}"/>
          </ac:cxnSpMkLst>
        </pc:cxnChg>
        <pc:cxnChg chg="del mod">
          <ac:chgData name="Hayk Barseghyan" userId="1af3c995-31f7-415e-9aa1-2b36900e994d" providerId="ADAL" clId="{817F6B4A-A95C-41F4-9215-42C8F6493746}" dt="2021-03-19T20:53:37.453" v="1480" actId="478"/>
          <ac:cxnSpMkLst>
            <pc:docMk/>
            <pc:sldMk cId="2230132588" sldId="666"/>
            <ac:cxnSpMk id="81" creationId="{4BCC25EA-B583-41A5-993F-C933337AE38C}"/>
          </ac:cxnSpMkLst>
        </pc:cxnChg>
        <pc:cxnChg chg="del mod">
          <ac:chgData name="Hayk Barseghyan" userId="1af3c995-31f7-415e-9aa1-2b36900e994d" providerId="ADAL" clId="{817F6B4A-A95C-41F4-9215-42C8F6493746}" dt="2021-03-19T20:53:39.502" v="1481" actId="478"/>
          <ac:cxnSpMkLst>
            <pc:docMk/>
            <pc:sldMk cId="2230132588" sldId="666"/>
            <ac:cxnSpMk id="84" creationId="{B2FDD7DF-34CC-49AF-BA68-F741766F788A}"/>
          </ac:cxnSpMkLst>
        </pc:cxnChg>
      </pc:sldChg>
    </pc:docChg>
  </pc:docChgLst>
  <pc:docChgLst>
    <pc:chgData name="Hayk Barseghyan" userId="1af3c995-31f7-415e-9aa1-2b36900e994d" providerId="ADAL" clId="{67884524-D562-4D7F-839E-951A995161A3}"/>
    <pc:docChg chg="undo redo custSel addSld delSld modSld">
      <pc:chgData name="Hayk Barseghyan" userId="1af3c995-31f7-415e-9aa1-2b36900e994d" providerId="ADAL" clId="{67884524-D562-4D7F-839E-951A995161A3}" dt="2021-04-13T22:44:16.701" v="2825" actId="1038"/>
      <pc:docMkLst>
        <pc:docMk/>
      </pc:docMkLst>
      <pc:sldChg chg="del">
        <pc:chgData name="Hayk Barseghyan" userId="1af3c995-31f7-415e-9aa1-2b36900e994d" providerId="ADAL" clId="{67884524-D562-4D7F-839E-951A995161A3}" dt="2021-04-09T15:39:18.623" v="164" actId="47"/>
        <pc:sldMkLst>
          <pc:docMk/>
          <pc:sldMk cId="143339667" sldId="655"/>
        </pc:sldMkLst>
      </pc:sldChg>
      <pc:sldChg chg="addSp delSp modSp mod modNotesTx">
        <pc:chgData name="Hayk Barseghyan" userId="1af3c995-31f7-415e-9aa1-2b36900e994d" providerId="ADAL" clId="{67884524-D562-4D7F-839E-951A995161A3}" dt="2021-04-09T21:59:14.409" v="2750" actId="1076"/>
        <pc:sldMkLst>
          <pc:docMk/>
          <pc:sldMk cId="742313956" sldId="656"/>
        </pc:sldMkLst>
        <pc:spChg chg="add mod">
          <ac:chgData name="Hayk Barseghyan" userId="1af3c995-31f7-415e-9aa1-2b36900e994d" providerId="ADAL" clId="{67884524-D562-4D7F-839E-951A995161A3}" dt="2021-04-09T20:32:28.865" v="2723" actId="1038"/>
          <ac:spMkLst>
            <pc:docMk/>
            <pc:sldMk cId="742313956" sldId="656"/>
            <ac:spMk id="14" creationId="{3F8EDA24-EE92-45E3-A63D-8DC82C39D29C}"/>
          </ac:spMkLst>
        </pc:spChg>
        <pc:spChg chg="add del mod">
          <ac:chgData name="Hayk Barseghyan" userId="1af3c995-31f7-415e-9aa1-2b36900e994d" providerId="ADAL" clId="{67884524-D562-4D7F-839E-951A995161A3}" dt="2021-04-09T19:03:29.103" v="2360" actId="478"/>
          <ac:spMkLst>
            <pc:docMk/>
            <pc:sldMk cId="742313956" sldId="656"/>
            <ac:spMk id="16" creationId="{165804BB-C112-4D51-AF2F-C51797B94D45}"/>
          </ac:spMkLst>
        </pc:spChg>
        <pc:spChg chg="add mod">
          <ac:chgData name="Hayk Barseghyan" userId="1af3c995-31f7-415e-9aa1-2b36900e994d" providerId="ADAL" clId="{67884524-D562-4D7F-839E-951A995161A3}" dt="2021-04-09T20:32:28.865" v="2723" actId="1038"/>
          <ac:spMkLst>
            <pc:docMk/>
            <pc:sldMk cId="742313956" sldId="656"/>
            <ac:spMk id="17" creationId="{C7B0D6C8-86CD-445E-B412-874834C5BCE0}"/>
          </ac:spMkLst>
        </pc:spChg>
        <pc:spChg chg="del">
          <ac:chgData name="Hayk Barseghyan" userId="1af3c995-31f7-415e-9aa1-2b36900e994d" providerId="ADAL" clId="{67884524-D562-4D7F-839E-951A995161A3}" dt="2021-04-09T20:31:40.366" v="2703" actId="478"/>
          <ac:spMkLst>
            <pc:docMk/>
            <pc:sldMk cId="742313956" sldId="656"/>
            <ac:spMk id="18" creationId="{5DD4D5E1-1043-4AC3-B4A3-DB3836370A00}"/>
          </ac:spMkLst>
        </pc:spChg>
        <pc:spChg chg="del mod">
          <ac:chgData name="Hayk Barseghyan" userId="1af3c995-31f7-415e-9aa1-2b36900e994d" providerId="ADAL" clId="{67884524-D562-4D7F-839E-951A995161A3}" dt="2021-04-09T20:28:57.954" v="2690" actId="21"/>
          <ac:spMkLst>
            <pc:docMk/>
            <pc:sldMk cId="742313956" sldId="656"/>
            <ac:spMk id="19" creationId="{3F12C9F5-C449-4B43-AC1C-C3E0C524D931}"/>
          </ac:spMkLst>
        </pc:spChg>
        <pc:spChg chg="add mod">
          <ac:chgData name="Hayk Barseghyan" userId="1af3c995-31f7-415e-9aa1-2b36900e994d" providerId="ADAL" clId="{67884524-D562-4D7F-839E-951A995161A3}" dt="2021-04-09T20:32:28.865" v="2723" actId="1038"/>
          <ac:spMkLst>
            <pc:docMk/>
            <pc:sldMk cId="742313956" sldId="656"/>
            <ac:spMk id="20" creationId="{1CB373C8-38EF-4E2F-A755-BBAD3481AA7D}"/>
          </ac:spMkLst>
        </pc:spChg>
        <pc:spChg chg="add mod">
          <ac:chgData name="Hayk Barseghyan" userId="1af3c995-31f7-415e-9aa1-2b36900e994d" providerId="ADAL" clId="{67884524-D562-4D7F-839E-951A995161A3}" dt="2021-04-09T20:32:28.865" v="2723" actId="1038"/>
          <ac:spMkLst>
            <pc:docMk/>
            <pc:sldMk cId="742313956" sldId="656"/>
            <ac:spMk id="21" creationId="{A03CF11F-5F5D-4149-B7B4-AC1A24BF1B35}"/>
          </ac:spMkLst>
        </pc:spChg>
        <pc:spChg chg="add mod">
          <ac:chgData name="Hayk Barseghyan" userId="1af3c995-31f7-415e-9aa1-2b36900e994d" providerId="ADAL" clId="{67884524-D562-4D7F-839E-951A995161A3}" dt="2021-04-09T20:31:29.013" v="2701" actId="1076"/>
          <ac:spMkLst>
            <pc:docMk/>
            <pc:sldMk cId="742313956" sldId="656"/>
            <ac:spMk id="23" creationId="{72FB1E45-4C94-42F2-BEA4-180DEA8D61E2}"/>
          </ac:spMkLst>
        </pc:spChg>
        <pc:spChg chg="del">
          <ac:chgData name="Hayk Barseghyan" userId="1af3c995-31f7-415e-9aa1-2b36900e994d" providerId="ADAL" clId="{67884524-D562-4D7F-839E-951A995161A3}" dt="2021-04-09T18:12:53.449" v="2293" actId="478"/>
          <ac:spMkLst>
            <pc:docMk/>
            <pc:sldMk cId="742313956" sldId="656"/>
            <ac:spMk id="24" creationId="{08AD8F4B-F50F-48B3-A1C6-A8E9F84AFB80}"/>
          </ac:spMkLst>
        </pc:spChg>
        <pc:spChg chg="del">
          <ac:chgData name="Hayk Barseghyan" userId="1af3c995-31f7-415e-9aa1-2b36900e994d" providerId="ADAL" clId="{67884524-D562-4D7F-839E-951A995161A3}" dt="2021-04-09T18:12:53.449" v="2293" actId="478"/>
          <ac:spMkLst>
            <pc:docMk/>
            <pc:sldMk cId="742313956" sldId="656"/>
            <ac:spMk id="25" creationId="{09902C2B-5D85-4723-8E35-13D99ED2764C}"/>
          </ac:spMkLst>
        </pc:spChg>
        <pc:spChg chg="del">
          <ac:chgData name="Hayk Barseghyan" userId="1af3c995-31f7-415e-9aa1-2b36900e994d" providerId="ADAL" clId="{67884524-D562-4D7F-839E-951A995161A3}" dt="2021-04-09T18:12:53.449" v="2293" actId="478"/>
          <ac:spMkLst>
            <pc:docMk/>
            <pc:sldMk cId="742313956" sldId="656"/>
            <ac:spMk id="26" creationId="{28F00DCA-4ACB-421E-8A62-5F0025FD3DB2}"/>
          </ac:spMkLst>
        </pc:spChg>
        <pc:spChg chg="add mod">
          <ac:chgData name="Hayk Barseghyan" userId="1af3c995-31f7-415e-9aa1-2b36900e994d" providerId="ADAL" clId="{67884524-D562-4D7F-839E-951A995161A3}" dt="2021-04-09T20:31:26.126" v="2699" actId="1076"/>
          <ac:spMkLst>
            <pc:docMk/>
            <pc:sldMk cId="742313956" sldId="656"/>
            <ac:spMk id="27" creationId="{7E9C8F3F-17F1-46F4-8548-E46075F18624}"/>
          </ac:spMkLst>
        </pc:spChg>
        <pc:spChg chg="add mod">
          <ac:chgData name="Hayk Barseghyan" userId="1af3c995-31f7-415e-9aa1-2b36900e994d" providerId="ADAL" clId="{67884524-D562-4D7F-839E-951A995161A3}" dt="2021-04-09T20:31:26.126" v="2699" actId="1076"/>
          <ac:spMkLst>
            <pc:docMk/>
            <pc:sldMk cId="742313956" sldId="656"/>
            <ac:spMk id="28" creationId="{26162908-999C-46CB-AD37-6DCE2E310DDA}"/>
          </ac:spMkLst>
        </pc:spChg>
        <pc:spChg chg="add mod">
          <ac:chgData name="Hayk Barseghyan" userId="1af3c995-31f7-415e-9aa1-2b36900e994d" providerId="ADAL" clId="{67884524-D562-4D7F-839E-951A995161A3}" dt="2021-04-09T20:31:26.126" v="2699" actId="1076"/>
          <ac:spMkLst>
            <pc:docMk/>
            <pc:sldMk cId="742313956" sldId="656"/>
            <ac:spMk id="29" creationId="{4B5ECF8E-AC64-43BC-9AB8-D359743BF00E}"/>
          </ac:spMkLst>
        </pc:spChg>
        <pc:spChg chg="add mod">
          <ac:chgData name="Hayk Barseghyan" userId="1af3c995-31f7-415e-9aa1-2b36900e994d" providerId="ADAL" clId="{67884524-D562-4D7F-839E-951A995161A3}" dt="2021-04-09T20:31:26.126" v="2699" actId="1076"/>
          <ac:spMkLst>
            <pc:docMk/>
            <pc:sldMk cId="742313956" sldId="656"/>
            <ac:spMk id="30" creationId="{45096969-A9E3-447B-84B4-04672D0522EE}"/>
          </ac:spMkLst>
        </pc:spChg>
        <pc:spChg chg="del mod">
          <ac:chgData name="Hayk Barseghyan" userId="1af3c995-31f7-415e-9aa1-2b36900e994d" providerId="ADAL" clId="{67884524-D562-4D7F-839E-951A995161A3}" dt="2021-04-09T19:03:17.908" v="2358" actId="478"/>
          <ac:spMkLst>
            <pc:docMk/>
            <pc:sldMk cId="742313956" sldId="656"/>
            <ac:spMk id="32" creationId="{C8EED87A-0AE7-41CB-B85F-5690D93EF3E6}"/>
          </ac:spMkLst>
        </pc:spChg>
        <pc:spChg chg="add mod">
          <ac:chgData name="Hayk Barseghyan" userId="1af3c995-31f7-415e-9aa1-2b36900e994d" providerId="ADAL" clId="{67884524-D562-4D7F-839E-951A995161A3}" dt="2021-04-09T20:31:26.126" v="2699" actId="1076"/>
          <ac:spMkLst>
            <pc:docMk/>
            <pc:sldMk cId="742313956" sldId="656"/>
            <ac:spMk id="33" creationId="{8CFF7B01-E15A-4E1D-92B1-D59F9488EC80}"/>
          </ac:spMkLst>
        </pc:spChg>
        <pc:spChg chg="add mod">
          <ac:chgData name="Hayk Barseghyan" userId="1af3c995-31f7-415e-9aa1-2b36900e994d" providerId="ADAL" clId="{67884524-D562-4D7F-839E-951A995161A3}" dt="2021-04-09T20:31:26.126" v="2699" actId="1076"/>
          <ac:spMkLst>
            <pc:docMk/>
            <pc:sldMk cId="742313956" sldId="656"/>
            <ac:spMk id="34" creationId="{E9222BD2-B966-48F7-978F-1318F5D674F3}"/>
          </ac:spMkLst>
        </pc:spChg>
        <pc:spChg chg="add mod">
          <ac:chgData name="Hayk Barseghyan" userId="1af3c995-31f7-415e-9aa1-2b36900e994d" providerId="ADAL" clId="{67884524-D562-4D7F-839E-951A995161A3}" dt="2021-04-09T20:31:26.126" v="2699" actId="1076"/>
          <ac:spMkLst>
            <pc:docMk/>
            <pc:sldMk cId="742313956" sldId="656"/>
            <ac:spMk id="35" creationId="{5D34BFF3-440E-48EA-855C-E2515CE91612}"/>
          </ac:spMkLst>
        </pc:spChg>
        <pc:spChg chg="add mod">
          <ac:chgData name="Hayk Barseghyan" userId="1af3c995-31f7-415e-9aa1-2b36900e994d" providerId="ADAL" clId="{67884524-D562-4D7F-839E-951A995161A3}" dt="2021-04-09T20:32:19.261" v="2718" actId="1037"/>
          <ac:spMkLst>
            <pc:docMk/>
            <pc:sldMk cId="742313956" sldId="656"/>
            <ac:spMk id="37" creationId="{50D367EC-26C9-42C4-960C-7F17502E01D7}"/>
          </ac:spMkLst>
        </pc:spChg>
        <pc:spChg chg="add mod">
          <ac:chgData name="Hayk Barseghyan" userId="1af3c995-31f7-415e-9aa1-2b36900e994d" providerId="ADAL" clId="{67884524-D562-4D7F-839E-951A995161A3}" dt="2021-04-09T20:32:02.025" v="2709" actId="20577"/>
          <ac:spMkLst>
            <pc:docMk/>
            <pc:sldMk cId="742313956" sldId="656"/>
            <ac:spMk id="38" creationId="{C0DC8D2B-DAB2-47BC-8E1F-304E4713F65A}"/>
          </ac:spMkLst>
        </pc:spChg>
        <pc:spChg chg="add mod">
          <ac:chgData name="Hayk Barseghyan" userId="1af3c995-31f7-415e-9aa1-2b36900e994d" providerId="ADAL" clId="{67884524-D562-4D7F-839E-951A995161A3}" dt="2021-04-09T20:32:10.960" v="2713" actId="20577"/>
          <ac:spMkLst>
            <pc:docMk/>
            <pc:sldMk cId="742313956" sldId="656"/>
            <ac:spMk id="39" creationId="{5EF4EE1F-D110-4D27-8A39-0488338A7477}"/>
          </ac:spMkLst>
        </pc:spChg>
        <pc:spChg chg="del mod">
          <ac:chgData name="Hayk Barseghyan" userId="1af3c995-31f7-415e-9aa1-2b36900e994d" providerId="ADAL" clId="{67884524-D562-4D7F-839E-951A995161A3}" dt="2021-04-09T20:28:57.954" v="2690" actId="21"/>
          <ac:spMkLst>
            <pc:docMk/>
            <pc:sldMk cId="742313956" sldId="656"/>
            <ac:spMk id="40" creationId="{03C35834-9994-4DBC-A8F8-7F81D9308BC6}"/>
          </ac:spMkLst>
        </pc:spChg>
        <pc:spChg chg="del mod">
          <ac:chgData name="Hayk Barseghyan" userId="1af3c995-31f7-415e-9aa1-2b36900e994d" providerId="ADAL" clId="{67884524-D562-4D7F-839E-951A995161A3}" dt="2021-04-09T20:28:57.954" v="2690" actId="21"/>
          <ac:spMkLst>
            <pc:docMk/>
            <pc:sldMk cId="742313956" sldId="656"/>
            <ac:spMk id="41" creationId="{77AA0295-E04C-47D7-9AD2-E60A3E1CF6E9}"/>
          </ac:spMkLst>
        </pc:spChg>
        <pc:spChg chg="add mod">
          <ac:chgData name="Hayk Barseghyan" userId="1af3c995-31f7-415e-9aa1-2b36900e994d" providerId="ADAL" clId="{67884524-D562-4D7F-839E-951A995161A3}" dt="2021-04-09T21:37:02.498" v="2749" actId="1076"/>
          <ac:spMkLst>
            <pc:docMk/>
            <pc:sldMk cId="742313956" sldId="656"/>
            <ac:spMk id="42" creationId="{6DDBB1BF-A060-4469-8C25-83BC8B02C54D}"/>
          </ac:spMkLst>
        </pc:spChg>
        <pc:spChg chg="mod">
          <ac:chgData name="Hayk Barseghyan" userId="1af3c995-31f7-415e-9aa1-2b36900e994d" providerId="ADAL" clId="{67884524-D562-4D7F-839E-951A995161A3}" dt="2021-04-09T18:13:23.851" v="2298" actId="20577"/>
          <ac:spMkLst>
            <pc:docMk/>
            <pc:sldMk cId="742313956" sldId="656"/>
            <ac:spMk id="49" creationId="{270740F3-8276-4A91-AA98-A4A4273156A7}"/>
          </ac:spMkLst>
        </pc:spChg>
        <pc:picChg chg="del mod">
          <ac:chgData name="Hayk Barseghyan" userId="1af3c995-31f7-415e-9aa1-2b36900e994d" providerId="ADAL" clId="{67884524-D562-4D7F-839E-951A995161A3}" dt="2021-04-09T20:28:57.954" v="2690" actId="21"/>
          <ac:picMkLst>
            <pc:docMk/>
            <pc:sldMk cId="742313956" sldId="656"/>
            <ac:picMk id="8" creationId="{2025D8F4-DB00-4692-A85A-11644A3ECBF3}"/>
          </ac:picMkLst>
        </pc:picChg>
        <pc:picChg chg="add mod">
          <ac:chgData name="Hayk Barseghyan" userId="1af3c995-31f7-415e-9aa1-2b36900e994d" providerId="ADAL" clId="{67884524-D562-4D7F-839E-951A995161A3}" dt="2021-04-09T20:32:28.865" v="2723" actId="1038"/>
          <ac:picMkLst>
            <pc:docMk/>
            <pc:sldMk cId="742313956" sldId="656"/>
            <ac:picMk id="22" creationId="{201254A7-FF41-4E95-92B1-BEA41BDE41A3}"/>
          </ac:picMkLst>
        </pc:picChg>
        <pc:picChg chg="del">
          <ac:chgData name="Hayk Barseghyan" userId="1af3c995-31f7-415e-9aa1-2b36900e994d" providerId="ADAL" clId="{67884524-D562-4D7F-839E-951A995161A3}" dt="2021-04-09T18:12:49.900" v="2291" actId="478"/>
          <ac:picMkLst>
            <pc:docMk/>
            <pc:sldMk cId="742313956" sldId="656"/>
            <ac:picMk id="31" creationId="{A423A7A3-37E0-495F-A41D-46390BECA406}"/>
          </ac:picMkLst>
        </pc:picChg>
        <pc:picChg chg="add mod">
          <ac:chgData name="Hayk Barseghyan" userId="1af3c995-31f7-415e-9aa1-2b36900e994d" providerId="ADAL" clId="{67884524-D562-4D7F-839E-951A995161A3}" dt="2021-04-09T21:59:14.409" v="2750" actId="1076"/>
          <ac:picMkLst>
            <pc:docMk/>
            <pc:sldMk cId="742313956" sldId="656"/>
            <ac:picMk id="36" creationId="{DBF16D19-79D0-48EF-B670-E7442E814215}"/>
          </ac:picMkLst>
        </pc:picChg>
        <pc:cxnChg chg="del mod">
          <ac:chgData name="Hayk Barseghyan" userId="1af3c995-31f7-415e-9aa1-2b36900e994d" providerId="ADAL" clId="{67884524-D562-4D7F-839E-951A995161A3}" dt="2021-04-09T18:12:51.855" v="2292" actId="478"/>
          <ac:cxnSpMkLst>
            <pc:docMk/>
            <pc:sldMk cId="742313956" sldId="656"/>
            <ac:cxnSpMk id="15" creationId="{83C67EB0-D1EA-4634-9EF7-15A5E4407077}"/>
          </ac:cxnSpMkLst>
        </pc:cxnChg>
      </pc:sldChg>
      <pc:sldChg chg="addSp delSp modSp mod modNotesTx">
        <pc:chgData name="Hayk Barseghyan" userId="1af3c995-31f7-415e-9aa1-2b36900e994d" providerId="ADAL" clId="{67884524-D562-4D7F-839E-951A995161A3}" dt="2021-04-09T20:30:44.014" v="2693" actId="1076"/>
        <pc:sldMkLst>
          <pc:docMk/>
          <pc:sldMk cId="2755479697" sldId="657"/>
        </pc:sldMkLst>
        <pc:spChg chg="del">
          <ac:chgData name="Hayk Barseghyan" userId="1af3c995-31f7-415e-9aa1-2b36900e994d" providerId="ADAL" clId="{67884524-D562-4D7F-839E-951A995161A3}" dt="2021-04-09T19:13:36.121" v="2362" actId="478"/>
          <ac:spMkLst>
            <pc:docMk/>
            <pc:sldMk cId="2755479697" sldId="657"/>
            <ac:spMk id="31" creationId="{9E94FD29-26A3-4250-90B8-01A2CDD1802D}"/>
          </ac:spMkLst>
        </pc:spChg>
        <pc:spChg chg="mod">
          <ac:chgData name="Hayk Barseghyan" userId="1af3c995-31f7-415e-9aa1-2b36900e994d" providerId="ADAL" clId="{67884524-D562-4D7F-839E-951A995161A3}" dt="2021-04-09T19:43:13.877" v="2587" actId="1035"/>
          <ac:spMkLst>
            <pc:docMk/>
            <pc:sldMk cId="2755479697" sldId="657"/>
            <ac:spMk id="33" creationId="{A160E36A-BAB1-47CD-94C7-4E111391A11F}"/>
          </ac:spMkLst>
        </pc:spChg>
        <pc:spChg chg="mod">
          <ac:chgData name="Hayk Barseghyan" userId="1af3c995-31f7-415e-9aa1-2b36900e994d" providerId="ADAL" clId="{67884524-D562-4D7F-839E-951A995161A3}" dt="2021-04-09T19:45:28.705" v="2665" actId="1036"/>
          <ac:spMkLst>
            <pc:docMk/>
            <pc:sldMk cId="2755479697" sldId="657"/>
            <ac:spMk id="34" creationId="{05CB38A4-C9D7-49FD-99AF-2F0DEDA1D811}"/>
          </ac:spMkLst>
        </pc:spChg>
        <pc:spChg chg="mod">
          <ac:chgData name="Hayk Barseghyan" userId="1af3c995-31f7-415e-9aa1-2b36900e994d" providerId="ADAL" clId="{67884524-D562-4D7F-839E-951A995161A3}" dt="2021-04-09T19:43:13.877" v="2587" actId="1035"/>
          <ac:spMkLst>
            <pc:docMk/>
            <pc:sldMk cId="2755479697" sldId="657"/>
            <ac:spMk id="36" creationId="{AAA6FDD3-1997-4440-B229-25C5E9AA3C78}"/>
          </ac:spMkLst>
        </pc:spChg>
        <pc:spChg chg="mod">
          <ac:chgData name="Hayk Barseghyan" userId="1af3c995-31f7-415e-9aa1-2b36900e994d" providerId="ADAL" clId="{67884524-D562-4D7F-839E-951A995161A3}" dt="2021-04-09T19:43:49.349" v="2615" actId="1076"/>
          <ac:spMkLst>
            <pc:docMk/>
            <pc:sldMk cId="2755479697" sldId="657"/>
            <ac:spMk id="37" creationId="{8FB068C2-9704-43F5-A556-B959D1EBFF14}"/>
          </ac:spMkLst>
        </pc:spChg>
        <pc:spChg chg="mod">
          <ac:chgData name="Hayk Barseghyan" userId="1af3c995-31f7-415e-9aa1-2b36900e994d" providerId="ADAL" clId="{67884524-D562-4D7F-839E-951A995161A3}" dt="2021-04-09T19:43:13.877" v="2587" actId="1035"/>
          <ac:spMkLst>
            <pc:docMk/>
            <pc:sldMk cId="2755479697" sldId="657"/>
            <ac:spMk id="38" creationId="{E1D4BE3F-7DAB-455D-95E5-C2EE8C764DA9}"/>
          </ac:spMkLst>
        </pc:spChg>
        <pc:spChg chg="add mod">
          <ac:chgData name="Hayk Barseghyan" userId="1af3c995-31f7-415e-9aa1-2b36900e994d" providerId="ADAL" clId="{67884524-D562-4D7F-839E-951A995161A3}" dt="2021-04-09T19:43:13.877" v="2587" actId="1035"/>
          <ac:spMkLst>
            <pc:docMk/>
            <pc:sldMk cId="2755479697" sldId="657"/>
            <ac:spMk id="39" creationId="{353CECBA-0A0B-4EAF-9643-B1C81CD82A1A}"/>
          </ac:spMkLst>
        </pc:spChg>
        <pc:spChg chg="add mod">
          <ac:chgData name="Hayk Barseghyan" userId="1af3c995-31f7-415e-9aa1-2b36900e994d" providerId="ADAL" clId="{67884524-D562-4D7F-839E-951A995161A3}" dt="2021-04-09T19:43:13.877" v="2587" actId="1035"/>
          <ac:spMkLst>
            <pc:docMk/>
            <pc:sldMk cId="2755479697" sldId="657"/>
            <ac:spMk id="40" creationId="{F5AEBB0C-2A5B-4023-AE6D-5D88F7529866}"/>
          </ac:spMkLst>
        </pc:spChg>
        <pc:spChg chg="add mod">
          <ac:chgData name="Hayk Barseghyan" userId="1af3c995-31f7-415e-9aa1-2b36900e994d" providerId="ADAL" clId="{67884524-D562-4D7F-839E-951A995161A3}" dt="2021-04-09T19:43:13.877" v="2587" actId="1035"/>
          <ac:spMkLst>
            <pc:docMk/>
            <pc:sldMk cId="2755479697" sldId="657"/>
            <ac:spMk id="41" creationId="{55A3B37C-081D-4E21-9CF4-C9161EF4F5F2}"/>
          </ac:spMkLst>
        </pc:spChg>
        <pc:spChg chg="add mod">
          <ac:chgData name="Hayk Barseghyan" userId="1af3c995-31f7-415e-9aa1-2b36900e994d" providerId="ADAL" clId="{67884524-D562-4D7F-839E-951A995161A3}" dt="2021-04-09T19:43:13.877" v="2587" actId="1035"/>
          <ac:spMkLst>
            <pc:docMk/>
            <pc:sldMk cId="2755479697" sldId="657"/>
            <ac:spMk id="42" creationId="{1182288B-CFF7-40F7-9174-269C6CBA88C5}"/>
          </ac:spMkLst>
        </pc:spChg>
        <pc:spChg chg="add mod">
          <ac:chgData name="Hayk Barseghyan" userId="1af3c995-31f7-415e-9aa1-2b36900e994d" providerId="ADAL" clId="{67884524-D562-4D7F-839E-951A995161A3}" dt="2021-04-09T19:43:13.877" v="2587" actId="1035"/>
          <ac:spMkLst>
            <pc:docMk/>
            <pc:sldMk cId="2755479697" sldId="657"/>
            <ac:spMk id="43" creationId="{61AE17A9-AD32-488E-8694-DCCB04339400}"/>
          </ac:spMkLst>
        </pc:spChg>
        <pc:spChg chg="add mod">
          <ac:chgData name="Hayk Barseghyan" userId="1af3c995-31f7-415e-9aa1-2b36900e994d" providerId="ADAL" clId="{67884524-D562-4D7F-839E-951A995161A3}" dt="2021-04-09T19:44:24.756" v="2650" actId="1035"/>
          <ac:spMkLst>
            <pc:docMk/>
            <pc:sldMk cId="2755479697" sldId="657"/>
            <ac:spMk id="44" creationId="{F272A63F-66AA-4F20-94A1-ADE22B2CCDF1}"/>
          </ac:spMkLst>
        </pc:spChg>
        <pc:spChg chg="add mod">
          <ac:chgData name="Hayk Barseghyan" userId="1af3c995-31f7-415e-9aa1-2b36900e994d" providerId="ADAL" clId="{67884524-D562-4D7F-839E-951A995161A3}" dt="2021-04-09T19:44:05.729" v="2629" actId="1036"/>
          <ac:spMkLst>
            <pc:docMk/>
            <pc:sldMk cId="2755479697" sldId="657"/>
            <ac:spMk id="45" creationId="{68362A5A-75F7-4F73-BD7D-EEB1C62E1ED8}"/>
          </ac:spMkLst>
        </pc:spChg>
        <pc:spChg chg="add mod">
          <ac:chgData name="Hayk Barseghyan" userId="1af3c995-31f7-415e-9aa1-2b36900e994d" providerId="ADAL" clId="{67884524-D562-4D7F-839E-951A995161A3}" dt="2021-04-09T19:43:59.439" v="2616" actId="1076"/>
          <ac:spMkLst>
            <pc:docMk/>
            <pc:sldMk cId="2755479697" sldId="657"/>
            <ac:spMk id="46" creationId="{E5AA8A5C-3356-4D5A-B5F5-B43D88A6869B}"/>
          </ac:spMkLst>
        </pc:spChg>
        <pc:spChg chg="del mod">
          <ac:chgData name="Hayk Barseghyan" userId="1af3c995-31f7-415e-9aa1-2b36900e994d" providerId="ADAL" clId="{67884524-D562-4D7F-839E-951A995161A3}" dt="2021-04-09T19:43:03.977" v="2565" actId="478"/>
          <ac:spMkLst>
            <pc:docMk/>
            <pc:sldMk cId="2755479697" sldId="657"/>
            <ac:spMk id="49" creationId="{270740F3-8276-4A91-AA98-A4A4273156A7}"/>
          </ac:spMkLst>
        </pc:spChg>
        <pc:spChg chg="add mod">
          <ac:chgData name="Hayk Barseghyan" userId="1af3c995-31f7-415e-9aa1-2b36900e994d" providerId="ADAL" clId="{67884524-D562-4D7F-839E-951A995161A3}" dt="2021-04-09T19:45:28.705" v="2665" actId="1036"/>
          <ac:spMkLst>
            <pc:docMk/>
            <pc:sldMk cId="2755479697" sldId="657"/>
            <ac:spMk id="61" creationId="{74CC2BC4-2A0E-41FD-BD92-FBDA7CAA9CD4}"/>
          </ac:spMkLst>
        </pc:spChg>
        <pc:spChg chg="add mod">
          <ac:chgData name="Hayk Barseghyan" userId="1af3c995-31f7-415e-9aa1-2b36900e994d" providerId="ADAL" clId="{67884524-D562-4D7F-839E-951A995161A3}" dt="2021-04-09T19:45:28.705" v="2665" actId="1036"/>
          <ac:spMkLst>
            <pc:docMk/>
            <pc:sldMk cId="2755479697" sldId="657"/>
            <ac:spMk id="62" creationId="{256E1282-B7ED-444F-A42C-12229DC99F9B}"/>
          </ac:spMkLst>
        </pc:spChg>
        <pc:spChg chg="add mod">
          <ac:chgData name="Hayk Barseghyan" userId="1af3c995-31f7-415e-9aa1-2b36900e994d" providerId="ADAL" clId="{67884524-D562-4D7F-839E-951A995161A3}" dt="2021-04-09T19:45:28.705" v="2665" actId="1036"/>
          <ac:spMkLst>
            <pc:docMk/>
            <pc:sldMk cId="2755479697" sldId="657"/>
            <ac:spMk id="63" creationId="{9502FD97-3801-438C-80C5-A24226710C4F}"/>
          </ac:spMkLst>
        </pc:spChg>
        <pc:spChg chg="del">
          <ac:chgData name="Hayk Barseghyan" userId="1af3c995-31f7-415e-9aa1-2b36900e994d" providerId="ADAL" clId="{67884524-D562-4D7F-839E-951A995161A3}" dt="2021-04-09T19:37:38.181" v="2398" actId="478"/>
          <ac:spMkLst>
            <pc:docMk/>
            <pc:sldMk cId="2755479697" sldId="657"/>
            <ac:spMk id="68" creationId="{34BD1FF5-2295-462F-BA39-E70FC71178F8}"/>
          </ac:spMkLst>
        </pc:spChg>
        <pc:spChg chg="del">
          <ac:chgData name="Hayk Barseghyan" userId="1af3c995-31f7-415e-9aa1-2b36900e994d" providerId="ADAL" clId="{67884524-D562-4D7F-839E-951A995161A3}" dt="2021-04-09T19:37:41.121" v="2399" actId="478"/>
          <ac:spMkLst>
            <pc:docMk/>
            <pc:sldMk cId="2755479697" sldId="657"/>
            <ac:spMk id="71" creationId="{5AADF1D3-8691-430F-89D1-A94B46D2A263}"/>
          </ac:spMkLst>
        </pc:spChg>
        <pc:spChg chg="del">
          <ac:chgData name="Hayk Barseghyan" userId="1af3c995-31f7-415e-9aa1-2b36900e994d" providerId="ADAL" clId="{67884524-D562-4D7F-839E-951A995161A3}" dt="2021-04-09T19:37:42.725" v="2400" actId="478"/>
          <ac:spMkLst>
            <pc:docMk/>
            <pc:sldMk cId="2755479697" sldId="657"/>
            <ac:spMk id="72" creationId="{6E8E9403-AB50-4FEB-B4C4-601B6706A470}"/>
          </ac:spMkLst>
        </pc:spChg>
        <pc:spChg chg="mod">
          <ac:chgData name="Hayk Barseghyan" userId="1af3c995-31f7-415e-9aa1-2b36900e994d" providerId="ADAL" clId="{67884524-D562-4D7F-839E-951A995161A3}" dt="2021-04-09T19:45:28.705" v="2665" actId="1036"/>
          <ac:spMkLst>
            <pc:docMk/>
            <pc:sldMk cId="2755479697" sldId="657"/>
            <ac:spMk id="73" creationId="{1D26E09B-A378-4E7C-B3BE-7B103434FCB6}"/>
          </ac:spMkLst>
        </pc:spChg>
        <pc:spChg chg="mod">
          <ac:chgData name="Hayk Barseghyan" userId="1af3c995-31f7-415e-9aa1-2b36900e994d" providerId="ADAL" clId="{67884524-D562-4D7F-839E-951A995161A3}" dt="2021-04-09T19:45:28.705" v="2665" actId="1036"/>
          <ac:spMkLst>
            <pc:docMk/>
            <pc:sldMk cId="2755479697" sldId="657"/>
            <ac:spMk id="78" creationId="{A378CE8E-FD3C-4B20-A24B-AF9809EA6C83}"/>
          </ac:spMkLst>
        </pc:spChg>
        <pc:spChg chg="mod">
          <ac:chgData name="Hayk Barseghyan" userId="1af3c995-31f7-415e-9aa1-2b36900e994d" providerId="ADAL" clId="{67884524-D562-4D7F-839E-951A995161A3}" dt="2021-04-09T19:45:28.705" v="2665" actId="1036"/>
          <ac:spMkLst>
            <pc:docMk/>
            <pc:sldMk cId="2755479697" sldId="657"/>
            <ac:spMk id="79" creationId="{C51ADB4D-3640-45C3-80EF-5502C71420FD}"/>
          </ac:spMkLst>
        </pc:spChg>
        <pc:spChg chg="add mod">
          <ac:chgData name="Hayk Barseghyan" userId="1af3c995-31f7-415e-9aa1-2b36900e994d" providerId="ADAL" clId="{67884524-D562-4D7F-839E-951A995161A3}" dt="2021-04-09T19:46:18.321" v="2674" actId="1076"/>
          <ac:spMkLst>
            <pc:docMk/>
            <pc:sldMk cId="2755479697" sldId="657"/>
            <ac:spMk id="80" creationId="{540C032E-3B07-4BB5-9479-D34E3D35F713}"/>
          </ac:spMkLst>
        </pc:spChg>
        <pc:spChg chg="del">
          <ac:chgData name="Hayk Barseghyan" userId="1af3c995-31f7-415e-9aa1-2b36900e994d" providerId="ADAL" clId="{67884524-D562-4D7F-839E-951A995161A3}" dt="2021-04-09T19:21:55.558" v="2367" actId="478"/>
          <ac:spMkLst>
            <pc:docMk/>
            <pc:sldMk cId="2755479697" sldId="657"/>
            <ac:spMk id="81" creationId="{07786BAB-F6A6-4296-89B6-7CA9DAA57F71}"/>
          </ac:spMkLst>
        </pc:spChg>
        <pc:spChg chg="del">
          <ac:chgData name="Hayk Barseghyan" userId="1af3c995-31f7-415e-9aa1-2b36900e994d" providerId="ADAL" clId="{67884524-D562-4D7F-839E-951A995161A3}" dt="2021-04-09T19:21:55.558" v="2367" actId="478"/>
          <ac:spMkLst>
            <pc:docMk/>
            <pc:sldMk cId="2755479697" sldId="657"/>
            <ac:spMk id="82" creationId="{6061F006-A694-4901-A849-27628F0B9AA7}"/>
          </ac:spMkLst>
        </pc:spChg>
        <pc:spChg chg="add mod">
          <ac:chgData name="Hayk Barseghyan" userId="1af3c995-31f7-415e-9aa1-2b36900e994d" providerId="ADAL" clId="{67884524-D562-4D7F-839E-951A995161A3}" dt="2021-04-09T19:46:30.281" v="2679" actId="1076"/>
          <ac:spMkLst>
            <pc:docMk/>
            <pc:sldMk cId="2755479697" sldId="657"/>
            <ac:spMk id="84" creationId="{730636F3-73A0-43F8-9E2C-68FEB536E6D2}"/>
          </ac:spMkLst>
        </pc:spChg>
        <pc:spChg chg="add mod">
          <ac:chgData name="Hayk Barseghyan" userId="1af3c995-31f7-415e-9aa1-2b36900e994d" providerId="ADAL" clId="{67884524-D562-4D7F-839E-951A995161A3}" dt="2021-04-09T20:30:44.014" v="2693" actId="1076"/>
          <ac:spMkLst>
            <pc:docMk/>
            <pc:sldMk cId="2755479697" sldId="657"/>
            <ac:spMk id="87" creationId="{2C9C4A4E-D24B-4AC3-A14C-2629326039C9}"/>
          </ac:spMkLst>
        </pc:spChg>
        <pc:spChg chg="add mod">
          <ac:chgData name="Hayk Barseghyan" userId="1af3c995-31f7-415e-9aa1-2b36900e994d" providerId="ADAL" clId="{67884524-D562-4D7F-839E-951A995161A3}" dt="2021-04-09T20:30:44.014" v="2693" actId="1076"/>
          <ac:spMkLst>
            <pc:docMk/>
            <pc:sldMk cId="2755479697" sldId="657"/>
            <ac:spMk id="88" creationId="{6882F801-419D-4634-93E8-1E3BDF3E1499}"/>
          </ac:spMkLst>
        </pc:spChg>
        <pc:spChg chg="add mod">
          <ac:chgData name="Hayk Barseghyan" userId="1af3c995-31f7-415e-9aa1-2b36900e994d" providerId="ADAL" clId="{67884524-D562-4D7F-839E-951A995161A3}" dt="2021-04-09T20:30:44.014" v="2693" actId="1076"/>
          <ac:spMkLst>
            <pc:docMk/>
            <pc:sldMk cId="2755479697" sldId="657"/>
            <ac:spMk id="89" creationId="{0907A344-8B17-4CD5-8643-DC5A53A68265}"/>
          </ac:spMkLst>
        </pc:spChg>
        <pc:spChg chg="mod">
          <ac:chgData name="Hayk Barseghyan" userId="1af3c995-31f7-415e-9aa1-2b36900e994d" providerId="ADAL" clId="{67884524-D562-4D7F-839E-951A995161A3}" dt="2021-04-09T19:45:09.915" v="2656" actId="1076"/>
          <ac:spMkLst>
            <pc:docMk/>
            <pc:sldMk cId="2755479697" sldId="657"/>
            <ac:spMk id="91" creationId="{890F756B-174F-4736-BB50-7F07F8A6C603}"/>
          </ac:spMkLst>
        </pc:spChg>
        <pc:spChg chg="mod">
          <ac:chgData name="Hayk Barseghyan" userId="1af3c995-31f7-415e-9aa1-2b36900e994d" providerId="ADAL" clId="{67884524-D562-4D7F-839E-951A995161A3}" dt="2021-04-09T19:45:16.645" v="2657" actId="1076"/>
          <ac:spMkLst>
            <pc:docMk/>
            <pc:sldMk cId="2755479697" sldId="657"/>
            <ac:spMk id="94" creationId="{BF106B4E-9057-4F0F-B25D-27BD2332C592}"/>
          </ac:spMkLst>
        </pc:spChg>
        <pc:spChg chg="mod">
          <ac:chgData name="Hayk Barseghyan" userId="1af3c995-31f7-415e-9aa1-2b36900e994d" providerId="ADAL" clId="{67884524-D562-4D7F-839E-951A995161A3}" dt="2021-04-09T19:45:28.705" v="2665" actId="1036"/>
          <ac:spMkLst>
            <pc:docMk/>
            <pc:sldMk cId="2755479697" sldId="657"/>
            <ac:spMk id="99" creationId="{5463678B-2C98-4048-B0E3-1D5FC1D58F2B}"/>
          </ac:spMkLst>
        </pc:spChg>
        <pc:picChg chg="mod">
          <ac:chgData name="Hayk Barseghyan" userId="1af3c995-31f7-415e-9aa1-2b36900e994d" providerId="ADAL" clId="{67884524-D562-4D7F-839E-951A995161A3}" dt="2021-04-09T19:44:35.215" v="2652" actId="1038"/>
          <ac:picMkLst>
            <pc:docMk/>
            <pc:sldMk cId="2755479697" sldId="657"/>
            <ac:picMk id="6" creationId="{647E26B7-A751-4F7B-AE55-58021DFF200F}"/>
          </ac:picMkLst>
        </pc:picChg>
        <pc:picChg chg="add mod ord">
          <ac:chgData name="Hayk Barseghyan" userId="1af3c995-31f7-415e-9aa1-2b36900e994d" providerId="ADAL" clId="{67884524-D562-4D7F-839E-951A995161A3}" dt="2021-04-09T19:45:28.705" v="2665" actId="1036"/>
          <ac:picMkLst>
            <pc:docMk/>
            <pc:sldMk cId="2755479697" sldId="657"/>
            <ac:picMk id="10" creationId="{9949D67C-CD43-476D-A15F-434A6C52C9E1}"/>
          </ac:picMkLst>
        </pc:picChg>
        <pc:picChg chg="del">
          <ac:chgData name="Hayk Barseghyan" userId="1af3c995-31f7-415e-9aa1-2b36900e994d" providerId="ADAL" clId="{67884524-D562-4D7F-839E-951A995161A3}" dt="2021-04-09T19:19:49.708" v="2363" actId="478"/>
          <ac:picMkLst>
            <pc:docMk/>
            <pc:sldMk cId="2755479697" sldId="657"/>
            <ac:picMk id="18" creationId="{F227534F-7555-45D8-89C1-5409D1E697AC}"/>
          </ac:picMkLst>
        </pc:picChg>
        <pc:picChg chg="add del mod">
          <ac:chgData name="Hayk Barseghyan" userId="1af3c995-31f7-415e-9aa1-2b36900e994d" providerId="ADAL" clId="{67884524-D562-4D7F-839E-951A995161A3}" dt="2021-04-09T19:45:28.705" v="2665" actId="1036"/>
          <ac:picMkLst>
            <pc:docMk/>
            <pc:sldMk cId="2755479697" sldId="657"/>
            <ac:picMk id="29" creationId="{CF9A21CF-EDBB-4665-A266-4092EEDE63E8}"/>
          </ac:picMkLst>
        </pc:picChg>
        <pc:picChg chg="mod">
          <ac:chgData name="Hayk Barseghyan" userId="1af3c995-31f7-415e-9aa1-2b36900e994d" providerId="ADAL" clId="{67884524-D562-4D7F-839E-951A995161A3}" dt="2021-04-09T19:45:28.705" v="2665" actId="1036"/>
          <ac:picMkLst>
            <pc:docMk/>
            <pc:sldMk cId="2755479697" sldId="657"/>
            <ac:picMk id="32" creationId="{9C4F5BC9-4380-4AC1-A310-9AB023C36173}"/>
          </ac:picMkLst>
        </pc:picChg>
        <pc:picChg chg="add mod">
          <ac:chgData name="Hayk Barseghyan" userId="1af3c995-31f7-415e-9aa1-2b36900e994d" providerId="ADAL" clId="{67884524-D562-4D7F-839E-951A995161A3}" dt="2021-04-09T19:43:13.877" v="2587" actId="1035"/>
          <ac:picMkLst>
            <pc:docMk/>
            <pc:sldMk cId="2755479697" sldId="657"/>
            <ac:picMk id="35" creationId="{C411C50E-0EFE-405E-BA71-FD8EF002C28E}"/>
          </ac:picMkLst>
        </pc:picChg>
        <pc:picChg chg="add mod">
          <ac:chgData name="Hayk Barseghyan" userId="1af3c995-31f7-415e-9aa1-2b36900e994d" providerId="ADAL" clId="{67884524-D562-4D7F-839E-951A995161A3}" dt="2021-04-09T20:30:44.014" v="2693" actId="1076"/>
          <ac:picMkLst>
            <pc:docMk/>
            <pc:sldMk cId="2755479697" sldId="657"/>
            <ac:picMk id="86" creationId="{7998BD3D-AF7C-4AE7-8766-551D8298153B}"/>
          </ac:picMkLst>
        </pc:picChg>
        <pc:cxnChg chg="add mod">
          <ac:chgData name="Hayk Barseghyan" userId="1af3c995-31f7-415e-9aa1-2b36900e994d" providerId="ADAL" clId="{67884524-D562-4D7F-839E-951A995161A3}" dt="2021-04-09T19:44:10.937" v="2630" actId="14100"/>
          <ac:cxnSpMkLst>
            <pc:docMk/>
            <pc:sldMk cId="2755479697" sldId="657"/>
            <ac:cxnSpMk id="47" creationId="{73BF53E9-C085-40A1-AEDB-FCEABF721442}"/>
          </ac:cxnSpMkLst>
        </pc:cxnChg>
        <pc:cxnChg chg="add mod">
          <ac:chgData name="Hayk Barseghyan" userId="1af3c995-31f7-415e-9aa1-2b36900e994d" providerId="ADAL" clId="{67884524-D562-4D7F-839E-951A995161A3}" dt="2021-04-09T19:44:46.051" v="2654" actId="14100"/>
          <ac:cxnSpMkLst>
            <pc:docMk/>
            <pc:sldMk cId="2755479697" sldId="657"/>
            <ac:cxnSpMk id="48" creationId="{FE91A509-8B73-4677-B2DF-1BA28F8B3202}"/>
          </ac:cxnSpMkLst>
        </pc:cxnChg>
        <pc:cxnChg chg="add mod">
          <ac:chgData name="Hayk Barseghyan" userId="1af3c995-31f7-415e-9aa1-2b36900e994d" providerId="ADAL" clId="{67884524-D562-4D7F-839E-951A995161A3}" dt="2021-04-09T19:44:24.756" v="2650" actId="1035"/>
          <ac:cxnSpMkLst>
            <pc:docMk/>
            <pc:sldMk cId="2755479697" sldId="657"/>
            <ac:cxnSpMk id="50" creationId="{C9B05F2B-D39A-4EA5-830F-063B90555EF0}"/>
          </ac:cxnSpMkLst>
        </pc:cxnChg>
        <pc:cxnChg chg="mod">
          <ac:chgData name="Hayk Barseghyan" userId="1af3c995-31f7-415e-9aa1-2b36900e994d" providerId="ADAL" clId="{67884524-D562-4D7F-839E-951A995161A3}" dt="2021-04-09T19:45:28.705" v="2665" actId="1036"/>
          <ac:cxnSpMkLst>
            <pc:docMk/>
            <pc:sldMk cId="2755479697" sldId="657"/>
            <ac:cxnSpMk id="83" creationId="{58D0C8E9-615F-4BB4-8DBD-A90AD120C04D}"/>
          </ac:cxnSpMkLst>
        </pc:cxnChg>
        <pc:cxnChg chg="mod">
          <ac:chgData name="Hayk Barseghyan" userId="1af3c995-31f7-415e-9aa1-2b36900e994d" providerId="ADAL" clId="{67884524-D562-4D7F-839E-951A995161A3}" dt="2021-04-09T19:45:28.705" v="2665" actId="1036"/>
          <ac:cxnSpMkLst>
            <pc:docMk/>
            <pc:sldMk cId="2755479697" sldId="657"/>
            <ac:cxnSpMk id="85" creationId="{0EF1E4F0-CD42-453C-B817-5170CC59B83F}"/>
          </ac:cxnSpMkLst>
        </pc:cxnChg>
        <pc:cxnChg chg="mod">
          <ac:chgData name="Hayk Barseghyan" userId="1af3c995-31f7-415e-9aa1-2b36900e994d" providerId="ADAL" clId="{67884524-D562-4D7F-839E-951A995161A3}" dt="2021-04-09T19:45:28.705" v="2665" actId="1036"/>
          <ac:cxnSpMkLst>
            <pc:docMk/>
            <pc:sldMk cId="2755479697" sldId="657"/>
            <ac:cxnSpMk id="95" creationId="{16507A16-B1EA-41FC-BA29-6F79662AB745}"/>
          </ac:cxnSpMkLst>
        </pc:cxnChg>
        <pc:cxnChg chg="mod">
          <ac:chgData name="Hayk Barseghyan" userId="1af3c995-31f7-415e-9aa1-2b36900e994d" providerId="ADAL" clId="{67884524-D562-4D7F-839E-951A995161A3}" dt="2021-04-09T19:45:28.705" v="2665" actId="1036"/>
          <ac:cxnSpMkLst>
            <pc:docMk/>
            <pc:sldMk cId="2755479697" sldId="657"/>
            <ac:cxnSpMk id="96" creationId="{0E9D330C-7EF6-4A8F-8BD0-1DFEE913D44D}"/>
          </ac:cxnSpMkLst>
        </pc:cxnChg>
        <pc:cxnChg chg="mod">
          <ac:chgData name="Hayk Barseghyan" userId="1af3c995-31f7-415e-9aa1-2b36900e994d" providerId="ADAL" clId="{67884524-D562-4D7F-839E-951A995161A3}" dt="2021-04-09T19:45:39.408" v="2667" actId="14100"/>
          <ac:cxnSpMkLst>
            <pc:docMk/>
            <pc:sldMk cId="2755479697" sldId="657"/>
            <ac:cxnSpMk id="98" creationId="{17657C10-69D0-4CE3-8C03-DFB56D86A81D}"/>
          </ac:cxnSpMkLst>
        </pc:cxnChg>
        <pc:cxnChg chg="mod">
          <ac:chgData name="Hayk Barseghyan" userId="1af3c995-31f7-415e-9aa1-2b36900e994d" providerId="ADAL" clId="{67884524-D562-4D7F-839E-951A995161A3}" dt="2021-04-09T19:45:28.705" v="2665" actId="1036"/>
          <ac:cxnSpMkLst>
            <pc:docMk/>
            <pc:sldMk cId="2755479697" sldId="657"/>
            <ac:cxnSpMk id="101" creationId="{19BBA3F5-EFCD-49F7-BDCC-66B89FA196B9}"/>
          </ac:cxnSpMkLst>
        </pc:cxnChg>
        <pc:cxnChg chg="mod">
          <ac:chgData name="Hayk Barseghyan" userId="1af3c995-31f7-415e-9aa1-2b36900e994d" providerId="ADAL" clId="{67884524-D562-4D7F-839E-951A995161A3}" dt="2021-04-09T19:45:28.705" v="2665" actId="1036"/>
          <ac:cxnSpMkLst>
            <pc:docMk/>
            <pc:sldMk cId="2755479697" sldId="657"/>
            <ac:cxnSpMk id="104" creationId="{05153E8D-36D1-430B-B3A6-660A80B985D2}"/>
          </ac:cxnSpMkLst>
        </pc:cxnChg>
      </pc:sldChg>
      <pc:sldChg chg="del">
        <pc:chgData name="Hayk Barseghyan" userId="1af3c995-31f7-415e-9aa1-2b36900e994d" providerId="ADAL" clId="{67884524-D562-4D7F-839E-951A995161A3}" dt="2021-04-09T20:27:52.430" v="2687" actId="47"/>
        <pc:sldMkLst>
          <pc:docMk/>
          <pc:sldMk cId="2000704347" sldId="660"/>
        </pc:sldMkLst>
      </pc:sldChg>
      <pc:sldChg chg="del">
        <pc:chgData name="Hayk Barseghyan" userId="1af3c995-31f7-415e-9aa1-2b36900e994d" providerId="ADAL" clId="{67884524-D562-4D7F-839E-951A995161A3}" dt="2021-04-09T20:27:38.247" v="2685" actId="47"/>
        <pc:sldMkLst>
          <pc:docMk/>
          <pc:sldMk cId="3227928584" sldId="661"/>
        </pc:sldMkLst>
      </pc:sldChg>
      <pc:sldChg chg="addSp delSp modSp mod modNotesTx">
        <pc:chgData name="Hayk Barseghyan" userId="1af3c995-31f7-415e-9aa1-2b36900e994d" providerId="ADAL" clId="{67884524-D562-4D7F-839E-951A995161A3}" dt="2021-04-13T22:44:16.701" v="2825" actId="1038"/>
        <pc:sldMkLst>
          <pc:docMk/>
          <pc:sldMk cId="47234520" sldId="663"/>
        </pc:sldMkLst>
        <pc:spChg chg="add del mod">
          <ac:chgData name="Hayk Barseghyan" userId="1af3c995-31f7-415e-9aa1-2b36900e994d" providerId="ADAL" clId="{67884524-D562-4D7F-839E-951A995161A3}" dt="2021-04-09T17:16:11.955" v="1436" actId="478"/>
          <ac:spMkLst>
            <pc:docMk/>
            <pc:sldMk cId="47234520" sldId="663"/>
            <ac:spMk id="31" creationId="{08611494-1387-492C-B2A8-071CAD01ABA5}"/>
          </ac:spMkLst>
        </pc:spChg>
        <pc:spChg chg="add del mod">
          <ac:chgData name="Hayk Barseghyan" userId="1af3c995-31f7-415e-9aa1-2b36900e994d" providerId="ADAL" clId="{67884524-D562-4D7F-839E-951A995161A3}" dt="2021-04-09T16:43:39.244" v="900" actId="478"/>
          <ac:spMkLst>
            <pc:docMk/>
            <pc:sldMk cId="47234520" sldId="663"/>
            <ac:spMk id="32" creationId="{926721C2-BB52-41F7-B799-2996425A8C09}"/>
          </ac:spMkLst>
        </pc:spChg>
        <pc:spChg chg="mod">
          <ac:chgData name="Hayk Barseghyan" userId="1af3c995-31f7-415e-9aa1-2b36900e994d" providerId="ADAL" clId="{67884524-D562-4D7F-839E-951A995161A3}" dt="2021-04-09T18:11:57.731" v="2260" actId="1035"/>
          <ac:spMkLst>
            <pc:docMk/>
            <pc:sldMk cId="47234520" sldId="663"/>
            <ac:spMk id="33" creationId="{27D04DB1-6D7F-4335-AAA1-99D44F3F14E9}"/>
          </ac:spMkLst>
        </pc:spChg>
        <pc:spChg chg="add del mod">
          <ac:chgData name="Hayk Barseghyan" userId="1af3c995-31f7-415e-9aa1-2b36900e994d" providerId="ADAL" clId="{67884524-D562-4D7F-839E-951A995161A3}" dt="2021-04-09T16:43:39.244" v="900" actId="478"/>
          <ac:spMkLst>
            <pc:docMk/>
            <pc:sldMk cId="47234520" sldId="663"/>
            <ac:spMk id="34" creationId="{23C52F60-862C-4DAC-8692-C7BDD30147D7}"/>
          </ac:spMkLst>
        </pc:spChg>
        <pc:spChg chg="add del mod">
          <ac:chgData name="Hayk Barseghyan" userId="1af3c995-31f7-415e-9aa1-2b36900e994d" providerId="ADAL" clId="{67884524-D562-4D7F-839E-951A995161A3}" dt="2021-04-09T16:43:35.783" v="891" actId="478"/>
          <ac:spMkLst>
            <pc:docMk/>
            <pc:sldMk cId="47234520" sldId="663"/>
            <ac:spMk id="35" creationId="{8C4459FA-86DA-4379-8AB5-BC0B9B1FEB70}"/>
          </ac:spMkLst>
        </pc:spChg>
        <pc:spChg chg="del mod">
          <ac:chgData name="Hayk Barseghyan" userId="1af3c995-31f7-415e-9aa1-2b36900e994d" providerId="ADAL" clId="{67884524-D562-4D7F-839E-951A995161A3}" dt="2021-04-09T16:27:35.574" v="550" actId="478"/>
          <ac:spMkLst>
            <pc:docMk/>
            <pc:sldMk cId="47234520" sldId="663"/>
            <ac:spMk id="36" creationId="{D1390CDB-8C38-45E4-B737-627C1887B062}"/>
          </ac:spMkLst>
        </pc:spChg>
        <pc:spChg chg="add del mod">
          <ac:chgData name="Hayk Barseghyan" userId="1af3c995-31f7-415e-9aa1-2b36900e994d" providerId="ADAL" clId="{67884524-D562-4D7F-839E-951A995161A3}" dt="2021-04-09T16:28:34.041" v="746" actId="478"/>
          <ac:spMkLst>
            <pc:docMk/>
            <pc:sldMk cId="47234520" sldId="663"/>
            <ac:spMk id="37" creationId="{F3D4A9E7-689F-40B1-A884-C4E60CC348C2}"/>
          </ac:spMkLst>
        </pc:spChg>
        <pc:spChg chg="del">
          <ac:chgData name="Hayk Barseghyan" userId="1af3c995-31f7-415e-9aa1-2b36900e994d" providerId="ADAL" clId="{67884524-D562-4D7F-839E-951A995161A3}" dt="2021-04-09T16:10:30.558" v="194" actId="478"/>
          <ac:spMkLst>
            <pc:docMk/>
            <pc:sldMk cId="47234520" sldId="663"/>
            <ac:spMk id="38" creationId="{B638ABDB-D9E0-4BD6-B852-539AADEF668A}"/>
          </ac:spMkLst>
        </pc:spChg>
        <pc:spChg chg="del mod">
          <ac:chgData name="Hayk Barseghyan" userId="1af3c995-31f7-415e-9aa1-2b36900e994d" providerId="ADAL" clId="{67884524-D562-4D7F-839E-951A995161A3}" dt="2021-04-09T17:18:34.130" v="1525" actId="478"/>
          <ac:spMkLst>
            <pc:docMk/>
            <pc:sldMk cId="47234520" sldId="663"/>
            <ac:spMk id="39" creationId="{4AF27A96-917F-4EF1-9A35-A7FA933A8FDE}"/>
          </ac:spMkLst>
        </pc:spChg>
        <pc:spChg chg="add del mod">
          <ac:chgData name="Hayk Barseghyan" userId="1af3c995-31f7-415e-9aa1-2b36900e994d" providerId="ADAL" clId="{67884524-D562-4D7F-839E-951A995161A3}" dt="2021-04-09T17:18:08.437" v="1521" actId="478"/>
          <ac:spMkLst>
            <pc:docMk/>
            <pc:sldMk cId="47234520" sldId="663"/>
            <ac:spMk id="40" creationId="{08261CF3-C3D6-467E-A4A7-54C304632B30}"/>
          </ac:spMkLst>
        </pc:spChg>
        <pc:spChg chg="add del mod">
          <ac:chgData name="Hayk Barseghyan" userId="1af3c995-31f7-415e-9aa1-2b36900e994d" providerId="ADAL" clId="{67884524-D562-4D7F-839E-951A995161A3}" dt="2021-04-09T16:43:34.275" v="883" actId="478"/>
          <ac:spMkLst>
            <pc:docMk/>
            <pc:sldMk cId="47234520" sldId="663"/>
            <ac:spMk id="41" creationId="{65303B93-BC2D-4D06-800E-52D5605AAF7B}"/>
          </ac:spMkLst>
        </pc:spChg>
        <pc:spChg chg="mod">
          <ac:chgData name="Hayk Barseghyan" userId="1af3c995-31f7-415e-9aa1-2b36900e994d" providerId="ADAL" clId="{67884524-D562-4D7F-839E-951A995161A3}" dt="2021-04-09T17:54:28.610" v="1976" actId="1035"/>
          <ac:spMkLst>
            <pc:docMk/>
            <pc:sldMk cId="47234520" sldId="663"/>
            <ac:spMk id="42" creationId="{A6A7EB23-F2F1-4B41-AF1C-F4019CBB76B4}"/>
          </ac:spMkLst>
        </pc:spChg>
        <pc:spChg chg="mod">
          <ac:chgData name="Hayk Barseghyan" userId="1af3c995-31f7-415e-9aa1-2b36900e994d" providerId="ADAL" clId="{67884524-D562-4D7F-839E-951A995161A3}" dt="2021-04-09T17:54:28.610" v="1976" actId="1035"/>
          <ac:spMkLst>
            <pc:docMk/>
            <pc:sldMk cId="47234520" sldId="663"/>
            <ac:spMk id="43" creationId="{22614E9B-0192-4105-BED4-42AFDEB76135}"/>
          </ac:spMkLst>
        </pc:spChg>
        <pc:spChg chg="add del mod">
          <ac:chgData name="Hayk Barseghyan" userId="1af3c995-31f7-415e-9aa1-2b36900e994d" providerId="ADAL" clId="{67884524-D562-4D7F-839E-951A995161A3}" dt="2021-04-09T16:43:34.986" v="886" actId="478"/>
          <ac:spMkLst>
            <pc:docMk/>
            <pc:sldMk cId="47234520" sldId="663"/>
            <ac:spMk id="44" creationId="{D47DFABE-C2F1-47BF-9CA9-6BBA689251A4}"/>
          </ac:spMkLst>
        </pc:spChg>
        <pc:spChg chg="add del mod">
          <ac:chgData name="Hayk Barseghyan" userId="1af3c995-31f7-415e-9aa1-2b36900e994d" providerId="ADAL" clId="{67884524-D562-4D7F-839E-951A995161A3}" dt="2021-04-09T16:43:35.955" v="892" actId="478"/>
          <ac:spMkLst>
            <pc:docMk/>
            <pc:sldMk cId="47234520" sldId="663"/>
            <ac:spMk id="45" creationId="{A8281844-ECED-4F1A-A85A-DD708676FDD6}"/>
          </ac:spMkLst>
        </pc:spChg>
        <pc:spChg chg="mod">
          <ac:chgData name="Hayk Barseghyan" userId="1af3c995-31f7-415e-9aa1-2b36900e994d" providerId="ADAL" clId="{67884524-D562-4D7F-839E-951A995161A3}" dt="2021-04-09T17:54:28.610" v="1976" actId="1035"/>
          <ac:spMkLst>
            <pc:docMk/>
            <pc:sldMk cId="47234520" sldId="663"/>
            <ac:spMk id="46" creationId="{CFC0E298-E244-4D43-AC83-9C57B99A2027}"/>
          </ac:spMkLst>
        </pc:spChg>
        <pc:spChg chg="add del mod">
          <ac:chgData name="Hayk Barseghyan" userId="1af3c995-31f7-415e-9aa1-2b36900e994d" providerId="ADAL" clId="{67884524-D562-4D7F-839E-951A995161A3}" dt="2021-04-09T17:09:48.509" v="909" actId="478"/>
          <ac:spMkLst>
            <pc:docMk/>
            <pc:sldMk cId="47234520" sldId="663"/>
            <ac:spMk id="47" creationId="{2357C981-38E6-44A1-92C6-4438A5C118A1}"/>
          </ac:spMkLst>
        </pc:spChg>
        <pc:spChg chg="add del mod">
          <ac:chgData name="Hayk Barseghyan" userId="1af3c995-31f7-415e-9aa1-2b36900e994d" providerId="ADAL" clId="{67884524-D562-4D7F-839E-951A995161A3}" dt="2021-04-09T16:43:38.498" v="899" actId="478"/>
          <ac:spMkLst>
            <pc:docMk/>
            <pc:sldMk cId="47234520" sldId="663"/>
            <ac:spMk id="48" creationId="{E116090F-5C51-4B82-A90E-5221E9241736}"/>
          </ac:spMkLst>
        </pc:spChg>
        <pc:spChg chg="del">
          <ac:chgData name="Hayk Barseghyan" userId="1af3c995-31f7-415e-9aa1-2b36900e994d" providerId="ADAL" clId="{67884524-D562-4D7F-839E-951A995161A3}" dt="2021-04-09T17:09:23.506" v="904" actId="478"/>
          <ac:spMkLst>
            <pc:docMk/>
            <pc:sldMk cId="47234520" sldId="663"/>
            <ac:spMk id="50" creationId="{EFAE23AD-764D-4717-BFC6-A667BE9E9DA0}"/>
          </ac:spMkLst>
        </pc:spChg>
        <pc:spChg chg="mod">
          <ac:chgData name="Hayk Barseghyan" userId="1af3c995-31f7-415e-9aa1-2b36900e994d" providerId="ADAL" clId="{67884524-D562-4D7F-839E-951A995161A3}" dt="2021-04-09T17:54:28.610" v="1976" actId="1035"/>
          <ac:spMkLst>
            <pc:docMk/>
            <pc:sldMk cId="47234520" sldId="663"/>
            <ac:spMk id="51" creationId="{9798F9A3-1382-497E-B44B-594D4B24624B}"/>
          </ac:spMkLst>
        </pc:spChg>
        <pc:spChg chg="add mod">
          <ac:chgData name="Hayk Barseghyan" userId="1af3c995-31f7-415e-9aa1-2b36900e994d" providerId="ADAL" clId="{67884524-D562-4D7F-839E-951A995161A3}" dt="2021-04-09T17:54:54.368" v="1997" actId="14100"/>
          <ac:spMkLst>
            <pc:docMk/>
            <pc:sldMk cId="47234520" sldId="663"/>
            <ac:spMk id="52" creationId="{A3E4ADEA-8569-4795-BE33-9F69F442A45E}"/>
          </ac:spMkLst>
        </pc:spChg>
        <pc:spChg chg="mod">
          <ac:chgData name="Hayk Barseghyan" userId="1af3c995-31f7-415e-9aa1-2b36900e994d" providerId="ADAL" clId="{67884524-D562-4D7F-839E-951A995161A3}" dt="2021-04-09T17:54:28.610" v="1976" actId="1035"/>
          <ac:spMkLst>
            <pc:docMk/>
            <pc:sldMk cId="47234520" sldId="663"/>
            <ac:spMk id="53" creationId="{5327C358-684E-4D6A-80D1-00FE015EB529}"/>
          </ac:spMkLst>
        </pc:spChg>
        <pc:spChg chg="del">
          <ac:chgData name="Hayk Barseghyan" userId="1af3c995-31f7-415e-9aa1-2b36900e994d" providerId="ADAL" clId="{67884524-D562-4D7F-839E-951A995161A3}" dt="2021-04-09T17:09:23.506" v="904" actId="478"/>
          <ac:spMkLst>
            <pc:docMk/>
            <pc:sldMk cId="47234520" sldId="663"/>
            <ac:spMk id="54" creationId="{AEFE19ED-D06A-4675-A62E-6210959B4F43}"/>
          </ac:spMkLst>
        </pc:spChg>
        <pc:spChg chg="add del mod">
          <ac:chgData name="Hayk Barseghyan" userId="1af3c995-31f7-415e-9aa1-2b36900e994d" providerId="ADAL" clId="{67884524-D562-4D7F-839E-951A995161A3}" dt="2021-04-09T17:16:07.156" v="1435" actId="478"/>
          <ac:spMkLst>
            <pc:docMk/>
            <pc:sldMk cId="47234520" sldId="663"/>
            <ac:spMk id="55" creationId="{1842A577-3351-495B-96C0-B94487EBACD7}"/>
          </ac:spMkLst>
        </pc:spChg>
        <pc:spChg chg="mod">
          <ac:chgData name="Hayk Barseghyan" userId="1af3c995-31f7-415e-9aa1-2b36900e994d" providerId="ADAL" clId="{67884524-D562-4D7F-839E-951A995161A3}" dt="2021-04-09T17:54:28.610" v="1976" actId="1035"/>
          <ac:spMkLst>
            <pc:docMk/>
            <pc:sldMk cId="47234520" sldId="663"/>
            <ac:spMk id="56" creationId="{B7D042E6-A9A2-4A90-94A4-3A23DC3ECE2B}"/>
          </ac:spMkLst>
        </pc:spChg>
        <pc:spChg chg="mod">
          <ac:chgData name="Hayk Barseghyan" userId="1af3c995-31f7-415e-9aa1-2b36900e994d" providerId="ADAL" clId="{67884524-D562-4D7F-839E-951A995161A3}" dt="2021-04-09T17:54:28.610" v="1976" actId="1035"/>
          <ac:spMkLst>
            <pc:docMk/>
            <pc:sldMk cId="47234520" sldId="663"/>
            <ac:spMk id="57" creationId="{508547CC-91BF-4ACA-AF7D-3F69DF44DE59}"/>
          </ac:spMkLst>
        </pc:spChg>
        <pc:spChg chg="mod">
          <ac:chgData name="Hayk Barseghyan" userId="1af3c995-31f7-415e-9aa1-2b36900e994d" providerId="ADAL" clId="{67884524-D562-4D7F-839E-951A995161A3}" dt="2021-04-09T17:54:28.610" v="1976" actId="1035"/>
          <ac:spMkLst>
            <pc:docMk/>
            <pc:sldMk cId="47234520" sldId="663"/>
            <ac:spMk id="58" creationId="{D61BAF5E-4DA2-43A9-B710-E5677683F7C5}"/>
          </ac:spMkLst>
        </pc:spChg>
        <pc:spChg chg="add del mod">
          <ac:chgData name="Hayk Barseghyan" userId="1af3c995-31f7-415e-9aa1-2b36900e994d" providerId="ADAL" clId="{67884524-D562-4D7F-839E-951A995161A3}" dt="2021-04-09T17:18:31.556" v="1524"/>
          <ac:spMkLst>
            <pc:docMk/>
            <pc:sldMk cId="47234520" sldId="663"/>
            <ac:spMk id="59" creationId="{6B37AE1D-0EB5-47DB-A48B-3F95440F7ABD}"/>
          </ac:spMkLst>
        </pc:spChg>
        <pc:spChg chg="add del mod">
          <ac:chgData name="Hayk Barseghyan" userId="1af3c995-31f7-415e-9aa1-2b36900e994d" providerId="ADAL" clId="{67884524-D562-4D7F-839E-951A995161A3}" dt="2021-04-09T17:42:31.410" v="1876" actId="478"/>
          <ac:spMkLst>
            <pc:docMk/>
            <pc:sldMk cId="47234520" sldId="663"/>
            <ac:spMk id="60" creationId="{D73E704B-05C3-4913-9B12-F720FA143B41}"/>
          </ac:spMkLst>
        </pc:spChg>
        <pc:spChg chg="add mod">
          <ac:chgData name="Hayk Barseghyan" userId="1af3c995-31f7-415e-9aa1-2b36900e994d" providerId="ADAL" clId="{67884524-D562-4D7F-839E-951A995161A3}" dt="2021-04-09T18:11:57.731" v="2260" actId="1035"/>
          <ac:spMkLst>
            <pc:docMk/>
            <pc:sldMk cId="47234520" sldId="663"/>
            <ac:spMk id="61" creationId="{4AB0CFBE-6ABA-471B-B7F6-97AC3847E8C1}"/>
          </ac:spMkLst>
        </pc:spChg>
        <pc:spChg chg="add mod">
          <ac:chgData name="Hayk Barseghyan" userId="1af3c995-31f7-415e-9aa1-2b36900e994d" providerId="ADAL" clId="{67884524-D562-4D7F-839E-951A995161A3}" dt="2021-04-09T18:11:57.731" v="2260" actId="1035"/>
          <ac:spMkLst>
            <pc:docMk/>
            <pc:sldMk cId="47234520" sldId="663"/>
            <ac:spMk id="62" creationId="{23588E92-8DCF-4B53-A51D-C88D2224D1CF}"/>
          </ac:spMkLst>
        </pc:spChg>
        <pc:spChg chg="add mod">
          <ac:chgData name="Hayk Barseghyan" userId="1af3c995-31f7-415e-9aa1-2b36900e994d" providerId="ADAL" clId="{67884524-D562-4D7F-839E-951A995161A3}" dt="2021-04-09T17:53:11.477" v="1911" actId="1038"/>
          <ac:spMkLst>
            <pc:docMk/>
            <pc:sldMk cId="47234520" sldId="663"/>
            <ac:spMk id="63" creationId="{84F934A4-611F-44FB-8B13-D0CABF74578C}"/>
          </ac:spMkLst>
        </pc:spChg>
        <pc:spChg chg="add mod">
          <ac:chgData name="Hayk Barseghyan" userId="1af3c995-31f7-415e-9aa1-2b36900e994d" providerId="ADAL" clId="{67884524-D562-4D7F-839E-951A995161A3}" dt="2021-04-09T17:53:31.960" v="1925" actId="20577"/>
          <ac:spMkLst>
            <pc:docMk/>
            <pc:sldMk cId="47234520" sldId="663"/>
            <ac:spMk id="64" creationId="{D5B88C53-1267-43E9-A872-7A27541480C4}"/>
          </ac:spMkLst>
        </pc:spChg>
        <pc:spChg chg="add mod">
          <ac:chgData name="Hayk Barseghyan" userId="1af3c995-31f7-415e-9aa1-2b36900e994d" providerId="ADAL" clId="{67884524-D562-4D7F-839E-951A995161A3}" dt="2021-04-09T17:53:11.477" v="1911" actId="1038"/>
          <ac:spMkLst>
            <pc:docMk/>
            <pc:sldMk cId="47234520" sldId="663"/>
            <ac:spMk id="65" creationId="{A90A70B5-00F7-4E46-850E-09FB5CC72DFB}"/>
          </ac:spMkLst>
        </pc:spChg>
        <pc:spChg chg="add mod">
          <ac:chgData name="Hayk Barseghyan" userId="1af3c995-31f7-415e-9aa1-2b36900e994d" providerId="ADAL" clId="{67884524-D562-4D7F-839E-951A995161A3}" dt="2021-04-09T17:53:11.477" v="1911" actId="1038"/>
          <ac:spMkLst>
            <pc:docMk/>
            <pc:sldMk cId="47234520" sldId="663"/>
            <ac:spMk id="66" creationId="{A2FE0F7F-F9F3-4884-A6A9-F306AB7775ED}"/>
          </ac:spMkLst>
        </pc:spChg>
        <pc:spChg chg="add mod">
          <ac:chgData name="Hayk Barseghyan" userId="1af3c995-31f7-415e-9aa1-2b36900e994d" providerId="ADAL" clId="{67884524-D562-4D7F-839E-951A995161A3}" dt="2021-04-09T17:53:41.279" v="1932" actId="1036"/>
          <ac:spMkLst>
            <pc:docMk/>
            <pc:sldMk cId="47234520" sldId="663"/>
            <ac:spMk id="67" creationId="{0588F349-52E1-473B-A019-10F0D9E8FC63}"/>
          </ac:spMkLst>
        </pc:spChg>
        <pc:spChg chg="add mod">
          <ac:chgData name="Hayk Barseghyan" userId="1af3c995-31f7-415e-9aa1-2b36900e994d" providerId="ADAL" clId="{67884524-D562-4D7F-839E-951A995161A3}" dt="2021-04-09T17:53:11.477" v="1911" actId="1038"/>
          <ac:spMkLst>
            <pc:docMk/>
            <pc:sldMk cId="47234520" sldId="663"/>
            <ac:spMk id="68" creationId="{F6139559-FC2A-456A-8342-94F20EB84DD2}"/>
          </ac:spMkLst>
        </pc:spChg>
        <pc:spChg chg="add mod">
          <ac:chgData name="Hayk Barseghyan" userId="1af3c995-31f7-415e-9aa1-2b36900e994d" providerId="ADAL" clId="{67884524-D562-4D7F-839E-951A995161A3}" dt="2021-04-09T17:54:02.325" v="1939" actId="1038"/>
          <ac:spMkLst>
            <pc:docMk/>
            <pc:sldMk cId="47234520" sldId="663"/>
            <ac:spMk id="69" creationId="{A6CFF939-AB11-4DF5-BA33-A3B1F23EFC9C}"/>
          </ac:spMkLst>
        </pc:spChg>
        <pc:spChg chg="add mod">
          <ac:chgData name="Hayk Barseghyan" userId="1af3c995-31f7-415e-9aa1-2b36900e994d" providerId="ADAL" clId="{67884524-D562-4D7F-839E-951A995161A3}" dt="2021-04-09T17:55:04.818" v="1999" actId="1076"/>
          <ac:spMkLst>
            <pc:docMk/>
            <pc:sldMk cId="47234520" sldId="663"/>
            <ac:spMk id="70" creationId="{8031B137-C3F0-4779-9A51-6370A0030434}"/>
          </ac:spMkLst>
        </pc:spChg>
        <pc:spChg chg="add mod">
          <ac:chgData name="Hayk Barseghyan" userId="1af3c995-31f7-415e-9aa1-2b36900e994d" providerId="ADAL" clId="{67884524-D562-4D7F-839E-951A995161A3}" dt="2021-04-09T18:02:53.865" v="2041" actId="20577"/>
          <ac:spMkLst>
            <pc:docMk/>
            <pc:sldMk cId="47234520" sldId="663"/>
            <ac:spMk id="71" creationId="{73C2C6F9-B109-4E92-92DC-92B593CE93A7}"/>
          </ac:spMkLst>
        </pc:spChg>
        <pc:spChg chg="add mod">
          <ac:chgData name="Hayk Barseghyan" userId="1af3c995-31f7-415e-9aa1-2b36900e994d" providerId="ADAL" clId="{67884524-D562-4D7F-839E-951A995161A3}" dt="2021-04-09T18:03:00.588" v="2042" actId="1076"/>
          <ac:spMkLst>
            <pc:docMk/>
            <pc:sldMk cId="47234520" sldId="663"/>
            <ac:spMk id="72" creationId="{AF7DFB1A-BADD-46CE-A117-AF4B7269888D}"/>
          </ac:spMkLst>
        </pc:spChg>
        <pc:spChg chg="add mod">
          <ac:chgData name="Hayk Barseghyan" userId="1af3c995-31f7-415e-9aa1-2b36900e994d" providerId="ADAL" clId="{67884524-D562-4D7F-839E-951A995161A3}" dt="2021-04-13T22:44:03.610" v="2818" actId="1036"/>
          <ac:spMkLst>
            <pc:docMk/>
            <pc:sldMk cId="47234520" sldId="663"/>
            <ac:spMk id="73" creationId="{DD4811A7-E0A9-41B3-B8DC-E47701716FAF}"/>
          </ac:spMkLst>
        </pc:spChg>
        <pc:spChg chg="del">
          <ac:chgData name="Hayk Barseghyan" userId="1af3c995-31f7-415e-9aa1-2b36900e994d" providerId="ADAL" clId="{67884524-D562-4D7F-839E-951A995161A3}" dt="2021-04-09T16:10:49.691" v="196" actId="478"/>
          <ac:spMkLst>
            <pc:docMk/>
            <pc:sldMk cId="47234520" sldId="663"/>
            <ac:spMk id="74" creationId="{300107C0-2A44-48D8-8889-DC81D8213279}"/>
          </ac:spMkLst>
        </pc:spChg>
        <pc:spChg chg="add mod">
          <ac:chgData name="Hayk Barseghyan" userId="1af3c995-31f7-415e-9aa1-2b36900e994d" providerId="ADAL" clId="{67884524-D562-4D7F-839E-951A995161A3}" dt="2021-04-09T18:05:13.094" v="2236" actId="1036"/>
          <ac:spMkLst>
            <pc:docMk/>
            <pc:sldMk cId="47234520" sldId="663"/>
            <ac:spMk id="75" creationId="{55B29BB4-4DA3-430F-8130-CB66A2BD6D32}"/>
          </ac:spMkLst>
        </pc:spChg>
        <pc:spChg chg="add mod">
          <ac:chgData name="Hayk Barseghyan" userId="1af3c995-31f7-415e-9aa1-2b36900e994d" providerId="ADAL" clId="{67884524-D562-4D7F-839E-951A995161A3}" dt="2021-04-13T22:44:16.701" v="2825" actId="1038"/>
          <ac:spMkLst>
            <pc:docMk/>
            <pc:sldMk cId="47234520" sldId="663"/>
            <ac:spMk id="76" creationId="{A9DF7FB2-24F6-4FB2-AD52-8402A21DCAEF}"/>
          </ac:spMkLst>
        </pc:spChg>
        <pc:spChg chg="add del">
          <ac:chgData name="Hayk Barseghyan" userId="1af3c995-31f7-415e-9aa1-2b36900e994d" providerId="ADAL" clId="{67884524-D562-4D7F-839E-951A995161A3}" dt="2021-04-09T16:43:39.244" v="900" actId="478"/>
          <ac:spMkLst>
            <pc:docMk/>
            <pc:sldMk cId="47234520" sldId="663"/>
            <ac:spMk id="88" creationId="{7309DE7D-82B3-4F46-B078-58EBF40D4703}"/>
          </ac:spMkLst>
        </pc:spChg>
        <pc:spChg chg="del">
          <ac:chgData name="Hayk Barseghyan" userId="1af3c995-31f7-415e-9aa1-2b36900e994d" providerId="ADAL" clId="{67884524-D562-4D7F-839E-951A995161A3}" dt="2021-04-09T16:11:09.808" v="199" actId="478"/>
          <ac:spMkLst>
            <pc:docMk/>
            <pc:sldMk cId="47234520" sldId="663"/>
            <ac:spMk id="89" creationId="{480DB1C9-4E87-4915-8B99-BCAC4399DCEB}"/>
          </ac:spMkLst>
        </pc:spChg>
        <pc:spChg chg="del">
          <ac:chgData name="Hayk Barseghyan" userId="1af3c995-31f7-415e-9aa1-2b36900e994d" providerId="ADAL" clId="{67884524-D562-4D7F-839E-951A995161A3}" dt="2021-04-09T16:10:30.558" v="194" actId="478"/>
          <ac:spMkLst>
            <pc:docMk/>
            <pc:sldMk cId="47234520" sldId="663"/>
            <ac:spMk id="91" creationId="{13B1F2AA-C6E8-4BA8-9C3E-AADD95A31E93}"/>
          </ac:spMkLst>
        </pc:spChg>
        <pc:spChg chg="del">
          <ac:chgData name="Hayk Barseghyan" userId="1af3c995-31f7-415e-9aa1-2b36900e994d" providerId="ADAL" clId="{67884524-D562-4D7F-839E-951A995161A3}" dt="2021-04-09T16:10:30.558" v="194" actId="478"/>
          <ac:spMkLst>
            <pc:docMk/>
            <pc:sldMk cId="47234520" sldId="663"/>
            <ac:spMk id="92" creationId="{C38076EE-D1EB-4356-9361-84DA46C2351B}"/>
          </ac:spMkLst>
        </pc:spChg>
        <pc:spChg chg="del">
          <ac:chgData name="Hayk Barseghyan" userId="1af3c995-31f7-415e-9aa1-2b36900e994d" providerId="ADAL" clId="{67884524-D562-4D7F-839E-951A995161A3}" dt="2021-04-09T17:09:24.501" v="905" actId="478"/>
          <ac:spMkLst>
            <pc:docMk/>
            <pc:sldMk cId="47234520" sldId="663"/>
            <ac:spMk id="93" creationId="{3EAC0E29-A0FD-42DD-8F3E-7B6BDF36A320}"/>
          </ac:spMkLst>
        </pc:spChg>
        <pc:spChg chg="del mod">
          <ac:chgData name="Hayk Barseghyan" userId="1af3c995-31f7-415e-9aa1-2b36900e994d" providerId="ADAL" clId="{67884524-D562-4D7F-839E-951A995161A3}" dt="2021-04-09T17:41:22.514" v="1852" actId="478"/>
          <ac:spMkLst>
            <pc:docMk/>
            <pc:sldMk cId="47234520" sldId="663"/>
            <ac:spMk id="98" creationId="{CC1A3F83-E94B-4F3C-9D62-2C0B7D404690}"/>
          </ac:spMkLst>
        </pc:spChg>
        <pc:picChg chg="mod">
          <ac:chgData name="Hayk Barseghyan" userId="1af3c995-31f7-415e-9aa1-2b36900e994d" providerId="ADAL" clId="{67884524-D562-4D7F-839E-951A995161A3}" dt="2021-04-09T17:54:28.610" v="1976" actId="1035"/>
          <ac:picMkLst>
            <pc:docMk/>
            <pc:sldMk cId="47234520" sldId="663"/>
            <ac:picMk id="3" creationId="{83ED3CC2-4027-49CD-B58C-F97A5ED1330E}"/>
          </ac:picMkLst>
        </pc:picChg>
        <pc:picChg chg="add mod">
          <ac:chgData name="Hayk Barseghyan" userId="1af3c995-31f7-415e-9aa1-2b36900e994d" providerId="ADAL" clId="{67884524-D562-4D7F-839E-951A995161A3}" dt="2021-04-09T17:54:09.506" v="1940" actId="14100"/>
          <ac:picMkLst>
            <pc:docMk/>
            <pc:sldMk cId="47234520" sldId="663"/>
            <ac:picMk id="4" creationId="{A8FF9AE5-A77C-4422-9C70-671AF89E8142}"/>
          </ac:picMkLst>
        </pc:picChg>
        <pc:picChg chg="add del">
          <ac:chgData name="Hayk Barseghyan" userId="1af3c995-31f7-415e-9aa1-2b36900e994d" providerId="ADAL" clId="{67884524-D562-4D7F-839E-951A995161A3}" dt="2021-04-09T17:58:11.158" v="2002" actId="478"/>
          <ac:picMkLst>
            <pc:docMk/>
            <pc:sldMk cId="47234520" sldId="663"/>
            <ac:picMk id="6" creationId="{C129BC8B-003B-4507-BA6E-9DC9053834DD}"/>
          </ac:picMkLst>
        </pc:picChg>
        <pc:picChg chg="add mod">
          <ac:chgData name="Hayk Barseghyan" userId="1af3c995-31f7-415e-9aa1-2b36900e994d" providerId="ADAL" clId="{67884524-D562-4D7F-839E-951A995161A3}" dt="2021-04-09T18:02:29.054" v="2009" actId="1076"/>
          <ac:picMkLst>
            <pc:docMk/>
            <pc:sldMk cId="47234520" sldId="663"/>
            <ac:picMk id="8" creationId="{4D1E0338-6129-41F0-94D9-1DCA45EAD7A9}"/>
          </ac:picMkLst>
        </pc:picChg>
        <pc:picChg chg="del">
          <ac:chgData name="Hayk Barseghyan" userId="1af3c995-31f7-415e-9aa1-2b36900e994d" providerId="ADAL" clId="{67884524-D562-4D7F-839E-951A995161A3}" dt="2021-04-09T17:09:10.896" v="902" actId="478"/>
          <ac:picMkLst>
            <pc:docMk/>
            <pc:sldMk cId="47234520" sldId="663"/>
            <ac:picMk id="10" creationId="{E238B8FE-BA66-4E00-BE15-D0DF19DE94CD}"/>
          </ac:picMkLst>
        </pc:picChg>
        <pc:picChg chg="add mod">
          <ac:chgData name="Hayk Barseghyan" userId="1af3c995-31f7-415e-9aa1-2b36900e994d" providerId="ADAL" clId="{67884524-D562-4D7F-839E-951A995161A3}" dt="2021-04-09T18:04:33.344" v="2054" actId="1036"/>
          <ac:picMkLst>
            <pc:docMk/>
            <pc:sldMk cId="47234520" sldId="663"/>
            <ac:picMk id="11" creationId="{815F0E20-3CD9-4CAA-8F13-637B6F337576}"/>
          </ac:picMkLst>
        </pc:picChg>
        <pc:picChg chg="del">
          <ac:chgData name="Hayk Barseghyan" userId="1af3c995-31f7-415e-9aa1-2b36900e994d" providerId="ADAL" clId="{67884524-D562-4D7F-839E-951A995161A3}" dt="2021-04-09T17:09:22.032" v="903" actId="478"/>
          <ac:picMkLst>
            <pc:docMk/>
            <pc:sldMk cId="47234520" sldId="663"/>
            <ac:picMk id="13" creationId="{A8E41785-72B2-4763-8ED7-1E2D89338DBD}"/>
          </ac:picMkLst>
        </pc:picChg>
        <pc:picChg chg="del">
          <ac:chgData name="Hayk Barseghyan" userId="1af3c995-31f7-415e-9aa1-2b36900e994d" providerId="ADAL" clId="{67884524-D562-4D7F-839E-951A995161A3}" dt="2021-04-09T16:10:19.975" v="193" actId="478"/>
          <ac:picMkLst>
            <pc:docMk/>
            <pc:sldMk cId="47234520" sldId="663"/>
            <ac:picMk id="27" creationId="{4FE6C486-F782-468B-985B-6C0EFD2310B0}"/>
          </ac:picMkLst>
        </pc:picChg>
        <pc:cxnChg chg="del mod">
          <ac:chgData name="Hayk Barseghyan" userId="1af3c995-31f7-415e-9aa1-2b36900e994d" providerId="ADAL" clId="{67884524-D562-4D7F-839E-951A995161A3}" dt="2021-04-09T16:10:48.093" v="195" actId="478"/>
          <ac:cxnSpMkLst>
            <pc:docMk/>
            <pc:sldMk cId="47234520" sldId="663"/>
            <ac:cxnSpMk id="49" creationId="{4423681D-AADF-4D62-AC9E-3FDDF18E21B9}"/>
          </ac:cxnSpMkLst>
        </pc:cxnChg>
        <pc:cxnChg chg="del mod">
          <ac:chgData name="Hayk Barseghyan" userId="1af3c995-31f7-415e-9aa1-2b36900e994d" providerId="ADAL" clId="{67884524-D562-4D7F-839E-951A995161A3}" dt="2021-04-09T16:10:50.743" v="197" actId="478"/>
          <ac:cxnSpMkLst>
            <pc:docMk/>
            <pc:sldMk cId="47234520" sldId="663"/>
            <ac:cxnSpMk id="81" creationId="{4BCC25EA-B583-41A5-993F-C933337AE38C}"/>
          </ac:cxnSpMkLst>
        </pc:cxnChg>
        <pc:cxnChg chg="del mod">
          <ac:chgData name="Hayk Barseghyan" userId="1af3c995-31f7-415e-9aa1-2b36900e994d" providerId="ADAL" clId="{67884524-D562-4D7F-839E-951A995161A3}" dt="2021-04-09T16:10:51.579" v="198" actId="478"/>
          <ac:cxnSpMkLst>
            <pc:docMk/>
            <pc:sldMk cId="47234520" sldId="663"/>
            <ac:cxnSpMk id="84" creationId="{B2FDD7DF-34CC-49AF-BA68-F741766F788A}"/>
          </ac:cxnSpMkLst>
        </pc:cxnChg>
        <pc:cxnChg chg="del">
          <ac:chgData name="Hayk Barseghyan" userId="1af3c995-31f7-415e-9aa1-2b36900e994d" providerId="ADAL" clId="{67884524-D562-4D7F-839E-951A995161A3}" dt="2021-04-09T17:09:23.506" v="904" actId="478"/>
          <ac:cxnSpMkLst>
            <pc:docMk/>
            <pc:sldMk cId="47234520" sldId="663"/>
            <ac:cxnSpMk id="95" creationId="{5EB10151-CF0F-4162-A03A-2FB4661DCBE8}"/>
          </ac:cxnSpMkLst>
        </pc:cxnChg>
      </pc:sldChg>
      <pc:sldChg chg="delSp modSp del mod">
        <pc:chgData name="Hayk Barseghyan" userId="1af3c995-31f7-415e-9aa1-2b36900e994d" providerId="ADAL" clId="{67884524-D562-4D7F-839E-951A995161A3}" dt="2021-04-09T19:46:55.539" v="2680" actId="47"/>
        <pc:sldMkLst>
          <pc:docMk/>
          <pc:sldMk cId="4129799046" sldId="665"/>
        </pc:sldMkLst>
        <pc:spChg chg="del">
          <ac:chgData name="Hayk Barseghyan" userId="1af3c995-31f7-415e-9aa1-2b36900e994d" providerId="ADAL" clId="{67884524-D562-4D7F-839E-951A995161A3}" dt="2021-04-09T19:02:15.535" v="2349" actId="21"/>
          <ac:spMkLst>
            <pc:docMk/>
            <pc:sldMk cId="4129799046" sldId="665"/>
            <ac:spMk id="36" creationId="{D1390CDB-8C38-45E4-B737-627C1887B062}"/>
          </ac:spMkLst>
        </pc:spChg>
        <pc:spChg chg="del">
          <ac:chgData name="Hayk Barseghyan" userId="1af3c995-31f7-415e-9aa1-2b36900e994d" providerId="ADAL" clId="{67884524-D562-4D7F-839E-951A995161A3}" dt="2021-04-09T19:02:15.535" v="2349" actId="21"/>
          <ac:spMkLst>
            <pc:docMk/>
            <pc:sldMk cId="4129799046" sldId="665"/>
            <ac:spMk id="39" creationId="{4AF27A96-917F-4EF1-9A35-A7FA933A8FDE}"/>
          </ac:spMkLst>
        </pc:spChg>
        <pc:spChg chg="del">
          <ac:chgData name="Hayk Barseghyan" userId="1af3c995-31f7-415e-9aa1-2b36900e994d" providerId="ADAL" clId="{67884524-D562-4D7F-839E-951A995161A3}" dt="2021-04-09T19:02:15.535" v="2349" actId="21"/>
          <ac:spMkLst>
            <pc:docMk/>
            <pc:sldMk cId="4129799046" sldId="665"/>
            <ac:spMk id="42" creationId="{A6A7EB23-F2F1-4B41-AF1C-F4019CBB76B4}"/>
          </ac:spMkLst>
        </pc:spChg>
        <pc:spChg chg="del">
          <ac:chgData name="Hayk Barseghyan" userId="1af3c995-31f7-415e-9aa1-2b36900e994d" providerId="ADAL" clId="{67884524-D562-4D7F-839E-951A995161A3}" dt="2021-04-09T19:02:15.535" v="2349" actId="21"/>
          <ac:spMkLst>
            <pc:docMk/>
            <pc:sldMk cId="4129799046" sldId="665"/>
            <ac:spMk id="51" creationId="{9798F9A3-1382-497E-B44B-594D4B24624B}"/>
          </ac:spMkLst>
        </pc:spChg>
        <pc:spChg chg="del">
          <ac:chgData name="Hayk Barseghyan" userId="1af3c995-31f7-415e-9aa1-2b36900e994d" providerId="ADAL" clId="{67884524-D562-4D7F-839E-951A995161A3}" dt="2021-04-09T19:02:15.535" v="2349" actId="21"/>
          <ac:spMkLst>
            <pc:docMk/>
            <pc:sldMk cId="4129799046" sldId="665"/>
            <ac:spMk id="58" creationId="{D61BAF5E-4DA2-43A9-B710-E5677683F7C5}"/>
          </ac:spMkLst>
        </pc:spChg>
        <pc:picChg chg="del">
          <ac:chgData name="Hayk Barseghyan" userId="1af3c995-31f7-415e-9aa1-2b36900e994d" providerId="ADAL" clId="{67884524-D562-4D7F-839E-951A995161A3}" dt="2021-04-09T19:02:15.535" v="2349" actId="21"/>
          <ac:picMkLst>
            <pc:docMk/>
            <pc:sldMk cId="4129799046" sldId="665"/>
            <ac:picMk id="30" creationId="{1D784E8D-27C4-4F68-A620-A9BC920296D8}"/>
          </ac:picMkLst>
        </pc:picChg>
        <pc:cxnChg chg="mod">
          <ac:chgData name="Hayk Barseghyan" userId="1af3c995-31f7-415e-9aa1-2b36900e994d" providerId="ADAL" clId="{67884524-D562-4D7F-839E-951A995161A3}" dt="2021-04-09T19:02:15.535" v="2349" actId="21"/>
          <ac:cxnSpMkLst>
            <pc:docMk/>
            <pc:sldMk cId="4129799046" sldId="665"/>
            <ac:cxnSpMk id="84" creationId="{B2FDD7DF-34CC-49AF-BA68-F741766F788A}"/>
          </ac:cxnSpMkLst>
        </pc:cxnChg>
      </pc:sldChg>
      <pc:sldChg chg="delSp modSp del mod">
        <pc:chgData name="Hayk Barseghyan" userId="1af3c995-31f7-415e-9aa1-2b36900e994d" providerId="ADAL" clId="{67884524-D562-4D7F-839E-951A995161A3}" dt="2021-04-09T20:27:47.490" v="2686" actId="47"/>
        <pc:sldMkLst>
          <pc:docMk/>
          <pc:sldMk cId="2230132588" sldId="666"/>
        </pc:sldMkLst>
        <pc:spChg chg="del">
          <ac:chgData name="Hayk Barseghyan" userId="1af3c995-31f7-415e-9aa1-2b36900e994d" providerId="ADAL" clId="{67884524-D562-4D7F-839E-951A995161A3}" dt="2021-04-09T19:03:05.064" v="2354" actId="21"/>
          <ac:spMkLst>
            <pc:docMk/>
            <pc:sldMk cId="2230132588" sldId="666"/>
            <ac:spMk id="36" creationId="{D1390CDB-8C38-45E4-B737-627C1887B062}"/>
          </ac:spMkLst>
        </pc:spChg>
        <pc:spChg chg="del">
          <ac:chgData name="Hayk Barseghyan" userId="1af3c995-31f7-415e-9aa1-2b36900e994d" providerId="ADAL" clId="{67884524-D562-4D7F-839E-951A995161A3}" dt="2021-04-09T19:03:05.064" v="2354" actId="21"/>
          <ac:spMkLst>
            <pc:docMk/>
            <pc:sldMk cId="2230132588" sldId="666"/>
            <ac:spMk id="39" creationId="{4AF27A96-917F-4EF1-9A35-A7FA933A8FDE}"/>
          </ac:spMkLst>
        </pc:spChg>
        <pc:spChg chg="del">
          <ac:chgData name="Hayk Barseghyan" userId="1af3c995-31f7-415e-9aa1-2b36900e994d" providerId="ADAL" clId="{67884524-D562-4D7F-839E-951A995161A3}" dt="2021-04-09T19:03:05.064" v="2354" actId="21"/>
          <ac:spMkLst>
            <pc:docMk/>
            <pc:sldMk cId="2230132588" sldId="666"/>
            <ac:spMk id="42" creationId="{A6A7EB23-F2F1-4B41-AF1C-F4019CBB76B4}"/>
          </ac:spMkLst>
        </pc:spChg>
        <pc:spChg chg="del">
          <ac:chgData name="Hayk Barseghyan" userId="1af3c995-31f7-415e-9aa1-2b36900e994d" providerId="ADAL" clId="{67884524-D562-4D7F-839E-951A995161A3}" dt="2021-04-09T19:03:05.064" v="2354" actId="21"/>
          <ac:spMkLst>
            <pc:docMk/>
            <pc:sldMk cId="2230132588" sldId="666"/>
            <ac:spMk id="51" creationId="{9798F9A3-1382-497E-B44B-594D4B24624B}"/>
          </ac:spMkLst>
        </pc:spChg>
        <pc:spChg chg="del">
          <ac:chgData name="Hayk Barseghyan" userId="1af3c995-31f7-415e-9aa1-2b36900e994d" providerId="ADAL" clId="{67884524-D562-4D7F-839E-951A995161A3}" dt="2021-04-09T19:03:05.064" v="2354" actId="21"/>
          <ac:spMkLst>
            <pc:docMk/>
            <pc:sldMk cId="2230132588" sldId="666"/>
            <ac:spMk id="53" creationId="{5327C358-684E-4D6A-80D1-00FE015EB529}"/>
          </ac:spMkLst>
        </pc:spChg>
        <pc:spChg chg="del">
          <ac:chgData name="Hayk Barseghyan" userId="1af3c995-31f7-415e-9aa1-2b36900e994d" providerId="ADAL" clId="{67884524-D562-4D7F-839E-951A995161A3}" dt="2021-04-09T19:03:05.064" v="2354" actId="21"/>
          <ac:spMkLst>
            <pc:docMk/>
            <pc:sldMk cId="2230132588" sldId="666"/>
            <ac:spMk id="56" creationId="{B7D042E6-A9A2-4A90-94A4-3A23DC3ECE2B}"/>
          </ac:spMkLst>
        </pc:spChg>
        <pc:spChg chg="del">
          <ac:chgData name="Hayk Barseghyan" userId="1af3c995-31f7-415e-9aa1-2b36900e994d" providerId="ADAL" clId="{67884524-D562-4D7F-839E-951A995161A3}" dt="2021-04-09T19:03:05.064" v="2354" actId="21"/>
          <ac:spMkLst>
            <pc:docMk/>
            <pc:sldMk cId="2230132588" sldId="666"/>
            <ac:spMk id="57" creationId="{508547CC-91BF-4ACA-AF7D-3F69DF44DE59}"/>
          </ac:spMkLst>
        </pc:spChg>
        <pc:spChg chg="del">
          <ac:chgData name="Hayk Barseghyan" userId="1af3c995-31f7-415e-9aa1-2b36900e994d" providerId="ADAL" clId="{67884524-D562-4D7F-839E-951A995161A3}" dt="2021-04-09T19:03:05.064" v="2354" actId="21"/>
          <ac:spMkLst>
            <pc:docMk/>
            <pc:sldMk cId="2230132588" sldId="666"/>
            <ac:spMk id="58" creationId="{D61BAF5E-4DA2-43A9-B710-E5677683F7C5}"/>
          </ac:spMkLst>
        </pc:spChg>
        <pc:picChg chg="del">
          <ac:chgData name="Hayk Barseghyan" userId="1af3c995-31f7-415e-9aa1-2b36900e994d" providerId="ADAL" clId="{67884524-D562-4D7F-839E-951A995161A3}" dt="2021-04-09T19:03:05.064" v="2354" actId="21"/>
          <ac:picMkLst>
            <pc:docMk/>
            <pc:sldMk cId="2230132588" sldId="666"/>
            <ac:picMk id="31" creationId="{A268F165-891D-4E0E-95D3-4928F0ED258F}"/>
          </ac:picMkLst>
        </pc:picChg>
        <pc:cxnChg chg="mod">
          <ac:chgData name="Hayk Barseghyan" userId="1af3c995-31f7-415e-9aa1-2b36900e994d" providerId="ADAL" clId="{67884524-D562-4D7F-839E-951A995161A3}" dt="2021-04-09T19:03:05.064" v="2354" actId="21"/>
          <ac:cxnSpMkLst>
            <pc:docMk/>
            <pc:sldMk cId="2230132588" sldId="666"/>
            <ac:cxnSpMk id="37" creationId="{937AADC3-57B6-4F7D-B029-7175FA4FA202}"/>
          </ac:cxnSpMkLst>
        </pc:cxnChg>
      </pc:sldChg>
      <pc:sldChg chg="modSp mod">
        <pc:chgData name="Hayk Barseghyan" userId="1af3c995-31f7-415e-9aa1-2b36900e994d" providerId="ADAL" clId="{67884524-D562-4D7F-839E-951A995161A3}" dt="2021-04-09T18:12:17.053" v="2290" actId="1036"/>
        <pc:sldMkLst>
          <pc:docMk/>
          <pc:sldMk cId="2324644523" sldId="667"/>
        </pc:sldMkLst>
        <pc:spChg chg="mod">
          <ac:chgData name="Hayk Barseghyan" userId="1af3c995-31f7-415e-9aa1-2b36900e994d" providerId="ADAL" clId="{67884524-D562-4D7F-839E-951A995161A3}" dt="2021-04-09T17:16:42.297" v="1449" actId="1036"/>
          <ac:spMkLst>
            <pc:docMk/>
            <pc:sldMk cId="2324644523" sldId="667"/>
            <ac:spMk id="28" creationId="{627423C8-B194-4935-85FA-5ED8C3D13EA3}"/>
          </ac:spMkLst>
        </pc:spChg>
        <pc:spChg chg="mod">
          <ac:chgData name="Hayk Barseghyan" userId="1af3c995-31f7-415e-9aa1-2b36900e994d" providerId="ADAL" clId="{67884524-D562-4D7F-839E-951A995161A3}" dt="2021-04-09T18:12:17.053" v="2290" actId="1036"/>
          <ac:spMkLst>
            <pc:docMk/>
            <pc:sldMk cId="2324644523" sldId="667"/>
            <ac:spMk id="33" creationId="{27D04DB1-6D7F-4335-AAA1-99D44F3F14E9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41" creationId="{26367393-9A3A-4910-9224-AAD444228D62}"/>
          </ac:spMkLst>
        </pc:spChg>
        <pc:spChg chg="mod">
          <ac:chgData name="Hayk Barseghyan" userId="1af3c995-31f7-415e-9aa1-2b36900e994d" providerId="ADAL" clId="{67884524-D562-4D7F-839E-951A995161A3}" dt="2021-04-09T17:16:47.870" v="1460" actId="1036"/>
          <ac:spMkLst>
            <pc:docMk/>
            <pc:sldMk cId="2324644523" sldId="667"/>
            <ac:spMk id="43" creationId="{E5E72085-E385-4A63-A046-158DF2223D97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44" creationId="{732812E5-D6B9-4FEF-975D-E2E3D93D0E47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45" creationId="{706B5154-0B8D-4A97-9481-9F43337FAC30}"/>
          </ac:spMkLst>
        </pc:spChg>
        <pc:spChg chg="mod">
          <ac:chgData name="Hayk Barseghyan" userId="1af3c995-31f7-415e-9aa1-2b36900e994d" providerId="ADAL" clId="{67884524-D562-4D7F-839E-951A995161A3}" dt="2021-04-09T18:12:17.053" v="2290" actId="1036"/>
          <ac:spMkLst>
            <pc:docMk/>
            <pc:sldMk cId="2324644523" sldId="667"/>
            <ac:spMk id="46" creationId="{72FDDD23-4386-406F-909B-D87F05B38C36}"/>
          </ac:spMkLst>
        </pc:spChg>
        <pc:spChg chg="mod">
          <ac:chgData name="Hayk Barseghyan" userId="1af3c995-31f7-415e-9aa1-2b36900e994d" providerId="ADAL" clId="{67884524-D562-4D7F-839E-951A995161A3}" dt="2021-04-09T18:12:17.053" v="2290" actId="1036"/>
          <ac:spMkLst>
            <pc:docMk/>
            <pc:sldMk cId="2324644523" sldId="667"/>
            <ac:spMk id="47" creationId="{8CDE9EFE-773D-4D8D-B55E-0E5879D472AC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50" creationId="{95CC6DAF-1719-438F-B149-27EE31AAC27B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51" creationId="{A184D65A-9C51-47FB-804F-072D60CD6C03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53" creationId="{4D4255AA-33C7-4FB4-B572-CC587A055A38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54" creationId="{B8AA38EC-2D55-45ED-80D2-05BC2BD008BE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55" creationId="{CEBE6057-539E-4D34-BEBB-573D89B05350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56" creationId="{C8AB3E85-3BA5-42B3-80A6-1EDA4EF78B0C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57" creationId="{6CC8DEFE-AF0B-460C-99B4-95942B60A3D5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65" creationId="{7B0A550E-B214-4B38-81C9-D41D56CD4B8B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88" creationId="{7309DE7D-82B3-4F46-B078-58EBF40D4703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93" creationId="{3EAC0E29-A0FD-42DD-8F3E-7B6BDF36A320}"/>
          </ac:spMkLst>
        </pc:spChg>
        <pc:spChg chg="mod">
          <ac:chgData name="Hayk Barseghyan" userId="1af3c995-31f7-415e-9aa1-2b36900e994d" providerId="ADAL" clId="{67884524-D562-4D7F-839E-951A995161A3}" dt="2021-04-09T16:25:38.972" v="286" actId="1037"/>
          <ac:spMkLst>
            <pc:docMk/>
            <pc:sldMk cId="2324644523" sldId="667"/>
            <ac:spMk id="94" creationId="{C3B2E742-FF55-4D80-8A82-03F353C11C9E}"/>
          </ac:spMkLst>
        </pc:spChg>
        <pc:picChg chg="mod">
          <ac:chgData name="Hayk Barseghyan" userId="1af3c995-31f7-415e-9aa1-2b36900e994d" providerId="ADAL" clId="{67884524-D562-4D7F-839E-951A995161A3}" dt="2021-04-09T16:25:38.972" v="286" actId="1037"/>
          <ac:picMkLst>
            <pc:docMk/>
            <pc:sldMk cId="2324644523" sldId="667"/>
            <ac:picMk id="8" creationId="{C2F4CFAE-19D4-4CF3-AA27-972256137E91}"/>
          </ac:picMkLst>
        </pc:picChg>
        <pc:picChg chg="mod">
          <ac:chgData name="Hayk Barseghyan" userId="1af3c995-31f7-415e-9aa1-2b36900e994d" providerId="ADAL" clId="{67884524-D562-4D7F-839E-951A995161A3}" dt="2021-04-09T16:25:38.972" v="286" actId="1037"/>
          <ac:picMkLst>
            <pc:docMk/>
            <pc:sldMk cId="2324644523" sldId="667"/>
            <ac:picMk id="10" creationId="{94505D45-D7CA-43EA-A472-64A3846DE999}"/>
          </ac:picMkLst>
        </pc:picChg>
        <pc:picChg chg="mod">
          <ac:chgData name="Hayk Barseghyan" userId="1af3c995-31f7-415e-9aa1-2b36900e994d" providerId="ADAL" clId="{67884524-D562-4D7F-839E-951A995161A3}" dt="2021-04-09T16:25:38.972" v="286" actId="1037"/>
          <ac:picMkLst>
            <pc:docMk/>
            <pc:sldMk cId="2324644523" sldId="667"/>
            <ac:picMk id="12" creationId="{275784C0-4287-4244-9FF5-6076621E868E}"/>
          </ac:picMkLst>
        </pc:picChg>
        <pc:picChg chg="mod">
          <ac:chgData name="Hayk Barseghyan" userId="1af3c995-31f7-415e-9aa1-2b36900e994d" providerId="ADAL" clId="{67884524-D562-4D7F-839E-951A995161A3}" dt="2021-04-09T16:25:38.972" v="286" actId="1037"/>
          <ac:picMkLst>
            <pc:docMk/>
            <pc:sldMk cId="2324644523" sldId="667"/>
            <ac:picMk id="32" creationId="{D220D809-FBE8-496C-A502-B21C41CEC52D}"/>
          </ac:picMkLst>
        </pc:picChg>
      </pc:sldChg>
      <pc:sldChg chg="modSp mod modNotesTx">
        <pc:chgData name="Hayk Barseghyan" userId="1af3c995-31f7-415e-9aa1-2b36900e994d" providerId="ADAL" clId="{67884524-D562-4D7F-839E-951A995161A3}" dt="2021-04-09T20:26:54.315" v="2682" actId="20577"/>
        <pc:sldMkLst>
          <pc:docMk/>
          <pc:sldMk cId="2946833462" sldId="671"/>
        </pc:sldMkLst>
        <pc:spChg chg="mod">
          <ac:chgData name="Hayk Barseghyan" userId="1af3c995-31f7-415e-9aa1-2b36900e994d" providerId="ADAL" clId="{67884524-D562-4D7F-839E-951A995161A3}" dt="2021-04-09T16:08:46.695" v="166" actId="1076"/>
          <ac:spMkLst>
            <pc:docMk/>
            <pc:sldMk cId="2946833462" sldId="671"/>
            <ac:spMk id="15" creationId="{1DA809E1-700B-4B5F-80D1-146841C532CC}"/>
          </ac:spMkLst>
        </pc:spChg>
        <pc:spChg chg="mod">
          <ac:chgData name="Hayk Barseghyan" userId="1af3c995-31f7-415e-9aa1-2b36900e994d" providerId="ADAL" clId="{67884524-D562-4D7F-839E-951A995161A3}" dt="2021-04-09T16:08:46.695" v="166" actId="1076"/>
          <ac:spMkLst>
            <pc:docMk/>
            <pc:sldMk cId="2946833462" sldId="671"/>
            <ac:spMk id="16" creationId="{219D3844-749C-4AC5-8AAC-A5A6E4F706D5}"/>
          </ac:spMkLst>
        </pc:spChg>
        <pc:spChg chg="mod">
          <ac:chgData name="Hayk Barseghyan" userId="1af3c995-31f7-415e-9aa1-2b36900e994d" providerId="ADAL" clId="{67884524-D562-4D7F-839E-951A995161A3}" dt="2021-04-09T16:08:46.695" v="166" actId="1076"/>
          <ac:spMkLst>
            <pc:docMk/>
            <pc:sldMk cId="2946833462" sldId="671"/>
            <ac:spMk id="17" creationId="{238D452B-545B-49D2-9AA5-4774F789BA52}"/>
          </ac:spMkLst>
        </pc:spChg>
        <pc:spChg chg="mod">
          <ac:chgData name="Hayk Barseghyan" userId="1af3c995-31f7-415e-9aa1-2b36900e994d" providerId="ADAL" clId="{67884524-D562-4D7F-839E-951A995161A3}" dt="2021-04-09T16:08:46.695" v="166" actId="1076"/>
          <ac:spMkLst>
            <pc:docMk/>
            <pc:sldMk cId="2946833462" sldId="671"/>
            <ac:spMk id="18" creationId="{3B330CDD-DF8E-4329-9F8F-0C05A3EBA278}"/>
          </ac:spMkLst>
        </pc:spChg>
        <pc:spChg chg="mod">
          <ac:chgData name="Hayk Barseghyan" userId="1af3c995-31f7-415e-9aa1-2b36900e994d" providerId="ADAL" clId="{67884524-D562-4D7F-839E-951A995161A3}" dt="2021-04-09T16:08:46.695" v="166" actId="1076"/>
          <ac:spMkLst>
            <pc:docMk/>
            <pc:sldMk cId="2946833462" sldId="671"/>
            <ac:spMk id="19" creationId="{92E3FBB9-4482-4901-BB7B-515414A60BF3}"/>
          </ac:spMkLst>
        </pc:spChg>
        <pc:spChg chg="mod">
          <ac:chgData name="Hayk Barseghyan" userId="1af3c995-31f7-415e-9aa1-2b36900e994d" providerId="ADAL" clId="{67884524-D562-4D7F-839E-951A995161A3}" dt="2021-04-09T16:08:46.695" v="166" actId="1076"/>
          <ac:spMkLst>
            <pc:docMk/>
            <pc:sldMk cId="2946833462" sldId="671"/>
            <ac:spMk id="20" creationId="{33617DAE-E7EA-4947-A705-85255111007E}"/>
          </ac:spMkLst>
        </pc:spChg>
        <pc:spChg chg="mod">
          <ac:chgData name="Hayk Barseghyan" userId="1af3c995-31f7-415e-9aa1-2b36900e994d" providerId="ADAL" clId="{67884524-D562-4D7F-839E-951A995161A3}" dt="2021-04-09T16:08:46.695" v="166" actId="1076"/>
          <ac:spMkLst>
            <pc:docMk/>
            <pc:sldMk cId="2946833462" sldId="671"/>
            <ac:spMk id="21" creationId="{C9A0FE9C-502B-4BBD-8A60-74F846E3930A}"/>
          </ac:spMkLst>
        </pc:spChg>
        <pc:spChg chg="mod">
          <ac:chgData name="Hayk Barseghyan" userId="1af3c995-31f7-415e-9aa1-2b36900e994d" providerId="ADAL" clId="{67884524-D562-4D7F-839E-951A995161A3}" dt="2021-04-09T16:08:46.695" v="166" actId="1076"/>
          <ac:spMkLst>
            <pc:docMk/>
            <pc:sldMk cId="2946833462" sldId="671"/>
            <ac:spMk id="22" creationId="{097F0FB6-DB3D-4B12-9E76-180A15D9B845}"/>
          </ac:spMkLst>
        </pc:spChg>
        <pc:picChg chg="mod">
          <ac:chgData name="Hayk Barseghyan" userId="1af3c995-31f7-415e-9aa1-2b36900e994d" providerId="ADAL" clId="{67884524-D562-4D7F-839E-951A995161A3}" dt="2021-04-09T16:08:46.695" v="166" actId="1076"/>
          <ac:picMkLst>
            <pc:docMk/>
            <pc:sldMk cId="2946833462" sldId="671"/>
            <ac:picMk id="14" creationId="{BD596D5A-A8B5-4F23-971B-B0033B030440}"/>
          </ac:picMkLst>
        </pc:picChg>
        <pc:cxnChg chg="mod">
          <ac:chgData name="Hayk Barseghyan" userId="1af3c995-31f7-415e-9aa1-2b36900e994d" providerId="ADAL" clId="{67884524-D562-4D7F-839E-951A995161A3}" dt="2021-04-09T16:08:46.695" v="166" actId="1076"/>
          <ac:cxnSpMkLst>
            <pc:docMk/>
            <pc:sldMk cId="2946833462" sldId="671"/>
            <ac:cxnSpMk id="23" creationId="{B97A16ED-5542-4DD1-94CA-D032D3F72196}"/>
          </ac:cxnSpMkLst>
        </pc:cxnChg>
        <pc:cxnChg chg="mod">
          <ac:chgData name="Hayk Barseghyan" userId="1af3c995-31f7-415e-9aa1-2b36900e994d" providerId="ADAL" clId="{67884524-D562-4D7F-839E-951A995161A3}" dt="2021-04-09T16:08:46.695" v="166" actId="1076"/>
          <ac:cxnSpMkLst>
            <pc:docMk/>
            <pc:sldMk cId="2946833462" sldId="671"/>
            <ac:cxnSpMk id="24" creationId="{792D8F66-E748-410F-BB9B-B632B254BDFB}"/>
          </ac:cxnSpMkLst>
        </pc:cxnChg>
        <pc:cxnChg chg="mod">
          <ac:chgData name="Hayk Barseghyan" userId="1af3c995-31f7-415e-9aa1-2b36900e994d" providerId="ADAL" clId="{67884524-D562-4D7F-839E-951A995161A3}" dt="2021-04-09T16:08:46.695" v="166" actId="1076"/>
          <ac:cxnSpMkLst>
            <pc:docMk/>
            <pc:sldMk cId="2946833462" sldId="671"/>
            <ac:cxnSpMk id="25" creationId="{A4F48631-3605-414B-96A3-B4E7701F3903}"/>
          </ac:cxnSpMkLst>
        </pc:cxnChg>
      </pc:sldChg>
      <pc:sldChg chg="addSp delSp modSp add mod modNotesTx">
        <pc:chgData name="Hayk Barseghyan" userId="1af3c995-31f7-415e-9aa1-2b36900e994d" providerId="ADAL" clId="{67884524-D562-4D7F-839E-951A995161A3}" dt="2021-04-09T20:27:04.910" v="2684" actId="20577"/>
        <pc:sldMkLst>
          <pc:docMk/>
          <pc:sldMk cId="1326918807" sldId="673"/>
        </pc:sldMkLst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15" creationId="{1DA809E1-700B-4B5F-80D1-146841C532CC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16" creationId="{219D3844-749C-4AC5-8AAC-A5A6E4F706D5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17" creationId="{238D452B-545B-49D2-9AA5-4774F789BA52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18" creationId="{3B330CDD-DF8E-4329-9F8F-0C05A3EBA278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19" creationId="{92E3FBB9-4482-4901-BB7B-515414A60BF3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20" creationId="{33617DAE-E7EA-4947-A705-85255111007E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21" creationId="{C9A0FE9C-502B-4BBD-8A60-74F846E3930A}"/>
          </ac:spMkLst>
        </pc:spChg>
        <pc:spChg chg="del">
          <ac:chgData name="Hayk Barseghyan" userId="1af3c995-31f7-415e-9aa1-2b36900e994d" providerId="ADAL" clId="{67884524-D562-4D7F-839E-951A995161A3}" dt="2021-04-09T14:23:08.027" v="20" actId="478"/>
          <ac:spMkLst>
            <pc:docMk/>
            <pc:sldMk cId="1326918807" sldId="673"/>
            <ac:spMk id="22" creationId="{097F0FB6-DB3D-4B12-9E76-180A15D9B845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28" creationId="{627423C8-B194-4935-85FA-5ED8C3D13EA3}"/>
          </ac:spMkLst>
        </pc:spChg>
        <pc:spChg chg="del">
          <ac:chgData name="Hayk Barseghyan" userId="1af3c995-31f7-415e-9aa1-2b36900e994d" providerId="ADAL" clId="{67884524-D562-4D7F-839E-951A995161A3}" dt="2021-04-09T14:23:08.027" v="20" actId="478"/>
          <ac:spMkLst>
            <pc:docMk/>
            <pc:sldMk cId="1326918807" sldId="673"/>
            <ac:spMk id="30" creationId="{68ED1E75-B125-4C10-BB29-81E202553B2C}"/>
          </ac:spMkLst>
        </pc:spChg>
        <pc:spChg chg="mod">
          <ac:chgData name="Hayk Barseghyan" userId="1af3c995-31f7-415e-9aa1-2b36900e994d" providerId="ADAL" clId="{67884524-D562-4D7F-839E-951A995161A3}" dt="2021-04-09T14:22:52.070" v="18" actId="20577"/>
          <ac:spMkLst>
            <pc:docMk/>
            <pc:sldMk cId="1326918807" sldId="673"/>
            <ac:spMk id="33" creationId="{27D04DB1-6D7F-4335-AAA1-99D44F3F14E9}"/>
          </ac:spMkLst>
        </pc:spChg>
        <pc:spChg chg="del">
          <ac:chgData name="Hayk Barseghyan" userId="1af3c995-31f7-415e-9aa1-2b36900e994d" providerId="ADAL" clId="{67884524-D562-4D7F-839E-951A995161A3}" dt="2021-04-09T14:23:08.027" v="20" actId="478"/>
          <ac:spMkLst>
            <pc:docMk/>
            <pc:sldMk cId="1326918807" sldId="673"/>
            <ac:spMk id="34" creationId="{9E232FB5-9A42-4416-8E4E-5620B622F041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36" creationId="{D1390CDB-8C38-45E4-B737-627C1887B062}"/>
          </ac:spMkLst>
        </pc:spChg>
        <pc:spChg chg="add del mod">
          <ac:chgData name="Hayk Barseghyan" userId="1af3c995-31f7-415e-9aa1-2b36900e994d" providerId="ADAL" clId="{67884524-D562-4D7F-839E-951A995161A3}" dt="2021-04-09T14:24:05.361" v="24" actId="478"/>
          <ac:spMkLst>
            <pc:docMk/>
            <pc:sldMk cId="1326918807" sldId="673"/>
            <ac:spMk id="37" creationId="{D2556AD3-BA58-4172-B724-DE960F979BB7}"/>
          </ac:spMkLst>
        </pc:spChg>
        <pc:spChg chg="add mod">
          <ac:chgData name="Hayk Barseghyan" userId="1af3c995-31f7-415e-9aa1-2b36900e994d" providerId="ADAL" clId="{67884524-D562-4D7F-839E-951A995161A3}" dt="2021-04-09T15:16:30.435" v="42" actId="14100"/>
          <ac:spMkLst>
            <pc:docMk/>
            <pc:sldMk cId="1326918807" sldId="673"/>
            <ac:spMk id="39" creationId="{C6930C5C-1A06-4122-AEF1-3939C5BC870A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40" creationId="{EFE6C304-6608-4E19-9AF5-28280CCAEF69}"/>
          </ac:spMkLst>
        </pc:spChg>
        <pc:spChg chg="add mod">
          <ac:chgData name="Hayk Barseghyan" userId="1af3c995-31f7-415e-9aa1-2b36900e994d" providerId="ADAL" clId="{67884524-D562-4D7F-839E-951A995161A3}" dt="2021-04-09T14:24:16.097" v="25" actId="1076"/>
          <ac:spMkLst>
            <pc:docMk/>
            <pc:sldMk cId="1326918807" sldId="673"/>
            <ac:spMk id="41" creationId="{A22BB18F-5194-4153-BAC8-C262EF1DDDDE}"/>
          </ac:spMkLst>
        </pc:spChg>
        <pc:spChg chg="add mod">
          <ac:chgData name="Hayk Barseghyan" userId="1af3c995-31f7-415e-9aa1-2b36900e994d" providerId="ADAL" clId="{67884524-D562-4D7F-839E-951A995161A3}" dt="2021-04-09T15:35:51.320" v="73" actId="1037"/>
          <ac:spMkLst>
            <pc:docMk/>
            <pc:sldMk cId="1326918807" sldId="673"/>
            <ac:spMk id="42" creationId="{1A14296C-A126-4A4E-83FF-3B21985FF6C3}"/>
          </ac:spMkLst>
        </pc:spChg>
        <pc:spChg chg="add del mod">
          <ac:chgData name="Hayk Barseghyan" userId="1af3c995-31f7-415e-9aa1-2b36900e994d" providerId="ADAL" clId="{67884524-D562-4D7F-839E-951A995161A3}" dt="2021-04-09T15:13:54.412" v="32" actId="478"/>
          <ac:spMkLst>
            <pc:docMk/>
            <pc:sldMk cId="1326918807" sldId="673"/>
            <ac:spMk id="43" creationId="{854A7DD3-6FF6-4D90-B0F8-9B0884F1E0AB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44" creationId="{732812E5-D6B9-4FEF-975D-E2E3D93D0E47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45" creationId="{706B5154-0B8D-4A97-9481-9F43337FAC30}"/>
          </ac:spMkLst>
        </pc:spChg>
        <pc:spChg chg="add del mod">
          <ac:chgData name="Hayk Barseghyan" userId="1af3c995-31f7-415e-9aa1-2b36900e994d" providerId="ADAL" clId="{67884524-D562-4D7F-839E-951A995161A3}" dt="2021-04-09T15:13:53.188" v="31" actId="478"/>
          <ac:spMkLst>
            <pc:docMk/>
            <pc:sldMk cId="1326918807" sldId="673"/>
            <ac:spMk id="46" creationId="{3991B28C-2EB9-484A-B965-B8CC84E2F9F0}"/>
          </ac:spMkLst>
        </pc:spChg>
        <pc:spChg chg="add mod">
          <ac:chgData name="Hayk Barseghyan" userId="1af3c995-31f7-415e-9aa1-2b36900e994d" providerId="ADAL" clId="{67884524-D562-4D7F-839E-951A995161A3}" dt="2021-04-09T15:35:35.822" v="68" actId="20577"/>
          <ac:spMkLst>
            <pc:docMk/>
            <pc:sldMk cId="1326918807" sldId="673"/>
            <ac:spMk id="47" creationId="{8AE1C1CF-2982-46EE-BBB5-F2BFC3AE3ED5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48" creationId="{7DECEAD3-1F4B-4349-B3E1-EC2281C752C7}"/>
          </ac:spMkLst>
        </pc:spChg>
        <pc:spChg chg="add mod">
          <ac:chgData name="Hayk Barseghyan" userId="1af3c995-31f7-415e-9aa1-2b36900e994d" providerId="ADAL" clId="{67884524-D562-4D7F-839E-951A995161A3}" dt="2021-04-09T15:35:29.550" v="64" actId="1076"/>
          <ac:spMkLst>
            <pc:docMk/>
            <pc:sldMk cId="1326918807" sldId="673"/>
            <ac:spMk id="50" creationId="{3B7C139F-6476-4E93-B928-A38566762C3A}"/>
          </ac:spMkLst>
        </pc:spChg>
        <pc:spChg chg="add del mod">
          <ac:chgData name="Hayk Barseghyan" userId="1af3c995-31f7-415e-9aa1-2b36900e994d" providerId="ADAL" clId="{67884524-D562-4D7F-839E-951A995161A3}" dt="2021-04-09T15:35:07.411" v="56" actId="478"/>
          <ac:spMkLst>
            <pc:docMk/>
            <pc:sldMk cId="1326918807" sldId="673"/>
            <ac:spMk id="51" creationId="{0F8133B1-5B0A-47DE-9456-B6585CA7C6E4}"/>
          </ac:spMkLst>
        </pc:spChg>
        <pc:spChg chg="add mod">
          <ac:chgData name="Hayk Barseghyan" userId="1af3c995-31f7-415e-9aa1-2b36900e994d" providerId="ADAL" clId="{67884524-D562-4D7F-839E-951A995161A3}" dt="2021-04-09T15:35:21.488" v="63" actId="20577"/>
          <ac:spMkLst>
            <pc:docMk/>
            <pc:sldMk cId="1326918807" sldId="673"/>
            <ac:spMk id="53" creationId="{C3FB21F2-301A-4C0F-B759-287A936DA90E}"/>
          </ac:spMkLst>
        </pc:spChg>
        <pc:spChg chg="add del mod">
          <ac:chgData name="Hayk Barseghyan" userId="1af3c995-31f7-415e-9aa1-2b36900e994d" providerId="ADAL" clId="{67884524-D562-4D7F-839E-951A995161A3}" dt="2021-04-09T15:35:10.331" v="57" actId="478"/>
          <ac:spMkLst>
            <pc:docMk/>
            <pc:sldMk cId="1326918807" sldId="673"/>
            <ac:spMk id="54" creationId="{10E99458-A32D-451B-B45E-DB6EFFD594C3}"/>
          </ac:spMkLst>
        </pc:spChg>
        <pc:spChg chg="add mod">
          <ac:chgData name="Hayk Barseghyan" userId="1af3c995-31f7-415e-9aa1-2b36900e994d" providerId="ADAL" clId="{67884524-D562-4D7F-839E-951A995161A3}" dt="2021-04-09T15:28:47.997" v="50" actId="14100"/>
          <ac:spMkLst>
            <pc:docMk/>
            <pc:sldMk cId="1326918807" sldId="673"/>
            <ac:spMk id="55" creationId="{1480A490-4E36-4102-8115-ADC2AA4F7761}"/>
          </ac:spMkLst>
        </pc:spChg>
        <pc:spChg chg="add mod">
          <ac:chgData name="Hayk Barseghyan" userId="1af3c995-31f7-415e-9aa1-2b36900e994d" providerId="ADAL" clId="{67884524-D562-4D7F-839E-951A995161A3}" dt="2021-04-09T15:28:51.010" v="51" actId="1076"/>
          <ac:spMkLst>
            <pc:docMk/>
            <pc:sldMk cId="1326918807" sldId="673"/>
            <ac:spMk id="56" creationId="{CFC98ADF-75D5-4DB7-BE62-79053734A9E8}"/>
          </ac:spMkLst>
        </pc:spChg>
        <pc:spChg chg="add mod">
          <ac:chgData name="Hayk Barseghyan" userId="1af3c995-31f7-415e-9aa1-2b36900e994d" providerId="ADAL" clId="{67884524-D562-4D7F-839E-951A995161A3}" dt="2021-04-09T15:36:42.470" v="89" actId="113"/>
          <ac:spMkLst>
            <pc:docMk/>
            <pc:sldMk cId="1326918807" sldId="673"/>
            <ac:spMk id="57" creationId="{C96C0B54-C927-4F57-9448-61F2B86967BC}"/>
          </ac:spMkLst>
        </pc:spChg>
        <pc:spChg chg="add mod">
          <ac:chgData name="Hayk Barseghyan" userId="1af3c995-31f7-415e-9aa1-2b36900e994d" providerId="ADAL" clId="{67884524-D562-4D7F-839E-951A995161A3}" dt="2021-04-09T15:37:54.781" v="163" actId="20577"/>
          <ac:spMkLst>
            <pc:docMk/>
            <pc:sldMk cId="1326918807" sldId="673"/>
            <ac:spMk id="58" creationId="{987FE37B-B689-41AF-BF07-7F3C3FAD1AE1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88" creationId="{7309DE7D-82B3-4F46-B078-58EBF40D4703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91" creationId="{13B1F2AA-C6E8-4BA8-9C3E-AADD95A31E93}"/>
          </ac:spMkLst>
        </pc:spChg>
        <pc:spChg chg="del">
          <ac:chgData name="Hayk Barseghyan" userId="1af3c995-31f7-415e-9aa1-2b36900e994d" providerId="ADAL" clId="{67884524-D562-4D7F-839E-951A995161A3}" dt="2021-04-09T14:23:08.027" v="20" actId="478"/>
          <ac:spMkLst>
            <pc:docMk/>
            <pc:sldMk cId="1326918807" sldId="673"/>
            <ac:spMk id="92" creationId="{C38076EE-D1EB-4356-9361-84DA46C2351B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93" creationId="{3EAC0E29-A0FD-42DD-8F3E-7B6BDF36A320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94" creationId="{C3B2E742-FF55-4D80-8A82-03F353C11C9E}"/>
          </ac:spMkLst>
        </pc:spChg>
        <pc:spChg chg="del">
          <ac:chgData name="Hayk Barseghyan" userId="1af3c995-31f7-415e-9aa1-2b36900e994d" providerId="ADAL" clId="{67884524-D562-4D7F-839E-951A995161A3}" dt="2021-04-09T14:23:00.424" v="19" actId="478"/>
          <ac:spMkLst>
            <pc:docMk/>
            <pc:sldMk cId="1326918807" sldId="673"/>
            <ac:spMk id="98" creationId="{CC1A3F83-E94B-4F3C-9D62-2C0B7D404690}"/>
          </ac:spMkLst>
        </pc:spChg>
        <pc:picChg chg="add del mod">
          <ac:chgData name="Hayk Barseghyan" userId="1af3c995-31f7-415e-9aa1-2b36900e994d" providerId="ADAL" clId="{67884524-D562-4D7F-839E-951A995161A3}" dt="2021-04-09T15:16:36.397" v="44" actId="478"/>
          <ac:picMkLst>
            <pc:docMk/>
            <pc:sldMk cId="1326918807" sldId="673"/>
            <ac:picMk id="3" creationId="{652AE09D-798C-4831-894D-DF83F4909925}"/>
          </ac:picMkLst>
        </pc:picChg>
        <pc:picChg chg="del">
          <ac:chgData name="Hayk Barseghyan" userId="1af3c995-31f7-415e-9aa1-2b36900e994d" providerId="ADAL" clId="{67884524-D562-4D7F-839E-951A995161A3}" dt="2021-04-09T14:23:00.424" v="19" actId="478"/>
          <ac:picMkLst>
            <pc:docMk/>
            <pc:sldMk cId="1326918807" sldId="673"/>
            <ac:picMk id="4" creationId="{6EE723D7-82C2-40C7-9EDF-695ABCFD2852}"/>
          </ac:picMkLst>
        </pc:picChg>
        <pc:picChg chg="add mod">
          <ac:chgData name="Hayk Barseghyan" userId="1af3c995-31f7-415e-9aa1-2b36900e994d" providerId="ADAL" clId="{67884524-D562-4D7F-839E-951A995161A3}" dt="2021-04-09T15:17:39.715" v="49" actId="1076"/>
          <ac:picMkLst>
            <pc:docMk/>
            <pc:sldMk cId="1326918807" sldId="673"/>
            <ac:picMk id="6" creationId="{F6AB2EC4-60C1-41BD-8793-D6840DD687B2}"/>
          </ac:picMkLst>
        </pc:picChg>
        <pc:picChg chg="add mod">
          <ac:chgData name="Hayk Barseghyan" userId="1af3c995-31f7-415e-9aa1-2b36900e994d" providerId="ADAL" clId="{67884524-D562-4D7F-839E-951A995161A3}" dt="2021-04-09T15:33:54.218" v="55" actId="1076"/>
          <ac:picMkLst>
            <pc:docMk/>
            <pc:sldMk cId="1326918807" sldId="673"/>
            <ac:picMk id="8" creationId="{83CD2CE8-9922-4F0B-A1FE-1866A3018006}"/>
          </ac:picMkLst>
        </pc:picChg>
        <pc:picChg chg="del">
          <ac:chgData name="Hayk Barseghyan" userId="1af3c995-31f7-415e-9aa1-2b36900e994d" providerId="ADAL" clId="{67884524-D562-4D7F-839E-951A995161A3}" dt="2021-04-09T14:23:00.424" v="19" actId="478"/>
          <ac:picMkLst>
            <pc:docMk/>
            <pc:sldMk cId="1326918807" sldId="673"/>
            <ac:picMk id="14" creationId="{BD596D5A-A8B5-4F23-971B-B0033B030440}"/>
          </ac:picMkLst>
        </pc:picChg>
        <pc:picChg chg="del">
          <ac:chgData name="Hayk Barseghyan" userId="1af3c995-31f7-415e-9aa1-2b36900e994d" providerId="ADAL" clId="{67884524-D562-4D7F-839E-951A995161A3}" dt="2021-04-09T14:23:00.424" v="19" actId="478"/>
          <ac:picMkLst>
            <pc:docMk/>
            <pc:sldMk cId="1326918807" sldId="673"/>
            <ac:picMk id="35" creationId="{347E1D22-E15C-425D-925B-99F60A60B955}"/>
          </ac:picMkLst>
        </pc:picChg>
        <pc:picChg chg="add del mod">
          <ac:chgData name="Hayk Barseghyan" userId="1af3c995-31f7-415e-9aa1-2b36900e994d" providerId="ADAL" clId="{67884524-D562-4D7F-839E-951A995161A3}" dt="2021-04-09T15:13:49.949" v="30" actId="478"/>
          <ac:picMkLst>
            <pc:docMk/>
            <pc:sldMk cId="1326918807" sldId="673"/>
            <ac:picMk id="38" creationId="{C1DDAC7F-01B2-45C3-BC07-595F5B5D6C25}"/>
          </ac:picMkLst>
        </pc:picChg>
        <pc:cxnChg chg="add mod">
          <ac:chgData name="Hayk Barseghyan" userId="1af3c995-31f7-415e-9aa1-2b36900e994d" providerId="ADAL" clId="{67884524-D562-4D7F-839E-951A995161A3}" dt="2021-04-09T15:37:23.432" v="106" actId="1036"/>
          <ac:cxnSpMkLst>
            <pc:docMk/>
            <pc:sldMk cId="1326918807" sldId="673"/>
            <ac:cxnSpMk id="10" creationId="{D0270CF5-E165-434E-BEC2-B69D1690DF1F}"/>
          </ac:cxnSpMkLst>
        </pc:cxnChg>
        <pc:cxnChg chg="del mod">
          <ac:chgData name="Hayk Barseghyan" userId="1af3c995-31f7-415e-9aa1-2b36900e994d" providerId="ADAL" clId="{67884524-D562-4D7F-839E-951A995161A3}" dt="2021-04-09T14:23:00.424" v="19" actId="478"/>
          <ac:cxnSpMkLst>
            <pc:docMk/>
            <pc:sldMk cId="1326918807" sldId="673"/>
            <ac:cxnSpMk id="23" creationId="{B97A16ED-5542-4DD1-94CA-D032D3F72196}"/>
          </ac:cxnSpMkLst>
        </pc:cxnChg>
        <pc:cxnChg chg="del mod">
          <ac:chgData name="Hayk Barseghyan" userId="1af3c995-31f7-415e-9aa1-2b36900e994d" providerId="ADAL" clId="{67884524-D562-4D7F-839E-951A995161A3}" dt="2021-04-09T14:23:00.424" v="19" actId="478"/>
          <ac:cxnSpMkLst>
            <pc:docMk/>
            <pc:sldMk cId="1326918807" sldId="673"/>
            <ac:cxnSpMk id="24" creationId="{792D8F66-E748-410F-BB9B-B632B254BDFB}"/>
          </ac:cxnSpMkLst>
        </pc:cxnChg>
        <pc:cxnChg chg="del mod">
          <ac:chgData name="Hayk Barseghyan" userId="1af3c995-31f7-415e-9aa1-2b36900e994d" providerId="ADAL" clId="{67884524-D562-4D7F-839E-951A995161A3}" dt="2021-04-09T14:23:00.424" v="19" actId="478"/>
          <ac:cxnSpMkLst>
            <pc:docMk/>
            <pc:sldMk cId="1326918807" sldId="673"/>
            <ac:cxnSpMk id="25" creationId="{A4F48631-3605-414B-96A3-B4E7701F3903}"/>
          </ac:cxnSpMkLst>
        </pc:cxnChg>
        <pc:cxnChg chg="del mod">
          <ac:chgData name="Hayk Barseghyan" userId="1af3c995-31f7-415e-9aa1-2b36900e994d" providerId="ADAL" clId="{67884524-D562-4D7F-839E-951A995161A3}" dt="2021-04-09T14:23:00.424" v="19" actId="478"/>
          <ac:cxnSpMkLst>
            <pc:docMk/>
            <pc:sldMk cId="1326918807" sldId="673"/>
            <ac:cxnSpMk id="49" creationId="{4423681D-AADF-4D62-AC9E-3FDDF18E21B9}"/>
          </ac:cxnSpMkLst>
        </pc:cxnChg>
        <pc:cxnChg chg="del mod">
          <ac:chgData name="Hayk Barseghyan" userId="1af3c995-31f7-415e-9aa1-2b36900e994d" providerId="ADAL" clId="{67884524-D562-4D7F-839E-951A995161A3}" dt="2021-04-09T14:23:00.424" v="19" actId="478"/>
          <ac:cxnSpMkLst>
            <pc:docMk/>
            <pc:sldMk cId="1326918807" sldId="673"/>
            <ac:cxnSpMk id="52" creationId="{67E81840-D31A-48DD-9275-CD08F7D6F031}"/>
          </ac:cxnSpMkLst>
        </pc:cxnChg>
        <pc:cxnChg chg="del">
          <ac:chgData name="Hayk Barseghyan" userId="1af3c995-31f7-415e-9aa1-2b36900e994d" providerId="ADAL" clId="{67884524-D562-4D7F-839E-951A995161A3}" dt="2021-04-09T14:23:00.424" v="19" actId="478"/>
          <ac:cxnSpMkLst>
            <pc:docMk/>
            <pc:sldMk cId="1326918807" sldId="673"/>
            <ac:cxnSpMk id="95" creationId="{5EB10151-CF0F-4162-A03A-2FB4661DCBE8}"/>
          </ac:cxnSpMkLst>
        </pc:cxnChg>
      </pc:sldChg>
      <pc:sldChg chg="new">
        <pc:chgData name="Hayk Barseghyan" userId="1af3c995-31f7-415e-9aa1-2b36900e994d" providerId="ADAL" clId="{67884524-D562-4D7F-839E-951A995161A3}" dt="2021-04-09T20:28:09.497" v="2688" actId="680"/>
        <pc:sldMkLst>
          <pc:docMk/>
          <pc:sldMk cId="1199739442" sldId="674"/>
        </pc:sldMkLst>
      </pc:sldChg>
      <pc:sldChg chg="new">
        <pc:chgData name="Hayk Barseghyan" userId="1af3c995-31f7-415e-9aa1-2b36900e994d" providerId="ADAL" clId="{67884524-D562-4D7F-839E-951A995161A3}" dt="2021-04-09T20:28:10.130" v="2689" actId="680"/>
        <pc:sldMkLst>
          <pc:docMk/>
          <pc:sldMk cId="3274253545" sldId="675"/>
        </pc:sldMkLst>
      </pc:sldChg>
    </pc:docChg>
  </pc:docChgLst>
  <pc:docChgLst>
    <pc:chgData name="Hayk Barseghyan" userId="1af3c995-31f7-415e-9aa1-2b36900e994d" providerId="ADAL" clId="{70A19F8E-9ADD-45E3-8B5D-5634A3FE2C93}"/>
    <pc:docChg chg="undo redo custSel addSld delSld modSld sldOrd">
      <pc:chgData name="Hayk Barseghyan" userId="1af3c995-31f7-415e-9aa1-2b36900e994d" providerId="ADAL" clId="{70A19F8E-9ADD-45E3-8B5D-5634A3FE2C93}" dt="2021-02-11T01:21:14.329" v="1312" actId="1076"/>
      <pc:docMkLst>
        <pc:docMk/>
      </pc:docMkLst>
      <pc:sldChg chg="addSp delSp modSp del mod addAnim delAnim modNotesTx">
        <pc:chgData name="Hayk Barseghyan" userId="1af3c995-31f7-415e-9aa1-2b36900e994d" providerId="ADAL" clId="{70A19F8E-9ADD-45E3-8B5D-5634A3FE2C93}" dt="2021-02-09T21:27:48.716" v="237" actId="47"/>
        <pc:sldMkLst>
          <pc:docMk/>
          <pc:sldMk cId="1114573650" sldId="646"/>
        </pc:sldMkLst>
        <pc:spChg chg="add del mod">
          <ac:chgData name="Hayk Barseghyan" userId="1af3c995-31f7-415e-9aa1-2b36900e994d" providerId="ADAL" clId="{70A19F8E-9ADD-45E3-8B5D-5634A3FE2C93}" dt="2021-02-09T00:30:19.695" v="4" actId="478"/>
          <ac:spMkLst>
            <pc:docMk/>
            <pc:sldMk cId="1114573650" sldId="646"/>
            <ac:spMk id="3" creationId="{2A30F171-827A-4212-BE87-99F9DF8C0422}"/>
          </ac:spMkLst>
        </pc:spChg>
        <pc:spChg chg="mod">
          <ac:chgData name="Hayk Barseghyan" userId="1af3c995-31f7-415e-9aa1-2b36900e994d" providerId="ADAL" clId="{70A19F8E-9ADD-45E3-8B5D-5634A3FE2C93}" dt="2021-02-09T00:31:11.835" v="12" actId="1076"/>
          <ac:spMkLst>
            <pc:docMk/>
            <pc:sldMk cId="1114573650" sldId="646"/>
            <ac:spMk id="6" creationId="{E9E66140-A658-4DEE-9573-4304BC04CC56}"/>
          </ac:spMkLst>
        </pc:spChg>
        <pc:spChg chg="add del mod">
          <ac:chgData name="Hayk Barseghyan" userId="1af3c995-31f7-415e-9aa1-2b36900e994d" providerId="ADAL" clId="{70A19F8E-9ADD-45E3-8B5D-5634A3FE2C93}" dt="2021-02-09T00:31:05.296" v="11" actId="478"/>
          <ac:spMkLst>
            <pc:docMk/>
            <pc:sldMk cId="1114573650" sldId="646"/>
            <ac:spMk id="7" creationId="{3138AA1A-ACBA-4072-AC18-1017A0681BA8}"/>
          </ac:spMkLst>
        </pc:spChg>
        <pc:spChg chg="add del mod">
          <ac:chgData name="Hayk Barseghyan" userId="1af3c995-31f7-415e-9aa1-2b36900e994d" providerId="ADAL" clId="{70A19F8E-9ADD-45E3-8B5D-5634A3FE2C93}" dt="2021-02-09T00:31:11.835" v="12" actId="1076"/>
          <ac:spMkLst>
            <pc:docMk/>
            <pc:sldMk cId="1114573650" sldId="646"/>
            <ac:spMk id="14" creationId="{55EB0B41-296F-4FBB-97FF-32249797D0C9}"/>
          </ac:spMkLst>
        </pc:spChg>
        <pc:spChg chg="add del mod">
          <ac:chgData name="Hayk Barseghyan" userId="1af3c995-31f7-415e-9aa1-2b36900e994d" providerId="ADAL" clId="{70A19F8E-9ADD-45E3-8B5D-5634A3FE2C93}" dt="2021-02-09T00:31:11.835" v="12" actId="1076"/>
          <ac:spMkLst>
            <pc:docMk/>
            <pc:sldMk cId="1114573650" sldId="646"/>
            <ac:spMk id="20" creationId="{DC33B53F-C004-4970-B448-8A649B8568F0}"/>
          </ac:spMkLst>
        </pc:spChg>
        <pc:spChg chg="mod">
          <ac:chgData name="Hayk Barseghyan" userId="1af3c995-31f7-415e-9aa1-2b36900e994d" providerId="ADAL" clId="{70A19F8E-9ADD-45E3-8B5D-5634A3FE2C93}" dt="2021-02-09T00:31:11.835" v="12" actId="1076"/>
          <ac:spMkLst>
            <pc:docMk/>
            <pc:sldMk cId="1114573650" sldId="646"/>
            <ac:spMk id="24" creationId="{F62DE925-A59E-4BC8-BE17-4E6DCBBB6D8C}"/>
          </ac:spMkLst>
        </pc:spChg>
        <pc:spChg chg="mod">
          <ac:chgData name="Hayk Barseghyan" userId="1af3c995-31f7-415e-9aa1-2b36900e994d" providerId="ADAL" clId="{70A19F8E-9ADD-45E3-8B5D-5634A3FE2C93}" dt="2021-02-09T00:31:11.835" v="12" actId="1076"/>
          <ac:spMkLst>
            <pc:docMk/>
            <pc:sldMk cId="1114573650" sldId="646"/>
            <ac:spMk id="26" creationId="{5783A8ED-AC57-4198-A523-8EC5D0B8E160}"/>
          </ac:spMkLst>
        </pc:spChg>
        <pc:spChg chg="del">
          <ac:chgData name="Hayk Barseghyan" userId="1af3c995-31f7-415e-9aa1-2b36900e994d" providerId="ADAL" clId="{70A19F8E-9ADD-45E3-8B5D-5634A3FE2C93}" dt="2021-02-09T21:27:21.495" v="231" actId="21"/>
          <ac:spMkLst>
            <pc:docMk/>
            <pc:sldMk cId="1114573650" sldId="646"/>
            <ac:spMk id="28" creationId="{A12D5E6B-10D3-4A67-B506-E321EA47746F}"/>
          </ac:spMkLst>
        </pc:spChg>
        <pc:spChg chg="mod">
          <ac:chgData name="Hayk Barseghyan" userId="1af3c995-31f7-415e-9aa1-2b36900e994d" providerId="ADAL" clId="{70A19F8E-9ADD-45E3-8B5D-5634A3FE2C93}" dt="2021-02-09T00:31:11.835" v="12" actId="1076"/>
          <ac:spMkLst>
            <pc:docMk/>
            <pc:sldMk cId="1114573650" sldId="646"/>
            <ac:spMk id="29" creationId="{DCB53B52-7164-44C2-9AC3-FF010418BA46}"/>
          </ac:spMkLst>
        </pc:spChg>
        <pc:spChg chg="del">
          <ac:chgData name="Hayk Barseghyan" userId="1af3c995-31f7-415e-9aa1-2b36900e994d" providerId="ADAL" clId="{70A19F8E-9ADD-45E3-8B5D-5634A3FE2C93}" dt="2021-02-09T21:27:21.495" v="231" actId="21"/>
          <ac:spMkLst>
            <pc:docMk/>
            <pc:sldMk cId="1114573650" sldId="646"/>
            <ac:spMk id="31" creationId="{837C44B4-2AC9-4472-A78D-BAD61D0A0EC3}"/>
          </ac:spMkLst>
        </pc:spChg>
        <pc:spChg chg="add del">
          <ac:chgData name="Hayk Barseghyan" userId="1af3c995-31f7-415e-9aa1-2b36900e994d" providerId="ADAL" clId="{70A19F8E-9ADD-45E3-8B5D-5634A3FE2C93}" dt="2021-02-09T00:30:25.501" v="6" actId="478"/>
          <ac:spMkLst>
            <pc:docMk/>
            <pc:sldMk cId="1114573650" sldId="646"/>
            <ac:spMk id="33" creationId="{3F5450E2-2C08-4118-B9EC-FCB169DDBFFA}"/>
          </ac:spMkLst>
        </pc:spChg>
        <pc:spChg chg="add mod">
          <ac:chgData name="Hayk Barseghyan" userId="1af3c995-31f7-415e-9aa1-2b36900e994d" providerId="ADAL" clId="{70A19F8E-9ADD-45E3-8B5D-5634A3FE2C93}" dt="2021-02-09T00:30:57.443" v="9" actId="571"/>
          <ac:spMkLst>
            <pc:docMk/>
            <pc:sldMk cId="1114573650" sldId="646"/>
            <ac:spMk id="35" creationId="{B1C36635-823A-4EEA-B5FC-8FAEF01D441E}"/>
          </ac:spMkLst>
        </pc:spChg>
        <pc:spChg chg="add mod">
          <ac:chgData name="Hayk Barseghyan" userId="1af3c995-31f7-415e-9aa1-2b36900e994d" providerId="ADAL" clId="{70A19F8E-9ADD-45E3-8B5D-5634A3FE2C93}" dt="2021-02-09T00:30:57.443" v="9" actId="571"/>
          <ac:spMkLst>
            <pc:docMk/>
            <pc:sldMk cId="1114573650" sldId="646"/>
            <ac:spMk id="37" creationId="{F7F10159-B820-4124-8CB5-4B34C57FAAD6}"/>
          </ac:spMkLst>
        </pc:spChg>
        <pc:spChg chg="add mod">
          <ac:chgData name="Hayk Barseghyan" userId="1af3c995-31f7-415e-9aa1-2b36900e994d" providerId="ADAL" clId="{70A19F8E-9ADD-45E3-8B5D-5634A3FE2C93}" dt="2021-02-09T00:30:57.443" v="9" actId="571"/>
          <ac:spMkLst>
            <pc:docMk/>
            <pc:sldMk cId="1114573650" sldId="646"/>
            <ac:spMk id="39" creationId="{347A0514-66DE-48F0-AE99-E1BB97A2CF2C}"/>
          </ac:spMkLst>
        </pc:spChg>
        <pc:spChg chg="add mod">
          <ac:chgData name="Hayk Barseghyan" userId="1af3c995-31f7-415e-9aa1-2b36900e994d" providerId="ADAL" clId="{70A19F8E-9ADD-45E3-8B5D-5634A3FE2C93}" dt="2021-02-09T00:30:57.443" v="9" actId="571"/>
          <ac:spMkLst>
            <pc:docMk/>
            <pc:sldMk cId="1114573650" sldId="646"/>
            <ac:spMk id="41" creationId="{7438FCAE-09E5-47F0-8954-01A9233C2406}"/>
          </ac:spMkLst>
        </pc:spChg>
        <pc:spChg chg="add mod">
          <ac:chgData name="Hayk Barseghyan" userId="1af3c995-31f7-415e-9aa1-2b36900e994d" providerId="ADAL" clId="{70A19F8E-9ADD-45E3-8B5D-5634A3FE2C93}" dt="2021-02-09T00:30:57.443" v="9" actId="571"/>
          <ac:spMkLst>
            <pc:docMk/>
            <pc:sldMk cId="1114573650" sldId="646"/>
            <ac:spMk id="42" creationId="{0C13CE9B-4230-418A-91E7-107AD0EB68EE}"/>
          </ac:spMkLst>
        </pc:spChg>
        <pc:spChg chg="add mod">
          <ac:chgData name="Hayk Barseghyan" userId="1af3c995-31f7-415e-9aa1-2b36900e994d" providerId="ADAL" clId="{70A19F8E-9ADD-45E3-8B5D-5634A3FE2C93}" dt="2021-02-09T00:30:57.443" v="9" actId="571"/>
          <ac:spMkLst>
            <pc:docMk/>
            <pc:sldMk cId="1114573650" sldId="646"/>
            <ac:spMk id="44" creationId="{D0BD886C-A334-4178-9622-A06FCA4A6743}"/>
          </ac:spMkLst>
        </pc:spChg>
        <pc:picChg chg="add mod">
          <ac:chgData name="Hayk Barseghyan" userId="1af3c995-31f7-415e-9aa1-2b36900e994d" providerId="ADAL" clId="{70A19F8E-9ADD-45E3-8B5D-5634A3FE2C93}" dt="2021-02-09T20:17:54.215" v="50" actId="1076"/>
          <ac:picMkLst>
            <pc:docMk/>
            <pc:sldMk cId="1114573650" sldId="646"/>
            <ac:picMk id="3" creationId="{0921970F-2BD2-472F-9073-A9C9A7020CA2}"/>
          </ac:picMkLst>
        </pc:picChg>
        <pc:picChg chg="mod">
          <ac:chgData name="Hayk Barseghyan" userId="1af3c995-31f7-415e-9aa1-2b36900e994d" providerId="ADAL" clId="{70A19F8E-9ADD-45E3-8B5D-5634A3FE2C93}" dt="2021-02-09T00:32:53.943" v="29" actId="14100"/>
          <ac:picMkLst>
            <pc:docMk/>
            <pc:sldMk cId="1114573650" sldId="646"/>
            <ac:picMk id="4" creationId="{F8824934-F2C1-40C1-81BF-6DA7CF13D970}"/>
          </ac:picMkLst>
        </pc:picChg>
        <pc:picChg chg="add mod">
          <ac:chgData name="Hayk Barseghyan" userId="1af3c995-31f7-415e-9aa1-2b36900e994d" providerId="ADAL" clId="{70A19F8E-9ADD-45E3-8B5D-5634A3FE2C93}" dt="2021-02-09T00:30:57.443" v="9" actId="571"/>
          <ac:picMkLst>
            <pc:docMk/>
            <pc:sldMk cId="1114573650" sldId="646"/>
            <ac:picMk id="32" creationId="{B42DA5AB-5E9F-4F75-B253-5C62E75E597B}"/>
          </ac:picMkLst>
        </pc:picChg>
        <pc:picChg chg="mod">
          <ac:chgData name="Hayk Barseghyan" userId="1af3c995-31f7-415e-9aa1-2b36900e994d" providerId="ADAL" clId="{70A19F8E-9ADD-45E3-8B5D-5634A3FE2C93}" dt="2021-02-09T00:31:11.835" v="12" actId="1076"/>
          <ac:picMkLst>
            <pc:docMk/>
            <pc:sldMk cId="1114573650" sldId="646"/>
            <ac:picMk id="36" creationId="{B8200A9A-6BAD-4FA2-8D5D-EAAB866BE546}"/>
          </ac:picMkLst>
        </pc:picChg>
        <pc:picChg chg="del">
          <ac:chgData name="Hayk Barseghyan" userId="1af3c995-31f7-415e-9aa1-2b36900e994d" providerId="ADAL" clId="{70A19F8E-9ADD-45E3-8B5D-5634A3FE2C93}" dt="2021-02-09T00:30:10.148" v="0" actId="478"/>
          <ac:picMkLst>
            <pc:docMk/>
            <pc:sldMk cId="1114573650" sldId="646"/>
            <ac:picMk id="38" creationId="{CA362049-A0ED-4E8E-98ED-279D2F75D13D}"/>
          </ac:picMkLst>
        </pc:picChg>
        <pc:picChg chg="add del mod">
          <ac:chgData name="Hayk Barseghyan" userId="1af3c995-31f7-415e-9aa1-2b36900e994d" providerId="ADAL" clId="{70A19F8E-9ADD-45E3-8B5D-5634A3FE2C93}" dt="2021-02-09T21:22:52.688" v="192" actId="21"/>
          <ac:picMkLst>
            <pc:docMk/>
            <pc:sldMk cId="1114573650" sldId="646"/>
            <ac:picMk id="46" creationId="{D87738BC-EF4E-4A26-9250-1127278FFEE5}"/>
          </ac:picMkLst>
        </pc:picChg>
        <pc:cxnChg chg="add del">
          <ac:chgData name="Hayk Barseghyan" userId="1af3c995-31f7-415e-9aa1-2b36900e994d" providerId="ADAL" clId="{70A19F8E-9ADD-45E3-8B5D-5634A3FE2C93}" dt="2021-02-09T00:32:23.625" v="24" actId="478"/>
          <ac:cxnSpMkLst>
            <pc:docMk/>
            <pc:sldMk cId="1114573650" sldId="646"/>
            <ac:cxnSpMk id="17" creationId="{F1CA1562-D43F-4A2A-A4BF-3F2B93034AEB}"/>
          </ac:cxnSpMkLst>
        </pc:cxnChg>
        <pc:cxnChg chg="mod">
          <ac:chgData name="Hayk Barseghyan" userId="1af3c995-31f7-415e-9aa1-2b36900e994d" providerId="ADAL" clId="{70A19F8E-9ADD-45E3-8B5D-5634A3FE2C93}" dt="2021-02-09T00:31:11.835" v="12" actId="1076"/>
          <ac:cxnSpMkLst>
            <pc:docMk/>
            <pc:sldMk cId="1114573650" sldId="646"/>
            <ac:cxnSpMk id="19" creationId="{732DCE49-F7F9-4E88-9EA8-BFBA6488315D}"/>
          </ac:cxnSpMkLst>
        </pc:cxnChg>
        <pc:cxnChg chg="add del">
          <ac:chgData name="Hayk Barseghyan" userId="1af3c995-31f7-415e-9aa1-2b36900e994d" providerId="ADAL" clId="{70A19F8E-9ADD-45E3-8B5D-5634A3FE2C93}" dt="2021-02-09T00:30:22.532" v="5" actId="478"/>
          <ac:cxnSpMkLst>
            <pc:docMk/>
            <pc:sldMk cId="1114573650" sldId="646"/>
            <ac:cxnSpMk id="25" creationId="{6E636096-3B77-498A-87D4-5123E45FEFC1}"/>
          </ac:cxnSpMkLst>
        </pc:cxnChg>
        <pc:cxnChg chg="mod">
          <ac:chgData name="Hayk Barseghyan" userId="1af3c995-31f7-415e-9aa1-2b36900e994d" providerId="ADAL" clId="{70A19F8E-9ADD-45E3-8B5D-5634A3FE2C93}" dt="2021-02-09T00:31:11.835" v="12" actId="1076"/>
          <ac:cxnSpMkLst>
            <pc:docMk/>
            <pc:sldMk cId="1114573650" sldId="646"/>
            <ac:cxnSpMk id="27" creationId="{016591D9-C3E7-4F13-B53C-9D6A26AB5143}"/>
          </ac:cxnSpMkLst>
        </pc:cxnChg>
        <pc:cxnChg chg="mod">
          <ac:chgData name="Hayk Barseghyan" userId="1af3c995-31f7-415e-9aa1-2b36900e994d" providerId="ADAL" clId="{70A19F8E-9ADD-45E3-8B5D-5634A3FE2C93}" dt="2021-02-09T00:31:11.835" v="12" actId="1076"/>
          <ac:cxnSpMkLst>
            <pc:docMk/>
            <pc:sldMk cId="1114573650" sldId="646"/>
            <ac:cxnSpMk id="30" creationId="{677CB651-6F1A-4BE8-8A4B-E06CE078B05C}"/>
          </ac:cxnSpMkLst>
        </pc:cxnChg>
        <pc:cxnChg chg="del">
          <ac:chgData name="Hayk Barseghyan" userId="1af3c995-31f7-415e-9aa1-2b36900e994d" providerId="ADAL" clId="{70A19F8E-9ADD-45E3-8B5D-5634A3FE2C93}" dt="2021-02-09T00:31:15.120" v="13" actId="478"/>
          <ac:cxnSpMkLst>
            <pc:docMk/>
            <pc:sldMk cId="1114573650" sldId="646"/>
            <ac:cxnSpMk id="34" creationId="{8D0194B8-4F09-4B1E-926B-3675251AB895}"/>
          </ac:cxnSpMkLst>
        </pc:cxnChg>
        <pc:cxnChg chg="add mod">
          <ac:chgData name="Hayk Barseghyan" userId="1af3c995-31f7-415e-9aa1-2b36900e994d" providerId="ADAL" clId="{70A19F8E-9ADD-45E3-8B5D-5634A3FE2C93}" dt="2021-02-09T00:30:57.443" v="9" actId="571"/>
          <ac:cxnSpMkLst>
            <pc:docMk/>
            <pc:sldMk cId="1114573650" sldId="646"/>
            <ac:cxnSpMk id="40" creationId="{CBD34BC2-C091-4ACE-82F2-C14BE58E7D27}"/>
          </ac:cxnSpMkLst>
        </pc:cxnChg>
        <pc:cxnChg chg="add mod">
          <ac:chgData name="Hayk Barseghyan" userId="1af3c995-31f7-415e-9aa1-2b36900e994d" providerId="ADAL" clId="{70A19F8E-9ADD-45E3-8B5D-5634A3FE2C93}" dt="2021-02-09T00:30:57.443" v="9" actId="571"/>
          <ac:cxnSpMkLst>
            <pc:docMk/>
            <pc:sldMk cId="1114573650" sldId="646"/>
            <ac:cxnSpMk id="43" creationId="{5D88AEBE-C1A2-434D-A9B0-014E59147D45}"/>
          </ac:cxnSpMkLst>
        </pc:cxnChg>
        <pc:cxnChg chg="add mod">
          <ac:chgData name="Hayk Barseghyan" userId="1af3c995-31f7-415e-9aa1-2b36900e994d" providerId="ADAL" clId="{70A19F8E-9ADD-45E3-8B5D-5634A3FE2C93}" dt="2021-02-09T00:30:57.443" v="9" actId="571"/>
          <ac:cxnSpMkLst>
            <pc:docMk/>
            <pc:sldMk cId="1114573650" sldId="646"/>
            <ac:cxnSpMk id="45" creationId="{394FC760-8D8D-4170-B166-280BF3DE99A9}"/>
          </ac:cxnSpMkLst>
        </pc:cxnChg>
      </pc:sldChg>
      <pc:sldChg chg="delSp del mod">
        <pc:chgData name="Hayk Barseghyan" userId="1af3c995-31f7-415e-9aa1-2b36900e994d" providerId="ADAL" clId="{70A19F8E-9ADD-45E3-8B5D-5634A3FE2C93}" dt="2021-02-09T00:33:24.718" v="35" actId="47"/>
        <pc:sldMkLst>
          <pc:docMk/>
          <pc:sldMk cId="2830969817" sldId="647"/>
        </pc:sldMkLst>
        <pc:picChg chg="del">
          <ac:chgData name="Hayk Barseghyan" userId="1af3c995-31f7-415e-9aa1-2b36900e994d" providerId="ADAL" clId="{70A19F8E-9ADD-45E3-8B5D-5634A3FE2C93}" dt="2021-02-09T00:31:53.796" v="21" actId="21"/>
          <ac:picMkLst>
            <pc:docMk/>
            <pc:sldMk cId="2830969817" sldId="647"/>
            <ac:picMk id="4" creationId="{83E0E0FB-31C1-4632-9616-6C3C8C3CA9F6}"/>
          </ac:picMkLst>
        </pc:picChg>
        <pc:picChg chg="del">
          <ac:chgData name="Hayk Barseghyan" userId="1af3c995-31f7-415e-9aa1-2b36900e994d" providerId="ADAL" clId="{70A19F8E-9ADD-45E3-8B5D-5634A3FE2C93}" dt="2021-02-09T00:31:51.263" v="20" actId="478"/>
          <ac:picMkLst>
            <pc:docMk/>
            <pc:sldMk cId="2830969817" sldId="647"/>
            <ac:picMk id="5" creationId="{F39D0EB7-9FD9-4EE0-8A7B-748FD593ED96}"/>
          </ac:picMkLst>
        </pc:picChg>
      </pc:sldChg>
      <pc:sldChg chg="modSp mod ord">
        <pc:chgData name="Hayk Barseghyan" userId="1af3c995-31f7-415e-9aa1-2b36900e994d" providerId="ADAL" clId="{70A19F8E-9ADD-45E3-8B5D-5634A3FE2C93}" dt="2021-02-09T21:30:37.643" v="239"/>
        <pc:sldMkLst>
          <pc:docMk/>
          <pc:sldMk cId="3868126251" sldId="648"/>
        </pc:sldMkLst>
        <pc:picChg chg="mod">
          <ac:chgData name="Hayk Barseghyan" userId="1af3c995-31f7-415e-9aa1-2b36900e994d" providerId="ADAL" clId="{70A19F8E-9ADD-45E3-8B5D-5634A3FE2C93}" dt="2021-02-09T20:02:33.690" v="45" actId="1076"/>
          <ac:picMkLst>
            <pc:docMk/>
            <pc:sldMk cId="3868126251" sldId="648"/>
            <ac:picMk id="2" creationId="{44662BBE-6899-4B54-8430-6FDA2B55B48C}"/>
          </ac:picMkLst>
        </pc:picChg>
      </pc:sldChg>
      <pc:sldChg chg="addSp delSp modSp new del mod">
        <pc:chgData name="Hayk Barseghyan" userId="1af3c995-31f7-415e-9aa1-2b36900e994d" providerId="ADAL" clId="{70A19F8E-9ADD-45E3-8B5D-5634A3FE2C93}" dt="2021-02-09T21:13:27.235" v="86" actId="47"/>
        <pc:sldMkLst>
          <pc:docMk/>
          <pc:sldMk cId="2922904709" sldId="649"/>
        </pc:sldMkLst>
        <pc:picChg chg="add mod">
          <ac:chgData name="Hayk Barseghyan" userId="1af3c995-31f7-415e-9aa1-2b36900e994d" providerId="ADAL" clId="{70A19F8E-9ADD-45E3-8B5D-5634A3FE2C93}" dt="2021-02-09T20:01:45.173" v="40" actId="1076"/>
          <ac:picMkLst>
            <pc:docMk/>
            <pc:sldMk cId="2922904709" sldId="649"/>
            <ac:picMk id="2" creationId="{40BD256A-8FE4-44E6-9F61-D9AAFDE00166}"/>
          </ac:picMkLst>
        </pc:picChg>
        <pc:picChg chg="add del mod">
          <ac:chgData name="Hayk Barseghyan" userId="1af3c995-31f7-415e-9aa1-2b36900e994d" providerId="ADAL" clId="{70A19F8E-9ADD-45E3-8B5D-5634A3FE2C93}" dt="2021-02-09T20:02:27.477" v="44" actId="478"/>
          <ac:picMkLst>
            <pc:docMk/>
            <pc:sldMk cId="2922904709" sldId="649"/>
            <ac:picMk id="3" creationId="{F4CED0EB-47D1-4B60-9CC0-370319DE4C9E}"/>
          </ac:picMkLst>
        </pc:picChg>
      </pc:sldChg>
      <pc:sldChg chg="add del">
        <pc:chgData name="Hayk Barseghyan" userId="1af3c995-31f7-415e-9aa1-2b36900e994d" providerId="ADAL" clId="{70A19F8E-9ADD-45E3-8B5D-5634A3FE2C93}" dt="2021-02-09T20:43:46.741" v="73" actId="47"/>
        <pc:sldMkLst>
          <pc:docMk/>
          <pc:sldMk cId="2212278529" sldId="650"/>
        </pc:sldMkLst>
      </pc:sldChg>
      <pc:sldChg chg="addSp delSp modSp add mod">
        <pc:chgData name="Hayk Barseghyan" userId="1af3c995-31f7-415e-9aa1-2b36900e994d" providerId="ADAL" clId="{70A19F8E-9ADD-45E3-8B5D-5634A3FE2C93}" dt="2021-02-11T01:21:14.329" v="1312" actId="1076"/>
        <pc:sldMkLst>
          <pc:docMk/>
          <pc:sldMk cId="524483127" sldId="651"/>
        </pc:sldMkLst>
        <pc:spChg chg="add del mod">
          <ac:chgData name="Hayk Barseghyan" userId="1af3c995-31f7-415e-9aa1-2b36900e994d" providerId="ADAL" clId="{70A19F8E-9ADD-45E3-8B5D-5634A3FE2C93}" dt="2021-02-09T21:19:57.857" v="141" actId="478"/>
          <ac:spMkLst>
            <pc:docMk/>
            <pc:sldMk cId="524483127" sldId="651"/>
            <ac:spMk id="8" creationId="{C679A925-52DB-4BB7-ACD5-341BE23BFC23}"/>
          </ac:spMkLst>
        </pc:spChg>
        <pc:spChg chg="add mod">
          <ac:chgData name="Hayk Barseghyan" userId="1af3c995-31f7-415e-9aa1-2b36900e994d" providerId="ADAL" clId="{70A19F8E-9ADD-45E3-8B5D-5634A3FE2C93}" dt="2021-02-09T21:26:31.363" v="227" actId="1076"/>
          <ac:spMkLst>
            <pc:docMk/>
            <pc:sldMk cId="524483127" sldId="651"/>
            <ac:spMk id="9" creationId="{FAEB7540-E1AA-4AA8-8E2D-B822141FCC75}"/>
          </ac:spMkLst>
        </pc:spChg>
        <pc:spChg chg="add mod">
          <ac:chgData name="Hayk Barseghyan" userId="1af3c995-31f7-415e-9aa1-2b36900e994d" providerId="ADAL" clId="{70A19F8E-9ADD-45E3-8B5D-5634A3FE2C93}" dt="2021-02-09T21:20:11.258" v="164" actId="1036"/>
          <ac:spMkLst>
            <pc:docMk/>
            <pc:sldMk cId="524483127" sldId="651"/>
            <ac:spMk id="15" creationId="{1DA809E1-700B-4B5F-80D1-146841C532CC}"/>
          </ac:spMkLst>
        </pc:spChg>
        <pc:spChg chg="add mod">
          <ac:chgData name="Hayk Barseghyan" userId="1af3c995-31f7-415e-9aa1-2b36900e994d" providerId="ADAL" clId="{70A19F8E-9ADD-45E3-8B5D-5634A3FE2C93}" dt="2021-02-09T21:20:11.258" v="164" actId="1036"/>
          <ac:spMkLst>
            <pc:docMk/>
            <pc:sldMk cId="524483127" sldId="651"/>
            <ac:spMk id="16" creationId="{219D3844-749C-4AC5-8AAC-A5A6E4F706D5}"/>
          </ac:spMkLst>
        </pc:spChg>
        <pc:spChg chg="add mod">
          <ac:chgData name="Hayk Barseghyan" userId="1af3c995-31f7-415e-9aa1-2b36900e994d" providerId="ADAL" clId="{70A19F8E-9ADD-45E3-8B5D-5634A3FE2C93}" dt="2021-02-09T21:20:11.258" v="164" actId="1036"/>
          <ac:spMkLst>
            <pc:docMk/>
            <pc:sldMk cId="524483127" sldId="651"/>
            <ac:spMk id="17" creationId="{238D452B-545B-49D2-9AA5-4774F789BA52}"/>
          </ac:spMkLst>
        </pc:spChg>
        <pc:spChg chg="add mod">
          <ac:chgData name="Hayk Barseghyan" userId="1af3c995-31f7-415e-9aa1-2b36900e994d" providerId="ADAL" clId="{70A19F8E-9ADD-45E3-8B5D-5634A3FE2C93}" dt="2021-02-09T21:20:11.258" v="164" actId="1036"/>
          <ac:spMkLst>
            <pc:docMk/>
            <pc:sldMk cId="524483127" sldId="651"/>
            <ac:spMk id="18" creationId="{3B330CDD-DF8E-4329-9F8F-0C05A3EBA278}"/>
          </ac:spMkLst>
        </pc:spChg>
        <pc:spChg chg="add mod">
          <ac:chgData name="Hayk Barseghyan" userId="1af3c995-31f7-415e-9aa1-2b36900e994d" providerId="ADAL" clId="{70A19F8E-9ADD-45E3-8B5D-5634A3FE2C93}" dt="2021-02-09T21:20:11.258" v="164" actId="1036"/>
          <ac:spMkLst>
            <pc:docMk/>
            <pc:sldMk cId="524483127" sldId="651"/>
            <ac:spMk id="19" creationId="{92E3FBB9-4482-4901-BB7B-515414A60BF3}"/>
          </ac:spMkLst>
        </pc:spChg>
        <pc:spChg chg="add mod">
          <ac:chgData name="Hayk Barseghyan" userId="1af3c995-31f7-415e-9aa1-2b36900e994d" providerId="ADAL" clId="{70A19F8E-9ADD-45E3-8B5D-5634A3FE2C93}" dt="2021-02-09T21:20:11.258" v="164" actId="1036"/>
          <ac:spMkLst>
            <pc:docMk/>
            <pc:sldMk cId="524483127" sldId="651"/>
            <ac:spMk id="20" creationId="{33617DAE-E7EA-4947-A705-85255111007E}"/>
          </ac:spMkLst>
        </pc:spChg>
        <pc:spChg chg="add mod">
          <ac:chgData name="Hayk Barseghyan" userId="1af3c995-31f7-415e-9aa1-2b36900e994d" providerId="ADAL" clId="{70A19F8E-9ADD-45E3-8B5D-5634A3FE2C93}" dt="2021-02-09T21:20:11.258" v="164" actId="1036"/>
          <ac:spMkLst>
            <pc:docMk/>
            <pc:sldMk cId="524483127" sldId="651"/>
            <ac:spMk id="21" creationId="{C9A0FE9C-502B-4BBD-8A60-74F846E3930A}"/>
          </ac:spMkLst>
        </pc:spChg>
        <pc:spChg chg="add mod">
          <ac:chgData name="Hayk Barseghyan" userId="1af3c995-31f7-415e-9aa1-2b36900e994d" providerId="ADAL" clId="{70A19F8E-9ADD-45E3-8B5D-5634A3FE2C93}" dt="2021-02-09T21:20:11.258" v="164" actId="1036"/>
          <ac:spMkLst>
            <pc:docMk/>
            <pc:sldMk cId="524483127" sldId="651"/>
            <ac:spMk id="22" creationId="{097F0FB6-DB3D-4B12-9E76-180A15D9B845}"/>
          </ac:spMkLst>
        </pc:spChg>
        <pc:spChg chg="add mod">
          <ac:chgData name="Hayk Barseghyan" userId="1af3c995-31f7-415e-9aa1-2b36900e994d" providerId="ADAL" clId="{70A19F8E-9ADD-45E3-8B5D-5634A3FE2C93}" dt="2021-02-09T23:42:52.679" v="392" actId="20577"/>
          <ac:spMkLst>
            <pc:docMk/>
            <pc:sldMk cId="524483127" sldId="651"/>
            <ac:spMk id="28" creationId="{627423C8-B194-4935-85FA-5ED8C3D13EA3}"/>
          </ac:spMkLst>
        </pc:spChg>
        <pc:spChg chg="add del mod">
          <ac:chgData name="Hayk Barseghyan" userId="1af3c995-31f7-415e-9aa1-2b36900e994d" providerId="ADAL" clId="{70A19F8E-9ADD-45E3-8B5D-5634A3FE2C93}" dt="2021-02-09T21:20:03.248" v="142" actId="478"/>
          <ac:spMkLst>
            <pc:docMk/>
            <pc:sldMk cId="524483127" sldId="651"/>
            <ac:spMk id="29" creationId="{607C274E-B280-4572-A871-4EF5ECE80286}"/>
          </ac:spMkLst>
        </pc:spChg>
        <pc:spChg chg="add mod">
          <ac:chgData name="Hayk Barseghyan" userId="1af3c995-31f7-415e-9aa1-2b36900e994d" providerId="ADAL" clId="{70A19F8E-9ADD-45E3-8B5D-5634A3FE2C93}" dt="2021-02-09T23:42:55.244" v="394" actId="20577"/>
          <ac:spMkLst>
            <pc:docMk/>
            <pc:sldMk cId="524483127" sldId="651"/>
            <ac:spMk id="30" creationId="{68ED1E75-B125-4C10-BB29-81E202553B2C}"/>
          </ac:spMkLst>
        </pc:spChg>
        <pc:spChg chg="add mod">
          <ac:chgData name="Hayk Barseghyan" userId="1af3c995-31f7-415e-9aa1-2b36900e994d" providerId="ADAL" clId="{70A19F8E-9ADD-45E3-8B5D-5634A3FE2C93}" dt="2021-02-11T01:21:02.069" v="1309" actId="20577"/>
          <ac:spMkLst>
            <pc:docMk/>
            <pc:sldMk cId="524483127" sldId="651"/>
            <ac:spMk id="31" creationId="{831FD28B-6273-4CCE-B35E-843034652E14}"/>
          </ac:spMkLst>
        </pc:spChg>
        <pc:spChg chg="add del mod">
          <ac:chgData name="Hayk Barseghyan" userId="1af3c995-31f7-415e-9aa1-2b36900e994d" providerId="ADAL" clId="{70A19F8E-9ADD-45E3-8B5D-5634A3FE2C93}" dt="2021-02-10T00:56:31.715" v="799" actId="478"/>
          <ac:spMkLst>
            <pc:docMk/>
            <pc:sldMk cId="524483127" sldId="651"/>
            <ac:spMk id="31" creationId="{85DF863F-2BCD-44E2-B1C2-A1A04810460A}"/>
          </ac:spMkLst>
        </pc:spChg>
        <pc:spChg chg="add mod">
          <ac:chgData name="Hayk Barseghyan" userId="1af3c995-31f7-415e-9aa1-2b36900e994d" providerId="ADAL" clId="{70A19F8E-9ADD-45E3-8B5D-5634A3FE2C93}" dt="2021-02-11T01:21:14.329" v="1312" actId="1076"/>
          <ac:spMkLst>
            <pc:docMk/>
            <pc:sldMk cId="524483127" sldId="651"/>
            <ac:spMk id="32" creationId="{3C8C9310-67BF-4B6E-89F4-3CEC1EC49D05}"/>
          </ac:spMkLst>
        </pc:spChg>
        <pc:spChg chg="add del mod">
          <ac:chgData name="Hayk Barseghyan" userId="1af3c995-31f7-415e-9aa1-2b36900e994d" providerId="ADAL" clId="{70A19F8E-9ADD-45E3-8B5D-5634A3FE2C93}" dt="2021-02-10T00:56:31.715" v="799" actId="478"/>
          <ac:spMkLst>
            <pc:docMk/>
            <pc:sldMk cId="524483127" sldId="651"/>
            <ac:spMk id="32" creationId="{A43E28E5-3F33-464E-A48E-76E863F54969}"/>
          </ac:spMkLst>
        </pc:spChg>
        <pc:spChg chg="add del mod ord">
          <ac:chgData name="Hayk Barseghyan" userId="1af3c995-31f7-415e-9aa1-2b36900e994d" providerId="ADAL" clId="{70A19F8E-9ADD-45E3-8B5D-5634A3FE2C93}" dt="2021-02-10T00:56:34.790" v="800" actId="478"/>
          <ac:spMkLst>
            <pc:docMk/>
            <pc:sldMk cId="524483127" sldId="651"/>
            <ac:spMk id="33" creationId="{C592B722-755B-4A29-A4CA-7571AE17BEEE}"/>
          </ac:spMkLst>
        </pc:spChg>
        <pc:spChg chg="add del mod ord">
          <ac:chgData name="Hayk Barseghyan" userId="1af3c995-31f7-415e-9aa1-2b36900e994d" providerId="ADAL" clId="{70A19F8E-9ADD-45E3-8B5D-5634A3FE2C93}" dt="2021-02-10T00:56:34.790" v="800" actId="478"/>
          <ac:spMkLst>
            <pc:docMk/>
            <pc:sldMk cId="524483127" sldId="651"/>
            <ac:spMk id="34" creationId="{B4982F10-38F2-41B4-95DB-97A3A9973771}"/>
          </ac:spMkLst>
        </pc:spChg>
        <pc:spChg chg="add mod">
          <ac:chgData name="Hayk Barseghyan" userId="1af3c995-31f7-415e-9aa1-2b36900e994d" providerId="ADAL" clId="{70A19F8E-9ADD-45E3-8B5D-5634A3FE2C93}" dt="2021-02-09T21:24:36.935" v="208" actId="688"/>
          <ac:spMkLst>
            <pc:docMk/>
            <pc:sldMk cId="524483127" sldId="651"/>
            <ac:spMk id="48" creationId="{7DECEAD3-1F4B-4349-B3E1-EC2281C752C7}"/>
          </ac:spMkLst>
        </pc:spChg>
        <pc:spChg chg="add mod">
          <ac:chgData name="Hayk Barseghyan" userId="1af3c995-31f7-415e-9aa1-2b36900e994d" providerId="ADAL" clId="{70A19F8E-9ADD-45E3-8B5D-5634A3FE2C93}" dt="2021-02-09T21:27:31.484" v="235" actId="1076"/>
          <ac:spMkLst>
            <pc:docMk/>
            <pc:sldMk cId="524483127" sldId="651"/>
            <ac:spMk id="58" creationId="{C7E49091-0ACC-4142-9B93-9F0BE2716A65}"/>
          </ac:spMkLst>
        </pc:spChg>
        <pc:spChg chg="add mod">
          <ac:chgData name="Hayk Barseghyan" userId="1af3c995-31f7-415e-9aa1-2b36900e994d" providerId="ADAL" clId="{70A19F8E-9ADD-45E3-8B5D-5634A3FE2C93}" dt="2021-02-09T21:27:35.479" v="236" actId="1076"/>
          <ac:spMkLst>
            <pc:docMk/>
            <pc:sldMk cId="524483127" sldId="651"/>
            <ac:spMk id="59" creationId="{D1E7461A-0DE2-46AC-9A6B-AD21D7804CB3}"/>
          </ac:spMkLst>
        </pc:spChg>
        <pc:picChg chg="del mod">
          <ac:chgData name="Hayk Barseghyan" userId="1af3c995-31f7-415e-9aa1-2b36900e994d" providerId="ADAL" clId="{70A19F8E-9ADD-45E3-8B5D-5634A3FE2C93}" dt="2021-02-09T21:13:26.336" v="85" actId="478"/>
          <ac:picMkLst>
            <pc:docMk/>
            <pc:sldMk cId="524483127" sldId="651"/>
            <ac:picMk id="2" creationId="{40BD256A-8FE4-44E6-9F61-D9AAFDE00166}"/>
          </ac:picMkLst>
        </pc:picChg>
        <pc:picChg chg="add del mod">
          <ac:chgData name="Hayk Barseghyan" userId="1af3c995-31f7-415e-9aa1-2b36900e994d" providerId="ADAL" clId="{70A19F8E-9ADD-45E3-8B5D-5634A3FE2C93}" dt="2021-02-09T21:14:06.998" v="94" actId="21"/>
          <ac:picMkLst>
            <pc:docMk/>
            <pc:sldMk cId="524483127" sldId="651"/>
            <ac:picMk id="3" creationId="{0249E553-E42A-4CA6-9DCB-C0981861851B}"/>
          </ac:picMkLst>
        </pc:picChg>
        <pc:picChg chg="add del mod">
          <ac:chgData name="Hayk Barseghyan" userId="1af3c995-31f7-415e-9aa1-2b36900e994d" providerId="ADAL" clId="{70A19F8E-9ADD-45E3-8B5D-5634A3FE2C93}" dt="2021-02-09T21:14:06.998" v="94" actId="21"/>
          <ac:picMkLst>
            <pc:docMk/>
            <pc:sldMk cId="524483127" sldId="651"/>
            <ac:picMk id="4" creationId="{799A2022-B3E2-4627-B5A7-AC6AD86E3FCD}"/>
          </ac:picMkLst>
        </pc:picChg>
        <pc:picChg chg="add del mod">
          <ac:chgData name="Hayk Barseghyan" userId="1af3c995-31f7-415e-9aa1-2b36900e994d" providerId="ADAL" clId="{70A19F8E-9ADD-45E3-8B5D-5634A3FE2C93}" dt="2021-02-09T21:17:36.564" v="122" actId="478"/>
          <ac:picMkLst>
            <pc:docMk/>
            <pc:sldMk cId="524483127" sldId="651"/>
            <ac:picMk id="5" creationId="{62C3D30D-9F9C-47E4-B8A4-4ED76F544E95}"/>
          </ac:picMkLst>
        </pc:picChg>
        <pc:picChg chg="add del mod">
          <ac:chgData name="Hayk Barseghyan" userId="1af3c995-31f7-415e-9aa1-2b36900e994d" providerId="ADAL" clId="{70A19F8E-9ADD-45E3-8B5D-5634A3FE2C93}" dt="2021-02-09T21:19:49.789" v="138" actId="478"/>
          <ac:picMkLst>
            <pc:docMk/>
            <pc:sldMk cId="524483127" sldId="651"/>
            <ac:picMk id="6" creationId="{0F7C4E39-9047-4299-AD9C-F97E31CB9E8A}"/>
          </ac:picMkLst>
        </pc:picChg>
        <pc:picChg chg="add del mod">
          <ac:chgData name="Hayk Barseghyan" userId="1af3c995-31f7-415e-9aa1-2b36900e994d" providerId="ADAL" clId="{70A19F8E-9ADD-45E3-8B5D-5634A3FE2C93}" dt="2021-02-09T21:21:27.116" v="176" actId="478"/>
          <ac:picMkLst>
            <pc:docMk/>
            <pc:sldMk cId="524483127" sldId="651"/>
            <ac:picMk id="7" creationId="{15F43BE9-852D-4AFD-BCB3-EECD83510366}"/>
          </ac:picMkLst>
        </pc:picChg>
        <pc:picChg chg="add mod">
          <ac:chgData name="Hayk Barseghyan" userId="1af3c995-31f7-415e-9aa1-2b36900e994d" providerId="ADAL" clId="{70A19F8E-9ADD-45E3-8B5D-5634A3FE2C93}" dt="2021-02-09T21:20:11.258" v="164" actId="1036"/>
          <ac:picMkLst>
            <pc:docMk/>
            <pc:sldMk cId="524483127" sldId="651"/>
            <ac:picMk id="14" creationId="{BD596D5A-A8B5-4F23-971B-B0033B030440}"/>
          </ac:picMkLst>
        </pc:picChg>
        <pc:picChg chg="add mod ord">
          <ac:chgData name="Hayk Barseghyan" userId="1af3c995-31f7-415e-9aa1-2b36900e994d" providerId="ADAL" clId="{70A19F8E-9ADD-45E3-8B5D-5634A3FE2C93}" dt="2021-02-11T01:20:05.362" v="1297" actId="1076"/>
          <ac:picMkLst>
            <pc:docMk/>
            <pc:sldMk cId="524483127" sldId="651"/>
            <ac:picMk id="35" creationId="{66FD96DE-C6EB-4683-ADCB-50E7FBA9AAF3}"/>
          </ac:picMkLst>
        </pc:picChg>
        <pc:picChg chg="add mod">
          <ac:chgData name="Hayk Barseghyan" userId="1af3c995-31f7-415e-9aa1-2b36900e994d" providerId="ADAL" clId="{70A19F8E-9ADD-45E3-8B5D-5634A3FE2C93}" dt="2021-02-09T23:21:42.016" v="357" actId="2085"/>
          <ac:picMkLst>
            <pc:docMk/>
            <pc:sldMk cId="524483127" sldId="651"/>
            <ac:picMk id="36" creationId="{E9E5B046-D97F-4288-AA74-79294CC4F6EE}"/>
          </ac:picMkLst>
        </pc:picChg>
        <pc:picChg chg="add mod ord">
          <ac:chgData name="Hayk Barseghyan" userId="1af3c995-31f7-415e-9aa1-2b36900e994d" providerId="ADAL" clId="{70A19F8E-9ADD-45E3-8B5D-5634A3FE2C93}" dt="2021-02-09T21:25:38.826" v="218" actId="167"/>
          <ac:picMkLst>
            <pc:docMk/>
            <pc:sldMk cId="524483127" sldId="651"/>
            <ac:picMk id="43" creationId="{4F5972F7-3200-4EE7-BF84-33C378BBBBBB}"/>
          </ac:picMkLst>
        </pc:picChg>
        <pc:picChg chg="add mod">
          <ac:chgData name="Hayk Barseghyan" userId="1af3c995-31f7-415e-9aa1-2b36900e994d" providerId="ADAL" clId="{70A19F8E-9ADD-45E3-8B5D-5634A3FE2C93}" dt="2021-02-09T21:25:23.842" v="216" actId="1076"/>
          <ac:picMkLst>
            <pc:docMk/>
            <pc:sldMk cId="524483127" sldId="651"/>
            <ac:picMk id="55" creationId="{3292E05B-B4A2-4F12-88CC-882830945CA9}"/>
          </ac:picMkLst>
        </pc:picChg>
        <pc:cxnChg chg="add del mod">
          <ac:chgData name="Hayk Barseghyan" userId="1af3c995-31f7-415e-9aa1-2b36900e994d" providerId="ADAL" clId="{70A19F8E-9ADD-45E3-8B5D-5634A3FE2C93}" dt="2021-02-09T21:19:53.672" v="140" actId="478"/>
          <ac:cxnSpMkLst>
            <pc:docMk/>
            <pc:sldMk cId="524483127" sldId="651"/>
            <ac:cxnSpMk id="10" creationId="{9F4A69BA-DEBE-47A2-B156-4E034D3CFFBF}"/>
          </ac:cxnSpMkLst>
        </pc:cxnChg>
        <pc:cxnChg chg="add del mod">
          <ac:chgData name="Hayk Barseghyan" userId="1af3c995-31f7-415e-9aa1-2b36900e994d" providerId="ADAL" clId="{70A19F8E-9ADD-45E3-8B5D-5634A3FE2C93}" dt="2021-02-09T21:19:52.426" v="139" actId="478"/>
          <ac:cxnSpMkLst>
            <pc:docMk/>
            <pc:sldMk cId="524483127" sldId="651"/>
            <ac:cxnSpMk id="11" creationId="{9A8ECCA5-4262-460C-BB89-DA6D02619CD7}"/>
          </ac:cxnSpMkLst>
        </pc:cxnChg>
        <pc:cxnChg chg="add mod">
          <ac:chgData name="Hayk Barseghyan" userId="1af3c995-31f7-415e-9aa1-2b36900e994d" providerId="ADAL" clId="{70A19F8E-9ADD-45E3-8B5D-5634A3FE2C93}" dt="2021-02-09T21:26:31.363" v="227" actId="1076"/>
          <ac:cxnSpMkLst>
            <pc:docMk/>
            <pc:sldMk cId="524483127" sldId="651"/>
            <ac:cxnSpMk id="12" creationId="{77BFB2D3-AD99-4A46-A69B-5F7DA3AE9F40}"/>
          </ac:cxnSpMkLst>
        </pc:cxnChg>
        <pc:cxnChg chg="add mod">
          <ac:chgData name="Hayk Barseghyan" userId="1af3c995-31f7-415e-9aa1-2b36900e994d" providerId="ADAL" clId="{70A19F8E-9ADD-45E3-8B5D-5634A3FE2C93}" dt="2021-02-09T21:26:31.363" v="227" actId="1076"/>
          <ac:cxnSpMkLst>
            <pc:docMk/>
            <pc:sldMk cId="524483127" sldId="651"/>
            <ac:cxnSpMk id="13" creationId="{9C5A0F15-52CF-47D7-9374-8C8C2F340DD2}"/>
          </ac:cxnSpMkLst>
        </pc:cxnChg>
        <pc:cxnChg chg="add mod">
          <ac:chgData name="Hayk Barseghyan" userId="1af3c995-31f7-415e-9aa1-2b36900e994d" providerId="ADAL" clId="{70A19F8E-9ADD-45E3-8B5D-5634A3FE2C93}" dt="2021-02-09T21:20:11.258" v="164" actId="1036"/>
          <ac:cxnSpMkLst>
            <pc:docMk/>
            <pc:sldMk cId="524483127" sldId="651"/>
            <ac:cxnSpMk id="23" creationId="{B97A16ED-5542-4DD1-94CA-D032D3F72196}"/>
          </ac:cxnSpMkLst>
        </pc:cxnChg>
        <pc:cxnChg chg="add mod">
          <ac:chgData name="Hayk Barseghyan" userId="1af3c995-31f7-415e-9aa1-2b36900e994d" providerId="ADAL" clId="{70A19F8E-9ADD-45E3-8B5D-5634A3FE2C93}" dt="2021-02-09T21:20:11.258" v="164" actId="1036"/>
          <ac:cxnSpMkLst>
            <pc:docMk/>
            <pc:sldMk cId="524483127" sldId="651"/>
            <ac:cxnSpMk id="24" creationId="{792D8F66-E748-410F-BB9B-B632B254BDFB}"/>
          </ac:cxnSpMkLst>
        </pc:cxnChg>
        <pc:cxnChg chg="add mod">
          <ac:chgData name="Hayk Barseghyan" userId="1af3c995-31f7-415e-9aa1-2b36900e994d" providerId="ADAL" clId="{70A19F8E-9ADD-45E3-8B5D-5634A3FE2C93}" dt="2021-02-09T21:20:11.258" v="164" actId="1036"/>
          <ac:cxnSpMkLst>
            <pc:docMk/>
            <pc:sldMk cId="524483127" sldId="651"/>
            <ac:cxnSpMk id="25" creationId="{A4F48631-3605-414B-96A3-B4E7701F3903}"/>
          </ac:cxnSpMkLst>
        </pc:cxnChg>
        <pc:cxnChg chg="add mod">
          <ac:chgData name="Hayk Barseghyan" userId="1af3c995-31f7-415e-9aa1-2b36900e994d" providerId="ADAL" clId="{70A19F8E-9ADD-45E3-8B5D-5634A3FE2C93}" dt="2021-02-09T21:20:11.258" v="164" actId="1036"/>
          <ac:cxnSpMkLst>
            <pc:docMk/>
            <pc:sldMk cId="524483127" sldId="651"/>
            <ac:cxnSpMk id="26" creationId="{251C4E22-4DE1-42F8-831F-C59D805817CB}"/>
          </ac:cxnSpMkLst>
        </pc:cxnChg>
        <pc:cxnChg chg="add mod">
          <ac:chgData name="Hayk Barseghyan" userId="1af3c995-31f7-415e-9aa1-2b36900e994d" providerId="ADAL" clId="{70A19F8E-9ADD-45E3-8B5D-5634A3FE2C93}" dt="2021-02-09T21:20:11.258" v="164" actId="1036"/>
          <ac:cxnSpMkLst>
            <pc:docMk/>
            <pc:sldMk cId="524483127" sldId="651"/>
            <ac:cxnSpMk id="27" creationId="{3A04AB6E-BA74-4664-AB00-DE51EF69DC08}"/>
          </ac:cxnSpMkLst>
        </pc:cxnChg>
        <pc:cxnChg chg="add mod">
          <ac:chgData name="Hayk Barseghyan" userId="1af3c995-31f7-415e-9aa1-2b36900e994d" providerId="ADAL" clId="{70A19F8E-9ADD-45E3-8B5D-5634A3FE2C93}" dt="2021-02-09T21:26:48.428" v="230" actId="14100"/>
          <ac:cxnSpMkLst>
            <pc:docMk/>
            <pc:sldMk cId="524483127" sldId="651"/>
            <ac:cxnSpMk id="49" creationId="{4423681D-AADF-4D62-AC9E-3FDDF18E21B9}"/>
          </ac:cxnSpMkLst>
        </pc:cxnChg>
        <pc:cxnChg chg="add mod">
          <ac:chgData name="Hayk Barseghyan" userId="1af3c995-31f7-415e-9aa1-2b36900e994d" providerId="ADAL" clId="{70A19F8E-9ADD-45E3-8B5D-5634A3FE2C93}" dt="2021-02-09T21:26:44.283" v="229" actId="14100"/>
          <ac:cxnSpMkLst>
            <pc:docMk/>
            <pc:sldMk cId="524483127" sldId="651"/>
            <ac:cxnSpMk id="52" creationId="{67E81840-D31A-48DD-9275-CD08F7D6F031}"/>
          </ac:cxnSpMkLst>
        </pc:cxnChg>
      </pc:sldChg>
      <pc:sldChg chg="addSp delSp modSp add mod ord">
        <pc:chgData name="Hayk Barseghyan" userId="1af3c995-31f7-415e-9aa1-2b36900e994d" providerId="ADAL" clId="{70A19F8E-9ADD-45E3-8B5D-5634A3FE2C93}" dt="2021-02-10T01:13:32.649" v="927" actId="165"/>
        <pc:sldMkLst>
          <pc:docMk/>
          <pc:sldMk cId="779035963" sldId="652"/>
        </pc:sldMkLst>
        <pc:spChg chg="add del mod">
          <ac:chgData name="Hayk Barseghyan" userId="1af3c995-31f7-415e-9aa1-2b36900e994d" providerId="ADAL" clId="{70A19F8E-9ADD-45E3-8B5D-5634A3FE2C93}" dt="2021-02-09T23:42:19.856" v="384" actId="21"/>
          <ac:spMkLst>
            <pc:docMk/>
            <pc:sldMk cId="779035963" sldId="652"/>
            <ac:spMk id="12" creationId="{192C500F-D30A-43C6-B402-03D63B6889FE}"/>
          </ac:spMkLst>
        </pc:spChg>
        <pc:grpChg chg="add del mod">
          <ac:chgData name="Hayk Barseghyan" userId="1af3c995-31f7-415e-9aa1-2b36900e994d" providerId="ADAL" clId="{70A19F8E-9ADD-45E3-8B5D-5634A3FE2C93}" dt="2021-02-09T23:40:08.263" v="363" actId="165"/>
          <ac:grpSpMkLst>
            <pc:docMk/>
            <pc:sldMk cId="779035963" sldId="652"/>
            <ac:grpSpMk id="9" creationId="{234A4397-E559-4994-BFCF-C605E7F5192D}"/>
          </ac:grpSpMkLst>
        </pc:grpChg>
        <pc:grpChg chg="add del mod">
          <ac:chgData name="Hayk Barseghyan" userId="1af3c995-31f7-415e-9aa1-2b36900e994d" providerId="ADAL" clId="{70A19F8E-9ADD-45E3-8B5D-5634A3FE2C93}" dt="2021-02-10T01:13:32.649" v="927" actId="165"/>
          <ac:grpSpMkLst>
            <pc:docMk/>
            <pc:sldMk cId="779035963" sldId="652"/>
            <ac:grpSpMk id="13" creationId="{6A4A6CE2-B1A4-490E-9AC0-C63C634B7473}"/>
          </ac:grpSpMkLst>
        </pc:grpChg>
        <pc:picChg chg="del">
          <ac:chgData name="Hayk Barseghyan" userId="1af3c995-31f7-415e-9aa1-2b36900e994d" providerId="ADAL" clId="{70A19F8E-9ADD-45E3-8B5D-5634A3FE2C93}" dt="2021-02-09T21:14:01.663" v="93" actId="478"/>
          <ac:picMkLst>
            <pc:docMk/>
            <pc:sldMk cId="779035963" sldId="652"/>
            <ac:picMk id="2" creationId="{44662BBE-6899-4B54-8430-6FDA2B55B48C}"/>
          </ac:picMkLst>
        </pc:picChg>
        <pc:picChg chg="add del mod">
          <ac:chgData name="Hayk Barseghyan" userId="1af3c995-31f7-415e-9aa1-2b36900e994d" providerId="ADAL" clId="{70A19F8E-9ADD-45E3-8B5D-5634A3FE2C93}" dt="2021-02-09T23:17:46.522" v="269" actId="478"/>
          <ac:picMkLst>
            <pc:docMk/>
            <pc:sldMk cId="779035963" sldId="652"/>
            <ac:picMk id="3" creationId="{5C1D4A7B-5DA8-4A94-B5D7-172FA404B00D}"/>
          </ac:picMkLst>
        </pc:picChg>
        <pc:picChg chg="add del mod">
          <ac:chgData name="Hayk Barseghyan" userId="1af3c995-31f7-415e-9aa1-2b36900e994d" providerId="ADAL" clId="{70A19F8E-9ADD-45E3-8B5D-5634A3FE2C93}" dt="2021-02-10T00:48:19.073" v="703" actId="478"/>
          <ac:picMkLst>
            <pc:docMk/>
            <pc:sldMk cId="779035963" sldId="652"/>
            <ac:picMk id="4" creationId="{5B08F50E-179D-4AAF-A37A-152323162ABC}"/>
          </ac:picMkLst>
        </pc:picChg>
        <pc:picChg chg="add mod topLvl">
          <ac:chgData name="Hayk Barseghyan" userId="1af3c995-31f7-415e-9aa1-2b36900e994d" providerId="ADAL" clId="{70A19F8E-9ADD-45E3-8B5D-5634A3FE2C93}" dt="2021-02-10T01:13:32.649" v="927" actId="165"/>
          <ac:picMkLst>
            <pc:docMk/>
            <pc:sldMk cId="779035963" sldId="652"/>
            <ac:picMk id="6" creationId="{29673125-500E-43F5-B58F-69DE183A953F}"/>
          </ac:picMkLst>
        </pc:picChg>
        <pc:picChg chg="add del mod topLvl">
          <ac:chgData name="Hayk Barseghyan" userId="1af3c995-31f7-415e-9aa1-2b36900e994d" providerId="ADAL" clId="{70A19F8E-9ADD-45E3-8B5D-5634A3FE2C93}" dt="2021-02-09T23:40:10.501" v="364" actId="478"/>
          <ac:picMkLst>
            <pc:docMk/>
            <pc:sldMk cId="779035963" sldId="652"/>
            <ac:picMk id="8" creationId="{E170FB90-7733-4B3F-B4AE-14CDDF319F25}"/>
          </ac:picMkLst>
        </pc:picChg>
        <pc:picChg chg="add mod topLvl">
          <ac:chgData name="Hayk Barseghyan" userId="1af3c995-31f7-415e-9aa1-2b36900e994d" providerId="ADAL" clId="{70A19F8E-9ADD-45E3-8B5D-5634A3FE2C93}" dt="2021-02-10T01:13:32.649" v="927" actId="165"/>
          <ac:picMkLst>
            <pc:docMk/>
            <pc:sldMk cId="779035963" sldId="652"/>
            <ac:picMk id="11" creationId="{93BCB08C-5D80-4873-BCE0-EE955C255779}"/>
          </ac:picMkLst>
        </pc:picChg>
        <pc:picChg chg="add del">
          <ac:chgData name="Hayk Barseghyan" userId="1af3c995-31f7-415e-9aa1-2b36900e994d" providerId="ADAL" clId="{70A19F8E-9ADD-45E3-8B5D-5634A3FE2C93}" dt="2021-02-10T01:11:28.537" v="912" actId="22"/>
          <ac:picMkLst>
            <pc:docMk/>
            <pc:sldMk cId="779035963" sldId="652"/>
            <ac:picMk id="15" creationId="{9BD761A4-A9F5-40C0-9D01-F43663B73F79}"/>
          </ac:picMkLst>
        </pc:picChg>
        <pc:picChg chg="add mod">
          <ac:chgData name="Hayk Barseghyan" userId="1af3c995-31f7-415e-9aa1-2b36900e994d" providerId="ADAL" clId="{70A19F8E-9ADD-45E3-8B5D-5634A3FE2C93}" dt="2021-02-10T01:12:09.976" v="914" actId="14100"/>
          <ac:picMkLst>
            <pc:docMk/>
            <pc:sldMk cId="779035963" sldId="652"/>
            <ac:picMk id="17" creationId="{B156458E-E13E-4479-9FE5-90D11C044CE8}"/>
          </ac:picMkLst>
        </pc:picChg>
        <pc:picChg chg="add del mod">
          <ac:chgData name="Hayk Barseghyan" userId="1af3c995-31f7-415e-9aa1-2b36900e994d" providerId="ADAL" clId="{70A19F8E-9ADD-45E3-8B5D-5634A3FE2C93}" dt="2021-02-10T01:12:49.929" v="922" actId="478"/>
          <ac:picMkLst>
            <pc:docMk/>
            <pc:sldMk cId="779035963" sldId="652"/>
            <ac:picMk id="19" creationId="{3260E65C-AC73-4983-9BE7-D9E494A75516}"/>
          </ac:picMkLst>
        </pc:picChg>
        <pc:picChg chg="add mod">
          <ac:chgData name="Hayk Barseghyan" userId="1af3c995-31f7-415e-9aa1-2b36900e994d" providerId="ADAL" clId="{70A19F8E-9ADD-45E3-8B5D-5634A3FE2C93}" dt="2021-02-10T01:13:17.446" v="926" actId="14100"/>
          <ac:picMkLst>
            <pc:docMk/>
            <pc:sldMk cId="779035963" sldId="652"/>
            <ac:picMk id="21" creationId="{6E8C6618-D138-4944-8E6F-18F2105A5E40}"/>
          </ac:picMkLst>
        </pc:picChg>
      </pc:sldChg>
      <pc:sldChg chg="add del">
        <pc:chgData name="Hayk Barseghyan" userId="1af3c995-31f7-415e-9aa1-2b36900e994d" providerId="ADAL" clId="{70A19F8E-9ADD-45E3-8B5D-5634A3FE2C93}" dt="2021-02-09T23:43:29.185" v="395" actId="47"/>
        <pc:sldMkLst>
          <pc:docMk/>
          <pc:sldMk cId="733043255" sldId="653"/>
        </pc:sldMkLst>
      </pc:sldChg>
      <pc:sldChg chg="addSp delSp modSp add mod modNotesTx">
        <pc:chgData name="Hayk Barseghyan" userId="1af3c995-31f7-415e-9aa1-2b36900e994d" providerId="ADAL" clId="{70A19F8E-9ADD-45E3-8B5D-5634A3FE2C93}" dt="2021-02-11T01:20:53.730" v="1307" actId="1076"/>
        <pc:sldMkLst>
          <pc:docMk/>
          <pc:sldMk cId="827945534" sldId="654"/>
        </pc:sldMkLst>
        <pc:spChg chg="add del">
          <ac:chgData name="Hayk Barseghyan" userId="1af3c995-31f7-415e-9aa1-2b36900e994d" providerId="ADAL" clId="{70A19F8E-9ADD-45E3-8B5D-5634A3FE2C93}" dt="2021-02-10T01:35:58.411" v="1247" actId="11529"/>
          <ac:spMkLst>
            <pc:docMk/>
            <pc:sldMk cId="827945534" sldId="654"/>
            <ac:spMk id="2" creationId="{AACAB489-2A52-4A70-A0BB-31815E41380E}"/>
          </ac:spMkLst>
        </pc:spChg>
        <pc:spChg chg="del">
          <ac:chgData name="Hayk Barseghyan" userId="1af3c995-31f7-415e-9aa1-2b36900e994d" providerId="ADAL" clId="{70A19F8E-9ADD-45E3-8B5D-5634A3FE2C93}" dt="2021-02-09T22:19:26.112" v="246" actId="478"/>
          <ac:spMkLst>
            <pc:docMk/>
            <pc:sldMk cId="827945534" sldId="654"/>
            <ac:spMk id="9" creationId="{FAEB7540-E1AA-4AA8-8E2D-B822141FCC75}"/>
          </ac:spMkLst>
        </pc:spChg>
        <pc:spChg chg="add del">
          <ac:chgData name="Hayk Barseghyan" userId="1af3c995-31f7-415e-9aa1-2b36900e994d" providerId="ADAL" clId="{70A19F8E-9ADD-45E3-8B5D-5634A3FE2C93}" dt="2021-02-09T23:48:47.430" v="631" actId="11529"/>
          <ac:spMkLst>
            <pc:docMk/>
            <pc:sldMk cId="827945534" sldId="654"/>
            <ac:spMk id="11" creationId="{7D2A35EF-8F85-4086-AAEC-0826F9BDEC6B}"/>
          </ac:spMkLst>
        </pc:spChg>
        <pc:spChg chg="del">
          <ac:chgData name="Hayk Barseghyan" userId="1af3c995-31f7-415e-9aa1-2b36900e994d" providerId="ADAL" clId="{70A19F8E-9ADD-45E3-8B5D-5634A3FE2C93}" dt="2021-02-09T22:19:17.519" v="244" actId="478"/>
          <ac:spMkLst>
            <pc:docMk/>
            <pc:sldMk cId="827945534" sldId="654"/>
            <ac:spMk id="15" creationId="{1DA809E1-700B-4B5F-80D1-146841C532CC}"/>
          </ac:spMkLst>
        </pc:spChg>
        <pc:spChg chg="del">
          <ac:chgData name="Hayk Barseghyan" userId="1af3c995-31f7-415e-9aa1-2b36900e994d" providerId="ADAL" clId="{70A19F8E-9ADD-45E3-8B5D-5634A3FE2C93}" dt="2021-02-09T22:19:17.519" v="244" actId="478"/>
          <ac:spMkLst>
            <pc:docMk/>
            <pc:sldMk cId="827945534" sldId="654"/>
            <ac:spMk id="16" creationId="{219D3844-749C-4AC5-8AAC-A5A6E4F706D5}"/>
          </ac:spMkLst>
        </pc:spChg>
        <pc:spChg chg="del">
          <ac:chgData name="Hayk Barseghyan" userId="1af3c995-31f7-415e-9aa1-2b36900e994d" providerId="ADAL" clId="{70A19F8E-9ADD-45E3-8B5D-5634A3FE2C93}" dt="2021-02-09T22:19:17.519" v="244" actId="478"/>
          <ac:spMkLst>
            <pc:docMk/>
            <pc:sldMk cId="827945534" sldId="654"/>
            <ac:spMk id="17" creationId="{238D452B-545B-49D2-9AA5-4774F789BA52}"/>
          </ac:spMkLst>
        </pc:spChg>
        <pc:spChg chg="del">
          <ac:chgData name="Hayk Barseghyan" userId="1af3c995-31f7-415e-9aa1-2b36900e994d" providerId="ADAL" clId="{70A19F8E-9ADD-45E3-8B5D-5634A3FE2C93}" dt="2021-02-09T22:19:17.519" v="244" actId="478"/>
          <ac:spMkLst>
            <pc:docMk/>
            <pc:sldMk cId="827945534" sldId="654"/>
            <ac:spMk id="18" creationId="{3B330CDD-DF8E-4329-9F8F-0C05A3EBA278}"/>
          </ac:spMkLst>
        </pc:spChg>
        <pc:spChg chg="del">
          <ac:chgData name="Hayk Barseghyan" userId="1af3c995-31f7-415e-9aa1-2b36900e994d" providerId="ADAL" clId="{70A19F8E-9ADD-45E3-8B5D-5634A3FE2C93}" dt="2021-02-09T22:19:17.519" v="244" actId="478"/>
          <ac:spMkLst>
            <pc:docMk/>
            <pc:sldMk cId="827945534" sldId="654"/>
            <ac:spMk id="19" creationId="{92E3FBB9-4482-4901-BB7B-515414A60BF3}"/>
          </ac:spMkLst>
        </pc:spChg>
        <pc:spChg chg="del">
          <ac:chgData name="Hayk Barseghyan" userId="1af3c995-31f7-415e-9aa1-2b36900e994d" providerId="ADAL" clId="{70A19F8E-9ADD-45E3-8B5D-5634A3FE2C93}" dt="2021-02-09T22:19:17.519" v="244" actId="478"/>
          <ac:spMkLst>
            <pc:docMk/>
            <pc:sldMk cId="827945534" sldId="654"/>
            <ac:spMk id="20" creationId="{33617DAE-E7EA-4947-A705-85255111007E}"/>
          </ac:spMkLst>
        </pc:spChg>
        <pc:spChg chg="del">
          <ac:chgData name="Hayk Barseghyan" userId="1af3c995-31f7-415e-9aa1-2b36900e994d" providerId="ADAL" clId="{70A19F8E-9ADD-45E3-8B5D-5634A3FE2C93}" dt="2021-02-09T22:19:17.519" v="244" actId="478"/>
          <ac:spMkLst>
            <pc:docMk/>
            <pc:sldMk cId="827945534" sldId="654"/>
            <ac:spMk id="21" creationId="{C9A0FE9C-502B-4BBD-8A60-74F846E3930A}"/>
          </ac:spMkLst>
        </pc:spChg>
        <pc:spChg chg="del">
          <ac:chgData name="Hayk Barseghyan" userId="1af3c995-31f7-415e-9aa1-2b36900e994d" providerId="ADAL" clId="{70A19F8E-9ADD-45E3-8B5D-5634A3FE2C93}" dt="2021-02-09T22:19:17.519" v="244" actId="478"/>
          <ac:spMkLst>
            <pc:docMk/>
            <pc:sldMk cId="827945534" sldId="654"/>
            <ac:spMk id="22" creationId="{097F0FB6-DB3D-4B12-9E76-180A15D9B845}"/>
          </ac:spMkLst>
        </pc:spChg>
        <pc:spChg chg="mod">
          <ac:chgData name="Hayk Barseghyan" userId="1af3c995-31f7-415e-9aa1-2b36900e994d" providerId="ADAL" clId="{70A19F8E-9ADD-45E3-8B5D-5634A3FE2C93}" dt="2021-02-10T01:27:02.550" v="1121" actId="1036"/>
          <ac:spMkLst>
            <pc:docMk/>
            <pc:sldMk cId="827945534" sldId="654"/>
            <ac:spMk id="28" creationId="{627423C8-B194-4935-85FA-5ED8C3D13EA3}"/>
          </ac:spMkLst>
        </pc:spChg>
        <pc:spChg chg="add mod">
          <ac:chgData name="Hayk Barseghyan" userId="1af3c995-31f7-415e-9aa1-2b36900e994d" providerId="ADAL" clId="{70A19F8E-9ADD-45E3-8B5D-5634A3FE2C93}" dt="2021-02-10T01:38:07.384" v="1256" actId="208"/>
          <ac:spMkLst>
            <pc:docMk/>
            <pc:sldMk cId="827945534" sldId="654"/>
            <ac:spMk id="29" creationId="{BF880D0C-7AA2-4DE0-BCB3-74F7E125FD7C}"/>
          </ac:spMkLst>
        </pc:spChg>
        <pc:spChg chg="mod">
          <ac:chgData name="Hayk Barseghyan" userId="1af3c995-31f7-415e-9aa1-2b36900e994d" providerId="ADAL" clId="{70A19F8E-9ADD-45E3-8B5D-5634A3FE2C93}" dt="2021-02-11T01:20:18.151" v="1298" actId="1076"/>
          <ac:spMkLst>
            <pc:docMk/>
            <pc:sldMk cId="827945534" sldId="654"/>
            <ac:spMk id="30" creationId="{68ED1E75-B125-4C10-BB29-81E202553B2C}"/>
          </ac:spMkLst>
        </pc:spChg>
        <pc:spChg chg="mod">
          <ac:chgData name="Hayk Barseghyan" userId="1af3c995-31f7-415e-9aa1-2b36900e994d" providerId="ADAL" clId="{70A19F8E-9ADD-45E3-8B5D-5634A3FE2C93}" dt="2021-02-09T23:48:15.463" v="600" actId="164"/>
          <ac:spMkLst>
            <pc:docMk/>
            <pc:sldMk cId="827945534" sldId="654"/>
            <ac:spMk id="31" creationId="{85DF863F-2BCD-44E2-B1C2-A1A04810460A}"/>
          </ac:spMkLst>
        </pc:spChg>
        <pc:spChg chg="mod">
          <ac:chgData name="Hayk Barseghyan" userId="1af3c995-31f7-415e-9aa1-2b36900e994d" providerId="ADAL" clId="{70A19F8E-9ADD-45E3-8B5D-5634A3FE2C93}" dt="2021-02-09T23:48:15.463" v="600" actId="164"/>
          <ac:spMkLst>
            <pc:docMk/>
            <pc:sldMk cId="827945534" sldId="654"/>
            <ac:spMk id="32" creationId="{A43E28E5-3F33-464E-A48E-76E863F54969}"/>
          </ac:spMkLst>
        </pc:spChg>
        <pc:spChg chg="del">
          <ac:chgData name="Hayk Barseghyan" userId="1af3c995-31f7-415e-9aa1-2b36900e994d" providerId="ADAL" clId="{70A19F8E-9ADD-45E3-8B5D-5634A3FE2C93}" dt="2021-02-09T23:21:02.450" v="355" actId="478"/>
          <ac:spMkLst>
            <pc:docMk/>
            <pc:sldMk cId="827945534" sldId="654"/>
            <ac:spMk id="33" creationId="{C592B722-755B-4A29-A4CA-7571AE17BEEE}"/>
          </ac:spMkLst>
        </pc:spChg>
        <pc:spChg chg="del">
          <ac:chgData name="Hayk Barseghyan" userId="1af3c995-31f7-415e-9aa1-2b36900e994d" providerId="ADAL" clId="{70A19F8E-9ADD-45E3-8B5D-5634A3FE2C93}" dt="2021-02-09T23:21:02.450" v="355" actId="478"/>
          <ac:spMkLst>
            <pc:docMk/>
            <pc:sldMk cId="827945534" sldId="654"/>
            <ac:spMk id="34" creationId="{B4982F10-38F2-41B4-95DB-97A3A9973771}"/>
          </ac:spMkLst>
        </pc:spChg>
        <pc:spChg chg="add mod">
          <ac:chgData name="Hayk Barseghyan" userId="1af3c995-31f7-415e-9aa1-2b36900e994d" providerId="ADAL" clId="{70A19F8E-9ADD-45E3-8B5D-5634A3FE2C93}" dt="2021-02-10T01:31:33.534" v="1192" actId="14100"/>
          <ac:spMkLst>
            <pc:docMk/>
            <pc:sldMk cId="827945534" sldId="654"/>
            <ac:spMk id="38" creationId="{731FBF45-3F6B-44DD-B211-111B688BBE1E}"/>
          </ac:spMkLst>
        </pc:spChg>
        <pc:spChg chg="add mod">
          <ac:chgData name="Hayk Barseghyan" userId="1af3c995-31f7-415e-9aa1-2b36900e994d" providerId="ADAL" clId="{70A19F8E-9ADD-45E3-8B5D-5634A3FE2C93}" dt="2021-02-10T00:52:41.133" v="719" actId="164"/>
          <ac:spMkLst>
            <pc:docMk/>
            <pc:sldMk cId="827945534" sldId="654"/>
            <ac:spMk id="44" creationId="{0C85C3E2-DE72-4F69-97FD-EE2A64F65902}"/>
          </ac:spMkLst>
        </pc:spChg>
        <pc:spChg chg="add del mod">
          <ac:chgData name="Hayk Barseghyan" userId="1af3c995-31f7-415e-9aa1-2b36900e994d" providerId="ADAL" clId="{70A19F8E-9ADD-45E3-8B5D-5634A3FE2C93}" dt="2021-02-10T01:36:01.108" v="1248" actId="478"/>
          <ac:spMkLst>
            <pc:docMk/>
            <pc:sldMk cId="827945534" sldId="654"/>
            <ac:spMk id="48" creationId="{3B92DCFD-938D-4B9E-96FF-300EA5F73610}"/>
          </ac:spMkLst>
        </pc:spChg>
        <pc:spChg chg="del">
          <ac:chgData name="Hayk Barseghyan" userId="1af3c995-31f7-415e-9aa1-2b36900e994d" providerId="ADAL" clId="{70A19F8E-9ADD-45E3-8B5D-5634A3FE2C93}" dt="2021-02-09T23:52:21.771" v="699" actId="478"/>
          <ac:spMkLst>
            <pc:docMk/>
            <pc:sldMk cId="827945534" sldId="654"/>
            <ac:spMk id="48" creationId="{7DECEAD3-1F4B-4349-B3E1-EC2281C752C7}"/>
          </ac:spMkLst>
        </pc:spChg>
        <pc:spChg chg="add mod">
          <ac:chgData name="Hayk Barseghyan" userId="1af3c995-31f7-415e-9aa1-2b36900e994d" providerId="ADAL" clId="{70A19F8E-9ADD-45E3-8B5D-5634A3FE2C93}" dt="2021-02-11T01:20:43.440" v="1304" actId="1076"/>
          <ac:spMkLst>
            <pc:docMk/>
            <pc:sldMk cId="827945534" sldId="654"/>
            <ac:spMk id="48" creationId="{A5767109-BE3E-4EBA-BE34-EC7C3FC9B538}"/>
          </ac:spMkLst>
        </pc:spChg>
        <pc:spChg chg="add mod">
          <ac:chgData name="Hayk Barseghyan" userId="1af3c995-31f7-415e-9aa1-2b36900e994d" providerId="ADAL" clId="{70A19F8E-9ADD-45E3-8B5D-5634A3FE2C93}" dt="2021-02-10T00:52:41.133" v="719" actId="164"/>
          <ac:spMkLst>
            <pc:docMk/>
            <pc:sldMk cId="827945534" sldId="654"/>
            <ac:spMk id="50" creationId="{55CD9F97-512F-48BF-9B69-5CDE38C934FC}"/>
          </ac:spMkLst>
        </pc:spChg>
        <pc:spChg chg="add mod">
          <ac:chgData name="Hayk Barseghyan" userId="1af3c995-31f7-415e-9aa1-2b36900e994d" providerId="ADAL" clId="{70A19F8E-9ADD-45E3-8B5D-5634A3FE2C93}" dt="2021-02-10T00:52:41.133" v="719" actId="164"/>
          <ac:spMkLst>
            <pc:docMk/>
            <pc:sldMk cId="827945534" sldId="654"/>
            <ac:spMk id="51" creationId="{AC3B91D7-FF9B-4988-9E6B-EAD51DD2DF4F}"/>
          </ac:spMkLst>
        </pc:spChg>
        <pc:spChg chg="add mod">
          <ac:chgData name="Hayk Barseghyan" userId="1af3c995-31f7-415e-9aa1-2b36900e994d" providerId="ADAL" clId="{70A19F8E-9ADD-45E3-8B5D-5634A3FE2C93}" dt="2021-02-11T01:20:53.730" v="1307" actId="1076"/>
          <ac:spMkLst>
            <pc:docMk/>
            <pc:sldMk cId="827945534" sldId="654"/>
            <ac:spMk id="52" creationId="{3C4CF752-D100-4648-B7BC-5DB3FB658991}"/>
          </ac:spMkLst>
        </pc:spChg>
        <pc:spChg chg="del">
          <ac:chgData name="Hayk Barseghyan" userId="1af3c995-31f7-415e-9aa1-2b36900e994d" providerId="ADAL" clId="{70A19F8E-9ADD-45E3-8B5D-5634A3FE2C93}" dt="2021-02-09T23:52:30.227" v="701" actId="478"/>
          <ac:spMkLst>
            <pc:docMk/>
            <pc:sldMk cId="827945534" sldId="654"/>
            <ac:spMk id="58" creationId="{C7E49091-0ACC-4142-9B93-9F0BE2716A65}"/>
          </ac:spMkLst>
        </pc:spChg>
        <pc:spChg chg="del">
          <ac:chgData name="Hayk Barseghyan" userId="1af3c995-31f7-415e-9aa1-2b36900e994d" providerId="ADAL" clId="{70A19F8E-9ADD-45E3-8B5D-5634A3FE2C93}" dt="2021-02-09T23:52:29.370" v="700" actId="478"/>
          <ac:spMkLst>
            <pc:docMk/>
            <pc:sldMk cId="827945534" sldId="654"/>
            <ac:spMk id="59" creationId="{D1E7461A-0DE2-46AC-9A6B-AD21D7804CB3}"/>
          </ac:spMkLst>
        </pc:spChg>
        <pc:spChg chg="add mod">
          <ac:chgData name="Hayk Barseghyan" userId="1af3c995-31f7-415e-9aa1-2b36900e994d" providerId="ADAL" clId="{70A19F8E-9ADD-45E3-8B5D-5634A3FE2C93}" dt="2021-02-10T01:28:23.568" v="1147" actId="164"/>
          <ac:spMkLst>
            <pc:docMk/>
            <pc:sldMk cId="827945534" sldId="654"/>
            <ac:spMk id="67" creationId="{D3CA6639-3DFD-44CD-8DDA-C2B8FC98978D}"/>
          </ac:spMkLst>
        </pc:spChg>
        <pc:spChg chg="add mod">
          <ac:chgData name="Hayk Barseghyan" userId="1af3c995-31f7-415e-9aa1-2b36900e994d" providerId="ADAL" clId="{70A19F8E-9ADD-45E3-8B5D-5634A3FE2C93}" dt="2021-02-10T01:28:23.568" v="1147" actId="164"/>
          <ac:spMkLst>
            <pc:docMk/>
            <pc:sldMk cId="827945534" sldId="654"/>
            <ac:spMk id="68" creationId="{60B9B4CC-3AE9-4F32-BB63-6ADC3AE49767}"/>
          </ac:spMkLst>
        </pc:spChg>
        <pc:spChg chg="add mod topLvl">
          <ac:chgData name="Hayk Barseghyan" userId="1af3c995-31f7-415e-9aa1-2b36900e994d" providerId="ADAL" clId="{70A19F8E-9ADD-45E3-8B5D-5634A3FE2C93}" dt="2021-02-10T01:27:49.751" v="1136" actId="164"/>
          <ac:spMkLst>
            <pc:docMk/>
            <pc:sldMk cId="827945534" sldId="654"/>
            <ac:spMk id="73" creationId="{91DBD2C9-4ACA-4927-9A95-4EC82B003CC2}"/>
          </ac:spMkLst>
        </pc:spChg>
        <pc:spChg chg="add mod topLvl">
          <ac:chgData name="Hayk Barseghyan" userId="1af3c995-31f7-415e-9aa1-2b36900e994d" providerId="ADAL" clId="{70A19F8E-9ADD-45E3-8B5D-5634A3FE2C93}" dt="2021-02-10T01:27:49.751" v="1136" actId="164"/>
          <ac:spMkLst>
            <pc:docMk/>
            <pc:sldMk cId="827945534" sldId="654"/>
            <ac:spMk id="74" creationId="{E8182E25-D223-4590-8CCA-35902E2FEDE1}"/>
          </ac:spMkLst>
        </pc:spChg>
        <pc:spChg chg="add mod topLvl">
          <ac:chgData name="Hayk Barseghyan" userId="1af3c995-31f7-415e-9aa1-2b36900e994d" providerId="ADAL" clId="{70A19F8E-9ADD-45E3-8B5D-5634A3FE2C93}" dt="2021-02-10T01:27:49.751" v="1136" actId="164"/>
          <ac:spMkLst>
            <pc:docMk/>
            <pc:sldMk cId="827945534" sldId="654"/>
            <ac:spMk id="75" creationId="{70654682-8FF8-4790-8813-B14F325AC03B}"/>
          </ac:spMkLst>
        </pc:spChg>
        <pc:spChg chg="add mod">
          <ac:chgData name="Hayk Barseghyan" userId="1af3c995-31f7-415e-9aa1-2b36900e994d" providerId="ADAL" clId="{70A19F8E-9ADD-45E3-8B5D-5634A3FE2C93}" dt="2021-02-10T01:19:10.999" v="1022" actId="164"/>
          <ac:spMkLst>
            <pc:docMk/>
            <pc:sldMk cId="827945534" sldId="654"/>
            <ac:spMk id="81" creationId="{3994C99E-8F4A-43D9-B869-C209C2448ED5}"/>
          </ac:spMkLst>
        </pc:spChg>
        <pc:spChg chg="add mod">
          <ac:chgData name="Hayk Barseghyan" userId="1af3c995-31f7-415e-9aa1-2b36900e994d" providerId="ADAL" clId="{70A19F8E-9ADD-45E3-8B5D-5634A3FE2C93}" dt="2021-02-10T01:19:10.999" v="1022" actId="164"/>
          <ac:spMkLst>
            <pc:docMk/>
            <pc:sldMk cId="827945534" sldId="654"/>
            <ac:spMk id="82" creationId="{1E003483-CEF4-48D6-9E79-17B99FDF3E9E}"/>
          </ac:spMkLst>
        </pc:spChg>
        <pc:spChg chg="add mod">
          <ac:chgData name="Hayk Barseghyan" userId="1af3c995-31f7-415e-9aa1-2b36900e994d" providerId="ADAL" clId="{70A19F8E-9ADD-45E3-8B5D-5634A3FE2C93}" dt="2021-02-10T01:19:10.999" v="1022" actId="164"/>
          <ac:spMkLst>
            <pc:docMk/>
            <pc:sldMk cId="827945534" sldId="654"/>
            <ac:spMk id="83" creationId="{B6F43EBE-5C11-48EA-83D6-128216B25E57}"/>
          </ac:spMkLst>
        </pc:spChg>
        <pc:spChg chg="add mod">
          <ac:chgData name="Hayk Barseghyan" userId="1af3c995-31f7-415e-9aa1-2b36900e994d" providerId="ADAL" clId="{70A19F8E-9ADD-45E3-8B5D-5634A3FE2C93}" dt="2021-02-10T01:19:10.999" v="1022" actId="164"/>
          <ac:spMkLst>
            <pc:docMk/>
            <pc:sldMk cId="827945534" sldId="654"/>
            <ac:spMk id="84" creationId="{7E3331DF-FE4A-49BB-B840-90A7A872D9FB}"/>
          </ac:spMkLst>
        </pc:spChg>
        <pc:spChg chg="add mod">
          <ac:chgData name="Hayk Barseghyan" userId="1af3c995-31f7-415e-9aa1-2b36900e994d" providerId="ADAL" clId="{70A19F8E-9ADD-45E3-8B5D-5634A3FE2C93}" dt="2021-02-10T01:27:49.751" v="1136" actId="164"/>
          <ac:spMkLst>
            <pc:docMk/>
            <pc:sldMk cId="827945534" sldId="654"/>
            <ac:spMk id="87" creationId="{2E5488B3-4E09-45F6-B727-EEEADE67C711}"/>
          </ac:spMkLst>
        </pc:spChg>
        <pc:spChg chg="add mod">
          <ac:chgData name="Hayk Barseghyan" userId="1af3c995-31f7-415e-9aa1-2b36900e994d" providerId="ADAL" clId="{70A19F8E-9ADD-45E3-8B5D-5634A3FE2C93}" dt="2021-02-10T01:27:49.751" v="1136" actId="164"/>
          <ac:spMkLst>
            <pc:docMk/>
            <pc:sldMk cId="827945534" sldId="654"/>
            <ac:spMk id="88" creationId="{AD2436C3-0D18-476F-B906-80E8F4D6FF7A}"/>
          </ac:spMkLst>
        </pc:spChg>
        <pc:spChg chg="add mod">
          <ac:chgData name="Hayk Barseghyan" userId="1af3c995-31f7-415e-9aa1-2b36900e994d" providerId="ADAL" clId="{70A19F8E-9ADD-45E3-8B5D-5634A3FE2C93}" dt="2021-02-10T01:27:49.751" v="1136" actId="164"/>
          <ac:spMkLst>
            <pc:docMk/>
            <pc:sldMk cId="827945534" sldId="654"/>
            <ac:spMk id="104" creationId="{09F82EBC-8FE7-4978-A432-258EADAB4A7C}"/>
          </ac:spMkLst>
        </pc:spChg>
        <pc:spChg chg="add mod">
          <ac:chgData name="Hayk Barseghyan" userId="1af3c995-31f7-415e-9aa1-2b36900e994d" providerId="ADAL" clId="{70A19F8E-9ADD-45E3-8B5D-5634A3FE2C93}" dt="2021-02-10T01:29:22.877" v="1170" actId="1076"/>
          <ac:spMkLst>
            <pc:docMk/>
            <pc:sldMk cId="827945534" sldId="654"/>
            <ac:spMk id="107" creationId="{BC0792DA-1127-48FD-A582-05E47E97B134}"/>
          </ac:spMkLst>
        </pc:spChg>
        <pc:spChg chg="add mod">
          <ac:chgData name="Hayk Barseghyan" userId="1af3c995-31f7-415e-9aa1-2b36900e994d" providerId="ADAL" clId="{70A19F8E-9ADD-45E3-8B5D-5634A3FE2C93}" dt="2021-02-10T01:33:29.124" v="1229" actId="1036"/>
          <ac:spMkLst>
            <pc:docMk/>
            <pc:sldMk cId="827945534" sldId="654"/>
            <ac:spMk id="108" creationId="{259FC43F-09D6-43C3-AA81-1690713F7632}"/>
          </ac:spMkLst>
        </pc:spChg>
        <pc:spChg chg="add mod">
          <ac:chgData name="Hayk Barseghyan" userId="1af3c995-31f7-415e-9aa1-2b36900e994d" providerId="ADAL" clId="{70A19F8E-9ADD-45E3-8B5D-5634A3FE2C93}" dt="2021-02-10T01:37:30.503" v="1255" actId="208"/>
          <ac:spMkLst>
            <pc:docMk/>
            <pc:sldMk cId="827945534" sldId="654"/>
            <ac:spMk id="110" creationId="{C9BF5608-8FA5-4E0E-8EC7-4C89C8050A07}"/>
          </ac:spMkLst>
        </pc:spChg>
        <pc:spChg chg="add mod">
          <ac:chgData name="Hayk Barseghyan" userId="1af3c995-31f7-415e-9aa1-2b36900e994d" providerId="ADAL" clId="{70A19F8E-9ADD-45E3-8B5D-5634A3FE2C93}" dt="2021-02-10T01:37:30.503" v="1255" actId="208"/>
          <ac:spMkLst>
            <pc:docMk/>
            <pc:sldMk cId="827945534" sldId="654"/>
            <ac:spMk id="111" creationId="{7D458B18-8E57-4E9D-BB87-1AA20127D901}"/>
          </ac:spMkLst>
        </pc:spChg>
        <pc:grpChg chg="add mod ord">
          <ac:chgData name="Hayk Barseghyan" userId="1af3c995-31f7-415e-9aa1-2b36900e994d" providerId="ADAL" clId="{70A19F8E-9ADD-45E3-8B5D-5634A3FE2C93}" dt="2021-02-10T01:29:16.370" v="1169" actId="1076"/>
          <ac:grpSpMkLst>
            <pc:docMk/>
            <pc:sldMk cId="827945534" sldId="654"/>
            <ac:grpSpMk id="10" creationId="{F42BC947-A5E9-40A9-BBF3-A551526EBE7B}"/>
          </ac:grpSpMkLst>
        </pc:grpChg>
        <pc:grpChg chg="add del mod">
          <ac:chgData name="Hayk Barseghyan" userId="1af3c995-31f7-415e-9aa1-2b36900e994d" providerId="ADAL" clId="{70A19F8E-9ADD-45E3-8B5D-5634A3FE2C93}" dt="2021-02-09T23:42:23.902" v="386" actId="478"/>
          <ac:grpSpMkLst>
            <pc:docMk/>
            <pc:sldMk cId="827945534" sldId="654"/>
            <ac:grpSpMk id="39" creationId="{C4DF3679-358D-4F4B-A126-30A32DB65645}"/>
          </ac:grpSpMkLst>
        </pc:grpChg>
        <pc:grpChg chg="add del mod">
          <ac:chgData name="Hayk Barseghyan" userId="1af3c995-31f7-415e-9aa1-2b36900e994d" providerId="ADAL" clId="{70A19F8E-9ADD-45E3-8B5D-5634A3FE2C93}" dt="2021-02-10T00:51:36.465" v="707" actId="165"/>
          <ac:grpSpMkLst>
            <pc:docMk/>
            <pc:sldMk cId="827945534" sldId="654"/>
            <ac:grpSpMk id="45" creationId="{2475BDD5-D2DB-4B90-B63D-76F9305C2678}"/>
          </ac:grpSpMkLst>
        </pc:grpChg>
        <pc:grpChg chg="add mod">
          <ac:chgData name="Hayk Barseghyan" userId="1af3c995-31f7-415e-9aa1-2b36900e994d" providerId="ADAL" clId="{70A19F8E-9ADD-45E3-8B5D-5634A3FE2C93}" dt="2021-02-10T00:52:15.142" v="713" actId="164"/>
          <ac:grpSpMkLst>
            <pc:docMk/>
            <pc:sldMk cId="827945534" sldId="654"/>
            <ac:grpSpMk id="54" creationId="{3DCBB6E7-3859-4243-BB1C-D80796940547}"/>
          </ac:grpSpMkLst>
        </pc:grpChg>
        <pc:grpChg chg="add mod">
          <ac:chgData name="Hayk Barseghyan" userId="1af3c995-31f7-415e-9aa1-2b36900e994d" providerId="ADAL" clId="{70A19F8E-9ADD-45E3-8B5D-5634A3FE2C93}" dt="2021-02-10T00:52:38.282" v="718" actId="338"/>
          <ac:grpSpMkLst>
            <pc:docMk/>
            <pc:sldMk cId="827945534" sldId="654"/>
            <ac:grpSpMk id="57" creationId="{D4AF1E9F-4820-4588-870D-A56156C0864B}"/>
          </ac:grpSpMkLst>
        </pc:grpChg>
        <pc:grpChg chg="add mod">
          <ac:chgData name="Hayk Barseghyan" userId="1af3c995-31f7-415e-9aa1-2b36900e994d" providerId="ADAL" clId="{70A19F8E-9ADD-45E3-8B5D-5634A3FE2C93}" dt="2021-02-10T01:34:38.713" v="1243" actId="1038"/>
          <ac:grpSpMkLst>
            <pc:docMk/>
            <pc:sldMk cId="827945534" sldId="654"/>
            <ac:grpSpMk id="60" creationId="{4E313384-1C78-459B-BB63-90009F44FF76}"/>
          </ac:grpSpMkLst>
        </pc:grpChg>
        <pc:grpChg chg="add del mod">
          <ac:chgData name="Hayk Barseghyan" userId="1af3c995-31f7-415e-9aa1-2b36900e994d" providerId="ADAL" clId="{70A19F8E-9ADD-45E3-8B5D-5634A3FE2C93}" dt="2021-02-10T01:18:34.608" v="997" actId="165"/>
          <ac:grpSpMkLst>
            <pc:docMk/>
            <pc:sldMk cId="827945534" sldId="654"/>
            <ac:grpSpMk id="80" creationId="{D63CD316-C4C8-42F1-96BD-C3984B100C49}"/>
          </ac:grpSpMkLst>
        </pc:grpChg>
        <pc:grpChg chg="add mod">
          <ac:chgData name="Hayk Barseghyan" userId="1af3c995-31f7-415e-9aa1-2b36900e994d" providerId="ADAL" clId="{70A19F8E-9ADD-45E3-8B5D-5634A3FE2C93}" dt="2021-02-10T01:27:34.527" v="1135" actId="1036"/>
          <ac:grpSpMkLst>
            <pc:docMk/>
            <pc:sldMk cId="827945534" sldId="654"/>
            <ac:grpSpMk id="85" creationId="{557AE439-D02F-4A9D-9266-BB65A8EAA5EC}"/>
          </ac:grpSpMkLst>
        </pc:grpChg>
        <pc:grpChg chg="add del mod">
          <ac:chgData name="Hayk Barseghyan" userId="1af3c995-31f7-415e-9aa1-2b36900e994d" providerId="ADAL" clId="{70A19F8E-9ADD-45E3-8B5D-5634A3FE2C93}" dt="2021-02-10T01:22:47.910" v="1057" actId="165"/>
          <ac:grpSpMkLst>
            <pc:docMk/>
            <pc:sldMk cId="827945534" sldId="654"/>
            <ac:grpSpMk id="86" creationId="{D0A90921-65D2-49CA-9974-E3967C677B67}"/>
          </ac:grpSpMkLst>
        </pc:grpChg>
        <pc:grpChg chg="add mod">
          <ac:chgData name="Hayk Barseghyan" userId="1af3c995-31f7-415e-9aa1-2b36900e994d" providerId="ADAL" clId="{70A19F8E-9ADD-45E3-8B5D-5634A3FE2C93}" dt="2021-02-10T01:23:14.451" v="1059" actId="164"/>
          <ac:grpSpMkLst>
            <pc:docMk/>
            <pc:sldMk cId="827945534" sldId="654"/>
            <ac:grpSpMk id="89" creationId="{2387746C-EFAC-4526-BE0B-3DA2E6409865}"/>
          </ac:grpSpMkLst>
        </pc:grpChg>
        <pc:grpChg chg="add mod">
          <ac:chgData name="Hayk Barseghyan" userId="1af3c995-31f7-415e-9aa1-2b36900e994d" providerId="ADAL" clId="{70A19F8E-9ADD-45E3-8B5D-5634A3FE2C93}" dt="2021-02-10T01:27:57.732" v="1144" actId="1036"/>
          <ac:grpSpMkLst>
            <pc:docMk/>
            <pc:sldMk cId="827945534" sldId="654"/>
            <ac:grpSpMk id="105" creationId="{A554AF4F-F2EC-499E-AD80-B9AFE5FE56A6}"/>
          </ac:grpSpMkLst>
        </pc:grpChg>
        <pc:grpChg chg="add mod">
          <ac:chgData name="Hayk Barseghyan" userId="1af3c995-31f7-415e-9aa1-2b36900e994d" providerId="ADAL" clId="{70A19F8E-9ADD-45E3-8B5D-5634A3FE2C93}" dt="2021-02-10T01:36:07.335" v="1251" actId="1076"/>
          <ac:grpSpMkLst>
            <pc:docMk/>
            <pc:sldMk cId="827945534" sldId="654"/>
            <ac:grpSpMk id="106" creationId="{FB70DBDB-EC7B-45C1-BCD2-EEC48EF9C8C3}"/>
          </ac:grpSpMkLst>
        </pc:grpChg>
        <pc:picChg chg="add del mod">
          <ac:chgData name="Hayk Barseghyan" userId="1af3c995-31f7-415e-9aa1-2b36900e994d" providerId="ADAL" clId="{70A19F8E-9ADD-45E3-8B5D-5634A3FE2C93}" dt="2021-02-09T23:13:14.837" v="250" actId="478"/>
          <ac:picMkLst>
            <pc:docMk/>
            <pc:sldMk cId="827945534" sldId="654"/>
            <ac:picMk id="3" creationId="{B4471CEB-F271-404F-B826-26EEDE140AD7}"/>
          </ac:picMkLst>
        </pc:picChg>
        <pc:picChg chg="add mod ord">
          <ac:chgData name="Hayk Barseghyan" userId="1af3c995-31f7-415e-9aa1-2b36900e994d" providerId="ADAL" clId="{70A19F8E-9ADD-45E3-8B5D-5634A3FE2C93}" dt="2021-02-09T23:48:15.463" v="600" actId="164"/>
          <ac:picMkLst>
            <pc:docMk/>
            <pc:sldMk cId="827945534" sldId="654"/>
            <ac:picMk id="5" creationId="{D92F977B-0C11-413D-983E-89281DFDED3C}"/>
          </ac:picMkLst>
        </pc:picChg>
        <pc:picChg chg="del">
          <ac:chgData name="Hayk Barseghyan" userId="1af3c995-31f7-415e-9aa1-2b36900e994d" providerId="ADAL" clId="{70A19F8E-9ADD-45E3-8B5D-5634A3FE2C93}" dt="2021-02-09T22:19:17.519" v="244" actId="478"/>
          <ac:picMkLst>
            <pc:docMk/>
            <pc:sldMk cId="827945534" sldId="654"/>
            <ac:picMk id="14" creationId="{BD596D5A-A8B5-4F23-971B-B0033B030440}"/>
          </ac:picMkLst>
        </pc:picChg>
        <pc:picChg chg="del">
          <ac:chgData name="Hayk Barseghyan" userId="1af3c995-31f7-415e-9aa1-2b36900e994d" providerId="ADAL" clId="{70A19F8E-9ADD-45E3-8B5D-5634A3FE2C93}" dt="2021-02-09T22:19:23.567" v="245" actId="478"/>
          <ac:picMkLst>
            <pc:docMk/>
            <pc:sldMk cId="827945534" sldId="654"/>
            <ac:picMk id="35" creationId="{66FD96DE-C6EB-4683-ADCB-50E7FBA9AAF3}"/>
          </ac:picMkLst>
        </pc:picChg>
        <pc:picChg chg="del">
          <ac:chgData name="Hayk Barseghyan" userId="1af3c995-31f7-415e-9aa1-2b36900e994d" providerId="ADAL" clId="{70A19F8E-9ADD-45E3-8B5D-5634A3FE2C93}" dt="2021-02-09T22:18:54.059" v="241" actId="478"/>
          <ac:picMkLst>
            <pc:docMk/>
            <pc:sldMk cId="827945534" sldId="654"/>
            <ac:picMk id="36" creationId="{E9E5B046-D97F-4288-AA74-79294CC4F6EE}"/>
          </ac:picMkLst>
        </pc:picChg>
        <pc:picChg chg="mod">
          <ac:chgData name="Hayk Barseghyan" userId="1af3c995-31f7-415e-9aa1-2b36900e994d" providerId="ADAL" clId="{70A19F8E-9ADD-45E3-8B5D-5634A3FE2C93}" dt="2021-02-09T23:25:18.932" v="358" actId="2085"/>
          <ac:picMkLst>
            <pc:docMk/>
            <pc:sldMk cId="827945534" sldId="654"/>
            <ac:picMk id="40" creationId="{32338F36-F73C-4104-8E67-660032A7B509}"/>
          </ac:picMkLst>
        </pc:picChg>
        <pc:picChg chg="mod">
          <ac:chgData name="Hayk Barseghyan" userId="1af3c995-31f7-415e-9aa1-2b36900e994d" providerId="ADAL" clId="{70A19F8E-9ADD-45E3-8B5D-5634A3FE2C93}" dt="2021-02-09T23:25:18.932" v="358" actId="2085"/>
          <ac:picMkLst>
            <pc:docMk/>
            <pc:sldMk cId="827945534" sldId="654"/>
            <ac:picMk id="41" creationId="{C9FA7B09-35B9-4CB3-8BC2-CD5F4F99354B}"/>
          </ac:picMkLst>
        </pc:picChg>
        <pc:picChg chg="del">
          <ac:chgData name="Hayk Barseghyan" userId="1af3c995-31f7-415e-9aa1-2b36900e994d" providerId="ADAL" clId="{70A19F8E-9ADD-45E3-8B5D-5634A3FE2C93}" dt="2021-02-09T23:52:19.702" v="698" actId="478"/>
          <ac:picMkLst>
            <pc:docMk/>
            <pc:sldMk cId="827945534" sldId="654"/>
            <ac:picMk id="43" creationId="{4F5972F7-3200-4EE7-BF84-33C378BBBBBB}"/>
          </ac:picMkLst>
        </pc:picChg>
        <pc:picChg chg="mod topLvl">
          <ac:chgData name="Hayk Barseghyan" userId="1af3c995-31f7-415e-9aa1-2b36900e994d" providerId="ADAL" clId="{70A19F8E-9ADD-45E3-8B5D-5634A3FE2C93}" dt="2021-02-10T00:52:41.133" v="719" actId="164"/>
          <ac:picMkLst>
            <pc:docMk/>
            <pc:sldMk cId="827945534" sldId="654"/>
            <ac:picMk id="46" creationId="{7145314F-0180-45EB-BCCC-45ACC338B04F}"/>
          </ac:picMkLst>
        </pc:picChg>
        <pc:picChg chg="mod topLvl">
          <ac:chgData name="Hayk Barseghyan" userId="1af3c995-31f7-415e-9aa1-2b36900e994d" providerId="ADAL" clId="{70A19F8E-9ADD-45E3-8B5D-5634A3FE2C93}" dt="2021-02-10T00:52:41.133" v="719" actId="164"/>
          <ac:picMkLst>
            <pc:docMk/>
            <pc:sldMk cId="827945534" sldId="654"/>
            <ac:picMk id="47" creationId="{67DEB9C8-1071-4239-A286-985511548301}"/>
          </ac:picMkLst>
        </pc:picChg>
        <pc:picChg chg="del">
          <ac:chgData name="Hayk Barseghyan" userId="1af3c995-31f7-415e-9aa1-2b36900e994d" providerId="ADAL" clId="{70A19F8E-9ADD-45E3-8B5D-5634A3FE2C93}" dt="2021-02-09T22:18:58.089" v="242" actId="478"/>
          <ac:picMkLst>
            <pc:docMk/>
            <pc:sldMk cId="827945534" sldId="654"/>
            <ac:picMk id="55" creationId="{3292E05B-B4A2-4F12-88CC-882830945CA9}"/>
          </ac:picMkLst>
        </pc:picChg>
        <pc:picChg chg="add mod">
          <ac:chgData name="Hayk Barseghyan" userId="1af3c995-31f7-415e-9aa1-2b36900e994d" providerId="ADAL" clId="{70A19F8E-9ADD-45E3-8B5D-5634A3FE2C93}" dt="2021-02-10T01:28:23.568" v="1147" actId="164"/>
          <ac:picMkLst>
            <pc:docMk/>
            <pc:sldMk cId="827945534" sldId="654"/>
            <ac:picMk id="66" creationId="{89FAF7D9-3D2F-45E6-BA4C-A30C7F100316}"/>
          </ac:picMkLst>
        </pc:picChg>
        <pc:picChg chg="add del mod">
          <ac:chgData name="Hayk Barseghyan" userId="1af3c995-31f7-415e-9aa1-2b36900e994d" providerId="ADAL" clId="{70A19F8E-9ADD-45E3-8B5D-5634A3FE2C93}" dt="2021-02-10T00:59:55.775" v="806" actId="478"/>
          <ac:picMkLst>
            <pc:docMk/>
            <pc:sldMk cId="827945534" sldId="654"/>
            <ac:picMk id="70" creationId="{DF8BDD36-85B4-4491-9875-B5AEE965777C}"/>
          </ac:picMkLst>
        </pc:picChg>
        <pc:picChg chg="add mod topLvl">
          <ac:chgData name="Hayk Barseghyan" userId="1af3c995-31f7-415e-9aa1-2b36900e994d" providerId="ADAL" clId="{70A19F8E-9ADD-45E3-8B5D-5634A3FE2C93}" dt="2021-02-10T01:27:49.751" v="1136" actId="164"/>
          <ac:picMkLst>
            <pc:docMk/>
            <pc:sldMk cId="827945534" sldId="654"/>
            <ac:picMk id="72" creationId="{C27F3FE3-7355-4683-9D50-418D2CA241EB}"/>
          </ac:picMkLst>
        </pc:picChg>
        <pc:picChg chg="add del">
          <ac:chgData name="Hayk Barseghyan" userId="1af3c995-31f7-415e-9aa1-2b36900e994d" providerId="ADAL" clId="{70A19F8E-9ADD-45E3-8B5D-5634A3FE2C93}" dt="2021-02-10T01:13:44.285" v="929" actId="22"/>
          <ac:picMkLst>
            <pc:docMk/>
            <pc:sldMk cId="827945534" sldId="654"/>
            <ac:picMk id="77" creationId="{DA97149A-6EFB-4F08-A191-2281C0382236}"/>
          </ac:picMkLst>
        </pc:picChg>
        <pc:picChg chg="add mod topLvl">
          <ac:chgData name="Hayk Barseghyan" userId="1af3c995-31f7-415e-9aa1-2b36900e994d" providerId="ADAL" clId="{70A19F8E-9ADD-45E3-8B5D-5634A3FE2C93}" dt="2021-02-10T01:19:10.999" v="1022" actId="164"/>
          <ac:picMkLst>
            <pc:docMk/>
            <pc:sldMk cId="827945534" sldId="654"/>
            <ac:picMk id="78" creationId="{43E6FCA7-360B-4F33-9EB9-E12771BDDBAE}"/>
          </ac:picMkLst>
        </pc:picChg>
        <pc:picChg chg="add mod topLvl">
          <ac:chgData name="Hayk Barseghyan" userId="1af3c995-31f7-415e-9aa1-2b36900e994d" providerId="ADAL" clId="{70A19F8E-9ADD-45E3-8B5D-5634A3FE2C93}" dt="2021-02-10T01:19:10.999" v="1022" actId="164"/>
          <ac:picMkLst>
            <pc:docMk/>
            <pc:sldMk cId="827945534" sldId="654"/>
            <ac:picMk id="79" creationId="{4B4BA86D-68E3-4855-9F82-3A1968F086D5}"/>
          </ac:picMkLst>
        </pc:picChg>
        <pc:cxnChg chg="add del mod">
          <ac:chgData name="Hayk Barseghyan" userId="1af3c995-31f7-415e-9aa1-2b36900e994d" providerId="ADAL" clId="{70A19F8E-9ADD-45E3-8B5D-5634A3FE2C93}" dt="2021-02-10T01:38:51.604" v="1293" actId="478"/>
          <ac:cxnSpMkLst>
            <pc:docMk/>
            <pc:sldMk cId="827945534" sldId="654"/>
            <ac:cxnSpMk id="7" creationId="{53AD605F-CEE7-4A5D-BD92-3A060A17AFCE}"/>
          </ac:cxnSpMkLst>
        </pc:cxnChg>
        <pc:cxnChg chg="mod">
          <ac:chgData name="Hayk Barseghyan" userId="1af3c995-31f7-415e-9aa1-2b36900e994d" providerId="ADAL" clId="{70A19F8E-9ADD-45E3-8B5D-5634A3FE2C93}" dt="2021-02-10T01:38:07.384" v="1256" actId="208"/>
          <ac:cxnSpMkLst>
            <pc:docMk/>
            <pc:sldMk cId="827945534" sldId="654"/>
            <ac:cxnSpMk id="12" creationId="{77BFB2D3-AD99-4A46-A69B-5F7DA3AE9F40}"/>
          </ac:cxnSpMkLst>
        </pc:cxnChg>
        <pc:cxnChg chg="del mod">
          <ac:chgData name="Hayk Barseghyan" userId="1af3c995-31f7-415e-9aa1-2b36900e994d" providerId="ADAL" clId="{70A19F8E-9ADD-45E3-8B5D-5634A3FE2C93}" dt="2021-02-09T22:19:09.428" v="243" actId="478"/>
          <ac:cxnSpMkLst>
            <pc:docMk/>
            <pc:sldMk cId="827945534" sldId="654"/>
            <ac:cxnSpMk id="13" creationId="{9C5A0F15-52CF-47D7-9374-8C8C2F340DD2}"/>
          </ac:cxnSpMkLst>
        </pc:cxnChg>
        <pc:cxnChg chg="del mod">
          <ac:chgData name="Hayk Barseghyan" userId="1af3c995-31f7-415e-9aa1-2b36900e994d" providerId="ADAL" clId="{70A19F8E-9ADD-45E3-8B5D-5634A3FE2C93}" dt="2021-02-09T22:19:17.519" v="244" actId="478"/>
          <ac:cxnSpMkLst>
            <pc:docMk/>
            <pc:sldMk cId="827945534" sldId="654"/>
            <ac:cxnSpMk id="23" creationId="{B97A16ED-5542-4DD1-94CA-D032D3F72196}"/>
          </ac:cxnSpMkLst>
        </pc:cxnChg>
        <pc:cxnChg chg="del">
          <ac:chgData name="Hayk Barseghyan" userId="1af3c995-31f7-415e-9aa1-2b36900e994d" providerId="ADAL" clId="{70A19F8E-9ADD-45E3-8B5D-5634A3FE2C93}" dt="2021-02-09T22:19:17.519" v="244" actId="478"/>
          <ac:cxnSpMkLst>
            <pc:docMk/>
            <pc:sldMk cId="827945534" sldId="654"/>
            <ac:cxnSpMk id="24" creationId="{792D8F66-E748-410F-BB9B-B632B254BDFB}"/>
          </ac:cxnSpMkLst>
        </pc:cxnChg>
        <pc:cxnChg chg="del">
          <ac:chgData name="Hayk Barseghyan" userId="1af3c995-31f7-415e-9aa1-2b36900e994d" providerId="ADAL" clId="{70A19F8E-9ADD-45E3-8B5D-5634A3FE2C93}" dt="2021-02-09T22:19:17.519" v="244" actId="478"/>
          <ac:cxnSpMkLst>
            <pc:docMk/>
            <pc:sldMk cId="827945534" sldId="654"/>
            <ac:cxnSpMk id="25" creationId="{A4F48631-3605-414B-96A3-B4E7701F3903}"/>
          </ac:cxnSpMkLst>
        </pc:cxnChg>
        <pc:cxnChg chg="del">
          <ac:chgData name="Hayk Barseghyan" userId="1af3c995-31f7-415e-9aa1-2b36900e994d" providerId="ADAL" clId="{70A19F8E-9ADD-45E3-8B5D-5634A3FE2C93}" dt="2021-02-09T22:19:17.519" v="244" actId="478"/>
          <ac:cxnSpMkLst>
            <pc:docMk/>
            <pc:sldMk cId="827945534" sldId="654"/>
            <ac:cxnSpMk id="26" creationId="{251C4E22-4DE1-42F8-831F-C59D805817CB}"/>
          </ac:cxnSpMkLst>
        </pc:cxnChg>
        <pc:cxnChg chg="del">
          <ac:chgData name="Hayk Barseghyan" userId="1af3c995-31f7-415e-9aa1-2b36900e994d" providerId="ADAL" clId="{70A19F8E-9ADD-45E3-8B5D-5634A3FE2C93}" dt="2021-02-09T22:19:17.519" v="244" actId="478"/>
          <ac:cxnSpMkLst>
            <pc:docMk/>
            <pc:sldMk cId="827945534" sldId="654"/>
            <ac:cxnSpMk id="27" creationId="{3A04AB6E-BA74-4664-AB00-DE51EF69DC08}"/>
          </ac:cxnSpMkLst>
        </pc:cxnChg>
        <pc:cxnChg chg="del mod">
          <ac:chgData name="Hayk Barseghyan" userId="1af3c995-31f7-415e-9aa1-2b36900e994d" providerId="ADAL" clId="{70A19F8E-9ADD-45E3-8B5D-5634A3FE2C93}" dt="2021-02-09T23:52:21.771" v="699" actId="478"/>
          <ac:cxnSpMkLst>
            <pc:docMk/>
            <pc:sldMk cId="827945534" sldId="654"/>
            <ac:cxnSpMk id="49" creationId="{4423681D-AADF-4D62-AC9E-3FDDF18E21B9}"/>
          </ac:cxnSpMkLst>
        </pc:cxnChg>
        <pc:cxnChg chg="add mod">
          <ac:chgData name="Hayk Barseghyan" userId="1af3c995-31f7-415e-9aa1-2b36900e994d" providerId="ADAL" clId="{70A19F8E-9ADD-45E3-8B5D-5634A3FE2C93}" dt="2021-02-10T01:36:26.522" v="1254" actId="208"/>
          <ac:cxnSpMkLst>
            <pc:docMk/>
            <pc:sldMk cId="827945534" sldId="654"/>
            <ac:cxnSpMk id="49" creationId="{D482CA38-14E8-45AF-8202-90566DF01A86}"/>
          </ac:cxnSpMkLst>
        </pc:cxnChg>
        <pc:cxnChg chg="del">
          <ac:chgData name="Hayk Barseghyan" userId="1af3c995-31f7-415e-9aa1-2b36900e994d" providerId="ADAL" clId="{70A19F8E-9ADD-45E3-8B5D-5634A3FE2C93}" dt="2021-02-09T23:52:21.771" v="699" actId="478"/>
          <ac:cxnSpMkLst>
            <pc:docMk/>
            <pc:sldMk cId="827945534" sldId="654"/>
            <ac:cxnSpMk id="52" creationId="{67E81840-D31A-48DD-9275-CD08F7D6F031}"/>
          </ac:cxnSpMkLst>
        </pc:cxnChg>
        <pc:cxnChg chg="add mod">
          <ac:chgData name="Hayk Barseghyan" userId="1af3c995-31f7-415e-9aa1-2b36900e994d" providerId="ADAL" clId="{70A19F8E-9ADD-45E3-8B5D-5634A3FE2C93}" dt="2021-02-10T01:27:49.751" v="1136" actId="164"/>
          <ac:cxnSpMkLst>
            <pc:docMk/>
            <pc:sldMk cId="827945534" sldId="654"/>
            <ac:cxnSpMk id="91" creationId="{52159647-0C48-4CD2-8732-C6E92C910CDE}"/>
          </ac:cxnSpMkLst>
        </pc:cxnChg>
        <pc:cxnChg chg="add mod">
          <ac:chgData name="Hayk Barseghyan" userId="1af3c995-31f7-415e-9aa1-2b36900e994d" providerId="ADAL" clId="{70A19F8E-9ADD-45E3-8B5D-5634A3FE2C93}" dt="2021-02-10T01:27:49.751" v="1136" actId="164"/>
          <ac:cxnSpMkLst>
            <pc:docMk/>
            <pc:sldMk cId="827945534" sldId="654"/>
            <ac:cxnSpMk id="94" creationId="{60EF80C4-7832-4078-AB63-C2C9C5ADCFCD}"/>
          </ac:cxnSpMkLst>
        </pc:cxnChg>
        <pc:cxnChg chg="add mod">
          <ac:chgData name="Hayk Barseghyan" userId="1af3c995-31f7-415e-9aa1-2b36900e994d" providerId="ADAL" clId="{70A19F8E-9ADD-45E3-8B5D-5634A3FE2C93}" dt="2021-02-10T01:27:49.751" v="1136" actId="164"/>
          <ac:cxnSpMkLst>
            <pc:docMk/>
            <pc:sldMk cId="827945534" sldId="654"/>
            <ac:cxnSpMk id="98" creationId="{1DE56AF7-917F-457D-A274-D0A730100E6A}"/>
          </ac:cxnSpMkLst>
        </pc:cxnChg>
        <pc:cxnChg chg="add mod">
          <ac:chgData name="Hayk Barseghyan" userId="1af3c995-31f7-415e-9aa1-2b36900e994d" providerId="ADAL" clId="{70A19F8E-9ADD-45E3-8B5D-5634A3FE2C93}" dt="2021-02-10T01:27:49.751" v="1136" actId="164"/>
          <ac:cxnSpMkLst>
            <pc:docMk/>
            <pc:sldMk cId="827945534" sldId="654"/>
            <ac:cxnSpMk id="100" creationId="{1F9ADF56-C081-4F74-95B0-EFB91BA50260}"/>
          </ac:cxnSpMkLst>
        </pc:cxnChg>
        <pc:cxnChg chg="add mod">
          <ac:chgData name="Hayk Barseghyan" userId="1af3c995-31f7-415e-9aa1-2b36900e994d" providerId="ADAL" clId="{70A19F8E-9ADD-45E3-8B5D-5634A3FE2C93}" dt="2021-02-10T01:37:30.503" v="1255" actId="208"/>
          <ac:cxnSpMkLst>
            <pc:docMk/>
            <pc:sldMk cId="827945534" sldId="654"/>
            <ac:cxnSpMk id="112" creationId="{E249D177-7017-436F-A541-3BC956E34475}"/>
          </ac:cxnSpMkLst>
        </pc:cxnChg>
        <pc:cxnChg chg="add mod">
          <ac:chgData name="Hayk Barseghyan" userId="1af3c995-31f7-415e-9aa1-2b36900e994d" providerId="ADAL" clId="{70A19F8E-9ADD-45E3-8B5D-5634A3FE2C93}" dt="2021-02-10T01:37:30.503" v="1255" actId="208"/>
          <ac:cxnSpMkLst>
            <pc:docMk/>
            <pc:sldMk cId="827945534" sldId="654"/>
            <ac:cxnSpMk id="115" creationId="{9FD92BDB-58CD-4458-98F3-99188233AC86}"/>
          </ac:cxnSpMkLst>
        </pc:cxnChg>
      </pc:sldChg>
      <pc:sldChg chg="delSp add mod">
        <pc:chgData name="Hayk Barseghyan" userId="1af3c995-31f7-415e-9aa1-2b36900e994d" providerId="ADAL" clId="{70A19F8E-9ADD-45E3-8B5D-5634A3FE2C93}" dt="2021-02-10T00:48:22.346" v="704" actId="478"/>
        <pc:sldMkLst>
          <pc:docMk/>
          <pc:sldMk cId="1106897071" sldId="655"/>
        </pc:sldMkLst>
        <pc:grpChg chg="del">
          <ac:chgData name="Hayk Barseghyan" userId="1af3c995-31f7-415e-9aa1-2b36900e994d" providerId="ADAL" clId="{70A19F8E-9ADD-45E3-8B5D-5634A3FE2C93}" dt="2021-02-10T00:48:22.346" v="704" actId="478"/>
          <ac:grpSpMkLst>
            <pc:docMk/>
            <pc:sldMk cId="1106897071" sldId="655"/>
            <ac:grpSpMk id="13" creationId="{6A4A6CE2-B1A4-490E-9AC0-C63C634B7473}"/>
          </ac:grpSpMkLst>
        </pc:grpChg>
      </pc:sldChg>
    </pc:docChg>
  </pc:docChgLst>
  <pc:docChgLst>
    <pc:chgData name="Hayk Barseghyan" userId="1af3c995-31f7-415e-9aa1-2b36900e994d" providerId="ADAL" clId="{3ED879A1-7E81-491E-A2EB-FC02A648EDF9}"/>
    <pc:docChg chg="custSel addSld delSld modSld">
      <pc:chgData name="Hayk Barseghyan" userId="1af3c995-31f7-415e-9aa1-2b36900e994d" providerId="ADAL" clId="{3ED879A1-7E81-491E-A2EB-FC02A648EDF9}" dt="2021-06-25T18:51:11.134" v="6"/>
      <pc:docMkLst>
        <pc:docMk/>
      </pc:docMkLst>
      <pc:sldChg chg="add del">
        <pc:chgData name="Hayk Barseghyan" userId="1af3c995-31f7-415e-9aa1-2b36900e994d" providerId="ADAL" clId="{3ED879A1-7E81-491E-A2EB-FC02A648EDF9}" dt="2021-06-25T18:51:11.134" v="6"/>
        <pc:sldMkLst>
          <pc:docMk/>
          <pc:sldMk cId="1289568086" sldId="256"/>
        </pc:sldMkLst>
      </pc:sldChg>
      <pc:sldChg chg="add del">
        <pc:chgData name="Hayk Barseghyan" userId="1af3c995-31f7-415e-9aa1-2b36900e994d" providerId="ADAL" clId="{3ED879A1-7E81-491E-A2EB-FC02A648EDF9}" dt="2021-06-25T18:51:11.134" v="6"/>
        <pc:sldMkLst>
          <pc:docMk/>
          <pc:sldMk cId="2619879681" sldId="258"/>
        </pc:sldMkLst>
      </pc:sldChg>
      <pc:sldChg chg="del">
        <pc:chgData name="Hayk Barseghyan" userId="1af3c995-31f7-415e-9aa1-2b36900e994d" providerId="ADAL" clId="{3ED879A1-7E81-491E-A2EB-FC02A648EDF9}" dt="2021-06-25T18:49:03.011" v="2" actId="47"/>
        <pc:sldMkLst>
          <pc:docMk/>
          <pc:sldMk cId="2755479697" sldId="657"/>
        </pc:sldMkLst>
      </pc:sldChg>
      <pc:sldChg chg="del">
        <pc:chgData name="Hayk Barseghyan" userId="1af3c995-31f7-415e-9aa1-2b36900e994d" providerId="ADAL" clId="{3ED879A1-7E81-491E-A2EB-FC02A648EDF9}" dt="2021-06-25T18:49:02.679" v="1" actId="47"/>
        <pc:sldMkLst>
          <pc:docMk/>
          <pc:sldMk cId="47234520" sldId="663"/>
        </pc:sldMkLst>
      </pc:sldChg>
      <pc:sldChg chg="del">
        <pc:chgData name="Hayk Barseghyan" userId="1af3c995-31f7-415e-9aa1-2b36900e994d" providerId="ADAL" clId="{3ED879A1-7E81-491E-A2EB-FC02A648EDF9}" dt="2021-06-25T18:49:02.404" v="0" actId="47"/>
        <pc:sldMkLst>
          <pc:docMk/>
          <pc:sldMk cId="2324644523" sldId="667"/>
        </pc:sldMkLst>
      </pc:sldChg>
      <pc:sldChg chg="delSp mod">
        <pc:chgData name="Hayk Barseghyan" userId="1af3c995-31f7-415e-9aa1-2b36900e994d" providerId="ADAL" clId="{3ED879A1-7E81-491E-A2EB-FC02A648EDF9}" dt="2021-06-25T18:49:39.312" v="4" actId="478"/>
        <pc:sldMkLst>
          <pc:docMk/>
          <pc:sldMk cId="1326918807" sldId="673"/>
        </pc:sldMkLst>
        <pc:spChg chg="del">
          <ac:chgData name="Hayk Barseghyan" userId="1af3c995-31f7-415e-9aa1-2b36900e994d" providerId="ADAL" clId="{3ED879A1-7E81-491E-A2EB-FC02A648EDF9}" dt="2021-06-25T18:49:39.312" v="4" actId="478"/>
          <ac:spMkLst>
            <pc:docMk/>
            <pc:sldMk cId="1326918807" sldId="673"/>
            <ac:spMk id="41" creationId="{A22BB18F-5194-4153-BAC8-C262EF1DDDDE}"/>
          </ac:spMkLst>
        </pc:spChg>
      </pc:sldChg>
      <pc:sldChg chg="del">
        <pc:chgData name="Hayk Barseghyan" userId="1af3c995-31f7-415e-9aa1-2b36900e994d" providerId="ADAL" clId="{3ED879A1-7E81-491E-A2EB-FC02A648EDF9}" dt="2021-06-25T18:49:03.533" v="3" actId="47"/>
        <pc:sldMkLst>
          <pc:docMk/>
          <pc:sldMk cId="1780613847" sldId="676"/>
        </pc:sldMkLst>
      </pc:sldChg>
    </pc:docChg>
  </pc:docChgLst>
  <pc:docChgLst>
    <pc:chgData name="Hayk Barseghyan" userId="1af3c995-31f7-415e-9aa1-2b36900e994d" providerId="ADAL" clId="{6219D68C-F070-4DB1-998A-C9AA21C25743}"/>
    <pc:docChg chg="undo redo custSel addSld delSld modSld">
      <pc:chgData name="Hayk Barseghyan" userId="1af3c995-31f7-415e-9aa1-2b36900e994d" providerId="ADAL" clId="{6219D68C-F070-4DB1-998A-C9AA21C25743}" dt="2021-05-01T20:25:38.313" v="1980" actId="1076"/>
      <pc:docMkLst>
        <pc:docMk/>
      </pc:docMkLst>
      <pc:sldChg chg="addSp delSp modSp del mod">
        <pc:chgData name="Hayk Barseghyan" userId="1af3c995-31f7-415e-9aa1-2b36900e994d" providerId="ADAL" clId="{6219D68C-F070-4DB1-998A-C9AA21C25743}" dt="2021-04-23T20:07:02.716" v="1531" actId="47"/>
        <pc:sldMkLst>
          <pc:docMk/>
          <pc:sldMk cId="742313956" sldId="656"/>
        </pc:sldMkLst>
        <pc:spChg chg="add mod">
          <ac:chgData name="Hayk Barseghyan" userId="1af3c995-31f7-415e-9aa1-2b36900e994d" providerId="ADAL" clId="{6219D68C-F070-4DB1-998A-C9AA21C25743}" dt="2021-04-23T19:51:59.680" v="1498" actId="164"/>
          <ac:spMkLst>
            <pc:docMk/>
            <pc:sldMk cId="742313956" sldId="656"/>
            <ac:spMk id="11" creationId="{06001330-BC58-44F9-BB01-F2A7C4ED5966}"/>
          </ac:spMkLst>
        </pc:spChg>
        <pc:spChg chg="add mod">
          <ac:chgData name="Hayk Barseghyan" userId="1af3c995-31f7-415e-9aa1-2b36900e994d" providerId="ADAL" clId="{6219D68C-F070-4DB1-998A-C9AA21C25743}" dt="2021-04-23T19:51:59.680" v="1498" actId="164"/>
          <ac:spMkLst>
            <pc:docMk/>
            <pc:sldMk cId="742313956" sldId="656"/>
            <ac:spMk id="13" creationId="{F4750FB0-4613-4F9A-A502-BFF02B951156}"/>
          </ac:spMkLst>
        </pc:spChg>
        <pc:spChg chg="del">
          <ac:chgData name="Hayk Barseghyan" userId="1af3c995-31f7-415e-9aa1-2b36900e994d" providerId="ADAL" clId="{6219D68C-F070-4DB1-998A-C9AA21C25743}" dt="2021-04-23T17:46:00.849" v="350" actId="478"/>
          <ac:spMkLst>
            <pc:docMk/>
            <pc:sldMk cId="742313956" sldId="656"/>
            <ac:spMk id="14" creationId="{3F8EDA24-EE92-45E3-A63D-8DC82C39D29C}"/>
          </ac:spMkLst>
        </pc:spChg>
        <pc:spChg chg="add mod">
          <ac:chgData name="Hayk Barseghyan" userId="1af3c995-31f7-415e-9aa1-2b36900e994d" providerId="ADAL" clId="{6219D68C-F070-4DB1-998A-C9AA21C25743}" dt="2021-04-23T19:51:59.680" v="1498" actId="164"/>
          <ac:spMkLst>
            <pc:docMk/>
            <pc:sldMk cId="742313956" sldId="656"/>
            <ac:spMk id="15" creationId="{F69D1834-CAA6-4228-B860-B920E20E6D5E}"/>
          </ac:spMkLst>
        </pc:spChg>
        <pc:spChg chg="del">
          <ac:chgData name="Hayk Barseghyan" userId="1af3c995-31f7-415e-9aa1-2b36900e994d" providerId="ADAL" clId="{6219D68C-F070-4DB1-998A-C9AA21C25743}" dt="2021-04-23T17:46:00.849" v="350" actId="478"/>
          <ac:spMkLst>
            <pc:docMk/>
            <pc:sldMk cId="742313956" sldId="656"/>
            <ac:spMk id="17" creationId="{C7B0D6C8-86CD-445E-B412-874834C5BCE0}"/>
          </ac:spMkLst>
        </pc:spChg>
        <pc:spChg chg="del">
          <ac:chgData name="Hayk Barseghyan" userId="1af3c995-31f7-415e-9aa1-2b36900e994d" providerId="ADAL" clId="{6219D68C-F070-4DB1-998A-C9AA21C25743}" dt="2021-04-23T17:46:00.849" v="350" actId="478"/>
          <ac:spMkLst>
            <pc:docMk/>
            <pc:sldMk cId="742313956" sldId="656"/>
            <ac:spMk id="20" creationId="{1CB373C8-38EF-4E2F-A755-BBAD3481AA7D}"/>
          </ac:spMkLst>
        </pc:spChg>
        <pc:spChg chg="del">
          <ac:chgData name="Hayk Barseghyan" userId="1af3c995-31f7-415e-9aa1-2b36900e994d" providerId="ADAL" clId="{6219D68C-F070-4DB1-998A-C9AA21C25743}" dt="2021-04-23T17:46:00.849" v="350" actId="478"/>
          <ac:spMkLst>
            <pc:docMk/>
            <pc:sldMk cId="742313956" sldId="656"/>
            <ac:spMk id="21" creationId="{A03CF11F-5F5D-4149-B7B4-AC1A24BF1B35}"/>
          </ac:spMkLst>
        </pc:spChg>
        <pc:spChg chg="del">
          <ac:chgData name="Hayk Barseghyan" userId="1af3c995-31f7-415e-9aa1-2b36900e994d" providerId="ADAL" clId="{6219D68C-F070-4DB1-998A-C9AA21C25743}" dt="2021-04-23T17:46:04.475" v="351" actId="478"/>
          <ac:spMkLst>
            <pc:docMk/>
            <pc:sldMk cId="742313956" sldId="656"/>
            <ac:spMk id="23" creationId="{72FB1E45-4C94-42F2-BEA4-180DEA8D61E2}"/>
          </ac:spMkLst>
        </pc:spChg>
        <pc:spChg chg="add del mod">
          <ac:chgData name="Hayk Barseghyan" userId="1af3c995-31f7-415e-9aa1-2b36900e994d" providerId="ADAL" clId="{6219D68C-F070-4DB1-998A-C9AA21C25743}" dt="2021-04-23T17:46:23.698" v="357" actId="478"/>
          <ac:spMkLst>
            <pc:docMk/>
            <pc:sldMk cId="742313956" sldId="656"/>
            <ac:spMk id="24" creationId="{0A7187AF-1436-4851-BC2F-DB3E06DB109A}"/>
          </ac:spMkLst>
        </pc:spChg>
        <pc:spChg chg="del">
          <ac:chgData name="Hayk Barseghyan" userId="1af3c995-31f7-415e-9aa1-2b36900e994d" providerId="ADAL" clId="{6219D68C-F070-4DB1-998A-C9AA21C25743}" dt="2021-04-23T17:46:06.627" v="352" actId="478"/>
          <ac:spMkLst>
            <pc:docMk/>
            <pc:sldMk cId="742313956" sldId="656"/>
            <ac:spMk id="27" creationId="{7E9C8F3F-17F1-46F4-8548-E46075F18624}"/>
          </ac:spMkLst>
        </pc:spChg>
        <pc:spChg chg="del">
          <ac:chgData name="Hayk Barseghyan" userId="1af3c995-31f7-415e-9aa1-2b36900e994d" providerId="ADAL" clId="{6219D68C-F070-4DB1-998A-C9AA21C25743}" dt="2021-04-23T17:46:07.769" v="353" actId="478"/>
          <ac:spMkLst>
            <pc:docMk/>
            <pc:sldMk cId="742313956" sldId="656"/>
            <ac:spMk id="29" creationId="{4B5ECF8E-AC64-43BC-9AB8-D359743BF00E}"/>
          </ac:spMkLst>
        </pc:spChg>
        <pc:spChg chg="del">
          <ac:chgData name="Hayk Barseghyan" userId="1af3c995-31f7-415e-9aa1-2b36900e994d" providerId="ADAL" clId="{6219D68C-F070-4DB1-998A-C9AA21C25743}" dt="2021-04-23T17:46:07.769" v="353" actId="478"/>
          <ac:spMkLst>
            <pc:docMk/>
            <pc:sldMk cId="742313956" sldId="656"/>
            <ac:spMk id="30" creationId="{45096969-A9E3-447B-84B4-04672D0522EE}"/>
          </ac:spMkLst>
        </pc:spChg>
        <pc:spChg chg="add mod">
          <ac:chgData name="Hayk Barseghyan" userId="1af3c995-31f7-415e-9aa1-2b36900e994d" providerId="ADAL" clId="{6219D68C-F070-4DB1-998A-C9AA21C25743}" dt="2021-04-23T19:31:59.448" v="848" actId="1076"/>
          <ac:spMkLst>
            <pc:docMk/>
            <pc:sldMk cId="742313956" sldId="656"/>
            <ac:spMk id="32" creationId="{4576823C-8257-4F33-AC2D-4B2B29F14775}"/>
          </ac:spMkLst>
        </pc:spChg>
        <pc:spChg chg="del">
          <ac:chgData name="Hayk Barseghyan" userId="1af3c995-31f7-415e-9aa1-2b36900e994d" providerId="ADAL" clId="{6219D68C-F070-4DB1-998A-C9AA21C25743}" dt="2021-04-23T17:46:07.769" v="353" actId="478"/>
          <ac:spMkLst>
            <pc:docMk/>
            <pc:sldMk cId="742313956" sldId="656"/>
            <ac:spMk id="33" creationId="{8CFF7B01-E15A-4E1D-92B1-D59F9488EC80}"/>
          </ac:spMkLst>
        </pc:spChg>
        <pc:spChg chg="del">
          <ac:chgData name="Hayk Barseghyan" userId="1af3c995-31f7-415e-9aa1-2b36900e994d" providerId="ADAL" clId="{6219D68C-F070-4DB1-998A-C9AA21C25743}" dt="2021-04-23T17:46:07.769" v="353" actId="478"/>
          <ac:spMkLst>
            <pc:docMk/>
            <pc:sldMk cId="742313956" sldId="656"/>
            <ac:spMk id="34" creationId="{E9222BD2-B966-48F7-978F-1318F5D674F3}"/>
          </ac:spMkLst>
        </pc:spChg>
        <pc:spChg chg="del">
          <ac:chgData name="Hayk Barseghyan" userId="1af3c995-31f7-415e-9aa1-2b36900e994d" providerId="ADAL" clId="{6219D68C-F070-4DB1-998A-C9AA21C25743}" dt="2021-04-23T17:46:07.769" v="353" actId="478"/>
          <ac:spMkLst>
            <pc:docMk/>
            <pc:sldMk cId="742313956" sldId="656"/>
            <ac:spMk id="35" creationId="{5D34BFF3-440E-48EA-855C-E2515CE91612}"/>
          </ac:spMkLst>
        </pc:spChg>
        <pc:spChg chg="del">
          <ac:chgData name="Hayk Barseghyan" userId="1af3c995-31f7-415e-9aa1-2b36900e994d" providerId="ADAL" clId="{6219D68C-F070-4DB1-998A-C9AA21C25743}" dt="2021-04-23T17:46:00.849" v="350" actId="478"/>
          <ac:spMkLst>
            <pc:docMk/>
            <pc:sldMk cId="742313956" sldId="656"/>
            <ac:spMk id="37" creationId="{50D367EC-26C9-42C4-960C-7F17502E01D7}"/>
          </ac:spMkLst>
        </pc:spChg>
        <pc:spChg chg="del mod">
          <ac:chgData name="Hayk Barseghyan" userId="1af3c995-31f7-415e-9aa1-2b36900e994d" providerId="ADAL" clId="{6219D68C-F070-4DB1-998A-C9AA21C25743}" dt="2021-04-23T17:45:58.675" v="349" actId="478"/>
          <ac:spMkLst>
            <pc:docMk/>
            <pc:sldMk cId="742313956" sldId="656"/>
            <ac:spMk id="38" creationId="{C0DC8D2B-DAB2-47BC-8E1F-304E4713F65A}"/>
          </ac:spMkLst>
        </pc:spChg>
        <pc:spChg chg="del">
          <ac:chgData name="Hayk Barseghyan" userId="1af3c995-31f7-415e-9aa1-2b36900e994d" providerId="ADAL" clId="{6219D68C-F070-4DB1-998A-C9AA21C25743}" dt="2021-04-23T17:46:00.849" v="350" actId="478"/>
          <ac:spMkLst>
            <pc:docMk/>
            <pc:sldMk cId="742313956" sldId="656"/>
            <ac:spMk id="39" creationId="{5EF4EE1F-D110-4D27-8A39-0488338A7477}"/>
          </ac:spMkLst>
        </pc:spChg>
        <pc:spChg chg="add mod">
          <ac:chgData name="Hayk Barseghyan" userId="1af3c995-31f7-415e-9aa1-2b36900e994d" providerId="ADAL" clId="{6219D68C-F070-4DB1-998A-C9AA21C25743}" dt="2021-04-23T19:51:59.680" v="1498" actId="164"/>
          <ac:spMkLst>
            <pc:docMk/>
            <pc:sldMk cId="742313956" sldId="656"/>
            <ac:spMk id="40" creationId="{CC8EC1A9-E46A-4FB9-928B-800CD9A61386}"/>
          </ac:spMkLst>
        </pc:spChg>
        <pc:spChg chg="add mod">
          <ac:chgData name="Hayk Barseghyan" userId="1af3c995-31f7-415e-9aa1-2b36900e994d" providerId="ADAL" clId="{6219D68C-F070-4DB1-998A-C9AA21C25743}" dt="2021-04-23T19:30:31.628" v="834" actId="164"/>
          <ac:spMkLst>
            <pc:docMk/>
            <pc:sldMk cId="742313956" sldId="656"/>
            <ac:spMk id="41" creationId="{A12FFF2D-6054-478E-987E-2D10BCF962C1}"/>
          </ac:spMkLst>
        </pc:spChg>
        <pc:spChg chg="del">
          <ac:chgData name="Hayk Barseghyan" userId="1af3c995-31f7-415e-9aa1-2b36900e994d" providerId="ADAL" clId="{6219D68C-F070-4DB1-998A-C9AA21C25743}" dt="2021-04-23T17:46:00.849" v="350" actId="478"/>
          <ac:spMkLst>
            <pc:docMk/>
            <pc:sldMk cId="742313956" sldId="656"/>
            <ac:spMk id="42" creationId="{6DDBB1BF-A060-4469-8C25-83BC8B02C54D}"/>
          </ac:spMkLst>
        </pc:spChg>
        <pc:spChg chg="add mod">
          <ac:chgData name="Hayk Barseghyan" userId="1af3c995-31f7-415e-9aa1-2b36900e994d" providerId="ADAL" clId="{6219D68C-F070-4DB1-998A-C9AA21C25743}" dt="2021-04-23T19:30:31.628" v="834" actId="164"/>
          <ac:spMkLst>
            <pc:docMk/>
            <pc:sldMk cId="742313956" sldId="656"/>
            <ac:spMk id="43" creationId="{3FDAAB9C-0F54-4E9E-91F1-CAED058C877E}"/>
          </ac:spMkLst>
        </pc:spChg>
        <pc:spChg chg="add del mod">
          <ac:chgData name="Hayk Barseghyan" userId="1af3c995-31f7-415e-9aa1-2b36900e994d" providerId="ADAL" clId="{6219D68C-F070-4DB1-998A-C9AA21C25743}" dt="2021-04-23T19:39:06.872" v="1173" actId="478"/>
          <ac:spMkLst>
            <pc:docMk/>
            <pc:sldMk cId="742313956" sldId="656"/>
            <ac:spMk id="44" creationId="{B444B9DE-B724-479C-8999-A7C1E1DEF288}"/>
          </ac:spMkLst>
        </pc:spChg>
        <pc:spChg chg="add mod">
          <ac:chgData name="Hayk Barseghyan" userId="1af3c995-31f7-415e-9aa1-2b36900e994d" providerId="ADAL" clId="{6219D68C-F070-4DB1-998A-C9AA21C25743}" dt="2021-04-23T19:34:28.751" v="1025" actId="1038"/>
          <ac:spMkLst>
            <pc:docMk/>
            <pc:sldMk cId="742313956" sldId="656"/>
            <ac:spMk id="45" creationId="{DE97DEC9-9469-4AC9-AFFC-C06448B2F392}"/>
          </ac:spMkLst>
        </pc:spChg>
        <pc:spChg chg="add mod">
          <ac:chgData name="Hayk Barseghyan" userId="1af3c995-31f7-415e-9aa1-2b36900e994d" providerId="ADAL" clId="{6219D68C-F070-4DB1-998A-C9AA21C25743}" dt="2021-04-23T19:34:28.751" v="1025" actId="1038"/>
          <ac:spMkLst>
            <pc:docMk/>
            <pc:sldMk cId="742313956" sldId="656"/>
            <ac:spMk id="46" creationId="{8B0BF721-14E5-40F3-AA7F-C8B363CFF81E}"/>
          </ac:spMkLst>
        </pc:spChg>
        <pc:spChg chg="add mod">
          <ac:chgData name="Hayk Barseghyan" userId="1af3c995-31f7-415e-9aa1-2b36900e994d" providerId="ADAL" clId="{6219D68C-F070-4DB1-998A-C9AA21C25743}" dt="2021-04-23T19:34:28.751" v="1025" actId="1038"/>
          <ac:spMkLst>
            <pc:docMk/>
            <pc:sldMk cId="742313956" sldId="656"/>
            <ac:spMk id="47" creationId="{6063FE5F-9C4F-469B-BEBA-10D935F78F24}"/>
          </ac:spMkLst>
        </pc:spChg>
        <pc:spChg chg="add mod">
          <ac:chgData name="Hayk Barseghyan" userId="1af3c995-31f7-415e-9aa1-2b36900e994d" providerId="ADAL" clId="{6219D68C-F070-4DB1-998A-C9AA21C25743}" dt="2021-04-23T19:34:42.595" v="1030" actId="1035"/>
          <ac:spMkLst>
            <pc:docMk/>
            <pc:sldMk cId="742313956" sldId="656"/>
            <ac:spMk id="48" creationId="{0DD98128-F8E9-470D-AE1E-B600111913DF}"/>
          </ac:spMkLst>
        </pc:spChg>
        <pc:spChg chg="del">
          <ac:chgData name="Hayk Barseghyan" userId="1af3c995-31f7-415e-9aa1-2b36900e994d" providerId="ADAL" clId="{6219D68C-F070-4DB1-998A-C9AA21C25743}" dt="2021-04-23T17:46:11.724" v="355" actId="478"/>
          <ac:spMkLst>
            <pc:docMk/>
            <pc:sldMk cId="742313956" sldId="656"/>
            <ac:spMk id="49" creationId="{270740F3-8276-4A91-AA98-A4A4273156A7}"/>
          </ac:spMkLst>
        </pc:spChg>
        <pc:spChg chg="add mod">
          <ac:chgData name="Hayk Barseghyan" userId="1af3c995-31f7-415e-9aa1-2b36900e994d" providerId="ADAL" clId="{6219D68C-F070-4DB1-998A-C9AA21C25743}" dt="2021-04-23T19:51:59.680" v="1498" actId="164"/>
          <ac:spMkLst>
            <pc:docMk/>
            <pc:sldMk cId="742313956" sldId="656"/>
            <ac:spMk id="50" creationId="{21FD5FEF-F42F-4BCD-84C1-121B238E7E7E}"/>
          </ac:spMkLst>
        </pc:spChg>
        <pc:spChg chg="add mod">
          <ac:chgData name="Hayk Barseghyan" userId="1af3c995-31f7-415e-9aa1-2b36900e994d" providerId="ADAL" clId="{6219D68C-F070-4DB1-998A-C9AA21C25743}" dt="2021-04-23T19:51:59.680" v="1498" actId="164"/>
          <ac:spMkLst>
            <pc:docMk/>
            <pc:sldMk cId="742313956" sldId="656"/>
            <ac:spMk id="51" creationId="{5AA0D3E7-A0A0-412C-A58E-F9EC126BC901}"/>
          </ac:spMkLst>
        </pc:spChg>
        <pc:spChg chg="add mod">
          <ac:chgData name="Hayk Barseghyan" userId="1af3c995-31f7-415e-9aa1-2b36900e994d" providerId="ADAL" clId="{6219D68C-F070-4DB1-998A-C9AA21C25743}" dt="2021-04-23T19:48:57.993" v="1402" actId="1076"/>
          <ac:spMkLst>
            <pc:docMk/>
            <pc:sldMk cId="742313956" sldId="656"/>
            <ac:spMk id="57" creationId="{565C2C29-117D-432E-ACC0-619CB33A1491}"/>
          </ac:spMkLst>
        </pc:spChg>
        <pc:spChg chg="add del mod">
          <ac:chgData name="Hayk Barseghyan" userId="1af3c995-31f7-415e-9aa1-2b36900e994d" providerId="ADAL" clId="{6219D68C-F070-4DB1-998A-C9AA21C25743}" dt="2021-04-23T19:44:12.774" v="1353" actId="478"/>
          <ac:spMkLst>
            <pc:docMk/>
            <pc:sldMk cId="742313956" sldId="656"/>
            <ac:spMk id="58" creationId="{0E88591A-9828-476E-80B7-3BE557633629}"/>
          </ac:spMkLst>
        </pc:spChg>
        <pc:spChg chg="add mod">
          <ac:chgData name="Hayk Barseghyan" userId="1af3c995-31f7-415e-9aa1-2b36900e994d" providerId="ADAL" clId="{6219D68C-F070-4DB1-998A-C9AA21C25743}" dt="2021-04-23T19:49:11.232" v="1405" actId="1076"/>
          <ac:spMkLst>
            <pc:docMk/>
            <pc:sldMk cId="742313956" sldId="656"/>
            <ac:spMk id="59" creationId="{15313879-A821-4C5D-B80C-8FB52E14A5A0}"/>
          </ac:spMkLst>
        </pc:spChg>
        <pc:spChg chg="add del mod">
          <ac:chgData name="Hayk Barseghyan" userId="1af3c995-31f7-415e-9aa1-2b36900e994d" providerId="ADAL" clId="{6219D68C-F070-4DB1-998A-C9AA21C25743}" dt="2021-04-23T19:49:14.292" v="1406" actId="478"/>
          <ac:spMkLst>
            <pc:docMk/>
            <pc:sldMk cId="742313956" sldId="656"/>
            <ac:spMk id="60" creationId="{4CF924E3-E564-4950-A8FD-BFBBDE09A6CB}"/>
          </ac:spMkLst>
        </pc:spChg>
        <pc:spChg chg="add mod">
          <ac:chgData name="Hayk Barseghyan" userId="1af3c995-31f7-415e-9aa1-2b36900e994d" providerId="ADAL" clId="{6219D68C-F070-4DB1-998A-C9AA21C25743}" dt="2021-04-23T19:49:28.950" v="1409" actId="1076"/>
          <ac:spMkLst>
            <pc:docMk/>
            <pc:sldMk cId="742313956" sldId="656"/>
            <ac:spMk id="61" creationId="{C5F39450-ED40-423A-9344-E7C2FD7739A4}"/>
          </ac:spMkLst>
        </pc:spChg>
        <pc:spChg chg="add del mod">
          <ac:chgData name="Hayk Barseghyan" userId="1af3c995-31f7-415e-9aa1-2b36900e994d" providerId="ADAL" clId="{6219D68C-F070-4DB1-998A-C9AA21C25743}" dt="2021-04-23T19:49:31.920" v="1410" actId="478"/>
          <ac:spMkLst>
            <pc:docMk/>
            <pc:sldMk cId="742313956" sldId="656"/>
            <ac:spMk id="62" creationId="{E998038A-C1BD-48BF-AC19-E9115CF1D2D7}"/>
          </ac:spMkLst>
        </pc:spChg>
        <pc:spChg chg="add mod">
          <ac:chgData name="Hayk Barseghyan" userId="1af3c995-31f7-415e-9aa1-2b36900e994d" providerId="ADAL" clId="{6219D68C-F070-4DB1-998A-C9AA21C25743}" dt="2021-04-23T19:51:04.297" v="1449" actId="1035"/>
          <ac:spMkLst>
            <pc:docMk/>
            <pc:sldMk cId="742313956" sldId="656"/>
            <ac:spMk id="63" creationId="{56EDD3D2-55AE-46A2-9039-F41D796F075E}"/>
          </ac:spMkLst>
        </pc:spChg>
        <pc:spChg chg="add del mod">
          <ac:chgData name="Hayk Barseghyan" userId="1af3c995-31f7-415e-9aa1-2b36900e994d" providerId="ADAL" clId="{6219D68C-F070-4DB1-998A-C9AA21C25743}" dt="2021-04-23T19:48:05.227" v="1394" actId="478"/>
          <ac:spMkLst>
            <pc:docMk/>
            <pc:sldMk cId="742313956" sldId="656"/>
            <ac:spMk id="64" creationId="{14027FA3-AA1C-48E1-8F64-DC79AB00A645}"/>
          </ac:spMkLst>
        </pc:spChg>
        <pc:spChg chg="add del mod">
          <ac:chgData name="Hayk Barseghyan" userId="1af3c995-31f7-415e-9aa1-2b36900e994d" providerId="ADAL" clId="{6219D68C-F070-4DB1-998A-C9AA21C25743}" dt="2021-04-23T19:48:09.214" v="1395" actId="478"/>
          <ac:spMkLst>
            <pc:docMk/>
            <pc:sldMk cId="742313956" sldId="656"/>
            <ac:spMk id="65" creationId="{7757182C-274F-489F-B49C-E73E1FD5781D}"/>
          </ac:spMkLst>
        </pc:spChg>
        <pc:spChg chg="add mod">
          <ac:chgData name="Hayk Barseghyan" userId="1af3c995-31f7-415e-9aa1-2b36900e994d" providerId="ADAL" clId="{6219D68C-F070-4DB1-998A-C9AA21C25743}" dt="2021-04-23T19:51:04.297" v="1449" actId="1035"/>
          <ac:spMkLst>
            <pc:docMk/>
            <pc:sldMk cId="742313956" sldId="656"/>
            <ac:spMk id="70" creationId="{0037C422-DF3F-4D2F-ACE9-B436C9FB6D34}"/>
          </ac:spMkLst>
        </pc:spChg>
        <pc:spChg chg="add mod">
          <ac:chgData name="Hayk Barseghyan" userId="1af3c995-31f7-415e-9aa1-2b36900e994d" providerId="ADAL" clId="{6219D68C-F070-4DB1-998A-C9AA21C25743}" dt="2021-04-23T19:50:19.870" v="1418" actId="20577"/>
          <ac:spMkLst>
            <pc:docMk/>
            <pc:sldMk cId="742313956" sldId="656"/>
            <ac:spMk id="71" creationId="{89951722-6149-454D-B9E9-67A920998D34}"/>
          </ac:spMkLst>
        </pc:spChg>
        <pc:grpChg chg="add mod">
          <ac:chgData name="Hayk Barseghyan" userId="1af3c995-31f7-415e-9aa1-2b36900e994d" providerId="ADAL" clId="{6219D68C-F070-4DB1-998A-C9AA21C25743}" dt="2021-04-23T19:30:31.628" v="834" actId="164"/>
          <ac:grpSpMkLst>
            <pc:docMk/>
            <pc:sldMk cId="742313956" sldId="656"/>
            <ac:grpSpMk id="12" creationId="{F3285E57-4C16-4A30-87B2-5E177D867159}"/>
          </ac:grpSpMkLst>
        </pc:grpChg>
        <pc:grpChg chg="add mod ord">
          <ac:chgData name="Hayk Barseghyan" userId="1af3c995-31f7-415e-9aa1-2b36900e994d" providerId="ADAL" clId="{6219D68C-F070-4DB1-998A-C9AA21C25743}" dt="2021-04-23T19:52:10.994" v="1499" actId="167"/>
          <ac:grpSpMkLst>
            <pc:docMk/>
            <pc:sldMk cId="742313956" sldId="656"/>
            <ac:grpSpMk id="72" creationId="{F57D181F-CEB6-47F0-A525-2E3BFCCF0E03}"/>
          </ac:grpSpMkLst>
        </pc:grpChg>
        <pc:picChg chg="add mod">
          <ac:chgData name="Hayk Barseghyan" userId="1af3c995-31f7-415e-9aa1-2b36900e994d" providerId="ADAL" clId="{6219D68C-F070-4DB1-998A-C9AA21C25743}" dt="2021-04-23T19:51:59.680" v="1498" actId="164"/>
          <ac:picMkLst>
            <pc:docMk/>
            <pc:sldMk cId="742313956" sldId="656"/>
            <ac:picMk id="3" creationId="{3E0DEB74-E8EC-4A38-9C02-090BF6B19991}"/>
          </ac:picMkLst>
        </pc:picChg>
        <pc:picChg chg="add mod">
          <ac:chgData name="Hayk Barseghyan" userId="1af3c995-31f7-415e-9aa1-2b36900e994d" providerId="ADAL" clId="{6219D68C-F070-4DB1-998A-C9AA21C25743}" dt="2021-04-23T19:51:59.680" v="1498" actId="164"/>
          <ac:picMkLst>
            <pc:docMk/>
            <pc:sldMk cId="742313956" sldId="656"/>
            <ac:picMk id="5" creationId="{DE7B92EA-4764-4B20-8491-3CDE109E0325}"/>
          </ac:picMkLst>
        </pc:picChg>
        <pc:picChg chg="add del mod">
          <ac:chgData name="Hayk Barseghyan" userId="1af3c995-31f7-415e-9aa1-2b36900e994d" providerId="ADAL" clId="{6219D68C-F070-4DB1-998A-C9AA21C25743}" dt="2021-04-23T19:20:29.224" v="603" actId="478"/>
          <ac:picMkLst>
            <pc:docMk/>
            <pc:sldMk cId="742313956" sldId="656"/>
            <ac:picMk id="7" creationId="{E539E6AB-3CEF-4C6F-94F2-AABB3B6FCD5F}"/>
          </ac:picMkLst>
        </pc:picChg>
        <pc:picChg chg="add mod">
          <ac:chgData name="Hayk Barseghyan" userId="1af3c995-31f7-415e-9aa1-2b36900e994d" providerId="ADAL" clId="{6219D68C-F070-4DB1-998A-C9AA21C25743}" dt="2021-04-23T19:51:59.680" v="1498" actId="164"/>
          <ac:picMkLst>
            <pc:docMk/>
            <pc:sldMk cId="742313956" sldId="656"/>
            <ac:picMk id="9" creationId="{6BC207CB-9FB8-4841-B2F9-B1839F6CDA10}"/>
          </ac:picMkLst>
        </pc:picChg>
        <pc:picChg chg="del">
          <ac:chgData name="Hayk Barseghyan" userId="1af3c995-31f7-415e-9aa1-2b36900e994d" providerId="ADAL" clId="{6219D68C-F070-4DB1-998A-C9AA21C25743}" dt="2021-04-23T17:45:54.419" v="347" actId="478"/>
          <ac:picMkLst>
            <pc:docMk/>
            <pc:sldMk cId="742313956" sldId="656"/>
            <ac:picMk id="22" creationId="{201254A7-FF41-4E95-92B1-BEA41BDE41A3}"/>
          </ac:picMkLst>
        </pc:picChg>
        <pc:picChg chg="add del mod">
          <ac:chgData name="Hayk Barseghyan" userId="1af3c995-31f7-415e-9aa1-2b36900e994d" providerId="ADAL" clId="{6219D68C-F070-4DB1-998A-C9AA21C25743}" dt="2021-04-23T19:02:29.840" v="433" actId="478"/>
          <ac:picMkLst>
            <pc:docMk/>
            <pc:sldMk cId="742313956" sldId="656"/>
            <ac:picMk id="25" creationId="{B45531B4-63F0-44DD-8435-A9F8116FE313}"/>
          </ac:picMkLst>
        </pc:picChg>
        <pc:picChg chg="add del mod ord">
          <ac:chgData name="Hayk Barseghyan" userId="1af3c995-31f7-415e-9aa1-2b36900e994d" providerId="ADAL" clId="{6219D68C-F070-4DB1-998A-C9AA21C25743}" dt="2021-04-23T19:42:50.837" v="1342" actId="478"/>
          <ac:picMkLst>
            <pc:docMk/>
            <pc:sldMk cId="742313956" sldId="656"/>
            <ac:picMk id="26" creationId="{DF7F1C73-6D23-4985-A4FC-B5803171904D}"/>
          </ac:picMkLst>
        </pc:picChg>
        <pc:picChg chg="del mod">
          <ac:chgData name="Hayk Barseghyan" userId="1af3c995-31f7-415e-9aa1-2b36900e994d" providerId="ADAL" clId="{6219D68C-F070-4DB1-998A-C9AA21C25743}" dt="2021-04-23T19:01:15.587" v="424" actId="478"/>
          <ac:picMkLst>
            <pc:docMk/>
            <pc:sldMk cId="742313956" sldId="656"/>
            <ac:picMk id="36" creationId="{DBF16D19-79D0-48EF-B670-E7442E814215}"/>
          </ac:picMkLst>
        </pc:picChg>
        <pc:cxnChg chg="add mod">
          <ac:chgData name="Hayk Barseghyan" userId="1af3c995-31f7-415e-9aa1-2b36900e994d" providerId="ADAL" clId="{6219D68C-F070-4DB1-998A-C9AA21C25743}" dt="2021-04-23T19:51:59.680" v="1498" actId="164"/>
          <ac:cxnSpMkLst>
            <pc:docMk/>
            <pc:sldMk cId="742313956" sldId="656"/>
            <ac:cxnSpMk id="18" creationId="{E5ACFC3E-50ED-4222-9EAE-489B96394EA3}"/>
          </ac:cxnSpMkLst>
        </pc:cxnChg>
        <pc:cxnChg chg="add mod">
          <ac:chgData name="Hayk Barseghyan" userId="1af3c995-31f7-415e-9aa1-2b36900e994d" providerId="ADAL" clId="{6219D68C-F070-4DB1-998A-C9AA21C25743}" dt="2021-04-23T19:51:59.680" v="1498" actId="164"/>
          <ac:cxnSpMkLst>
            <pc:docMk/>
            <pc:sldMk cId="742313956" sldId="656"/>
            <ac:cxnSpMk id="52" creationId="{F9675BBF-DE6B-40D7-872E-9FEAF727A2F1}"/>
          </ac:cxnSpMkLst>
        </pc:cxnChg>
        <pc:cxnChg chg="add mod">
          <ac:chgData name="Hayk Barseghyan" userId="1af3c995-31f7-415e-9aa1-2b36900e994d" providerId="ADAL" clId="{6219D68C-F070-4DB1-998A-C9AA21C25743}" dt="2021-04-23T19:51:59.680" v="1498" actId="164"/>
          <ac:cxnSpMkLst>
            <pc:docMk/>
            <pc:sldMk cId="742313956" sldId="656"/>
            <ac:cxnSpMk id="53" creationId="{F8E8402F-9D3C-4880-8F83-3B19AE3F80A6}"/>
          </ac:cxnSpMkLst>
        </pc:cxnChg>
      </pc:sldChg>
      <pc:sldChg chg="addSp delSp modSp add del mod">
        <pc:chgData name="Hayk Barseghyan" userId="1af3c995-31f7-415e-9aa1-2b36900e994d" providerId="ADAL" clId="{6219D68C-F070-4DB1-998A-C9AA21C25743}" dt="2021-04-23T20:07:18.494" v="1535" actId="47"/>
        <pc:sldMkLst>
          <pc:docMk/>
          <pc:sldMk cId="2755479697" sldId="657"/>
        </pc:sldMkLst>
        <pc:spChg chg="add mod">
          <ac:chgData name="Hayk Barseghyan" userId="1af3c995-31f7-415e-9aa1-2b36900e994d" providerId="ADAL" clId="{6219D68C-F070-4DB1-998A-C9AA21C25743}" dt="2021-04-23T17:01:11.537" v="270" actId="1037"/>
          <ac:spMkLst>
            <pc:docMk/>
            <pc:sldMk cId="2755479697" sldId="657"/>
            <ac:spMk id="69" creationId="{39DF4C24-55AD-4AA7-8C4F-AABC6826E119}"/>
          </ac:spMkLst>
        </pc:spChg>
        <pc:spChg chg="add del mod">
          <ac:chgData name="Hayk Barseghyan" userId="1af3c995-31f7-415e-9aa1-2b36900e994d" providerId="ADAL" clId="{6219D68C-F070-4DB1-998A-C9AA21C25743}" dt="2021-04-23T16:59:38.841" v="218" actId="478"/>
          <ac:spMkLst>
            <pc:docMk/>
            <pc:sldMk cId="2755479697" sldId="657"/>
            <ac:spMk id="70" creationId="{972E7CEE-AD02-4707-BB71-6D04E7DD2977}"/>
          </ac:spMkLst>
        </pc:spChg>
        <pc:spChg chg="add mod">
          <ac:chgData name="Hayk Barseghyan" userId="1af3c995-31f7-415e-9aa1-2b36900e994d" providerId="ADAL" clId="{6219D68C-F070-4DB1-998A-C9AA21C25743}" dt="2021-04-23T17:01:23.541" v="280" actId="1037"/>
          <ac:spMkLst>
            <pc:docMk/>
            <pc:sldMk cId="2755479697" sldId="657"/>
            <ac:spMk id="71" creationId="{A199C091-2B7B-49A1-874E-C00BD79C925A}"/>
          </ac:spMkLst>
        </pc:spChg>
        <pc:spChg chg="mod">
          <ac:chgData name="Hayk Barseghyan" userId="1af3c995-31f7-415e-9aa1-2b36900e994d" providerId="ADAL" clId="{6219D68C-F070-4DB1-998A-C9AA21C25743}" dt="2021-04-23T17:01:15.347" v="274" actId="1038"/>
          <ac:spMkLst>
            <pc:docMk/>
            <pc:sldMk cId="2755479697" sldId="657"/>
            <ac:spMk id="78" creationId="{A378CE8E-FD3C-4B20-A24B-AF9809EA6C83}"/>
          </ac:spMkLst>
        </pc:spChg>
        <pc:spChg chg="del">
          <ac:chgData name="Hayk Barseghyan" userId="1af3c995-31f7-415e-9aa1-2b36900e994d" providerId="ADAL" clId="{6219D68C-F070-4DB1-998A-C9AA21C25743}" dt="2021-04-23T16:55:46.047" v="10" actId="478"/>
          <ac:spMkLst>
            <pc:docMk/>
            <pc:sldMk cId="2755479697" sldId="657"/>
            <ac:spMk id="79" creationId="{C51ADB4D-3640-45C3-80EF-5502C71420FD}"/>
          </ac:spMkLst>
        </pc:spChg>
        <pc:spChg chg="mod">
          <ac:chgData name="Hayk Barseghyan" userId="1af3c995-31f7-415e-9aa1-2b36900e994d" providerId="ADAL" clId="{6219D68C-F070-4DB1-998A-C9AA21C25743}" dt="2021-04-23T16:57:47.565" v="112" actId="14100"/>
          <ac:spMkLst>
            <pc:docMk/>
            <pc:sldMk cId="2755479697" sldId="657"/>
            <ac:spMk id="99" creationId="{5463678B-2C98-4048-B0E3-1D5FC1D58F2B}"/>
          </ac:spMkLst>
        </pc:spChg>
        <pc:picChg chg="add del mod">
          <ac:chgData name="Hayk Barseghyan" userId="1af3c995-31f7-415e-9aa1-2b36900e994d" providerId="ADAL" clId="{6219D68C-F070-4DB1-998A-C9AA21C25743}" dt="2021-04-23T16:53:20.780" v="4" actId="478"/>
          <ac:picMkLst>
            <pc:docMk/>
            <pc:sldMk cId="2755479697" sldId="657"/>
            <ac:picMk id="3" creationId="{B1854D55-3284-47E9-BA38-004FA2FC80F5}"/>
          </ac:picMkLst>
        </pc:picChg>
        <pc:picChg chg="add mod ord">
          <ac:chgData name="Hayk Barseghyan" userId="1af3c995-31f7-415e-9aa1-2b36900e994d" providerId="ADAL" clId="{6219D68C-F070-4DB1-998A-C9AA21C25743}" dt="2021-04-23T17:01:11.537" v="270" actId="1037"/>
          <ac:picMkLst>
            <pc:docMk/>
            <pc:sldMk cId="2755479697" sldId="657"/>
            <ac:picMk id="9" creationId="{8B0847C3-CE5B-4766-AF17-CBC08685E32C}"/>
          </ac:picMkLst>
        </pc:picChg>
        <pc:picChg chg="del">
          <ac:chgData name="Hayk Barseghyan" userId="1af3c995-31f7-415e-9aa1-2b36900e994d" providerId="ADAL" clId="{6219D68C-F070-4DB1-998A-C9AA21C25743}" dt="2021-04-23T16:53:24.017" v="5" actId="478"/>
          <ac:picMkLst>
            <pc:docMk/>
            <pc:sldMk cId="2755479697" sldId="657"/>
            <ac:picMk id="10" creationId="{9949D67C-CD43-476D-A15F-434A6C52C9E1}"/>
          </ac:picMkLst>
        </pc:picChg>
        <pc:picChg chg="add mod ord">
          <ac:chgData name="Hayk Barseghyan" userId="1af3c995-31f7-415e-9aa1-2b36900e994d" providerId="ADAL" clId="{6219D68C-F070-4DB1-998A-C9AA21C25743}" dt="2021-04-23T17:01:23.541" v="280" actId="1037"/>
          <ac:picMkLst>
            <pc:docMk/>
            <pc:sldMk cId="2755479697" sldId="657"/>
            <ac:picMk id="12" creationId="{24303299-FA55-4AC5-8F58-E201F7339903}"/>
          </ac:picMkLst>
        </pc:picChg>
        <pc:cxnChg chg="mod">
          <ac:chgData name="Hayk Barseghyan" userId="1af3c995-31f7-415e-9aa1-2b36900e994d" providerId="ADAL" clId="{6219D68C-F070-4DB1-998A-C9AA21C25743}" dt="2021-04-23T17:01:11.537" v="270" actId="1037"/>
          <ac:cxnSpMkLst>
            <pc:docMk/>
            <pc:sldMk cId="2755479697" sldId="657"/>
            <ac:cxnSpMk id="83" creationId="{58D0C8E9-615F-4BB4-8DBD-A90AD120C04D}"/>
          </ac:cxnSpMkLst>
        </pc:cxnChg>
        <pc:cxnChg chg="mod">
          <ac:chgData name="Hayk Barseghyan" userId="1af3c995-31f7-415e-9aa1-2b36900e994d" providerId="ADAL" clId="{6219D68C-F070-4DB1-998A-C9AA21C25743}" dt="2021-04-23T17:01:23.541" v="280" actId="1037"/>
          <ac:cxnSpMkLst>
            <pc:docMk/>
            <pc:sldMk cId="2755479697" sldId="657"/>
            <ac:cxnSpMk id="85" creationId="{0EF1E4F0-CD42-453C-B817-5170CC59B83F}"/>
          </ac:cxnSpMkLst>
        </pc:cxnChg>
        <pc:cxnChg chg="mod">
          <ac:chgData name="Hayk Barseghyan" userId="1af3c995-31f7-415e-9aa1-2b36900e994d" providerId="ADAL" clId="{6219D68C-F070-4DB1-998A-C9AA21C25743}" dt="2021-04-23T16:57:47.565" v="112" actId="14100"/>
          <ac:cxnSpMkLst>
            <pc:docMk/>
            <pc:sldMk cId="2755479697" sldId="657"/>
            <ac:cxnSpMk id="95" creationId="{16507A16-B1EA-41FC-BA29-6F79662AB745}"/>
          </ac:cxnSpMkLst>
        </pc:cxnChg>
        <pc:cxnChg chg="mod">
          <ac:chgData name="Hayk Barseghyan" userId="1af3c995-31f7-415e-9aa1-2b36900e994d" providerId="ADAL" clId="{6219D68C-F070-4DB1-998A-C9AA21C25743}" dt="2021-04-23T16:57:47.565" v="112" actId="14100"/>
          <ac:cxnSpMkLst>
            <pc:docMk/>
            <pc:sldMk cId="2755479697" sldId="657"/>
            <ac:cxnSpMk id="96" creationId="{0E9D330C-7EF6-4A8F-8BD0-1DFEE913D44D}"/>
          </ac:cxnSpMkLst>
        </pc:cxnChg>
        <pc:cxnChg chg="mod">
          <ac:chgData name="Hayk Barseghyan" userId="1af3c995-31f7-415e-9aa1-2b36900e994d" providerId="ADAL" clId="{6219D68C-F070-4DB1-998A-C9AA21C25743}" dt="2021-04-23T17:01:11.537" v="270" actId="1037"/>
          <ac:cxnSpMkLst>
            <pc:docMk/>
            <pc:sldMk cId="2755479697" sldId="657"/>
            <ac:cxnSpMk id="101" creationId="{19BBA3F5-EFCD-49F7-BDCC-66B89FA196B9}"/>
          </ac:cxnSpMkLst>
        </pc:cxnChg>
        <pc:cxnChg chg="mod">
          <ac:chgData name="Hayk Barseghyan" userId="1af3c995-31f7-415e-9aa1-2b36900e994d" providerId="ADAL" clId="{6219D68C-F070-4DB1-998A-C9AA21C25743}" dt="2021-04-23T17:01:23.541" v="280" actId="1037"/>
          <ac:cxnSpMkLst>
            <pc:docMk/>
            <pc:sldMk cId="2755479697" sldId="657"/>
            <ac:cxnSpMk id="104" creationId="{05153E8D-36D1-430B-B3A6-660A80B985D2}"/>
          </ac:cxnSpMkLst>
        </pc:cxnChg>
      </pc:sldChg>
      <pc:sldChg chg="addSp delSp modSp mod modNotesTx">
        <pc:chgData name="Hayk Barseghyan" userId="1af3c995-31f7-415e-9aa1-2b36900e994d" providerId="ADAL" clId="{6219D68C-F070-4DB1-998A-C9AA21C25743}" dt="2021-05-01T20:25:37.760" v="1979" actId="478"/>
        <pc:sldMkLst>
          <pc:docMk/>
          <pc:sldMk cId="47234520" sldId="663"/>
        </pc:sldMkLst>
        <pc:spChg chg="mod">
          <ac:chgData name="Hayk Barseghyan" userId="1af3c995-31f7-415e-9aa1-2b36900e994d" providerId="ADAL" clId="{6219D68C-F070-4DB1-998A-C9AA21C25743}" dt="2021-05-01T20:25:22.312" v="1965" actId="1035"/>
          <ac:spMkLst>
            <pc:docMk/>
            <pc:sldMk cId="47234520" sldId="663"/>
            <ac:spMk id="73" creationId="{DD4811A7-E0A9-41B3-B8DC-E47701716FAF}"/>
          </ac:spMkLst>
        </pc:spChg>
        <pc:spChg chg="mod">
          <ac:chgData name="Hayk Barseghyan" userId="1af3c995-31f7-415e-9aa1-2b36900e994d" providerId="ADAL" clId="{6219D68C-F070-4DB1-998A-C9AA21C25743}" dt="2021-05-01T20:25:23.399" v="1968" actId="1035"/>
          <ac:spMkLst>
            <pc:docMk/>
            <pc:sldMk cId="47234520" sldId="663"/>
            <ac:spMk id="75" creationId="{55B29BB4-4DA3-430F-8130-CB66A2BD6D32}"/>
          </ac:spMkLst>
        </pc:spChg>
        <pc:spChg chg="mod">
          <ac:chgData name="Hayk Barseghyan" userId="1af3c995-31f7-415e-9aa1-2b36900e994d" providerId="ADAL" clId="{6219D68C-F070-4DB1-998A-C9AA21C25743}" dt="2021-05-01T20:25:20.820" v="1959" actId="1035"/>
          <ac:spMkLst>
            <pc:docMk/>
            <pc:sldMk cId="47234520" sldId="663"/>
            <ac:spMk id="76" creationId="{A9DF7FB2-24F6-4FB2-AD52-8402A21DCAEF}"/>
          </ac:spMkLst>
        </pc:spChg>
        <pc:picChg chg="add del">
          <ac:chgData name="Hayk Barseghyan" userId="1af3c995-31f7-415e-9aa1-2b36900e994d" providerId="ADAL" clId="{6219D68C-F070-4DB1-998A-C9AA21C25743}" dt="2021-05-01T20:25:37.760" v="1979" actId="478"/>
          <ac:picMkLst>
            <pc:docMk/>
            <pc:sldMk cId="47234520" sldId="663"/>
            <ac:picMk id="8" creationId="{4D1E0338-6129-41F0-94D9-1DCA45EAD7A9}"/>
          </ac:picMkLst>
        </pc:picChg>
        <pc:cxnChg chg="add del mod">
          <ac:chgData name="Hayk Barseghyan" userId="1af3c995-31f7-415e-9aa1-2b36900e994d" providerId="ADAL" clId="{6219D68C-F070-4DB1-998A-C9AA21C25743}" dt="2021-05-01T20:25:37.529" v="1978" actId="11529"/>
          <ac:cxnSpMkLst>
            <pc:docMk/>
            <pc:sldMk cId="47234520" sldId="663"/>
            <ac:cxnSpMk id="5" creationId="{F454AFEB-4972-4B51-93C9-59FFBD54285F}"/>
          </ac:cxnSpMkLst>
        </pc:cxnChg>
      </pc:sldChg>
      <pc:sldChg chg="modSp mod modNotesTx">
        <pc:chgData name="Hayk Barseghyan" userId="1af3c995-31f7-415e-9aa1-2b36900e994d" providerId="ADAL" clId="{6219D68C-F070-4DB1-998A-C9AA21C25743}" dt="2021-04-30T18:19:28.298" v="1644" actId="14100"/>
        <pc:sldMkLst>
          <pc:docMk/>
          <pc:sldMk cId="2324644523" sldId="667"/>
        </pc:sldMkLst>
        <pc:picChg chg="mod">
          <ac:chgData name="Hayk Barseghyan" userId="1af3c995-31f7-415e-9aa1-2b36900e994d" providerId="ADAL" clId="{6219D68C-F070-4DB1-998A-C9AA21C25743}" dt="2021-04-30T18:19:28.298" v="1644" actId="14100"/>
          <ac:picMkLst>
            <pc:docMk/>
            <pc:sldMk cId="2324644523" sldId="667"/>
            <ac:picMk id="12" creationId="{275784C0-4287-4244-9FF5-6076621E868E}"/>
          </ac:picMkLst>
        </pc:picChg>
      </pc:sldChg>
      <pc:sldChg chg="del">
        <pc:chgData name="Hayk Barseghyan" userId="1af3c995-31f7-415e-9aa1-2b36900e994d" providerId="ADAL" clId="{6219D68C-F070-4DB1-998A-C9AA21C25743}" dt="2021-04-23T20:11:12.879" v="1540" actId="47"/>
        <pc:sldMkLst>
          <pc:docMk/>
          <pc:sldMk cId="511255801" sldId="669"/>
        </pc:sldMkLst>
      </pc:sldChg>
      <pc:sldChg chg="del">
        <pc:chgData name="Hayk Barseghyan" userId="1af3c995-31f7-415e-9aa1-2b36900e994d" providerId="ADAL" clId="{6219D68C-F070-4DB1-998A-C9AA21C25743}" dt="2021-04-23T20:11:11.022" v="1539" actId="47"/>
        <pc:sldMkLst>
          <pc:docMk/>
          <pc:sldMk cId="1941966632" sldId="670"/>
        </pc:sldMkLst>
      </pc:sldChg>
      <pc:sldChg chg="del">
        <pc:chgData name="Hayk Barseghyan" userId="1af3c995-31f7-415e-9aa1-2b36900e994d" providerId="ADAL" clId="{6219D68C-F070-4DB1-998A-C9AA21C25743}" dt="2021-04-23T20:07:05.590" v="1532" actId="47"/>
        <pc:sldMkLst>
          <pc:docMk/>
          <pc:sldMk cId="4227624210" sldId="672"/>
        </pc:sldMkLst>
      </pc:sldChg>
      <pc:sldChg chg="del">
        <pc:chgData name="Hayk Barseghyan" userId="1af3c995-31f7-415e-9aa1-2b36900e994d" providerId="ADAL" clId="{6219D68C-F070-4DB1-998A-C9AA21C25743}" dt="2021-04-23T20:10:56.304" v="1537" actId="47"/>
        <pc:sldMkLst>
          <pc:docMk/>
          <pc:sldMk cId="1199739442" sldId="674"/>
        </pc:sldMkLst>
      </pc:sldChg>
      <pc:sldChg chg="del">
        <pc:chgData name="Hayk Barseghyan" userId="1af3c995-31f7-415e-9aa1-2b36900e994d" providerId="ADAL" clId="{6219D68C-F070-4DB1-998A-C9AA21C25743}" dt="2021-04-23T20:10:57.849" v="1538" actId="47"/>
        <pc:sldMkLst>
          <pc:docMk/>
          <pc:sldMk cId="3274253545" sldId="675"/>
        </pc:sldMkLst>
      </pc:sldChg>
      <pc:sldChg chg="addSp delSp modSp add del mod modNotesTx">
        <pc:chgData name="Hayk Barseghyan" userId="1af3c995-31f7-415e-9aa1-2b36900e994d" providerId="ADAL" clId="{6219D68C-F070-4DB1-998A-C9AA21C25743}" dt="2021-05-01T20:25:38.313" v="1980" actId="1076"/>
        <pc:sldMkLst>
          <pc:docMk/>
          <pc:sldMk cId="1780613847" sldId="676"/>
        </pc:sldMkLst>
        <pc:spChg chg="mod">
          <ac:chgData name="Hayk Barseghyan" userId="1af3c995-31f7-415e-9aa1-2b36900e994d" providerId="ADAL" clId="{6219D68C-F070-4DB1-998A-C9AA21C25743}" dt="2021-04-23T19:56:14.324" v="1526" actId="1076"/>
          <ac:spMkLst>
            <pc:docMk/>
            <pc:sldMk cId="1780613847" sldId="676"/>
            <ac:spMk id="33" creationId="{27D04DB1-6D7F-4335-AAA1-99D44F3F14E9}"/>
          </ac:spMkLst>
        </pc:spChg>
        <pc:spChg chg="add mod">
          <ac:chgData name="Hayk Barseghyan" userId="1af3c995-31f7-415e-9aa1-2b36900e994d" providerId="ADAL" clId="{6219D68C-F070-4DB1-998A-C9AA21C25743}" dt="2021-04-23T19:56:18.882" v="1527" actId="1076"/>
          <ac:spMkLst>
            <pc:docMk/>
            <pc:sldMk cId="1780613847" sldId="676"/>
            <ac:spMk id="34" creationId="{CD96114C-9ECA-4181-9AAA-3D8F6DDCCA44}"/>
          </ac:spMkLst>
        </pc:spChg>
        <pc:spChg chg="add mod">
          <ac:chgData name="Hayk Barseghyan" userId="1af3c995-31f7-415e-9aa1-2b36900e994d" providerId="ADAL" clId="{6219D68C-F070-4DB1-998A-C9AA21C25743}" dt="2021-05-01T20:25:38.313" v="1980" actId="1076"/>
          <ac:spMkLst>
            <pc:docMk/>
            <pc:sldMk cId="1780613847" sldId="676"/>
            <ac:spMk id="35" creationId="{ACD90391-5370-403C-9017-A237DB8E9FD0}"/>
          </ac:spMkLst>
        </pc:spChg>
        <pc:spChg chg="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41" creationId="{7675D8CC-8FDF-4DC2-B06E-CCBDA767CC0F}"/>
          </ac:spMkLst>
        </pc:spChg>
        <pc:spChg chg="del">
          <ac:chgData name="Hayk Barseghyan" userId="1af3c995-31f7-415e-9aa1-2b36900e994d" providerId="ADAL" clId="{6219D68C-F070-4DB1-998A-C9AA21C25743}" dt="2021-04-23T17:44:10.508" v="323" actId="478"/>
          <ac:spMkLst>
            <pc:docMk/>
            <pc:sldMk cId="1780613847" sldId="676"/>
            <ac:spMk id="42" creationId="{A6A7EB23-F2F1-4B41-AF1C-F4019CBB76B4}"/>
          </ac:spMkLst>
        </pc:spChg>
        <pc:spChg chg="del">
          <ac:chgData name="Hayk Barseghyan" userId="1af3c995-31f7-415e-9aa1-2b36900e994d" providerId="ADAL" clId="{6219D68C-F070-4DB1-998A-C9AA21C25743}" dt="2021-04-23T18:32:37.094" v="378" actId="478"/>
          <ac:spMkLst>
            <pc:docMk/>
            <pc:sldMk cId="1780613847" sldId="676"/>
            <ac:spMk id="43" creationId="{22614E9B-0192-4105-BED4-42AFDEB76135}"/>
          </ac:spMkLst>
        </pc:spChg>
        <pc:spChg chg="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44" creationId="{4AE0062C-19A5-49C0-BAEB-2D7874B942F8}"/>
          </ac:spMkLst>
        </pc:spChg>
        <pc:spChg chg="mod">
          <ac:chgData name="Hayk Barseghyan" userId="1af3c995-31f7-415e-9aa1-2b36900e994d" providerId="ADAL" clId="{6219D68C-F070-4DB1-998A-C9AA21C25743}" dt="2021-04-23T19:57:01.980" v="1529" actId="1582"/>
          <ac:spMkLst>
            <pc:docMk/>
            <pc:sldMk cId="1780613847" sldId="676"/>
            <ac:spMk id="45" creationId="{1390E846-F705-43D4-9C87-ED6365A226C2}"/>
          </ac:spMkLst>
        </pc:spChg>
        <pc:spChg chg="del">
          <ac:chgData name="Hayk Barseghyan" userId="1af3c995-31f7-415e-9aa1-2b36900e994d" providerId="ADAL" clId="{6219D68C-F070-4DB1-998A-C9AA21C25743}" dt="2021-04-23T18:32:37.094" v="378" actId="478"/>
          <ac:spMkLst>
            <pc:docMk/>
            <pc:sldMk cId="1780613847" sldId="676"/>
            <ac:spMk id="46" creationId="{CFC0E298-E244-4D43-AC83-9C57B99A2027}"/>
          </ac:spMkLst>
        </pc:spChg>
        <pc:spChg chg="mod">
          <ac:chgData name="Hayk Barseghyan" userId="1af3c995-31f7-415e-9aa1-2b36900e994d" providerId="ADAL" clId="{6219D68C-F070-4DB1-998A-C9AA21C25743}" dt="2021-04-23T19:57:01.980" v="1529" actId="1582"/>
          <ac:spMkLst>
            <pc:docMk/>
            <pc:sldMk cId="1780613847" sldId="676"/>
            <ac:spMk id="47" creationId="{19528131-C37C-40EF-832B-232C7911505A}"/>
          </ac:spMkLst>
        </pc:spChg>
        <pc:spChg chg="mod">
          <ac:chgData name="Hayk Barseghyan" userId="1af3c995-31f7-415e-9aa1-2b36900e994d" providerId="ADAL" clId="{6219D68C-F070-4DB1-998A-C9AA21C25743}" dt="2021-04-23T19:57:01.980" v="1529" actId="1582"/>
          <ac:spMkLst>
            <pc:docMk/>
            <pc:sldMk cId="1780613847" sldId="676"/>
            <ac:spMk id="48" creationId="{58C12CD4-2E96-44DE-B29A-5990E95761B2}"/>
          </ac:spMkLst>
        </pc:spChg>
        <pc:spChg chg="mod">
          <ac:chgData name="Hayk Barseghyan" userId="1af3c995-31f7-415e-9aa1-2b36900e994d" providerId="ADAL" clId="{6219D68C-F070-4DB1-998A-C9AA21C25743}" dt="2021-04-23T19:57:01.980" v="1529" actId="1582"/>
          <ac:spMkLst>
            <pc:docMk/>
            <pc:sldMk cId="1780613847" sldId="676"/>
            <ac:spMk id="49" creationId="{0F9DCDB2-C370-467F-8574-B0563F8D8F68}"/>
          </ac:spMkLst>
        </pc:spChg>
        <pc:spChg chg="del">
          <ac:chgData name="Hayk Barseghyan" userId="1af3c995-31f7-415e-9aa1-2b36900e994d" providerId="ADAL" clId="{6219D68C-F070-4DB1-998A-C9AA21C25743}" dt="2021-04-23T17:44:10.508" v="323" actId="478"/>
          <ac:spMkLst>
            <pc:docMk/>
            <pc:sldMk cId="1780613847" sldId="676"/>
            <ac:spMk id="51" creationId="{9798F9A3-1382-497E-B44B-594D4B24624B}"/>
          </ac:spMkLst>
        </pc:spChg>
        <pc:spChg chg="del">
          <ac:chgData name="Hayk Barseghyan" userId="1af3c995-31f7-415e-9aa1-2b36900e994d" providerId="ADAL" clId="{6219D68C-F070-4DB1-998A-C9AA21C25743}" dt="2021-04-23T17:42:44.861" v="322" actId="478"/>
          <ac:spMkLst>
            <pc:docMk/>
            <pc:sldMk cId="1780613847" sldId="676"/>
            <ac:spMk id="52" creationId="{A3E4ADEA-8569-4795-BE33-9F69F442A45E}"/>
          </ac:spMkLst>
        </pc:spChg>
        <pc:spChg chg="del">
          <ac:chgData name="Hayk Barseghyan" userId="1af3c995-31f7-415e-9aa1-2b36900e994d" providerId="ADAL" clId="{6219D68C-F070-4DB1-998A-C9AA21C25743}" dt="2021-04-23T17:44:10.508" v="323" actId="478"/>
          <ac:spMkLst>
            <pc:docMk/>
            <pc:sldMk cId="1780613847" sldId="676"/>
            <ac:spMk id="53" creationId="{5327C358-684E-4D6A-80D1-00FE015EB529}"/>
          </ac:spMkLst>
        </pc:spChg>
        <pc:spChg chg="del">
          <ac:chgData name="Hayk Barseghyan" userId="1af3c995-31f7-415e-9aa1-2b36900e994d" providerId="ADAL" clId="{6219D68C-F070-4DB1-998A-C9AA21C25743}" dt="2021-04-23T17:44:10.508" v="323" actId="478"/>
          <ac:spMkLst>
            <pc:docMk/>
            <pc:sldMk cId="1780613847" sldId="676"/>
            <ac:spMk id="56" creationId="{B7D042E6-A9A2-4A90-94A4-3A23DC3ECE2B}"/>
          </ac:spMkLst>
        </pc:spChg>
        <pc:spChg chg="del">
          <ac:chgData name="Hayk Barseghyan" userId="1af3c995-31f7-415e-9aa1-2b36900e994d" providerId="ADAL" clId="{6219D68C-F070-4DB1-998A-C9AA21C25743}" dt="2021-04-23T17:44:10.508" v="323" actId="478"/>
          <ac:spMkLst>
            <pc:docMk/>
            <pc:sldMk cId="1780613847" sldId="676"/>
            <ac:spMk id="57" creationId="{508547CC-91BF-4ACA-AF7D-3F69DF44DE59}"/>
          </ac:spMkLst>
        </pc:spChg>
        <pc:spChg chg="del">
          <ac:chgData name="Hayk Barseghyan" userId="1af3c995-31f7-415e-9aa1-2b36900e994d" providerId="ADAL" clId="{6219D68C-F070-4DB1-998A-C9AA21C25743}" dt="2021-04-23T17:44:10.508" v="323" actId="478"/>
          <ac:spMkLst>
            <pc:docMk/>
            <pc:sldMk cId="1780613847" sldId="676"/>
            <ac:spMk id="58" creationId="{D61BAF5E-4DA2-43A9-B710-E5677683F7C5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59" creationId="{5AC728AF-3C27-4013-8586-0577382227E7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60" creationId="{1ED5E4CE-3FC3-4CAC-A509-3999A5988FE4}"/>
          </ac:spMkLst>
        </pc:spChg>
        <pc:spChg chg="del">
          <ac:chgData name="Hayk Barseghyan" userId="1af3c995-31f7-415e-9aa1-2b36900e994d" providerId="ADAL" clId="{6219D68C-F070-4DB1-998A-C9AA21C25743}" dt="2021-04-23T17:42:21.047" v="315" actId="478"/>
          <ac:spMkLst>
            <pc:docMk/>
            <pc:sldMk cId="1780613847" sldId="676"/>
            <ac:spMk id="61" creationId="{4AB0CFBE-6ABA-471B-B7F6-97AC3847E8C1}"/>
          </ac:spMkLst>
        </pc:spChg>
        <pc:spChg chg="del mod">
          <ac:chgData name="Hayk Barseghyan" userId="1af3c995-31f7-415e-9aa1-2b36900e994d" providerId="ADAL" clId="{6219D68C-F070-4DB1-998A-C9AA21C25743}" dt="2021-04-23T18:31:31.997" v="376" actId="478"/>
          <ac:spMkLst>
            <pc:docMk/>
            <pc:sldMk cId="1780613847" sldId="676"/>
            <ac:spMk id="62" creationId="{23588E92-8DCF-4B53-A51D-C88D2224D1CF}"/>
          </ac:spMkLst>
        </pc:spChg>
        <pc:spChg chg="mod">
          <ac:chgData name="Hayk Barseghyan" userId="1af3c995-31f7-415e-9aa1-2b36900e994d" providerId="ADAL" clId="{6219D68C-F070-4DB1-998A-C9AA21C25743}" dt="2021-05-01T20:25:38.313" v="1980" actId="1076"/>
          <ac:spMkLst>
            <pc:docMk/>
            <pc:sldMk cId="1780613847" sldId="676"/>
            <ac:spMk id="63" creationId="{84F934A4-611F-44FB-8B13-D0CABF74578C}"/>
          </ac:spMkLst>
        </pc:spChg>
        <pc:spChg chg="mod">
          <ac:chgData name="Hayk Barseghyan" userId="1af3c995-31f7-415e-9aa1-2b36900e994d" providerId="ADAL" clId="{6219D68C-F070-4DB1-998A-C9AA21C25743}" dt="2021-05-01T20:25:38.313" v="1980" actId="1076"/>
          <ac:spMkLst>
            <pc:docMk/>
            <pc:sldMk cId="1780613847" sldId="676"/>
            <ac:spMk id="64" creationId="{D5B88C53-1267-43E9-A872-7A27541480C4}"/>
          </ac:spMkLst>
        </pc:spChg>
        <pc:spChg chg="mod">
          <ac:chgData name="Hayk Barseghyan" userId="1af3c995-31f7-415e-9aa1-2b36900e994d" providerId="ADAL" clId="{6219D68C-F070-4DB1-998A-C9AA21C25743}" dt="2021-05-01T20:25:38.313" v="1980" actId="1076"/>
          <ac:spMkLst>
            <pc:docMk/>
            <pc:sldMk cId="1780613847" sldId="676"/>
            <ac:spMk id="65" creationId="{A90A70B5-00F7-4E46-850E-09FB5CC72DFB}"/>
          </ac:spMkLst>
        </pc:spChg>
        <pc:spChg chg="del mod">
          <ac:chgData name="Hayk Barseghyan" userId="1af3c995-31f7-415e-9aa1-2b36900e994d" providerId="ADAL" clId="{6219D68C-F070-4DB1-998A-C9AA21C25743}" dt="2021-04-23T17:41:53.047" v="309" actId="478"/>
          <ac:spMkLst>
            <pc:docMk/>
            <pc:sldMk cId="1780613847" sldId="676"/>
            <ac:spMk id="66" creationId="{A2FE0F7F-F9F3-4884-A6A9-F306AB7775ED}"/>
          </ac:spMkLst>
        </pc:spChg>
        <pc:spChg chg="del mod">
          <ac:chgData name="Hayk Barseghyan" userId="1af3c995-31f7-415e-9aa1-2b36900e994d" providerId="ADAL" clId="{6219D68C-F070-4DB1-998A-C9AA21C25743}" dt="2021-04-23T17:41:51.928" v="308" actId="478"/>
          <ac:spMkLst>
            <pc:docMk/>
            <pc:sldMk cId="1780613847" sldId="676"/>
            <ac:spMk id="67" creationId="{0588F349-52E1-473B-A019-10F0D9E8FC63}"/>
          </ac:spMkLst>
        </pc:spChg>
        <pc:spChg chg="mod">
          <ac:chgData name="Hayk Barseghyan" userId="1af3c995-31f7-415e-9aa1-2b36900e994d" providerId="ADAL" clId="{6219D68C-F070-4DB1-998A-C9AA21C25743}" dt="2021-05-01T20:25:38.313" v="1980" actId="1076"/>
          <ac:spMkLst>
            <pc:docMk/>
            <pc:sldMk cId="1780613847" sldId="676"/>
            <ac:spMk id="68" creationId="{F6139559-FC2A-456A-8342-94F20EB84DD2}"/>
          </ac:spMkLst>
        </pc:spChg>
        <pc:spChg chg="mod">
          <ac:chgData name="Hayk Barseghyan" userId="1af3c995-31f7-415e-9aa1-2b36900e994d" providerId="ADAL" clId="{6219D68C-F070-4DB1-998A-C9AA21C25743}" dt="2021-05-01T20:25:38.313" v="1980" actId="1076"/>
          <ac:spMkLst>
            <pc:docMk/>
            <pc:sldMk cId="1780613847" sldId="676"/>
            <ac:spMk id="69" creationId="{A6CFF939-AB11-4DF5-BA33-A3B1F23EFC9C}"/>
          </ac:spMkLst>
        </pc:spChg>
        <pc:spChg chg="del">
          <ac:chgData name="Hayk Barseghyan" userId="1af3c995-31f7-415e-9aa1-2b36900e994d" providerId="ADAL" clId="{6219D68C-F070-4DB1-998A-C9AA21C25743}" dt="2021-04-23T18:31:32.714" v="377" actId="478"/>
          <ac:spMkLst>
            <pc:docMk/>
            <pc:sldMk cId="1780613847" sldId="676"/>
            <ac:spMk id="70" creationId="{8031B137-C3F0-4779-9A51-6370A0030434}"/>
          </ac:spMkLst>
        </pc:spChg>
        <pc:spChg chg="del">
          <ac:chgData name="Hayk Barseghyan" userId="1af3c995-31f7-415e-9aa1-2b36900e994d" providerId="ADAL" clId="{6219D68C-F070-4DB1-998A-C9AA21C25743}" dt="2021-04-23T17:14:01.755" v="287" actId="478"/>
          <ac:spMkLst>
            <pc:docMk/>
            <pc:sldMk cId="1780613847" sldId="676"/>
            <ac:spMk id="71" creationId="{73C2C6F9-B109-4E92-92DC-92B593CE93A7}"/>
          </ac:spMkLst>
        </pc:spChg>
        <pc:spChg chg="del">
          <ac:chgData name="Hayk Barseghyan" userId="1af3c995-31f7-415e-9aa1-2b36900e994d" providerId="ADAL" clId="{6219D68C-F070-4DB1-998A-C9AA21C25743}" dt="2021-04-23T18:32:38.483" v="379" actId="478"/>
          <ac:spMkLst>
            <pc:docMk/>
            <pc:sldMk cId="1780613847" sldId="676"/>
            <ac:spMk id="72" creationId="{AF7DFB1A-BADD-46CE-A117-AF4B7269888D}"/>
          </ac:spMkLst>
        </pc:spChg>
        <pc:spChg chg="del">
          <ac:chgData name="Hayk Barseghyan" userId="1af3c995-31f7-415e-9aa1-2b36900e994d" providerId="ADAL" clId="{6219D68C-F070-4DB1-998A-C9AA21C25743}" dt="2021-04-23T17:14:10.155" v="288" actId="478"/>
          <ac:spMkLst>
            <pc:docMk/>
            <pc:sldMk cId="1780613847" sldId="676"/>
            <ac:spMk id="73" creationId="{DD4811A7-E0A9-41B3-B8DC-E47701716FAF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74" creationId="{5E088D17-1CDB-406E-8B7D-027CA736B15B}"/>
          </ac:spMkLst>
        </pc:spChg>
        <pc:spChg chg="del">
          <ac:chgData name="Hayk Barseghyan" userId="1af3c995-31f7-415e-9aa1-2b36900e994d" providerId="ADAL" clId="{6219D68C-F070-4DB1-998A-C9AA21C25743}" dt="2021-04-23T17:14:12.081" v="289" actId="478"/>
          <ac:spMkLst>
            <pc:docMk/>
            <pc:sldMk cId="1780613847" sldId="676"/>
            <ac:spMk id="75" creationId="{55B29BB4-4DA3-430F-8130-CB66A2BD6D32}"/>
          </ac:spMkLst>
        </pc:spChg>
        <pc:spChg chg="del">
          <ac:chgData name="Hayk Barseghyan" userId="1af3c995-31f7-415e-9aa1-2b36900e994d" providerId="ADAL" clId="{6219D68C-F070-4DB1-998A-C9AA21C25743}" dt="2021-04-23T17:14:14.027" v="290" actId="478"/>
          <ac:spMkLst>
            <pc:docMk/>
            <pc:sldMk cId="1780613847" sldId="676"/>
            <ac:spMk id="76" creationId="{A9DF7FB2-24F6-4FB2-AD52-8402A21DCAEF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77" creationId="{49E6A42D-2CBB-4BA9-8F94-584B53097622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78" creationId="{30D9B1ED-CD2C-408D-98BA-9F14BE9D3799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79" creationId="{B2862F03-407E-4A31-B23D-9B69B9228188}"/>
          </ac:spMkLst>
        </pc:spChg>
        <pc:spChg chg="add mod">
          <ac:chgData name="Hayk Barseghyan" userId="1af3c995-31f7-415e-9aa1-2b36900e994d" providerId="ADAL" clId="{6219D68C-F070-4DB1-998A-C9AA21C25743}" dt="2021-04-23T19:57:11.774" v="1530" actId="2085"/>
          <ac:spMkLst>
            <pc:docMk/>
            <pc:sldMk cId="1780613847" sldId="676"/>
            <ac:spMk id="80" creationId="{9D7A9385-B053-4758-B16A-EBAA3B5FBD01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81" creationId="{B5EFB9BC-8A19-4FD1-9F4E-9DD0D8DD7704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82" creationId="{0026D85C-A647-4512-9856-0411890C3DA1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83" creationId="{F5D571F9-32C0-4F2C-9AFC-808CC16FE4BB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84" creationId="{9BC84427-16C4-4C7A-BA2C-ECAE23D81E60}"/>
          </ac:spMkLst>
        </pc:spChg>
        <pc:spChg chg="add mod">
          <ac:chgData name="Hayk Barseghyan" userId="1af3c995-31f7-415e-9aa1-2b36900e994d" providerId="ADAL" clId="{6219D68C-F070-4DB1-998A-C9AA21C25743}" dt="2021-04-23T19:55:03.083" v="1521" actId="404"/>
          <ac:spMkLst>
            <pc:docMk/>
            <pc:sldMk cId="1780613847" sldId="676"/>
            <ac:spMk id="85" creationId="{B81C8CCF-1848-4F5A-B5C6-8DC571AC5DA8}"/>
          </ac:spMkLst>
        </pc:spChg>
        <pc:grpChg chg="add mod">
          <ac:chgData name="Hayk Barseghyan" userId="1af3c995-31f7-415e-9aa1-2b36900e994d" providerId="ADAL" clId="{6219D68C-F070-4DB1-998A-C9AA21C25743}" dt="2021-05-01T20:25:38.313" v="1980" actId="1076"/>
          <ac:grpSpMkLst>
            <pc:docMk/>
            <pc:sldMk cId="1780613847" sldId="676"/>
            <ac:grpSpMk id="7" creationId="{3EC1877B-FA2D-43B4-9ED5-CB4DBF6B7674}"/>
          </ac:grpSpMkLst>
        </pc:grpChg>
        <pc:grpChg chg="add mod">
          <ac:chgData name="Hayk Barseghyan" userId="1af3c995-31f7-415e-9aa1-2b36900e994d" providerId="ADAL" clId="{6219D68C-F070-4DB1-998A-C9AA21C25743}" dt="2021-04-23T19:54:46.440" v="1513" actId="164"/>
          <ac:grpSpMkLst>
            <pc:docMk/>
            <pc:sldMk cId="1780613847" sldId="676"/>
            <ac:grpSpMk id="37" creationId="{7DA96F6F-1449-4817-867D-F403B288E5DA}"/>
          </ac:grpSpMkLst>
        </pc:grpChg>
        <pc:picChg chg="del">
          <ac:chgData name="Hayk Barseghyan" userId="1af3c995-31f7-415e-9aa1-2b36900e994d" providerId="ADAL" clId="{6219D68C-F070-4DB1-998A-C9AA21C25743}" dt="2021-04-23T17:40:02.954" v="303" actId="478"/>
          <ac:picMkLst>
            <pc:docMk/>
            <pc:sldMk cId="1780613847" sldId="676"/>
            <ac:picMk id="3" creationId="{83ED3CC2-4027-49CD-B58C-F97A5ED1330E}"/>
          </ac:picMkLst>
        </pc:picChg>
        <pc:picChg chg="add del">
          <ac:chgData name="Hayk Barseghyan" userId="1af3c995-31f7-415e-9aa1-2b36900e994d" providerId="ADAL" clId="{6219D68C-F070-4DB1-998A-C9AA21C25743}" dt="2021-04-23T17:14:37.126" v="293" actId="478"/>
          <ac:picMkLst>
            <pc:docMk/>
            <pc:sldMk cId="1780613847" sldId="676"/>
            <ac:picMk id="4" creationId="{A8FF9AE5-A77C-4422-9C70-671AF89E8142}"/>
          </ac:picMkLst>
        </pc:picChg>
        <pc:picChg chg="add del mod">
          <ac:chgData name="Hayk Barseghyan" userId="1af3c995-31f7-415e-9aa1-2b36900e994d" providerId="ADAL" clId="{6219D68C-F070-4DB1-998A-C9AA21C25743}" dt="2021-04-23T19:52:26.107" v="1500" actId="478"/>
          <ac:picMkLst>
            <pc:docMk/>
            <pc:sldMk cId="1780613847" sldId="676"/>
            <ac:picMk id="5" creationId="{33A3765D-84E5-403B-81E3-4C16CE3A6F00}"/>
          </ac:picMkLst>
        </pc:picChg>
        <pc:picChg chg="add del mod">
          <ac:chgData name="Hayk Barseghyan" userId="1af3c995-31f7-415e-9aa1-2b36900e994d" providerId="ADAL" clId="{6219D68C-F070-4DB1-998A-C9AA21C25743}" dt="2021-04-23T19:54:28.721" v="1509" actId="478"/>
          <ac:picMkLst>
            <pc:docMk/>
            <pc:sldMk cId="1780613847" sldId="676"/>
            <ac:picMk id="6" creationId="{45D5B70B-5AA6-4A73-B8A8-1EC884003ABB}"/>
          </ac:picMkLst>
        </pc:picChg>
        <pc:picChg chg="del">
          <ac:chgData name="Hayk Barseghyan" userId="1af3c995-31f7-415e-9aa1-2b36900e994d" providerId="ADAL" clId="{6219D68C-F070-4DB1-998A-C9AA21C25743}" dt="2021-04-23T17:13:20.318" v="283" actId="478"/>
          <ac:picMkLst>
            <pc:docMk/>
            <pc:sldMk cId="1780613847" sldId="676"/>
            <ac:picMk id="8" creationId="{4D1E0338-6129-41F0-94D9-1DCA45EAD7A9}"/>
          </ac:picMkLst>
        </pc:picChg>
        <pc:picChg chg="del">
          <ac:chgData name="Hayk Barseghyan" userId="1af3c995-31f7-415e-9aa1-2b36900e994d" providerId="ADAL" clId="{6219D68C-F070-4DB1-998A-C9AA21C25743}" dt="2021-04-23T17:13:22.708" v="284" actId="478"/>
          <ac:picMkLst>
            <pc:docMk/>
            <pc:sldMk cId="1780613847" sldId="676"/>
            <ac:picMk id="11" creationId="{815F0E20-3CD9-4CAA-8F13-637B6F337576}"/>
          </ac:picMkLst>
        </pc:picChg>
        <pc:picChg chg="add del mod">
          <ac:chgData name="Hayk Barseghyan" userId="1af3c995-31f7-415e-9aa1-2b36900e994d" providerId="ADAL" clId="{6219D68C-F070-4DB1-998A-C9AA21C25743}" dt="2021-04-23T19:54:16.447" v="1508" actId="478"/>
          <ac:picMkLst>
            <pc:docMk/>
            <pc:sldMk cId="1780613847" sldId="676"/>
            <ac:picMk id="36" creationId="{2F482C22-59C1-41D7-B382-EDFFBCED82AD}"/>
          </ac:picMkLst>
        </pc:picChg>
        <pc:picChg chg="mod">
          <ac:chgData name="Hayk Barseghyan" userId="1af3c995-31f7-415e-9aa1-2b36900e994d" providerId="ADAL" clId="{6219D68C-F070-4DB1-998A-C9AA21C25743}" dt="2021-04-23T19:54:29.724" v="1510"/>
          <ac:picMkLst>
            <pc:docMk/>
            <pc:sldMk cId="1780613847" sldId="676"/>
            <ac:picMk id="38" creationId="{FD9FC26F-0415-4B5F-BF86-117CBB4A0A44}"/>
          </ac:picMkLst>
        </pc:picChg>
        <pc:picChg chg="mod">
          <ac:chgData name="Hayk Barseghyan" userId="1af3c995-31f7-415e-9aa1-2b36900e994d" providerId="ADAL" clId="{6219D68C-F070-4DB1-998A-C9AA21C25743}" dt="2021-04-23T19:54:29.724" v="1510"/>
          <ac:picMkLst>
            <pc:docMk/>
            <pc:sldMk cId="1780613847" sldId="676"/>
            <ac:picMk id="39" creationId="{511E78E7-4FC7-4EC2-B095-16C8A4175CAA}"/>
          </ac:picMkLst>
        </pc:picChg>
        <pc:picChg chg="mod">
          <ac:chgData name="Hayk Barseghyan" userId="1af3c995-31f7-415e-9aa1-2b36900e994d" providerId="ADAL" clId="{6219D68C-F070-4DB1-998A-C9AA21C25743}" dt="2021-04-23T19:54:29.724" v="1510"/>
          <ac:picMkLst>
            <pc:docMk/>
            <pc:sldMk cId="1780613847" sldId="676"/>
            <ac:picMk id="40" creationId="{3B408454-DDCB-44E4-9AEC-115659EFE6F4}"/>
          </ac:picMkLst>
        </pc:picChg>
        <pc:cxnChg chg="mod">
          <ac:chgData name="Hayk Barseghyan" userId="1af3c995-31f7-415e-9aa1-2b36900e994d" providerId="ADAL" clId="{6219D68C-F070-4DB1-998A-C9AA21C25743}" dt="2021-04-23T19:57:01.980" v="1529" actId="1582"/>
          <ac:cxnSpMkLst>
            <pc:docMk/>
            <pc:sldMk cId="1780613847" sldId="676"/>
            <ac:cxnSpMk id="50" creationId="{96A45FC2-CB07-4E9E-9E13-1D3D6F92ED77}"/>
          </ac:cxnSpMkLst>
        </pc:cxnChg>
        <pc:cxnChg chg="mod">
          <ac:chgData name="Hayk Barseghyan" userId="1af3c995-31f7-415e-9aa1-2b36900e994d" providerId="ADAL" clId="{6219D68C-F070-4DB1-998A-C9AA21C25743}" dt="2021-04-23T19:57:01.980" v="1529" actId="1582"/>
          <ac:cxnSpMkLst>
            <pc:docMk/>
            <pc:sldMk cId="1780613847" sldId="676"/>
            <ac:cxnSpMk id="54" creationId="{4C5BEBDC-685A-4A97-84B7-017C61427E96}"/>
          </ac:cxnSpMkLst>
        </pc:cxnChg>
        <pc:cxnChg chg="mod">
          <ac:chgData name="Hayk Barseghyan" userId="1af3c995-31f7-415e-9aa1-2b36900e994d" providerId="ADAL" clId="{6219D68C-F070-4DB1-998A-C9AA21C25743}" dt="2021-04-23T19:57:01.980" v="1529" actId="1582"/>
          <ac:cxnSpMkLst>
            <pc:docMk/>
            <pc:sldMk cId="1780613847" sldId="676"/>
            <ac:cxnSpMk id="55" creationId="{37A91041-BAE3-4334-AA29-FDCC13BAD83D}"/>
          </ac:cxnSpMkLst>
        </pc:cxnChg>
      </pc:sldChg>
    </pc:docChg>
  </pc:docChgLst>
  <pc:docChgLst>
    <pc:chgData name="Hayk Barseghyan" userId="1af3c995-31f7-415e-9aa1-2b36900e994d" providerId="ADAL" clId="{0476C44F-774A-4C95-8BCB-A7592F9379F1}"/>
    <pc:docChg chg="undo redo custSel modSld">
      <pc:chgData name="Hayk Barseghyan" userId="1af3c995-31f7-415e-9aa1-2b36900e994d" providerId="ADAL" clId="{0476C44F-774A-4C95-8BCB-A7592F9379F1}" dt="2021-02-19T17:54:31.346" v="847" actId="20577"/>
      <pc:docMkLst>
        <pc:docMk/>
      </pc:docMkLst>
      <pc:sldChg chg="addSp modSp mod">
        <pc:chgData name="Hayk Barseghyan" userId="1af3c995-31f7-415e-9aa1-2b36900e994d" providerId="ADAL" clId="{0476C44F-774A-4C95-8BCB-A7592F9379F1}" dt="2021-02-19T14:40:41.918" v="10" actId="1035"/>
        <pc:sldMkLst>
          <pc:docMk/>
          <pc:sldMk cId="524483127" sldId="651"/>
        </pc:sldMkLst>
        <pc:spChg chg="add mod">
          <ac:chgData name="Hayk Barseghyan" userId="1af3c995-31f7-415e-9aa1-2b36900e994d" providerId="ADAL" clId="{0476C44F-774A-4C95-8BCB-A7592F9379F1}" dt="2021-02-19T14:40:41.918" v="10" actId="1035"/>
          <ac:spMkLst>
            <pc:docMk/>
            <pc:sldMk cId="524483127" sldId="651"/>
            <ac:spMk id="44" creationId="{732812E5-D6B9-4FEF-975D-E2E3D93D0E47}"/>
          </ac:spMkLst>
        </pc:spChg>
        <pc:spChg chg="add mod">
          <ac:chgData name="Hayk Barseghyan" userId="1af3c995-31f7-415e-9aa1-2b36900e994d" providerId="ADAL" clId="{0476C44F-774A-4C95-8BCB-A7592F9379F1}" dt="2021-02-19T14:40:41.918" v="10" actId="1035"/>
          <ac:spMkLst>
            <pc:docMk/>
            <pc:sldMk cId="524483127" sldId="651"/>
            <ac:spMk id="45" creationId="{706B5154-0B8D-4A97-9481-9F43337FAC30}"/>
          </ac:spMkLst>
        </pc:spChg>
      </pc:sldChg>
      <pc:sldChg chg="addSp delSp modSp mod">
        <pc:chgData name="Hayk Barseghyan" userId="1af3c995-31f7-415e-9aa1-2b36900e994d" providerId="ADAL" clId="{0476C44F-774A-4C95-8BCB-A7592F9379F1}" dt="2021-02-19T17:54:31.346" v="847" actId="20577"/>
        <pc:sldMkLst>
          <pc:docMk/>
          <pc:sldMk cId="2324661198" sldId="4370"/>
        </pc:sldMkLst>
        <pc:spChg chg="del">
          <ac:chgData name="Hayk Barseghyan" userId="1af3c995-31f7-415e-9aa1-2b36900e994d" providerId="ADAL" clId="{0476C44F-774A-4C95-8BCB-A7592F9379F1}" dt="2021-02-19T17:13:32.614" v="681" actId="478"/>
          <ac:spMkLst>
            <pc:docMk/>
            <pc:sldMk cId="2324661198" sldId="4370"/>
            <ac:spMk id="3" creationId="{010D94A6-1571-47AC-8B0C-2DA904C32033}"/>
          </ac:spMkLst>
        </pc:spChg>
        <pc:spChg chg="add del mod">
          <ac:chgData name="Hayk Barseghyan" userId="1af3c995-31f7-415e-9aa1-2b36900e994d" providerId="ADAL" clId="{0476C44F-774A-4C95-8BCB-A7592F9379F1}" dt="2021-02-19T17:13:35.907" v="682" actId="478"/>
          <ac:spMkLst>
            <pc:docMk/>
            <pc:sldMk cId="2324661198" sldId="4370"/>
            <ac:spMk id="4" creationId="{F4FAE4B0-C567-4AEC-BD5F-BE73D84EAD3C}"/>
          </ac:spMkLst>
        </pc:spChg>
        <pc:graphicFrameChg chg="mod modGraphic">
          <ac:chgData name="Hayk Barseghyan" userId="1af3c995-31f7-415e-9aa1-2b36900e994d" providerId="ADAL" clId="{0476C44F-774A-4C95-8BCB-A7592F9379F1}" dt="2021-02-19T17:54:31.346" v="847" actId="20577"/>
          <ac:graphicFrameMkLst>
            <pc:docMk/>
            <pc:sldMk cId="2324661198" sldId="4370"/>
            <ac:graphicFrameMk id="6" creationId="{5C840AF8-9E14-4FE1-9250-5EAC6D079BED}"/>
          </ac:graphicFrameMkLst>
        </pc:graphicFrameChg>
      </pc:sldChg>
    </pc:docChg>
  </pc:docChgLst>
  <pc:docChgLst>
    <pc:chgData name="Guest User" userId="S::urn:spo:anon#b4cde6609404b313bc8003d13e330a44680d87cf950eaa8c40a78ec233681f73::" providerId="AD" clId="Web-{2462C2B7-D638-496B-AAAA-3281853F78CD}"/>
    <pc:docChg chg="addSld modSld">
      <pc:chgData name="Guest User" userId="S::urn:spo:anon#b4cde6609404b313bc8003d13e330a44680d87cf950eaa8c40a78ec233681f73::" providerId="AD" clId="Web-{2462C2B7-D638-496B-AAAA-3281853F78CD}" dt="2021-02-08T20:03:21.788" v="38" actId="1076"/>
      <pc:docMkLst>
        <pc:docMk/>
      </pc:docMkLst>
      <pc:sldChg chg="addSp delSp modSp new">
        <pc:chgData name="Guest User" userId="S::urn:spo:anon#b4cde6609404b313bc8003d13e330a44680d87cf950eaa8c40a78ec233681f73::" providerId="AD" clId="Web-{2462C2B7-D638-496B-AAAA-3281853F78CD}" dt="2021-02-08T20:02:38.350" v="30" actId="1076"/>
        <pc:sldMkLst>
          <pc:docMk/>
          <pc:sldMk cId="2830969817" sldId="647"/>
        </pc:sldMkLst>
        <pc:picChg chg="add del mod">
          <ac:chgData name="Guest User" userId="S::urn:spo:anon#b4cde6609404b313bc8003d13e330a44680d87cf950eaa8c40a78ec233681f73::" providerId="AD" clId="Web-{2462C2B7-D638-496B-AAAA-3281853F78CD}" dt="2021-02-08T20:00:16.726" v="2"/>
          <ac:picMkLst>
            <pc:docMk/>
            <pc:sldMk cId="2830969817" sldId="647"/>
            <ac:picMk id="2" creationId="{8DA7A654-C94F-4966-87BA-68F6A73DF65F}"/>
          </ac:picMkLst>
        </pc:picChg>
        <pc:picChg chg="add del mod">
          <ac:chgData name="Guest User" userId="S::urn:spo:anon#b4cde6609404b313bc8003d13e330a44680d87cf950eaa8c40a78ec233681f73::" providerId="AD" clId="Web-{2462C2B7-D638-496B-AAAA-3281853F78CD}" dt="2021-02-08T20:00:56.335" v="10"/>
          <ac:picMkLst>
            <pc:docMk/>
            <pc:sldMk cId="2830969817" sldId="647"/>
            <ac:picMk id="3" creationId="{4F0E83B4-AFE1-4777-85E2-B53C01C126B7}"/>
          </ac:picMkLst>
        </pc:picChg>
        <pc:picChg chg="add mod">
          <ac:chgData name="Guest User" userId="S::urn:spo:anon#b4cde6609404b313bc8003d13e330a44680d87cf950eaa8c40a78ec233681f73::" providerId="AD" clId="Web-{2462C2B7-D638-496B-AAAA-3281853F78CD}" dt="2021-02-08T20:02:01.601" v="22" actId="1076"/>
          <ac:picMkLst>
            <pc:docMk/>
            <pc:sldMk cId="2830969817" sldId="647"/>
            <ac:picMk id="4" creationId="{83E0E0FB-31C1-4632-9616-6C3C8C3CA9F6}"/>
          </ac:picMkLst>
        </pc:picChg>
        <pc:picChg chg="add mod">
          <ac:chgData name="Guest User" userId="S::urn:spo:anon#b4cde6609404b313bc8003d13e330a44680d87cf950eaa8c40a78ec233681f73::" providerId="AD" clId="Web-{2462C2B7-D638-496B-AAAA-3281853F78CD}" dt="2021-02-08T20:02:06.444" v="25" actId="1076"/>
          <ac:picMkLst>
            <pc:docMk/>
            <pc:sldMk cId="2830969817" sldId="647"/>
            <ac:picMk id="5" creationId="{F39D0EB7-9FD9-4EE0-8A7B-748FD593ED96}"/>
          </ac:picMkLst>
        </pc:picChg>
        <pc:picChg chg="add del mod">
          <ac:chgData name="Guest User" userId="S::urn:spo:anon#b4cde6609404b313bc8003d13e330a44680d87cf950eaa8c40a78ec233681f73::" providerId="AD" clId="Web-{2462C2B7-D638-496B-AAAA-3281853F78CD}" dt="2021-02-08T20:02:21.397" v="28"/>
          <ac:picMkLst>
            <pc:docMk/>
            <pc:sldMk cId="2830969817" sldId="647"/>
            <ac:picMk id="6" creationId="{BD2AE2E5-BD43-43B2-BAE4-54F2F40CBB7E}"/>
          </ac:picMkLst>
        </pc:picChg>
        <pc:picChg chg="add mod">
          <ac:chgData name="Guest User" userId="S::urn:spo:anon#b4cde6609404b313bc8003d13e330a44680d87cf950eaa8c40a78ec233681f73::" providerId="AD" clId="Web-{2462C2B7-D638-496B-AAAA-3281853F78CD}" dt="2021-02-08T20:02:38.350" v="30" actId="1076"/>
          <ac:picMkLst>
            <pc:docMk/>
            <pc:sldMk cId="2830969817" sldId="647"/>
            <ac:picMk id="7" creationId="{8DBDBCD6-2898-415D-A898-3ED53325DB2A}"/>
          </ac:picMkLst>
        </pc:picChg>
      </pc:sldChg>
      <pc:sldChg chg="addSp modSp new">
        <pc:chgData name="Guest User" userId="S::urn:spo:anon#b4cde6609404b313bc8003d13e330a44680d87cf950eaa8c40a78ec233681f73::" providerId="AD" clId="Web-{2462C2B7-D638-496B-AAAA-3281853F78CD}" dt="2021-02-08T20:03:21.788" v="38" actId="1076"/>
        <pc:sldMkLst>
          <pc:docMk/>
          <pc:sldMk cId="3868126251" sldId="648"/>
        </pc:sldMkLst>
        <pc:picChg chg="add mod">
          <ac:chgData name="Guest User" userId="S::urn:spo:anon#b4cde6609404b313bc8003d13e330a44680d87cf950eaa8c40a78ec233681f73::" providerId="AD" clId="Web-{2462C2B7-D638-496B-AAAA-3281853F78CD}" dt="2021-02-08T20:03:21.788" v="38" actId="1076"/>
          <ac:picMkLst>
            <pc:docMk/>
            <pc:sldMk cId="3868126251" sldId="648"/>
            <ac:picMk id="2" creationId="{44662BBE-6899-4B54-8430-6FDA2B55B48C}"/>
          </ac:picMkLst>
        </pc:picChg>
      </pc:sldChg>
    </pc:docChg>
  </pc:docChgLst>
  <pc:docChgLst>
    <pc:chgData name="Hayk Barseghyan" userId="1af3c995-31f7-415e-9aa1-2b36900e994d" providerId="ADAL" clId="{0674612F-D638-47B5-8F01-B20833F5508E}"/>
    <pc:docChg chg="custSel delSld modSld sldOrd">
      <pc:chgData name="Hayk Barseghyan" userId="1af3c995-31f7-415e-9aa1-2b36900e994d" providerId="ADAL" clId="{0674612F-D638-47B5-8F01-B20833F5508E}" dt="2021-12-13T09:32:40.103" v="114" actId="20577"/>
      <pc:docMkLst>
        <pc:docMk/>
      </pc:docMkLst>
      <pc:sldChg chg="modSp mod ord modNotesTx">
        <pc:chgData name="Hayk Barseghyan" userId="1af3c995-31f7-415e-9aa1-2b36900e994d" providerId="ADAL" clId="{0674612F-D638-47B5-8F01-B20833F5508E}" dt="2021-12-06T22:00:53.628" v="97" actId="20577"/>
        <pc:sldMkLst>
          <pc:docMk/>
          <pc:sldMk cId="2946833462" sldId="671"/>
        </pc:sldMkLst>
        <pc:spChg chg="mod">
          <ac:chgData name="Hayk Barseghyan" userId="1af3c995-31f7-415e-9aa1-2b36900e994d" providerId="ADAL" clId="{0674612F-D638-47B5-8F01-B20833F5508E}" dt="2021-10-28T00:11:14.428" v="2" actId="20577"/>
          <ac:spMkLst>
            <pc:docMk/>
            <pc:sldMk cId="2946833462" sldId="671"/>
            <ac:spMk id="33" creationId="{27D04DB1-6D7F-4335-AAA1-99D44F3F14E9}"/>
          </ac:spMkLst>
        </pc:spChg>
      </pc:sldChg>
      <pc:sldChg chg="delSp del mod">
        <pc:chgData name="Hayk Barseghyan" userId="1af3c995-31f7-415e-9aa1-2b36900e994d" providerId="ADAL" clId="{0674612F-D638-47B5-8F01-B20833F5508E}" dt="2021-12-06T22:00:33.219" v="96" actId="47"/>
        <pc:sldMkLst>
          <pc:docMk/>
          <pc:sldMk cId="1326918807" sldId="673"/>
        </pc:sldMkLst>
        <pc:spChg chg="del">
          <ac:chgData name="Hayk Barseghyan" userId="1af3c995-31f7-415e-9aa1-2b36900e994d" providerId="ADAL" clId="{0674612F-D638-47B5-8F01-B20833F5508E}" dt="2021-12-06T21:59:53.072" v="12" actId="478"/>
          <ac:spMkLst>
            <pc:docMk/>
            <pc:sldMk cId="1326918807" sldId="673"/>
            <ac:spMk id="55" creationId="{1480A490-4E36-4102-8115-ADC2AA4F7761}"/>
          </ac:spMkLst>
        </pc:spChg>
        <pc:spChg chg="del">
          <ac:chgData name="Hayk Barseghyan" userId="1af3c995-31f7-415e-9aa1-2b36900e994d" providerId="ADAL" clId="{0674612F-D638-47B5-8F01-B20833F5508E}" dt="2021-12-06T21:59:54.304" v="13" actId="478"/>
          <ac:spMkLst>
            <pc:docMk/>
            <pc:sldMk cId="1326918807" sldId="673"/>
            <ac:spMk id="56" creationId="{CFC98ADF-75D5-4DB7-BE62-79053734A9E8}"/>
          </ac:spMkLst>
        </pc:spChg>
      </pc:sldChg>
      <pc:sldChg chg="addSp delSp modSp mod ord modNotesTx">
        <pc:chgData name="Hayk Barseghyan" userId="1af3c995-31f7-415e-9aa1-2b36900e994d" providerId="ADAL" clId="{0674612F-D638-47B5-8F01-B20833F5508E}" dt="2021-12-13T09:32:40.103" v="114" actId="20577"/>
        <pc:sldMkLst>
          <pc:docMk/>
          <pc:sldMk cId="1894380217" sldId="674"/>
        </pc:sldMkLst>
        <pc:spChg chg="add mod">
          <ac:chgData name="Hayk Barseghyan" userId="1af3c995-31f7-415e-9aa1-2b36900e994d" providerId="ADAL" clId="{0674612F-D638-47B5-8F01-B20833F5508E}" dt="2021-12-06T22:00:27.843" v="95" actId="1035"/>
          <ac:spMkLst>
            <pc:docMk/>
            <pc:sldMk cId="1894380217" sldId="674"/>
            <ac:spMk id="11" creationId="{E18FD5EC-CCB8-45C4-AA26-CE4D3B946B2D}"/>
          </ac:spMkLst>
        </pc:spChg>
        <pc:spChg chg="add mod">
          <ac:chgData name="Hayk Barseghyan" userId="1af3c995-31f7-415e-9aa1-2b36900e994d" providerId="ADAL" clId="{0674612F-D638-47B5-8F01-B20833F5508E}" dt="2021-12-06T22:00:27.843" v="95" actId="1035"/>
          <ac:spMkLst>
            <pc:docMk/>
            <pc:sldMk cId="1894380217" sldId="674"/>
            <ac:spMk id="12" creationId="{17B0C2FB-367A-4468-A7A5-1476E4765510}"/>
          </ac:spMkLst>
        </pc:spChg>
        <pc:spChg chg="add mod">
          <ac:chgData name="Hayk Barseghyan" userId="1af3c995-31f7-415e-9aa1-2b36900e994d" providerId="ADAL" clId="{0674612F-D638-47B5-8F01-B20833F5508E}" dt="2021-12-06T22:00:27.843" v="95" actId="1035"/>
          <ac:spMkLst>
            <pc:docMk/>
            <pc:sldMk cId="1894380217" sldId="674"/>
            <ac:spMk id="13" creationId="{D16470C1-6BBF-4680-97EA-8EEAF33BAA35}"/>
          </ac:spMkLst>
        </pc:spChg>
        <pc:spChg chg="add mod">
          <ac:chgData name="Hayk Barseghyan" userId="1af3c995-31f7-415e-9aa1-2b36900e994d" providerId="ADAL" clId="{0674612F-D638-47B5-8F01-B20833F5508E}" dt="2021-12-06T22:00:27.843" v="95" actId="1035"/>
          <ac:spMkLst>
            <pc:docMk/>
            <pc:sldMk cId="1894380217" sldId="674"/>
            <ac:spMk id="14" creationId="{4104E8C0-8D44-4913-BC41-1A8304AD0443}"/>
          </ac:spMkLst>
        </pc:spChg>
        <pc:spChg chg="add mod">
          <ac:chgData name="Hayk Barseghyan" userId="1af3c995-31f7-415e-9aa1-2b36900e994d" providerId="ADAL" clId="{0674612F-D638-47B5-8F01-B20833F5508E}" dt="2021-12-06T22:00:27.843" v="95" actId="1035"/>
          <ac:spMkLst>
            <pc:docMk/>
            <pc:sldMk cId="1894380217" sldId="674"/>
            <ac:spMk id="15" creationId="{FFBAF37F-1B94-45EC-A133-CEFB26A81DB4}"/>
          </ac:spMkLst>
        </pc:spChg>
        <pc:spChg chg="add mod">
          <ac:chgData name="Hayk Barseghyan" userId="1af3c995-31f7-415e-9aa1-2b36900e994d" providerId="ADAL" clId="{0674612F-D638-47B5-8F01-B20833F5508E}" dt="2021-12-06T22:00:27.843" v="95" actId="1035"/>
          <ac:spMkLst>
            <pc:docMk/>
            <pc:sldMk cId="1894380217" sldId="674"/>
            <ac:spMk id="16" creationId="{6FAC1FB4-A8EF-438D-BB34-6981ADDE7974}"/>
          </ac:spMkLst>
        </pc:spChg>
        <pc:spChg chg="del">
          <ac:chgData name="Hayk Barseghyan" userId="1af3c995-31f7-415e-9aa1-2b36900e994d" providerId="ADAL" clId="{0674612F-D638-47B5-8F01-B20833F5508E}" dt="2021-12-06T22:00:09.959" v="17" actId="478"/>
          <ac:spMkLst>
            <pc:docMk/>
            <pc:sldMk cId="1894380217" sldId="674"/>
            <ac:spMk id="17" creationId="{C343FFD7-1811-46C8-B40A-EFDFA0EC724D}"/>
          </ac:spMkLst>
        </pc:spChg>
        <pc:spChg chg="add mod">
          <ac:chgData name="Hayk Barseghyan" userId="1af3c995-31f7-415e-9aa1-2b36900e994d" providerId="ADAL" clId="{0674612F-D638-47B5-8F01-B20833F5508E}" dt="2021-12-06T22:00:27.843" v="95" actId="1035"/>
          <ac:spMkLst>
            <pc:docMk/>
            <pc:sldMk cId="1894380217" sldId="674"/>
            <ac:spMk id="20" creationId="{DA936DED-808B-4696-B141-ABFB9BDC7E24}"/>
          </ac:spMkLst>
        </pc:spChg>
        <pc:spChg chg="add mod">
          <ac:chgData name="Hayk Barseghyan" userId="1af3c995-31f7-415e-9aa1-2b36900e994d" providerId="ADAL" clId="{0674612F-D638-47B5-8F01-B20833F5508E}" dt="2021-12-06T22:00:27.843" v="95" actId="1035"/>
          <ac:spMkLst>
            <pc:docMk/>
            <pc:sldMk cId="1894380217" sldId="674"/>
            <ac:spMk id="22" creationId="{B141BA14-43EF-4FBF-A060-B12FDA82F529}"/>
          </ac:spMkLst>
        </pc:spChg>
        <pc:spChg chg="mod">
          <ac:chgData name="Hayk Barseghyan" userId="1af3c995-31f7-415e-9aa1-2b36900e994d" providerId="ADAL" clId="{0674612F-D638-47B5-8F01-B20833F5508E}" dt="2021-12-06T22:00:06.146" v="16" actId="20577"/>
          <ac:spMkLst>
            <pc:docMk/>
            <pc:sldMk cId="1894380217" sldId="674"/>
            <ac:spMk id="33" creationId="{27D04DB1-6D7F-4335-AAA1-99D44F3F14E9}"/>
          </ac:spMkLst>
        </pc:spChg>
        <pc:spChg chg="del">
          <ac:chgData name="Hayk Barseghyan" userId="1af3c995-31f7-415e-9aa1-2b36900e994d" providerId="ADAL" clId="{0674612F-D638-47B5-8F01-B20833F5508E}" dt="2021-12-06T22:00:09.959" v="17" actId="478"/>
          <ac:spMkLst>
            <pc:docMk/>
            <pc:sldMk cId="1894380217" sldId="674"/>
            <ac:spMk id="56" creationId="{CFC98ADF-75D5-4DB7-BE62-79053734A9E8}"/>
          </ac:spMkLst>
        </pc:spChg>
        <pc:picChg chg="add mod">
          <ac:chgData name="Hayk Barseghyan" userId="1af3c995-31f7-415e-9aa1-2b36900e994d" providerId="ADAL" clId="{0674612F-D638-47B5-8F01-B20833F5508E}" dt="2021-12-06T22:00:27.843" v="95" actId="1035"/>
          <ac:picMkLst>
            <pc:docMk/>
            <pc:sldMk cId="1894380217" sldId="674"/>
            <ac:picMk id="18" creationId="{8B36E3C8-D739-4A42-86DF-1D8C91F273D2}"/>
          </ac:picMkLst>
        </pc:picChg>
        <pc:picChg chg="add mod">
          <ac:chgData name="Hayk Barseghyan" userId="1af3c995-31f7-415e-9aa1-2b36900e994d" providerId="ADAL" clId="{0674612F-D638-47B5-8F01-B20833F5508E}" dt="2021-12-06T22:00:27.843" v="95" actId="1035"/>
          <ac:picMkLst>
            <pc:docMk/>
            <pc:sldMk cId="1894380217" sldId="674"/>
            <ac:picMk id="19" creationId="{BC4B6027-5932-4898-9413-36DA8C8D20CA}"/>
          </ac:picMkLst>
        </pc:picChg>
        <pc:cxnChg chg="add mod">
          <ac:chgData name="Hayk Barseghyan" userId="1af3c995-31f7-415e-9aa1-2b36900e994d" providerId="ADAL" clId="{0674612F-D638-47B5-8F01-B20833F5508E}" dt="2021-12-06T22:00:27.843" v="95" actId="1035"/>
          <ac:cxnSpMkLst>
            <pc:docMk/>
            <pc:sldMk cId="1894380217" sldId="674"/>
            <ac:cxnSpMk id="21" creationId="{A8B938B4-90AB-4D3C-BB4F-AD76061C7A60}"/>
          </ac:cxnSpMkLst>
        </pc:cxnChg>
      </pc:sldChg>
      <pc:sldChg chg="modSp mod ord modNotesTx">
        <pc:chgData name="Hayk Barseghyan" userId="1af3c995-31f7-415e-9aa1-2b36900e994d" providerId="ADAL" clId="{0674612F-D638-47B5-8F01-B20833F5508E}" dt="2021-12-06T22:05:41.285" v="99" actId="20577"/>
        <pc:sldMkLst>
          <pc:docMk/>
          <pc:sldMk cId="367579465" sldId="675"/>
        </pc:sldMkLst>
        <pc:spChg chg="mod">
          <ac:chgData name="Hayk Barseghyan" userId="1af3c995-31f7-415e-9aa1-2b36900e994d" providerId="ADAL" clId="{0674612F-D638-47B5-8F01-B20833F5508E}" dt="2021-12-06T22:00:00.487" v="14" actId="20577"/>
          <ac:spMkLst>
            <pc:docMk/>
            <pc:sldMk cId="367579465" sldId="675"/>
            <ac:spMk id="33" creationId="{27D04DB1-6D7F-4335-AAA1-99D44F3F14E9}"/>
          </ac:spMkLst>
        </pc:spChg>
      </pc:sldChg>
      <pc:sldChg chg="modSp mod ord">
        <pc:chgData name="Hayk Barseghyan" userId="1af3c995-31f7-415e-9aa1-2b36900e994d" providerId="ADAL" clId="{0674612F-D638-47B5-8F01-B20833F5508E}" dt="2021-12-06T22:00:03.236" v="15" actId="20577"/>
        <pc:sldMkLst>
          <pc:docMk/>
          <pc:sldMk cId="2438198957" sldId="676"/>
        </pc:sldMkLst>
        <pc:spChg chg="mod">
          <ac:chgData name="Hayk Barseghyan" userId="1af3c995-31f7-415e-9aa1-2b36900e994d" providerId="ADAL" clId="{0674612F-D638-47B5-8F01-B20833F5508E}" dt="2021-12-06T22:00:03.236" v="15" actId="20577"/>
          <ac:spMkLst>
            <pc:docMk/>
            <pc:sldMk cId="2438198957" sldId="676"/>
            <ac:spMk id="33" creationId="{27D04DB1-6D7F-4335-AAA1-99D44F3F14E9}"/>
          </ac:spMkLst>
        </pc:spChg>
      </pc:sldChg>
    </pc:docChg>
  </pc:docChgLst>
  <pc:docChgLst>
    <pc:chgData name="Hayk Barseghyan" userId="1af3c995-31f7-415e-9aa1-2b36900e994d" providerId="ADAL" clId="{ECAA696D-07C2-4671-886A-D983D4AD93C9}"/>
    <pc:docChg chg="undo custSel modSld">
      <pc:chgData name="Hayk Barseghyan" userId="1af3c995-31f7-415e-9aa1-2b36900e994d" providerId="ADAL" clId="{ECAA696D-07C2-4671-886A-D983D4AD93C9}" dt="2021-04-16T22:21:20.108" v="337" actId="20577"/>
      <pc:docMkLst>
        <pc:docMk/>
      </pc:docMkLst>
      <pc:sldChg chg="delSp modSp mod">
        <pc:chgData name="Hayk Barseghyan" userId="1af3c995-31f7-415e-9aa1-2b36900e994d" providerId="ADAL" clId="{ECAA696D-07C2-4671-886A-D983D4AD93C9}" dt="2021-04-16T22:21:20.108" v="337" actId="20577"/>
        <pc:sldMkLst>
          <pc:docMk/>
          <pc:sldMk cId="742313956" sldId="656"/>
        </pc:sldMkLst>
        <pc:spChg chg="del">
          <ac:chgData name="Hayk Barseghyan" userId="1af3c995-31f7-415e-9aa1-2b36900e994d" providerId="ADAL" clId="{ECAA696D-07C2-4671-886A-D983D4AD93C9}" dt="2021-04-16T20:41:01.724" v="334" actId="478"/>
          <ac:spMkLst>
            <pc:docMk/>
            <pc:sldMk cId="742313956" sldId="656"/>
            <ac:spMk id="28" creationId="{26162908-999C-46CB-AD37-6DCE2E310DDA}"/>
          </ac:spMkLst>
        </pc:spChg>
        <pc:spChg chg="mod">
          <ac:chgData name="Hayk Barseghyan" userId="1af3c995-31f7-415e-9aa1-2b36900e994d" providerId="ADAL" clId="{ECAA696D-07C2-4671-886A-D983D4AD93C9}" dt="2021-04-16T22:21:20.108" v="337" actId="20577"/>
          <ac:spMkLst>
            <pc:docMk/>
            <pc:sldMk cId="742313956" sldId="656"/>
            <ac:spMk id="42" creationId="{6DDBB1BF-A060-4469-8C25-83BC8B02C54D}"/>
          </ac:spMkLst>
        </pc:spChg>
        <pc:picChg chg="mod">
          <ac:chgData name="Hayk Barseghyan" userId="1af3c995-31f7-415e-9aa1-2b36900e994d" providerId="ADAL" clId="{ECAA696D-07C2-4671-886A-D983D4AD93C9}" dt="2021-04-16T20:59:40.531" v="335" actId="1076"/>
          <ac:picMkLst>
            <pc:docMk/>
            <pc:sldMk cId="742313956" sldId="656"/>
            <ac:picMk id="36" creationId="{DBF16D19-79D0-48EF-B670-E7442E814215}"/>
          </ac:picMkLst>
        </pc:picChg>
      </pc:sldChg>
      <pc:sldChg chg="addSp delSp modSp mod modNotesTx">
        <pc:chgData name="Hayk Barseghyan" userId="1af3c995-31f7-415e-9aa1-2b36900e994d" providerId="ADAL" clId="{ECAA696D-07C2-4671-886A-D983D4AD93C9}" dt="2021-04-16T20:40:06.115" v="333" actId="14100"/>
        <pc:sldMkLst>
          <pc:docMk/>
          <pc:sldMk cId="2755479697" sldId="657"/>
        </pc:sldMkLst>
        <pc:spChg chg="add mod">
          <ac:chgData name="Hayk Barseghyan" userId="1af3c995-31f7-415e-9aa1-2b36900e994d" providerId="ADAL" clId="{ECAA696D-07C2-4671-886A-D983D4AD93C9}" dt="2021-04-16T20:37:34.629" v="292" actId="207"/>
          <ac:spMkLst>
            <pc:docMk/>
            <pc:sldMk cId="2755479697" sldId="657"/>
            <ac:spMk id="5" creationId="{47BFAFC9-CBD8-4A58-9705-1B714B3A6D5A}"/>
          </ac:spMkLst>
        </pc:spChg>
        <pc:spChg chg="add mod">
          <ac:chgData name="Hayk Barseghyan" userId="1af3c995-31f7-415e-9aa1-2b36900e994d" providerId="ADAL" clId="{ECAA696D-07C2-4671-886A-D983D4AD93C9}" dt="2021-04-16T20:31:01.540" v="287" actId="1038"/>
          <ac:spMkLst>
            <pc:docMk/>
            <pc:sldMk cId="2755479697" sldId="657"/>
            <ac:spMk id="49" creationId="{FE9A15E4-8680-45EE-B44F-384C95C35DCC}"/>
          </ac:spMkLst>
        </pc:spChg>
        <pc:spChg chg="add mod">
          <ac:chgData name="Hayk Barseghyan" userId="1af3c995-31f7-415e-9aa1-2b36900e994d" providerId="ADAL" clId="{ECAA696D-07C2-4671-886A-D983D4AD93C9}" dt="2021-04-16T20:31:01.540" v="287" actId="1038"/>
          <ac:spMkLst>
            <pc:docMk/>
            <pc:sldMk cId="2755479697" sldId="657"/>
            <ac:spMk id="51" creationId="{635177A0-A6BB-4CCC-84DF-E8A52026D256}"/>
          </ac:spMkLst>
        </pc:spChg>
        <pc:spChg chg="add mod">
          <ac:chgData name="Hayk Barseghyan" userId="1af3c995-31f7-415e-9aa1-2b36900e994d" providerId="ADAL" clId="{ECAA696D-07C2-4671-886A-D983D4AD93C9}" dt="2021-04-16T20:31:01.540" v="287" actId="1038"/>
          <ac:spMkLst>
            <pc:docMk/>
            <pc:sldMk cId="2755479697" sldId="657"/>
            <ac:spMk id="52" creationId="{B727AEA1-A841-4135-8490-48BDECF42D5D}"/>
          </ac:spMkLst>
        </pc:spChg>
        <pc:spChg chg="add mod">
          <ac:chgData name="Hayk Barseghyan" userId="1af3c995-31f7-415e-9aa1-2b36900e994d" providerId="ADAL" clId="{ECAA696D-07C2-4671-886A-D983D4AD93C9}" dt="2021-04-16T20:31:01.540" v="287" actId="1038"/>
          <ac:spMkLst>
            <pc:docMk/>
            <pc:sldMk cId="2755479697" sldId="657"/>
            <ac:spMk id="60" creationId="{BEB5D91C-24B9-4379-866A-39C51F59F835}"/>
          </ac:spMkLst>
        </pc:spChg>
        <pc:spChg chg="add mod">
          <ac:chgData name="Hayk Barseghyan" userId="1af3c995-31f7-415e-9aa1-2b36900e994d" providerId="ADAL" clId="{ECAA696D-07C2-4671-886A-D983D4AD93C9}" dt="2021-04-16T20:31:01.540" v="287" actId="1038"/>
          <ac:spMkLst>
            <pc:docMk/>
            <pc:sldMk cId="2755479697" sldId="657"/>
            <ac:spMk id="64" creationId="{DBCEA1FE-608D-4A34-81BB-B85F0283D60C}"/>
          </ac:spMkLst>
        </pc:spChg>
        <pc:spChg chg="add mod">
          <ac:chgData name="Hayk Barseghyan" userId="1af3c995-31f7-415e-9aa1-2b36900e994d" providerId="ADAL" clId="{ECAA696D-07C2-4671-886A-D983D4AD93C9}" dt="2021-04-16T20:38:11.280" v="310" actId="1036"/>
          <ac:spMkLst>
            <pc:docMk/>
            <pc:sldMk cId="2755479697" sldId="657"/>
            <ac:spMk id="65" creationId="{B801EC8F-3EB5-488C-B7DF-48F03C1AD209}"/>
          </ac:spMkLst>
        </pc:spChg>
        <pc:spChg chg="add mod">
          <ac:chgData name="Hayk Barseghyan" userId="1af3c995-31f7-415e-9aa1-2b36900e994d" providerId="ADAL" clId="{ECAA696D-07C2-4671-886A-D983D4AD93C9}" dt="2021-04-16T20:39:11.612" v="328" actId="1076"/>
          <ac:spMkLst>
            <pc:docMk/>
            <pc:sldMk cId="2755479697" sldId="657"/>
            <ac:spMk id="66" creationId="{9D8244E2-BE60-433D-9260-4642F3636024}"/>
          </ac:spMkLst>
        </pc:spChg>
        <pc:spChg chg="mod">
          <ac:chgData name="Hayk Barseghyan" userId="1af3c995-31f7-415e-9aa1-2b36900e994d" providerId="ADAL" clId="{ECAA696D-07C2-4671-886A-D983D4AD93C9}" dt="2021-04-16T20:30:53.336" v="229" actId="1038"/>
          <ac:spMkLst>
            <pc:docMk/>
            <pc:sldMk cId="2755479697" sldId="657"/>
            <ac:spMk id="84" creationId="{730636F3-73A0-43F8-9E2C-68FEB536E6D2}"/>
          </ac:spMkLst>
        </pc:spChg>
        <pc:spChg chg="del">
          <ac:chgData name="Hayk Barseghyan" userId="1af3c995-31f7-415e-9aa1-2b36900e994d" providerId="ADAL" clId="{ECAA696D-07C2-4671-886A-D983D4AD93C9}" dt="2021-04-16T18:39:09.906" v="10" actId="478"/>
          <ac:spMkLst>
            <pc:docMk/>
            <pc:sldMk cId="2755479697" sldId="657"/>
            <ac:spMk id="87" creationId="{2C9C4A4E-D24B-4AC3-A14C-2629326039C9}"/>
          </ac:spMkLst>
        </pc:spChg>
        <pc:spChg chg="del">
          <ac:chgData name="Hayk Barseghyan" userId="1af3c995-31f7-415e-9aa1-2b36900e994d" providerId="ADAL" clId="{ECAA696D-07C2-4671-886A-D983D4AD93C9}" dt="2021-04-16T18:39:11.630" v="11" actId="478"/>
          <ac:spMkLst>
            <pc:docMk/>
            <pc:sldMk cId="2755479697" sldId="657"/>
            <ac:spMk id="88" creationId="{6882F801-419D-4634-93E8-1E3BDF3E1499}"/>
          </ac:spMkLst>
        </pc:spChg>
        <pc:spChg chg="mod">
          <ac:chgData name="Hayk Barseghyan" userId="1af3c995-31f7-415e-9aa1-2b36900e994d" providerId="ADAL" clId="{ECAA696D-07C2-4671-886A-D983D4AD93C9}" dt="2021-04-16T20:31:01.540" v="287" actId="1038"/>
          <ac:spMkLst>
            <pc:docMk/>
            <pc:sldMk cId="2755479697" sldId="657"/>
            <ac:spMk id="89" creationId="{0907A344-8B17-4CD5-8643-DC5A53A68265}"/>
          </ac:spMkLst>
        </pc:spChg>
        <pc:grpChg chg="add mod">
          <ac:chgData name="Hayk Barseghyan" userId="1af3c995-31f7-415e-9aa1-2b36900e994d" providerId="ADAL" clId="{ECAA696D-07C2-4671-886A-D983D4AD93C9}" dt="2021-04-16T20:31:01.540" v="287" actId="1038"/>
          <ac:grpSpMkLst>
            <pc:docMk/>
            <pc:sldMk cId="2755479697" sldId="657"/>
            <ac:grpSpMk id="4" creationId="{C368A8EB-14EF-4782-8C3C-F0388C5862E6}"/>
          </ac:grpSpMkLst>
        </pc:grpChg>
        <pc:grpChg chg="add mod">
          <ac:chgData name="Hayk Barseghyan" userId="1af3c995-31f7-415e-9aa1-2b36900e994d" providerId="ADAL" clId="{ECAA696D-07C2-4671-886A-D983D4AD93C9}" dt="2021-04-16T20:28:33.731" v="187" actId="164"/>
          <ac:grpSpMkLst>
            <pc:docMk/>
            <pc:sldMk cId="2755479697" sldId="657"/>
            <ac:grpSpMk id="54" creationId="{D2F2B013-C5E7-4E9D-8562-B9F2D67DB945}"/>
          </ac:grpSpMkLst>
        </pc:grpChg>
        <pc:picChg chg="add del mod">
          <ac:chgData name="Hayk Barseghyan" userId="1af3c995-31f7-415e-9aa1-2b36900e994d" providerId="ADAL" clId="{ECAA696D-07C2-4671-886A-D983D4AD93C9}" dt="2021-04-16T20:22:48.895" v="20" actId="478"/>
          <ac:picMkLst>
            <pc:docMk/>
            <pc:sldMk cId="2755479697" sldId="657"/>
            <ac:picMk id="3" creationId="{C43D1794-9875-4173-B879-4E2F9DE06D1F}"/>
          </ac:picMkLst>
        </pc:picChg>
        <pc:picChg chg="add mod">
          <ac:chgData name="Hayk Barseghyan" userId="1af3c995-31f7-415e-9aa1-2b36900e994d" providerId="ADAL" clId="{ECAA696D-07C2-4671-886A-D983D4AD93C9}" dt="2021-04-16T20:28:33.731" v="187" actId="164"/>
          <ac:picMkLst>
            <pc:docMk/>
            <pc:sldMk cId="2755479697" sldId="657"/>
            <ac:picMk id="53" creationId="{E22327CB-E139-4250-B07D-3341F9775563}"/>
          </ac:picMkLst>
        </pc:picChg>
        <pc:picChg chg="mod">
          <ac:chgData name="Hayk Barseghyan" userId="1af3c995-31f7-415e-9aa1-2b36900e994d" providerId="ADAL" clId="{ECAA696D-07C2-4671-886A-D983D4AD93C9}" dt="2021-04-16T20:22:49.384" v="21"/>
          <ac:picMkLst>
            <pc:docMk/>
            <pc:sldMk cId="2755479697" sldId="657"/>
            <ac:picMk id="55" creationId="{70F582B9-93A9-48A8-BB2F-44A40F2F2B90}"/>
          </ac:picMkLst>
        </pc:picChg>
        <pc:picChg chg="mod">
          <ac:chgData name="Hayk Barseghyan" userId="1af3c995-31f7-415e-9aa1-2b36900e994d" providerId="ADAL" clId="{ECAA696D-07C2-4671-886A-D983D4AD93C9}" dt="2021-04-16T20:22:49.384" v="21"/>
          <ac:picMkLst>
            <pc:docMk/>
            <pc:sldMk cId="2755479697" sldId="657"/>
            <ac:picMk id="56" creationId="{39225BE2-F126-4DED-A459-F465DFF5472C}"/>
          </ac:picMkLst>
        </pc:picChg>
        <pc:picChg chg="add mod">
          <ac:chgData name="Hayk Barseghyan" userId="1af3c995-31f7-415e-9aa1-2b36900e994d" providerId="ADAL" clId="{ECAA696D-07C2-4671-886A-D983D4AD93C9}" dt="2021-04-16T20:28:33.731" v="187" actId="164"/>
          <ac:picMkLst>
            <pc:docMk/>
            <pc:sldMk cId="2755479697" sldId="657"/>
            <ac:picMk id="57" creationId="{2ADCE061-2C18-45DA-98E8-6424F85E0F63}"/>
          </ac:picMkLst>
        </pc:picChg>
        <pc:picChg chg="add mod">
          <ac:chgData name="Hayk Barseghyan" userId="1af3c995-31f7-415e-9aa1-2b36900e994d" providerId="ADAL" clId="{ECAA696D-07C2-4671-886A-D983D4AD93C9}" dt="2021-04-16T20:28:33.731" v="187" actId="164"/>
          <ac:picMkLst>
            <pc:docMk/>
            <pc:sldMk cId="2755479697" sldId="657"/>
            <ac:picMk id="59" creationId="{C334BA2E-3D9C-43BC-A7ED-7E43B7E88220}"/>
          </ac:picMkLst>
        </pc:picChg>
        <pc:picChg chg="del">
          <ac:chgData name="Hayk Barseghyan" userId="1af3c995-31f7-415e-9aa1-2b36900e994d" providerId="ADAL" clId="{ECAA696D-07C2-4671-886A-D983D4AD93C9}" dt="2021-04-16T18:38:22.973" v="6" actId="478"/>
          <ac:picMkLst>
            <pc:docMk/>
            <pc:sldMk cId="2755479697" sldId="657"/>
            <ac:picMk id="86" creationId="{7998BD3D-AF7C-4AE7-8766-551D8298153B}"/>
          </ac:picMkLst>
        </pc:picChg>
        <pc:cxnChg chg="add mod">
          <ac:chgData name="Hayk Barseghyan" userId="1af3c995-31f7-415e-9aa1-2b36900e994d" providerId="ADAL" clId="{ECAA696D-07C2-4671-886A-D983D4AD93C9}" dt="2021-04-16T20:39:51.881" v="330" actId="208"/>
          <ac:cxnSpMkLst>
            <pc:docMk/>
            <pc:sldMk cId="2755479697" sldId="657"/>
            <ac:cxnSpMk id="8" creationId="{37C5667E-AF4C-4294-AE90-CB98C1920D8C}"/>
          </ac:cxnSpMkLst>
        </pc:cxnChg>
        <pc:cxnChg chg="add mod">
          <ac:chgData name="Hayk Barseghyan" userId="1af3c995-31f7-415e-9aa1-2b36900e994d" providerId="ADAL" clId="{ECAA696D-07C2-4671-886A-D983D4AD93C9}" dt="2021-04-16T20:28:33.731" v="187" actId="164"/>
          <ac:cxnSpMkLst>
            <pc:docMk/>
            <pc:sldMk cId="2755479697" sldId="657"/>
            <ac:cxnSpMk id="58" creationId="{BE81400E-E8EA-4BDC-94FA-7D442EA4D738}"/>
          </ac:cxnSpMkLst>
        </pc:cxnChg>
        <pc:cxnChg chg="add mod">
          <ac:chgData name="Hayk Barseghyan" userId="1af3c995-31f7-415e-9aa1-2b36900e994d" providerId="ADAL" clId="{ECAA696D-07C2-4671-886A-D983D4AD93C9}" dt="2021-04-16T20:40:06.115" v="333" actId="14100"/>
          <ac:cxnSpMkLst>
            <pc:docMk/>
            <pc:sldMk cId="2755479697" sldId="657"/>
            <ac:cxnSpMk id="67" creationId="{8725184B-9E61-4032-99E7-9E4C8A88DACF}"/>
          </ac:cxnSpMkLst>
        </pc:cxnChg>
      </pc:sldChg>
    </pc:docChg>
  </pc:docChgLst>
  <pc:docChgLst>
    <pc:chgData name="Hayk Barseghyan" userId="1af3c995-31f7-415e-9aa1-2b36900e994d" providerId="ADAL" clId="{55777B30-4759-489C-9469-E3C9A2B62456}"/>
    <pc:docChg chg="undo custSel addSld delSld modSld sldOrd">
      <pc:chgData name="Hayk Barseghyan" userId="1af3c995-31f7-415e-9aa1-2b36900e994d" providerId="ADAL" clId="{55777B30-4759-489C-9469-E3C9A2B62456}" dt="2021-02-12T22:29:38.070" v="319" actId="1035"/>
      <pc:docMkLst>
        <pc:docMk/>
      </pc:docMkLst>
      <pc:sldChg chg="addSp delSp modSp mod">
        <pc:chgData name="Hayk Barseghyan" userId="1af3c995-31f7-415e-9aa1-2b36900e994d" providerId="ADAL" clId="{55777B30-4759-489C-9469-E3C9A2B62456}" dt="2021-02-12T22:22:00.071" v="270" actId="14100"/>
        <pc:sldMkLst>
          <pc:docMk/>
          <pc:sldMk cId="524483127" sldId="651"/>
        </pc:sldMkLst>
        <pc:spChg chg="del">
          <ac:chgData name="Hayk Barseghyan" userId="1af3c995-31f7-415e-9aa1-2b36900e994d" providerId="ADAL" clId="{55777B30-4759-489C-9469-E3C9A2B62456}" dt="2021-02-12T22:13:58.784" v="12" actId="478"/>
          <ac:spMkLst>
            <pc:docMk/>
            <pc:sldMk cId="524483127" sldId="651"/>
            <ac:spMk id="9" creationId="{FAEB7540-E1AA-4AA8-8E2D-B822141FCC75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15" creationId="{1DA809E1-700B-4B5F-80D1-146841C532CC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16" creationId="{219D3844-749C-4AC5-8AAC-A5A6E4F706D5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17" creationId="{238D452B-545B-49D2-9AA5-4774F789BA52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18" creationId="{3B330CDD-DF8E-4329-9F8F-0C05A3EBA278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19" creationId="{92E3FBB9-4482-4901-BB7B-515414A60BF3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20" creationId="{33617DAE-E7EA-4947-A705-85255111007E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21" creationId="{C9A0FE9C-502B-4BBD-8A60-74F846E3930A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22" creationId="{097F0FB6-DB3D-4B12-9E76-180A15D9B845}"/>
          </ac:spMkLst>
        </pc:spChg>
        <pc:spChg chg="mod">
          <ac:chgData name="Hayk Barseghyan" userId="1af3c995-31f7-415e-9aa1-2b36900e994d" providerId="ADAL" clId="{55777B30-4759-489C-9469-E3C9A2B62456}" dt="2021-02-12T22:19:54.676" v="242" actId="1076"/>
          <ac:spMkLst>
            <pc:docMk/>
            <pc:sldMk cId="524483127" sldId="651"/>
            <ac:spMk id="32" creationId="{3C8C9310-67BF-4B6E-89F4-3CEC1EC49D05}"/>
          </ac:spMkLst>
        </pc:spChg>
        <pc:spChg chg="del">
          <ac:chgData name="Hayk Barseghyan" userId="1af3c995-31f7-415e-9aa1-2b36900e994d" providerId="ADAL" clId="{55777B30-4759-489C-9469-E3C9A2B62456}" dt="2021-02-12T22:14:00.984" v="13" actId="478"/>
          <ac:spMkLst>
            <pc:docMk/>
            <pc:sldMk cId="524483127" sldId="651"/>
            <ac:spMk id="45" creationId="{E1202E27-E275-4FF1-9346-5942DC51A46F}"/>
          </ac:spMkLst>
        </pc:spChg>
        <pc:spChg chg="del">
          <ac:chgData name="Hayk Barseghyan" userId="1af3c995-31f7-415e-9aa1-2b36900e994d" providerId="ADAL" clId="{55777B30-4759-489C-9469-E3C9A2B62456}" dt="2021-02-12T22:14:02.139" v="14" actId="478"/>
          <ac:spMkLst>
            <pc:docMk/>
            <pc:sldMk cId="524483127" sldId="651"/>
            <ac:spMk id="46" creationId="{53DB97C0-C16E-4AF3-9475-288F41C17F0C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48" creationId="{7DECEAD3-1F4B-4349-B3E1-EC2281C752C7}"/>
          </ac:spMkLst>
        </pc:spChg>
        <pc:spChg chg="del">
          <ac:chgData name="Hayk Barseghyan" userId="1af3c995-31f7-415e-9aa1-2b36900e994d" providerId="ADAL" clId="{55777B30-4759-489C-9469-E3C9A2B62456}" dt="2021-02-12T22:14:08.757" v="17" actId="478"/>
          <ac:spMkLst>
            <pc:docMk/>
            <pc:sldMk cId="524483127" sldId="651"/>
            <ac:spMk id="54" creationId="{F7458320-CCC7-41FB-87F4-002910417CD3}"/>
          </ac:spMkLst>
        </pc:spChg>
        <pc:spChg chg="add mod">
          <ac:chgData name="Hayk Barseghyan" userId="1af3c995-31f7-415e-9aa1-2b36900e994d" providerId="ADAL" clId="{55777B30-4759-489C-9469-E3C9A2B62456}" dt="2021-02-12T22:20:01.479" v="243" actId="1076"/>
          <ac:spMkLst>
            <pc:docMk/>
            <pc:sldMk cId="524483127" sldId="651"/>
            <ac:spMk id="55" creationId="{9AD5CECB-0BA9-4EBD-8AE8-0307D147913B}"/>
          </ac:spMkLst>
        </pc:spChg>
        <pc:spChg chg="del">
          <ac:chgData name="Hayk Barseghyan" userId="1af3c995-31f7-415e-9aa1-2b36900e994d" providerId="ADAL" clId="{55777B30-4759-489C-9469-E3C9A2B62456}" dt="2021-02-12T22:14:10.542" v="18" actId="478"/>
          <ac:spMkLst>
            <pc:docMk/>
            <pc:sldMk cId="524483127" sldId="651"/>
            <ac:spMk id="56" creationId="{902E1D0E-02B6-46FE-95D6-E066345D07BC}"/>
          </ac:spMkLst>
        </pc:spChg>
        <pc:spChg chg="del">
          <ac:chgData name="Hayk Barseghyan" userId="1af3c995-31f7-415e-9aa1-2b36900e994d" providerId="ADAL" clId="{55777B30-4759-489C-9469-E3C9A2B62456}" dt="2021-02-12T22:14:08.757" v="17" actId="478"/>
          <ac:spMkLst>
            <pc:docMk/>
            <pc:sldMk cId="524483127" sldId="651"/>
            <ac:spMk id="57" creationId="{5C46408B-2224-4888-8628-992ACAE3B9B5}"/>
          </ac:spMkLst>
        </pc:spChg>
        <pc:spChg chg="add mod">
          <ac:chgData name="Hayk Barseghyan" userId="1af3c995-31f7-415e-9aa1-2b36900e994d" providerId="ADAL" clId="{55777B30-4759-489C-9469-E3C9A2B62456}" dt="2021-02-12T22:20:01.479" v="243" actId="1076"/>
          <ac:spMkLst>
            <pc:docMk/>
            <pc:sldMk cId="524483127" sldId="651"/>
            <ac:spMk id="58" creationId="{002B4B61-AB6E-4E11-8801-11D8ACFF1C22}"/>
          </ac:spMkLst>
        </pc:spChg>
        <pc:spChg chg="add mod">
          <ac:chgData name="Hayk Barseghyan" userId="1af3c995-31f7-415e-9aa1-2b36900e994d" providerId="ADAL" clId="{55777B30-4759-489C-9469-E3C9A2B62456}" dt="2021-02-12T22:20:01.479" v="243" actId="1076"/>
          <ac:spMkLst>
            <pc:docMk/>
            <pc:sldMk cId="524483127" sldId="651"/>
            <ac:spMk id="59" creationId="{81B4F53B-4971-47E2-A09B-A1DE6AA56811}"/>
          </ac:spMkLst>
        </pc:spChg>
        <pc:spChg chg="add mod">
          <ac:chgData name="Hayk Barseghyan" userId="1af3c995-31f7-415e-9aa1-2b36900e994d" providerId="ADAL" clId="{55777B30-4759-489C-9469-E3C9A2B62456}" dt="2021-02-12T22:20:01.479" v="243" actId="1076"/>
          <ac:spMkLst>
            <pc:docMk/>
            <pc:sldMk cId="524483127" sldId="651"/>
            <ac:spMk id="60" creationId="{1A525A27-DC8A-4BFA-8660-F4F75A534028}"/>
          </ac:spMkLst>
        </pc:spChg>
        <pc:spChg chg="del">
          <ac:chgData name="Hayk Barseghyan" userId="1af3c995-31f7-415e-9aa1-2b36900e994d" providerId="ADAL" clId="{55777B30-4759-489C-9469-E3C9A2B62456}" dt="2021-02-12T22:14:08.757" v="17" actId="478"/>
          <ac:spMkLst>
            <pc:docMk/>
            <pc:sldMk cId="524483127" sldId="651"/>
            <ac:spMk id="61" creationId="{78673695-BE63-4187-8E05-62448935B3F1}"/>
          </ac:spMkLst>
        </pc:spChg>
        <pc:spChg chg="del">
          <ac:chgData name="Hayk Barseghyan" userId="1af3c995-31f7-415e-9aa1-2b36900e994d" providerId="ADAL" clId="{55777B30-4759-489C-9469-E3C9A2B62456}" dt="2021-02-12T22:14:03.807" v="15" actId="478"/>
          <ac:spMkLst>
            <pc:docMk/>
            <pc:sldMk cId="524483127" sldId="651"/>
            <ac:spMk id="62" creationId="{166F1B38-B853-4F51-B5BF-0D624B3F55C0}"/>
          </ac:spMkLst>
        </pc:spChg>
        <pc:spChg chg="add mod">
          <ac:chgData name="Hayk Barseghyan" userId="1af3c995-31f7-415e-9aa1-2b36900e994d" providerId="ADAL" clId="{55777B30-4759-489C-9469-E3C9A2B62456}" dt="2021-02-12T22:21:52.762" v="268" actId="14100"/>
          <ac:spMkLst>
            <pc:docMk/>
            <pc:sldMk cId="524483127" sldId="651"/>
            <ac:spMk id="68" creationId="{BFE438C0-9CDB-450A-9900-696FFB97E024}"/>
          </ac:spMkLst>
        </pc:spChg>
        <pc:spChg chg="add mod">
          <ac:chgData name="Hayk Barseghyan" userId="1af3c995-31f7-415e-9aa1-2b36900e994d" providerId="ADAL" clId="{55777B30-4759-489C-9469-E3C9A2B62456}" dt="2021-02-12T22:22:00.071" v="270" actId="14100"/>
          <ac:spMkLst>
            <pc:docMk/>
            <pc:sldMk cId="524483127" sldId="651"/>
            <ac:spMk id="69" creationId="{F076E557-D021-4E27-8E35-A6C953574CA2}"/>
          </ac:spMkLst>
        </pc:spChg>
        <pc:spChg chg="add mod">
          <ac:chgData name="Hayk Barseghyan" userId="1af3c995-31f7-415e-9aa1-2b36900e994d" providerId="ADAL" clId="{55777B30-4759-489C-9469-E3C9A2B62456}" dt="2021-02-12T22:21:20.603" v="261" actId="1035"/>
          <ac:spMkLst>
            <pc:docMk/>
            <pc:sldMk cId="524483127" sldId="651"/>
            <ac:spMk id="70" creationId="{71869405-F198-4778-BB55-85845ED07D4B}"/>
          </ac:spMkLst>
        </pc:spChg>
        <pc:spChg chg="add mod">
          <ac:chgData name="Hayk Barseghyan" userId="1af3c995-31f7-415e-9aa1-2b36900e994d" providerId="ADAL" clId="{55777B30-4759-489C-9469-E3C9A2B62456}" dt="2021-02-12T22:21:20.603" v="261" actId="1035"/>
          <ac:spMkLst>
            <pc:docMk/>
            <pc:sldMk cId="524483127" sldId="651"/>
            <ac:spMk id="71" creationId="{B4ED1561-7983-4F59-A4B7-657095020BBE}"/>
          </ac:spMkLst>
        </pc:spChg>
        <pc:spChg chg="add mod">
          <ac:chgData name="Hayk Barseghyan" userId="1af3c995-31f7-415e-9aa1-2b36900e994d" providerId="ADAL" clId="{55777B30-4759-489C-9469-E3C9A2B62456}" dt="2021-02-12T22:21:20.603" v="261" actId="1035"/>
          <ac:spMkLst>
            <pc:docMk/>
            <pc:sldMk cId="524483127" sldId="651"/>
            <ac:spMk id="72" creationId="{ADB5E731-8580-40D2-8E74-9E9B610A7035}"/>
          </ac:spMkLst>
        </pc:spChg>
        <pc:spChg chg="mod">
          <ac:chgData name="Hayk Barseghyan" userId="1af3c995-31f7-415e-9aa1-2b36900e994d" providerId="ADAL" clId="{55777B30-4759-489C-9469-E3C9A2B62456}" dt="2021-02-12T22:18:27.676" v="205" actId="1076"/>
          <ac:spMkLst>
            <pc:docMk/>
            <pc:sldMk cId="524483127" sldId="651"/>
            <ac:spMk id="88" creationId="{7309DE7D-82B3-4F46-B078-58EBF40D4703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91" creationId="{13B1F2AA-C6E8-4BA8-9C3E-AADD95A31E93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92" creationId="{C38076EE-D1EB-4356-9361-84DA46C2351B}"/>
          </ac:spMkLst>
        </pc:spChg>
        <pc:spChg chg="mod">
          <ac:chgData name="Hayk Barseghyan" userId="1af3c995-31f7-415e-9aa1-2b36900e994d" providerId="ADAL" clId="{55777B30-4759-489C-9469-E3C9A2B62456}" dt="2021-02-12T22:21:44.059" v="266" actId="14100"/>
          <ac:spMkLst>
            <pc:docMk/>
            <pc:sldMk cId="524483127" sldId="651"/>
            <ac:spMk id="93" creationId="{3EAC0E29-A0FD-42DD-8F3E-7B6BDF36A320}"/>
          </ac:spMkLst>
        </pc:spChg>
        <pc:spChg chg="mod">
          <ac:chgData name="Hayk Barseghyan" userId="1af3c995-31f7-415e-9aa1-2b36900e994d" providerId="ADAL" clId="{55777B30-4759-489C-9469-E3C9A2B62456}" dt="2021-02-12T22:21:36.457" v="264" actId="1076"/>
          <ac:spMkLst>
            <pc:docMk/>
            <pc:sldMk cId="524483127" sldId="651"/>
            <ac:spMk id="94" creationId="{C3B2E742-FF55-4D80-8A82-03F353C11C9E}"/>
          </ac:spMkLst>
        </pc:spChg>
        <pc:spChg chg="del">
          <ac:chgData name="Hayk Barseghyan" userId="1af3c995-31f7-415e-9aa1-2b36900e994d" providerId="ADAL" clId="{55777B30-4759-489C-9469-E3C9A2B62456}" dt="2021-02-12T21:44:46.082" v="9" actId="478"/>
          <ac:spMkLst>
            <pc:docMk/>
            <pc:sldMk cId="524483127" sldId="651"/>
            <ac:spMk id="97" creationId="{2C10D2CA-3F19-4321-86BC-73EED86092D3}"/>
          </ac:spMkLst>
        </pc:spChg>
        <pc:spChg chg="mod">
          <ac:chgData name="Hayk Barseghyan" userId="1af3c995-31f7-415e-9aa1-2b36900e994d" providerId="ADAL" clId="{55777B30-4759-489C-9469-E3C9A2B62456}" dt="2021-02-12T22:18:57.394" v="235" actId="1038"/>
          <ac:spMkLst>
            <pc:docMk/>
            <pc:sldMk cId="524483127" sldId="651"/>
            <ac:spMk id="98" creationId="{CC1A3F83-E94B-4F3C-9D62-2C0B7D404690}"/>
          </ac:spMkLst>
        </pc:spChg>
        <pc:picChg chg="mod">
          <ac:chgData name="Hayk Barseghyan" userId="1af3c995-31f7-415e-9aa1-2b36900e994d" providerId="ADAL" clId="{55777B30-4759-489C-9469-E3C9A2B62456}" dt="2021-02-12T22:18:57.394" v="235" actId="1038"/>
          <ac:picMkLst>
            <pc:docMk/>
            <pc:sldMk cId="524483127" sldId="651"/>
            <ac:picMk id="3" creationId="{4349EB37-DBC2-4C1A-92F4-42F3EFE3046E}"/>
          </ac:picMkLst>
        </pc:picChg>
        <pc:picChg chg="mod">
          <ac:chgData name="Hayk Barseghyan" userId="1af3c995-31f7-415e-9aa1-2b36900e994d" providerId="ADAL" clId="{55777B30-4759-489C-9469-E3C9A2B62456}" dt="2021-02-12T22:18:57.394" v="235" actId="1038"/>
          <ac:picMkLst>
            <pc:docMk/>
            <pc:sldMk cId="524483127" sldId="651"/>
            <ac:picMk id="14" creationId="{BD596D5A-A8B5-4F23-971B-B0033B030440}"/>
          </ac:picMkLst>
        </pc:picChg>
        <pc:picChg chg="add del">
          <ac:chgData name="Hayk Barseghyan" userId="1af3c995-31f7-415e-9aa1-2b36900e994d" providerId="ADAL" clId="{55777B30-4759-489C-9469-E3C9A2B62456}" dt="2021-02-12T21:44:42.992" v="8" actId="478"/>
          <ac:picMkLst>
            <pc:docMk/>
            <pc:sldMk cId="524483127" sldId="651"/>
            <ac:picMk id="37" creationId="{1CAC37ED-BD26-468D-A4D4-DD1DB2974763}"/>
          </ac:picMkLst>
        </pc:picChg>
        <pc:picChg chg="del">
          <ac:chgData name="Hayk Barseghyan" userId="1af3c995-31f7-415e-9aa1-2b36900e994d" providerId="ADAL" clId="{55777B30-4759-489C-9469-E3C9A2B62456}" dt="2021-02-12T22:14:05.363" v="16" actId="478"/>
          <ac:picMkLst>
            <pc:docMk/>
            <pc:sldMk cId="524483127" sldId="651"/>
            <ac:picMk id="47" creationId="{CEDD3B1B-C263-4B57-8CBB-CB1FEC2206B8}"/>
          </ac:picMkLst>
        </pc:picChg>
        <pc:picChg chg="add mod ord">
          <ac:chgData name="Hayk Barseghyan" userId="1af3c995-31f7-415e-9aa1-2b36900e994d" providerId="ADAL" clId="{55777B30-4759-489C-9469-E3C9A2B62456}" dt="2021-02-12T22:20:01.479" v="243" actId="1076"/>
          <ac:picMkLst>
            <pc:docMk/>
            <pc:sldMk cId="524483127" sldId="651"/>
            <ac:picMk id="53" creationId="{464C3B69-E342-48F9-B03D-0B5F5F0ACE9C}"/>
          </ac:picMkLst>
        </pc:picChg>
        <pc:picChg chg="add mod">
          <ac:chgData name="Hayk Barseghyan" userId="1af3c995-31f7-415e-9aa1-2b36900e994d" providerId="ADAL" clId="{55777B30-4759-489C-9469-E3C9A2B62456}" dt="2021-02-12T22:21:20.603" v="261" actId="1035"/>
          <ac:picMkLst>
            <pc:docMk/>
            <pc:sldMk cId="524483127" sldId="651"/>
            <ac:picMk id="67" creationId="{E570B23F-ADB0-46BD-A2CC-C574B9BEF054}"/>
          </ac:picMkLst>
        </pc:picChg>
        <pc:picChg chg="mod">
          <ac:chgData name="Hayk Barseghyan" userId="1af3c995-31f7-415e-9aa1-2b36900e994d" providerId="ADAL" clId="{55777B30-4759-489C-9469-E3C9A2B62456}" dt="2021-02-12T22:18:27.676" v="205" actId="1076"/>
          <ac:picMkLst>
            <pc:docMk/>
            <pc:sldMk cId="524483127" sldId="651"/>
            <ac:picMk id="87" creationId="{CB13D170-E4E8-47EE-A56B-B439A249975F}"/>
          </ac:picMkLst>
        </pc:picChg>
        <pc:cxnChg chg="del mod">
          <ac:chgData name="Hayk Barseghyan" userId="1af3c995-31f7-415e-9aa1-2b36900e994d" providerId="ADAL" clId="{55777B30-4759-489C-9469-E3C9A2B62456}" dt="2021-02-12T22:13:57.747" v="11" actId="478"/>
          <ac:cxnSpMkLst>
            <pc:docMk/>
            <pc:sldMk cId="524483127" sldId="651"/>
            <ac:cxnSpMk id="12" creationId="{77BFB2D3-AD99-4A46-A69B-5F7DA3AE9F40}"/>
          </ac:cxnSpMkLst>
        </pc:cxnChg>
        <pc:cxnChg chg="del mod">
          <ac:chgData name="Hayk Barseghyan" userId="1af3c995-31f7-415e-9aa1-2b36900e994d" providerId="ADAL" clId="{55777B30-4759-489C-9469-E3C9A2B62456}" dt="2021-02-12T22:13:54.212" v="10" actId="478"/>
          <ac:cxnSpMkLst>
            <pc:docMk/>
            <pc:sldMk cId="524483127" sldId="651"/>
            <ac:cxnSpMk id="13" creationId="{9C5A0F15-52CF-47D7-9374-8C8C2F340DD2}"/>
          </ac:cxnSpMkLst>
        </pc:cxnChg>
        <pc:cxnChg chg="mod">
          <ac:chgData name="Hayk Barseghyan" userId="1af3c995-31f7-415e-9aa1-2b36900e994d" providerId="ADAL" clId="{55777B30-4759-489C-9469-E3C9A2B62456}" dt="2021-02-12T22:18:57.394" v="235" actId="1038"/>
          <ac:cxnSpMkLst>
            <pc:docMk/>
            <pc:sldMk cId="524483127" sldId="651"/>
            <ac:cxnSpMk id="23" creationId="{B97A16ED-5542-4DD1-94CA-D032D3F72196}"/>
          </ac:cxnSpMkLst>
        </pc:cxnChg>
        <pc:cxnChg chg="mod">
          <ac:chgData name="Hayk Barseghyan" userId="1af3c995-31f7-415e-9aa1-2b36900e994d" providerId="ADAL" clId="{55777B30-4759-489C-9469-E3C9A2B62456}" dt="2021-02-12T22:18:57.394" v="235" actId="1038"/>
          <ac:cxnSpMkLst>
            <pc:docMk/>
            <pc:sldMk cId="524483127" sldId="651"/>
            <ac:cxnSpMk id="24" creationId="{792D8F66-E748-410F-BB9B-B632B254BDFB}"/>
          </ac:cxnSpMkLst>
        </pc:cxnChg>
        <pc:cxnChg chg="mod">
          <ac:chgData name="Hayk Barseghyan" userId="1af3c995-31f7-415e-9aa1-2b36900e994d" providerId="ADAL" clId="{55777B30-4759-489C-9469-E3C9A2B62456}" dt="2021-02-12T22:18:57.394" v="235" actId="1038"/>
          <ac:cxnSpMkLst>
            <pc:docMk/>
            <pc:sldMk cId="524483127" sldId="651"/>
            <ac:cxnSpMk id="25" creationId="{A4F48631-3605-414B-96A3-B4E7701F3903}"/>
          </ac:cxnSpMkLst>
        </pc:cxnChg>
        <pc:cxnChg chg="mod">
          <ac:chgData name="Hayk Barseghyan" userId="1af3c995-31f7-415e-9aa1-2b36900e994d" providerId="ADAL" clId="{55777B30-4759-489C-9469-E3C9A2B62456}" dt="2021-02-12T22:19:07.293" v="236" actId="14100"/>
          <ac:cxnSpMkLst>
            <pc:docMk/>
            <pc:sldMk cId="524483127" sldId="651"/>
            <ac:cxnSpMk id="49" creationId="{4423681D-AADF-4D62-AC9E-3FDDF18E21B9}"/>
          </ac:cxnSpMkLst>
        </pc:cxnChg>
        <pc:cxnChg chg="mod">
          <ac:chgData name="Hayk Barseghyan" userId="1af3c995-31f7-415e-9aa1-2b36900e994d" providerId="ADAL" clId="{55777B30-4759-489C-9469-E3C9A2B62456}" dt="2021-02-12T22:19:10.618" v="237" actId="14100"/>
          <ac:cxnSpMkLst>
            <pc:docMk/>
            <pc:sldMk cId="524483127" sldId="651"/>
            <ac:cxnSpMk id="52" creationId="{67E81840-D31A-48DD-9275-CD08F7D6F031}"/>
          </ac:cxnSpMkLst>
        </pc:cxnChg>
        <pc:cxnChg chg="del">
          <ac:chgData name="Hayk Barseghyan" userId="1af3c995-31f7-415e-9aa1-2b36900e994d" providerId="ADAL" clId="{55777B30-4759-489C-9469-E3C9A2B62456}" dt="2021-02-12T22:14:08.757" v="17" actId="478"/>
          <ac:cxnSpMkLst>
            <pc:docMk/>
            <pc:sldMk cId="524483127" sldId="651"/>
            <ac:cxnSpMk id="63" creationId="{C0AA72CC-1333-4FD8-8FD6-2BAF30BE944A}"/>
          </ac:cxnSpMkLst>
        </pc:cxnChg>
        <pc:cxnChg chg="add mod">
          <ac:chgData name="Hayk Barseghyan" userId="1af3c995-31f7-415e-9aa1-2b36900e994d" providerId="ADAL" clId="{55777B30-4759-489C-9469-E3C9A2B62456}" dt="2021-02-12T22:21:10.049" v="253" actId="14100"/>
          <ac:cxnSpMkLst>
            <pc:docMk/>
            <pc:sldMk cId="524483127" sldId="651"/>
            <ac:cxnSpMk id="64" creationId="{F274B9A3-4C67-4722-8732-C7A66953712F}"/>
          </ac:cxnSpMkLst>
        </pc:cxnChg>
        <pc:cxnChg chg="add mod">
          <ac:chgData name="Hayk Barseghyan" userId="1af3c995-31f7-415e-9aa1-2b36900e994d" providerId="ADAL" clId="{55777B30-4759-489C-9469-E3C9A2B62456}" dt="2021-02-12T22:21:00.637" v="251" actId="14100"/>
          <ac:cxnSpMkLst>
            <pc:docMk/>
            <pc:sldMk cId="524483127" sldId="651"/>
            <ac:cxnSpMk id="65" creationId="{D98E99A8-FFAE-4851-A23C-C378F77B6F31}"/>
          </ac:cxnSpMkLst>
        </pc:cxnChg>
        <pc:cxnChg chg="add del mod">
          <ac:chgData name="Hayk Barseghyan" userId="1af3c995-31f7-415e-9aa1-2b36900e994d" providerId="ADAL" clId="{55777B30-4759-489C-9469-E3C9A2B62456}" dt="2021-02-12T22:20:53.199" v="250" actId="478"/>
          <ac:cxnSpMkLst>
            <pc:docMk/>
            <pc:sldMk cId="524483127" sldId="651"/>
            <ac:cxnSpMk id="66" creationId="{5A79555D-C5C3-45E1-9594-B8AAEC25BBB3}"/>
          </ac:cxnSpMkLst>
        </pc:cxnChg>
        <pc:cxnChg chg="add mod">
          <ac:chgData name="Hayk Barseghyan" userId="1af3c995-31f7-415e-9aa1-2b36900e994d" providerId="ADAL" clId="{55777B30-4759-489C-9469-E3C9A2B62456}" dt="2021-02-12T22:21:20.603" v="261" actId="1035"/>
          <ac:cxnSpMkLst>
            <pc:docMk/>
            <pc:sldMk cId="524483127" sldId="651"/>
            <ac:cxnSpMk id="73" creationId="{20C8AA2C-05C4-4361-83EB-053DFCFB4BD6}"/>
          </ac:cxnSpMkLst>
        </pc:cxnChg>
        <pc:cxnChg chg="mod">
          <ac:chgData name="Hayk Barseghyan" userId="1af3c995-31f7-415e-9aa1-2b36900e994d" providerId="ADAL" clId="{55777B30-4759-489C-9469-E3C9A2B62456}" dt="2021-02-12T22:18:27.676" v="205" actId="1076"/>
          <ac:cxnSpMkLst>
            <pc:docMk/>
            <pc:sldMk cId="524483127" sldId="651"/>
            <ac:cxnSpMk id="95" creationId="{5EB10151-CF0F-4162-A03A-2FB4661DCBE8}"/>
          </ac:cxnSpMkLst>
        </pc:cxnChg>
      </pc:sldChg>
      <pc:sldChg chg="modSp mod">
        <pc:chgData name="Hayk Barseghyan" userId="1af3c995-31f7-415e-9aa1-2b36900e994d" providerId="ADAL" clId="{55777B30-4759-489C-9469-E3C9A2B62456}" dt="2021-02-12T22:29:38.070" v="319" actId="1035"/>
        <pc:sldMkLst>
          <pc:docMk/>
          <pc:sldMk cId="827945534" sldId="654"/>
        </pc:sldMkLst>
        <pc:spChg chg="mod">
          <ac:chgData name="Hayk Barseghyan" userId="1af3c995-31f7-415e-9aa1-2b36900e994d" providerId="ADAL" clId="{55777B30-4759-489C-9469-E3C9A2B62456}" dt="2021-02-12T22:29:26.533" v="314" actId="1035"/>
          <ac:spMkLst>
            <pc:docMk/>
            <pc:sldMk cId="827945534" sldId="654"/>
            <ac:spMk id="44" creationId="{0C85C3E2-DE72-4F69-97FD-EE2A64F65902}"/>
          </ac:spMkLst>
        </pc:spChg>
        <pc:spChg chg="mod">
          <ac:chgData name="Hayk Barseghyan" userId="1af3c995-31f7-415e-9aa1-2b36900e994d" providerId="ADAL" clId="{55777B30-4759-489C-9469-E3C9A2B62456}" dt="2021-02-12T22:29:38.070" v="319" actId="1035"/>
          <ac:spMkLst>
            <pc:docMk/>
            <pc:sldMk cId="827945534" sldId="654"/>
            <ac:spMk id="50" creationId="{55CD9F97-512F-48BF-9B69-5CDE38C934FC}"/>
          </ac:spMkLst>
        </pc:spChg>
        <pc:spChg chg="mod">
          <ac:chgData name="Hayk Barseghyan" userId="1af3c995-31f7-415e-9aa1-2b36900e994d" providerId="ADAL" clId="{55777B30-4759-489C-9469-E3C9A2B62456}" dt="2021-02-12T22:29:08.701" v="309" actId="255"/>
          <ac:spMkLst>
            <pc:docMk/>
            <pc:sldMk cId="827945534" sldId="654"/>
            <ac:spMk id="51" creationId="{AC3B91D7-FF9B-4988-9E6B-EAD51DD2DF4F}"/>
          </ac:spMkLst>
        </pc:spChg>
        <pc:spChg chg="mod">
          <ac:chgData name="Hayk Barseghyan" userId="1af3c995-31f7-415e-9aa1-2b36900e994d" providerId="ADAL" clId="{55777B30-4759-489C-9469-E3C9A2B62456}" dt="2021-02-12T22:28:52.538" v="304" actId="1035"/>
          <ac:spMkLst>
            <pc:docMk/>
            <pc:sldMk cId="827945534" sldId="654"/>
            <ac:spMk id="69" creationId="{E1E5F7CF-BD53-4D18-9581-71C86B5CC80B}"/>
          </ac:spMkLst>
        </pc:spChg>
        <pc:spChg chg="mod">
          <ac:chgData name="Hayk Barseghyan" userId="1af3c995-31f7-415e-9aa1-2b36900e994d" providerId="ADAL" clId="{55777B30-4759-489C-9469-E3C9A2B62456}" dt="2021-02-12T22:28:39.485" v="290" actId="1035"/>
          <ac:spMkLst>
            <pc:docMk/>
            <pc:sldMk cId="827945534" sldId="654"/>
            <ac:spMk id="70" creationId="{C130D79F-13B5-4C92-B80F-4EB8B3100D47}"/>
          </ac:spMkLst>
        </pc:spChg>
        <pc:spChg chg="mod">
          <ac:chgData name="Hayk Barseghyan" userId="1af3c995-31f7-415e-9aa1-2b36900e994d" providerId="ADAL" clId="{55777B30-4759-489C-9469-E3C9A2B62456}" dt="2021-02-12T22:28:28.095" v="280" actId="14100"/>
          <ac:spMkLst>
            <pc:docMk/>
            <pc:sldMk cId="827945534" sldId="654"/>
            <ac:spMk id="86" creationId="{88884125-F75C-4D8B-80D0-8186E9D62A91}"/>
          </ac:spMkLst>
        </pc:spChg>
        <pc:spChg chg="mod">
          <ac:chgData name="Hayk Barseghyan" userId="1af3c995-31f7-415e-9aa1-2b36900e994d" providerId="ADAL" clId="{55777B30-4759-489C-9469-E3C9A2B62456}" dt="2021-02-12T22:28:20.848" v="278" actId="1035"/>
          <ac:spMkLst>
            <pc:docMk/>
            <pc:sldMk cId="827945534" sldId="654"/>
            <ac:spMk id="89" creationId="{73E0F48C-F069-413E-8BDC-0DEC675D822E}"/>
          </ac:spMkLst>
        </pc:spChg>
        <pc:spChg chg="mod">
          <ac:chgData name="Hayk Barseghyan" userId="1af3c995-31f7-415e-9aa1-2b36900e994d" providerId="ADAL" clId="{55777B30-4759-489C-9469-E3C9A2B62456}" dt="2021-02-12T22:29:01.988" v="308" actId="1035"/>
          <ac:spMkLst>
            <pc:docMk/>
            <pc:sldMk cId="827945534" sldId="654"/>
            <ac:spMk id="101" creationId="{C9248449-982F-4C60-8168-07A673D9C059}"/>
          </ac:spMkLst>
        </pc:spChg>
      </pc:sldChg>
      <pc:sldChg chg="add ord">
        <pc:chgData name="Hayk Barseghyan" userId="1af3c995-31f7-415e-9aa1-2b36900e994d" providerId="ADAL" clId="{55777B30-4759-489C-9469-E3C9A2B62456}" dt="2021-02-12T19:29:21.631" v="2"/>
        <pc:sldMkLst>
          <pc:docMk/>
          <pc:sldMk cId="1377579920" sldId="4369"/>
        </pc:sldMkLst>
      </pc:sldChg>
      <pc:sldChg chg="add ord">
        <pc:chgData name="Hayk Barseghyan" userId="1af3c995-31f7-415e-9aa1-2b36900e994d" providerId="ADAL" clId="{55777B30-4759-489C-9469-E3C9A2B62456}" dt="2021-02-12T19:29:23.934" v="4"/>
        <pc:sldMkLst>
          <pc:docMk/>
          <pc:sldMk cId="2324661198" sldId="4370"/>
        </pc:sldMkLst>
      </pc:sldChg>
      <pc:sldChg chg="add del">
        <pc:chgData name="Hayk Barseghyan" userId="1af3c995-31f7-415e-9aa1-2b36900e994d" providerId="ADAL" clId="{55777B30-4759-489C-9469-E3C9A2B62456}" dt="2021-02-12T22:22:41.089" v="271" actId="47"/>
        <pc:sldMkLst>
          <pc:docMk/>
          <pc:sldMk cId="1783779040" sldId="4371"/>
        </pc:sldMkLst>
      </pc:sldChg>
    </pc:docChg>
  </pc:docChgLst>
  <pc:docChgLst>
    <pc:chgData name="Hayk Barseghyan" userId="1af3c995-31f7-415e-9aa1-2b36900e994d" providerId="ADAL" clId="{3E3BB8FF-7463-48E0-B83F-7175787D09E2}"/>
    <pc:docChg chg="undo custSel addSld delSld modSld sldOrd">
      <pc:chgData name="Hayk Barseghyan" userId="1af3c995-31f7-415e-9aa1-2b36900e994d" providerId="ADAL" clId="{3E3BB8FF-7463-48E0-B83F-7175787D09E2}" dt="2021-08-23T23:15:40.723" v="474"/>
      <pc:docMkLst>
        <pc:docMk/>
      </pc:docMkLst>
      <pc:sldChg chg="modSp mod">
        <pc:chgData name="Hayk Barseghyan" userId="1af3c995-31f7-415e-9aa1-2b36900e994d" providerId="ADAL" clId="{3E3BB8FF-7463-48E0-B83F-7175787D09E2}" dt="2021-07-23T19:43:26.263" v="100" actId="20577"/>
        <pc:sldMkLst>
          <pc:docMk/>
          <pc:sldMk cId="2946833462" sldId="671"/>
        </pc:sldMkLst>
        <pc:spChg chg="mod">
          <ac:chgData name="Hayk Barseghyan" userId="1af3c995-31f7-415e-9aa1-2b36900e994d" providerId="ADAL" clId="{3E3BB8FF-7463-48E0-B83F-7175787D09E2}" dt="2021-07-23T19:43:26.263" v="100" actId="20577"/>
          <ac:spMkLst>
            <pc:docMk/>
            <pc:sldMk cId="2946833462" sldId="671"/>
            <ac:spMk id="33" creationId="{27D04DB1-6D7F-4335-AAA1-99D44F3F14E9}"/>
          </ac:spMkLst>
        </pc:spChg>
      </pc:sldChg>
      <pc:sldChg chg="modSp mod ord modNotesTx">
        <pc:chgData name="Hayk Barseghyan" userId="1af3c995-31f7-415e-9aa1-2b36900e994d" providerId="ADAL" clId="{3E3BB8FF-7463-48E0-B83F-7175787D09E2}" dt="2021-08-10T19:31:02.475" v="326"/>
        <pc:sldMkLst>
          <pc:docMk/>
          <pc:sldMk cId="1326918807" sldId="673"/>
        </pc:sldMkLst>
        <pc:spChg chg="mod">
          <ac:chgData name="Hayk Barseghyan" userId="1af3c995-31f7-415e-9aa1-2b36900e994d" providerId="ADAL" clId="{3E3BB8FF-7463-48E0-B83F-7175787D09E2}" dt="2021-08-09T23:38:32.259" v="318" actId="20577"/>
          <ac:spMkLst>
            <pc:docMk/>
            <pc:sldMk cId="1326918807" sldId="673"/>
            <ac:spMk id="33" creationId="{27D04DB1-6D7F-4335-AAA1-99D44F3F14E9}"/>
          </ac:spMkLst>
        </pc:spChg>
      </pc:sldChg>
      <pc:sldChg chg="addSp delSp modSp add mod">
        <pc:chgData name="Hayk Barseghyan" userId="1af3c995-31f7-415e-9aa1-2b36900e994d" providerId="ADAL" clId="{3E3BB8FF-7463-48E0-B83F-7175787D09E2}" dt="2021-07-23T18:42:49.766" v="96" actId="1076"/>
        <pc:sldMkLst>
          <pc:docMk/>
          <pc:sldMk cId="1894380217" sldId="674"/>
        </pc:sldMkLst>
        <pc:spChg chg="add mod">
          <ac:chgData name="Hayk Barseghyan" userId="1af3c995-31f7-415e-9aa1-2b36900e994d" providerId="ADAL" clId="{3E3BB8FF-7463-48E0-B83F-7175787D09E2}" dt="2021-07-23T18:42:43.983" v="94" actId="1035"/>
          <ac:spMkLst>
            <pc:docMk/>
            <pc:sldMk cId="1894380217" sldId="674"/>
            <ac:spMk id="17" creationId="{C343FFD7-1811-46C8-B40A-EFDFA0EC724D}"/>
          </ac:spMkLst>
        </pc:spChg>
        <pc:spChg chg="mod">
          <ac:chgData name="Hayk Barseghyan" userId="1af3c995-31f7-415e-9aa1-2b36900e994d" providerId="ADAL" clId="{3E3BB8FF-7463-48E0-B83F-7175787D09E2}" dt="2021-07-23T18:34:04.124" v="8" actId="20577"/>
          <ac:spMkLst>
            <pc:docMk/>
            <pc:sldMk cId="1894380217" sldId="674"/>
            <ac:spMk id="33" creationId="{27D04DB1-6D7F-4335-AAA1-99D44F3F14E9}"/>
          </ac:spMkLst>
        </pc:spChg>
        <pc:spChg chg="mod">
          <ac:chgData name="Hayk Barseghyan" userId="1af3c995-31f7-415e-9aa1-2b36900e994d" providerId="ADAL" clId="{3E3BB8FF-7463-48E0-B83F-7175787D09E2}" dt="2021-07-23T18:41:27.387" v="22" actId="14100"/>
          <ac:spMkLst>
            <pc:docMk/>
            <pc:sldMk cId="1894380217" sldId="674"/>
            <ac:spMk id="39" creationId="{C6930C5C-1A06-4122-AEF1-3939C5BC870A}"/>
          </ac:spMkLst>
        </pc:spChg>
        <pc:spChg chg="mod">
          <ac:chgData name="Hayk Barseghyan" userId="1af3c995-31f7-415e-9aa1-2b36900e994d" providerId="ADAL" clId="{3E3BB8FF-7463-48E0-B83F-7175787D09E2}" dt="2021-07-23T18:41:37.193" v="26" actId="1076"/>
          <ac:spMkLst>
            <pc:docMk/>
            <pc:sldMk cId="1894380217" sldId="674"/>
            <ac:spMk id="42" creationId="{1A14296C-A126-4A4E-83FF-3B21985FF6C3}"/>
          </ac:spMkLst>
        </pc:spChg>
        <pc:spChg chg="mod">
          <ac:chgData name="Hayk Barseghyan" userId="1af3c995-31f7-415e-9aa1-2b36900e994d" providerId="ADAL" clId="{3E3BB8FF-7463-48E0-B83F-7175787D09E2}" dt="2021-07-23T18:41:45.567" v="28" actId="1076"/>
          <ac:spMkLst>
            <pc:docMk/>
            <pc:sldMk cId="1894380217" sldId="674"/>
            <ac:spMk id="47" creationId="{8AE1C1CF-2982-46EE-BBB5-F2BFC3AE3ED5}"/>
          </ac:spMkLst>
        </pc:spChg>
        <pc:spChg chg="mod">
          <ac:chgData name="Hayk Barseghyan" userId="1af3c995-31f7-415e-9aa1-2b36900e994d" providerId="ADAL" clId="{3E3BB8FF-7463-48E0-B83F-7175787D09E2}" dt="2021-07-23T18:41:59.762" v="33" actId="1076"/>
          <ac:spMkLst>
            <pc:docMk/>
            <pc:sldMk cId="1894380217" sldId="674"/>
            <ac:spMk id="50" creationId="{3B7C139F-6476-4E93-B928-A38566762C3A}"/>
          </ac:spMkLst>
        </pc:spChg>
        <pc:spChg chg="mod">
          <ac:chgData name="Hayk Barseghyan" userId="1af3c995-31f7-415e-9aa1-2b36900e994d" providerId="ADAL" clId="{3E3BB8FF-7463-48E0-B83F-7175787D09E2}" dt="2021-07-23T18:42:22.954" v="47" actId="1076"/>
          <ac:spMkLst>
            <pc:docMk/>
            <pc:sldMk cId="1894380217" sldId="674"/>
            <ac:spMk id="53" creationId="{C3FB21F2-301A-4C0F-B759-287A936DA90E}"/>
          </ac:spMkLst>
        </pc:spChg>
        <pc:spChg chg="del mod">
          <ac:chgData name="Hayk Barseghyan" userId="1af3c995-31f7-415e-9aa1-2b36900e994d" providerId="ADAL" clId="{3E3BB8FF-7463-48E0-B83F-7175787D09E2}" dt="2021-07-23T18:42:47.059" v="95" actId="478"/>
          <ac:spMkLst>
            <pc:docMk/>
            <pc:sldMk cId="1894380217" sldId="674"/>
            <ac:spMk id="55" creationId="{1480A490-4E36-4102-8115-ADC2AA4F7761}"/>
          </ac:spMkLst>
        </pc:spChg>
        <pc:spChg chg="mod">
          <ac:chgData name="Hayk Barseghyan" userId="1af3c995-31f7-415e-9aa1-2b36900e994d" providerId="ADAL" clId="{3E3BB8FF-7463-48E0-B83F-7175787D09E2}" dt="2021-07-23T18:42:49.766" v="96" actId="1076"/>
          <ac:spMkLst>
            <pc:docMk/>
            <pc:sldMk cId="1894380217" sldId="674"/>
            <ac:spMk id="56" creationId="{CFC98ADF-75D5-4DB7-BE62-79053734A9E8}"/>
          </ac:spMkLst>
        </pc:spChg>
        <pc:spChg chg="del">
          <ac:chgData name="Hayk Barseghyan" userId="1af3c995-31f7-415e-9aa1-2b36900e994d" providerId="ADAL" clId="{3E3BB8FF-7463-48E0-B83F-7175787D09E2}" dt="2021-07-23T18:34:16.108" v="11" actId="478"/>
          <ac:spMkLst>
            <pc:docMk/>
            <pc:sldMk cId="1894380217" sldId="674"/>
            <ac:spMk id="57" creationId="{C96C0B54-C927-4F57-9448-61F2B86967BC}"/>
          </ac:spMkLst>
        </pc:spChg>
        <pc:spChg chg="del">
          <ac:chgData name="Hayk Barseghyan" userId="1af3c995-31f7-415e-9aa1-2b36900e994d" providerId="ADAL" clId="{3E3BB8FF-7463-48E0-B83F-7175787D09E2}" dt="2021-07-23T18:34:16.108" v="11" actId="478"/>
          <ac:spMkLst>
            <pc:docMk/>
            <pc:sldMk cId="1894380217" sldId="674"/>
            <ac:spMk id="58" creationId="{987FE37B-B689-41AF-BF07-7F3C3FAD1AE1}"/>
          </ac:spMkLst>
        </pc:spChg>
        <pc:picChg chg="add mod">
          <ac:chgData name="Hayk Barseghyan" userId="1af3c995-31f7-415e-9aa1-2b36900e994d" providerId="ADAL" clId="{3E3BB8FF-7463-48E0-B83F-7175787D09E2}" dt="2021-07-23T18:41:21.887" v="21" actId="14100"/>
          <ac:picMkLst>
            <pc:docMk/>
            <pc:sldMk cId="1894380217" sldId="674"/>
            <ac:picMk id="3" creationId="{CEE35313-B80B-4C60-AC98-1196045232A4}"/>
          </ac:picMkLst>
        </pc:picChg>
        <pc:picChg chg="del">
          <ac:chgData name="Hayk Barseghyan" userId="1af3c995-31f7-415e-9aa1-2b36900e994d" providerId="ADAL" clId="{3E3BB8FF-7463-48E0-B83F-7175787D09E2}" dt="2021-07-23T18:34:11.460" v="9" actId="478"/>
          <ac:picMkLst>
            <pc:docMk/>
            <pc:sldMk cId="1894380217" sldId="674"/>
            <ac:picMk id="6" creationId="{F6AB2EC4-60C1-41BD-8793-D6840DD687B2}"/>
          </ac:picMkLst>
        </pc:picChg>
        <pc:picChg chg="del">
          <ac:chgData name="Hayk Barseghyan" userId="1af3c995-31f7-415e-9aa1-2b36900e994d" providerId="ADAL" clId="{3E3BB8FF-7463-48E0-B83F-7175787D09E2}" dt="2021-07-23T18:34:13.109" v="10" actId="478"/>
          <ac:picMkLst>
            <pc:docMk/>
            <pc:sldMk cId="1894380217" sldId="674"/>
            <ac:picMk id="8" creationId="{83CD2CE8-9922-4F0B-A1FE-1866A3018006}"/>
          </ac:picMkLst>
        </pc:picChg>
        <pc:cxnChg chg="del">
          <ac:chgData name="Hayk Barseghyan" userId="1af3c995-31f7-415e-9aa1-2b36900e994d" providerId="ADAL" clId="{3E3BB8FF-7463-48E0-B83F-7175787D09E2}" dt="2021-07-23T18:34:16.108" v="11" actId="478"/>
          <ac:cxnSpMkLst>
            <pc:docMk/>
            <pc:sldMk cId="1894380217" sldId="674"/>
            <ac:cxnSpMk id="10" creationId="{D0270CF5-E165-434E-BEC2-B69D1690DF1F}"/>
          </ac:cxnSpMkLst>
        </pc:cxnChg>
      </pc:sldChg>
      <pc:sldChg chg="addSp delSp modSp add mod modNotesTx">
        <pc:chgData name="Hayk Barseghyan" userId="1af3c995-31f7-415e-9aa1-2b36900e994d" providerId="ADAL" clId="{3E3BB8FF-7463-48E0-B83F-7175787D09E2}" dt="2021-08-10T19:30:52.085" v="325"/>
        <pc:sldMkLst>
          <pc:docMk/>
          <pc:sldMk cId="367579465" sldId="675"/>
        </pc:sldMkLst>
        <pc:spChg chg="del">
          <ac:chgData name="Hayk Barseghyan" userId="1af3c995-31f7-415e-9aa1-2b36900e994d" providerId="ADAL" clId="{3E3BB8FF-7463-48E0-B83F-7175787D09E2}" dt="2021-08-09T23:18:57.185" v="104" actId="478"/>
          <ac:spMkLst>
            <pc:docMk/>
            <pc:sldMk cId="367579465" sldId="675"/>
            <ac:spMk id="15" creationId="{1DA809E1-700B-4B5F-80D1-146841C532CC}"/>
          </ac:spMkLst>
        </pc:spChg>
        <pc:spChg chg="del">
          <ac:chgData name="Hayk Barseghyan" userId="1af3c995-31f7-415e-9aa1-2b36900e994d" providerId="ADAL" clId="{3E3BB8FF-7463-48E0-B83F-7175787D09E2}" dt="2021-08-09T23:18:57.185" v="104" actId="478"/>
          <ac:spMkLst>
            <pc:docMk/>
            <pc:sldMk cId="367579465" sldId="675"/>
            <ac:spMk id="16" creationId="{219D3844-749C-4AC5-8AAC-A5A6E4F706D5}"/>
          </ac:spMkLst>
        </pc:spChg>
        <pc:spChg chg="del">
          <ac:chgData name="Hayk Barseghyan" userId="1af3c995-31f7-415e-9aa1-2b36900e994d" providerId="ADAL" clId="{3E3BB8FF-7463-48E0-B83F-7175787D09E2}" dt="2021-08-09T23:18:57.185" v="104" actId="478"/>
          <ac:spMkLst>
            <pc:docMk/>
            <pc:sldMk cId="367579465" sldId="675"/>
            <ac:spMk id="17" creationId="{238D452B-545B-49D2-9AA5-4774F789BA52}"/>
          </ac:spMkLst>
        </pc:spChg>
        <pc:spChg chg="del">
          <ac:chgData name="Hayk Barseghyan" userId="1af3c995-31f7-415e-9aa1-2b36900e994d" providerId="ADAL" clId="{3E3BB8FF-7463-48E0-B83F-7175787D09E2}" dt="2021-08-09T23:18:57.185" v="104" actId="478"/>
          <ac:spMkLst>
            <pc:docMk/>
            <pc:sldMk cId="367579465" sldId="675"/>
            <ac:spMk id="18" creationId="{3B330CDD-DF8E-4329-9F8F-0C05A3EBA278}"/>
          </ac:spMkLst>
        </pc:spChg>
        <pc:spChg chg="del">
          <ac:chgData name="Hayk Barseghyan" userId="1af3c995-31f7-415e-9aa1-2b36900e994d" providerId="ADAL" clId="{3E3BB8FF-7463-48E0-B83F-7175787D09E2}" dt="2021-08-09T23:18:57.185" v="104" actId="478"/>
          <ac:spMkLst>
            <pc:docMk/>
            <pc:sldMk cId="367579465" sldId="675"/>
            <ac:spMk id="19" creationId="{92E3FBB9-4482-4901-BB7B-515414A60BF3}"/>
          </ac:spMkLst>
        </pc:spChg>
        <pc:spChg chg="del">
          <ac:chgData name="Hayk Barseghyan" userId="1af3c995-31f7-415e-9aa1-2b36900e994d" providerId="ADAL" clId="{3E3BB8FF-7463-48E0-B83F-7175787D09E2}" dt="2021-08-09T23:18:57.185" v="104" actId="478"/>
          <ac:spMkLst>
            <pc:docMk/>
            <pc:sldMk cId="367579465" sldId="675"/>
            <ac:spMk id="20" creationId="{33617DAE-E7EA-4947-A705-85255111007E}"/>
          </ac:spMkLst>
        </pc:spChg>
        <pc:spChg chg="del">
          <ac:chgData name="Hayk Barseghyan" userId="1af3c995-31f7-415e-9aa1-2b36900e994d" providerId="ADAL" clId="{3E3BB8FF-7463-48E0-B83F-7175787D09E2}" dt="2021-08-09T23:18:57.185" v="104" actId="478"/>
          <ac:spMkLst>
            <pc:docMk/>
            <pc:sldMk cId="367579465" sldId="675"/>
            <ac:spMk id="21" creationId="{C9A0FE9C-502B-4BBD-8A60-74F846E3930A}"/>
          </ac:spMkLst>
        </pc:spChg>
        <pc:spChg chg="del">
          <ac:chgData name="Hayk Barseghyan" userId="1af3c995-31f7-415e-9aa1-2b36900e994d" providerId="ADAL" clId="{3E3BB8FF-7463-48E0-B83F-7175787D09E2}" dt="2021-08-09T23:19:00.299" v="105" actId="478"/>
          <ac:spMkLst>
            <pc:docMk/>
            <pc:sldMk cId="367579465" sldId="675"/>
            <ac:spMk id="22" creationId="{097F0FB6-DB3D-4B12-9E76-180A15D9B845}"/>
          </ac:spMkLst>
        </pc:spChg>
        <pc:spChg chg="mod">
          <ac:chgData name="Hayk Barseghyan" userId="1af3c995-31f7-415e-9aa1-2b36900e994d" providerId="ADAL" clId="{3E3BB8FF-7463-48E0-B83F-7175787D09E2}" dt="2021-08-09T23:27:15.342" v="220" actId="1035"/>
          <ac:spMkLst>
            <pc:docMk/>
            <pc:sldMk cId="367579465" sldId="675"/>
            <ac:spMk id="28" creationId="{627423C8-B194-4935-85FA-5ED8C3D13EA3}"/>
          </ac:spMkLst>
        </pc:spChg>
        <pc:spChg chg="mod">
          <ac:chgData name="Hayk Barseghyan" userId="1af3c995-31f7-415e-9aa1-2b36900e994d" providerId="ADAL" clId="{3E3BB8FF-7463-48E0-B83F-7175787D09E2}" dt="2021-08-09T23:20:19.800" v="122" actId="1076"/>
          <ac:spMkLst>
            <pc:docMk/>
            <pc:sldMk cId="367579465" sldId="675"/>
            <ac:spMk id="30" creationId="{68ED1E75-B125-4C10-BB29-81E202553B2C}"/>
          </ac:spMkLst>
        </pc:spChg>
        <pc:spChg chg="mod">
          <ac:chgData name="Hayk Barseghyan" userId="1af3c995-31f7-415e-9aa1-2b36900e994d" providerId="ADAL" clId="{3E3BB8FF-7463-48E0-B83F-7175787D09E2}" dt="2021-08-09T23:20:28.781" v="123" actId="20577"/>
          <ac:spMkLst>
            <pc:docMk/>
            <pc:sldMk cId="367579465" sldId="675"/>
            <ac:spMk id="33" creationId="{27D04DB1-6D7F-4335-AAA1-99D44F3F14E9}"/>
          </ac:spMkLst>
        </pc:spChg>
        <pc:spChg chg="del">
          <ac:chgData name="Hayk Barseghyan" userId="1af3c995-31f7-415e-9aa1-2b36900e994d" providerId="ADAL" clId="{3E3BB8FF-7463-48E0-B83F-7175787D09E2}" dt="2021-08-09T23:19:06.749" v="108" actId="478"/>
          <ac:spMkLst>
            <pc:docMk/>
            <pc:sldMk cId="367579465" sldId="675"/>
            <ac:spMk id="34" creationId="{9E232FB5-9A42-4416-8E4E-5620B622F041}"/>
          </ac:spMkLst>
        </pc:spChg>
        <pc:spChg chg="del">
          <ac:chgData name="Hayk Barseghyan" userId="1af3c995-31f7-415e-9aa1-2b36900e994d" providerId="ADAL" clId="{3E3BB8FF-7463-48E0-B83F-7175787D09E2}" dt="2021-08-09T23:19:04.539" v="106" actId="478"/>
          <ac:spMkLst>
            <pc:docMk/>
            <pc:sldMk cId="367579465" sldId="675"/>
            <ac:spMk id="36" creationId="{D1390CDB-8C38-45E4-B737-627C1887B062}"/>
          </ac:spMkLst>
        </pc:spChg>
        <pc:spChg chg="del">
          <ac:chgData name="Hayk Barseghyan" userId="1af3c995-31f7-415e-9aa1-2b36900e994d" providerId="ADAL" clId="{3E3BB8FF-7463-48E0-B83F-7175787D09E2}" dt="2021-08-09T23:19:05.509" v="107" actId="478"/>
          <ac:spMkLst>
            <pc:docMk/>
            <pc:sldMk cId="367579465" sldId="675"/>
            <ac:spMk id="40" creationId="{EFE6C304-6608-4E19-9AF5-28280CCAEF69}"/>
          </ac:spMkLst>
        </pc:spChg>
        <pc:spChg chg="mod">
          <ac:chgData name="Hayk Barseghyan" userId="1af3c995-31f7-415e-9aa1-2b36900e994d" providerId="ADAL" clId="{3E3BB8FF-7463-48E0-B83F-7175787D09E2}" dt="2021-08-09T23:27:15.342" v="220" actId="1035"/>
          <ac:spMkLst>
            <pc:docMk/>
            <pc:sldMk cId="367579465" sldId="675"/>
            <ac:spMk id="44" creationId="{732812E5-D6B9-4FEF-975D-E2E3D93D0E47}"/>
          </ac:spMkLst>
        </pc:spChg>
        <pc:spChg chg="mod">
          <ac:chgData name="Hayk Barseghyan" userId="1af3c995-31f7-415e-9aa1-2b36900e994d" providerId="ADAL" clId="{3E3BB8FF-7463-48E0-B83F-7175787D09E2}" dt="2021-08-09T23:27:15.342" v="220" actId="1035"/>
          <ac:spMkLst>
            <pc:docMk/>
            <pc:sldMk cId="367579465" sldId="675"/>
            <ac:spMk id="45" creationId="{706B5154-0B8D-4A97-9481-9F43337FAC30}"/>
          </ac:spMkLst>
        </pc:spChg>
        <pc:spChg chg="mod">
          <ac:chgData name="Hayk Barseghyan" userId="1af3c995-31f7-415e-9aa1-2b36900e994d" providerId="ADAL" clId="{3E3BB8FF-7463-48E0-B83F-7175787D09E2}" dt="2021-08-09T23:20:48.110" v="128" actId="1076"/>
          <ac:spMkLst>
            <pc:docMk/>
            <pc:sldMk cId="367579465" sldId="675"/>
            <ac:spMk id="48" creationId="{7DECEAD3-1F4B-4349-B3E1-EC2281C752C7}"/>
          </ac:spMkLst>
        </pc:spChg>
        <pc:spChg chg="add mod">
          <ac:chgData name="Hayk Barseghyan" userId="1af3c995-31f7-415e-9aa1-2b36900e994d" providerId="ADAL" clId="{3E3BB8FF-7463-48E0-B83F-7175787D09E2}" dt="2021-08-09T23:27:04.311" v="214" actId="1037"/>
          <ac:spMkLst>
            <pc:docMk/>
            <pc:sldMk cId="367579465" sldId="675"/>
            <ac:spMk id="55" creationId="{C6BE4A34-B7D7-499E-83B7-11106E08C6DD}"/>
          </ac:spMkLst>
        </pc:spChg>
        <pc:spChg chg="add mod">
          <ac:chgData name="Hayk Barseghyan" userId="1af3c995-31f7-415e-9aa1-2b36900e994d" providerId="ADAL" clId="{3E3BB8FF-7463-48E0-B83F-7175787D09E2}" dt="2021-08-09T23:27:39.943" v="230" actId="20577"/>
          <ac:spMkLst>
            <pc:docMk/>
            <pc:sldMk cId="367579465" sldId="675"/>
            <ac:spMk id="58" creationId="{6078E741-6FB6-4560-8393-F2D74C732C4D}"/>
          </ac:spMkLst>
        </pc:spChg>
        <pc:spChg chg="add del mod">
          <ac:chgData name="Hayk Barseghyan" userId="1af3c995-31f7-415e-9aa1-2b36900e994d" providerId="ADAL" clId="{3E3BB8FF-7463-48E0-B83F-7175787D09E2}" dt="2021-08-09T23:30:35.101" v="272" actId="478"/>
          <ac:spMkLst>
            <pc:docMk/>
            <pc:sldMk cId="367579465" sldId="675"/>
            <ac:spMk id="59" creationId="{1BFA7512-1BC8-43EE-90B9-4F245F6F3E00}"/>
          </ac:spMkLst>
        </pc:spChg>
        <pc:spChg chg="add mod">
          <ac:chgData name="Hayk Barseghyan" userId="1af3c995-31f7-415e-9aa1-2b36900e994d" providerId="ADAL" clId="{3E3BB8FF-7463-48E0-B83F-7175787D09E2}" dt="2021-08-09T23:30:29.659" v="271" actId="255"/>
          <ac:spMkLst>
            <pc:docMk/>
            <pc:sldMk cId="367579465" sldId="675"/>
            <ac:spMk id="60" creationId="{D77A4C8D-C1FE-4A10-96B3-457C22F17E74}"/>
          </ac:spMkLst>
        </pc:spChg>
        <pc:spChg chg="add mod">
          <ac:chgData name="Hayk Barseghyan" userId="1af3c995-31f7-415e-9aa1-2b36900e994d" providerId="ADAL" clId="{3E3BB8FF-7463-48E0-B83F-7175787D09E2}" dt="2021-08-09T23:30:29.659" v="271" actId="255"/>
          <ac:spMkLst>
            <pc:docMk/>
            <pc:sldMk cId="367579465" sldId="675"/>
            <ac:spMk id="61" creationId="{EA1805BD-33BF-4C02-8CE7-A436EC3EFDBE}"/>
          </ac:spMkLst>
        </pc:spChg>
        <pc:spChg chg="add mod">
          <ac:chgData name="Hayk Barseghyan" userId="1af3c995-31f7-415e-9aa1-2b36900e994d" providerId="ADAL" clId="{3E3BB8FF-7463-48E0-B83F-7175787D09E2}" dt="2021-08-09T23:30:29.659" v="271" actId="255"/>
          <ac:spMkLst>
            <pc:docMk/>
            <pc:sldMk cId="367579465" sldId="675"/>
            <ac:spMk id="62" creationId="{B3E4F9CD-90D5-46B0-92E4-E92A2F878159}"/>
          </ac:spMkLst>
        </pc:spChg>
        <pc:spChg chg="add mod">
          <ac:chgData name="Hayk Barseghyan" userId="1af3c995-31f7-415e-9aa1-2b36900e994d" providerId="ADAL" clId="{3E3BB8FF-7463-48E0-B83F-7175787D09E2}" dt="2021-08-09T23:30:29.659" v="271" actId="255"/>
          <ac:spMkLst>
            <pc:docMk/>
            <pc:sldMk cId="367579465" sldId="675"/>
            <ac:spMk id="63" creationId="{28F67F68-8291-4DDC-AAA9-3B9AA20CEE6B}"/>
          </ac:spMkLst>
        </pc:spChg>
        <pc:spChg chg="mod">
          <ac:chgData name="Hayk Barseghyan" userId="1af3c995-31f7-415e-9aa1-2b36900e994d" providerId="ADAL" clId="{3E3BB8FF-7463-48E0-B83F-7175787D09E2}" dt="2021-08-09T23:27:15.342" v="220" actId="1035"/>
          <ac:spMkLst>
            <pc:docMk/>
            <pc:sldMk cId="367579465" sldId="675"/>
            <ac:spMk id="88" creationId="{7309DE7D-82B3-4F46-B078-58EBF40D4703}"/>
          </ac:spMkLst>
        </pc:spChg>
        <pc:spChg chg="mod">
          <ac:chgData name="Hayk Barseghyan" userId="1af3c995-31f7-415e-9aa1-2b36900e994d" providerId="ADAL" clId="{3E3BB8FF-7463-48E0-B83F-7175787D09E2}" dt="2021-08-09T23:20:10.163" v="120" actId="1076"/>
          <ac:spMkLst>
            <pc:docMk/>
            <pc:sldMk cId="367579465" sldId="675"/>
            <ac:spMk id="91" creationId="{13B1F2AA-C6E8-4BA8-9C3E-AADD95A31E93}"/>
          </ac:spMkLst>
        </pc:spChg>
        <pc:spChg chg="mod">
          <ac:chgData name="Hayk Barseghyan" userId="1af3c995-31f7-415e-9aa1-2b36900e994d" providerId="ADAL" clId="{3E3BB8FF-7463-48E0-B83F-7175787D09E2}" dt="2021-08-09T23:20:14.338" v="121" actId="1076"/>
          <ac:spMkLst>
            <pc:docMk/>
            <pc:sldMk cId="367579465" sldId="675"/>
            <ac:spMk id="92" creationId="{C38076EE-D1EB-4356-9361-84DA46C2351B}"/>
          </ac:spMkLst>
        </pc:spChg>
        <pc:spChg chg="mod">
          <ac:chgData name="Hayk Barseghyan" userId="1af3c995-31f7-415e-9aa1-2b36900e994d" providerId="ADAL" clId="{3E3BB8FF-7463-48E0-B83F-7175787D09E2}" dt="2021-08-09T23:28:59.951" v="241" actId="1076"/>
          <ac:spMkLst>
            <pc:docMk/>
            <pc:sldMk cId="367579465" sldId="675"/>
            <ac:spMk id="93" creationId="{3EAC0E29-A0FD-42DD-8F3E-7B6BDF36A320}"/>
          </ac:spMkLst>
        </pc:spChg>
        <pc:spChg chg="mod">
          <ac:chgData name="Hayk Barseghyan" userId="1af3c995-31f7-415e-9aa1-2b36900e994d" providerId="ADAL" clId="{3E3BB8FF-7463-48E0-B83F-7175787D09E2}" dt="2021-08-09T23:27:15.342" v="220" actId="1035"/>
          <ac:spMkLst>
            <pc:docMk/>
            <pc:sldMk cId="367579465" sldId="675"/>
            <ac:spMk id="94" creationId="{C3B2E742-FF55-4D80-8A82-03F353C11C9E}"/>
          </ac:spMkLst>
        </pc:spChg>
        <pc:spChg chg="del">
          <ac:chgData name="Hayk Barseghyan" userId="1af3c995-31f7-415e-9aa1-2b36900e994d" providerId="ADAL" clId="{3E3BB8FF-7463-48E0-B83F-7175787D09E2}" dt="2021-08-09T23:19:12.013" v="110" actId="478"/>
          <ac:spMkLst>
            <pc:docMk/>
            <pc:sldMk cId="367579465" sldId="675"/>
            <ac:spMk id="98" creationId="{CC1A3F83-E94B-4F3C-9D62-2C0B7D404690}"/>
          </ac:spMkLst>
        </pc:spChg>
        <pc:picChg chg="add mod ord">
          <ac:chgData name="Hayk Barseghyan" userId="1af3c995-31f7-415e-9aa1-2b36900e994d" providerId="ADAL" clId="{3E3BB8FF-7463-48E0-B83F-7175787D09E2}" dt="2021-08-09T23:19:59.418" v="119" actId="1076"/>
          <ac:picMkLst>
            <pc:docMk/>
            <pc:sldMk cId="367579465" sldId="675"/>
            <ac:picMk id="3" creationId="{89416CF9-2961-43A8-BE38-EB46493DB566}"/>
          </ac:picMkLst>
        </pc:picChg>
        <pc:picChg chg="del">
          <ac:chgData name="Hayk Barseghyan" userId="1af3c995-31f7-415e-9aa1-2b36900e994d" providerId="ADAL" clId="{3E3BB8FF-7463-48E0-B83F-7175787D09E2}" dt="2021-08-09T23:19:10.653" v="109" actId="478"/>
          <ac:picMkLst>
            <pc:docMk/>
            <pc:sldMk cId="367579465" sldId="675"/>
            <ac:picMk id="4" creationId="{6EE723D7-82C2-40C7-9EDF-695ABCFD2852}"/>
          </ac:picMkLst>
        </pc:picChg>
        <pc:picChg chg="del">
          <ac:chgData name="Hayk Barseghyan" userId="1af3c995-31f7-415e-9aa1-2b36900e994d" providerId="ADAL" clId="{3E3BB8FF-7463-48E0-B83F-7175787D09E2}" dt="2021-08-09T23:18:57.185" v="104" actId="478"/>
          <ac:picMkLst>
            <pc:docMk/>
            <pc:sldMk cId="367579465" sldId="675"/>
            <ac:picMk id="14" creationId="{BD596D5A-A8B5-4F23-971B-B0033B030440}"/>
          </ac:picMkLst>
        </pc:picChg>
        <pc:picChg chg="add mod ord">
          <ac:chgData name="Hayk Barseghyan" userId="1af3c995-31f7-415e-9aa1-2b36900e994d" providerId="ADAL" clId="{3E3BB8FF-7463-48E0-B83F-7175787D09E2}" dt="2021-08-09T23:28:57.010" v="240" actId="14100"/>
          <ac:picMkLst>
            <pc:docMk/>
            <pc:sldMk cId="367579465" sldId="675"/>
            <ac:picMk id="32" creationId="{A87BA2ED-21CF-433D-A82D-F0066DDED12B}"/>
          </ac:picMkLst>
        </pc:picChg>
        <pc:picChg chg="del">
          <ac:chgData name="Hayk Barseghyan" userId="1af3c995-31f7-415e-9aa1-2b36900e994d" providerId="ADAL" clId="{3E3BB8FF-7463-48E0-B83F-7175787D09E2}" dt="2021-08-09T23:21:16.663" v="136" actId="478"/>
          <ac:picMkLst>
            <pc:docMk/>
            <pc:sldMk cId="367579465" sldId="675"/>
            <ac:picMk id="35" creationId="{347E1D22-E15C-425D-925B-99F60A60B955}"/>
          </ac:picMkLst>
        </pc:picChg>
        <pc:picChg chg="add mod">
          <ac:chgData name="Hayk Barseghyan" userId="1af3c995-31f7-415e-9aa1-2b36900e994d" providerId="ADAL" clId="{3E3BB8FF-7463-48E0-B83F-7175787D09E2}" dt="2021-08-09T23:28:52.880" v="239" actId="14100"/>
          <ac:picMkLst>
            <pc:docMk/>
            <pc:sldMk cId="367579465" sldId="675"/>
            <ac:picMk id="42" creationId="{81257E0E-7E90-4137-8531-102945D85D66}"/>
          </ac:picMkLst>
        </pc:picChg>
        <pc:cxnChg chg="del mod">
          <ac:chgData name="Hayk Barseghyan" userId="1af3c995-31f7-415e-9aa1-2b36900e994d" providerId="ADAL" clId="{3E3BB8FF-7463-48E0-B83F-7175787D09E2}" dt="2021-08-09T23:18:57.185" v="104" actId="478"/>
          <ac:cxnSpMkLst>
            <pc:docMk/>
            <pc:sldMk cId="367579465" sldId="675"/>
            <ac:cxnSpMk id="23" creationId="{B97A16ED-5542-4DD1-94CA-D032D3F72196}"/>
          </ac:cxnSpMkLst>
        </pc:cxnChg>
        <pc:cxnChg chg="del mod">
          <ac:chgData name="Hayk Barseghyan" userId="1af3c995-31f7-415e-9aa1-2b36900e994d" providerId="ADAL" clId="{3E3BB8FF-7463-48E0-B83F-7175787D09E2}" dt="2021-08-09T23:18:57.185" v="104" actId="478"/>
          <ac:cxnSpMkLst>
            <pc:docMk/>
            <pc:sldMk cId="367579465" sldId="675"/>
            <ac:cxnSpMk id="24" creationId="{792D8F66-E748-410F-BB9B-B632B254BDFB}"/>
          </ac:cxnSpMkLst>
        </pc:cxnChg>
        <pc:cxnChg chg="del mod">
          <ac:chgData name="Hayk Barseghyan" userId="1af3c995-31f7-415e-9aa1-2b36900e994d" providerId="ADAL" clId="{3E3BB8FF-7463-48E0-B83F-7175787D09E2}" dt="2021-08-09T23:18:57.185" v="104" actId="478"/>
          <ac:cxnSpMkLst>
            <pc:docMk/>
            <pc:sldMk cId="367579465" sldId="675"/>
            <ac:cxnSpMk id="25" creationId="{A4F48631-3605-414B-96A3-B4E7701F3903}"/>
          </ac:cxnSpMkLst>
        </pc:cxnChg>
        <pc:cxnChg chg="mod">
          <ac:chgData name="Hayk Barseghyan" userId="1af3c995-31f7-415e-9aa1-2b36900e994d" providerId="ADAL" clId="{3E3BB8FF-7463-48E0-B83F-7175787D09E2}" dt="2021-08-09T23:27:04.311" v="214" actId="1037"/>
          <ac:cxnSpMkLst>
            <pc:docMk/>
            <pc:sldMk cId="367579465" sldId="675"/>
            <ac:cxnSpMk id="49" creationId="{4423681D-AADF-4D62-AC9E-3FDDF18E21B9}"/>
          </ac:cxnSpMkLst>
        </pc:cxnChg>
        <pc:cxnChg chg="mod">
          <ac:chgData name="Hayk Barseghyan" userId="1af3c995-31f7-415e-9aa1-2b36900e994d" providerId="ADAL" clId="{3E3BB8FF-7463-48E0-B83F-7175787D09E2}" dt="2021-08-09T23:27:15.342" v="220" actId="1035"/>
          <ac:cxnSpMkLst>
            <pc:docMk/>
            <pc:sldMk cId="367579465" sldId="675"/>
            <ac:cxnSpMk id="52" creationId="{67E81840-D31A-48DD-9275-CD08F7D6F031}"/>
          </ac:cxnSpMkLst>
        </pc:cxnChg>
        <pc:cxnChg chg="mod">
          <ac:chgData name="Hayk Barseghyan" userId="1af3c995-31f7-415e-9aa1-2b36900e994d" providerId="ADAL" clId="{3E3BB8FF-7463-48E0-B83F-7175787D09E2}" dt="2021-08-09T23:27:15.342" v="220" actId="1035"/>
          <ac:cxnSpMkLst>
            <pc:docMk/>
            <pc:sldMk cId="367579465" sldId="675"/>
            <ac:cxnSpMk id="95" creationId="{5EB10151-CF0F-4162-A03A-2FB4661DCBE8}"/>
          </ac:cxnSpMkLst>
        </pc:cxnChg>
      </pc:sldChg>
      <pc:sldChg chg="addSp delSp modSp add mod modNotesTx">
        <pc:chgData name="Hayk Barseghyan" userId="1af3c995-31f7-415e-9aa1-2b36900e994d" providerId="ADAL" clId="{3E3BB8FF-7463-48E0-B83F-7175787D09E2}" dt="2021-08-23T23:15:40.723" v="474"/>
        <pc:sldMkLst>
          <pc:docMk/>
          <pc:sldMk cId="2438198957" sldId="676"/>
        </pc:sldMkLst>
        <pc:spChg chg="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28" creationId="{627423C8-B194-4935-85FA-5ED8C3D13EA3}"/>
          </ac:spMkLst>
        </pc:spChg>
        <pc:spChg chg="add 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31" creationId="{E963D761-4F43-4E59-9052-2DA434FFDFA9}"/>
          </ac:spMkLst>
        </pc:spChg>
        <pc:spChg chg="add 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32" creationId="{F438C304-83B8-45CD-A109-05E6C21D2CB4}"/>
          </ac:spMkLst>
        </pc:spChg>
        <pc:spChg chg="mod">
          <ac:chgData name="Hayk Barseghyan" userId="1af3c995-31f7-415e-9aa1-2b36900e994d" providerId="ADAL" clId="{3E3BB8FF-7463-48E0-B83F-7175787D09E2}" dt="2021-08-09T23:38:28.554" v="317" actId="20577"/>
          <ac:spMkLst>
            <pc:docMk/>
            <pc:sldMk cId="2438198957" sldId="676"/>
            <ac:spMk id="33" creationId="{27D04DB1-6D7F-4335-AAA1-99D44F3F14E9}"/>
          </ac:spMkLst>
        </pc:spChg>
        <pc:spChg chg="add 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34" creationId="{64EFE294-4029-440F-BC4D-C634019521E7}"/>
          </ac:spMkLst>
        </pc:spChg>
        <pc:spChg chg="add 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35" creationId="{833F1CEA-23E9-4F34-B4B1-26A1C9467F1D}"/>
          </ac:spMkLst>
        </pc:spChg>
        <pc:spChg chg="add 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36" creationId="{CAE60184-4C09-4691-97B9-5DDCCFE48AE5}"/>
          </ac:spMkLst>
        </pc:spChg>
        <pc:spChg chg="add 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38" creationId="{FCA4F469-CCEE-40FD-8FAA-C87C4CBFAAB4}"/>
          </ac:spMkLst>
        </pc:spChg>
        <pc:spChg chg="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44" creationId="{732812E5-D6B9-4FEF-975D-E2E3D93D0E47}"/>
          </ac:spMkLst>
        </pc:spChg>
        <pc:spChg chg="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45" creationId="{706B5154-0B8D-4A97-9481-9F43337FAC30}"/>
          </ac:spMkLst>
        </pc:spChg>
        <pc:spChg chg="add mod">
          <ac:chgData name="Hayk Barseghyan" userId="1af3c995-31f7-415e-9aa1-2b36900e994d" providerId="ADAL" clId="{3E3BB8FF-7463-48E0-B83F-7175787D09E2}" dt="2021-08-23T23:06:13.627" v="447" actId="14100"/>
          <ac:spMkLst>
            <pc:docMk/>
            <pc:sldMk cId="2438198957" sldId="676"/>
            <ac:spMk id="46" creationId="{5933B143-BE76-4414-A533-7CE5ECC1745B}"/>
          </ac:spMkLst>
        </pc:spChg>
        <pc:spChg chg="mod">
          <ac:chgData name="Hayk Barseghyan" userId="1af3c995-31f7-415e-9aa1-2b36900e994d" providerId="ADAL" clId="{3E3BB8FF-7463-48E0-B83F-7175787D09E2}" dt="2021-08-09T23:36:58.304" v="305" actId="1037"/>
          <ac:spMkLst>
            <pc:docMk/>
            <pc:sldMk cId="2438198957" sldId="676"/>
            <ac:spMk id="48" creationId="{7DECEAD3-1F4B-4349-B3E1-EC2281C752C7}"/>
          </ac:spMkLst>
        </pc:spChg>
        <pc:spChg chg="add mod">
          <ac:chgData name="Hayk Barseghyan" userId="1af3c995-31f7-415e-9aa1-2b36900e994d" providerId="ADAL" clId="{3E3BB8FF-7463-48E0-B83F-7175787D09E2}" dt="2021-08-23T23:06:49.760" v="456" actId="14100"/>
          <ac:spMkLst>
            <pc:docMk/>
            <pc:sldMk cId="2438198957" sldId="676"/>
            <ac:spMk id="50" creationId="{18C599E3-4032-4F4A-8F81-442EBF276543}"/>
          </ac:spMkLst>
        </pc:spChg>
        <pc:spChg chg="del">
          <ac:chgData name="Hayk Barseghyan" userId="1af3c995-31f7-415e-9aa1-2b36900e994d" providerId="ADAL" clId="{3E3BB8FF-7463-48E0-B83F-7175787D09E2}" dt="2021-08-23T22:55:17.338" v="343" actId="478"/>
          <ac:spMkLst>
            <pc:docMk/>
            <pc:sldMk cId="2438198957" sldId="676"/>
            <ac:spMk id="55" creationId="{C6BE4A34-B7D7-499E-83B7-11106E08C6DD}"/>
          </ac:spMkLst>
        </pc:spChg>
        <pc:spChg chg="add mod">
          <ac:chgData name="Hayk Barseghyan" userId="1af3c995-31f7-415e-9aa1-2b36900e994d" providerId="ADAL" clId="{3E3BB8FF-7463-48E0-B83F-7175787D09E2}" dt="2021-08-23T23:07:56.432" v="467" actId="14100"/>
          <ac:spMkLst>
            <pc:docMk/>
            <pc:sldMk cId="2438198957" sldId="676"/>
            <ac:spMk id="57" creationId="{E83FEB94-1BE5-4382-B4A0-9B591263E5DF}"/>
          </ac:spMkLst>
        </pc:spChg>
        <pc:spChg chg="del">
          <ac:chgData name="Hayk Barseghyan" userId="1af3c995-31f7-415e-9aa1-2b36900e994d" providerId="ADAL" clId="{3E3BB8FF-7463-48E0-B83F-7175787D09E2}" dt="2021-08-23T22:55:49.500" v="348" actId="478"/>
          <ac:spMkLst>
            <pc:docMk/>
            <pc:sldMk cId="2438198957" sldId="676"/>
            <ac:spMk id="58" creationId="{6078E741-6FB6-4560-8393-F2D74C732C4D}"/>
          </ac:spMkLst>
        </pc:spChg>
        <pc:spChg chg="add mod">
          <ac:chgData name="Hayk Barseghyan" userId="1af3c995-31f7-415e-9aa1-2b36900e994d" providerId="ADAL" clId="{3E3BB8FF-7463-48E0-B83F-7175787D09E2}" dt="2021-08-23T23:08:11.186" v="471" actId="14100"/>
          <ac:spMkLst>
            <pc:docMk/>
            <pc:sldMk cId="2438198957" sldId="676"/>
            <ac:spMk id="59" creationId="{31CE57E1-DCBF-4B61-B759-996C1E2A7749}"/>
          </ac:spMkLst>
        </pc:spChg>
        <pc:spChg chg="del mod">
          <ac:chgData name="Hayk Barseghyan" userId="1af3c995-31f7-415e-9aa1-2b36900e994d" providerId="ADAL" clId="{3E3BB8FF-7463-48E0-B83F-7175787D09E2}" dt="2021-08-23T22:55:43.023" v="346" actId="478"/>
          <ac:spMkLst>
            <pc:docMk/>
            <pc:sldMk cId="2438198957" sldId="676"/>
            <ac:spMk id="60" creationId="{D77A4C8D-C1FE-4A10-96B3-457C22F17E74}"/>
          </ac:spMkLst>
        </pc:spChg>
        <pc:spChg chg="del mod">
          <ac:chgData name="Hayk Barseghyan" userId="1af3c995-31f7-415e-9aa1-2b36900e994d" providerId="ADAL" clId="{3E3BB8FF-7463-48E0-B83F-7175787D09E2}" dt="2021-08-23T22:55:43.023" v="346" actId="478"/>
          <ac:spMkLst>
            <pc:docMk/>
            <pc:sldMk cId="2438198957" sldId="676"/>
            <ac:spMk id="61" creationId="{EA1805BD-33BF-4C02-8CE7-A436EC3EFDBE}"/>
          </ac:spMkLst>
        </pc:spChg>
        <pc:spChg chg="del">
          <ac:chgData name="Hayk Barseghyan" userId="1af3c995-31f7-415e-9aa1-2b36900e994d" providerId="ADAL" clId="{3E3BB8FF-7463-48E0-B83F-7175787D09E2}" dt="2021-08-23T22:55:43.023" v="346" actId="478"/>
          <ac:spMkLst>
            <pc:docMk/>
            <pc:sldMk cId="2438198957" sldId="676"/>
            <ac:spMk id="62" creationId="{B3E4F9CD-90D5-46B0-92E4-E92A2F878159}"/>
          </ac:spMkLst>
        </pc:spChg>
        <pc:spChg chg="del mod">
          <ac:chgData name="Hayk Barseghyan" userId="1af3c995-31f7-415e-9aa1-2b36900e994d" providerId="ADAL" clId="{3E3BB8FF-7463-48E0-B83F-7175787D09E2}" dt="2021-08-23T22:55:43.023" v="346" actId="478"/>
          <ac:spMkLst>
            <pc:docMk/>
            <pc:sldMk cId="2438198957" sldId="676"/>
            <ac:spMk id="63" creationId="{28F67F68-8291-4DDC-AAA9-3B9AA20CEE6B}"/>
          </ac:spMkLst>
        </pc:spChg>
        <pc:spChg chg="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88" creationId="{7309DE7D-82B3-4F46-B078-58EBF40D4703}"/>
          </ac:spMkLst>
        </pc:spChg>
        <pc:spChg chg="mod">
          <ac:chgData name="Hayk Barseghyan" userId="1af3c995-31f7-415e-9aa1-2b36900e994d" providerId="ADAL" clId="{3E3BB8FF-7463-48E0-B83F-7175787D09E2}" dt="2021-08-09T23:36:34.696" v="297" actId="1076"/>
          <ac:spMkLst>
            <pc:docMk/>
            <pc:sldMk cId="2438198957" sldId="676"/>
            <ac:spMk id="91" creationId="{13B1F2AA-C6E8-4BA8-9C3E-AADD95A31E93}"/>
          </ac:spMkLst>
        </pc:spChg>
        <pc:spChg chg="mod">
          <ac:chgData name="Hayk Barseghyan" userId="1af3c995-31f7-415e-9aa1-2b36900e994d" providerId="ADAL" clId="{3E3BB8FF-7463-48E0-B83F-7175787D09E2}" dt="2021-08-09T23:36:38.097" v="298" actId="1076"/>
          <ac:spMkLst>
            <pc:docMk/>
            <pc:sldMk cId="2438198957" sldId="676"/>
            <ac:spMk id="92" creationId="{C38076EE-D1EB-4356-9361-84DA46C2351B}"/>
          </ac:spMkLst>
        </pc:spChg>
        <pc:spChg chg="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93" creationId="{3EAC0E29-A0FD-42DD-8F3E-7B6BDF36A320}"/>
          </ac:spMkLst>
        </pc:spChg>
        <pc:spChg chg="mod">
          <ac:chgData name="Hayk Barseghyan" userId="1af3c995-31f7-415e-9aa1-2b36900e994d" providerId="ADAL" clId="{3E3BB8FF-7463-48E0-B83F-7175787D09E2}" dt="2021-08-23T23:00:36.640" v="401" actId="1035"/>
          <ac:spMkLst>
            <pc:docMk/>
            <pc:sldMk cId="2438198957" sldId="676"/>
            <ac:spMk id="94" creationId="{C3B2E742-FF55-4D80-8A82-03F353C11C9E}"/>
          </ac:spMkLst>
        </pc:spChg>
        <pc:picChg chg="del">
          <ac:chgData name="Hayk Barseghyan" userId="1af3c995-31f7-415e-9aa1-2b36900e994d" providerId="ADAL" clId="{3E3BB8FF-7463-48E0-B83F-7175787D09E2}" dt="2021-08-09T23:35:47.367" v="284" actId="478"/>
          <ac:picMkLst>
            <pc:docMk/>
            <pc:sldMk cId="2438198957" sldId="676"/>
            <ac:picMk id="3" creationId="{89416CF9-2961-43A8-BE38-EB46493DB566}"/>
          </ac:picMkLst>
        </pc:picChg>
        <pc:picChg chg="add del mod">
          <ac:chgData name="Hayk Barseghyan" userId="1af3c995-31f7-415e-9aa1-2b36900e994d" providerId="ADAL" clId="{3E3BB8FF-7463-48E0-B83F-7175787D09E2}" dt="2021-08-23T22:59:18.393" v="359" actId="478"/>
          <ac:picMkLst>
            <pc:docMk/>
            <pc:sldMk cId="2438198957" sldId="676"/>
            <ac:picMk id="3" creationId="{FFDB5AE2-6B21-4E6A-B919-1E9DEA011DAF}"/>
          </ac:picMkLst>
        </pc:picChg>
        <pc:picChg chg="add del mod">
          <ac:chgData name="Hayk Barseghyan" userId="1af3c995-31f7-415e-9aa1-2b36900e994d" providerId="ADAL" clId="{3E3BB8FF-7463-48E0-B83F-7175787D09E2}" dt="2021-08-23T22:53:54.544" v="330" actId="478"/>
          <ac:picMkLst>
            <pc:docMk/>
            <pc:sldMk cId="2438198957" sldId="676"/>
            <ac:picMk id="4" creationId="{5E4248DE-A4C9-4664-A2C8-6E30601EC5C7}"/>
          </ac:picMkLst>
        </pc:picChg>
        <pc:picChg chg="add mod ord">
          <ac:chgData name="Hayk Barseghyan" userId="1af3c995-31f7-415e-9aa1-2b36900e994d" providerId="ADAL" clId="{3E3BB8FF-7463-48E0-B83F-7175787D09E2}" dt="2021-08-23T23:00:42.455" v="404" actId="1076"/>
          <ac:picMkLst>
            <pc:docMk/>
            <pc:sldMk cId="2438198957" sldId="676"/>
            <ac:picMk id="6" creationId="{6595B8DF-6171-4E00-B565-B3909597F7D5}"/>
          </ac:picMkLst>
        </pc:picChg>
        <pc:picChg chg="add del mod">
          <ac:chgData name="Hayk Barseghyan" userId="1af3c995-31f7-415e-9aa1-2b36900e994d" providerId="ADAL" clId="{3E3BB8FF-7463-48E0-B83F-7175787D09E2}" dt="2021-08-23T23:04:52.120" v="420" actId="21"/>
          <ac:picMkLst>
            <pc:docMk/>
            <pc:sldMk cId="2438198957" sldId="676"/>
            <ac:picMk id="10" creationId="{6B2AFA2D-BF0C-4432-8496-22FBE5892F2B}"/>
          </ac:picMkLst>
        </pc:picChg>
        <pc:picChg chg="add mod">
          <ac:chgData name="Hayk Barseghyan" userId="1af3c995-31f7-415e-9aa1-2b36900e994d" providerId="ADAL" clId="{3E3BB8FF-7463-48E0-B83F-7175787D09E2}" dt="2021-08-23T23:07:21.665" v="461" actId="1076"/>
          <ac:picMkLst>
            <pc:docMk/>
            <pc:sldMk cId="2438198957" sldId="676"/>
            <ac:picMk id="14" creationId="{DA62DBE8-4663-4B36-9CB2-D04CCB667CD9}"/>
          </ac:picMkLst>
        </pc:picChg>
        <pc:picChg chg="add mod ord">
          <ac:chgData name="Hayk Barseghyan" userId="1af3c995-31f7-415e-9aa1-2b36900e994d" providerId="ADAL" clId="{3E3BB8FF-7463-48E0-B83F-7175787D09E2}" dt="2021-08-23T23:00:36.640" v="401" actId="1035"/>
          <ac:picMkLst>
            <pc:docMk/>
            <pc:sldMk cId="2438198957" sldId="676"/>
            <ac:picMk id="16" creationId="{BD5DD64E-13E5-4AD9-8038-145E39A0E38E}"/>
          </ac:picMkLst>
        </pc:picChg>
        <pc:picChg chg="del">
          <ac:chgData name="Hayk Barseghyan" userId="1af3c995-31f7-415e-9aa1-2b36900e994d" providerId="ADAL" clId="{3E3BB8FF-7463-48E0-B83F-7175787D09E2}" dt="2021-08-09T23:37:07.409" v="306" actId="478"/>
          <ac:picMkLst>
            <pc:docMk/>
            <pc:sldMk cId="2438198957" sldId="676"/>
            <ac:picMk id="32" creationId="{A87BA2ED-21CF-433D-A82D-F0066DDED12B}"/>
          </ac:picMkLst>
        </pc:picChg>
        <pc:picChg chg="add mod">
          <ac:chgData name="Hayk Barseghyan" userId="1af3c995-31f7-415e-9aa1-2b36900e994d" providerId="ADAL" clId="{3E3BB8FF-7463-48E0-B83F-7175787D09E2}" dt="2021-08-23T23:00:36.640" v="401" actId="1035"/>
          <ac:picMkLst>
            <pc:docMk/>
            <pc:sldMk cId="2438198957" sldId="676"/>
            <ac:picMk id="37" creationId="{60D00180-6AAE-439B-9C8E-4781C2632715}"/>
          </ac:picMkLst>
        </pc:picChg>
        <pc:picChg chg="del">
          <ac:chgData name="Hayk Barseghyan" userId="1af3c995-31f7-415e-9aa1-2b36900e994d" providerId="ADAL" clId="{3E3BB8FF-7463-48E0-B83F-7175787D09E2}" dt="2021-08-09T23:35:06.935" v="274" actId="478"/>
          <ac:picMkLst>
            <pc:docMk/>
            <pc:sldMk cId="2438198957" sldId="676"/>
            <ac:picMk id="42" creationId="{81257E0E-7E90-4137-8531-102945D85D66}"/>
          </ac:picMkLst>
        </pc:picChg>
        <pc:picChg chg="add mod">
          <ac:chgData name="Hayk Barseghyan" userId="1af3c995-31f7-415e-9aa1-2b36900e994d" providerId="ADAL" clId="{3E3BB8FF-7463-48E0-B83F-7175787D09E2}" dt="2021-08-23T23:07:15.882" v="458" actId="14100"/>
          <ac:picMkLst>
            <pc:docMk/>
            <pc:sldMk cId="2438198957" sldId="676"/>
            <ac:picMk id="43" creationId="{293CC650-5941-4822-B2FB-022715A61654}"/>
          </ac:picMkLst>
        </pc:picChg>
        <pc:cxnChg chg="add mod">
          <ac:chgData name="Hayk Barseghyan" userId="1af3c995-31f7-415e-9aa1-2b36900e994d" providerId="ADAL" clId="{3E3BB8FF-7463-48E0-B83F-7175787D09E2}" dt="2021-08-23T23:07:15.882" v="458" actId="14100"/>
          <ac:cxnSpMkLst>
            <pc:docMk/>
            <pc:sldMk cId="2438198957" sldId="676"/>
            <ac:cxnSpMk id="47" creationId="{C76B2C81-59FB-4F72-AFFE-88348080CBF3}"/>
          </ac:cxnSpMkLst>
        </pc:cxnChg>
        <pc:cxnChg chg="mod">
          <ac:chgData name="Hayk Barseghyan" userId="1af3c995-31f7-415e-9aa1-2b36900e994d" providerId="ADAL" clId="{3E3BB8FF-7463-48E0-B83F-7175787D09E2}" dt="2021-08-23T23:00:47.198" v="406" actId="14100"/>
          <ac:cxnSpMkLst>
            <pc:docMk/>
            <pc:sldMk cId="2438198957" sldId="676"/>
            <ac:cxnSpMk id="49" creationId="{4423681D-AADF-4D62-AC9E-3FDDF18E21B9}"/>
          </ac:cxnSpMkLst>
        </pc:cxnChg>
        <pc:cxnChg chg="add mod">
          <ac:chgData name="Hayk Barseghyan" userId="1af3c995-31f7-415e-9aa1-2b36900e994d" providerId="ADAL" clId="{3E3BB8FF-7463-48E0-B83F-7175787D09E2}" dt="2021-08-23T23:07:21.665" v="461" actId="1076"/>
          <ac:cxnSpMkLst>
            <pc:docMk/>
            <pc:sldMk cId="2438198957" sldId="676"/>
            <ac:cxnSpMk id="51" creationId="{532A5246-3D8F-4113-9A9C-DD7DEDE46C07}"/>
          </ac:cxnSpMkLst>
        </pc:cxnChg>
        <pc:cxnChg chg="mod">
          <ac:chgData name="Hayk Barseghyan" userId="1af3c995-31f7-415e-9aa1-2b36900e994d" providerId="ADAL" clId="{3E3BB8FF-7463-48E0-B83F-7175787D09E2}" dt="2021-08-23T23:00:36.640" v="401" actId="1035"/>
          <ac:cxnSpMkLst>
            <pc:docMk/>
            <pc:sldMk cId="2438198957" sldId="676"/>
            <ac:cxnSpMk id="52" creationId="{67E81840-D31A-48DD-9275-CD08F7D6F031}"/>
          </ac:cxnSpMkLst>
        </pc:cxnChg>
        <pc:cxnChg chg="mod">
          <ac:chgData name="Hayk Barseghyan" userId="1af3c995-31f7-415e-9aa1-2b36900e994d" providerId="ADAL" clId="{3E3BB8FF-7463-48E0-B83F-7175787D09E2}" dt="2021-08-23T23:00:36.640" v="401" actId="1035"/>
          <ac:cxnSpMkLst>
            <pc:docMk/>
            <pc:sldMk cId="2438198957" sldId="676"/>
            <ac:cxnSpMk id="95" creationId="{5EB10151-CF0F-4162-A03A-2FB4661DCBE8}"/>
          </ac:cxnSpMkLst>
        </pc:cxnChg>
      </pc:sldChg>
      <pc:sldChg chg="modSp add del mod">
        <pc:chgData name="Hayk Barseghyan" userId="1af3c995-31f7-415e-9aa1-2b36900e994d" providerId="ADAL" clId="{3E3BB8FF-7463-48E0-B83F-7175787D09E2}" dt="2021-08-23T23:08:18.949" v="472" actId="47"/>
        <pc:sldMkLst>
          <pc:docMk/>
          <pc:sldMk cId="3996362990" sldId="677"/>
        </pc:sldMkLst>
        <pc:spChg chg="mod">
          <ac:chgData name="Hayk Barseghyan" userId="1af3c995-31f7-415e-9aa1-2b36900e994d" providerId="ADAL" clId="{3E3BB8FF-7463-48E0-B83F-7175787D09E2}" dt="2021-08-23T23:00:13.378" v="373" actId="20577"/>
          <ac:spMkLst>
            <pc:docMk/>
            <pc:sldMk cId="3996362990" sldId="677"/>
            <ac:spMk id="61" creationId="{EA1805BD-33BF-4C02-8CE7-A436EC3EFDBE}"/>
          </ac:spMkLst>
        </pc:spChg>
      </pc:sldChg>
    </pc:docChg>
  </pc:docChgLst>
  <pc:docChgLst>
    <pc:chgData name="Hayk Barseghyan" userId="1af3c995-31f7-415e-9aa1-2b36900e994d" providerId="ADAL" clId="{DE1D74AE-8A77-49E7-9855-88161E349991}"/>
    <pc:docChg chg="addSld modSld">
      <pc:chgData name="Hayk Barseghyan" userId="1af3c995-31f7-415e-9aa1-2b36900e994d" providerId="ADAL" clId="{DE1D74AE-8A77-49E7-9855-88161E349991}" dt="2021-03-26T17:51:01.546" v="0"/>
      <pc:docMkLst>
        <pc:docMk/>
      </pc:docMkLst>
      <pc:sldChg chg="add">
        <pc:chgData name="Hayk Barseghyan" userId="1af3c995-31f7-415e-9aa1-2b36900e994d" providerId="ADAL" clId="{DE1D74AE-8A77-49E7-9855-88161E349991}" dt="2021-03-26T17:51:01.546" v="0"/>
        <pc:sldMkLst>
          <pc:docMk/>
          <pc:sldMk cId="2324644523" sldId="667"/>
        </pc:sldMkLst>
      </pc:sldChg>
    </pc:docChg>
  </pc:docChgLst>
  <pc:docChgLst>
    <pc:chgData name="Hayk Barseghyan" userId="1af3c995-31f7-415e-9aa1-2b36900e994d" providerId="ADAL" clId="{2F91834A-475B-4F34-A1E3-28AB80E687F7}"/>
    <pc:docChg chg="undo custSel addSld delSld modSld sldOrd">
      <pc:chgData name="Hayk Barseghyan" userId="1af3c995-31f7-415e-9aa1-2b36900e994d" providerId="ADAL" clId="{2F91834A-475B-4F34-A1E3-28AB80E687F7}" dt="2021-04-02T21:46:58.656" v="1770" actId="20577"/>
      <pc:docMkLst>
        <pc:docMk/>
      </pc:docMkLst>
      <pc:sldChg chg="delSp add mod modNotesTx">
        <pc:chgData name="Hayk Barseghyan" userId="1af3c995-31f7-415e-9aa1-2b36900e994d" providerId="ADAL" clId="{2F91834A-475B-4F34-A1E3-28AB80E687F7}" dt="2021-04-02T21:06:17.300" v="974" actId="20577"/>
        <pc:sldMkLst>
          <pc:docMk/>
          <pc:sldMk cId="143339667" sldId="655"/>
        </pc:sldMkLst>
        <pc:spChg chg="del">
          <ac:chgData name="Hayk Barseghyan" userId="1af3c995-31f7-415e-9aa1-2b36900e994d" providerId="ADAL" clId="{2F91834A-475B-4F34-A1E3-28AB80E687F7}" dt="2021-04-02T21:06:01.473" v="944" actId="478"/>
          <ac:spMkLst>
            <pc:docMk/>
            <pc:sldMk cId="143339667" sldId="655"/>
            <ac:spMk id="42" creationId="{BCAF44B2-159A-4E49-9C66-509D0254A0FB}"/>
          </ac:spMkLst>
        </pc:spChg>
      </pc:sldChg>
      <pc:sldChg chg="del">
        <pc:chgData name="Hayk Barseghyan" userId="1af3c995-31f7-415e-9aa1-2b36900e994d" providerId="ADAL" clId="{2F91834A-475B-4F34-A1E3-28AB80E687F7}" dt="2021-04-02T14:51:46.095" v="2" actId="2696"/>
        <pc:sldMkLst>
          <pc:docMk/>
          <pc:sldMk cId="1879609064" sldId="655"/>
        </pc:sldMkLst>
      </pc:sldChg>
      <pc:sldChg chg="modSp mod">
        <pc:chgData name="Hayk Barseghyan" userId="1af3c995-31f7-415e-9aa1-2b36900e994d" providerId="ADAL" clId="{2F91834A-475B-4F34-A1E3-28AB80E687F7}" dt="2021-04-02T21:06:52.786" v="984" actId="20577"/>
        <pc:sldMkLst>
          <pc:docMk/>
          <pc:sldMk cId="3227928584" sldId="661"/>
        </pc:sldMkLst>
        <pc:spChg chg="mod">
          <ac:chgData name="Hayk Barseghyan" userId="1af3c995-31f7-415e-9aa1-2b36900e994d" providerId="ADAL" clId="{2F91834A-475B-4F34-A1E3-28AB80E687F7}" dt="2021-04-02T21:06:52.786" v="984" actId="20577"/>
          <ac:spMkLst>
            <pc:docMk/>
            <pc:sldMk cId="3227928584" sldId="661"/>
            <ac:spMk id="7" creationId="{E71A5CF8-4675-4894-B98F-9790B8805E6A}"/>
          </ac:spMkLst>
        </pc:spChg>
      </pc:sldChg>
      <pc:sldChg chg="addSp delSp modSp mod modNotesTx">
        <pc:chgData name="Hayk Barseghyan" userId="1af3c995-31f7-415e-9aa1-2b36900e994d" providerId="ADAL" clId="{2F91834A-475B-4F34-A1E3-28AB80E687F7}" dt="2021-04-02T21:22:08.588" v="1475" actId="20577"/>
        <pc:sldMkLst>
          <pc:docMk/>
          <pc:sldMk cId="47234520" sldId="663"/>
        </pc:sldMkLst>
        <pc:spChg chg="mod">
          <ac:chgData name="Hayk Barseghyan" userId="1af3c995-31f7-415e-9aa1-2b36900e994d" providerId="ADAL" clId="{2F91834A-475B-4F34-A1E3-28AB80E687F7}" dt="2021-04-02T21:21:46.686" v="1471" actId="20577"/>
          <ac:spMkLst>
            <pc:docMk/>
            <pc:sldMk cId="47234520" sldId="663"/>
            <ac:spMk id="33" creationId="{27D04DB1-6D7F-4335-AAA1-99D44F3F14E9}"/>
          </ac:spMkLst>
        </pc:spChg>
        <pc:picChg chg="add del">
          <ac:chgData name="Hayk Barseghyan" userId="1af3c995-31f7-415e-9aa1-2b36900e994d" providerId="ADAL" clId="{2F91834A-475B-4F34-A1E3-28AB80E687F7}" dt="2021-04-02T14:54:21.516" v="527" actId="478"/>
          <ac:picMkLst>
            <pc:docMk/>
            <pc:sldMk cId="47234520" sldId="663"/>
            <ac:picMk id="10" creationId="{E238B8FE-BA66-4E00-BE15-D0DF19DE94CD}"/>
          </ac:picMkLst>
        </pc:picChg>
      </pc:sldChg>
      <pc:sldChg chg="addSp delSp modSp mod modNotesTx">
        <pc:chgData name="Hayk Barseghyan" userId="1af3c995-31f7-415e-9aa1-2b36900e994d" providerId="ADAL" clId="{2F91834A-475B-4F34-A1E3-28AB80E687F7}" dt="2021-04-02T21:46:58.656" v="1770" actId="20577"/>
        <pc:sldMkLst>
          <pc:docMk/>
          <pc:sldMk cId="2324644523" sldId="667"/>
        </pc:sldMkLst>
        <pc:spChg chg="del">
          <ac:chgData name="Hayk Barseghyan" userId="1af3c995-31f7-415e-9aa1-2b36900e994d" providerId="ADAL" clId="{2F91834A-475B-4F34-A1E3-28AB80E687F7}" dt="2021-04-02T14:52:00.454" v="9" actId="478"/>
          <ac:spMkLst>
            <pc:docMk/>
            <pc:sldMk cId="2324644523" sldId="667"/>
            <ac:spMk id="15" creationId="{1DA809E1-700B-4B5F-80D1-146841C532CC}"/>
          </ac:spMkLst>
        </pc:spChg>
        <pc:spChg chg="del">
          <ac:chgData name="Hayk Barseghyan" userId="1af3c995-31f7-415e-9aa1-2b36900e994d" providerId="ADAL" clId="{2F91834A-475B-4F34-A1E3-28AB80E687F7}" dt="2021-04-02T14:52:00.454" v="9" actId="478"/>
          <ac:spMkLst>
            <pc:docMk/>
            <pc:sldMk cId="2324644523" sldId="667"/>
            <ac:spMk id="16" creationId="{219D3844-749C-4AC5-8AAC-A5A6E4F706D5}"/>
          </ac:spMkLst>
        </pc:spChg>
        <pc:spChg chg="del">
          <ac:chgData name="Hayk Barseghyan" userId="1af3c995-31f7-415e-9aa1-2b36900e994d" providerId="ADAL" clId="{2F91834A-475B-4F34-A1E3-28AB80E687F7}" dt="2021-04-02T14:52:00.454" v="9" actId="478"/>
          <ac:spMkLst>
            <pc:docMk/>
            <pc:sldMk cId="2324644523" sldId="667"/>
            <ac:spMk id="17" creationId="{238D452B-545B-49D2-9AA5-4774F789BA52}"/>
          </ac:spMkLst>
        </pc:spChg>
        <pc:spChg chg="del">
          <ac:chgData name="Hayk Barseghyan" userId="1af3c995-31f7-415e-9aa1-2b36900e994d" providerId="ADAL" clId="{2F91834A-475B-4F34-A1E3-28AB80E687F7}" dt="2021-04-02T14:52:00.454" v="9" actId="478"/>
          <ac:spMkLst>
            <pc:docMk/>
            <pc:sldMk cId="2324644523" sldId="667"/>
            <ac:spMk id="18" creationId="{3B330CDD-DF8E-4329-9F8F-0C05A3EBA278}"/>
          </ac:spMkLst>
        </pc:spChg>
        <pc:spChg chg="del">
          <ac:chgData name="Hayk Barseghyan" userId="1af3c995-31f7-415e-9aa1-2b36900e994d" providerId="ADAL" clId="{2F91834A-475B-4F34-A1E3-28AB80E687F7}" dt="2021-04-02T14:52:00.454" v="9" actId="478"/>
          <ac:spMkLst>
            <pc:docMk/>
            <pc:sldMk cId="2324644523" sldId="667"/>
            <ac:spMk id="19" creationId="{92E3FBB9-4482-4901-BB7B-515414A60BF3}"/>
          </ac:spMkLst>
        </pc:spChg>
        <pc:spChg chg="del">
          <ac:chgData name="Hayk Barseghyan" userId="1af3c995-31f7-415e-9aa1-2b36900e994d" providerId="ADAL" clId="{2F91834A-475B-4F34-A1E3-28AB80E687F7}" dt="2021-04-02T14:52:00.454" v="9" actId="478"/>
          <ac:spMkLst>
            <pc:docMk/>
            <pc:sldMk cId="2324644523" sldId="667"/>
            <ac:spMk id="20" creationId="{33617DAE-E7EA-4947-A705-85255111007E}"/>
          </ac:spMkLst>
        </pc:spChg>
        <pc:spChg chg="del">
          <ac:chgData name="Hayk Barseghyan" userId="1af3c995-31f7-415e-9aa1-2b36900e994d" providerId="ADAL" clId="{2F91834A-475B-4F34-A1E3-28AB80E687F7}" dt="2021-04-02T14:52:00.454" v="9" actId="478"/>
          <ac:spMkLst>
            <pc:docMk/>
            <pc:sldMk cId="2324644523" sldId="667"/>
            <ac:spMk id="21" creationId="{C9A0FE9C-502B-4BBD-8A60-74F846E3930A}"/>
          </ac:spMkLst>
        </pc:spChg>
        <pc:spChg chg="del">
          <ac:chgData name="Hayk Barseghyan" userId="1af3c995-31f7-415e-9aa1-2b36900e994d" providerId="ADAL" clId="{2F91834A-475B-4F34-A1E3-28AB80E687F7}" dt="2021-04-02T14:52:00.454" v="9" actId="478"/>
          <ac:spMkLst>
            <pc:docMk/>
            <pc:sldMk cId="2324644523" sldId="667"/>
            <ac:spMk id="22" creationId="{097F0FB6-DB3D-4B12-9E76-180A15D9B845}"/>
          </ac:spMkLst>
        </pc:spChg>
        <pc:spChg chg="mod">
          <ac:chgData name="Hayk Barseghyan" userId="1af3c995-31f7-415e-9aa1-2b36900e994d" providerId="ADAL" clId="{2F91834A-475B-4F34-A1E3-28AB80E687F7}" dt="2021-04-02T21:09:58.757" v="1206" actId="20577"/>
          <ac:spMkLst>
            <pc:docMk/>
            <pc:sldMk cId="2324644523" sldId="667"/>
            <ac:spMk id="28" creationId="{627423C8-B194-4935-85FA-5ED8C3D13EA3}"/>
          </ac:spMkLst>
        </pc:spChg>
        <pc:spChg chg="del">
          <ac:chgData name="Hayk Barseghyan" userId="1af3c995-31f7-415e-9aa1-2b36900e994d" providerId="ADAL" clId="{2F91834A-475B-4F34-A1E3-28AB80E687F7}" dt="2021-04-02T14:52:02.106" v="10" actId="478"/>
          <ac:spMkLst>
            <pc:docMk/>
            <pc:sldMk cId="2324644523" sldId="667"/>
            <ac:spMk id="30" creationId="{68ED1E75-B125-4C10-BB29-81E202553B2C}"/>
          </ac:spMkLst>
        </pc:spChg>
        <pc:spChg chg="del mod">
          <ac:chgData name="Hayk Barseghyan" userId="1af3c995-31f7-415e-9aa1-2b36900e994d" providerId="ADAL" clId="{2F91834A-475B-4F34-A1E3-28AB80E687F7}" dt="2021-04-02T21:09:44.414" v="1183" actId="478"/>
          <ac:spMkLst>
            <pc:docMk/>
            <pc:sldMk cId="2324644523" sldId="667"/>
            <ac:spMk id="34" creationId="{9E232FB5-9A42-4416-8E4E-5620B622F041}"/>
          </ac:spMkLst>
        </pc:spChg>
        <pc:spChg chg="del mod">
          <ac:chgData name="Hayk Barseghyan" userId="1af3c995-31f7-415e-9aa1-2b36900e994d" providerId="ADAL" clId="{2F91834A-475B-4F34-A1E3-28AB80E687F7}" dt="2021-04-02T21:09:44.414" v="1183" actId="478"/>
          <ac:spMkLst>
            <pc:docMk/>
            <pc:sldMk cId="2324644523" sldId="667"/>
            <ac:spMk id="36" creationId="{D1390CDB-8C38-45E4-B737-627C1887B062}"/>
          </ac:spMkLst>
        </pc:spChg>
        <pc:spChg chg="add mod">
          <ac:chgData name="Hayk Barseghyan" userId="1af3c995-31f7-415e-9aa1-2b36900e994d" providerId="ADAL" clId="{2F91834A-475B-4F34-A1E3-28AB80E687F7}" dt="2021-04-02T14:53:14.285" v="270" actId="571"/>
          <ac:spMkLst>
            <pc:docMk/>
            <pc:sldMk cId="2324644523" sldId="667"/>
            <ac:spMk id="37" creationId="{6608588D-6C55-4658-AE32-FE3F51F1D3A2}"/>
          </ac:spMkLst>
        </pc:spChg>
        <pc:spChg chg="add mod">
          <ac:chgData name="Hayk Barseghyan" userId="1af3c995-31f7-415e-9aa1-2b36900e994d" providerId="ADAL" clId="{2F91834A-475B-4F34-A1E3-28AB80E687F7}" dt="2021-04-02T14:53:14.285" v="270" actId="571"/>
          <ac:spMkLst>
            <pc:docMk/>
            <pc:sldMk cId="2324644523" sldId="667"/>
            <ac:spMk id="38" creationId="{3F0B461C-73C8-45E7-8830-C926228CF3B1}"/>
          </ac:spMkLst>
        </pc:spChg>
        <pc:spChg chg="add mod">
          <ac:chgData name="Hayk Barseghyan" userId="1af3c995-31f7-415e-9aa1-2b36900e994d" providerId="ADAL" clId="{2F91834A-475B-4F34-A1E3-28AB80E687F7}" dt="2021-04-02T14:53:14.285" v="270" actId="571"/>
          <ac:spMkLst>
            <pc:docMk/>
            <pc:sldMk cId="2324644523" sldId="667"/>
            <ac:spMk id="39" creationId="{80A38CC3-A007-458E-AF5D-3B8DDD74457C}"/>
          </ac:spMkLst>
        </pc:spChg>
        <pc:spChg chg="del mod">
          <ac:chgData name="Hayk Barseghyan" userId="1af3c995-31f7-415e-9aa1-2b36900e994d" providerId="ADAL" clId="{2F91834A-475B-4F34-A1E3-28AB80E687F7}" dt="2021-04-02T21:09:44.414" v="1183" actId="478"/>
          <ac:spMkLst>
            <pc:docMk/>
            <pc:sldMk cId="2324644523" sldId="667"/>
            <ac:spMk id="40" creationId="{EFE6C304-6608-4E19-9AF5-28280CCAEF69}"/>
          </ac:spMkLst>
        </pc:spChg>
        <pc:spChg chg="add mod">
          <ac:chgData name="Hayk Barseghyan" userId="1af3c995-31f7-415e-9aa1-2b36900e994d" providerId="ADAL" clId="{2F91834A-475B-4F34-A1E3-28AB80E687F7}" dt="2021-04-02T21:10:35.854" v="1284" actId="1038"/>
          <ac:spMkLst>
            <pc:docMk/>
            <pc:sldMk cId="2324644523" sldId="667"/>
            <ac:spMk id="41" creationId="{26367393-9A3A-4910-9224-AAD444228D62}"/>
          </ac:spMkLst>
        </pc:spChg>
        <pc:spChg chg="del mod">
          <ac:chgData name="Hayk Barseghyan" userId="1af3c995-31f7-415e-9aa1-2b36900e994d" providerId="ADAL" clId="{2F91834A-475B-4F34-A1E3-28AB80E687F7}" dt="2021-04-02T21:08:26.159" v="1174" actId="478"/>
          <ac:spMkLst>
            <pc:docMk/>
            <pc:sldMk cId="2324644523" sldId="667"/>
            <ac:spMk id="42" creationId="{BCAF44B2-159A-4E49-9C66-509D0254A0FB}"/>
          </ac:spMkLst>
        </pc:spChg>
        <pc:spChg chg="add mod">
          <ac:chgData name="Hayk Barseghyan" userId="1af3c995-31f7-415e-9aa1-2b36900e994d" providerId="ADAL" clId="{2F91834A-475B-4F34-A1E3-28AB80E687F7}" dt="2021-04-02T21:10:14.788" v="1230" actId="20577"/>
          <ac:spMkLst>
            <pc:docMk/>
            <pc:sldMk cId="2324644523" sldId="667"/>
            <ac:spMk id="43" creationId="{E5E72085-E385-4A63-A046-158DF2223D97}"/>
          </ac:spMkLst>
        </pc:spChg>
        <pc:spChg chg="mod">
          <ac:chgData name="Hayk Barseghyan" userId="1af3c995-31f7-415e-9aa1-2b36900e994d" providerId="ADAL" clId="{2F91834A-475B-4F34-A1E3-28AB80E687F7}" dt="2021-04-02T21:09:18.894" v="1181" actId="1076"/>
          <ac:spMkLst>
            <pc:docMk/>
            <pc:sldMk cId="2324644523" sldId="667"/>
            <ac:spMk id="44" creationId="{732812E5-D6B9-4FEF-975D-E2E3D93D0E47}"/>
          </ac:spMkLst>
        </pc:spChg>
        <pc:spChg chg="mod">
          <ac:chgData name="Hayk Barseghyan" userId="1af3c995-31f7-415e-9aa1-2b36900e994d" providerId="ADAL" clId="{2F91834A-475B-4F34-A1E3-28AB80E687F7}" dt="2021-04-02T21:09:18.894" v="1181" actId="1076"/>
          <ac:spMkLst>
            <pc:docMk/>
            <pc:sldMk cId="2324644523" sldId="667"/>
            <ac:spMk id="45" creationId="{706B5154-0B8D-4A97-9481-9F43337FAC30}"/>
          </ac:spMkLst>
        </pc:spChg>
        <pc:spChg chg="add mod">
          <ac:chgData name="Hayk Barseghyan" userId="1af3c995-31f7-415e-9aa1-2b36900e994d" providerId="ADAL" clId="{2F91834A-475B-4F34-A1E3-28AB80E687F7}" dt="2021-04-02T21:11:37.467" v="1319" actId="1035"/>
          <ac:spMkLst>
            <pc:docMk/>
            <pc:sldMk cId="2324644523" sldId="667"/>
            <ac:spMk id="46" creationId="{72FDDD23-4386-406F-909B-D87F05B38C36}"/>
          </ac:spMkLst>
        </pc:spChg>
        <pc:spChg chg="add mod">
          <ac:chgData name="Hayk Barseghyan" userId="1af3c995-31f7-415e-9aa1-2b36900e994d" providerId="ADAL" clId="{2F91834A-475B-4F34-A1E3-28AB80E687F7}" dt="2021-04-02T21:11:37.467" v="1319" actId="1035"/>
          <ac:spMkLst>
            <pc:docMk/>
            <pc:sldMk cId="2324644523" sldId="667"/>
            <ac:spMk id="47" creationId="{8CDE9EFE-773D-4D8D-B55E-0E5879D472AC}"/>
          </ac:spMkLst>
        </pc:spChg>
        <pc:spChg chg="del">
          <ac:chgData name="Hayk Barseghyan" userId="1af3c995-31f7-415e-9aa1-2b36900e994d" providerId="ADAL" clId="{2F91834A-475B-4F34-A1E3-28AB80E687F7}" dt="2021-04-02T14:51:57.812" v="7" actId="478"/>
          <ac:spMkLst>
            <pc:docMk/>
            <pc:sldMk cId="2324644523" sldId="667"/>
            <ac:spMk id="48" creationId="{7DECEAD3-1F4B-4349-B3E1-EC2281C752C7}"/>
          </ac:spMkLst>
        </pc:spChg>
        <pc:spChg chg="add mod">
          <ac:chgData name="Hayk Barseghyan" userId="1af3c995-31f7-415e-9aa1-2b36900e994d" providerId="ADAL" clId="{2F91834A-475B-4F34-A1E3-28AB80E687F7}" dt="2021-04-02T21:11:37.467" v="1319" actId="1035"/>
          <ac:spMkLst>
            <pc:docMk/>
            <pc:sldMk cId="2324644523" sldId="667"/>
            <ac:spMk id="50" creationId="{95CC6DAF-1719-438F-B149-27EE31AAC27B}"/>
          </ac:spMkLst>
        </pc:spChg>
        <pc:spChg chg="add mod">
          <ac:chgData name="Hayk Barseghyan" userId="1af3c995-31f7-415e-9aa1-2b36900e994d" providerId="ADAL" clId="{2F91834A-475B-4F34-A1E3-28AB80E687F7}" dt="2021-04-02T21:24:05.937" v="1505" actId="1076"/>
          <ac:spMkLst>
            <pc:docMk/>
            <pc:sldMk cId="2324644523" sldId="667"/>
            <ac:spMk id="51" creationId="{A184D65A-9C51-47FB-804F-072D60CD6C03}"/>
          </ac:spMkLst>
        </pc:spChg>
        <pc:spChg chg="add mod">
          <ac:chgData name="Hayk Barseghyan" userId="1af3c995-31f7-415e-9aa1-2b36900e994d" providerId="ADAL" clId="{2F91834A-475B-4F34-A1E3-28AB80E687F7}" dt="2021-04-02T21:12:07.569" v="1469" actId="1037"/>
          <ac:spMkLst>
            <pc:docMk/>
            <pc:sldMk cId="2324644523" sldId="667"/>
            <ac:spMk id="53" creationId="{4D4255AA-33C7-4FB4-B572-CC587A055A38}"/>
          </ac:spMkLst>
        </pc:spChg>
        <pc:spChg chg="add mod">
          <ac:chgData name="Hayk Barseghyan" userId="1af3c995-31f7-415e-9aa1-2b36900e994d" providerId="ADAL" clId="{2F91834A-475B-4F34-A1E3-28AB80E687F7}" dt="2021-04-02T21:12:07.569" v="1469" actId="1037"/>
          <ac:spMkLst>
            <pc:docMk/>
            <pc:sldMk cId="2324644523" sldId="667"/>
            <ac:spMk id="54" creationId="{B8AA38EC-2D55-45ED-80D2-05BC2BD008BE}"/>
          </ac:spMkLst>
        </pc:spChg>
        <pc:spChg chg="add mod">
          <ac:chgData name="Hayk Barseghyan" userId="1af3c995-31f7-415e-9aa1-2b36900e994d" providerId="ADAL" clId="{2F91834A-475B-4F34-A1E3-28AB80E687F7}" dt="2021-04-02T21:35:49.535" v="1656" actId="20577"/>
          <ac:spMkLst>
            <pc:docMk/>
            <pc:sldMk cId="2324644523" sldId="667"/>
            <ac:spMk id="55" creationId="{CEBE6057-539E-4D34-BEBB-573D89B05350}"/>
          </ac:spMkLst>
        </pc:spChg>
        <pc:spChg chg="add mod">
          <ac:chgData name="Hayk Barseghyan" userId="1af3c995-31f7-415e-9aa1-2b36900e994d" providerId="ADAL" clId="{2F91834A-475B-4F34-A1E3-28AB80E687F7}" dt="2021-04-02T21:34:19.533" v="1633" actId="1038"/>
          <ac:spMkLst>
            <pc:docMk/>
            <pc:sldMk cId="2324644523" sldId="667"/>
            <ac:spMk id="56" creationId="{C8AB3E85-3BA5-42B3-80A6-1EDA4EF78B0C}"/>
          </ac:spMkLst>
        </pc:spChg>
        <pc:spChg chg="add mod">
          <ac:chgData name="Hayk Barseghyan" userId="1af3c995-31f7-415e-9aa1-2b36900e994d" providerId="ADAL" clId="{2F91834A-475B-4F34-A1E3-28AB80E687F7}" dt="2021-04-02T21:34:32.450" v="1641" actId="1036"/>
          <ac:spMkLst>
            <pc:docMk/>
            <pc:sldMk cId="2324644523" sldId="667"/>
            <ac:spMk id="57" creationId="{6CC8DEFE-AF0B-460C-99B4-95942B60A3D5}"/>
          </ac:spMkLst>
        </pc:spChg>
        <pc:spChg chg="add mod">
          <ac:chgData name="Hayk Barseghyan" userId="1af3c995-31f7-415e-9aa1-2b36900e994d" providerId="ADAL" clId="{2F91834A-475B-4F34-A1E3-28AB80E687F7}" dt="2021-04-02T21:46:58.656" v="1770" actId="20577"/>
          <ac:spMkLst>
            <pc:docMk/>
            <pc:sldMk cId="2324644523" sldId="667"/>
            <ac:spMk id="65" creationId="{7B0A550E-B214-4B38-81C9-D41D56CD4B8B}"/>
          </ac:spMkLst>
        </pc:spChg>
        <pc:spChg chg="mod">
          <ac:chgData name="Hayk Barseghyan" userId="1af3c995-31f7-415e-9aa1-2b36900e994d" providerId="ADAL" clId="{2F91834A-475B-4F34-A1E3-28AB80E687F7}" dt="2021-04-02T21:09:08.425" v="1180" actId="1076"/>
          <ac:spMkLst>
            <pc:docMk/>
            <pc:sldMk cId="2324644523" sldId="667"/>
            <ac:spMk id="88" creationId="{7309DE7D-82B3-4F46-B078-58EBF40D4703}"/>
          </ac:spMkLst>
        </pc:spChg>
        <pc:spChg chg="del">
          <ac:chgData name="Hayk Barseghyan" userId="1af3c995-31f7-415e-9aa1-2b36900e994d" providerId="ADAL" clId="{2F91834A-475B-4F34-A1E3-28AB80E687F7}" dt="2021-04-02T14:52:02.106" v="10" actId="478"/>
          <ac:spMkLst>
            <pc:docMk/>
            <pc:sldMk cId="2324644523" sldId="667"/>
            <ac:spMk id="91" creationId="{13B1F2AA-C6E8-4BA8-9C3E-AADD95A31E93}"/>
          </ac:spMkLst>
        </pc:spChg>
        <pc:spChg chg="del">
          <ac:chgData name="Hayk Barseghyan" userId="1af3c995-31f7-415e-9aa1-2b36900e994d" providerId="ADAL" clId="{2F91834A-475B-4F34-A1E3-28AB80E687F7}" dt="2021-04-02T14:52:02.106" v="10" actId="478"/>
          <ac:spMkLst>
            <pc:docMk/>
            <pc:sldMk cId="2324644523" sldId="667"/>
            <ac:spMk id="92" creationId="{C38076EE-D1EB-4356-9361-84DA46C2351B}"/>
          </ac:spMkLst>
        </pc:spChg>
        <pc:spChg chg="mod">
          <ac:chgData name="Hayk Barseghyan" userId="1af3c995-31f7-415e-9aa1-2b36900e994d" providerId="ADAL" clId="{2F91834A-475B-4F34-A1E3-28AB80E687F7}" dt="2021-04-02T21:09:08.425" v="1180" actId="1076"/>
          <ac:spMkLst>
            <pc:docMk/>
            <pc:sldMk cId="2324644523" sldId="667"/>
            <ac:spMk id="93" creationId="{3EAC0E29-A0FD-42DD-8F3E-7B6BDF36A320}"/>
          </ac:spMkLst>
        </pc:spChg>
        <pc:spChg chg="mod">
          <ac:chgData name="Hayk Barseghyan" userId="1af3c995-31f7-415e-9aa1-2b36900e994d" providerId="ADAL" clId="{2F91834A-475B-4F34-A1E3-28AB80E687F7}" dt="2021-04-02T21:10:40.821" v="1285" actId="1076"/>
          <ac:spMkLst>
            <pc:docMk/>
            <pc:sldMk cId="2324644523" sldId="667"/>
            <ac:spMk id="94" creationId="{C3B2E742-FF55-4D80-8A82-03F353C11C9E}"/>
          </ac:spMkLst>
        </pc:spChg>
        <pc:spChg chg="del">
          <ac:chgData name="Hayk Barseghyan" userId="1af3c995-31f7-415e-9aa1-2b36900e994d" providerId="ADAL" clId="{2F91834A-475B-4F34-A1E3-28AB80E687F7}" dt="2021-04-02T14:51:55.053" v="6" actId="478"/>
          <ac:spMkLst>
            <pc:docMk/>
            <pc:sldMk cId="2324644523" sldId="667"/>
            <ac:spMk id="98" creationId="{CC1A3F83-E94B-4F3C-9D62-2C0B7D404690}"/>
          </ac:spMkLst>
        </pc:spChg>
        <pc:picChg chg="add del mod">
          <ac:chgData name="Hayk Barseghyan" userId="1af3c995-31f7-415e-9aa1-2b36900e994d" providerId="ADAL" clId="{2F91834A-475B-4F34-A1E3-28AB80E687F7}" dt="2021-04-02T21:29:43.137" v="1538" actId="478"/>
          <ac:picMkLst>
            <pc:docMk/>
            <pc:sldMk cId="2324644523" sldId="667"/>
            <ac:picMk id="3" creationId="{07B6F00D-675A-4E48-996C-019090E38B8D}"/>
          </ac:picMkLst>
        </pc:picChg>
        <pc:picChg chg="del">
          <ac:chgData name="Hayk Barseghyan" userId="1af3c995-31f7-415e-9aa1-2b36900e994d" providerId="ADAL" clId="{2F91834A-475B-4F34-A1E3-28AB80E687F7}" dt="2021-04-02T14:51:52.431" v="4" actId="478"/>
          <ac:picMkLst>
            <pc:docMk/>
            <pc:sldMk cId="2324644523" sldId="667"/>
            <ac:picMk id="4" creationId="{6EE723D7-82C2-40C7-9EDF-695ABCFD2852}"/>
          </ac:picMkLst>
        </pc:picChg>
        <pc:picChg chg="add del mod">
          <ac:chgData name="Hayk Barseghyan" userId="1af3c995-31f7-415e-9aa1-2b36900e994d" providerId="ADAL" clId="{2F91834A-475B-4F34-A1E3-28AB80E687F7}" dt="2021-04-02T21:29:41.315" v="1537" actId="478"/>
          <ac:picMkLst>
            <pc:docMk/>
            <pc:sldMk cId="2324644523" sldId="667"/>
            <ac:picMk id="6" creationId="{479FA128-23A9-47CB-A9D5-3C3F13CD097B}"/>
          </ac:picMkLst>
        </pc:picChg>
        <pc:picChg chg="add mod">
          <ac:chgData name="Hayk Barseghyan" userId="1af3c995-31f7-415e-9aa1-2b36900e994d" providerId="ADAL" clId="{2F91834A-475B-4F34-A1E3-28AB80E687F7}" dt="2021-04-02T21:34:00.236" v="1613" actId="1035"/>
          <ac:picMkLst>
            <pc:docMk/>
            <pc:sldMk cId="2324644523" sldId="667"/>
            <ac:picMk id="8" creationId="{C2F4CFAE-19D4-4CF3-AA27-972256137E91}"/>
          </ac:picMkLst>
        </pc:picChg>
        <pc:picChg chg="add mod ord">
          <ac:chgData name="Hayk Barseghyan" userId="1af3c995-31f7-415e-9aa1-2b36900e994d" providerId="ADAL" clId="{2F91834A-475B-4F34-A1E3-28AB80E687F7}" dt="2021-04-02T21:33:44.543" v="1610" actId="14100"/>
          <ac:picMkLst>
            <pc:docMk/>
            <pc:sldMk cId="2324644523" sldId="667"/>
            <ac:picMk id="10" creationId="{94505D45-D7CA-43EA-A472-64A3846DE999}"/>
          </ac:picMkLst>
        </pc:picChg>
        <pc:picChg chg="add mod">
          <ac:chgData name="Hayk Barseghyan" userId="1af3c995-31f7-415e-9aa1-2b36900e994d" providerId="ADAL" clId="{2F91834A-475B-4F34-A1E3-28AB80E687F7}" dt="2021-04-02T21:45:12.373" v="1737" actId="1076"/>
          <ac:picMkLst>
            <pc:docMk/>
            <pc:sldMk cId="2324644523" sldId="667"/>
            <ac:picMk id="12" creationId="{275784C0-4287-4244-9FF5-6076621E868E}"/>
          </ac:picMkLst>
        </pc:picChg>
        <pc:picChg chg="del">
          <ac:chgData name="Hayk Barseghyan" userId="1af3c995-31f7-415e-9aa1-2b36900e994d" providerId="ADAL" clId="{2F91834A-475B-4F34-A1E3-28AB80E687F7}" dt="2021-04-02T14:52:00.454" v="9" actId="478"/>
          <ac:picMkLst>
            <pc:docMk/>
            <pc:sldMk cId="2324644523" sldId="667"/>
            <ac:picMk id="14" creationId="{BD596D5A-A8B5-4F23-971B-B0033B030440}"/>
          </ac:picMkLst>
        </pc:picChg>
        <pc:picChg chg="add del mod">
          <ac:chgData name="Hayk Barseghyan" userId="1af3c995-31f7-415e-9aa1-2b36900e994d" providerId="ADAL" clId="{2F91834A-475B-4F34-A1E3-28AB80E687F7}" dt="2021-04-02T21:44:57.487" v="1734" actId="478"/>
          <ac:picMkLst>
            <pc:docMk/>
            <pc:sldMk cId="2324644523" sldId="667"/>
            <ac:picMk id="26" creationId="{1C6960C3-EA5F-49A9-8ECC-0AB65A2D458A}"/>
          </ac:picMkLst>
        </pc:picChg>
        <pc:picChg chg="add del mod">
          <ac:chgData name="Hayk Barseghyan" userId="1af3c995-31f7-415e-9aa1-2b36900e994d" providerId="ADAL" clId="{2F91834A-475B-4F34-A1E3-28AB80E687F7}" dt="2021-04-02T21:44:55.833" v="1733" actId="478"/>
          <ac:picMkLst>
            <pc:docMk/>
            <pc:sldMk cId="2324644523" sldId="667"/>
            <ac:picMk id="29" creationId="{C88F47DE-1273-4D8D-AC15-897E6CFA8A17}"/>
          </ac:picMkLst>
        </pc:picChg>
        <pc:picChg chg="add mod">
          <ac:chgData name="Hayk Barseghyan" userId="1af3c995-31f7-415e-9aa1-2b36900e994d" providerId="ADAL" clId="{2F91834A-475B-4F34-A1E3-28AB80E687F7}" dt="2021-04-02T21:46:25.238" v="1765" actId="14100"/>
          <ac:picMkLst>
            <pc:docMk/>
            <pc:sldMk cId="2324644523" sldId="667"/>
            <ac:picMk id="32" creationId="{D220D809-FBE8-496C-A502-B21C41CEC52D}"/>
          </ac:picMkLst>
        </pc:picChg>
        <pc:picChg chg="del mod">
          <ac:chgData name="Hayk Barseghyan" userId="1af3c995-31f7-415e-9aa1-2b36900e994d" providerId="ADAL" clId="{2F91834A-475B-4F34-A1E3-28AB80E687F7}" dt="2021-04-02T21:09:30.119" v="1182" actId="478"/>
          <ac:picMkLst>
            <pc:docMk/>
            <pc:sldMk cId="2324644523" sldId="667"/>
            <ac:picMk id="35" creationId="{347E1D22-E15C-425D-925B-99F60A60B955}"/>
          </ac:picMkLst>
        </pc:picChg>
        <pc:cxnChg chg="del mod">
          <ac:chgData name="Hayk Barseghyan" userId="1af3c995-31f7-415e-9aa1-2b36900e994d" providerId="ADAL" clId="{2F91834A-475B-4F34-A1E3-28AB80E687F7}" dt="2021-04-02T14:52:00.454" v="9" actId="478"/>
          <ac:cxnSpMkLst>
            <pc:docMk/>
            <pc:sldMk cId="2324644523" sldId="667"/>
            <ac:cxnSpMk id="23" creationId="{B97A16ED-5542-4DD1-94CA-D032D3F72196}"/>
          </ac:cxnSpMkLst>
        </pc:cxnChg>
        <pc:cxnChg chg="del mod">
          <ac:chgData name="Hayk Barseghyan" userId="1af3c995-31f7-415e-9aa1-2b36900e994d" providerId="ADAL" clId="{2F91834A-475B-4F34-A1E3-28AB80E687F7}" dt="2021-04-02T14:52:00.454" v="9" actId="478"/>
          <ac:cxnSpMkLst>
            <pc:docMk/>
            <pc:sldMk cId="2324644523" sldId="667"/>
            <ac:cxnSpMk id="24" creationId="{792D8F66-E748-410F-BB9B-B632B254BDFB}"/>
          </ac:cxnSpMkLst>
        </pc:cxnChg>
        <pc:cxnChg chg="del mod">
          <ac:chgData name="Hayk Barseghyan" userId="1af3c995-31f7-415e-9aa1-2b36900e994d" providerId="ADAL" clId="{2F91834A-475B-4F34-A1E3-28AB80E687F7}" dt="2021-04-02T14:52:00.454" v="9" actId="478"/>
          <ac:cxnSpMkLst>
            <pc:docMk/>
            <pc:sldMk cId="2324644523" sldId="667"/>
            <ac:cxnSpMk id="25" creationId="{A4F48631-3605-414B-96A3-B4E7701F3903}"/>
          </ac:cxnSpMkLst>
        </pc:cxnChg>
        <pc:cxnChg chg="del mod">
          <ac:chgData name="Hayk Barseghyan" userId="1af3c995-31f7-415e-9aa1-2b36900e994d" providerId="ADAL" clId="{2F91834A-475B-4F34-A1E3-28AB80E687F7}" dt="2021-04-02T14:51:58.662" v="8" actId="478"/>
          <ac:cxnSpMkLst>
            <pc:docMk/>
            <pc:sldMk cId="2324644523" sldId="667"/>
            <ac:cxnSpMk id="49" creationId="{4423681D-AADF-4D62-AC9E-3FDDF18E21B9}"/>
          </ac:cxnSpMkLst>
        </pc:cxnChg>
        <pc:cxnChg chg="del mod">
          <ac:chgData name="Hayk Barseghyan" userId="1af3c995-31f7-415e-9aa1-2b36900e994d" providerId="ADAL" clId="{2F91834A-475B-4F34-A1E3-28AB80E687F7}" dt="2021-04-02T14:51:54.055" v="5" actId="478"/>
          <ac:cxnSpMkLst>
            <pc:docMk/>
            <pc:sldMk cId="2324644523" sldId="667"/>
            <ac:cxnSpMk id="52" creationId="{67E81840-D31A-48DD-9275-CD08F7D6F031}"/>
          </ac:cxnSpMkLst>
        </pc:cxnChg>
        <pc:cxnChg chg="del mod">
          <ac:chgData name="Hayk Barseghyan" userId="1af3c995-31f7-415e-9aa1-2b36900e994d" providerId="ADAL" clId="{2F91834A-475B-4F34-A1E3-28AB80E687F7}" dt="2021-04-02T21:46:47.056" v="1766" actId="478"/>
          <ac:cxnSpMkLst>
            <pc:docMk/>
            <pc:sldMk cId="2324644523" sldId="667"/>
            <ac:cxnSpMk id="95" creationId="{5EB10151-CF0F-4162-A03A-2FB4661DCBE8}"/>
          </ac:cxnSpMkLst>
        </pc:cxnChg>
      </pc:sldChg>
      <pc:sldChg chg="new del ord">
        <pc:chgData name="Hayk Barseghyan" userId="1af3c995-31f7-415e-9aa1-2b36900e994d" providerId="ADAL" clId="{2F91834A-475B-4F34-A1E3-28AB80E687F7}" dt="2021-04-02T21:23:25.066" v="1482" actId="47"/>
        <pc:sldMkLst>
          <pc:docMk/>
          <pc:sldMk cId="2534952573" sldId="668"/>
        </pc:sldMkLst>
      </pc:sldChg>
      <pc:sldChg chg="addSp modSp new mod ord">
        <pc:chgData name="Hayk Barseghyan" userId="1af3c995-31f7-415e-9aa1-2b36900e994d" providerId="ADAL" clId="{2F91834A-475B-4F34-A1E3-28AB80E687F7}" dt="2021-04-02T21:23:14.958" v="1478"/>
        <pc:sldMkLst>
          <pc:docMk/>
          <pc:sldMk cId="511255801" sldId="669"/>
        </pc:sldMkLst>
        <pc:spChg chg="add mod">
          <ac:chgData name="Hayk Barseghyan" userId="1af3c995-31f7-415e-9aa1-2b36900e994d" providerId="ADAL" clId="{2F91834A-475B-4F34-A1E3-28AB80E687F7}" dt="2021-04-02T14:55:04.661" v="541" actId="1076"/>
          <ac:spMkLst>
            <pc:docMk/>
            <pc:sldMk cId="511255801" sldId="669"/>
            <ac:spMk id="2" creationId="{FDDD89BA-6328-4826-9F7D-5D5945E069B8}"/>
          </ac:spMkLst>
        </pc:spChg>
      </pc:sldChg>
      <pc:sldChg chg="add">
        <pc:chgData name="Hayk Barseghyan" userId="1af3c995-31f7-415e-9aa1-2b36900e994d" providerId="ADAL" clId="{2F91834A-475B-4F34-A1E3-28AB80E687F7}" dt="2021-04-02T14:54:30.246" v="528"/>
        <pc:sldMkLst>
          <pc:docMk/>
          <pc:sldMk cId="1941966632" sldId="670"/>
        </pc:sldMkLst>
      </pc:sldChg>
      <pc:sldChg chg="add">
        <pc:chgData name="Hayk Barseghyan" userId="1af3c995-31f7-415e-9aa1-2b36900e994d" providerId="ADAL" clId="{2F91834A-475B-4F34-A1E3-28AB80E687F7}" dt="2021-04-02T21:23:10.704" v="1476"/>
        <pc:sldMkLst>
          <pc:docMk/>
          <pc:sldMk cId="2946833462" sldId="671"/>
        </pc:sldMkLst>
      </pc:sldChg>
      <pc:sldChg chg="modSp add mod">
        <pc:chgData name="Hayk Barseghyan" userId="1af3c995-31f7-415e-9aa1-2b36900e994d" providerId="ADAL" clId="{2F91834A-475B-4F34-A1E3-28AB80E687F7}" dt="2021-04-02T21:23:47.129" v="1503" actId="20577"/>
        <pc:sldMkLst>
          <pc:docMk/>
          <pc:sldMk cId="4227624210" sldId="672"/>
        </pc:sldMkLst>
        <pc:spChg chg="mod">
          <ac:chgData name="Hayk Barseghyan" userId="1af3c995-31f7-415e-9aa1-2b36900e994d" providerId="ADAL" clId="{2F91834A-475B-4F34-A1E3-28AB80E687F7}" dt="2021-04-02T21:23:47.129" v="1503" actId="20577"/>
          <ac:spMkLst>
            <pc:docMk/>
            <pc:sldMk cId="4227624210" sldId="672"/>
            <ac:spMk id="2" creationId="{FDDD89BA-6328-4826-9F7D-5D5945E069B8}"/>
          </ac:spMkLst>
        </pc:spChg>
      </pc:sldChg>
    </pc:docChg>
  </pc:docChgLst>
  <pc:docChgLst>
    <pc:chgData name="Hayk Barseghyan" userId="1af3c995-31f7-415e-9aa1-2b36900e994d" providerId="ADAL" clId="{2C3CE223-BEF1-4D2A-8D7F-5E0676045699}"/>
    <pc:docChg chg="custSel delSld modSld">
      <pc:chgData name="Hayk Barseghyan" userId="1af3c995-31f7-415e-9aa1-2b36900e994d" providerId="ADAL" clId="{2C3CE223-BEF1-4D2A-8D7F-5E0676045699}" dt="2021-03-09T16:07:50.038" v="50" actId="478"/>
      <pc:docMkLst>
        <pc:docMk/>
      </pc:docMkLst>
      <pc:sldChg chg="addSp delSp modSp mod">
        <pc:chgData name="Hayk Barseghyan" userId="1af3c995-31f7-415e-9aa1-2b36900e994d" providerId="ADAL" clId="{2C3CE223-BEF1-4D2A-8D7F-5E0676045699}" dt="2021-03-09T15:49:15.822" v="48" actId="1076"/>
        <pc:sldMkLst>
          <pc:docMk/>
          <pc:sldMk cId="779035963" sldId="652"/>
        </pc:sldMkLst>
        <pc:picChg chg="add del mod">
          <ac:chgData name="Hayk Barseghyan" userId="1af3c995-31f7-415e-9aa1-2b36900e994d" providerId="ADAL" clId="{2C3CE223-BEF1-4D2A-8D7F-5E0676045699}" dt="2021-03-09T15:45:20.691" v="10" actId="478"/>
          <ac:picMkLst>
            <pc:docMk/>
            <pc:sldMk cId="779035963" sldId="652"/>
            <ac:picMk id="3" creationId="{98527207-AD1B-41B1-8D20-CE2A8F5B3A49}"/>
          </ac:picMkLst>
        </pc:picChg>
        <pc:picChg chg="add mod">
          <ac:chgData name="Hayk Barseghyan" userId="1af3c995-31f7-415e-9aa1-2b36900e994d" providerId="ADAL" clId="{2C3CE223-BEF1-4D2A-8D7F-5E0676045699}" dt="2021-03-09T15:49:12.268" v="47" actId="1076"/>
          <ac:picMkLst>
            <pc:docMk/>
            <pc:sldMk cId="779035963" sldId="652"/>
            <ac:picMk id="7" creationId="{5C9804F2-217B-4236-B291-FC3FB679AAA3}"/>
          </ac:picMkLst>
        </pc:picChg>
        <pc:picChg chg="mod">
          <ac:chgData name="Hayk Barseghyan" userId="1af3c995-31f7-415e-9aa1-2b36900e994d" providerId="ADAL" clId="{2C3CE223-BEF1-4D2A-8D7F-5E0676045699}" dt="2021-03-09T15:49:15.822" v="48" actId="1076"/>
          <ac:picMkLst>
            <pc:docMk/>
            <pc:sldMk cId="779035963" sldId="652"/>
            <ac:picMk id="21" creationId="{6E8C6618-D138-4944-8E6F-18F2105A5E40}"/>
          </ac:picMkLst>
        </pc:picChg>
      </pc:sldChg>
      <pc:sldChg chg="addSp delSp modSp mod">
        <pc:chgData name="Hayk Barseghyan" userId="1af3c995-31f7-415e-9aa1-2b36900e994d" providerId="ADAL" clId="{2C3CE223-BEF1-4D2A-8D7F-5E0676045699}" dt="2021-03-09T16:07:50.038" v="50" actId="478"/>
        <pc:sldMkLst>
          <pc:docMk/>
          <pc:sldMk cId="2358330284" sldId="656"/>
        </pc:sldMkLst>
        <pc:spChg chg="del mod">
          <ac:chgData name="Hayk Barseghyan" userId="1af3c995-31f7-415e-9aa1-2b36900e994d" providerId="ADAL" clId="{2C3CE223-BEF1-4D2A-8D7F-5E0676045699}" dt="2021-03-09T15:47:19.101" v="34" actId="478"/>
          <ac:spMkLst>
            <pc:docMk/>
            <pc:sldMk cId="2358330284" sldId="656"/>
            <ac:spMk id="6" creationId="{DCC070EE-C68A-4F43-9E6D-7528A9F0B5B5}"/>
          </ac:spMkLst>
        </pc:spChg>
        <pc:spChg chg="del">
          <ac:chgData name="Hayk Barseghyan" userId="1af3c995-31f7-415e-9aa1-2b36900e994d" providerId="ADAL" clId="{2C3CE223-BEF1-4D2A-8D7F-5E0676045699}" dt="2021-03-09T16:07:50.038" v="50" actId="478"/>
          <ac:spMkLst>
            <pc:docMk/>
            <pc:sldMk cId="2358330284" sldId="656"/>
            <ac:spMk id="46" creationId="{F12CE94F-9768-4348-9E90-CD072B837C6B}"/>
          </ac:spMkLst>
        </pc:spChg>
        <pc:spChg chg="del mod">
          <ac:chgData name="Hayk Barseghyan" userId="1af3c995-31f7-415e-9aa1-2b36900e994d" providerId="ADAL" clId="{2C3CE223-BEF1-4D2A-8D7F-5E0676045699}" dt="2021-03-09T15:46:55.986" v="29" actId="478"/>
          <ac:spMkLst>
            <pc:docMk/>
            <pc:sldMk cId="2358330284" sldId="656"/>
            <ac:spMk id="47" creationId="{7706E418-66C6-4F48-9E46-932FB52600F5}"/>
          </ac:spMkLst>
        </pc:spChg>
        <pc:spChg chg="mod">
          <ac:chgData name="Hayk Barseghyan" userId="1af3c995-31f7-415e-9aa1-2b36900e994d" providerId="ADAL" clId="{2C3CE223-BEF1-4D2A-8D7F-5E0676045699}" dt="2021-03-09T15:46:46.844" v="26" actId="1076"/>
          <ac:spMkLst>
            <pc:docMk/>
            <pc:sldMk cId="2358330284" sldId="656"/>
            <ac:spMk id="50" creationId="{3D4AFFA2-0EB1-479A-8CF2-256D7E2234D4}"/>
          </ac:spMkLst>
        </pc:spChg>
        <pc:spChg chg="mod">
          <ac:chgData name="Hayk Barseghyan" userId="1af3c995-31f7-415e-9aa1-2b36900e994d" providerId="ADAL" clId="{2C3CE223-BEF1-4D2A-8D7F-5E0676045699}" dt="2021-03-09T15:46:49.532" v="27" actId="1076"/>
          <ac:spMkLst>
            <pc:docMk/>
            <pc:sldMk cId="2358330284" sldId="656"/>
            <ac:spMk id="51" creationId="{462953EC-3CAB-4C48-8219-5F337546FD73}"/>
          </ac:spMkLst>
        </pc:spChg>
        <pc:spChg chg="mod">
          <ac:chgData name="Hayk Barseghyan" userId="1af3c995-31f7-415e-9aa1-2b36900e994d" providerId="ADAL" clId="{2C3CE223-BEF1-4D2A-8D7F-5E0676045699}" dt="2021-03-09T15:47:36.550" v="46" actId="14100"/>
          <ac:spMkLst>
            <pc:docMk/>
            <pc:sldMk cId="2358330284" sldId="656"/>
            <ac:spMk id="55" creationId="{67E70582-D155-4977-8567-F97FA5196E55}"/>
          </ac:spMkLst>
        </pc:spChg>
        <pc:picChg chg="del mod">
          <ac:chgData name="Hayk Barseghyan" userId="1af3c995-31f7-415e-9aa1-2b36900e994d" providerId="ADAL" clId="{2C3CE223-BEF1-4D2A-8D7F-5E0676045699}" dt="2021-03-09T15:46:20.408" v="19" actId="478"/>
          <ac:picMkLst>
            <pc:docMk/>
            <pc:sldMk cId="2358330284" sldId="656"/>
            <ac:picMk id="41" creationId="{C4828305-CE52-4BA4-9E44-3E3868CB3F25}"/>
          </ac:picMkLst>
        </pc:picChg>
        <pc:picChg chg="mod">
          <ac:chgData name="Hayk Barseghyan" userId="1af3c995-31f7-415e-9aa1-2b36900e994d" providerId="ADAL" clId="{2C3CE223-BEF1-4D2A-8D7F-5E0676045699}" dt="2021-03-09T15:47:31.751" v="45" actId="1035"/>
          <ac:picMkLst>
            <pc:docMk/>
            <pc:sldMk cId="2358330284" sldId="656"/>
            <ac:picMk id="54" creationId="{46E4ED50-9DC1-484D-9F24-CCAA96DB7FAB}"/>
          </ac:picMkLst>
        </pc:picChg>
        <pc:picChg chg="add mod">
          <ac:chgData name="Hayk Barseghyan" userId="1af3c995-31f7-415e-9aa1-2b36900e994d" providerId="ADAL" clId="{2C3CE223-BEF1-4D2A-8D7F-5E0676045699}" dt="2021-03-09T15:47:14.360" v="32" actId="14100"/>
          <ac:picMkLst>
            <pc:docMk/>
            <pc:sldMk cId="2358330284" sldId="656"/>
            <ac:picMk id="57" creationId="{74E1C826-45C6-40FA-A19C-1EA82439EEBC}"/>
          </ac:picMkLst>
        </pc:picChg>
      </pc:sldChg>
      <pc:sldChg chg="del">
        <pc:chgData name="Hayk Barseghyan" userId="1af3c995-31f7-415e-9aa1-2b36900e994d" providerId="ADAL" clId="{2C3CE223-BEF1-4D2A-8D7F-5E0676045699}" dt="2021-03-09T15:57:48.858" v="49" actId="47"/>
        <pc:sldMkLst>
          <pc:docMk/>
          <pc:sldMk cId="2214109847" sldId="4371"/>
        </pc:sldMkLst>
      </pc:sldChg>
    </pc:docChg>
  </pc:docChgLst>
  <pc:docChgLst>
    <pc:chgData name="Hayk Barseghyan" userId="1af3c995-31f7-415e-9aa1-2b36900e994d" providerId="ADAL" clId="{77B09DC0-6E65-42C7-8089-15FAF5F60744}"/>
    <pc:docChg chg="modSld">
      <pc:chgData name="Hayk Barseghyan" userId="1af3c995-31f7-415e-9aa1-2b36900e994d" providerId="ADAL" clId="{77B09DC0-6E65-42C7-8089-15FAF5F60744}" dt="2021-12-01T19:31:40.549" v="0" actId="1076"/>
      <pc:docMkLst>
        <pc:docMk/>
      </pc:docMkLst>
      <pc:sldChg chg="modSp mod">
        <pc:chgData name="Hayk Barseghyan" userId="1af3c995-31f7-415e-9aa1-2b36900e994d" providerId="ADAL" clId="{77B09DC0-6E65-42C7-8089-15FAF5F60744}" dt="2021-12-01T19:31:40.549" v="0" actId="1076"/>
        <pc:sldMkLst>
          <pc:docMk/>
          <pc:sldMk cId="367579465" sldId="675"/>
        </pc:sldMkLst>
        <pc:spChg chg="mod">
          <ac:chgData name="Hayk Barseghyan" userId="1af3c995-31f7-415e-9aa1-2b36900e994d" providerId="ADAL" clId="{77B09DC0-6E65-42C7-8089-15FAF5F60744}" dt="2021-12-01T19:31:40.549" v="0" actId="1076"/>
          <ac:spMkLst>
            <pc:docMk/>
            <pc:sldMk cId="367579465" sldId="675"/>
            <ac:spMk id="58" creationId="{6078E741-6FB6-4560-8393-F2D74C732C4D}"/>
          </ac:spMkLst>
        </pc:spChg>
      </pc:sldChg>
    </pc:docChg>
  </pc:docChgLst>
  <pc:docChgLst>
    <pc:chgData name="Hayk Barseghyan" userId="1af3c995-31f7-415e-9aa1-2b36900e994d" providerId="ADAL" clId="{C214967E-4090-4F63-9953-DF63951EA817}"/>
    <pc:docChg chg="undo redo custSel addSld delSld modSld sldOrd">
      <pc:chgData name="Hayk Barseghyan" userId="1af3c995-31f7-415e-9aa1-2b36900e994d" providerId="ADAL" clId="{C214967E-4090-4F63-9953-DF63951EA817}" dt="2021-03-12T23:22:53.433" v="460" actId="478"/>
      <pc:docMkLst>
        <pc:docMk/>
      </pc:docMkLst>
      <pc:sldChg chg="addSp delSp modSp del mod modNotesTx">
        <pc:chgData name="Hayk Barseghyan" userId="1af3c995-31f7-415e-9aa1-2b36900e994d" providerId="ADAL" clId="{C214967E-4090-4F63-9953-DF63951EA817}" dt="2021-03-12T22:27:34.944" v="228" actId="47"/>
        <pc:sldMkLst>
          <pc:docMk/>
          <pc:sldMk cId="524483127" sldId="651"/>
        </pc:sldMkLst>
        <pc:spChg chg="mod">
          <ac:chgData name="Hayk Barseghyan" userId="1af3c995-31f7-415e-9aa1-2b36900e994d" providerId="ADAL" clId="{C214967E-4090-4F63-9953-DF63951EA817}" dt="2021-03-12T22:16:46.511" v="161" actId="20577"/>
          <ac:spMkLst>
            <pc:docMk/>
            <pc:sldMk cId="524483127" sldId="651"/>
            <ac:spMk id="28" creationId="{627423C8-B194-4935-85FA-5ED8C3D13EA3}"/>
          </ac:spMkLst>
        </pc:spChg>
        <pc:spChg chg="del">
          <ac:chgData name="Hayk Barseghyan" userId="1af3c995-31f7-415e-9aa1-2b36900e994d" providerId="ADAL" clId="{C214967E-4090-4F63-9953-DF63951EA817}" dt="2021-03-12T22:15:15.320" v="134" actId="478"/>
          <ac:spMkLst>
            <pc:docMk/>
            <pc:sldMk cId="524483127" sldId="651"/>
            <ac:spMk id="32" creationId="{3C8C9310-67BF-4B6E-89F4-3CEC1EC49D05}"/>
          </ac:spMkLst>
        </pc:spChg>
        <pc:spChg chg="mod">
          <ac:chgData name="Hayk Barseghyan" userId="1af3c995-31f7-415e-9aa1-2b36900e994d" providerId="ADAL" clId="{C214967E-4090-4F63-9953-DF63951EA817}" dt="2021-03-12T22:14:44.643" v="127" actId="1076"/>
          <ac:spMkLst>
            <pc:docMk/>
            <pc:sldMk cId="524483127" sldId="651"/>
            <ac:spMk id="44" creationId="{732812E5-D6B9-4FEF-975D-E2E3D93D0E47}"/>
          </ac:spMkLst>
        </pc:spChg>
        <pc:spChg chg="mod">
          <ac:chgData name="Hayk Barseghyan" userId="1af3c995-31f7-415e-9aa1-2b36900e994d" providerId="ADAL" clId="{C214967E-4090-4F63-9953-DF63951EA817}" dt="2021-03-12T22:14:44.643" v="127" actId="1076"/>
          <ac:spMkLst>
            <pc:docMk/>
            <pc:sldMk cId="524483127" sldId="651"/>
            <ac:spMk id="45" creationId="{706B5154-0B8D-4A97-9481-9F43337FAC30}"/>
          </ac:spMkLst>
        </pc:spChg>
        <pc:spChg chg="mod">
          <ac:chgData name="Hayk Barseghyan" userId="1af3c995-31f7-415e-9aa1-2b36900e994d" providerId="ADAL" clId="{C214967E-4090-4F63-9953-DF63951EA817}" dt="2021-03-12T22:09:56.150" v="24" actId="14100"/>
          <ac:spMkLst>
            <pc:docMk/>
            <pc:sldMk cId="524483127" sldId="651"/>
            <ac:spMk id="48" creationId="{7DECEAD3-1F4B-4349-B3E1-EC2281C752C7}"/>
          </ac:spMkLst>
        </pc:spChg>
        <pc:spChg chg="del">
          <ac:chgData name="Hayk Barseghyan" userId="1af3c995-31f7-415e-9aa1-2b36900e994d" providerId="ADAL" clId="{C214967E-4090-4F63-9953-DF63951EA817}" dt="2021-03-12T22:10:06.267" v="26" actId="478"/>
          <ac:spMkLst>
            <pc:docMk/>
            <pc:sldMk cId="524483127" sldId="651"/>
            <ac:spMk id="55" creationId="{9AD5CECB-0BA9-4EBD-8AE8-0307D147913B}"/>
          </ac:spMkLst>
        </pc:spChg>
        <pc:spChg chg="del">
          <ac:chgData name="Hayk Barseghyan" userId="1af3c995-31f7-415e-9aa1-2b36900e994d" providerId="ADAL" clId="{C214967E-4090-4F63-9953-DF63951EA817}" dt="2021-03-12T22:10:11.847" v="30" actId="478"/>
          <ac:spMkLst>
            <pc:docMk/>
            <pc:sldMk cId="524483127" sldId="651"/>
            <ac:spMk id="58" creationId="{002B4B61-AB6E-4E11-8801-11D8ACFF1C22}"/>
          </ac:spMkLst>
        </pc:spChg>
        <pc:spChg chg="del">
          <ac:chgData name="Hayk Barseghyan" userId="1af3c995-31f7-415e-9aa1-2b36900e994d" providerId="ADAL" clId="{C214967E-4090-4F63-9953-DF63951EA817}" dt="2021-03-12T22:10:11.847" v="30" actId="478"/>
          <ac:spMkLst>
            <pc:docMk/>
            <pc:sldMk cId="524483127" sldId="651"/>
            <ac:spMk id="59" creationId="{81B4F53B-4971-47E2-A09B-A1DE6AA56811}"/>
          </ac:spMkLst>
        </pc:spChg>
        <pc:spChg chg="del">
          <ac:chgData name="Hayk Barseghyan" userId="1af3c995-31f7-415e-9aa1-2b36900e994d" providerId="ADAL" clId="{C214967E-4090-4F63-9953-DF63951EA817}" dt="2021-03-12T22:10:11.098" v="29" actId="478"/>
          <ac:spMkLst>
            <pc:docMk/>
            <pc:sldMk cId="524483127" sldId="651"/>
            <ac:spMk id="60" creationId="{1A525A27-DC8A-4BFA-8660-F4F75A534028}"/>
          </ac:spMkLst>
        </pc:spChg>
        <pc:spChg chg="del">
          <ac:chgData name="Hayk Barseghyan" userId="1af3c995-31f7-415e-9aa1-2b36900e994d" providerId="ADAL" clId="{C214967E-4090-4F63-9953-DF63951EA817}" dt="2021-03-12T22:15:09.010" v="133" actId="478"/>
          <ac:spMkLst>
            <pc:docMk/>
            <pc:sldMk cId="524483127" sldId="651"/>
            <ac:spMk id="68" creationId="{BFE438C0-9CDB-450A-9900-696FFB97E024}"/>
          </ac:spMkLst>
        </pc:spChg>
        <pc:spChg chg="del">
          <ac:chgData name="Hayk Barseghyan" userId="1af3c995-31f7-415e-9aa1-2b36900e994d" providerId="ADAL" clId="{C214967E-4090-4F63-9953-DF63951EA817}" dt="2021-03-12T22:15:09.010" v="133" actId="478"/>
          <ac:spMkLst>
            <pc:docMk/>
            <pc:sldMk cId="524483127" sldId="651"/>
            <ac:spMk id="69" creationId="{F076E557-D021-4E27-8E35-A6C953574CA2}"/>
          </ac:spMkLst>
        </pc:spChg>
        <pc:spChg chg="del">
          <ac:chgData name="Hayk Barseghyan" userId="1af3c995-31f7-415e-9aa1-2b36900e994d" providerId="ADAL" clId="{C214967E-4090-4F63-9953-DF63951EA817}" dt="2021-03-12T22:15:09.010" v="133" actId="478"/>
          <ac:spMkLst>
            <pc:docMk/>
            <pc:sldMk cId="524483127" sldId="651"/>
            <ac:spMk id="70" creationId="{71869405-F198-4778-BB55-85845ED07D4B}"/>
          </ac:spMkLst>
        </pc:spChg>
        <pc:spChg chg="del">
          <ac:chgData name="Hayk Barseghyan" userId="1af3c995-31f7-415e-9aa1-2b36900e994d" providerId="ADAL" clId="{C214967E-4090-4F63-9953-DF63951EA817}" dt="2021-03-12T22:15:09.010" v="133" actId="478"/>
          <ac:spMkLst>
            <pc:docMk/>
            <pc:sldMk cId="524483127" sldId="651"/>
            <ac:spMk id="71" creationId="{B4ED1561-7983-4F59-A4B7-657095020BBE}"/>
          </ac:spMkLst>
        </pc:spChg>
        <pc:spChg chg="del">
          <ac:chgData name="Hayk Barseghyan" userId="1af3c995-31f7-415e-9aa1-2b36900e994d" providerId="ADAL" clId="{C214967E-4090-4F63-9953-DF63951EA817}" dt="2021-03-12T22:15:09.010" v="133" actId="478"/>
          <ac:spMkLst>
            <pc:docMk/>
            <pc:sldMk cId="524483127" sldId="651"/>
            <ac:spMk id="72" creationId="{ADB5E731-8580-40D2-8E74-9E9B610A7035}"/>
          </ac:spMkLst>
        </pc:spChg>
        <pc:spChg chg="add del mod">
          <ac:chgData name="Hayk Barseghyan" userId="1af3c995-31f7-415e-9aa1-2b36900e994d" providerId="ADAL" clId="{C214967E-4090-4F63-9953-DF63951EA817}" dt="2021-03-12T22:25:19.632" v="201"/>
          <ac:spMkLst>
            <pc:docMk/>
            <pc:sldMk cId="524483127" sldId="651"/>
            <ac:spMk id="74" creationId="{7EADE750-1286-4321-98FE-F9EBF469F0E5}"/>
          </ac:spMkLst>
        </pc:spChg>
        <pc:spChg chg="add del mod">
          <ac:chgData name="Hayk Barseghyan" userId="1af3c995-31f7-415e-9aa1-2b36900e994d" providerId="ADAL" clId="{C214967E-4090-4F63-9953-DF63951EA817}" dt="2021-03-12T22:25:19.632" v="201"/>
          <ac:spMkLst>
            <pc:docMk/>
            <pc:sldMk cId="524483127" sldId="651"/>
            <ac:spMk id="75" creationId="{9B0BC4B5-3C0E-45D4-99C2-FA24E354D16E}"/>
          </ac:spMkLst>
        </pc:spChg>
        <pc:spChg chg="add del mod">
          <ac:chgData name="Hayk Barseghyan" userId="1af3c995-31f7-415e-9aa1-2b36900e994d" providerId="ADAL" clId="{C214967E-4090-4F63-9953-DF63951EA817}" dt="2021-03-12T22:25:19.632" v="201"/>
          <ac:spMkLst>
            <pc:docMk/>
            <pc:sldMk cId="524483127" sldId="651"/>
            <ac:spMk id="76" creationId="{73D5882E-5CDE-45A4-881F-3297A6313760}"/>
          </ac:spMkLst>
        </pc:spChg>
        <pc:spChg chg="mod">
          <ac:chgData name="Hayk Barseghyan" userId="1af3c995-31f7-415e-9aa1-2b36900e994d" providerId="ADAL" clId="{C214967E-4090-4F63-9953-DF63951EA817}" dt="2021-03-12T22:14:44.643" v="127" actId="1076"/>
          <ac:spMkLst>
            <pc:docMk/>
            <pc:sldMk cId="524483127" sldId="651"/>
            <ac:spMk id="88" creationId="{7309DE7D-82B3-4F46-B078-58EBF40D4703}"/>
          </ac:spMkLst>
        </pc:spChg>
        <pc:spChg chg="mod">
          <ac:chgData name="Hayk Barseghyan" userId="1af3c995-31f7-415e-9aa1-2b36900e994d" providerId="ADAL" clId="{C214967E-4090-4F63-9953-DF63951EA817}" dt="2021-03-12T22:14:44.643" v="127" actId="1076"/>
          <ac:spMkLst>
            <pc:docMk/>
            <pc:sldMk cId="524483127" sldId="651"/>
            <ac:spMk id="93" creationId="{3EAC0E29-A0FD-42DD-8F3E-7B6BDF36A320}"/>
          </ac:spMkLst>
        </pc:spChg>
        <pc:spChg chg="mod">
          <ac:chgData name="Hayk Barseghyan" userId="1af3c995-31f7-415e-9aa1-2b36900e994d" providerId="ADAL" clId="{C214967E-4090-4F63-9953-DF63951EA817}" dt="2021-03-12T22:14:44.643" v="127" actId="1076"/>
          <ac:spMkLst>
            <pc:docMk/>
            <pc:sldMk cId="524483127" sldId="651"/>
            <ac:spMk id="94" creationId="{C3B2E742-FF55-4D80-8A82-03F353C11C9E}"/>
          </ac:spMkLst>
        </pc:spChg>
        <pc:picChg chg="del mod">
          <ac:chgData name="Hayk Barseghyan" userId="1af3c995-31f7-415e-9aa1-2b36900e994d" providerId="ADAL" clId="{C214967E-4090-4F63-9953-DF63951EA817}" dt="2021-03-12T22:07:57.488" v="5" actId="478"/>
          <ac:picMkLst>
            <pc:docMk/>
            <pc:sldMk cId="524483127" sldId="651"/>
            <ac:picMk id="3" creationId="{4349EB37-DBC2-4C1A-92F4-42F3EFE3046E}"/>
          </ac:picMkLst>
        </pc:picChg>
        <pc:picChg chg="add mod ord">
          <ac:chgData name="Hayk Barseghyan" userId="1af3c995-31f7-415e-9aa1-2b36900e994d" providerId="ADAL" clId="{C214967E-4090-4F63-9953-DF63951EA817}" dt="2021-03-12T22:09:41.519" v="19" actId="1076"/>
          <ac:picMkLst>
            <pc:docMk/>
            <pc:sldMk cId="524483127" sldId="651"/>
            <ac:picMk id="4" creationId="{6EE723D7-82C2-40C7-9EDF-695ABCFD2852}"/>
          </ac:picMkLst>
        </pc:picChg>
        <pc:picChg chg="add del mod ord">
          <ac:chgData name="Hayk Barseghyan" userId="1af3c995-31f7-415e-9aa1-2b36900e994d" providerId="ADAL" clId="{C214967E-4090-4F63-9953-DF63951EA817}" dt="2021-03-12T22:12:41.804" v="66" actId="478"/>
          <ac:picMkLst>
            <pc:docMk/>
            <pc:sldMk cId="524483127" sldId="651"/>
            <ac:picMk id="27" creationId="{766A0B26-AAE5-43BC-96AB-3ECACF53F93B}"/>
          </ac:picMkLst>
        </pc:picChg>
        <pc:picChg chg="add mod ord">
          <ac:chgData name="Hayk Barseghyan" userId="1af3c995-31f7-415e-9aa1-2b36900e994d" providerId="ADAL" clId="{C214967E-4090-4F63-9953-DF63951EA817}" dt="2021-03-12T22:14:44.643" v="127" actId="1076"/>
          <ac:picMkLst>
            <pc:docMk/>
            <pc:sldMk cId="524483127" sldId="651"/>
            <ac:picMk id="35" creationId="{347E1D22-E15C-425D-925B-99F60A60B955}"/>
          </ac:picMkLst>
        </pc:picChg>
        <pc:picChg chg="del">
          <ac:chgData name="Hayk Barseghyan" userId="1af3c995-31f7-415e-9aa1-2b36900e994d" providerId="ADAL" clId="{C214967E-4090-4F63-9953-DF63951EA817}" dt="2021-03-12T22:10:03.233" v="25" actId="478"/>
          <ac:picMkLst>
            <pc:docMk/>
            <pc:sldMk cId="524483127" sldId="651"/>
            <ac:picMk id="53" creationId="{464C3B69-E342-48F9-B03D-0B5F5F0ACE9C}"/>
          </ac:picMkLst>
        </pc:picChg>
        <pc:picChg chg="del">
          <ac:chgData name="Hayk Barseghyan" userId="1af3c995-31f7-415e-9aa1-2b36900e994d" providerId="ADAL" clId="{C214967E-4090-4F63-9953-DF63951EA817}" dt="2021-03-12T22:15:09.010" v="133" actId="478"/>
          <ac:picMkLst>
            <pc:docMk/>
            <pc:sldMk cId="524483127" sldId="651"/>
            <ac:picMk id="67" creationId="{E570B23F-ADB0-46BD-A2CC-C574B9BEF054}"/>
          </ac:picMkLst>
        </pc:picChg>
        <pc:picChg chg="del">
          <ac:chgData name="Hayk Barseghyan" userId="1af3c995-31f7-415e-9aa1-2b36900e994d" providerId="ADAL" clId="{C214967E-4090-4F63-9953-DF63951EA817}" dt="2021-03-12T22:10:16.170" v="31" actId="478"/>
          <ac:picMkLst>
            <pc:docMk/>
            <pc:sldMk cId="524483127" sldId="651"/>
            <ac:picMk id="87" creationId="{CB13D170-E4E8-47EE-A56B-B439A249975F}"/>
          </ac:picMkLst>
        </pc:picChg>
        <pc:cxnChg chg="mod">
          <ac:chgData name="Hayk Barseghyan" userId="1af3c995-31f7-415e-9aa1-2b36900e994d" providerId="ADAL" clId="{C214967E-4090-4F63-9953-DF63951EA817}" dt="2021-03-12T22:09:37.099" v="18" actId="14100"/>
          <ac:cxnSpMkLst>
            <pc:docMk/>
            <pc:sldMk cId="524483127" sldId="651"/>
            <ac:cxnSpMk id="25" creationId="{A4F48631-3605-414B-96A3-B4E7701F3903}"/>
          </ac:cxnSpMkLst>
        </pc:cxnChg>
        <pc:cxnChg chg="mod">
          <ac:chgData name="Hayk Barseghyan" userId="1af3c995-31f7-415e-9aa1-2b36900e994d" providerId="ADAL" clId="{C214967E-4090-4F63-9953-DF63951EA817}" dt="2021-03-12T22:15:05.085" v="132" actId="14100"/>
          <ac:cxnSpMkLst>
            <pc:docMk/>
            <pc:sldMk cId="524483127" sldId="651"/>
            <ac:cxnSpMk id="49" creationId="{4423681D-AADF-4D62-AC9E-3FDDF18E21B9}"/>
          </ac:cxnSpMkLst>
        </pc:cxnChg>
        <pc:cxnChg chg="mod">
          <ac:chgData name="Hayk Barseghyan" userId="1af3c995-31f7-415e-9aa1-2b36900e994d" providerId="ADAL" clId="{C214967E-4090-4F63-9953-DF63951EA817}" dt="2021-03-12T22:14:57.906" v="129" actId="14100"/>
          <ac:cxnSpMkLst>
            <pc:docMk/>
            <pc:sldMk cId="524483127" sldId="651"/>
            <ac:cxnSpMk id="52" creationId="{67E81840-D31A-48DD-9275-CD08F7D6F031}"/>
          </ac:cxnSpMkLst>
        </pc:cxnChg>
        <pc:cxnChg chg="del mod">
          <ac:chgData name="Hayk Barseghyan" userId="1af3c995-31f7-415e-9aa1-2b36900e994d" providerId="ADAL" clId="{C214967E-4090-4F63-9953-DF63951EA817}" dt="2021-03-12T22:10:09.310" v="28" actId="478"/>
          <ac:cxnSpMkLst>
            <pc:docMk/>
            <pc:sldMk cId="524483127" sldId="651"/>
            <ac:cxnSpMk id="64" creationId="{F274B9A3-4C67-4722-8732-C7A66953712F}"/>
          </ac:cxnSpMkLst>
        </pc:cxnChg>
        <pc:cxnChg chg="del mod">
          <ac:chgData name="Hayk Barseghyan" userId="1af3c995-31f7-415e-9aa1-2b36900e994d" providerId="ADAL" clId="{C214967E-4090-4F63-9953-DF63951EA817}" dt="2021-03-12T22:10:08.186" v="27" actId="478"/>
          <ac:cxnSpMkLst>
            <pc:docMk/>
            <pc:sldMk cId="524483127" sldId="651"/>
            <ac:cxnSpMk id="65" creationId="{D98E99A8-FFAE-4851-A23C-C378F77B6F31}"/>
          </ac:cxnSpMkLst>
        </pc:cxnChg>
        <pc:cxnChg chg="del">
          <ac:chgData name="Hayk Barseghyan" userId="1af3c995-31f7-415e-9aa1-2b36900e994d" providerId="ADAL" clId="{C214967E-4090-4F63-9953-DF63951EA817}" dt="2021-03-12T22:15:09.010" v="133" actId="478"/>
          <ac:cxnSpMkLst>
            <pc:docMk/>
            <pc:sldMk cId="524483127" sldId="651"/>
            <ac:cxnSpMk id="73" creationId="{20C8AA2C-05C4-4361-83EB-053DFCFB4BD6}"/>
          </ac:cxnSpMkLst>
        </pc:cxnChg>
        <pc:cxnChg chg="mod">
          <ac:chgData name="Hayk Barseghyan" userId="1af3c995-31f7-415e-9aa1-2b36900e994d" providerId="ADAL" clId="{C214967E-4090-4F63-9953-DF63951EA817}" dt="2021-03-12T22:14:44.643" v="127" actId="1076"/>
          <ac:cxnSpMkLst>
            <pc:docMk/>
            <pc:sldMk cId="524483127" sldId="651"/>
            <ac:cxnSpMk id="95" creationId="{5EB10151-CF0F-4162-A03A-2FB4661DCBE8}"/>
          </ac:cxnSpMkLst>
        </pc:cxnChg>
      </pc:sldChg>
      <pc:sldChg chg="del">
        <pc:chgData name="Hayk Barseghyan" userId="1af3c995-31f7-415e-9aa1-2b36900e994d" providerId="ADAL" clId="{C214967E-4090-4F63-9953-DF63951EA817}" dt="2021-03-12T22:05:20.527" v="0" actId="47"/>
        <pc:sldMkLst>
          <pc:docMk/>
          <pc:sldMk cId="779035963" sldId="652"/>
        </pc:sldMkLst>
      </pc:sldChg>
      <pc:sldChg chg="addSp delSp modSp mod ord modNotesTx">
        <pc:chgData name="Hayk Barseghyan" userId="1af3c995-31f7-415e-9aa1-2b36900e994d" providerId="ADAL" clId="{C214967E-4090-4F63-9953-DF63951EA817}" dt="2021-03-12T23:16:56.101" v="451" actId="20577"/>
        <pc:sldMkLst>
          <pc:docMk/>
          <pc:sldMk cId="827945534" sldId="654"/>
        </pc:sldMkLst>
        <pc:spChg chg="del">
          <ac:chgData name="Hayk Barseghyan" userId="1af3c995-31f7-415e-9aa1-2b36900e994d" providerId="ADAL" clId="{C214967E-4090-4F63-9953-DF63951EA817}" dt="2021-03-12T22:16:06.255" v="153" actId="478"/>
          <ac:spMkLst>
            <pc:docMk/>
            <pc:sldMk cId="827945534" sldId="654"/>
            <ac:spMk id="29" creationId="{BF880D0C-7AA2-4DE0-BCB3-74F7E125FD7C}"/>
          </ac:spMkLst>
        </pc:spChg>
        <pc:spChg chg="del">
          <ac:chgData name="Hayk Barseghyan" userId="1af3c995-31f7-415e-9aa1-2b36900e994d" providerId="ADAL" clId="{C214967E-4090-4F63-9953-DF63951EA817}" dt="2021-03-12T22:16:18.137" v="155" actId="478"/>
          <ac:spMkLst>
            <pc:docMk/>
            <pc:sldMk cId="827945534" sldId="654"/>
            <ac:spMk id="48" creationId="{A5767109-BE3E-4EBA-BE34-EC7C3FC9B538}"/>
          </ac:spMkLst>
        </pc:spChg>
        <pc:spChg chg="add mod">
          <ac:chgData name="Hayk Barseghyan" userId="1af3c995-31f7-415e-9aa1-2b36900e994d" providerId="ADAL" clId="{C214967E-4090-4F63-9953-DF63951EA817}" dt="2021-03-12T22:17:05.168" v="164" actId="20577"/>
          <ac:spMkLst>
            <pc:docMk/>
            <pc:sldMk cId="827945534" sldId="654"/>
            <ac:spMk id="49" creationId="{270740F3-8276-4A91-AA98-A4A4273156A7}"/>
          </ac:spMkLst>
        </pc:spChg>
        <pc:spChg chg="del">
          <ac:chgData name="Hayk Barseghyan" userId="1af3c995-31f7-415e-9aa1-2b36900e994d" providerId="ADAL" clId="{C214967E-4090-4F63-9953-DF63951EA817}" dt="2021-03-12T22:16:02.915" v="152" actId="478"/>
          <ac:spMkLst>
            <pc:docMk/>
            <pc:sldMk cId="827945534" sldId="654"/>
            <ac:spMk id="52" creationId="{3C4CF752-D100-4648-B7BC-5DB3FB658991}"/>
          </ac:spMkLst>
        </pc:spChg>
        <pc:spChg chg="add del mod">
          <ac:chgData name="Hayk Barseghyan" userId="1af3c995-31f7-415e-9aa1-2b36900e994d" providerId="ADAL" clId="{C214967E-4090-4F63-9953-DF63951EA817}" dt="2021-03-12T22:25:32.391" v="203"/>
          <ac:spMkLst>
            <pc:docMk/>
            <pc:sldMk cId="827945534" sldId="654"/>
            <ac:spMk id="58" creationId="{FC6266D4-FA3B-46F7-892F-690309CE6F34}"/>
          </ac:spMkLst>
        </pc:spChg>
        <pc:spChg chg="add del mod">
          <ac:chgData name="Hayk Barseghyan" userId="1af3c995-31f7-415e-9aa1-2b36900e994d" providerId="ADAL" clId="{C214967E-4090-4F63-9953-DF63951EA817}" dt="2021-03-12T22:25:32.391" v="203"/>
          <ac:spMkLst>
            <pc:docMk/>
            <pc:sldMk cId="827945534" sldId="654"/>
            <ac:spMk id="59" creationId="{D1149067-B1B9-483F-B300-3A567F1B4437}"/>
          </ac:spMkLst>
        </pc:spChg>
        <pc:spChg chg="add del mod">
          <ac:chgData name="Hayk Barseghyan" userId="1af3c995-31f7-415e-9aa1-2b36900e994d" providerId="ADAL" clId="{C214967E-4090-4F63-9953-DF63951EA817}" dt="2021-03-12T22:25:32.391" v="203"/>
          <ac:spMkLst>
            <pc:docMk/>
            <pc:sldMk cId="827945534" sldId="654"/>
            <ac:spMk id="61" creationId="{2EBA3069-7C8B-486E-B15F-2518FD5778DF}"/>
          </ac:spMkLst>
        </pc:spChg>
        <pc:spChg chg="add mod">
          <ac:chgData name="Hayk Barseghyan" userId="1af3c995-31f7-415e-9aa1-2b36900e994d" providerId="ADAL" clId="{C214967E-4090-4F63-9953-DF63951EA817}" dt="2021-03-12T23:16:56.101" v="451" actId="20577"/>
          <ac:spMkLst>
            <pc:docMk/>
            <pc:sldMk cId="827945534" sldId="654"/>
            <ac:spMk id="62" creationId="{38EFEDEB-D3C1-4ECD-B1B8-22BD9481D192}"/>
          </ac:spMkLst>
        </pc:spChg>
        <pc:spChg chg="del">
          <ac:chgData name="Hayk Barseghyan" userId="1af3c995-31f7-415e-9aa1-2b36900e994d" providerId="ADAL" clId="{C214967E-4090-4F63-9953-DF63951EA817}" dt="2021-03-12T22:16:28.104" v="156" actId="478"/>
          <ac:spMkLst>
            <pc:docMk/>
            <pc:sldMk cId="827945534" sldId="654"/>
            <ac:spMk id="101" creationId="{C9248449-982F-4C60-8168-07A673D9C059}"/>
          </ac:spMkLst>
        </pc:spChg>
        <pc:spChg chg="del">
          <ac:chgData name="Hayk Barseghyan" userId="1af3c995-31f7-415e-9aa1-2b36900e994d" providerId="ADAL" clId="{C214967E-4090-4F63-9953-DF63951EA817}" dt="2021-03-12T22:16:06.255" v="153" actId="478"/>
          <ac:spMkLst>
            <pc:docMk/>
            <pc:sldMk cId="827945534" sldId="654"/>
            <ac:spMk id="107" creationId="{BC0792DA-1127-48FD-A582-05E47E97B134}"/>
          </ac:spMkLst>
        </pc:spChg>
        <pc:spChg chg="del">
          <ac:chgData name="Hayk Barseghyan" userId="1af3c995-31f7-415e-9aa1-2b36900e994d" providerId="ADAL" clId="{C214967E-4090-4F63-9953-DF63951EA817}" dt="2021-03-12T22:16:06.255" v="153" actId="478"/>
          <ac:spMkLst>
            <pc:docMk/>
            <pc:sldMk cId="827945534" sldId="654"/>
            <ac:spMk id="117" creationId="{AE5BBEBF-EB2C-498D-9B80-53D0F5A0D595}"/>
          </ac:spMkLst>
        </pc:spChg>
        <pc:grpChg chg="del">
          <ac:chgData name="Hayk Barseghyan" userId="1af3c995-31f7-415e-9aa1-2b36900e994d" providerId="ADAL" clId="{C214967E-4090-4F63-9953-DF63951EA817}" dt="2021-03-12T22:16:07.132" v="154" actId="478"/>
          <ac:grpSpMkLst>
            <pc:docMk/>
            <pc:sldMk cId="827945534" sldId="654"/>
            <ac:grpSpMk id="10" creationId="{F42BC947-A5E9-40A9-BBF3-A551526EBE7B}"/>
          </ac:grpSpMkLst>
        </pc:grpChg>
        <pc:grpChg chg="del">
          <ac:chgData name="Hayk Barseghyan" userId="1af3c995-31f7-415e-9aa1-2b36900e994d" providerId="ADAL" clId="{C214967E-4090-4F63-9953-DF63951EA817}" dt="2021-03-12T22:16:06.255" v="153" actId="478"/>
          <ac:grpSpMkLst>
            <pc:docMk/>
            <pc:sldMk cId="827945534" sldId="654"/>
            <ac:grpSpMk id="60" creationId="{4E313384-1C78-459B-BB63-90009F44FF76}"/>
          </ac:grpSpMkLst>
        </pc:grpChg>
        <pc:picChg chg="mod">
          <ac:chgData name="Hayk Barseghyan" userId="1af3c995-31f7-415e-9aa1-2b36900e994d" providerId="ADAL" clId="{C214967E-4090-4F63-9953-DF63951EA817}" dt="2021-03-12T22:36:40.535" v="276" actId="14100"/>
          <ac:picMkLst>
            <pc:docMk/>
            <pc:sldMk cId="827945534" sldId="654"/>
            <ac:picMk id="3" creationId="{8D3A5F37-3DE6-4371-B224-FA7A789D2484}"/>
          </ac:picMkLst>
        </pc:picChg>
        <pc:picChg chg="del">
          <ac:chgData name="Hayk Barseghyan" userId="1af3c995-31f7-415e-9aa1-2b36900e994d" providerId="ADAL" clId="{C214967E-4090-4F63-9953-DF63951EA817}" dt="2021-03-12T22:16:06.255" v="153" actId="478"/>
          <ac:picMkLst>
            <pc:docMk/>
            <pc:sldMk cId="827945534" sldId="654"/>
            <ac:picMk id="22" creationId="{7E5880E1-FE4E-4149-9D74-A8668402A859}"/>
          </ac:picMkLst>
        </pc:picChg>
        <pc:cxnChg chg="del mod">
          <ac:chgData name="Hayk Barseghyan" userId="1af3c995-31f7-415e-9aa1-2b36900e994d" providerId="ADAL" clId="{C214967E-4090-4F63-9953-DF63951EA817}" dt="2021-03-12T22:16:06.255" v="153" actId="478"/>
          <ac:cxnSpMkLst>
            <pc:docMk/>
            <pc:sldMk cId="827945534" sldId="654"/>
            <ac:cxnSpMk id="12" creationId="{77BFB2D3-AD99-4A46-A69B-5F7DA3AE9F40}"/>
          </ac:cxnSpMkLst>
        </pc:cxnChg>
      </pc:sldChg>
      <pc:sldChg chg="addSp delSp modSp add mod ord modNotesTx">
        <pc:chgData name="Hayk Barseghyan" userId="1af3c995-31f7-415e-9aa1-2b36900e994d" providerId="ADAL" clId="{C214967E-4090-4F63-9953-DF63951EA817}" dt="2021-03-12T23:12:41.382" v="428" actId="20577"/>
        <pc:sldMkLst>
          <pc:docMk/>
          <pc:sldMk cId="1879609064" sldId="655"/>
        </pc:sldMkLst>
        <pc:spChg chg="del mod">
          <ac:chgData name="Hayk Barseghyan" userId="1af3c995-31f7-415e-9aa1-2b36900e994d" providerId="ADAL" clId="{C214967E-4090-4F63-9953-DF63951EA817}" dt="2021-03-12T22:17:14.080" v="166" actId="478"/>
          <ac:spMkLst>
            <pc:docMk/>
            <pc:sldMk cId="1879609064" sldId="655"/>
            <ac:spMk id="31" creationId="{831FD28B-6273-4CCE-B35E-843034652E14}"/>
          </ac:spMkLst>
        </pc:spChg>
        <pc:spChg chg="add del mod">
          <ac:chgData name="Hayk Barseghyan" userId="1af3c995-31f7-415e-9aa1-2b36900e994d" providerId="ADAL" clId="{C214967E-4090-4F63-9953-DF63951EA817}" dt="2021-03-12T22:17:29.547" v="168" actId="478"/>
          <ac:spMkLst>
            <pc:docMk/>
            <pc:sldMk cId="1879609064" sldId="655"/>
            <ac:spMk id="32" creationId="{6938367C-4FFE-402F-AA8F-3AFCDF46E48A}"/>
          </ac:spMkLst>
        </pc:spChg>
        <pc:spChg chg="add mod">
          <ac:chgData name="Hayk Barseghyan" userId="1af3c995-31f7-415e-9aa1-2b36900e994d" providerId="ADAL" clId="{C214967E-4090-4F63-9953-DF63951EA817}" dt="2021-03-12T22:17:26.220" v="167"/>
          <ac:spMkLst>
            <pc:docMk/>
            <pc:sldMk cId="1879609064" sldId="655"/>
            <ac:spMk id="33" creationId="{27D04DB1-6D7F-4335-AAA1-99D44F3F14E9}"/>
          </ac:spMkLst>
        </pc:spChg>
        <pc:spChg chg="mod">
          <ac:chgData name="Hayk Barseghyan" userId="1af3c995-31f7-415e-9aa1-2b36900e994d" providerId="ADAL" clId="{C214967E-4090-4F63-9953-DF63951EA817}" dt="2021-03-12T23:12:41.382" v="428" actId="20577"/>
          <ac:spMkLst>
            <pc:docMk/>
            <pc:sldMk cId="1879609064" sldId="655"/>
            <ac:spMk id="98" creationId="{CC1A3F83-E94B-4F3C-9D62-2C0B7D404690}"/>
          </ac:spMkLst>
        </pc:spChg>
        <pc:picChg chg="add del mod">
          <ac:chgData name="Hayk Barseghyan" userId="1af3c995-31f7-415e-9aa1-2b36900e994d" providerId="ADAL" clId="{C214967E-4090-4F63-9953-DF63951EA817}" dt="2021-03-12T22:21:51.995" v="174" actId="478"/>
          <ac:picMkLst>
            <pc:docMk/>
            <pc:sldMk cId="1879609064" sldId="655"/>
            <ac:picMk id="3" creationId="{E4A513D3-DCB6-491E-8286-C3322A9BC810}"/>
          </ac:picMkLst>
        </pc:picChg>
      </pc:sldChg>
      <pc:sldChg chg="addSp delSp modSp add mod modNotesTx">
        <pc:chgData name="Hayk Barseghyan" userId="1af3c995-31f7-415e-9aa1-2b36900e994d" providerId="ADAL" clId="{C214967E-4090-4F63-9953-DF63951EA817}" dt="2021-03-12T22:29:43.074" v="251" actId="1076"/>
        <pc:sldMkLst>
          <pc:docMk/>
          <pc:sldMk cId="742313956" sldId="656"/>
        </pc:sldMkLst>
        <pc:spChg chg="del">
          <ac:chgData name="Hayk Barseghyan" userId="1af3c995-31f7-415e-9aa1-2b36900e994d" providerId="ADAL" clId="{C214967E-4090-4F63-9953-DF63951EA817}" dt="2021-03-12T22:24:20.593" v="198" actId="478"/>
          <ac:spMkLst>
            <pc:docMk/>
            <pc:sldMk cId="742313956" sldId="656"/>
            <ac:spMk id="28" creationId="{627423C8-B194-4935-85FA-5ED8C3D13EA3}"/>
          </ac:spMkLst>
        </pc:spChg>
        <pc:spChg chg="add mod">
          <ac:chgData name="Hayk Barseghyan" userId="1af3c995-31f7-415e-9aa1-2b36900e994d" providerId="ADAL" clId="{C214967E-4090-4F63-9953-DF63951EA817}" dt="2021-03-12T22:23:12.549" v="187" actId="1076"/>
          <ac:spMkLst>
            <pc:docMk/>
            <pc:sldMk cId="742313956" sldId="656"/>
            <ac:spMk id="32" creationId="{C8EED87A-0AE7-41CB-B85F-5690D93EF3E6}"/>
          </ac:spMkLst>
        </pc:spChg>
        <pc:spChg chg="add mod">
          <ac:chgData name="Hayk Barseghyan" userId="1af3c995-31f7-415e-9aa1-2b36900e994d" providerId="ADAL" clId="{C214967E-4090-4F63-9953-DF63951EA817}" dt="2021-03-12T22:26:35.396" v="209" actId="1076"/>
          <ac:spMkLst>
            <pc:docMk/>
            <pc:sldMk cId="742313956" sldId="656"/>
            <ac:spMk id="37" creationId="{46E22F1A-4B6B-4497-A10E-1133F9386895}"/>
          </ac:spMkLst>
        </pc:spChg>
        <pc:spChg chg="add mod">
          <ac:chgData name="Hayk Barseghyan" userId="1af3c995-31f7-415e-9aa1-2b36900e994d" providerId="ADAL" clId="{C214967E-4090-4F63-9953-DF63951EA817}" dt="2021-03-12T22:29:31.857" v="249" actId="20577"/>
          <ac:spMkLst>
            <pc:docMk/>
            <pc:sldMk cId="742313956" sldId="656"/>
            <ac:spMk id="40" creationId="{03C35834-9994-4DBC-A8F8-7F81D9308BC6}"/>
          </ac:spMkLst>
        </pc:spChg>
        <pc:spChg chg="add mod">
          <ac:chgData name="Hayk Barseghyan" userId="1af3c995-31f7-415e-9aa1-2b36900e994d" providerId="ADAL" clId="{C214967E-4090-4F63-9953-DF63951EA817}" dt="2021-03-12T22:29:43.074" v="251" actId="1076"/>
          <ac:spMkLst>
            <pc:docMk/>
            <pc:sldMk cId="742313956" sldId="656"/>
            <ac:spMk id="41" creationId="{77AA0295-E04C-47D7-9AD2-E60A3E1CF6E9}"/>
          </ac:spMkLst>
        </pc:spChg>
        <pc:spChg chg="add del mod">
          <ac:chgData name="Hayk Barseghyan" userId="1af3c995-31f7-415e-9aa1-2b36900e994d" providerId="ADAL" clId="{C214967E-4090-4F63-9953-DF63951EA817}" dt="2021-03-12T22:29:37.280" v="250" actId="478"/>
          <ac:spMkLst>
            <pc:docMk/>
            <pc:sldMk cId="742313956" sldId="656"/>
            <ac:spMk id="42" creationId="{D6CCB0B5-9F1C-4760-90C8-4196C57AF785}"/>
          </ac:spMkLst>
        </pc:spChg>
        <pc:spChg chg="mod">
          <ac:chgData name="Hayk Barseghyan" userId="1af3c995-31f7-415e-9aa1-2b36900e994d" providerId="ADAL" clId="{C214967E-4090-4F63-9953-DF63951EA817}" dt="2021-03-12T22:26:54.084" v="211" actId="20577"/>
          <ac:spMkLst>
            <pc:docMk/>
            <pc:sldMk cId="742313956" sldId="656"/>
            <ac:spMk id="49" creationId="{270740F3-8276-4A91-AA98-A4A4273156A7}"/>
          </ac:spMkLst>
        </pc:spChg>
        <pc:spChg chg="del">
          <ac:chgData name="Hayk Barseghyan" userId="1af3c995-31f7-415e-9aa1-2b36900e994d" providerId="ADAL" clId="{C214967E-4090-4F63-9953-DF63951EA817}" dt="2021-03-12T22:23:47.728" v="192" actId="478"/>
          <ac:spMkLst>
            <pc:docMk/>
            <pc:sldMk cId="742313956" sldId="656"/>
            <ac:spMk id="55" creationId="{07D69AF5-89C5-4D08-90B5-12B866765EE3}"/>
          </ac:spMkLst>
        </pc:spChg>
        <pc:spChg chg="del">
          <ac:chgData name="Hayk Barseghyan" userId="1af3c995-31f7-415e-9aa1-2b36900e994d" providerId="ADAL" clId="{C214967E-4090-4F63-9953-DF63951EA817}" dt="2021-03-12T22:26:17.981" v="205" actId="478"/>
          <ac:spMkLst>
            <pc:docMk/>
            <pc:sldMk cId="742313956" sldId="656"/>
            <ac:spMk id="69" creationId="{E1E5F7CF-BD53-4D18-9581-71C86B5CC80B}"/>
          </ac:spMkLst>
        </pc:spChg>
        <pc:spChg chg="del topLvl">
          <ac:chgData name="Hayk Barseghyan" userId="1af3c995-31f7-415e-9aa1-2b36900e994d" providerId="ADAL" clId="{C214967E-4090-4F63-9953-DF63951EA817}" dt="2021-03-12T22:26:20.380" v="206" actId="478"/>
          <ac:spMkLst>
            <pc:docMk/>
            <pc:sldMk cId="742313956" sldId="656"/>
            <ac:spMk id="70" creationId="{C130D79F-13B5-4C92-B80F-4EB8B3100D47}"/>
          </ac:spMkLst>
        </pc:spChg>
        <pc:spChg chg="mod topLvl">
          <ac:chgData name="Hayk Barseghyan" userId="1af3c995-31f7-415e-9aa1-2b36900e994d" providerId="ADAL" clId="{C214967E-4090-4F63-9953-DF63951EA817}" dt="2021-03-12T22:26:26.130" v="207" actId="1076"/>
          <ac:spMkLst>
            <pc:docMk/>
            <pc:sldMk cId="742313956" sldId="656"/>
            <ac:spMk id="76" creationId="{1C554B34-C002-4DB1-8784-4B391E209899}"/>
          </ac:spMkLst>
        </pc:spChg>
        <pc:spChg chg="del">
          <ac:chgData name="Hayk Barseghyan" userId="1af3c995-31f7-415e-9aa1-2b36900e994d" providerId="ADAL" clId="{C214967E-4090-4F63-9953-DF63951EA817}" dt="2021-03-12T22:28:30.389" v="233" actId="478"/>
          <ac:spMkLst>
            <pc:docMk/>
            <pc:sldMk cId="742313956" sldId="656"/>
            <ac:spMk id="86" creationId="{88884125-F75C-4D8B-80D0-8186E9D62A91}"/>
          </ac:spMkLst>
        </pc:spChg>
        <pc:spChg chg="del">
          <ac:chgData name="Hayk Barseghyan" userId="1af3c995-31f7-415e-9aa1-2b36900e994d" providerId="ADAL" clId="{C214967E-4090-4F63-9953-DF63951EA817}" dt="2021-03-12T22:28:28.469" v="232" actId="478"/>
          <ac:spMkLst>
            <pc:docMk/>
            <pc:sldMk cId="742313956" sldId="656"/>
            <ac:spMk id="89" creationId="{73E0F48C-F069-413E-8BDC-0DEC675D822E}"/>
          </ac:spMkLst>
        </pc:spChg>
        <pc:spChg chg="mod topLvl">
          <ac:chgData name="Hayk Barseghyan" userId="1af3c995-31f7-415e-9aa1-2b36900e994d" providerId="ADAL" clId="{C214967E-4090-4F63-9953-DF63951EA817}" dt="2021-03-12T22:28:57.478" v="243" actId="14100"/>
          <ac:spMkLst>
            <pc:docMk/>
            <pc:sldMk cId="742313956" sldId="656"/>
            <ac:spMk id="90" creationId="{413DD0F0-9162-4A06-A57F-A2B4EFE8B4A8}"/>
          </ac:spMkLst>
        </pc:spChg>
        <pc:spChg chg="del mod topLvl">
          <ac:chgData name="Hayk Barseghyan" userId="1af3c995-31f7-415e-9aa1-2b36900e994d" providerId="ADAL" clId="{C214967E-4090-4F63-9953-DF63951EA817}" dt="2021-03-12T22:28:48.694" v="239" actId="478"/>
          <ac:spMkLst>
            <pc:docMk/>
            <pc:sldMk cId="742313956" sldId="656"/>
            <ac:spMk id="92" creationId="{A7923036-41CC-45E7-87FE-8526B7B8123C}"/>
          </ac:spMkLst>
        </pc:spChg>
        <pc:spChg chg="del">
          <ac:chgData name="Hayk Barseghyan" userId="1af3c995-31f7-415e-9aa1-2b36900e994d" providerId="ADAL" clId="{C214967E-4090-4F63-9953-DF63951EA817}" dt="2021-03-12T22:28:35.467" v="235" actId="478"/>
          <ac:spMkLst>
            <pc:docMk/>
            <pc:sldMk cId="742313956" sldId="656"/>
            <ac:spMk id="93" creationId="{2002BCC4-A7D6-4550-844A-2D78A9481393}"/>
          </ac:spMkLst>
        </pc:spChg>
        <pc:spChg chg="del mod">
          <ac:chgData name="Hayk Barseghyan" userId="1af3c995-31f7-415e-9aa1-2b36900e994d" providerId="ADAL" clId="{C214967E-4090-4F63-9953-DF63951EA817}" dt="2021-03-12T22:23:15.024" v="188" actId="478"/>
          <ac:spMkLst>
            <pc:docMk/>
            <pc:sldMk cId="742313956" sldId="656"/>
            <ac:spMk id="118" creationId="{066264C0-0B22-4722-A2BA-8C702062244E}"/>
          </ac:spMkLst>
        </pc:spChg>
        <pc:grpChg chg="del">
          <ac:chgData name="Hayk Barseghyan" userId="1af3c995-31f7-415e-9aa1-2b36900e994d" providerId="ADAL" clId="{C214967E-4090-4F63-9953-DF63951EA817}" dt="2021-03-12T22:26:20.380" v="206" actId="478"/>
          <ac:grpSpMkLst>
            <pc:docMk/>
            <pc:sldMk cId="742313956" sldId="656"/>
            <ac:grpSpMk id="63" creationId="{EF2C7A10-0284-41A0-BC17-809962B03E09}"/>
          </ac:grpSpMkLst>
        </pc:grpChg>
        <pc:grpChg chg="add del mod">
          <ac:chgData name="Hayk Barseghyan" userId="1af3c995-31f7-415e-9aa1-2b36900e994d" providerId="ADAL" clId="{C214967E-4090-4F63-9953-DF63951EA817}" dt="2021-03-12T22:28:46.006" v="238" actId="165"/>
          <ac:grpSpMkLst>
            <pc:docMk/>
            <pc:sldMk cId="742313956" sldId="656"/>
            <ac:grpSpMk id="77" creationId="{44803872-5E86-449C-8096-E1A8CF55BF75}"/>
          </ac:grpSpMkLst>
        </pc:grpChg>
        <pc:grpChg chg="del">
          <ac:chgData name="Hayk Barseghyan" userId="1af3c995-31f7-415e-9aa1-2b36900e994d" providerId="ADAL" clId="{C214967E-4090-4F63-9953-DF63951EA817}" dt="2021-03-12T22:26:15.831" v="204" actId="478"/>
          <ac:grpSpMkLst>
            <pc:docMk/>
            <pc:sldMk cId="742313956" sldId="656"/>
            <ac:grpSpMk id="103" creationId="{6092B2D2-FD47-4DE2-B1C8-277AEE662DB1}"/>
          </ac:grpSpMkLst>
        </pc:grpChg>
        <pc:picChg chg="del">
          <ac:chgData name="Hayk Barseghyan" userId="1af3c995-31f7-415e-9aa1-2b36900e994d" providerId="ADAL" clId="{C214967E-4090-4F63-9953-DF63951EA817}" dt="2021-03-12T22:21:55.176" v="175" actId="478"/>
          <ac:picMkLst>
            <pc:docMk/>
            <pc:sldMk cId="742313956" sldId="656"/>
            <ac:picMk id="3" creationId="{8D3A5F37-3DE6-4371-B224-FA7A789D2484}"/>
          </ac:picMkLst>
        </pc:picChg>
        <pc:picChg chg="add mod">
          <ac:chgData name="Hayk Barseghyan" userId="1af3c995-31f7-415e-9aa1-2b36900e994d" providerId="ADAL" clId="{C214967E-4090-4F63-9953-DF63951EA817}" dt="2021-03-12T22:29:03.388" v="245" actId="14100"/>
          <ac:picMkLst>
            <pc:docMk/>
            <pc:sldMk cId="742313956" sldId="656"/>
            <ac:picMk id="8" creationId="{2025D8F4-DB00-4692-A85A-11644A3ECBF3}"/>
          </ac:picMkLst>
        </pc:picChg>
        <pc:picChg chg="del mod">
          <ac:chgData name="Hayk Barseghyan" userId="1af3c995-31f7-415e-9aa1-2b36900e994d" providerId="ADAL" clId="{C214967E-4090-4F63-9953-DF63951EA817}" dt="2021-03-12T22:24:22.686" v="199" actId="478"/>
          <ac:picMkLst>
            <pc:docMk/>
            <pc:sldMk cId="742313956" sldId="656"/>
            <ac:picMk id="17" creationId="{1EDA1680-38DE-45AC-BAB3-51091D58A59D}"/>
          </ac:picMkLst>
        </pc:picChg>
        <pc:picChg chg="add mod ord">
          <ac:chgData name="Hayk Barseghyan" userId="1af3c995-31f7-415e-9aa1-2b36900e994d" providerId="ADAL" clId="{C214967E-4090-4F63-9953-DF63951EA817}" dt="2021-03-12T22:22:08.830" v="179" actId="1076"/>
          <ac:picMkLst>
            <pc:docMk/>
            <pc:sldMk cId="742313956" sldId="656"/>
            <ac:picMk id="31" creationId="{A423A7A3-37E0-495F-A41D-46390BECA406}"/>
          </ac:picMkLst>
        </pc:picChg>
        <pc:cxnChg chg="add mod">
          <ac:chgData name="Hayk Barseghyan" userId="1af3c995-31f7-415e-9aa1-2b36900e994d" providerId="ADAL" clId="{C214967E-4090-4F63-9953-DF63951EA817}" dt="2021-03-12T22:24:08.226" v="196" actId="14100"/>
          <ac:cxnSpMkLst>
            <pc:docMk/>
            <pc:sldMk cId="742313956" sldId="656"/>
            <ac:cxnSpMk id="33" creationId="{1B628404-82F4-4D74-879A-D2CAC769448A}"/>
          </ac:cxnSpMkLst>
        </pc:cxnChg>
        <pc:cxnChg chg="del mod">
          <ac:chgData name="Hayk Barseghyan" userId="1af3c995-31f7-415e-9aa1-2b36900e994d" providerId="ADAL" clId="{C214967E-4090-4F63-9953-DF63951EA817}" dt="2021-03-12T22:23:44.275" v="190" actId="478"/>
          <ac:cxnSpMkLst>
            <pc:docMk/>
            <pc:sldMk cId="742313956" sldId="656"/>
            <ac:cxnSpMk id="56" creationId="{3CFAB489-8807-4BA3-9020-3CC0451293AE}"/>
          </ac:cxnSpMkLst>
        </pc:cxnChg>
        <pc:cxnChg chg="del mod">
          <ac:chgData name="Hayk Barseghyan" userId="1af3c995-31f7-415e-9aa1-2b36900e994d" providerId="ADAL" clId="{C214967E-4090-4F63-9953-DF63951EA817}" dt="2021-03-12T22:23:45.809" v="191" actId="478"/>
          <ac:cxnSpMkLst>
            <pc:docMk/>
            <pc:sldMk cId="742313956" sldId="656"/>
            <ac:cxnSpMk id="57" creationId="{0D4ABBEE-13C4-463C-BDA1-4546744CB24F}"/>
          </ac:cxnSpMkLst>
        </pc:cxnChg>
        <pc:cxnChg chg="del mod topLvl">
          <ac:chgData name="Hayk Barseghyan" userId="1af3c995-31f7-415e-9aa1-2b36900e994d" providerId="ADAL" clId="{C214967E-4090-4F63-9953-DF63951EA817}" dt="2021-03-12T22:28:48.694" v="239" actId="478"/>
          <ac:cxnSpMkLst>
            <pc:docMk/>
            <pc:sldMk cId="742313956" sldId="656"/>
            <ac:cxnSpMk id="97" creationId="{BBD9632F-6DAC-454A-87ED-47C5408900EE}"/>
          </ac:cxnSpMkLst>
        </pc:cxnChg>
        <pc:cxnChg chg="del mod">
          <ac:chgData name="Hayk Barseghyan" userId="1af3c995-31f7-415e-9aa1-2b36900e994d" providerId="ADAL" clId="{C214967E-4090-4F63-9953-DF63951EA817}" dt="2021-03-12T22:28:32.045" v="234" actId="478"/>
          <ac:cxnSpMkLst>
            <pc:docMk/>
            <pc:sldMk cId="742313956" sldId="656"/>
            <ac:cxnSpMk id="102" creationId="{C68D6FCC-99EA-4905-840B-A0BEF455C074}"/>
          </ac:cxnSpMkLst>
        </pc:cxnChg>
      </pc:sldChg>
      <pc:sldChg chg="del">
        <pc:chgData name="Hayk Barseghyan" userId="1af3c995-31f7-415e-9aa1-2b36900e994d" providerId="ADAL" clId="{C214967E-4090-4F63-9953-DF63951EA817}" dt="2021-03-12T22:05:28.260" v="3" actId="47"/>
        <pc:sldMkLst>
          <pc:docMk/>
          <pc:sldMk cId="2358330284" sldId="656"/>
        </pc:sldMkLst>
      </pc:sldChg>
      <pc:sldChg chg="addSp delSp modSp add mod modNotesTx">
        <pc:chgData name="Hayk Barseghyan" userId="1af3c995-31f7-415e-9aa1-2b36900e994d" providerId="ADAL" clId="{C214967E-4090-4F63-9953-DF63951EA817}" dt="2021-03-12T22:55:41.292" v="413" actId="1035"/>
        <pc:sldMkLst>
          <pc:docMk/>
          <pc:sldMk cId="2755479697" sldId="657"/>
        </pc:sldMkLst>
        <pc:spChg chg="mod">
          <ac:chgData name="Hayk Barseghyan" userId="1af3c995-31f7-415e-9aa1-2b36900e994d" providerId="ADAL" clId="{C214967E-4090-4F63-9953-DF63951EA817}" dt="2021-03-12T22:37:19.629" v="280"/>
          <ac:spMkLst>
            <pc:docMk/>
            <pc:sldMk cId="2755479697" sldId="657"/>
            <ac:spMk id="37" creationId="{ADC3A6C0-9673-44B5-8157-517D8CCB6D38}"/>
          </ac:spMkLst>
        </pc:spChg>
        <pc:spChg chg="mod">
          <ac:chgData name="Hayk Barseghyan" userId="1af3c995-31f7-415e-9aa1-2b36900e994d" providerId="ADAL" clId="{C214967E-4090-4F63-9953-DF63951EA817}" dt="2021-03-12T22:37:19.629" v="280"/>
          <ac:spMkLst>
            <pc:docMk/>
            <pc:sldMk cId="2755479697" sldId="657"/>
            <ac:spMk id="38" creationId="{C78C682C-B4FD-4188-A301-9BEDEBEC5AAD}"/>
          </ac:spMkLst>
        </pc:spChg>
        <pc:spChg chg="mod">
          <ac:chgData name="Hayk Barseghyan" userId="1af3c995-31f7-415e-9aa1-2b36900e994d" providerId="ADAL" clId="{C214967E-4090-4F63-9953-DF63951EA817}" dt="2021-03-12T22:37:19.629" v="280"/>
          <ac:spMkLst>
            <pc:docMk/>
            <pc:sldMk cId="2755479697" sldId="657"/>
            <ac:spMk id="39" creationId="{FC486772-EDCC-4B75-87E2-03610AC4B564}"/>
          </ac:spMkLst>
        </pc:spChg>
        <pc:spChg chg="mod">
          <ac:chgData name="Hayk Barseghyan" userId="1af3c995-31f7-415e-9aa1-2b36900e994d" providerId="ADAL" clId="{C214967E-4090-4F63-9953-DF63951EA817}" dt="2021-03-12T22:37:19.629" v="280"/>
          <ac:spMkLst>
            <pc:docMk/>
            <pc:sldMk cId="2755479697" sldId="657"/>
            <ac:spMk id="40" creationId="{F137C4FC-3AAD-49A2-B69A-7BE747B74DEC}"/>
          </ac:spMkLst>
        </pc:spChg>
        <pc:spChg chg="mod">
          <ac:chgData name="Hayk Barseghyan" userId="1af3c995-31f7-415e-9aa1-2b36900e994d" providerId="ADAL" clId="{C214967E-4090-4F63-9953-DF63951EA817}" dt="2021-03-12T22:37:19.629" v="280"/>
          <ac:spMkLst>
            <pc:docMk/>
            <pc:sldMk cId="2755479697" sldId="657"/>
            <ac:spMk id="43" creationId="{93CC7EF7-2130-4F2A-90EC-72C4506D5A1B}"/>
          </ac:spMkLst>
        </pc:spChg>
        <pc:spChg chg="mod">
          <ac:chgData name="Hayk Barseghyan" userId="1af3c995-31f7-415e-9aa1-2b36900e994d" providerId="ADAL" clId="{C214967E-4090-4F63-9953-DF63951EA817}" dt="2021-03-12T22:37:19.629" v="280"/>
          <ac:spMkLst>
            <pc:docMk/>
            <pc:sldMk cId="2755479697" sldId="657"/>
            <ac:spMk id="44" creationId="{64FBFE9C-E2CC-45FA-B249-3105F71C1B15}"/>
          </ac:spMkLst>
        </pc:spChg>
        <pc:spChg chg="mod">
          <ac:chgData name="Hayk Barseghyan" userId="1af3c995-31f7-415e-9aa1-2b36900e994d" providerId="ADAL" clId="{C214967E-4090-4F63-9953-DF63951EA817}" dt="2021-03-12T22:37:19.629" v="280"/>
          <ac:spMkLst>
            <pc:docMk/>
            <pc:sldMk cId="2755479697" sldId="657"/>
            <ac:spMk id="45" creationId="{5A13DF38-7D00-44DB-A7FE-527617A01A15}"/>
          </ac:spMkLst>
        </pc:spChg>
        <pc:spChg chg="mod">
          <ac:chgData name="Hayk Barseghyan" userId="1af3c995-31f7-415e-9aa1-2b36900e994d" providerId="ADAL" clId="{C214967E-4090-4F63-9953-DF63951EA817}" dt="2021-03-12T22:37:19.629" v="280"/>
          <ac:spMkLst>
            <pc:docMk/>
            <pc:sldMk cId="2755479697" sldId="657"/>
            <ac:spMk id="46" creationId="{A15201F8-7AA5-4BB0-A895-5D767B27B580}"/>
          </ac:spMkLst>
        </pc:spChg>
        <pc:spChg chg="mod">
          <ac:chgData name="Hayk Barseghyan" userId="1af3c995-31f7-415e-9aa1-2b36900e994d" providerId="ADAL" clId="{C214967E-4090-4F63-9953-DF63951EA817}" dt="2021-03-12T22:37:19.629" v="280"/>
          <ac:spMkLst>
            <pc:docMk/>
            <pc:sldMk cId="2755479697" sldId="657"/>
            <ac:spMk id="47" creationId="{15538AD2-D9CB-44A3-AEB7-42E756923ECA}"/>
          </ac:spMkLst>
        </pc:spChg>
        <pc:spChg chg="mod">
          <ac:chgData name="Hayk Barseghyan" userId="1af3c995-31f7-415e-9aa1-2b36900e994d" providerId="ADAL" clId="{C214967E-4090-4F63-9953-DF63951EA817}" dt="2021-03-12T22:32:26.811" v="254" actId="20577"/>
          <ac:spMkLst>
            <pc:docMk/>
            <pc:sldMk cId="2755479697" sldId="657"/>
            <ac:spMk id="49" creationId="{270740F3-8276-4A91-AA98-A4A4273156A7}"/>
          </ac:spMkLst>
        </pc:spChg>
        <pc:spChg chg="del">
          <ac:chgData name="Hayk Barseghyan" userId="1af3c995-31f7-415e-9aa1-2b36900e994d" providerId="ADAL" clId="{C214967E-4090-4F63-9953-DF63951EA817}" dt="2021-03-12T22:36:47.945" v="277" actId="478"/>
          <ac:spMkLst>
            <pc:docMk/>
            <pc:sldMk cId="2755479697" sldId="657"/>
            <ac:spMk id="55" creationId="{07D69AF5-89C5-4D08-90B5-12B866765EE3}"/>
          </ac:spMkLst>
        </pc:spChg>
        <pc:spChg chg="mod">
          <ac:chgData name="Hayk Barseghyan" userId="1af3c995-31f7-415e-9aa1-2b36900e994d" providerId="ADAL" clId="{C214967E-4090-4F63-9953-DF63951EA817}" dt="2021-03-12T22:37:19.629" v="280"/>
          <ac:spMkLst>
            <pc:docMk/>
            <pc:sldMk cId="2755479697" sldId="657"/>
            <ac:spMk id="58" creationId="{9EF23E3B-9C7E-47EC-A54B-447FD1CDABDF}"/>
          </ac:spMkLst>
        </pc:spChg>
        <pc:spChg chg="add del mod">
          <ac:chgData name="Hayk Barseghyan" userId="1af3c995-31f7-415e-9aa1-2b36900e994d" providerId="ADAL" clId="{C214967E-4090-4F63-9953-DF63951EA817}" dt="2021-03-12T22:37:25.732" v="283"/>
          <ac:spMkLst>
            <pc:docMk/>
            <pc:sldMk cId="2755479697" sldId="657"/>
            <ac:spMk id="59" creationId="{520279A6-C35E-4B8A-9E31-852294689C97}"/>
          </ac:spMkLst>
        </pc:spChg>
        <pc:spChg chg="add del mod">
          <ac:chgData name="Hayk Barseghyan" userId="1af3c995-31f7-415e-9aa1-2b36900e994d" providerId="ADAL" clId="{C214967E-4090-4F63-9953-DF63951EA817}" dt="2021-03-12T22:37:25.732" v="283"/>
          <ac:spMkLst>
            <pc:docMk/>
            <pc:sldMk cId="2755479697" sldId="657"/>
            <ac:spMk id="60" creationId="{5FE2847B-5772-4F43-A761-07475E5E3820}"/>
          </ac:spMkLst>
        </pc:spChg>
        <pc:spChg chg="mod topLvl">
          <ac:chgData name="Hayk Barseghyan" userId="1af3c995-31f7-415e-9aa1-2b36900e994d" providerId="ADAL" clId="{C214967E-4090-4F63-9953-DF63951EA817}" dt="2021-03-12T22:47:56.105" v="371" actId="20577"/>
          <ac:spMkLst>
            <pc:docMk/>
            <pc:sldMk cId="2755479697" sldId="657"/>
            <ac:spMk id="68" creationId="{34BD1FF5-2295-462F-BA39-E70FC71178F8}"/>
          </ac:spMkLst>
        </pc:spChg>
        <pc:spChg chg="mod topLvl">
          <ac:chgData name="Hayk Barseghyan" userId="1af3c995-31f7-415e-9aa1-2b36900e994d" providerId="ADAL" clId="{C214967E-4090-4F63-9953-DF63951EA817}" dt="2021-03-12T22:45:07.758" v="359" actId="165"/>
          <ac:spMkLst>
            <pc:docMk/>
            <pc:sldMk cId="2755479697" sldId="657"/>
            <ac:spMk id="71" creationId="{5AADF1D3-8691-430F-89D1-A94B46D2A263}"/>
          </ac:spMkLst>
        </pc:spChg>
        <pc:spChg chg="mod topLvl">
          <ac:chgData name="Hayk Barseghyan" userId="1af3c995-31f7-415e-9aa1-2b36900e994d" providerId="ADAL" clId="{C214967E-4090-4F63-9953-DF63951EA817}" dt="2021-03-12T22:48:01.022" v="375" actId="20577"/>
          <ac:spMkLst>
            <pc:docMk/>
            <pc:sldMk cId="2755479697" sldId="657"/>
            <ac:spMk id="72" creationId="{6E8E9403-AB50-4FEB-B4C4-601B6706A470}"/>
          </ac:spMkLst>
        </pc:spChg>
        <pc:spChg chg="mod topLvl">
          <ac:chgData name="Hayk Barseghyan" userId="1af3c995-31f7-415e-9aa1-2b36900e994d" providerId="ADAL" clId="{C214967E-4090-4F63-9953-DF63951EA817}" dt="2021-03-12T22:45:07.758" v="359" actId="165"/>
          <ac:spMkLst>
            <pc:docMk/>
            <pc:sldMk cId="2755479697" sldId="657"/>
            <ac:spMk id="73" creationId="{1D26E09B-A378-4E7C-B3BE-7B103434FCB6}"/>
          </ac:spMkLst>
        </pc:spChg>
        <pc:spChg chg="mod topLvl">
          <ac:chgData name="Hayk Barseghyan" userId="1af3c995-31f7-415e-9aa1-2b36900e994d" providerId="ADAL" clId="{C214967E-4090-4F63-9953-DF63951EA817}" dt="2021-03-12T22:41:56.216" v="325" actId="1076"/>
          <ac:spMkLst>
            <pc:docMk/>
            <pc:sldMk cId="2755479697" sldId="657"/>
            <ac:spMk id="78" creationId="{A378CE8E-FD3C-4B20-A24B-AF9809EA6C83}"/>
          </ac:spMkLst>
        </pc:spChg>
        <pc:spChg chg="mod topLvl">
          <ac:chgData name="Hayk Barseghyan" userId="1af3c995-31f7-415e-9aa1-2b36900e994d" providerId="ADAL" clId="{C214967E-4090-4F63-9953-DF63951EA817}" dt="2021-03-12T22:43:33.367" v="347" actId="1076"/>
          <ac:spMkLst>
            <pc:docMk/>
            <pc:sldMk cId="2755479697" sldId="657"/>
            <ac:spMk id="79" creationId="{C51ADB4D-3640-45C3-80EF-5502C71420FD}"/>
          </ac:spMkLst>
        </pc:spChg>
        <pc:spChg chg="del mod topLvl">
          <ac:chgData name="Hayk Barseghyan" userId="1af3c995-31f7-415e-9aa1-2b36900e994d" providerId="ADAL" clId="{C214967E-4090-4F63-9953-DF63951EA817}" dt="2021-03-12T22:41:11.139" v="315" actId="478"/>
          <ac:spMkLst>
            <pc:docMk/>
            <pc:sldMk cId="2755479697" sldId="657"/>
            <ac:spMk id="80" creationId="{409AC12A-628D-452C-BD40-9B3F7775622D}"/>
          </ac:spMkLst>
        </pc:spChg>
        <pc:spChg chg="mod topLvl">
          <ac:chgData name="Hayk Barseghyan" userId="1af3c995-31f7-415e-9aa1-2b36900e994d" providerId="ADAL" clId="{C214967E-4090-4F63-9953-DF63951EA817}" dt="2021-03-12T22:55:41.292" v="413" actId="1035"/>
          <ac:spMkLst>
            <pc:docMk/>
            <pc:sldMk cId="2755479697" sldId="657"/>
            <ac:spMk id="81" creationId="{07786BAB-F6A6-4296-89B6-7CA9DAA57F71}"/>
          </ac:spMkLst>
        </pc:spChg>
        <pc:spChg chg="mod topLvl">
          <ac:chgData name="Hayk Barseghyan" userId="1af3c995-31f7-415e-9aa1-2b36900e994d" providerId="ADAL" clId="{C214967E-4090-4F63-9953-DF63951EA817}" dt="2021-03-12T22:55:41.292" v="413" actId="1035"/>
          <ac:spMkLst>
            <pc:docMk/>
            <pc:sldMk cId="2755479697" sldId="657"/>
            <ac:spMk id="82" creationId="{6061F006-A694-4901-A849-27628F0B9AA7}"/>
          </ac:spMkLst>
        </pc:spChg>
        <pc:spChg chg="mod topLvl">
          <ac:chgData name="Hayk Barseghyan" userId="1af3c995-31f7-415e-9aa1-2b36900e994d" providerId="ADAL" clId="{C214967E-4090-4F63-9953-DF63951EA817}" dt="2021-03-12T22:41:07.055" v="314" actId="165"/>
          <ac:spMkLst>
            <pc:docMk/>
            <pc:sldMk cId="2755479697" sldId="657"/>
            <ac:spMk id="88" creationId="{2562C061-A185-46DF-B9DE-A215AEBDE50B}"/>
          </ac:spMkLst>
        </pc:spChg>
        <pc:spChg chg="add mod">
          <ac:chgData name="Hayk Barseghyan" userId="1af3c995-31f7-415e-9aa1-2b36900e994d" providerId="ADAL" clId="{C214967E-4090-4F63-9953-DF63951EA817}" dt="2021-03-12T22:38:01.557" v="288" actId="1076"/>
          <ac:spMkLst>
            <pc:docMk/>
            <pc:sldMk cId="2755479697" sldId="657"/>
            <ac:spMk id="91" creationId="{890F756B-174F-4736-BB50-7F07F8A6C603}"/>
          </ac:spMkLst>
        </pc:spChg>
        <pc:spChg chg="add mod">
          <ac:chgData name="Hayk Barseghyan" userId="1af3c995-31f7-415e-9aa1-2b36900e994d" providerId="ADAL" clId="{C214967E-4090-4F63-9953-DF63951EA817}" dt="2021-03-12T22:38:33.236" v="295" actId="1076"/>
          <ac:spMkLst>
            <pc:docMk/>
            <pc:sldMk cId="2755479697" sldId="657"/>
            <ac:spMk id="94" creationId="{BF106B4E-9057-4F0F-B25D-27BD2332C592}"/>
          </ac:spMkLst>
        </pc:spChg>
        <pc:spChg chg="add mod">
          <ac:chgData name="Hayk Barseghyan" userId="1af3c995-31f7-415e-9aa1-2b36900e994d" providerId="ADAL" clId="{C214967E-4090-4F63-9953-DF63951EA817}" dt="2021-03-12T22:41:29.090" v="320" actId="14100"/>
          <ac:spMkLst>
            <pc:docMk/>
            <pc:sldMk cId="2755479697" sldId="657"/>
            <ac:spMk id="99" creationId="{5463678B-2C98-4048-B0E3-1D5FC1D58F2B}"/>
          </ac:spMkLst>
        </pc:spChg>
        <pc:spChg chg="add del">
          <ac:chgData name="Hayk Barseghyan" userId="1af3c995-31f7-415e-9aa1-2b36900e994d" providerId="ADAL" clId="{C214967E-4090-4F63-9953-DF63951EA817}" dt="2021-03-12T22:44:53.477" v="357" actId="22"/>
          <ac:spMkLst>
            <pc:docMk/>
            <pc:sldMk cId="2755479697" sldId="657"/>
            <ac:spMk id="105" creationId="{C0200658-0728-4120-A822-C1D8375A6E24}"/>
          </ac:spMkLst>
        </pc:spChg>
        <pc:spChg chg="del">
          <ac:chgData name="Hayk Barseghyan" userId="1af3c995-31f7-415e-9aa1-2b36900e994d" providerId="ADAL" clId="{C214967E-4090-4F63-9953-DF63951EA817}" dt="2021-03-12T22:38:51.193" v="299" actId="478"/>
          <ac:spMkLst>
            <pc:docMk/>
            <pc:sldMk cId="2755479697" sldId="657"/>
            <ac:spMk id="118" creationId="{066264C0-0B22-4722-A2BA-8C702062244E}"/>
          </ac:spMkLst>
        </pc:spChg>
        <pc:grpChg chg="add del mod">
          <ac:chgData name="Hayk Barseghyan" userId="1af3c995-31f7-415e-9aa1-2b36900e994d" providerId="ADAL" clId="{C214967E-4090-4F63-9953-DF63951EA817}" dt="2021-03-12T22:37:25.732" v="283"/>
          <ac:grpSpMkLst>
            <pc:docMk/>
            <pc:sldMk cId="2755479697" sldId="657"/>
            <ac:grpSpMk id="34" creationId="{0744C0A6-B67C-428C-BD95-ED79B8FF5449}"/>
          </ac:grpSpMkLst>
        </pc:grpChg>
        <pc:grpChg chg="add del mod">
          <ac:chgData name="Hayk Barseghyan" userId="1af3c995-31f7-415e-9aa1-2b36900e994d" providerId="ADAL" clId="{C214967E-4090-4F63-9953-DF63951EA817}" dt="2021-03-12T22:37:25.732" v="283"/>
          <ac:grpSpMkLst>
            <pc:docMk/>
            <pc:sldMk cId="2755479697" sldId="657"/>
            <ac:grpSpMk id="41" creationId="{78580844-CB61-45A9-86A3-E8D0A58947F2}"/>
          </ac:grpSpMkLst>
        </pc:grpChg>
        <pc:grpChg chg="del">
          <ac:chgData name="Hayk Barseghyan" userId="1af3c995-31f7-415e-9aa1-2b36900e994d" providerId="ADAL" clId="{C214967E-4090-4F63-9953-DF63951EA817}" dt="2021-03-12T22:37:30.899" v="284" actId="478"/>
          <ac:grpSpMkLst>
            <pc:docMk/>
            <pc:sldMk cId="2755479697" sldId="657"/>
            <ac:grpSpMk id="63" creationId="{EF2C7A10-0284-41A0-BC17-809962B03E09}"/>
          </ac:grpSpMkLst>
        </pc:grpChg>
        <pc:grpChg chg="add del mod">
          <ac:chgData name="Hayk Barseghyan" userId="1af3c995-31f7-415e-9aa1-2b36900e994d" providerId="ADAL" clId="{C214967E-4090-4F63-9953-DF63951EA817}" dt="2021-03-12T22:45:07.758" v="359" actId="165"/>
          <ac:grpSpMkLst>
            <pc:docMk/>
            <pc:sldMk cId="2755479697" sldId="657"/>
            <ac:grpSpMk id="65" creationId="{9196FB17-B337-4E7A-B68E-6DD303E19620}"/>
          </ac:grpSpMkLst>
        </pc:grpChg>
        <pc:grpChg chg="add del mod">
          <ac:chgData name="Hayk Barseghyan" userId="1af3c995-31f7-415e-9aa1-2b36900e994d" providerId="ADAL" clId="{C214967E-4090-4F63-9953-DF63951EA817}" dt="2021-03-12T22:41:07.055" v="314" actId="165"/>
          <ac:grpSpMkLst>
            <pc:docMk/>
            <pc:sldMk cId="2755479697" sldId="657"/>
            <ac:grpSpMk id="74" creationId="{BCC8B8F5-45BA-46BB-912D-BCE8F8CF2F6B}"/>
          </ac:grpSpMkLst>
        </pc:grpChg>
        <pc:grpChg chg="del">
          <ac:chgData name="Hayk Barseghyan" userId="1af3c995-31f7-415e-9aa1-2b36900e994d" providerId="ADAL" clId="{C214967E-4090-4F63-9953-DF63951EA817}" dt="2021-03-12T22:37:30.899" v="284" actId="478"/>
          <ac:grpSpMkLst>
            <pc:docMk/>
            <pc:sldMk cId="2755479697" sldId="657"/>
            <ac:grpSpMk id="77" creationId="{44803872-5E86-449C-8096-E1A8CF55BF75}"/>
          </ac:grpSpMkLst>
        </pc:grpChg>
        <pc:grpChg chg="del">
          <ac:chgData name="Hayk Barseghyan" userId="1af3c995-31f7-415e-9aa1-2b36900e994d" providerId="ADAL" clId="{C214967E-4090-4F63-9953-DF63951EA817}" dt="2021-03-12T22:37:30.899" v="284" actId="478"/>
          <ac:grpSpMkLst>
            <pc:docMk/>
            <pc:sldMk cId="2755479697" sldId="657"/>
            <ac:grpSpMk id="103" creationId="{6092B2D2-FD47-4DE2-B1C8-277AEE662DB1}"/>
          </ac:grpSpMkLst>
        </pc:grpChg>
        <pc:picChg chg="del">
          <ac:chgData name="Hayk Barseghyan" userId="1af3c995-31f7-415e-9aa1-2b36900e994d" providerId="ADAL" clId="{C214967E-4090-4F63-9953-DF63951EA817}" dt="2021-03-12T22:32:28.882" v="255" actId="478"/>
          <ac:picMkLst>
            <pc:docMk/>
            <pc:sldMk cId="2755479697" sldId="657"/>
            <ac:picMk id="3" creationId="{8D3A5F37-3DE6-4371-B224-FA7A789D2484}"/>
          </ac:picMkLst>
        </pc:picChg>
        <pc:picChg chg="add del">
          <ac:chgData name="Hayk Barseghyan" userId="1af3c995-31f7-415e-9aa1-2b36900e994d" providerId="ADAL" clId="{C214967E-4090-4F63-9953-DF63951EA817}" dt="2021-03-12T22:35:46.285" v="268" actId="478"/>
          <ac:picMkLst>
            <pc:docMk/>
            <pc:sldMk cId="2755479697" sldId="657"/>
            <ac:picMk id="4" creationId="{CB449226-8FE1-4D7C-86AE-CECE2F887C09}"/>
          </ac:picMkLst>
        </pc:picChg>
        <pc:picChg chg="add mod ord">
          <ac:chgData name="Hayk Barseghyan" userId="1af3c995-31f7-415e-9aa1-2b36900e994d" providerId="ADAL" clId="{C214967E-4090-4F63-9953-DF63951EA817}" dt="2021-03-12T22:38:39.333" v="298" actId="1076"/>
          <ac:picMkLst>
            <pc:docMk/>
            <pc:sldMk cId="2755479697" sldId="657"/>
            <ac:picMk id="6" creationId="{647E26B7-A751-4F7B-AE55-58021DFF200F}"/>
          </ac:picMkLst>
        </pc:picChg>
        <pc:picChg chg="del">
          <ac:chgData name="Hayk Barseghyan" userId="1af3c995-31f7-415e-9aa1-2b36900e994d" providerId="ADAL" clId="{C214967E-4090-4F63-9953-DF63951EA817}" dt="2021-03-12T22:37:30.899" v="284" actId="478"/>
          <ac:picMkLst>
            <pc:docMk/>
            <pc:sldMk cId="2755479697" sldId="657"/>
            <ac:picMk id="17" creationId="{1EDA1680-38DE-45AC-BAB3-51091D58A59D}"/>
          </ac:picMkLst>
        </pc:picChg>
        <pc:picChg chg="add mod ord">
          <ac:chgData name="Hayk Barseghyan" userId="1af3c995-31f7-415e-9aa1-2b36900e994d" providerId="ADAL" clId="{C214967E-4090-4F63-9953-DF63951EA817}" dt="2021-03-12T22:42:07.995" v="328" actId="14100"/>
          <ac:picMkLst>
            <pc:docMk/>
            <pc:sldMk cId="2755479697" sldId="657"/>
            <ac:picMk id="18" creationId="{F227534F-7555-45D8-89C1-5409D1E697AC}"/>
          </ac:picMkLst>
        </pc:picChg>
        <pc:picChg chg="add mod">
          <ac:chgData name="Hayk Barseghyan" userId="1af3c995-31f7-415e-9aa1-2b36900e994d" providerId="ADAL" clId="{C214967E-4090-4F63-9953-DF63951EA817}" dt="2021-03-12T22:48:05.656" v="376" actId="1076"/>
          <ac:picMkLst>
            <pc:docMk/>
            <pc:sldMk cId="2755479697" sldId="657"/>
            <ac:picMk id="29" creationId="{CF9A21CF-EDBB-4665-A266-4092EEDE63E8}"/>
          </ac:picMkLst>
        </pc:picChg>
        <pc:picChg chg="add mod">
          <ac:chgData name="Hayk Barseghyan" userId="1af3c995-31f7-415e-9aa1-2b36900e994d" providerId="ADAL" clId="{C214967E-4090-4F63-9953-DF63951EA817}" dt="2021-03-12T22:48:40.690" v="381" actId="1076"/>
          <ac:picMkLst>
            <pc:docMk/>
            <pc:sldMk cId="2755479697" sldId="657"/>
            <ac:picMk id="32" creationId="{9C4F5BC9-4380-4AC1-A310-9AB023C36173}"/>
          </ac:picMkLst>
        </pc:picChg>
        <pc:picChg chg="mod">
          <ac:chgData name="Hayk Barseghyan" userId="1af3c995-31f7-415e-9aa1-2b36900e994d" providerId="ADAL" clId="{C214967E-4090-4F63-9953-DF63951EA817}" dt="2021-03-12T22:37:19.629" v="280"/>
          <ac:picMkLst>
            <pc:docMk/>
            <pc:sldMk cId="2755479697" sldId="657"/>
            <ac:picMk id="35" creationId="{4A2A92F4-EB22-4D25-B0B8-B2CE59C288AD}"/>
          </ac:picMkLst>
        </pc:picChg>
        <pc:picChg chg="mod">
          <ac:chgData name="Hayk Barseghyan" userId="1af3c995-31f7-415e-9aa1-2b36900e994d" providerId="ADAL" clId="{C214967E-4090-4F63-9953-DF63951EA817}" dt="2021-03-12T22:37:19.629" v="280"/>
          <ac:picMkLst>
            <pc:docMk/>
            <pc:sldMk cId="2755479697" sldId="657"/>
            <ac:picMk id="36" creationId="{439E66F0-82DD-4CC1-A305-60E54B017A5B}"/>
          </ac:picMkLst>
        </pc:picChg>
        <pc:picChg chg="mod">
          <ac:chgData name="Hayk Barseghyan" userId="1af3c995-31f7-415e-9aa1-2b36900e994d" providerId="ADAL" clId="{C214967E-4090-4F63-9953-DF63951EA817}" dt="2021-03-12T22:37:19.629" v="280"/>
          <ac:picMkLst>
            <pc:docMk/>
            <pc:sldMk cId="2755479697" sldId="657"/>
            <ac:picMk id="42" creationId="{F7E95F0E-8377-49C7-AF8C-673754C66FC4}"/>
          </ac:picMkLst>
        </pc:picChg>
        <pc:picChg chg="del mod topLvl">
          <ac:chgData name="Hayk Barseghyan" userId="1af3c995-31f7-415e-9aa1-2b36900e994d" providerId="ADAL" clId="{C214967E-4090-4F63-9953-DF63951EA817}" dt="2021-03-12T22:45:10.185" v="361" actId="478"/>
          <ac:picMkLst>
            <pc:docMk/>
            <pc:sldMk cId="2755479697" sldId="657"/>
            <ac:picMk id="66" creationId="{136A2B55-89A8-4E19-BF4E-02ADD0592F12}"/>
          </ac:picMkLst>
        </pc:picChg>
        <pc:picChg chg="del mod topLvl">
          <ac:chgData name="Hayk Barseghyan" userId="1af3c995-31f7-415e-9aa1-2b36900e994d" providerId="ADAL" clId="{C214967E-4090-4F63-9953-DF63951EA817}" dt="2021-03-12T22:45:09.453" v="360" actId="478"/>
          <ac:picMkLst>
            <pc:docMk/>
            <pc:sldMk cId="2755479697" sldId="657"/>
            <ac:picMk id="67" creationId="{4A45B47E-66F1-44B0-B77B-A1EFBF65FF08}"/>
          </ac:picMkLst>
        </pc:picChg>
        <pc:picChg chg="del mod">
          <ac:chgData name="Hayk Barseghyan" userId="1af3c995-31f7-415e-9aa1-2b36900e994d" providerId="ADAL" clId="{C214967E-4090-4F63-9953-DF63951EA817}" dt="2021-03-12T22:39:07.320" v="305" actId="478"/>
          <ac:picMkLst>
            <pc:docMk/>
            <pc:sldMk cId="2755479697" sldId="657"/>
            <ac:picMk id="75" creationId="{2D906F56-3743-4619-96D0-361FD37D8DAF}"/>
          </ac:picMkLst>
        </pc:picChg>
        <pc:cxnChg chg="mod">
          <ac:chgData name="Hayk Barseghyan" userId="1af3c995-31f7-415e-9aa1-2b36900e994d" providerId="ADAL" clId="{C214967E-4090-4F63-9953-DF63951EA817}" dt="2021-03-12T22:37:19.629" v="280"/>
          <ac:cxnSpMkLst>
            <pc:docMk/>
            <pc:sldMk cId="2755479697" sldId="657"/>
            <ac:cxnSpMk id="48" creationId="{B4A87CDE-DC2A-4612-BC3E-E890379127F3}"/>
          </ac:cxnSpMkLst>
        </pc:cxnChg>
        <pc:cxnChg chg="mod">
          <ac:chgData name="Hayk Barseghyan" userId="1af3c995-31f7-415e-9aa1-2b36900e994d" providerId="ADAL" clId="{C214967E-4090-4F63-9953-DF63951EA817}" dt="2021-03-12T22:37:19.629" v="280"/>
          <ac:cxnSpMkLst>
            <pc:docMk/>
            <pc:sldMk cId="2755479697" sldId="657"/>
            <ac:cxnSpMk id="50" creationId="{600367BF-7C7E-4611-AEC8-C90B1D82D767}"/>
          </ac:cxnSpMkLst>
        </pc:cxnChg>
        <pc:cxnChg chg="mod">
          <ac:chgData name="Hayk Barseghyan" userId="1af3c995-31f7-415e-9aa1-2b36900e994d" providerId="ADAL" clId="{C214967E-4090-4F63-9953-DF63951EA817}" dt="2021-03-12T22:37:19.629" v="280"/>
          <ac:cxnSpMkLst>
            <pc:docMk/>
            <pc:sldMk cId="2755479697" sldId="657"/>
            <ac:cxnSpMk id="51" creationId="{A5DEB52F-7945-42D9-AD4C-29407CD3E26E}"/>
          </ac:cxnSpMkLst>
        </pc:cxnChg>
        <pc:cxnChg chg="mod">
          <ac:chgData name="Hayk Barseghyan" userId="1af3c995-31f7-415e-9aa1-2b36900e994d" providerId="ADAL" clId="{C214967E-4090-4F63-9953-DF63951EA817}" dt="2021-03-12T22:37:19.629" v="280"/>
          <ac:cxnSpMkLst>
            <pc:docMk/>
            <pc:sldMk cId="2755479697" sldId="657"/>
            <ac:cxnSpMk id="52" creationId="{D9210F7F-4CE3-4AD4-A190-34BC995B0918}"/>
          </ac:cxnSpMkLst>
        </pc:cxnChg>
        <pc:cxnChg chg="del mod">
          <ac:chgData name="Hayk Barseghyan" userId="1af3c995-31f7-415e-9aa1-2b36900e994d" providerId="ADAL" clId="{C214967E-4090-4F63-9953-DF63951EA817}" dt="2021-03-12T22:36:51.484" v="279" actId="478"/>
          <ac:cxnSpMkLst>
            <pc:docMk/>
            <pc:sldMk cId="2755479697" sldId="657"/>
            <ac:cxnSpMk id="56" creationId="{3CFAB489-8807-4BA3-9020-3CC0451293AE}"/>
          </ac:cxnSpMkLst>
        </pc:cxnChg>
        <pc:cxnChg chg="del mod">
          <ac:chgData name="Hayk Barseghyan" userId="1af3c995-31f7-415e-9aa1-2b36900e994d" providerId="ADAL" clId="{C214967E-4090-4F63-9953-DF63951EA817}" dt="2021-03-12T22:36:50.081" v="278" actId="478"/>
          <ac:cxnSpMkLst>
            <pc:docMk/>
            <pc:sldMk cId="2755479697" sldId="657"/>
            <ac:cxnSpMk id="57" creationId="{0D4ABBEE-13C4-463C-BDA1-4546744CB24F}"/>
          </ac:cxnSpMkLst>
        </pc:cxnChg>
        <pc:cxnChg chg="add del mod">
          <ac:chgData name="Hayk Barseghyan" userId="1af3c995-31f7-415e-9aa1-2b36900e994d" providerId="ADAL" clId="{C214967E-4090-4F63-9953-DF63951EA817}" dt="2021-03-12T22:37:25.732" v="283"/>
          <ac:cxnSpMkLst>
            <pc:docMk/>
            <pc:sldMk cId="2755479697" sldId="657"/>
            <ac:cxnSpMk id="61" creationId="{C0142EC7-F7C2-42BA-B9C6-DF22CC0282B5}"/>
          </ac:cxnSpMkLst>
        </pc:cxnChg>
        <pc:cxnChg chg="add del mod">
          <ac:chgData name="Hayk Barseghyan" userId="1af3c995-31f7-415e-9aa1-2b36900e994d" providerId="ADAL" clId="{C214967E-4090-4F63-9953-DF63951EA817}" dt="2021-03-12T22:37:25.732" v="283"/>
          <ac:cxnSpMkLst>
            <pc:docMk/>
            <pc:sldMk cId="2755479697" sldId="657"/>
            <ac:cxnSpMk id="62" creationId="{A5B07789-0716-4167-90DB-EF0087A43C10}"/>
          </ac:cxnSpMkLst>
        </pc:cxnChg>
        <pc:cxnChg chg="add del mod">
          <ac:chgData name="Hayk Barseghyan" userId="1af3c995-31f7-415e-9aa1-2b36900e994d" providerId="ADAL" clId="{C214967E-4090-4F63-9953-DF63951EA817}" dt="2021-03-12T22:37:25.732" v="283"/>
          <ac:cxnSpMkLst>
            <pc:docMk/>
            <pc:sldMk cId="2755479697" sldId="657"/>
            <ac:cxnSpMk id="64" creationId="{5B9FA95A-3E0F-42CE-952C-B8F71041522B}"/>
          </ac:cxnSpMkLst>
        </pc:cxnChg>
        <pc:cxnChg chg="mod topLvl">
          <ac:chgData name="Hayk Barseghyan" userId="1af3c995-31f7-415e-9aa1-2b36900e994d" providerId="ADAL" clId="{C214967E-4090-4F63-9953-DF63951EA817}" dt="2021-03-12T22:43:19.910" v="343" actId="1076"/>
          <ac:cxnSpMkLst>
            <pc:docMk/>
            <pc:sldMk cId="2755479697" sldId="657"/>
            <ac:cxnSpMk id="83" creationId="{58D0C8E9-615F-4BB4-8DBD-A90AD120C04D}"/>
          </ac:cxnSpMkLst>
        </pc:cxnChg>
        <pc:cxnChg chg="del mod topLvl">
          <ac:chgData name="Hayk Barseghyan" userId="1af3c995-31f7-415e-9aa1-2b36900e994d" providerId="ADAL" clId="{C214967E-4090-4F63-9953-DF63951EA817}" dt="2021-03-12T22:43:22.700" v="344" actId="478"/>
          <ac:cxnSpMkLst>
            <pc:docMk/>
            <pc:sldMk cId="2755479697" sldId="657"/>
            <ac:cxnSpMk id="84" creationId="{1E8FD7B1-86A7-45BF-94F2-9DBC75C2D8F8}"/>
          </ac:cxnSpMkLst>
        </pc:cxnChg>
        <pc:cxnChg chg="mod topLvl">
          <ac:chgData name="Hayk Barseghyan" userId="1af3c995-31f7-415e-9aa1-2b36900e994d" providerId="ADAL" clId="{C214967E-4090-4F63-9953-DF63951EA817}" dt="2021-03-12T22:42:59.560" v="337" actId="1076"/>
          <ac:cxnSpMkLst>
            <pc:docMk/>
            <pc:sldMk cId="2755479697" sldId="657"/>
            <ac:cxnSpMk id="85" creationId="{0EF1E4F0-CD42-453C-B817-5170CC59B83F}"/>
          </ac:cxnSpMkLst>
        </pc:cxnChg>
        <pc:cxnChg chg="del mod topLvl">
          <ac:chgData name="Hayk Barseghyan" userId="1af3c995-31f7-415e-9aa1-2b36900e994d" providerId="ADAL" clId="{C214967E-4090-4F63-9953-DF63951EA817}" dt="2021-03-12T22:42:39.647" v="332" actId="478"/>
          <ac:cxnSpMkLst>
            <pc:docMk/>
            <pc:sldMk cId="2755479697" sldId="657"/>
            <ac:cxnSpMk id="87" creationId="{26547983-2F4A-434E-8E45-9B91B6EB23EB}"/>
          </ac:cxnSpMkLst>
        </pc:cxnChg>
        <pc:cxnChg chg="add mod">
          <ac:chgData name="Hayk Barseghyan" userId="1af3c995-31f7-415e-9aa1-2b36900e994d" providerId="ADAL" clId="{C214967E-4090-4F63-9953-DF63951EA817}" dt="2021-03-12T22:41:59.796" v="327" actId="14100"/>
          <ac:cxnSpMkLst>
            <pc:docMk/>
            <pc:sldMk cId="2755479697" sldId="657"/>
            <ac:cxnSpMk id="95" creationId="{16507A16-B1EA-41FC-BA29-6F79662AB745}"/>
          </ac:cxnSpMkLst>
        </pc:cxnChg>
        <pc:cxnChg chg="add mod">
          <ac:chgData name="Hayk Barseghyan" userId="1af3c995-31f7-415e-9aa1-2b36900e994d" providerId="ADAL" clId="{C214967E-4090-4F63-9953-DF63951EA817}" dt="2021-03-12T22:44:12.301" v="352" actId="14100"/>
          <ac:cxnSpMkLst>
            <pc:docMk/>
            <pc:sldMk cId="2755479697" sldId="657"/>
            <ac:cxnSpMk id="96" creationId="{0E9D330C-7EF6-4A8F-8BD0-1DFEE913D44D}"/>
          </ac:cxnSpMkLst>
        </pc:cxnChg>
        <pc:cxnChg chg="add mod">
          <ac:chgData name="Hayk Barseghyan" userId="1af3c995-31f7-415e-9aa1-2b36900e994d" providerId="ADAL" clId="{C214967E-4090-4F63-9953-DF63951EA817}" dt="2021-03-12T22:39:05.128" v="304" actId="14100"/>
          <ac:cxnSpMkLst>
            <pc:docMk/>
            <pc:sldMk cId="2755479697" sldId="657"/>
            <ac:cxnSpMk id="98" creationId="{17657C10-69D0-4CE3-8C03-DFB56D86A81D}"/>
          </ac:cxnSpMkLst>
        </pc:cxnChg>
        <pc:cxnChg chg="add del mod">
          <ac:chgData name="Hayk Barseghyan" userId="1af3c995-31f7-415e-9aa1-2b36900e994d" providerId="ADAL" clId="{C214967E-4090-4F63-9953-DF63951EA817}" dt="2021-03-12T22:43:03.767" v="339" actId="478"/>
          <ac:cxnSpMkLst>
            <pc:docMk/>
            <pc:sldMk cId="2755479697" sldId="657"/>
            <ac:cxnSpMk id="100" creationId="{3C4C6139-3852-4216-97AC-88DAEEAC83D9}"/>
          </ac:cxnSpMkLst>
        </pc:cxnChg>
        <pc:cxnChg chg="add mod">
          <ac:chgData name="Hayk Barseghyan" userId="1af3c995-31f7-415e-9aa1-2b36900e994d" providerId="ADAL" clId="{C214967E-4090-4F63-9953-DF63951EA817}" dt="2021-03-12T22:43:09.749" v="340" actId="1076"/>
          <ac:cxnSpMkLst>
            <pc:docMk/>
            <pc:sldMk cId="2755479697" sldId="657"/>
            <ac:cxnSpMk id="101" creationId="{19BBA3F5-EFCD-49F7-BDCC-66B89FA196B9}"/>
          </ac:cxnSpMkLst>
        </pc:cxnChg>
        <pc:cxnChg chg="del">
          <ac:chgData name="Hayk Barseghyan" userId="1af3c995-31f7-415e-9aa1-2b36900e994d" providerId="ADAL" clId="{C214967E-4090-4F63-9953-DF63951EA817}" dt="2021-03-12T22:37:30.899" v="284" actId="478"/>
          <ac:cxnSpMkLst>
            <pc:docMk/>
            <pc:sldMk cId="2755479697" sldId="657"/>
            <ac:cxnSpMk id="102" creationId="{C68D6FCC-99EA-4905-840B-A0BEF455C074}"/>
          </ac:cxnSpMkLst>
        </pc:cxnChg>
        <pc:cxnChg chg="add mod">
          <ac:chgData name="Hayk Barseghyan" userId="1af3c995-31f7-415e-9aa1-2b36900e994d" providerId="ADAL" clId="{C214967E-4090-4F63-9953-DF63951EA817}" dt="2021-03-12T22:43:58.389" v="351" actId="1076"/>
          <ac:cxnSpMkLst>
            <pc:docMk/>
            <pc:sldMk cId="2755479697" sldId="657"/>
            <ac:cxnSpMk id="104" creationId="{05153E8D-36D1-430B-B3A6-660A80B985D2}"/>
          </ac:cxnSpMkLst>
        </pc:cxnChg>
      </pc:sldChg>
      <pc:sldChg chg="delSp modSp add mod modNotesTx">
        <pc:chgData name="Hayk Barseghyan" userId="1af3c995-31f7-415e-9aa1-2b36900e994d" providerId="ADAL" clId="{C214967E-4090-4F63-9953-DF63951EA817}" dt="2021-03-12T22:44:38.237" v="355" actId="20577"/>
        <pc:sldMkLst>
          <pc:docMk/>
          <pc:sldMk cId="1987727170" sldId="658"/>
        </pc:sldMkLst>
        <pc:spChg chg="mod">
          <ac:chgData name="Hayk Barseghyan" userId="1af3c995-31f7-415e-9aa1-2b36900e994d" providerId="ADAL" clId="{C214967E-4090-4F63-9953-DF63951EA817}" dt="2021-03-12T22:34:12.580" v="259" actId="20577"/>
          <ac:spMkLst>
            <pc:docMk/>
            <pc:sldMk cId="1987727170" sldId="658"/>
            <ac:spMk id="49" creationId="{270740F3-8276-4A91-AA98-A4A4273156A7}"/>
          </ac:spMkLst>
        </pc:spChg>
        <pc:spChg chg="del">
          <ac:chgData name="Hayk Barseghyan" userId="1af3c995-31f7-415e-9aa1-2b36900e994d" providerId="ADAL" clId="{C214967E-4090-4F63-9953-DF63951EA817}" dt="2021-03-12T22:34:32.333" v="267" actId="478"/>
          <ac:spMkLst>
            <pc:docMk/>
            <pc:sldMk cId="1987727170" sldId="658"/>
            <ac:spMk id="118" creationId="{066264C0-0B22-4722-A2BA-8C702062244E}"/>
          </ac:spMkLst>
        </pc:spChg>
        <pc:grpChg chg="del">
          <ac:chgData name="Hayk Barseghyan" userId="1af3c995-31f7-415e-9aa1-2b36900e994d" providerId="ADAL" clId="{C214967E-4090-4F63-9953-DF63951EA817}" dt="2021-03-12T22:34:26.569" v="265" actId="478"/>
          <ac:grpSpMkLst>
            <pc:docMk/>
            <pc:sldMk cId="1987727170" sldId="658"/>
            <ac:grpSpMk id="63" creationId="{EF2C7A10-0284-41A0-BC17-809962B03E09}"/>
          </ac:grpSpMkLst>
        </pc:grpChg>
        <pc:grpChg chg="del">
          <ac:chgData name="Hayk Barseghyan" userId="1af3c995-31f7-415e-9aa1-2b36900e994d" providerId="ADAL" clId="{C214967E-4090-4F63-9953-DF63951EA817}" dt="2021-03-12T22:34:24.048" v="263" actId="478"/>
          <ac:grpSpMkLst>
            <pc:docMk/>
            <pc:sldMk cId="1987727170" sldId="658"/>
            <ac:grpSpMk id="77" creationId="{44803872-5E86-449C-8096-E1A8CF55BF75}"/>
          </ac:grpSpMkLst>
        </pc:grpChg>
        <pc:grpChg chg="del">
          <ac:chgData name="Hayk Barseghyan" userId="1af3c995-31f7-415e-9aa1-2b36900e994d" providerId="ADAL" clId="{C214967E-4090-4F63-9953-DF63951EA817}" dt="2021-03-12T22:34:27.255" v="266" actId="478"/>
          <ac:grpSpMkLst>
            <pc:docMk/>
            <pc:sldMk cId="1987727170" sldId="658"/>
            <ac:grpSpMk id="103" creationId="{6092B2D2-FD47-4DE2-B1C8-277AEE662DB1}"/>
          </ac:grpSpMkLst>
        </pc:grpChg>
        <pc:picChg chg="mod">
          <ac:chgData name="Hayk Barseghyan" userId="1af3c995-31f7-415e-9aa1-2b36900e994d" providerId="ADAL" clId="{C214967E-4090-4F63-9953-DF63951EA817}" dt="2021-03-12T22:34:21.144" v="261" actId="1076"/>
          <ac:picMkLst>
            <pc:docMk/>
            <pc:sldMk cId="1987727170" sldId="658"/>
            <ac:picMk id="4" creationId="{CB449226-8FE1-4D7C-86AE-CECE2F887C09}"/>
          </ac:picMkLst>
        </pc:picChg>
        <pc:picChg chg="del">
          <ac:chgData name="Hayk Barseghyan" userId="1af3c995-31f7-415e-9aa1-2b36900e994d" providerId="ADAL" clId="{C214967E-4090-4F63-9953-DF63951EA817}" dt="2021-03-12T22:34:23.085" v="262" actId="478"/>
          <ac:picMkLst>
            <pc:docMk/>
            <pc:sldMk cId="1987727170" sldId="658"/>
            <ac:picMk id="17" creationId="{1EDA1680-38DE-45AC-BAB3-51091D58A59D}"/>
          </ac:picMkLst>
        </pc:picChg>
        <pc:cxnChg chg="del">
          <ac:chgData name="Hayk Barseghyan" userId="1af3c995-31f7-415e-9aa1-2b36900e994d" providerId="ADAL" clId="{C214967E-4090-4F63-9953-DF63951EA817}" dt="2021-03-12T22:34:25.318" v="264" actId="478"/>
          <ac:cxnSpMkLst>
            <pc:docMk/>
            <pc:sldMk cId="1987727170" sldId="658"/>
            <ac:cxnSpMk id="102" creationId="{C68D6FCC-99EA-4905-840B-A0BEF455C074}"/>
          </ac:cxnSpMkLst>
        </pc:cxnChg>
      </pc:sldChg>
      <pc:sldChg chg="delSp modSp add mod">
        <pc:chgData name="Hayk Barseghyan" userId="1af3c995-31f7-415e-9aa1-2b36900e994d" providerId="ADAL" clId="{C214967E-4090-4F63-9953-DF63951EA817}" dt="2021-03-12T22:56:51.551" v="417" actId="478"/>
        <pc:sldMkLst>
          <pc:docMk/>
          <pc:sldMk cId="810307725" sldId="659"/>
        </pc:sldMkLst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28" creationId="{627423C8-B194-4935-85FA-5ED8C3D13EA3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30" creationId="{68ED1E75-B125-4C10-BB29-81E202553B2C}"/>
          </ac:spMkLst>
        </pc:spChg>
        <pc:spChg chg="mod">
          <ac:chgData name="Hayk Barseghyan" userId="1af3c995-31f7-415e-9aa1-2b36900e994d" providerId="ADAL" clId="{C214967E-4090-4F63-9953-DF63951EA817}" dt="2021-03-12T22:56:45.236" v="416" actId="20577"/>
          <ac:spMkLst>
            <pc:docMk/>
            <pc:sldMk cId="810307725" sldId="659"/>
            <ac:spMk id="49" creationId="{270740F3-8276-4A91-AA98-A4A4273156A7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53" creationId="{68B00FA6-B8FE-4BDC-965F-134174286DD9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54" creationId="{E863B169-6BF6-4624-A891-6B3C9852B628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68" creationId="{34BD1FF5-2295-462F-BA39-E70FC71178F8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71" creationId="{5AADF1D3-8691-430F-89D1-A94B46D2A263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72" creationId="{6E8E9403-AB50-4FEB-B4C4-601B6706A470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73" creationId="{1D26E09B-A378-4E7C-B3BE-7B103434FCB6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78" creationId="{A378CE8E-FD3C-4B20-A24B-AF9809EA6C83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79" creationId="{C51ADB4D-3640-45C3-80EF-5502C71420FD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81" creationId="{07786BAB-F6A6-4296-89B6-7CA9DAA57F71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82" creationId="{6061F006-A694-4901-A849-27628F0B9AA7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88" creationId="{2562C061-A185-46DF-B9DE-A215AEBDE50B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91" creationId="{890F756B-174F-4736-BB50-7F07F8A6C603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94" creationId="{BF106B4E-9057-4F0F-B25D-27BD2332C592}"/>
          </ac:spMkLst>
        </pc:spChg>
        <pc:spChg chg="del">
          <ac:chgData name="Hayk Barseghyan" userId="1af3c995-31f7-415e-9aa1-2b36900e994d" providerId="ADAL" clId="{C214967E-4090-4F63-9953-DF63951EA817}" dt="2021-03-12T22:56:51.551" v="417" actId="478"/>
          <ac:spMkLst>
            <pc:docMk/>
            <pc:sldMk cId="810307725" sldId="659"/>
            <ac:spMk id="99" creationId="{5463678B-2C98-4048-B0E3-1D5FC1D58F2B}"/>
          </ac:spMkLst>
        </pc:spChg>
        <pc:picChg chg="del">
          <ac:chgData name="Hayk Barseghyan" userId="1af3c995-31f7-415e-9aa1-2b36900e994d" providerId="ADAL" clId="{C214967E-4090-4F63-9953-DF63951EA817}" dt="2021-03-12T22:56:51.551" v="417" actId="478"/>
          <ac:picMkLst>
            <pc:docMk/>
            <pc:sldMk cId="810307725" sldId="659"/>
            <ac:picMk id="6" creationId="{647E26B7-A751-4F7B-AE55-58021DFF200F}"/>
          </ac:picMkLst>
        </pc:picChg>
        <pc:picChg chg="del">
          <ac:chgData name="Hayk Barseghyan" userId="1af3c995-31f7-415e-9aa1-2b36900e994d" providerId="ADAL" clId="{C214967E-4090-4F63-9953-DF63951EA817}" dt="2021-03-12T22:56:51.551" v="417" actId="478"/>
          <ac:picMkLst>
            <pc:docMk/>
            <pc:sldMk cId="810307725" sldId="659"/>
            <ac:picMk id="18" creationId="{F227534F-7555-45D8-89C1-5409D1E697AC}"/>
          </ac:picMkLst>
        </pc:picChg>
        <pc:picChg chg="del">
          <ac:chgData name="Hayk Barseghyan" userId="1af3c995-31f7-415e-9aa1-2b36900e994d" providerId="ADAL" clId="{C214967E-4090-4F63-9953-DF63951EA817}" dt="2021-03-12T22:56:51.551" v="417" actId="478"/>
          <ac:picMkLst>
            <pc:docMk/>
            <pc:sldMk cId="810307725" sldId="659"/>
            <ac:picMk id="29" creationId="{CF9A21CF-EDBB-4665-A266-4092EEDE63E8}"/>
          </ac:picMkLst>
        </pc:picChg>
        <pc:picChg chg="del">
          <ac:chgData name="Hayk Barseghyan" userId="1af3c995-31f7-415e-9aa1-2b36900e994d" providerId="ADAL" clId="{C214967E-4090-4F63-9953-DF63951EA817}" dt="2021-03-12T22:56:51.551" v="417" actId="478"/>
          <ac:picMkLst>
            <pc:docMk/>
            <pc:sldMk cId="810307725" sldId="659"/>
            <ac:picMk id="32" creationId="{9C4F5BC9-4380-4AC1-A310-9AB023C36173}"/>
          </ac:picMkLst>
        </pc:picChg>
        <pc:cxnChg chg="del">
          <ac:chgData name="Hayk Barseghyan" userId="1af3c995-31f7-415e-9aa1-2b36900e994d" providerId="ADAL" clId="{C214967E-4090-4F63-9953-DF63951EA817}" dt="2021-03-12T22:56:51.551" v="417" actId="478"/>
          <ac:cxnSpMkLst>
            <pc:docMk/>
            <pc:sldMk cId="810307725" sldId="659"/>
            <ac:cxnSpMk id="83" creationId="{58D0C8E9-615F-4BB4-8DBD-A90AD120C04D}"/>
          </ac:cxnSpMkLst>
        </pc:cxnChg>
        <pc:cxnChg chg="del">
          <ac:chgData name="Hayk Barseghyan" userId="1af3c995-31f7-415e-9aa1-2b36900e994d" providerId="ADAL" clId="{C214967E-4090-4F63-9953-DF63951EA817}" dt="2021-03-12T22:56:51.551" v="417" actId="478"/>
          <ac:cxnSpMkLst>
            <pc:docMk/>
            <pc:sldMk cId="810307725" sldId="659"/>
            <ac:cxnSpMk id="85" creationId="{0EF1E4F0-CD42-453C-B817-5170CC59B83F}"/>
          </ac:cxnSpMkLst>
        </pc:cxnChg>
        <pc:cxnChg chg="del mod">
          <ac:chgData name="Hayk Barseghyan" userId="1af3c995-31f7-415e-9aa1-2b36900e994d" providerId="ADAL" clId="{C214967E-4090-4F63-9953-DF63951EA817}" dt="2021-03-12T22:56:51.551" v="417" actId="478"/>
          <ac:cxnSpMkLst>
            <pc:docMk/>
            <pc:sldMk cId="810307725" sldId="659"/>
            <ac:cxnSpMk id="95" creationId="{16507A16-B1EA-41FC-BA29-6F79662AB745}"/>
          </ac:cxnSpMkLst>
        </pc:cxnChg>
        <pc:cxnChg chg="del mod">
          <ac:chgData name="Hayk Barseghyan" userId="1af3c995-31f7-415e-9aa1-2b36900e994d" providerId="ADAL" clId="{C214967E-4090-4F63-9953-DF63951EA817}" dt="2021-03-12T22:56:51.551" v="417" actId="478"/>
          <ac:cxnSpMkLst>
            <pc:docMk/>
            <pc:sldMk cId="810307725" sldId="659"/>
            <ac:cxnSpMk id="96" creationId="{0E9D330C-7EF6-4A8F-8BD0-1DFEE913D44D}"/>
          </ac:cxnSpMkLst>
        </pc:cxnChg>
        <pc:cxnChg chg="del mod">
          <ac:chgData name="Hayk Barseghyan" userId="1af3c995-31f7-415e-9aa1-2b36900e994d" providerId="ADAL" clId="{C214967E-4090-4F63-9953-DF63951EA817}" dt="2021-03-12T22:56:51.551" v="417" actId="478"/>
          <ac:cxnSpMkLst>
            <pc:docMk/>
            <pc:sldMk cId="810307725" sldId="659"/>
            <ac:cxnSpMk id="98" creationId="{17657C10-69D0-4CE3-8C03-DFB56D86A81D}"/>
          </ac:cxnSpMkLst>
        </pc:cxnChg>
        <pc:cxnChg chg="del">
          <ac:chgData name="Hayk Barseghyan" userId="1af3c995-31f7-415e-9aa1-2b36900e994d" providerId="ADAL" clId="{C214967E-4090-4F63-9953-DF63951EA817}" dt="2021-03-12T22:56:51.551" v="417" actId="478"/>
          <ac:cxnSpMkLst>
            <pc:docMk/>
            <pc:sldMk cId="810307725" sldId="659"/>
            <ac:cxnSpMk id="101" creationId="{19BBA3F5-EFCD-49F7-BDCC-66B89FA196B9}"/>
          </ac:cxnSpMkLst>
        </pc:cxnChg>
        <pc:cxnChg chg="del">
          <ac:chgData name="Hayk Barseghyan" userId="1af3c995-31f7-415e-9aa1-2b36900e994d" providerId="ADAL" clId="{C214967E-4090-4F63-9953-DF63951EA817}" dt="2021-03-12T22:56:51.551" v="417" actId="478"/>
          <ac:cxnSpMkLst>
            <pc:docMk/>
            <pc:sldMk cId="810307725" sldId="659"/>
            <ac:cxnSpMk id="104" creationId="{05153E8D-36D1-430B-B3A6-660A80B985D2}"/>
          </ac:cxnSpMkLst>
        </pc:cxnChg>
      </pc:sldChg>
      <pc:sldChg chg="delSp modSp add mod">
        <pc:chgData name="Hayk Barseghyan" userId="1af3c995-31f7-415e-9aa1-2b36900e994d" providerId="ADAL" clId="{C214967E-4090-4F63-9953-DF63951EA817}" dt="2021-03-12T22:57:31.995" v="426" actId="478"/>
        <pc:sldMkLst>
          <pc:docMk/>
          <pc:sldMk cId="2000704347" sldId="660"/>
        </pc:sldMkLst>
        <pc:spChg chg="del">
          <ac:chgData name="Hayk Barseghyan" userId="1af3c995-31f7-415e-9aa1-2b36900e994d" providerId="ADAL" clId="{C214967E-4090-4F63-9953-DF63951EA817}" dt="2021-03-12T22:57:21.818" v="423" actId="478"/>
          <ac:spMkLst>
            <pc:docMk/>
            <pc:sldMk cId="2000704347" sldId="660"/>
            <ac:spMk id="32" creationId="{C8EED87A-0AE7-41CB-B85F-5690D93EF3E6}"/>
          </ac:spMkLst>
        </pc:spChg>
        <pc:spChg chg="del">
          <ac:chgData name="Hayk Barseghyan" userId="1af3c995-31f7-415e-9aa1-2b36900e994d" providerId="ADAL" clId="{C214967E-4090-4F63-9953-DF63951EA817}" dt="2021-03-12T22:57:29.404" v="425" actId="478"/>
          <ac:spMkLst>
            <pc:docMk/>
            <pc:sldMk cId="2000704347" sldId="660"/>
            <ac:spMk id="37" creationId="{46E22F1A-4B6B-4497-A10E-1133F9386895}"/>
          </ac:spMkLst>
        </pc:spChg>
        <pc:spChg chg="del">
          <ac:chgData name="Hayk Barseghyan" userId="1af3c995-31f7-415e-9aa1-2b36900e994d" providerId="ADAL" clId="{C214967E-4090-4F63-9953-DF63951EA817}" dt="2021-03-12T22:57:29.404" v="425" actId="478"/>
          <ac:spMkLst>
            <pc:docMk/>
            <pc:sldMk cId="2000704347" sldId="660"/>
            <ac:spMk id="40" creationId="{03C35834-9994-4DBC-A8F8-7F81D9308BC6}"/>
          </ac:spMkLst>
        </pc:spChg>
        <pc:spChg chg="del">
          <ac:chgData name="Hayk Barseghyan" userId="1af3c995-31f7-415e-9aa1-2b36900e994d" providerId="ADAL" clId="{C214967E-4090-4F63-9953-DF63951EA817}" dt="2021-03-12T22:57:29.404" v="425" actId="478"/>
          <ac:spMkLst>
            <pc:docMk/>
            <pc:sldMk cId="2000704347" sldId="660"/>
            <ac:spMk id="41" creationId="{77AA0295-E04C-47D7-9AD2-E60A3E1CF6E9}"/>
          </ac:spMkLst>
        </pc:spChg>
        <pc:spChg chg="mod">
          <ac:chgData name="Hayk Barseghyan" userId="1af3c995-31f7-415e-9aa1-2b36900e994d" providerId="ADAL" clId="{C214967E-4090-4F63-9953-DF63951EA817}" dt="2021-03-12T22:57:12.084" v="420" actId="20577"/>
          <ac:spMkLst>
            <pc:docMk/>
            <pc:sldMk cId="2000704347" sldId="660"/>
            <ac:spMk id="49" creationId="{270740F3-8276-4A91-AA98-A4A4273156A7}"/>
          </ac:spMkLst>
        </pc:spChg>
        <pc:spChg chg="del">
          <ac:chgData name="Hayk Barseghyan" userId="1af3c995-31f7-415e-9aa1-2b36900e994d" providerId="ADAL" clId="{C214967E-4090-4F63-9953-DF63951EA817}" dt="2021-03-12T22:57:19.516" v="422" actId="478"/>
          <ac:spMkLst>
            <pc:docMk/>
            <pc:sldMk cId="2000704347" sldId="660"/>
            <ac:spMk id="76" creationId="{1C554B34-C002-4DB1-8784-4B391E209899}"/>
          </ac:spMkLst>
        </pc:spChg>
        <pc:spChg chg="del">
          <ac:chgData name="Hayk Barseghyan" userId="1af3c995-31f7-415e-9aa1-2b36900e994d" providerId="ADAL" clId="{C214967E-4090-4F63-9953-DF63951EA817}" dt="2021-03-12T22:57:29.404" v="425" actId="478"/>
          <ac:spMkLst>
            <pc:docMk/>
            <pc:sldMk cId="2000704347" sldId="660"/>
            <ac:spMk id="90" creationId="{413DD0F0-9162-4A06-A57F-A2B4EFE8B4A8}"/>
          </ac:spMkLst>
        </pc:spChg>
        <pc:picChg chg="del">
          <ac:chgData name="Hayk Barseghyan" userId="1af3c995-31f7-415e-9aa1-2b36900e994d" providerId="ADAL" clId="{C214967E-4090-4F63-9953-DF63951EA817}" dt="2021-03-12T22:57:24.484" v="424" actId="478"/>
          <ac:picMkLst>
            <pc:docMk/>
            <pc:sldMk cId="2000704347" sldId="660"/>
            <ac:picMk id="8" creationId="{2025D8F4-DB00-4692-A85A-11644A3ECBF3}"/>
          </ac:picMkLst>
        </pc:picChg>
        <pc:picChg chg="del">
          <ac:chgData name="Hayk Barseghyan" userId="1af3c995-31f7-415e-9aa1-2b36900e994d" providerId="ADAL" clId="{C214967E-4090-4F63-9953-DF63951EA817}" dt="2021-03-12T22:57:16.850" v="421" actId="478"/>
          <ac:picMkLst>
            <pc:docMk/>
            <pc:sldMk cId="2000704347" sldId="660"/>
            <ac:picMk id="31" creationId="{A423A7A3-37E0-495F-A41D-46390BECA406}"/>
          </ac:picMkLst>
        </pc:picChg>
        <pc:cxnChg chg="del">
          <ac:chgData name="Hayk Barseghyan" userId="1af3c995-31f7-415e-9aa1-2b36900e994d" providerId="ADAL" clId="{C214967E-4090-4F63-9953-DF63951EA817}" dt="2021-03-12T22:57:31.995" v="426" actId="478"/>
          <ac:cxnSpMkLst>
            <pc:docMk/>
            <pc:sldMk cId="2000704347" sldId="660"/>
            <ac:cxnSpMk id="33" creationId="{1B628404-82F4-4D74-879A-D2CAC769448A}"/>
          </ac:cxnSpMkLst>
        </pc:cxnChg>
      </pc:sldChg>
      <pc:sldChg chg="delSp modSp add mod modNotesTx">
        <pc:chgData name="Hayk Barseghyan" userId="1af3c995-31f7-415e-9aa1-2b36900e994d" providerId="ADAL" clId="{C214967E-4090-4F63-9953-DF63951EA817}" dt="2021-03-12T23:22:53.433" v="460" actId="478"/>
        <pc:sldMkLst>
          <pc:docMk/>
          <pc:sldMk cId="3227928584" sldId="661"/>
        </pc:sldMkLst>
        <pc:spChg chg="mod">
          <ac:chgData name="Hayk Barseghyan" userId="1af3c995-31f7-415e-9aa1-2b36900e994d" providerId="ADAL" clId="{C214967E-4090-4F63-9953-DF63951EA817}" dt="2021-03-12T23:22:44.218" v="453" actId="20577"/>
          <ac:spMkLst>
            <pc:docMk/>
            <pc:sldMk cId="3227928584" sldId="661"/>
            <ac:spMk id="49" creationId="{270740F3-8276-4A91-AA98-A4A4273156A7}"/>
          </ac:spMkLst>
        </pc:spChg>
        <pc:spChg chg="del">
          <ac:chgData name="Hayk Barseghyan" userId="1af3c995-31f7-415e-9aa1-2b36900e994d" providerId="ADAL" clId="{C214967E-4090-4F63-9953-DF63951EA817}" dt="2021-03-12T23:22:52.832" v="459" actId="478"/>
          <ac:spMkLst>
            <pc:docMk/>
            <pc:sldMk cId="3227928584" sldId="661"/>
            <ac:spMk id="55" creationId="{07D69AF5-89C5-4D08-90B5-12B866765EE3}"/>
          </ac:spMkLst>
        </pc:spChg>
        <pc:picChg chg="del">
          <ac:chgData name="Hayk Barseghyan" userId="1af3c995-31f7-415e-9aa1-2b36900e994d" providerId="ADAL" clId="{C214967E-4090-4F63-9953-DF63951EA817}" dt="2021-03-12T23:22:48.533" v="457" actId="478"/>
          <ac:picMkLst>
            <pc:docMk/>
            <pc:sldMk cId="3227928584" sldId="661"/>
            <ac:picMk id="4" creationId="{CB449226-8FE1-4D7C-86AE-CECE2F887C09}"/>
          </ac:picMkLst>
        </pc:picChg>
        <pc:cxnChg chg="del mod">
          <ac:chgData name="Hayk Barseghyan" userId="1af3c995-31f7-415e-9aa1-2b36900e994d" providerId="ADAL" clId="{C214967E-4090-4F63-9953-DF63951EA817}" dt="2021-03-12T23:22:53.433" v="460" actId="478"/>
          <ac:cxnSpMkLst>
            <pc:docMk/>
            <pc:sldMk cId="3227928584" sldId="661"/>
            <ac:cxnSpMk id="56" creationId="{3CFAB489-8807-4BA3-9020-3CC0451293AE}"/>
          </ac:cxnSpMkLst>
        </pc:cxnChg>
        <pc:cxnChg chg="del mod">
          <ac:chgData name="Hayk Barseghyan" userId="1af3c995-31f7-415e-9aa1-2b36900e994d" providerId="ADAL" clId="{C214967E-4090-4F63-9953-DF63951EA817}" dt="2021-03-12T23:22:52.040" v="458" actId="478"/>
          <ac:cxnSpMkLst>
            <pc:docMk/>
            <pc:sldMk cId="3227928584" sldId="661"/>
            <ac:cxnSpMk id="57" creationId="{0D4ABBEE-13C4-463C-BDA1-4546744CB24F}"/>
          </ac:cxnSpMkLst>
        </pc:cxnChg>
      </pc:sldChg>
      <pc:sldChg chg="del">
        <pc:chgData name="Hayk Barseghyan" userId="1af3c995-31f7-415e-9aa1-2b36900e994d" providerId="ADAL" clId="{C214967E-4090-4F63-9953-DF63951EA817}" dt="2021-03-12T22:05:21.345" v="1" actId="47"/>
        <pc:sldMkLst>
          <pc:docMk/>
          <pc:sldMk cId="1377579920" sldId="4369"/>
        </pc:sldMkLst>
      </pc:sldChg>
      <pc:sldChg chg="del">
        <pc:chgData name="Hayk Barseghyan" userId="1af3c995-31f7-415e-9aa1-2b36900e994d" providerId="ADAL" clId="{C214967E-4090-4F63-9953-DF63951EA817}" dt="2021-03-12T22:05:21.983" v="2" actId="47"/>
        <pc:sldMkLst>
          <pc:docMk/>
          <pc:sldMk cId="2324661198" sldId="4370"/>
        </pc:sldMkLst>
      </pc:sldChg>
    </pc:docChg>
  </pc:docChgLst>
  <pc:docChgLst>
    <pc:chgData name="Hayk Barseghyan" userId="1af3c995-31f7-415e-9aa1-2b36900e994d" providerId="ADAL" clId="{D0FCF0CF-18A9-445A-A55D-A143FC461721}"/>
    <pc:docChg chg="custSel modSld">
      <pc:chgData name="Hayk Barseghyan" userId="1af3c995-31f7-415e-9aa1-2b36900e994d" providerId="ADAL" clId="{D0FCF0CF-18A9-445A-A55D-A143FC461721}" dt="2022-07-06T19:53:36.173" v="5" actId="14100"/>
      <pc:docMkLst>
        <pc:docMk/>
      </pc:docMkLst>
      <pc:sldChg chg="delSp modSp mod">
        <pc:chgData name="Hayk Barseghyan" userId="1af3c995-31f7-415e-9aa1-2b36900e994d" providerId="ADAL" clId="{D0FCF0CF-18A9-445A-A55D-A143FC461721}" dt="2022-07-06T19:53:36.173" v="5" actId="14100"/>
        <pc:sldMkLst>
          <pc:docMk/>
          <pc:sldMk cId="2946833462" sldId="671"/>
        </pc:sldMkLst>
        <pc:spChg chg="mod">
          <ac:chgData name="Hayk Barseghyan" userId="1af3c995-31f7-415e-9aa1-2b36900e994d" providerId="ADAL" clId="{D0FCF0CF-18A9-445A-A55D-A143FC461721}" dt="2022-07-06T19:53:24.625" v="3" actId="1076"/>
          <ac:spMkLst>
            <pc:docMk/>
            <pc:sldMk cId="2946833462" sldId="671"/>
            <ac:spMk id="28" creationId="{627423C8-B194-4935-85FA-5ED8C3D13EA3}"/>
          </ac:spMkLst>
        </pc:spChg>
        <pc:spChg chg="del">
          <ac:chgData name="Hayk Barseghyan" userId="1af3c995-31f7-415e-9aa1-2b36900e994d" providerId="ADAL" clId="{D0FCF0CF-18A9-445A-A55D-A143FC461721}" dt="2022-07-06T19:53:09.880" v="1" actId="478"/>
          <ac:spMkLst>
            <pc:docMk/>
            <pc:sldMk cId="2946833462" sldId="671"/>
            <ac:spMk id="34" creationId="{9E232FB5-9A42-4416-8E4E-5620B622F041}"/>
          </ac:spMkLst>
        </pc:spChg>
        <pc:spChg chg="del">
          <ac:chgData name="Hayk Barseghyan" userId="1af3c995-31f7-415e-9aa1-2b36900e994d" providerId="ADAL" clId="{D0FCF0CF-18A9-445A-A55D-A143FC461721}" dt="2022-07-06T19:53:06.746" v="0" actId="478"/>
          <ac:spMkLst>
            <pc:docMk/>
            <pc:sldMk cId="2946833462" sldId="671"/>
            <ac:spMk id="36" creationId="{D1390CDB-8C38-45E4-B737-627C1887B062}"/>
          </ac:spMkLst>
        </pc:spChg>
        <pc:spChg chg="del">
          <ac:chgData name="Hayk Barseghyan" userId="1af3c995-31f7-415e-9aa1-2b36900e994d" providerId="ADAL" clId="{D0FCF0CF-18A9-445A-A55D-A143FC461721}" dt="2022-07-06T19:53:09.880" v="1" actId="478"/>
          <ac:spMkLst>
            <pc:docMk/>
            <pc:sldMk cId="2946833462" sldId="671"/>
            <ac:spMk id="40" creationId="{EFE6C304-6608-4E19-9AF5-28280CCAEF69}"/>
          </ac:spMkLst>
        </pc:spChg>
        <pc:spChg chg="mod">
          <ac:chgData name="Hayk Barseghyan" userId="1af3c995-31f7-415e-9aa1-2b36900e994d" providerId="ADAL" clId="{D0FCF0CF-18A9-445A-A55D-A143FC461721}" dt="2022-07-06T19:53:24.625" v="3" actId="1076"/>
          <ac:spMkLst>
            <pc:docMk/>
            <pc:sldMk cId="2946833462" sldId="671"/>
            <ac:spMk id="44" creationId="{732812E5-D6B9-4FEF-975D-E2E3D93D0E47}"/>
          </ac:spMkLst>
        </pc:spChg>
        <pc:spChg chg="mod">
          <ac:chgData name="Hayk Barseghyan" userId="1af3c995-31f7-415e-9aa1-2b36900e994d" providerId="ADAL" clId="{D0FCF0CF-18A9-445A-A55D-A143FC461721}" dt="2022-07-06T19:53:24.625" v="3" actId="1076"/>
          <ac:spMkLst>
            <pc:docMk/>
            <pc:sldMk cId="2946833462" sldId="671"/>
            <ac:spMk id="45" creationId="{706B5154-0B8D-4A97-9481-9F43337FAC30}"/>
          </ac:spMkLst>
        </pc:spChg>
        <pc:spChg chg="mod">
          <ac:chgData name="Hayk Barseghyan" userId="1af3c995-31f7-415e-9aa1-2b36900e994d" providerId="ADAL" clId="{D0FCF0CF-18A9-445A-A55D-A143FC461721}" dt="2022-07-06T19:53:24.625" v="3" actId="1076"/>
          <ac:spMkLst>
            <pc:docMk/>
            <pc:sldMk cId="2946833462" sldId="671"/>
            <ac:spMk id="88" creationId="{7309DE7D-82B3-4F46-B078-58EBF40D4703}"/>
          </ac:spMkLst>
        </pc:spChg>
        <pc:spChg chg="mod">
          <ac:chgData name="Hayk Barseghyan" userId="1af3c995-31f7-415e-9aa1-2b36900e994d" providerId="ADAL" clId="{D0FCF0CF-18A9-445A-A55D-A143FC461721}" dt="2022-07-06T19:53:24.625" v="3" actId="1076"/>
          <ac:spMkLst>
            <pc:docMk/>
            <pc:sldMk cId="2946833462" sldId="671"/>
            <ac:spMk id="93" creationId="{3EAC0E29-A0FD-42DD-8F3E-7B6BDF36A320}"/>
          </ac:spMkLst>
        </pc:spChg>
        <pc:spChg chg="mod">
          <ac:chgData name="Hayk Barseghyan" userId="1af3c995-31f7-415e-9aa1-2b36900e994d" providerId="ADAL" clId="{D0FCF0CF-18A9-445A-A55D-A143FC461721}" dt="2022-07-06T19:53:24.625" v="3" actId="1076"/>
          <ac:spMkLst>
            <pc:docMk/>
            <pc:sldMk cId="2946833462" sldId="671"/>
            <ac:spMk id="94" creationId="{C3B2E742-FF55-4D80-8A82-03F353C11C9E}"/>
          </ac:spMkLst>
        </pc:spChg>
        <pc:picChg chg="mod">
          <ac:chgData name="Hayk Barseghyan" userId="1af3c995-31f7-415e-9aa1-2b36900e994d" providerId="ADAL" clId="{D0FCF0CF-18A9-445A-A55D-A143FC461721}" dt="2022-07-06T19:53:24.625" v="3" actId="1076"/>
          <ac:picMkLst>
            <pc:docMk/>
            <pc:sldMk cId="2946833462" sldId="671"/>
            <ac:picMk id="35" creationId="{347E1D22-E15C-425D-925B-99F60A60B955}"/>
          </ac:picMkLst>
        </pc:picChg>
        <pc:cxnChg chg="mod">
          <ac:chgData name="Hayk Barseghyan" userId="1af3c995-31f7-415e-9aa1-2b36900e994d" providerId="ADAL" clId="{D0FCF0CF-18A9-445A-A55D-A143FC461721}" dt="2022-07-06T19:53:36.173" v="5" actId="14100"/>
          <ac:cxnSpMkLst>
            <pc:docMk/>
            <pc:sldMk cId="2946833462" sldId="671"/>
            <ac:cxnSpMk id="49" creationId="{4423681D-AADF-4D62-AC9E-3FDDF18E21B9}"/>
          </ac:cxnSpMkLst>
        </pc:cxnChg>
        <pc:cxnChg chg="mod">
          <ac:chgData name="Hayk Barseghyan" userId="1af3c995-31f7-415e-9aa1-2b36900e994d" providerId="ADAL" clId="{D0FCF0CF-18A9-445A-A55D-A143FC461721}" dt="2022-07-06T19:53:33.445" v="4" actId="14100"/>
          <ac:cxnSpMkLst>
            <pc:docMk/>
            <pc:sldMk cId="2946833462" sldId="671"/>
            <ac:cxnSpMk id="52" creationId="{67E81840-D31A-48DD-9275-CD08F7D6F031}"/>
          </ac:cxnSpMkLst>
        </pc:cxnChg>
        <pc:cxnChg chg="mod">
          <ac:chgData name="Hayk Barseghyan" userId="1af3c995-31f7-415e-9aa1-2b36900e994d" providerId="ADAL" clId="{D0FCF0CF-18A9-445A-A55D-A143FC461721}" dt="2022-07-06T19:53:24.625" v="3" actId="1076"/>
          <ac:cxnSpMkLst>
            <pc:docMk/>
            <pc:sldMk cId="2946833462" sldId="671"/>
            <ac:cxnSpMk id="95" creationId="{5EB10151-CF0F-4162-A03A-2FB4661DCBE8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EB5C37-DE57-4EB4-BEDE-5A55BD4842A0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11DEBC-8008-4B5D-8947-4D22F9142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313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0" dirty="0"/>
              <a:t>Figure S2A: </a:t>
            </a:r>
            <a:r>
              <a:rPr lang="en-US" b="0" i="0" dirty="0">
                <a:solidFill>
                  <a:srgbClr val="000000"/>
                </a:solidFill>
                <a:effectLst/>
                <a:latin typeface="Gotham"/>
              </a:rPr>
              <a:t>BN-065-01 (Robertsonian Translocation?)</a:t>
            </a:r>
            <a:endParaRPr lang="en-US" i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11DEBC-8008-4B5D-8947-4D22F9142E3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5349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0" dirty="0"/>
              <a:t>Figure S2B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1p11.2 (BN-044-1) – this is a marker chromosome</a:t>
            </a:r>
          </a:p>
          <a:p>
            <a:endParaRPr lang="en-US" i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11DEBC-8008-4B5D-8947-4D22F9142E3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0562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0" dirty="0"/>
              <a:t>Figure S2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N-096-01 Inverted 12q by fish not detected by ogm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ttps://us.bionanoaccess.com/ThreeLevels/index.html?objectpk=2376&amp;projectpk=24&amp;objecttypepk=16&amp;objectalias=BN-096-01_assembly_annotation&amp;parentobjpk=2371&amp;layout=SV</a:t>
            </a:r>
          </a:p>
          <a:p>
            <a:endParaRPr lang="en-US" i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11DEBC-8008-4B5D-8947-4D22F9142E3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14426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0" dirty="0"/>
              <a:t>Figure S2D: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lele_117 (del9-mask)</a:t>
            </a:r>
            <a:endParaRPr lang="en-US" i="0" dirty="0"/>
          </a:p>
          <a:p>
            <a:r>
              <a:rPr lang="en-US" i="0" dirty="0"/>
              <a:t>Figure S2E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lele_103 (IHH)</a:t>
            </a:r>
            <a:endParaRPr lang="en-US" i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11DEBC-8008-4B5D-8947-4D22F9142E3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686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568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227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880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994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457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659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650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414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885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150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830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A0A82-083F-454D-B921-DBD18E9D1EBF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3DF61-6C85-418D-BCF2-62B2E581D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094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69" r:id="rId1"/>
    <p:sldLayoutId id="2147483870" r:id="rId2"/>
    <p:sldLayoutId id="2147483871" r:id="rId3"/>
    <p:sldLayoutId id="2147483872" r:id="rId4"/>
    <p:sldLayoutId id="2147483873" r:id="rId5"/>
    <p:sldLayoutId id="2147483874" r:id="rId6"/>
    <p:sldLayoutId id="2147483875" r:id="rId7"/>
    <p:sldLayoutId id="2147483876" r:id="rId8"/>
    <p:sldLayoutId id="2147483877" r:id="rId9"/>
    <p:sldLayoutId id="2147483878" r:id="rId10"/>
    <p:sldLayoutId id="214748387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>
            <a:extLst>
              <a:ext uri="{FF2B5EF4-FFF2-40B4-BE49-F238E27FC236}">
                <a16:creationId xmlns:a16="http://schemas.microsoft.com/office/drawing/2014/main" id="{347E1D22-E15C-425D-925B-99F60A60B9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74968" y="1931973"/>
            <a:ext cx="6004172" cy="138258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EE723D7-82C2-40C7-9EDF-695ABCFD28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87398" y="574589"/>
            <a:ext cx="4212379" cy="4183527"/>
          </a:xfrm>
          <a:prstGeom prst="rect">
            <a:avLst/>
          </a:prstGeom>
        </p:spPr>
      </p:pic>
      <p:pic>
        <p:nvPicPr>
          <p:cNvPr id="14" name="Picture 13" descr="Text&#10;&#10;Description automatically generated">
            <a:extLst>
              <a:ext uri="{FF2B5EF4-FFF2-40B4-BE49-F238E27FC236}">
                <a16:creationId xmlns:a16="http://schemas.microsoft.com/office/drawing/2014/main" id="{BD596D5A-A8B5-4F23-971B-B0033B03044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88231" b="38430"/>
          <a:stretch/>
        </p:blipFill>
        <p:spPr>
          <a:xfrm>
            <a:off x="981088" y="1664664"/>
            <a:ext cx="138466" cy="62456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DA809E1-700B-4B5F-80D1-146841C532CC}"/>
              </a:ext>
            </a:extLst>
          </p:cNvPr>
          <p:cNvSpPr txBox="1"/>
          <p:nvPr/>
        </p:nvSpPr>
        <p:spPr>
          <a:xfrm>
            <a:off x="443878" y="1608784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Gotham Light" pitchFamily="2" charset="0"/>
              </a:rPr>
              <a:t>Insertion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19D3844-749C-4AC5-8AAC-A5A6E4F706D5}"/>
              </a:ext>
            </a:extLst>
          </p:cNvPr>
          <p:cNvSpPr txBox="1"/>
          <p:nvPr/>
        </p:nvSpPr>
        <p:spPr>
          <a:xfrm>
            <a:off x="463114" y="1733773"/>
            <a:ext cx="6351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Gotham Light" pitchFamily="2" charset="0"/>
              </a:rPr>
              <a:t>Deletion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38D452B-545B-49D2-9AA5-4774F789BA52}"/>
              </a:ext>
            </a:extLst>
          </p:cNvPr>
          <p:cNvSpPr txBox="1"/>
          <p:nvPr/>
        </p:nvSpPr>
        <p:spPr>
          <a:xfrm>
            <a:off x="426245" y="1858762"/>
            <a:ext cx="6719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Gotham Light" pitchFamily="2" charset="0"/>
              </a:rPr>
              <a:t>Inversion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B330CDD-DF8E-4329-9F8F-0C05A3EBA278}"/>
              </a:ext>
            </a:extLst>
          </p:cNvPr>
          <p:cNvSpPr txBox="1"/>
          <p:nvPr/>
        </p:nvSpPr>
        <p:spPr>
          <a:xfrm>
            <a:off x="337254" y="1983751"/>
            <a:ext cx="6639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Gotham Light" pitchFamily="2" charset="0"/>
              </a:rPr>
              <a:t>Duplicatio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2E3FBB9-4482-4901-BB7B-515414A60BF3}"/>
              </a:ext>
            </a:extLst>
          </p:cNvPr>
          <p:cNvSpPr txBox="1"/>
          <p:nvPr/>
        </p:nvSpPr>
        <p:spPr>
          <a:xfrm>
            <a:off x="247811" y="2108740"/>
            <a:ext cx="7521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Gotham Light" pitchFamily="2" charset="0"/>
              </a:rPr>
              <a:t>Translocatio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3617DAE-E7EA-4947-A705-85255111007E}"/>
              </a:ext>
            </a:extLst>
          </p:cNvPr>
          <p:cNvSpPr txBox="1"/>
          <p:nvPr/>
        </p:nvSpPr>
        <p:spPr>
          <a:xfrm>
            <a:off x="385467" y="2505714"/>
            <a:ext cx="6256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>
                <a:latin typeface="Gotham Light" pitchFamily="2" charset="0"/>
              </a:rPr>
              <a:t>CNV track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9A0FE9C-502B-4BBD-8A60-74F846E3930A}"/>
              </a:ext>
            </a:extLst>
          </p:cNvPr>
          <p:cNvSpPr txBox="1"/>
          <p:nvPr/>
        </p:nvSpPr>
        <p:spPr>
          <a:xfrm>
            <a:off x="384208" y="1154616"/>
            <a:ext cx="627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>
                <a:latin typeface="Gotham Light" pitchFamily="2" charset="0"/>
              </a:rPr>
              <a:t>Cytoband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97F0FB6-DB3D-4B12-9E76-180A15D9B845}"/>
              </a:ext>
            </a:extLst>
          </p:cNvPr>
          <p:cNvSpPr txBox="1"/>
          <p:nvPr/>
        </p:nvSpPr>
        <p:spPr>
          <a:xfrm>
            <a:off x="30458" y="1460573"/>
            <a:ext cx="96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>
                <a:latin typeface="Gotham Light" pitchFamily="2" charset="0"/>
              </a:rPr>
              <a:t>Structural variants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B97A16ED-5542-4DD1-94CA-D032D3F72196}"/>
              </a:ext>
            </a:extLst>
          </p:cNvPr>
          <p:cNvCxnSpPr>
            <a:cxnSpLocks/>
            <a:endCxn id="21" idx="3"/>
          </p:cNvCxnSpPr>
          <p:nvPr/>
        </p:nvCxnSpPr>
        <p:spPr>
          <a:xfrm flipH="1">
            <a:off x="1011303" y="1262338"/>
            <a:ext cx="839548" cy="0"/>
          </a:xfrm>
          <a:prstGeom prst="line">
            <a:avLst/>
          </a:prstGeom>
          <a:ln w="127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792D8F66-E748-410F-BB9B-B632B254BDFB}"/>
              </a:ext>
            </a:extLst>
          </p:cNvPr>
          <p:cNvCxnSpPr>
            <a:cxnSpLocks/>
            <a:endCxn id="22" idx="3"/>
          </p:cNvCxnSpPr>
          <p:nvPr/>
        </p:nvCxnSpPr>
        <p:spPr>
          <a:xfrm flipH="1">
            <a:off x="1000154" y="1568295"/>
            <a:ext cx="908295" cy="0"/>
          </a:xfrm>
          <a:prstGeom prst="line">
            <a:avLst/>
          </a:prstGeom>
          <a:ln w="127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A4F48631-3605-414B-96A3-B4E7701F3903}"/>
              </a:ext>
            </a:extLst>
          </p:cNvPr>
          <p:cNvCxnSpPr>
            <a:cxnSpLocks/>
            <a:endCxn id="20" idx="3"/>
          </p:cNvCxnSpPr>
          <p:nvPr/>
        </p:nvCxnSpPr>
        <p:spPr>
          <a:xfrm flipH="1">
            <a:off x="1011131" y="2613436"/>
            <a:ext cx="893778" cy="0"/>
          </a:xfrm>
          <a:prstGeom prst="line">
            <a:avLst/>
          </a:prstGeom>
          <a:ln w="127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627423C8-B194-4935-85FA-5ED8C3D13EA3}"/>
              </a:ext>
            </a:extLst>
          </p:cNvPr>
          <p:cNvSpPr txBox="1"/>
          <p:nvPr/>
        </p:nvSpPr>
        <p:spPr>
          <a:xfrm>
            <a:off x="8172665" y="1486645"/>
            <a:ext cx="15215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Gotham Light" pitchFamily="2" charset="0"/>
              </a:rPr>
              <a:t>OGM Copy Number View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8ED1E75-B125-4C10-BB29-81E202553B2C}"/>
              </a:ext>
            </a:extLst>
          </p:cNvPr>
          <p:cNvSpPr txBox="1"/>
          <p:nvPr/>
        </p:nvSpPr>
        <p:spPr>
          <a:xfrm>
            <a:off x="2430740" y="305406"/>
            <a:ext cx="13516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Gotham Light" pitchFamily="2" charset="0"/>
              </a:rPr>
              <a:t>OGM </a:t>
            </a:r>
            <a:r>
              <a:rPr lang="en-US" sz="1000" b="1" dirty="0" err="1">
                <a:latin typeface="Gotham Light" pitchFamily="2" charset="0"/>
              </a:rPr>
              <a:t>Circos</a:t>
            </a:r>
            <a:r>
              <a:rPr lang="en-US" sz="1000" b="1" dirty="0">
                <a:latin typeface="Gotham Light" pitchFamily="2" charset="0"/>
              </a:rPr>
              <a:t> Plot View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7DECEAD3-1F4B-4349-B3E1-EC2281C752C7}"/>
              </a:ext>
            </a:extLst>
          </p:cNvPr>
          <p:cNvSpPr/>
          <p:nvPr/>
        </p:nvSpPr>
        <p:spPr>
          <a:xfrm rot="19815677">
            <a:off x="2012394" y="3136775"/>
            <a:ext cx="312664" cy="283231"/>
          </a:xfrm>
          <a:prstGeom prst="rect">
            <a:avLst/>
          </a:prstGeom>
          <a:noFill/>
          <a:ln w="12700">
            <a:solidFill>
              <a:srgbClr val="0001F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4423681D-AADF-4D62-AC9E-3FDDF18E21B9}"/>
              </a:ext>
            </a:extLst>
          </p:cNvPr>
          <p:cNvCxnSpPr>
            <a:cxnSpLocks/>
            <a:endCxn id="48" idx="3"/>
          </p:cNvCxnSpPr>
          <p:nvPr/>
        </p:nvCxnSpPr>
        <p:spPr>
          <a:xfrm flipH="1">
            <a:off x="2304469" y="1739698"/>
            <a:ext cx="3223092" cy="1461145"/>
          </a:xfrm>
          <a:prstGeom prst="line">
            <a:avLst/>
          </a:prstGeom>
          <a:ln w="12700">
            <a:solidFill>
              <a:srgbClr val="0001F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7E81840-D31A-48DD-9275-CD08F7D6F031}"/>
              </a:ext>
            </a:extLst>
          </p:cNvPr>
          <p:cNvCxnSpPr>
            <a:cxnSpLocks/>
            <a:stCxn id="48" idx="3"/>
          </p:cNvCxnSpPr>
          <p:nvPr/>
        </p:nvCxnSpPr>
        <p:spPr>
          <a:xfrm>
            <a:off x="2304469" y="3200843"/>
            <a:ext cx="3223092" cy="364625"/>
          </a:xfrm>
          <a:prstGeom prst="line">
            <a:avLst/>
          </a:prstGeom>
          <a:ln w="12700">
            <a:solidFill>
              <a:srgbClr val="0001F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Rectangle 87">
            <a:extLst>
              <a:ext uri="{FF2B5EF4-FFF2-40B4-BE49-F238E27FC236}">
                <a16:creationId xmlns:a16="http://schemas.microsoft.com/office/drawing/2014/main" id="{7309DE7D-82B3-4F46-B078-58EBF40D4703}"/>
              </a:ext>
            </a:extLst>
          </p:cNvPr>
          <p:cNvSpPr/>
          <p:nvPr/>
        </p:nvSpPr>
        <p:spPr>
          <a:xfrm>
            <a:off x="5547184" y="1739698"/>
            <a:ext cx="6289189" cy="184491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3B1F2AA-C6E8-4BA8-9C3E-AADD95A31E93}"/>
              </a:ext>
            </a:extLst>
          </p:cNvPr>
          <p:cNvSpPr txBox="1"/>
          <p:nvPr/>
        </p:nvSpPr>
        <p:spPr>
          <a:xfrm rot="20470552">
            <a:off x="2439382" y="615613"/>
            <a:ext cx="234360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</a:rPr>
              <a:t>X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38076EE-D1EB-4356-9361-84DA46C2351B}"/>
              </a:ext>
            </a:extLst>
          </p:cNvPr>
          <p:cNvSpPr txBox="1"/>
          <p:nvPr/>
        </p:nvSpPr>
        <p:spPr>
          <a:xfrm rot="21314788">
            <a:off x="2889653" y="531637"/>
            <a:ext cx="231154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</a:rPr>
              <a:t>Y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3EAC0E29-A0FD-42DD-8F3E-7B6BDF36A320}"/>
              </a:ext>
            </a:extLst>
          </p:cNvPr>
          <p:cNvSpPr/>
          <p:nvPr/>
        </p:nvSpPr>
        <p:spPr>
          <a:xfrm rot="16200000">
            <a:off x="5222618" y="2432615"/>
            <a:ext cx="86994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Copy Number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C3B2E742-FF55-4D80-8A82-03F353C11C9E}"/>
              </a:ext>
            </a:extLst>
          </p:cNvPr>
          <p:cNvSpPr/>
          <p:nvPr/>
        </p:nvSpPr>
        <p:spPr>
          <a:xfrm>
            <a:off x="8325964" y="3350024"/>
            <a:ext cx="91003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Chromosomes</a:t>
            </a: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5EB10151-CF0F-4162-A03A-2FB4661DCBE8}"/>
              </a:ext>
            </a:extLst>
          </p:cNvPr>
          <p:cNvCxnSpPr>
            <a:cxnSpLocks/>
          </p:cNvCxnSpPr>
          <p:nvPr/>
        </p:nvCxnSpPr>
        <p:spPr>
          <a:xfrm>
            <a:off x="5867906" y="2733361"/>
            <a:ext cx="402230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>
            <a:extLst>
              <a:ext uri="{FF2B5EF4-FFF2-40B4-BE49-F238E27FC236}">
                <a16:creationId xmlns:a16="http://schemas.microsoft.com/office/drawing/2014/main" id="{CC1A3F83-E94B-4F3C-9D62-2C0B7D404690}"/>
              </a:ext>
            </a:extLst>
          </p:cNvPr>
          <p:cNvSpPr/>
          <p:nvPr/>
        </p:nvSpPr>
        <p:spPr>
          <a:xfrm>
            <a:off x="2512957" y="2323601"/>
            <a:ext cx="116961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dirty="0"/>
              <a:t>47,XY,+13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32812E5-D6B9-4FEF-975D-E2E3D93D0E47}"/>
              </a:ext>
            </a:extLst>
          </p:cNvPr>
          <p:cNvSpPr txBox="1"/>
          <p:nvPr/>
        </p:nvSpPr>
        <p:spPr>
          <a:xfrm>
            <a:off x="11428475" y="3207995"/>
            <a:ext cx="213520" cy="15388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400" b="1">
                <a:solidFill>
                  <a:schemeClr val="tx1">
                    <a:lumMod val="65000"/>
                    <a:lumOff val="35000"/>
                  </a:schemeClr>
                </a:solidFill>
                <a:latin typeface="Gotham Light" pitchFamily="2" charset="0"/>
              </a:rPr>
              <a:t>X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06B5154-0B8D-4A97-9481-9F43337FAC30}"/>
              </a:ext>
            </a:extLst>
          </p:cNvPr>
          <p:cNvSpPr txBox="1"/>
          <p:nvPr/>
        </p:nvSpPr>
        <p:spPr>
          <a:xfrm>
            <a:off x="11668205" y="3208854"/>
            <a:ext cx="129654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4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Gotham Light" pitchFamily="2" charset="0"/>
              </a:rPr>
              <a:t>Y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7D04DB1-6D7F-4335-AAA1-99D44F3F14E9}"/>
              </a:ext>
            </a:extLst>
          </p:cNvPr>
          <p:cNvSpPr txBox="1"/>
          <p:nvPr/>
        </p:nvSpPr>
        <p:spPr>
          <a:xfrm>
            <a:off x="289983" y="151884"/>
            <a:ext cx="4106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Gotham Light" pitchFamily="2" charset="0"/>
              </a:rPr>
              <a:t>A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46833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 descr="A picture containing text, device&#10;&#10;Description automatically generated">
            <a:extLst>
              <a:ext uri="{FF2B5EF4-FFF2-40B4-BE49-F238E27FC236}">
                <a16:creationId xmlns:a16="http://schemas.microsoft.com/office/drawing/2014/main" id="{A87BA2ED-21CF-433D-A82D-F0066DDED1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64200" y="3392679"/>
            <a:ext cx="6304839" cy="1338089"/>
          </a:xfrm>
          <a:prstGeom prst="rect">
            <a:avLst/>
          </a:prstGeom>
        </p:spPr>
      </p:pic>
      <p:pic>
        <p:nvPicPr>
          <p:cNvPr id="3" name="Picture 2" descr="Chart, sunburst chart&#10;&#10;Description automatically generated">
            <a:extLst>
              <a:ext uri="{FF2B5EF4-FFF2-40B4-BE49-F238E27FC236}">
                <a16:creationId xmlns:a16="http://schemas.microsoft.com/office/drawing/2014/main" id="{89416CF9-2961-43A8-BE38-EB46493DB5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9868" y="752029"/>
            <a:ext cx="4514017" cy="4413903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627423C8-B194-4935-85FA-5ED8C3D13EA3}"/>
              </a:ext>
            </a:extLst>
          </p:cNvPr>
          <p:cNvSpPr txBox="1"/>
          <p:nvPr/>
        </p:nvSpPr>
        <p:spPr>
          <a:xfrm>
            <a:off x="8140718" y="2907578"/>
            <a:ext cx="15215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Gotham Light" pitchFamily="2" charset="0"/>
              </a:rPr>
              <a:t>OGM Copy Number View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8ED1E75-B125-4C10-BB29-81E202553B2C}"/>
              </a:ext>
            </a:extLst>
          </p:cNvPr>
          <p:cNvSpPr txBox="1"/>
          <p:nvPr/>
        </p:nvSpPr>
        <p:spPr>
          <a:xfrm>
            <a:off x="2144456" y="343862"/>
            <a:ext cx="13516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Gotham Light" pitchFamily="2" charset="0"/>
              </a:rPr>
              <a:t>OGM </a:t>
            </a:r>
            <a:r>
              <a:rPr lang="en-US" sz="1000" b="1" dirty="0" err="1">
                <a:latin typeface="Gotham Light" pitchFamily="2" charset="0"/>
              </a:rPr>
              <a:t>Circos</a:t>
            </a:r>
            <a:r>
              <a:rPr lang="en-US" sz="1000" b="1" dirty="0">
                <a:latin typeface="Gotham Light" pitchFamily="2" charset="0"/>
              </a:rPr>
              <a:t> Plot View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7DECEAD3-1F4B-4349-B3E1-EC2281C752C7}"/>
              </a:ext>
            </a:extLst>
          </p:cNvPr>
          <p:cNvSpPr/>
          <p:nvPr/>
        </p:nvSpPr>
        <p:spPr>
          <a:xfrm rot="17819650">
            <a:off x="1991557" y="4124195"/>
            <a:ext cx="312664" cy="113416"/>
          </a:xfrm>
          <a:prstGeom prst="rect">
            <a:avLst/>
          </a:prstGeom>
          <a:noFill/>
          <a:ln w="12700">
            <a:solidFill>
              <a:srgbClr val="0001F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4423681D-AADF-4D62-AC9E-3FDDF18E21B9}"/>
              </a:ext>
            </a:extLst>
          </p:cNvPr>
          <p:cNvCxnSpPr>
            <a:cxnSpLocks/>
            <a:stCxn id="55" idx="1"/>
            <a:endCxn id="48" idx="2"/>
          </p:cNvCxnSpPr>
          <p:nvPr/>
        </p:nvCxnSpPr>
        <p:spPr>
          <a:xfrm flipH="1">
            <a:off x="2198419" y="1812760"/>
            <a:ext cx="3043001" cy="2393883"/>
          </a:xfrm>
          <a:prstGeom prst="line">
            <a:avLst/>
          </a:prstGeom>
          <a:ln w="12700">
            <a:solidFill>
              <a:srgbClr val="0001F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7E81840-D31A-48DD-9275-CD08F7D6F031}"/>
              </a:ext>
            </a:extLst>
          </p:cNvPr>
          <p:cNvCxnSpPr>
            <a:cxnSpLocks/>
            <a:stCxn id="48" idx="2"/>
            <a:endCxn id="88" idx="1"/>
          </p:cNvCxnSpPr>
          <p:nvPr/>
        </p:nvCxnSpPr>
        <p:spPr>
          <a:xfrm flipV="1">
            <a:off x="2198419" y="4083088"/>
            <a:ext cx="3052972" cy="123555"/>
          </a:xfrm>
          <a:prstGeom prst="line">
            <a:avLst/>
          </a:prstGeom>
          <a:ln w="12700">
            <a:solidFill>
              <a:srgbClr val="0001F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Rectangle 87">
            <a:extLst>
              <a:ext uri="{FF2B5EF4-FFF2-40B4-BE49-F238E27FC236}">
                <a16:creationId xmlns:a16="http://schemas.microsoft.com/office/drawing/2014/main" id="{7309DE7D-82B3-4F46-B078-58EBF40D4703}"/>
              </a:ext>
            </a:extLst>
          </p:cNvPr>
          <p:cNvSpPr/>
          <p:nvPr/>
        </p:nvSpPr>
        <p:spPr>
          <a:xfrm>
            <a:off x="5251391" y="3160631"/>
            <a:ext cx="6759723" cy="184491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3B1F2AA-C6E8-4BA8-9C3E-AADD95A31E93}"/>
              </a:ext>
            </a:extLst>
          </p:cNvPr>
          <p:cNvSpPr txBox="1"/>
          <p:nvPr/>
        </p:nvSpPr>
        <p:spPr>
          <a:xfrm rot="20470552">
            <a:off x="1956543" y="777982"/>
            <a:ext cx="234360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</a:rPr>
              <a:t>X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38076EE-D1EB-4356-9361-84DA46C2351B}"/>
              </a:ext>
            </a:extLst>
          </p:cNvPr>
          <p:cNvSpPr txBox="1"/>
          <p:nvPr/>
        </p:nvSpPr>
        <p:spPr>
          <a:xfrm rot="21314788">
            <a:off x="2423907" y="672643"/>
            <a:ext cx="231154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</a:rPr>
              <a:t>Y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3EAC0E29-A0FD-42DD-8F3E-7B6BDF36A320}"/>
              </a:ext>
            </a:extLst>
          </p:cNvPr>
          <p:cNvSpPr/>
          <p:nvPr/>
        </p:nvSpPr>
        <p:spPr>
          <a:xfrm rot="16200000">
            <a:off x="5025514" y="3904585"/>
            <a:ext cx="86994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Copy Number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C3B2E742-FF55-4D80-8A82-03F353C11C9E}"/>
              </a:ext>
            </a:extLst>
          </p:cNvPr>
          <p:cNvSpPr/>
          <p:nvPr/>
        </p:nvSpPr>
        <p:spPr>
          <a:xfrm>
            <a:off x="8294017" y="4770957"/>
            <a:ext cx="91003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Chromosomes</a:t>
            </a: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5EB10151-CF0F-4162-A03A-2FB4661DCBE8}"/>
              </a:ext>
            </a:extLst>
          </p:cNvPr>
          <p:cNvCxnSpPr>
            <a:cxnSpLocks/>
          </p:cNvCxnSpPr>
          <p:nvPr/>
        </p:nvCxnSpPr>
        <p:spPr>
          <a:xfrm flipH="1">
            <a:off x="9503957" y="3875177"/>
            <a:ext cx="212951" cy="26595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732812E5-D6B9-4FEF-975D-E2E3D93D0E47}"/>
              </a:ext>
            </a:extLst>
          </p:cNvPr>
          <p:cNvSpPr txBox="1"/>
          <p:nvPr/>
        </p:nvSpPr>
        <p:spPr>
          <a:xfrm>
            <a:off x="11571717" y="4620382"/>
            <a:ext cx="213520" cy="15388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4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Gotham Light" pitchFamily="2" charset="0"/>
              </a:rPr>
              <a:t>X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06B5154-0B8D-4A97-9481-9F43337FAC30}"/>
              </a:ext>
            </a:extLst>
          </p:cNvPr>
          <p:cNvSpPr txBox="1"/>
          <p:nvPr/>
        </p:nvSpPr>
        <p:spPr>
          <a:xfrm>
            <a:off x="11828538" y="4621241"/>
            <a:ext cx="129654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4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Gotham Light" pitchFamily="2" charset="0"/>
              </a:rPr>
              <a:t>Y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7D04DB1-6D7F-4335-AAA1-99D44F3F14E9}"/>
              </a:ext>
            </a:extLst>
          </p:cNvPr>
          <p:cNvSpPr txBox="1"/>
          <p:nvPr/>
        </p:nvSpPr>
        <p:spPr>
          <a:xfrm>
            <a:off x="289983" y="151884"/>
            <a:ext cx="4106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Gotham Light" pitchFamily="2" charset="0"/>
              </a:rPr>
              <a:t>B.</a:t>
            </a:r>
            <a:endParaRPr lang="en-US" dirty="0"/>
          </a:p>
        </p:txBody>
      </p:sp>
      <p:pic>
        <p:nvPicPr>
          <p:cNvPr id="42" name="Picture 41" descr="A picture containing timeline&#10;&#10;Description automatically generated">
            <a:extLst>
              <a:ext uri="{FF2B5EF4-FFF2-40B4-BE49-F238E27FC236}">
                <a16:creationId xmlns:a16="http://schemas.microsoft.com/office/drawing/2014/main" id="{81257E0E-7E90-4137-8531-102945D85D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80099" y="1029772"/>
            <a:ext cx="6094289" cy="1564683"/>
          </a:xfrm>
          <a:prstGeom prst="rect">
            <a:avLst/>
          </a:prstGeom>
        </p:spPr>
      </p:pic>
      <p:sp>
        <p:nvSpPr>
          <p:cNvPr id="55" name="Rectangle 54">
            <a:extLst>
              <a:ext uri="{FF2B5EF4-FFF2-40B4-BE49-F238E27FC236}">
                <a16:creationId xmlns:a16="http://schemas.microsoft.com/office/drawing/2014/main" id="{C6BE4A34-B7D7-499E-83B7-11106E08C6DD}"/>
              </a:ext>
            </a:extLst>
          </p:cNvPr>
          <p:cNvSpPr/>
          <p:nvPr/>
        </p:nvSpPr>
        <p:spPr>
          <a:xfrm>
            <a:off x="5241420" y="890303"/>
            <a:ext cx="6759723" cy="184491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078E741-6FB6-4560-8393-F2D74C732C4D}"/>
              </a:ext>
            </a:extLst>
          </p:cNvPr>
          <p:cNvSpPr txBox="1"/>
          <p:nvPr/>
        </p:nvSpPr>
        <p:spPr>
          <a:xfrm>
            <a:off x="8058108" y="643828"/>
            <a:ext cx="1233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Gotham Light" pitchFamily="2" charset="0"/>
              </a:rPr>
              <a:t>OGM Browser View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D77A4C8D-C1FE-4A10-96B3-457C22F17E74}"/>
              </a:ext>
            </a:extLst>
          </p:cNvPr>
          <p:cNvSpPr/>
          <p:nvPr/>
        </p:nvSpPr>
        <p:spPr>
          <a:xfrm>
            <a:off x="5359400" y="1829484"/>
            <a:ext cx="382188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900" dirty="0"/>
              <a:t>Sample </a:t>
            </a:r>
          </a:p>
          <a:p>
            <a:pPr algn="ctr"/>
            <a:r>
              <a:rPr lang="en-US" sz="900" dirty="0"/>
              <a:t>Map 1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EA1805BD-33BF-4C02-8CE7-A436EC3EFDBE}"/>
              </a:ext>
            </a:extLst>
          </p:cNvPr>
          <p:cNvSpPr/>
          <p:nvPr/>
        </p:nvSpPr>
        <p:spPr>
          <a:xfrm>
            <a:off x="4860210" y="2224816"/>
            <a:ext cx="937503" cy="1384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sz="900" dirty="0"/>
              <a:t>Ref </a:t>
            </a:r>
            <a:r>
              <a:rPr lang="en-US" sz="900" dirty="0" err="1"/>
              <a:t>Chr</a:t>
            </a:r>
            <a:r>
              <a:rPr lang="en-US" sz="900" dirty="0"/>
              <a:t> 11</a:t>
            </a: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B3E4F9CD-90D5-46B0-92E4-E92A2F878159}"/>
              </a:ext>
            </a:extLst>
          </p:cNvPr>
          <p:cNvSpPr/>
          <p:nvPr/>
        </p:nvSpPr>
        <p:spPr>
          <a:xfrm>
            <a:off x="5384800" y="2394634"/>
            <a:ext cx="382188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900" dirty="0"/>
              <a:t>Sample </a:t>
            </a:r>
          </a:p>
          <a:p>
            <a:pPr algn="ctr"/>
            <a:r>
              <a:rPr lang="en-US" sz="900" dirty="0"/>
              <a:t>Map 2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28F67F68-8291-4DDC-AAA9-3B9AA20CEE6B}"/>
              </a:ext>
            </a:extLst>
          </p:cNvPr>
          <p:cNvSpPr/>
          <p:nvPr/>
        </p:nvSpPr>
        <p:spPr>
          <a:xfrm>
            <a:off x="5346700" y="1359584"/>
            <a:ext cx="382188" cy="1384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900" dirty="0"/>
              <a:t>SV track</a:t>
            </a:r>
          </a:p>
        </p:txBody>
      </p:sp>
    </p:spTree>
    <p:extLst>
      <p:ext uri="{BB962C8B-B14F-4D97-AF65-F5344CB8AC3E}">
        <p14:creationId xmlns:p14="http://schemas.microsoft.com/office/powerpoint/2010/main" val="3675794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Chart&#10;&#10;Description automatically generated">
            <a:extLst>
              <a:ext uri="{FF2B5EF4-FFF2-40B4-BE49-F238E27FC236}">
                <a16:creationId xmlns:a16="http://schemas.microsoft.com/office/drawing/2014/main" id="{BD5DD64E-13E5-4AD9-8038-145E39A0E3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19987" y="595106"/>
            <a:ext cx="6370909" cy="1324430"/>
          </a:xfrm>
          <a:prstGeom prst="rect">
            <a:avLst/>
          </a:prstGeom>
        </p:spPr>
      </p:pic>
      <p:pic>
        <p:nvPicPr>
          <p:cNvPr id="6" name="Picture 5" descr="Chart, sunburst chart&#10;&#10;Description automatically generated">
            <a:extLst>
              <a:ext uri="{FF2B5EF4-FFF2-40B4-BE49-F238E27FC236}">
                <a16:creationId xmlns:a16="http://schemas.microsoft.com/office/drawing/2014/main" id="{6595B8DF-6171-4E00-B565-B3909597F7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0350" y="628649"/>
            <a:ext cx="4922584" cy="4888585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627423C8-B194-4935-85FA-5ED8C3D13EA3}"/>
              </a:ext>
            </a:extLst>
          </p:cNvPr>
          <p:cNvSpPr txBox="1"/>
          <p:nvPr/>
        </p:nvSpPr>
        <p:spPr>
          <a:xfrm>
            <a:off x="7927072" y="96008"/>
            <a:ext cx="15215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Gotham Light" pitchFamily="2" charset="0"/>
              </a:rPr>
              <a:t>OGM Copy Number View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8ED1E75-B125-4C10-BB29-81E202553B2C}"/>
              </a:ext>
            </a:extLst>
          </p:cNvPr>
          <p:cNvSpPr txBox="1"/>
          <p:nvPr/>
        </p:nvSpPr>
        <p:spPr>
          <a:xfrm>
            <a:off x="2144456" y="343862"/>
            <a:ext cx="13516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Gotham Light" pitchFamily="2" charset="0"/>
              </a:rPr>
              <a:t>OGM </a:t>
            </a:r>
            <a:r>
              <a:rPr lang="en-US" sz="1000" b="1" dirty="0" err="1">
                <a:latin typeface="Gotham Light" pitchFamily="2" charset="0"/>
              </a:rPr>
              <a:t>Circos</a:t>
            </a:r>
            <a:r>
              <a:rPr lang="en-US" sz="1000" b="1" dirty="0">
                <a:latin typeface="Gotham Light" pitchFamily="2" charset="0"/>
              </a:rPr>
              <a:t> Plot View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7DECEAD3-1F4B-4349-B3E1-EC2281C752C7}"/>
              </a:ext>
            </a:extLst>
          </p:cNvPr>
          <p:cNvSpPr/>
          <p:nvPr/>
        </p:nvSpPr>
        <p:spPr>
          <a:xfrm rot="19091043">
            <a:off x="1435261" y="3981090"/>
            <a:ext cx="393044" cy="208778"/>
          </a:xfrm>
          <a:prstGeom prst="rect">
            <a:avLst/>
          </a:prstGeom>
          <a:noFill/>
          <a:ln w="12700">
            <a:solidFill>
              <a:srgbClr val="0001F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4423681D-AADF-4D62-AC9E-3FDDF18E21B9}"/>
              </a:ext>
            </a:extLst>
          </p:cNvPr>
          <p:cNvCxnSpPr>
            <a:cxnSpLocks/>
            <a:stCxn id="31" idx="1"/>
            <a:endCxn id="48" idx="2"/>
          </p:cNvCxnSpPr>
          <p:nvPr/>
        </p:nvCxnSpPr>
        <p:spPr>
          <a:xfrm flipH="1">
            <a:off x="1701383" y="3453551"/>
            <a:ext cx="3569947" cy="709728"/>
          </a:xfrm>
          <a:prstGeom prst="line">
            <a:avLst/>
          </a:prstGeom>
          <a:ln w="12700">
            <a:solidFill>
              <a:srgbClr val="0001F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7E81840-D31A-48DD-9275-CD08F7D6F031}"/>
              </a:ext>
            </a:extLst>
          </p:cNvPr>
          <p:cNvCxnSpPr>
            <a:cxnSpLocks/>
            <a:stCxn id="48" idx="2"/>
            <a:endCxn id="88" idx="1"/>
          </p:cNvCxnSpPr>
          <p:nvPr/>
        </p:nvCxnSpPr>
        <p:spPr>
          <a:xfrm flipV="1">
            <a:off x="1701383" y="1309974"/>
            <a:ext cx="3575645" cy="2853305"/>
          </a:xfrm>
          <a:prstGeom prst="line">
            <a:avLst/>
          </a:prstGeom>
          <a:ln w="12700">
            <a:solidFill>
              <a:srgbClr val="0001F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Rectangle 87">
            <a:extLst>
              <a:ext uri="{FF2B5EF4-FFF2-40B4-BE49-F238E27FC236}">
                <a16:creationId xmlns:a16="http://schemas.microsoft.com/office/drawing/2014/main" id="{7309DE7D-82B3-4F46-B078-58EBF40D4703}"/>
              </a:ext>
            </a:extLst>
          </p:cNvPr>
          <p:cNvSpPr/>
          <p:nvPr/>
        </p:nvSpPr>
        <p:spPr>
          <a:xfrm>
            <a:off x="5277028" y="387517"/>
            <a:ext cx="6759723" cy="184491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3B1F2AA-C6E8-4BA8-9C3E-AADD95A31E93}"/>
              </a:ext>
            </a:extLst>
          </p:cNvPr>
          <p:cNvSpPr txBox="1"/>
          <p:nvPr/>
        </p:nvSpPr>
        <p:spPr>
          <a:xfrm rot="20470552">
            <a:off x="1854943" y="714483"/>
            <a:ext cx="234360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</a:rPr>
              <a:t>X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38076EE-D1EB-4356-9361-84DA46C2351B}"/>
              </a:ext>
            </a:extLst>
          </p:cNvPr>
          <p:cNvSpPr txBox="1"/>
          <p:nvPr/>
        </p:nvSpPr>
        <p:spPr>
          <a:xfrm rot="21314788">
            <a:off x="2404857" y="602793"/>
            <a:ext cx="231154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</a:rPr>
              <a:t>Y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3EAC0E29-A0FD-42DD-8F3E-7B6BDF36A320}"/>
              </a:ext>
            </a:extLst>
          </p:cNvPr>
          <p:cNvSpPr/>
          <p:nvPr/>
        </p:nvSpPr>
        <p:spPr>
          <a:xfrm rot="16200000">
            <a:off x="5051151" y="1131471"/>
            <a:ext cx="86994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Copy Number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C3B2E742-FF55-4D80-8A82-03F353C11C9E}"/>
              </a:ext>
            </a:extLst>
          </p:cNvPr>
          <p:cNvSpPr/>
          <p:nvPr/>
        </p:nvSpPr>
        <p:spPr>
          <a:xfrm>
            <a:off x="8319654" y="1997843"/>
            <a:ext cx="91003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Chromosomes</a:t>
            </a: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5EB10151-CF0F-4162-A03A-2FB4661DCBE8}"/>
              </a:ext>
            </a:extLst>
          </p:cNvPr>
          <p:cNvCxnSpPr>
            <a:cxnSpLocks/>
          </p:cNvCxnSpPr>
          <p:nvPr/>
        </p:nvCxnSpPr>
        <p:spPr>
          <a:xfrm flipH="1">
            <a:off x="9954467" y="931190"/>
            <a:ext cx="212951" cy="26595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732812E5-D6B9-4FEF-975D-E2E3D93D0E47}"/>
              </a:ext>
            </a:extLst>
          </p:cNvPr>
          <p:cNvSpPr txBox="1"/>
          <p:nvPr/>
        </p:nvSpPr>
        <p:spPr>
          <a:xfrm>
            <a:off x="11597354" y="1821868"/>
            <a:ext cx="213520" cy="15388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4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Gotham Light" pitchFamily="2" charset="0"/>
              </a:rPr>
              <a:t>X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06B5154-0B8D-4A97-9481-9F43337FAC30}"/>
              </a:ext>
            </a:extLst>
          </p:cNvPr>
          <p:cNvSpPr txBox="1"/>
          <p:nvPr/>
        </p:nvSpPr>
        <p:spPr>
          <a:xfrm>
            <a:off x="11841475" y="1822727"/>
            <a:ext cx="129654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4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Gotham Light" pitchFamily="2" charset="0"/>
              </a:rPr>
              <a:t>Y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7D04DB1-6D7F-4335-AAA1-99D44F3F14E9}"/>
              </a:ext>
            </a:extLst>
          </p:cNvPr>
          <p:cNvSpPr txBox="1"/>
          <p:nvPr/>
        </p:nvSpPr>
        <p:spPr>
          <a:xfrm>
            <a:off x="289983" y="151884"/>
            <a:ext cx="4106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Gotham Light" pitchFamily="2" charset="0"/>
              </a:rPr>
              <a:t>C.</a:t>
            </a:r>
            <a:endParaRPr lang="en-US" dirty="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E963D761-4F43-4E59-9052-2DA434FFDFA9}"/>
              </a:ext>
            </a:extLst>
          </p:cNvPr>
          <p:cNvSpPr/>
          <p:nvPr/>
        </p:nvSpPr>
        <p:spPr>
          <a:xfrm>
            <a:off x="5271330" y="2531094"/>
            <a:ext cx="6759723" cy="184491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438C304-83B8-45CD-A109-05E6C21D2CB4}"/>
              </a:ext>
            </a:extLst>
          </p:cNvPr>
          <p:cNvSpPr txBox="1"/>
          <p:nvPr/>
        </p:nvSpPr>
        <p:spPr>
          <a:xfrm>
            <a:off x="8092290" y="2299402"/>
            <a:ext cx="1233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Gotham Light" pitchFamily="2" charset="0"/>
              </a:rPr>
              <a:t>OGM Browser View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64EFE294-4029-440F-BC4D-C634019521E7}"/>
              </a:ext>
            </a:extLst>
          </p:cNvPr>
          <p:cNvSpPr/>
          <p:nvPr/>
        </p:nvSpPr>
        <p:spPr>
          <a:xfrm>
            <a:off x="5389310" y="3381375"/>
            <a:ext cx="382188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900" dirty="0"/>
              <a:t>Sample </a:t>
            </a:r>
          </a:p>
          <a:p>
            <a:pPr algn="ctr"/>
            <a:r>
              <a:rPr lang="en-US" sz="900" dirty="0"/>
              <a:t>Map 1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33F1CEA-23E9-4F34-B4B1-26A1C9467F1D}"/>
              </a:ext>
            </a:extLst>
          </p:cNvPr>
          <p:cNvSpPr/>
          <p:nvPr/>
        </p:nvSpPr>
        <p:spPr>
          <a:xfrm>
            <a:off x="5414710" y="4035425"/>
            <a:ext cx="382188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900" dirty="0"/>
              <a:t>Sample </a:t>
            </a:r>
          </a:p>
          <a:p>
            <a:pPr algn="ctr"/>
            <a:r>
              <a:rPr lang="en-US" sz="900" dirty="0"/>
              <a:t>Map 2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CAE60184-4C09-4691-97B9-5DDCCFE48AE5}"/>
              </a:ext>
            </a:extLst>
          </p:cNvPr>
          <p:cNvSpPr/>
          <p:nvPr/>
        </p:nvSpPr>
        <p:spPr>
          <a:xfrm>
            <a:off x="5389310" y="3038475"/>
            <a:ext cx="382188" cy="1384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900" dirty="0"/>
              <a:t>SV track</a:t>
            </a:r>
          </a:p>
        </p:txBody>
      </p:sp>
      <p:pic>
        <p:nvPicPr>
          <p:cNvPr id="37" name="Picture 36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60D00180-6AAE-439B-9C8E-4781C263271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71910" y="2595521"/>
            <a:ext cx="6115050" cy="1673033"/>
          </a:xfrm>
          <a:prstGeom prst="rect">
            <a:avLst/>
          </a:prstGeom>
        </p:spPr>
      </p:pic>
      <p:sp>
        <p:nvSpPr>
          <p:cNvPr id="38" name="Rectangle 37">
            <a:extLst>
              <a:ext uri="{FF2B5EF4-FFF2-40B4-BE49-F238E27FC236}">
                <a16:creationId xmlns:a16="http://schemas.microsoft.com/office/drawing/2014/main" id="{FCA4F469-CCEE-40FD-8FAA-C87C4CBFAAB4}"/>
              </a:ext>
            </a:extLst>
          </p:cNvPr>
          <p:cNvSpPr/>
          <p:nvPr/>
        </p:nvSpPr>
        <p:spPr>
          <a:xfrm>
            <a:off x="4873029" y="3859493"/>
            <a:ext cx="937503" cy="1384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sz="900" dirty="0"/>
              <a:t>Ref </a:t>
            </a:r>
            <a:r>
              <a:rPr lang="en-US" sz="900" dirty="0" err="1"/>
              <a:t>Chr</a:t>
            </a:r>
            <a:r>
              <a:rPr lang="en-US" sz="900" dirty="0"/>
              <a:t> 12</a:t>
            </a:r>
          </a:p>
        </p:txBody>
      </p:sp>
      <p:pic>
        <p:nvPicPr>
          <p:cNvPr id="14" name="Picture 13" descr="Timeline&#10;&#10;Description automatically generated">
            <a:extLst>
              <a:ext uri="{FF2B5EF4-FFF2-40B4-BE49-F238E27FC236}">
                <a16:creationId xmlns:a16="http://schemas.microsoft.com/office/drawing/2014/main" id="{DA62DBE8-4663-4B36-9CB2-D04CCB667CD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62628" y="4774087"/>
            <a:ext cx="3517964" cy="187881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3" name="Picture 42" descr="Chart&#10;&#10;Description automatically generated">
            <a:extLst>
              <a:ext uri="{FF2B5EF4-FFF2-40B4-BE49-F238E27FC236}">
                <a16:creationId xmlns:a16="http://schemas.microsoft.com/office/drawing/2014/main" id="{293CC650-5941-4822-B2FB-022715A6165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045865" y="4621542"/>
            <a:ext cx="3969522" cy="134919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46" name="Rectangle 45">
            <a:extLst>
              <a:ext uri="{FF2B5EF4-FFF2-40B4-BE49-F238E27FC236}">
                <a16:creationId xmlns:a16="http://schemas.microsoft.com/office/drawing/2014/main" id="{5933B143-BE76-4414-A533-7CE5ECC1745B}"/>
              </a:ext>
            </a:extLst>
          </p:cNvPr>
          <p:cNvSpPr/>
          <p:nvPr/>
        </p:nvSpPr>
        <p:spPr>
          <a:xfrm rot="16200000">
            <a:off x="11126941" y="3418634"/>
            <a:ext cx="1534774" cy="207935"/>
          </a:xfrm>
          <a:prstGeom prst="rect">
            <a:avLst/>
          </a:prstGeom>
          <a:noFill/>
          <a:ln w="12700">
            <a:solidFill>
              <a:srgbClr val="0001F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C76B2C81-59FB-4F72-AFFE-88348080CBF3}"/>
              </a:ext>
            </a:extLst>
          </p:cNvPr>
          <p:cNvCxnSpPr>
            <a:cxnSpLocks/>
            <a:stCxn id="43" idx="0"/>
            <a:endCxn id="46" idx="1"/>
          </p:cNvCxnSpPr>
          <p:nvPr/>
        </p:nvCxnSpPr>
        <p:spPr>
          <a:xfrm flipV="1">
            <a:off x="10030626" y="4289989"/>
            <a:ext cx="1863703" cy="331553"/>
          </a:xfrm>
          <a:prstGeom prst="line">
            <a:avLst/>
          </a:prstGeom>
          <a:ln w="12700">
            <a:solidFill>
              <a:srgbClr val="0001F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>
            <a:extLst>
              <a:ext uri="{FF2B5EF4-FFF2-40B4-BE49-F238E27FC236}">
                <a16:creationId xmlns:a16="http://schemas.microsoft.com/office/drawing/2014/main" id="{18C599E3-4032-4F4A-8F81-442EBF276543}"/>
              </a:ext>
            </a:extLst>
          </p:cNvPr>
          <p:cNvSpPr/>
          <p:nvPr/>
        </p:nvSpPr>
        <p:spPr>
          <a:xfrm rot="16200000">
            <a:off x="9018979" y="3412937"/>
            <a:ext cx="1534774" cy="207935"/>
          </a:xfrm>
          <a:prstGeom prst="rect">
            <a:avLst/>
          </a:prstGeom>
          <a:noFill/>
          <a:ln w="12700">
            <a:solidFill>
              <a:srgbClr val="0001F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532A5246-3D8F-4113-9A9C-DD7DEDE46C07}"/>
              </a:ext>
            </a:extLst>
          </p:cNvPr>
          <p:cNvCxnSpPr>
            <a:cxnSpLocks/>
            <a:stCxn id="14" idx="0"/>
            <a:endCxn id="50" idx="1"/>
          </p:cNvCxnSpPr>
          <p:nvPr/>
        </p:nvCxnSpPr>
        <p:spPr>
          <a:xfrm flipV="1">
            <a:off x="6121610" y="4284292"/>
            <a:ext cx="3664757" cy="489795"/>
          </a:xfrm>
          <a:prstGeom prst="line">
            <a:avLst/>
          </a:prstGeom>
          <a:ln w="12700">
            <a:solidFill>
              <a:srgbClr val="0001F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>
            <a:extLst>
              <a:ext uri="{FF2B5EF4-FFF2-40B4-BE49-F238E27FC236}">
                <a16:creationId xmlns:a16="http://schemas.microsoft.com/office/drawing/2014/main" id="{E83FEB94-1BE5-4382-B4A0-9B591263E5DF}"/>
              </a:ext>
            </a:extLst>
          </p:cNvPr>
          <p:cNvSpPr/>
          <p:nvPr/>
        </p:nvSpPr>
        <p:spPr>
          <a:xfrm rot="16200000">
            <a:off x="5034908" y="6171493"/>
            <a:ext cx="457200" cy="462885"/>
          </a:xfrm>
          <a:prstGeom prst="rect">
            <a:avLst/>
          </a:prstGeom>
          <a:noFill/>
          <a:ln w="12700">
            <a:solidFill>
              <a:srgbClr val="0001F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31CE57E1-DCBF-4B61-B759-996C1E2A7749}"/>
              </a:ext>
            </a:extLst>
          </p:cNvPr>
          <p:cNvSpPr/>
          <p:nvPr/>
        </p:nvSpPr>
        <p:spPr>
          <a:xfrm rot="16200000">
            <a:off x="11432147" y="5031344"/>
            <a:ext cx="522717" cy="635222"/>
          </a:xfrm>
          <a:prstGeom prst="rect">
            <a:avLst/>
          </a:prstGeom>
          <a:noFill/>
          <a:ln w="12700">
            <a:solidFill>
              <a:srgbClr val="0001F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1989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27D04DB1-6D7F-4335-AAA1-99D44F3F14E9}"/>
              </a:ext>
            </a:extLst>
          </p:cNvPr>
          <p:cNvSpPr txBox="1"/>
          <p:nvPr/>
        </p:nvSpPr>
        <p:spPr>
          <a:xfrm>
            <a:off x="289983" y="151884"/>
            <a:ext cx="4106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Gotham Light" pitchFamily="2" charset="0"/>
              </a:rPr>
              <a:t>D.</a:t>
            </a:r>
            <a:endParaRPr lang="en-US" dirty="0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C6930C5C-1A06-4122-AEF1-3939C5BC870A}"/>
              </a:ext>
            </a:extLst>
          </p:cNvPr>
          <p:cNvSpPr/>
          <p:nvPr/>
        </p:nvSpPr>
        <p:spPr>
          <a:xfrm>
            <a:off x="878367" y="576446"/>
            <a:ext cx="10534855" cy="227922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1A14296C-A126-4A4E-83FF-3B21985FF6C3}"/>
              </a:ext>
            </a:extLst>
          </p:cNvPr>
          <p:cNvSpPr/>
          <p:nvPr/>
        </p:nvSpPr>
        <p:spPr>
          <a:xfrm>
            <a:off x="997560" y="2109794"/>
            <a:ext cx="625002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800" dirty="0"/>
              <a:t>Sample Map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8AE1C1CF-2982-46EE-BBB5-F2BFC3AE3ED5}"/>
              </a:ext>
            </a:extLst>
          </p:cNvPr>
          <p:cNvSpPr/>
          <p:nvPr/>
        </p:nvSpPr>
        <p:spPr>
          <a:xfrm>
            <a:off x="1063674" y="1791161"/>
            <a:ext cx="625002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800" dirty="0"/>
              <a:t>Ref </a:t>
            </a:r>
            <a:r>
              <a:rPr lang="en-US" sz="800" dirty="0" err="1"/>
              <a:t>Chr</a:t>
            </a:r>
            <a:r>
              <a:rPr lang="en-US" sz="800" dirty="0"/>
              <a:t> 9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3B7C139F-6476-4E93-B928-A38566762C3A}"/>
              </a:ext>
            </a:extLst>
          </p:cNvPr>
          <p:cNvSpPr/>
          <p:nvPr/>
        </p:nvSpPr>
        <p:spPr>
          <a:xfrm>
            <a:off x="1052597" y="2567357"/>
            <a:ext cx="625002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800" dirty="0"/>
              <a:t>Ref </a:t>
            </a:r>
            <a:r>
              <a:rPr lang="en-US" sz="800" dirty="0" err="1"/>
              <a:t>Chr</a:t>
            </a:r>
            <a:r>
              <a:rPr lang="en-US" sz="800" dirty="0"/>
              <a:t> 21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C3FB21F2-301A-4C0F-B759-287A936DA90E}"/>
              </a:ext>
            </a:extLst>
          </p:cNvPr>
          <p:cNvSpPr/>
          <p:nvPr/>
        </p:nvSpPr>
        <p:spPr>
          <a:xfrm>
            <a:off x="1069131" y="1174756"/>
            <a:ext cx="478044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800" dirty="0"/>
              <a:t>CNV Track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EE35313-B80B-4C60-AC98-1196045232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3715" y="642648"/>
            <a:ext cx="9607934" cy="206143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18FD5EC-CCB8-45C4-AA26-CE4D3B946B2D}"/>
              </a:ext>
            </a:extLst>
          </p:cNvPr>
          <p:cNvSpPr txBox="1"/>
          <p:nvPr/>
        </p:nvSpPr>
        <p:spPr>
          <a:xfrm>
            <a:off x="289983" y="3009384"/>
            <a:ext cx="4106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Gotham Light" pitchFamily="2" charset="0"/>
              </a:rPr>
              <a:t>E.</a:t>
            </a:r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7B0C2FB-367A-4468-A7A5-1476E4765510}"/>
              </a:ext>
            </a:extLst>
          </p:cNvPr>
          <p:cNvSpPr/>
          <p:nvPr/>
        </p:nvSpPr>
        <p:spPr>
          <a:xfrm>
            <a:off x="878367" y="3433946"/>
            <a:ext cx="10534855" cy="1971036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D16470C1-6BBF-4680-97EA-8EEAF33BAA35}"/>
              </a:ext>
            </a:extLst>
          </p:cNvPr>
          <p:cNvSpPr/>
          <p:nvPr/>
        </p:nvSpPr>
        <p:spPr>
          <a:xfrm>
            <a:off x="953552" y="5172667"/>
            <a:ext cx="625002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800" dirty="0"/>
              <a:t>Sample Map 2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104E8C0-8D44-4913-BC41-1A8304AD0443}"/>
              </a:ext>
            </a:extLst>
          </p:cNvPr>
          <p:cNvSpPr/>
          <p:nvPr/>
        </p:nvSpPr>
        <p:spPr>
          <a:xfrm>
            <a:off x="1019665" y="4624211"/>
            <a:ext cx="625002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800" dirty="0"/>
              <a:t>Ref </a:t>
            </a:r>
            <a:r>
              <a:rPr lang="en-US" sz="800" dirty="0" err="1"/>
              <a:t>Chr</a:t>
            </a:r>
            <a:r>
              <a:rPr lang="en-US" sz="800" dirty="0"/>
              <a:t> 2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FBAF37F-1B94-45EC-A133-CEFB26A81DB4}"/>
              </a:ext>
            </a:extLst>
          </p:cNvPr>
          <p:cNvSpPr/>
          <p:nvPr/>
        </p:nvSpPr>
        <p:spPr>
          <a:xfrm>
            <a:off x="954800" y="4212177"/>
            <a:ext cx="625002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800" dirty="0"/>
              <a:t>Sample Map 1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FAC1FB4-A8EF-438D-BB34-6981ADDE7974}"/>
              </a:ext>
            </a:extLst>
          </p:cNvPr>
          <p:cNvSpPr/>
          <p:nvPr/>
        </p:nvSpPr>
        <p:spPr>
          <a:xfrm>
            <a:off x="1059351" y="3910010"/>
            <a:ext cx="478044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800" dirty="0"/>
              <a:t>Genes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8B36E3C8-D739-4A42-86DF-1D8C91F273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8132" y="3708876"/>
            <a:ext cx="9542477" cy="162523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C4B6027-5932-4898-9413-36DA8C8D20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07159" y="3473764"/>
            <a:ext cx="9559255" cy="220858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DA936DED-808B-4696-B141-ABFB9BDC7E24}"/>
              </a:ext>
            </a:extLst>
          </p:cNvPr>
          <p:cNvSpPr/>
          <p:nvPr/>
        </p:nvSpPr>
        <p:spPr>
          <a:xfrm>
            <a:off x="4591577" y="4918201"/>
            <a:ext cx="625002" cy="18466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200" b="1" dirty="0"/>
              <a:t>45.5 kbp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A8B938B4-90AB-4D3C-BB4F-AD76061C7A60}"/>
              </a:ext>
            </a:extLst>
          </p:cNvPr>
          <p:cNvCxnSpPr/>
          <p:nvPr/>
        </p:nvCxnSpPr>
        <p:spPr>
          <a:xfrm>
            <a:off x="9433420" y="5038632"/>
            <a:ext cx="1786855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>
            <a:extLst>
              <a:ext uri="{FF2B5EF4-FFF2-40B4-BE49-F238E27FC236}">
                <a16:creationId xmlns:a16="http://schemas.microsoft.com/office/drawing/2014/main" id="{B141BA14-43EF-4FBF-A060-B12FDA82F529}"/>
              </a:ext>
            </a:extLst>
          </p:cNvPr>
          <p:cNvSpPr/>
          <p:nvPr/>
        </p:nvSpPr>
        <p:spPr>
          <a:xfrm>
            <a:off x="10023449" y="4863666"/>
            <a:ext cx="625002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800" dirty="0"/>
              <a:t>No DLS labels</a:t>
            </a:r>
          </a:p>
        </p:txBody>
      </p:sp>
    </p:spTree>
    <p:extLst>
      <p:ext uri="{BB962C8B-B14F-4D97-AF65-F5344CB8AC3E}">
        <p14:creationId xmlns:p14="http://schemas.microsoft.com/office/powerpoint/2010/main" val="189438021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080993487106C48AF58DDEF95D72879" ma:contentTypeVersion="17" ma:contentTypeDescription="Create a new document." ma:contentTypeScope="" ma:versionID="a7296b9f4301bb64b6683a00e7e0aa2b">
  <xsd:schema xmlns:xsd="http://www.w3.org/2001/XMLSchema" xmlns:xs="http://www.w3.org/2001/XMLSchema" xmlns:p="http://schemas.microsoft.com/office/2006/metadata/properties" xmlns:ns2="17ad48cb-924a-4ad2-b63e-557a9dc1d180" xmlns:ns3="35fa4d3d-72ea-4ff4-b9f3-de83ca151370" targetNamespace="http://schemas.microsoft.com/office/2006/metadata/properties" ma:root="true" ma:fieldsID="358ec9f03750049b9d40b2468cfa2c66" ns2:_="" ns3:_="">
    <xsd:import namespace="17ad48cb-924a-4ad2-b63e-557a9dc1d180"/>
    <xsd:import namespace="35fa4d3d-72ea-4ff4-b9f3-de83ca15137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7ad48cb-924a-4ad2-b63e-557a9dc1d18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088e7e2f-d067-4d7f-bc3a-669ef235ae6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fa4d3d-72ea-4ff4-b9f3-de83ca151370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b394af82-1a90-49dd-a3de-d2dd7af22dd0}" ma:internalName="TaxCatchAll" ma:showField="CatchAllData" ma:web="35fa4d3d-72ea-4ff4-b9f3-de83ca15137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7ad48cb-924a-4ad2-b63e-557a9dc1d180">
      <Terms xmlns="http://schemas.microsoft.com/office/infopath/2007/PartnerControls"/>
    </lcf76f155ced4ddcb4097134ff3c332f>
    <TaxCatchAll xmlns="35fa4d3d-72ea-4ff4-b9f3-de83ca151370" xsi:nil="true"/>
  </documentManagement>
</p:properties>
</file>

<file path=customXml/itemProps1.xml><?xml version="1.0" encoding="utf-8"?>
<ds:datastoreItem xmlns:ds="http://schemas.openxmlformats.org/officeDocument/2006/customXml" ds:itemID="{890AF262-A2A7-4014-8752-91D312310F65}"/>
</file>

<file path=customXml/itemProps2.xml><?xml version="1.0" encoding="utf-8"?>
<ds:datastoreItem xmlns:ds="http://schemas.openxmlformats.org/officeDocument/2006/customXml" ds:itemID="{8EB8172E-19CF-4B61-863A-FCB60BB52EA5}"/>
</file>

<file path=customXml/itemProps3.xml><?xml version="1.0" encoding="utf-8"?>
<ds:datastoreItem xmlns:ds="http://schemas.openxmlformats.org/officeDocument/2006/customXml" ds:itemID="{4197D5B2-7962-48D5-9465-D401B04A4681}"/>
</file>

<file path=docProps/app.xml><?xml version="1.0" encoding="utf-8"?>
<Properties xmlns="http://schemas.openxmlformats.org/officeDocument/2006/extended-properties" xmlns:vt="http://schemas.openxmlformats.org/officeDocument/2006/docPropsVTypes">
  <Template>Ion</Template>
  <TotalTime>3737</TotalTime>
  <Words>219</Words>
  <Application>Microsoft Office PowerPoint</Application>
  <PresentationFormat>Widescreen</PresentationFormat>
  <Paragraphs>72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Gotham</vt:lpstr>
      <vt:lpstr>Gotham Light</vt:lpstr>
      <vt:lpstr>1_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P255995</dc:title>
  <dc:creator>Hayk Barseghyan</dc:creator>
  <cp:lastModifiedBy>Hayk Barseghyan</cp:lastModifiedBy>
  <cp:revision>5</cp:revision>
  <dcterms:created xsi:type="dcterms:W3CDTF">2017-09-29T21:55:18Z</dcterms:created>
  <dcterms:modified xsi:type="dcterms:W3CDTF">2022-07-06T19:53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080993487106C48AF58DDEF95D72879</vt:lpwstr>
  </property>
</Properties>
</file>